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9" autoAdjust="0"/>
    <p:restoredTop sz="94660"/>
  </p:normalViewPr>
  <p:slideViewPr>
    <p:cSldViewPr snapToGrid="0">
      <p:cViewPr>
        <p:scale>
          <a:sx n="80" d="100"/>
          <a:sy n="80" d="100"/>
        </p:scale>
        <p:origin x="678" y="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0322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450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007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847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988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9216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284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88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219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392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93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8D01B-6EAF-4400-8149-BBCEA9D3E46C}" type="datetimeFigureOut">
              <a:rPr kumimoji="1" lang="ja-JP" altLang="en-US" smtClean="0"/>
              <a:t>2018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00D800-76B9-4CCF-8B9D-895967A58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975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5876D29C-24E3-4CC3-9A0A-01F0D0C5DB7E}"/>
              </a:ext>
            </a:extLst>
          </p:cNvPr>
          <p:cNvGrpSpPr/>
          <p:nvPr/>
        </p:nvGrpSpPr>
        <p:grpSpPr>
          <a:xfrm>
            <a:off x="702908" y="1151359"/>
            <a:ext cx="7971307" cy="5153216"/>
            <a:chOff x="553496" y="759518"/>
            <a:chExt cx="7971307" cy="5153216"/>
          </a:xfrm>
        </p:grpSpPr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1843D7B7-774A-44E7-B31C-B27F1D9FF4C1}"/>
                </a:ext>
              </a:extLst>
            </p:cNvPr>
            <p:cNvGrpSpPr/>
            <p:nvPr/>
          </p:nvGrpSpPr>
          <p:grpSpPr>
            <a:xfrm>
              <a:off x="6147627" y="759518"/>
              <a:ext cx="2377176" cy="1504143"/>
              <a:chOff x="6147627" y="759518"/>
              <a:chExt cx="2377176" cy="1504143"/>
            </a:xfrm>
          </p:grpSpPr>
          <p:sp>
            <p:nvSpPr>
              <p:cNvPr id="15" name="フリーフォーム: 図形 14">
                <a:extLst>
                  <a:ext uri="{FF2B5EF4-FFF2-40B4-BE49-F238E27FC236}">
                    <a16:creationId xmlns:a16="http://schemas.microsoft.com/office/drawing/2014/main" id="{AE34B165-FEE1-42AC-8F6D-5C7A33403FC0}"/>
                  </a:ext>
                </a:extLst>
              </p:cNvPr>
              <p:cNvSpPr/>
              <p:nvPr/>
            </p:nvSpPr>
            <p:spPr>
              <a:xfrm>
                <a:off x="7178189" y="759518"/>
                <a:ext cx="1346614" cy="1453509"/>
              </a:xfrm>
              <a:custGeom>
                <a:avLst/>
                <a:gdLst>
                  <a:gd name="connsiteX0" fmla="*/ 0 w 1346614"/>
                  <a:gd name="connsiteY0" fmla="*/ 0 h 1453509"/>
                  <a:gd name="connsiteX1" fmla="*/ 8935 w 1346614"/>
                  <a:gd name="connsiteY1" fmla="*/ 14892 h 1453509"/>
                  <a:gd name="connsiteX2" fmla="*/ 17871 w 1346614"/>
                  <a:gd name="connsiteY2" fmla="*/ 23828 h 1453509"/>
                  <a:gd name="connsiteX3" fmla="*/ 23828 w 1346614"/>
                  <a:gd name="connsiteY3" fmla="*/ 32763 h 1453509"/>
                  <a:gd name="connsiteX4" fmla="*/ 26806 w 1346614"/>
                  <a:gd name="connsiteY4" fmla="*/ 47656 h 1453509"/>
                  <a:gd name="connsiteX5" fmla="*/ 41699 w 1346614"/>
                  <a:gd name="connsiteY5" fmla="*/ 62548 h 1453509"/>
                  <a:gd name="connsiteX6" fmla="*/ 68505 w 1346614"/>
                  <a:gd name="connsiteY6" fmla="*/ 53613 h 1453509"/>
                  <a:gd name="connsiteX7" fmla="*/ 77441 w 1346614"/>
                  <a:gd name="connsiteY7" fmla="*/ 29785 h 1453509"/>
                  <a:gd name="connsiteX8" fmla="*/ 89355 w 1346614"/>
                  <a:gd name="connsiteY8" fmla="*/ 26806 h 1453509"/>
                  <a:gd name="connsiteX9" fmla="*/ 125097 w 1346614"/>
                  <a:gd name="connsiteY9" fmla="*/ 23828 h 1453509"/>
                  <a:gd name="connsiteX10" fmla="*/ 131054 w 1346614"/>
                  <a:gd name="connsiteY10" fmla="*/ 32763 h 1453509"/>
                  <a:gd name="connsiteX11" fmla="*/ 134032 w 1346614"/>
                  <a:gd name="connsiteY11" fmla="*/ 41699 h 1453509"/>
                  <a:gd name="connsiteX12" fmla="*/ 139989 w 1346614"/>
                  <a:gd name="connsiteY12" fmla="*/ 50634 h 1453509"/>
                  <a:gd name="connsiteX13" fmla="*/ 142968 w 1346614"/>
                  <a:gd name="connsiteY13" fmla="*/ 62548 h 1453509"/>
                  <a:gd name="connsiteX14" fmla="*/ 148925 w 1346614"/>
                  <a:gd name="connsiteY14" fmla="*/ 71484 h 1453509"/>
                  <a:gd name="connsiteX15" fmla="*/ 154882 w 1346614"/>
                  <a:gd name="connsiteY15" fmla="*/ 83398 h 1453509"/>
                  <a:gd name="connsiteX16" fmla="*/ 160839 w 1346614"/>
                  <a:gd name="connsiteY16" fmla="*/ 92333 h 1453509"/>
                  <a:gd name="connsiteX17" fmla="*/ 166796 w 1346614"/>
                  <a:gd name="connsiteY17" fmla="*/ 104247 h 1453509"/>
                  <a:gd name="connsiteX18" fmla="*/ 175732 w 1346614"/>
                  <a:gd name="connsiteY18" fmla="*/ 110204 h 1453509"/>
                  <a:gd name="connsiteX19" fmla="*/ 187646 w 1346614"/>
                  <a:gd name="connsiteY19" fmla="*/ 131054 h 1453509"/>
                  <a:gd name="connsiteX20" fmla="*/ 196581 w 1346614"/>
                  <a:gd name="connsiteY20" fmla="*/ 137011 h 1453509"/>
                  <a:gd name="connsiteX21" fmla="*/ 202538 w 1346614"/>
                  <a:gd name="connsiteY21" fmla="*/ 154882 h 1453509"/>
                  <a:gd name="connsiteX22" fmla="*/ 220409 w 1346614"/>
                  <a:gd name="connsiteY22" fmla="*/ 175732 h 1453509"/>
                  <a:gd name="connsiteX23" fmla="*/ 223388 w 1346614"/>
                  <a:gd name="connsiteY23" fmla="*/ 187646 h 1453509"/>
                  <a:gd name="connsiteX24" fmla="*/ 241259 w 1346614"/>
                  <a:gd name="connsiteY24" fmla="*/ 202538 h 1453509"/>
                  <a:gd name="connsiteX25" fmla="*/ 265087 w 1346614"/>
                  <a:gd name="connsiteY25" fmla="*/ 226366 h 1453509"/>
                  <a:gd name="connsiteX26" fmla="*/ 277001 w 1346614"/>
                  <a:gd name="connsiteY26" fmla="*/ 244237 h 1453509"/>
                  <a:gd name="connsiteX27" fmla="*/ 282958 w 1346614"/>
                  <a:gd name="connsiteY27" fmla="*/ 265087 h 1453509"/>
                  <a:gd name="connsiteX28" fmla="*/ 291893 w 1346614"/>
                  <a:gd name="connsiteY28" fmla="*/ 271044 h 1453509"/>
                  <a:gd name="connsiteX29" fmla="*/ 312743 w 1346614"/>
                  <a:gd name="connsiteY29" fmla="*/ 300829 h 1453509"/>
                  <a:gd name="connsiteX30" fmla="*/ 321678 w 1346614"/>
                  <a:gd name="connsiteY30" fmla="*/ 318700 h 1453509"/>
                  <a:gd name="connsiteX31" fmla="*/ 330614 w 1346614"/>
                  <a:gd name="connsiteY31" fmla="*/ 336571 h 1453509"/>
                  <a:gd name="connsiteX32" fmla="*/ 345506 w 1346614"/>
                  <a:gd name="connsiteY32" fmla="*/ 363377 h 1453509"/>
                  <a:gd name="connsiteX33" fmla="*/ 360399 w 1346614"/>
                  <a:gd name="connsiteY33" fmla="*/ 390184 h 1453509"/>
                  <a:gd name="connsiteX34" fmla="*/ 369334 w 1346614"/>
                  <a:gd name="connsiteY34" fmla="*/ 399119 h 1453509"/>
                  <a:gd name="connsiteX35" fmla="*/ 384227 w 1346614"/>
                  <a:gd name="connsiteY35" fmla="*/ 419969 h 1453509"/>
                  <a:gd name="connsiteX36" fmla="*/ 393162 w 1346614"/>
                  <a:gd name="connsiteY36" fmla="*/ 425926 h 1453509"/>
                  <a:gd name="connsiteX37" fmla="*/ 402098 w 1346614"/>
                  <a:gd name="connsiteY37" fmla="*/ 434861 h 1453509"/>
                  <a:gd name="connsiteX38" fmla="*/ 408055 w 1346614"/>
                  <a:gd name="connsiteY38" fmla="*/ 443797 h 1453509"/>
                  <a:gd name="connsiteX39" fmla="*/ 416990 w 1346614"/>
                  <a:gd name="connsiteY39" fmla="*/ 446775 h 1453509"/>
                  <a:gd name="connsiteX40" fmla="*/ 443797 w 1346614"/>
                  <a:gd name="connsiteY40" fmla="*/ 473582 h 1453509"/>
                  <a:gd name="connsiteX41" fmla="*/ 452732 w 1346614"/>
                  <a:gd name="connsiteY41" fmla="*/ 482517 h 1453509"/>
                  <a:gd name="connsiteX42" fmla="*/ 479539 w 1346614"/>
                  <a:gd name="connsiteY42" fmla="*/ 515281 h 1453509"/>
                  <a:gd name="connsiteX43" fmla="*/ 500388 w 1346614"/>
                  <a:gd name="connsiteY43" fmla="*/ 533152 h 1453509"/>
                  <a:gd name="connsiteX44" fmla="*/ 524216 w 1346614"/>
                  <a:gd name="connsiteY44" fmla="*/ 545066 h 1453509"/>
                  <a:gd name="connsiteX45" fmla="*/ 542087 w 1346614"/>
                  <a:gd name="connsiteY45" fmla="*/ 556980 h 1453509"/>
                  <a:gd name="connsiteX46" fmla="*/ 551023 w 1346614"/>
                  <a:gd name="connsiteY46" fmla="*/ 562937 h 1453509"/>
                  <a:gd name="connsiteX47" fmla="*/ 568894 w 1346614"/>
                  <a:gd name="connsiteY47" fmla="*/ 574851 h 1453509"/>
                  <a:gd name="connsiteX48" fmla="*/ 577829 w 1346614"/>
                  <a:gd name="connsiteY48" fmla="*/ 583786 h 1453509"/>
                  <a:gd name="connsiteX49" fmla="*/ 589743 w 1346614"/>
                  <a:gd name="connsiteY49" fmla="*/ 592722 h 1453509"/>
                  <a:gd name="connsiteX50" fmla="*/ 598679 w 1346614"/>
                  <a:gd name="connsiteY50" fmla="*/ 601657 h 1453509"/>
                  <a:gd name="connsiteX51" fmla="*/ 607614 w 1346614"/>
                  <a:gd name="connsiteY51" fmla="*/ 604636 h 1453509"/>
                  <a:gd name="connsiteX52" fmla="*/ 646335 w 1346614"/>
                  <a:gd name="connsiteY52" fmla="*/ 622507 h 1453509"/>
                  <a:gd name="connsiteX53" fmla="*/ 667184 w 1346614"/>
                  <a:gd name="connsiteY53" fmla="*/ 625485 h 1453509"/>
                  <a:gd name="connsiteX54" fmla="*/ 673141 w 1346614"/>
                  <a:gd name="connsiteY54" fmla="*/ 634421 h 1453509"/>
                  <a:gd name="connsiteX55" fmla="*/ 685055 w 1346614"/>
                  <a:gd name="connsiteY55" fmla="*/ 637399 h 1453509"/>
                  <a:gd name="connsiteX56" fmla="*/ 720797 w 1346614"/>
                  <a:gd name="connsiteY56" fmla="*/ 643356 h 1453509"/>
                  <a:gd name="connsiteX57" fmla="*/ 750582 w 1346614"/>
                  <a:gd name="connsiteY57" fmla="*/ 649313 h 1453509"/>
                  <a:gd name="connsiteX58" fmla="*/ 759518 w 1346614"/>
                  <a:gd name="connsiteY58" fmla="*/ 652292 h 1453509"/>
                  <a:gd name="connsiteX59" fmla="*/ 777389 w 1346614"/>
                  <a:gd name="connsiteY59" fmla="*/ 661227 h 1453509"/>
                  <a:gd name="connsiteX60" fmla="*/ 795260 w 1346614"/>
                  <a:gd name="connsiteY60" fmla="*/ 676120 h 1453509"/>
                  <a:gd name="connsiteX61" fmla="*/ 804195 w 1346614"/>
                  <a:gd name="connsiteY61" fmla="*/ 685055 h 1453509"/>
                  <a:gd name="connsiteX62" fmla="*/ 813131 w 1346614"/>
                  <a:gd name="connsiteY62" fmla="*/ 691012 h 1453509"/>
                  <a:gd name="connsiteX63" fmla="*/ 822066 w 1346614"/>
                  <a:gd name="connsiteY63" fmla="*/ 699948 h 1453509"/>
                  <a:gd name="connsiteX64" fmla="*/ 836959 w 1346614"/>
                  <a:gd name="connsiteY64" fmla="*/ 705905 h 1453509"/>
                  <a:gd name="connsiteX65" fmla="*/ 857808 w 1346614"/>
                  <a:gd name="connsiteY65" fmla="*/ 735690 h 1453509"/>
                  <a:gd name="connsiteX66" fmla="*/ 863765 w 1346614"/>
                  <a:gd name="connsiteY66" fmla="*/ 744625 h 1453509"/>
                  <a:gd name="connsiteX67" fmla="*/ 872701 w 1346614"/>
                  <a:gd name="connsiteY67" fmla="*/ 747604 h 1453509"/>
                  <a:gd name="connsiteX68" fmla="*/ 908443 w 1346614"/>
                  <a:gd name="connsiteY68" fmla="*/ 753561 h 1453509"/>
                  <a:gd name="connsiteX69" fmla="*/ 932271 w 1346614"/>
                  <a:gd name="connsiteY69" fmla="*/ 750582 h 1453509"/>
                  <a:gd name="connsiteX70" fmla="*/ 970991 w 1346614"/>
                  <a:gd name="connsiteY70" fmla="*/ 741647 h 1453509"/>
                  <a:gd name="connsiteX71" fmla="*/ 1057368 w 1346614"/>
                  <a:gd name="connsiteY71" fmla="*/ 735690 h 1453509"/>
                  <a:gd name="connsiteX72" fmla="*/ 1087153 w 1346614"/>
                  <a:gd name="connsiteY72" fmla="*/ 729733 h 1453509"/>
                  <a:gd name="connsiteX73" fmla="*/ 1102046 w 1346614"/>
                  <a:gd name="connsiteY73" fmla="*/ 717819 h 1453509"/>
                  <a:gd name="connsiteX74" fmla="*/ 1110981 w 1346614"/>
                  <a:gd name="connsiteY74" fmla="*/ 702926 h 1453509"/>
                  <a:gd name="connsiteX75" fmla="*/ 1119917 w 1346614"/>
                  <a:gd name="connsiteY75" fmla="*/ 699948 h 1453509"/>
                  <a:gd name="connsiteX76" fmla="*/ 1128852 w 1346614"/>
                  <a:gd name="connsiteY76" fmla="*/ 693991 h 1453509"/>
                  <a:gd name="connsiteX77" fmla="*/ 1137788 w 1346614"/>
                  <a:gd name="connsiteY77" fmla="*/ 685055 h 1453509"/>
                  <a:gd name="connsiteX78" fmla="*/ 1161616 w 1346614"/>
                  <a:gd name="connsiteY78" fmla="*/ 673141 h 1453509"/>
                  <a:gd name="connsiteX79" fmla="*/ 1182465 w 1346614"/>
                  <a:gd name="connsiteY79" fmla="*/ 652292 h 1453509"/>
                  <a:gd name="connsiteX80" fmla="*/ 1203315 w 1346614"/>
                  <a:gd name="connsiteY80" fmla="*/ 637399 h 1453509"/>
                  <a:gd name="connsiteX81" fmla="*/ 1212250 w 1346614"/>
                  <a:gd name="connsiteY81" fmla="*/ 625485 h 1453509"/>
                  <a:gd name="connsiteX82" fmla="*/ 1221186 w 1346614"/>
                  <a:gd name="connsiteY82" fmla="*/ 622507 h 1453509"/>
                  <a:gd name="connsiteX83" fmla="*/ 1230121 w 1346614"/>
                  <a:gd name="connsiteY83" fmla="*/ 616550 h 1453509"/>
                  <a:gd name="connsiteX84" fmla="*/ 1245014 w 1346614"/>
                  <a:gd name="connsiteY84" fmla="*/ 619528 h 1453509"/>
                  <a:gd name="connsiteX85" fmla="*/ 1247992 w 1346614"/>
                  <a:gd name="connsiteY85" fmla="*/ 631442 h 1453509"/>
                  <a:gd name="connsiteX86" fmla="*/ 1253949 w 1346614"/>
                  <a:gd name="connsiteY86" fmla="*/ 640378 h 1453509"/>
                  <a:gd name="connsiteX87" fmla="*/ 1250971 w 1346614"/>
                  <a:gd name="connsiteY87" fmla="*/ 699948 h 1453509"/>
                  <a:gd name="connsiteX88" fmla="*/ 1233100 w 1346614"/>
                  <a:gd name="connsiteY88" fmla="*/ 711862 h 1453509"/>
                  <a:gd name="connsiteX89" fmla="*/ 1224164 w 1346614"/>
                  <a:gd name="connsiteY89" fmla="*/ 720797 h 1453509"/>
                  <a:gd name="connsiteX90" fmla="*/ 1206293 w 1346614"/>
                  <a:gd name="connsiteY90" fmla="*/ 726754 h 1453509"/>
                  <a:gd name="connsiteX91" fmla="*/ 1185444 w 1346614"/>
                  <a:gd name="connsiteY91" fmla="*/ 738668 h 1453509"/>
                  <a:gd name="connsiteX92" fmla="*/ 1164594 w 1346614"/>
                  <a:gd name="connsiteY92" fmla="*/ 753561 h 1453509"/>
                  <a:gd name="connsiteX93" fmla="*/ 1155659 w 1346614"/>
                  <a:gd name="connsiteY93" fmla="*/ 762496 h 1453509"/>
                  <a:gd name="connsiteX94" fmla="*/ 1149702 w 1346614"/>
                  <a:gd name="connsiteY94" fmla="*/ 780367 h 1453509"/>
                  <a:gd name="connsiteX95" fmla="*/ 1137788 w 1346614"/>
                  <a:gd name="connsiteY95" fmla="*/ 798238 h 1453509"/>
                  <a:gd name="connsiteX96" fmla="*/ 1125874 w 1346614"/>
                  <a:gd name="connsiteY96" fmla="*/ 825045 h 1453509"/>
                  <a:gd name="connsiteX97" fmla="*/ 1131831 w 1346614"/>
                  <a:gd name="connsiteY97" fmla="*/ 878658 h 1453509"/>
                  <a:gd name="connsiteX98" fmla="*/ 1149702 w 1346614"/>
                  <a:gd name="connsiteY98" fmla="*/ 896529 h 1453509"/>
                  <a:gd name="connsiteX99" fmla="*/ 1164594 w 1346614"/>
                  <a:gd name="connsiteY99" fmla="*/ 917378 h 1453509"/>
                  <a:gd name="connsiteX100" fmla="*/ 1167573 w 1346614"/>
                  <a:gd name="connsiteY100" fmla="*/ 926314 h 1453509"/>
                  <a:gd name="connsiteX101" fmla="*/ 1173530 w 1346614"/>
                  <a:gd name="connsiteY101" fmla="*/ 1024604 h 1453509"/>
                  <a:gd name="connsiteX102" fmla="*/ 1179487 w 1346614"/>
                  <a:gd name="connsiteY102" fmla="*/ 1039497 h 1453509"/>
                  <a:gd name="connsiteX103" fmla="*/ 1209272 w 1346614"/>
                  <a:gd name="connsiteY103" fmla="*/ 1036518 h 1453509"/>
                  <a:gd name="connsiteX104" fmla="*/ 1221186 w 1346614"/>
                  <a:gd name="connsiteY104" fmla="*/ 1033540 h 1453509"/>
                  <a:gd name="connsiteX105" fmla="*/ 1245014 w 1346614"/>
                  <a:gd name="connsiteY105" fmla="*/ 1021626 h 1453509"/>
                  <a:gd name="connsiteX106" fmla="*/ 1250971 w 1346614"/>
                  <a:gd name="connsiteY106" fmla="*/ 1012690 h 1453509"/>
                  <a:gd name="connsiteX107" fmla="*/ 1262885 w 1346614"/>
                  <a:gd name="connsiteY107" fmla="*/ 1009712 h 1453509"/>
                  <a:gd name="connsiteX108" fmla="*/ 1310541 w 1346614"/>
                  <a:gd name="connsiteY108" fmla="*/ 1006733 h 1453509"/>
                  <a:gd name="connsiteX109" fmla="*/ 1325433 w 1346614"/>
                  <a:gd name="connsiteY109" fmla="*/ 1003755 h 1453509"/>
                  <a:gd name="connsiteX110" fmla="*/ 1343304 w 1346614"/>
                  <a:gd name="connsiteY110" fmla="*/ 991841 h 1453509"/>
                  <a:gd name="connsiteX111" fmla="*/ 1346283 w 1346614"/>
                  <a:gd name="connsiteY111" fmla="*/ 1000776 h 1453509"/>
                  <a:gd name="connsiteX112" fmla="*/ 1343304 w 1346614"/>
                  <a:gd name="connsiteY112" fmla="*/ 1030561 h 1453509"/>
                  <a:gd name="connsiteX113" fmla="*/ 1328412 w 1346614"/>
                  <a:gd name="connsiteY113" fmla="*/ 1033540 h 1453509"/>
                  <a:gd name="connsiteX114" fmla="*/ 1286713 w 1346614"/>
                  <a:gd name="connsiteY114" fmla="*/ 1039497 h 1453509"/>
                  <a:gd name="connsiteX115" fmla="*/ 1268842 w 1346614"/>
                  <a:gd name="connsiteY115" fmla="*/ 1051411 h 1453509"/>
                  <a:gd name="connsiteX116" fmla="*/ 1259906 w 1346614"/>
                  <a:gd name="connsiteY116" fmla="*/ 1069282 h 1453509"/>
                  <a:gd name="connsiteX117" fmla="*/ 1256928 w 1346614"/>
                  <a:gd name="connsiteY117" fmla="*/ 1078218 h 1453509"/>
                  <a:gd name="connsiteX118" fmla="*/ 1194379 w 1346614"/>
                  <a:gd name="connsiteY118" fmla="*/ 1081196 h 1453509"/>
                  <a:gd name="connsiteX119" fmla="*/ 1185444 w 1346614"/>
                  <a:gd name="connsiteY119" fmla="*/ 1075239 h 1453509"/>
                  <a:gd name="connsiteX120" fmla="*/ 1161616 w 1346614"/>
                  <a:gd name="connsiteY120" fmla="*/ 1069282 h 1453509"/>
                  <a:gd name="connsiteX121" fmla="*/ 1152680 w 1346614"/>
                  <a:gd name="connsiteY121" fmla="*/ 1066304 h 1453509"/>
                  <a:gd name="connsiteX122" fmla="*/ 1113960 w 1346614"/>
                  <a:gd name="connsiteY122" fmla="*/ 1069282 h 1453509"/>
                  <a:gd name="connsiteX123" fmla="*/ 1105024 w 1346614"/>
                  <a:gd name="connsiteY123" fmla="*/ 1081196 h 1453509"/>
                  <a:gd name="connsiteX124" fmla="*/ 1096089 w 1346614"/>
                  <a:gd name="connsiteY124" fmla="*/ 1090132 h 1453509"/>
                  <a:gd name="connsiteX125" fmla="*/ 1081196 w 1346614"/>
                  <a:gd name="connsiteY125" fmla="*/ 1108003 h 1453509"/>
                  <a:gd name="connsiteX126" fmla="*/ 1060347 w 1346614"/>
                  <a:gd name="connsiteY126" fmla="*/ 1140766 h 1453509"/>
                  <a:gd name="connsiteX127" fmla="*/ 1051411 w 1346614"/>
                  <a:gd name="connsiteY127" fmla="*/ 1149702 h 1453509"/>
                  <a:gd name="connsiteX128" fmla="*/ 1024604 w 1346614"/>
                  <a:gd name="connsiteY128" fmla="*/ 1146723 h 1453509"/>
                  <a:gd name="connsiteX129" fmla="*/ 1015669 w 1346614"/>
                  <a:gd name="connsiteY129" fmla="*/ 1140766 h 1453509"/>
                  <a:gd name="connsiteX130" fmla="*/ 997798 w 1346614"/>
                  <a:gd name="connsiteY130" fmla="*/ 1122895 h 1453509"/>
                  <a:gd name="connsiteX131" fmla="*/ 979927 w 1346614"/>
                  <a:gd name="connsiteY131" fmla="*/ 1116938 h 1453509"/>
                  <a:gd name="connsiteX132" fmla="*/ 965034 w 1346614"/>
                  <a:gd name="connsiteY132" fmla="*/ 1134809 h 1453509"/>
                  <a:gd name="connsiteX133" fmla="*/ 956099 w 1346614"/>
                  <a:gd name="connsiteY133" fmla="*/ 1137788 h 1453509"/>
                  <a:gd name="connsiteX134" fmla="*/ 920357 w 1346614"/>
                  <a:gd name="connsiteY134" fmla="*/ 1140766 h 1453509"/>
                  <a:gd name="connsiteX135" fmla="*/ 905464 w 1346614"/>
                  <a:gd name="connsiteY135" fmla="*/ 1161616 h 1453509"/>
                  <a:gd name="connsiteX136" fmla="*/ 896529 w 1346614"/>
                  <a:gd name="connsiteY136" fmla="*/ 1167573 h 1453509"/>
                  <a:gd name="connsiteX137" fmla="*/ 872701 w 1346614"/>
                  <a:gd name="connsiteY137" fmla="*/ 1161616 h 1453509"/>
                  <a:gd name="connsiteX138" fmla="*/ 851851 w 1346614"/>
                  <a:gd name="connsiteY138" fmla="*/ 1149702 h 1453509"/>
                  <a:gd name="connsiteX139" fmla="*/ 848873 w 1346614"/>
                  <a:gd name="connsiteY139" fmla="*/ 1140766 h 1453509"/>
                  <a:gd name="connsiteX140" fmla="*/ 836959 w 1346614"/>
                  <a:gd name="connsiteY140" fmla="*/ 1137788 h 1453509"/>
                  <a:gd name="connsiteX141" fmla="*/ 786324 w 1346614"/>
                  <a:gd name="connsiteY141" fmla="*/ 1131831 h 1453509"/>
                  <a:gd name="connsiteX142" fmla="*/ 771432 w 1346614"/>
                  <a:gd name="connsiteY142" fmla="*/ 1128852 h 1453509"/>
                  <a:gd name="connsiteX143" fmla="*/ 765475 w 1346614"/>
                  <a:gd name="connsiteY143" fmla="*/ 1119917 h 1453509"/>
                  <a:gd name="connsiteX144" fmla="*/ 756539 w 1346614"/>
                  <a:gd name="connsiteY144" fmla="*/ 1113960 h 1453509"/>
                  <a:gd name="connsiteX145" fmla="*/ 741647 w 1346614"/>
                  <a:gd name="connsiteY145" fmla="*/ 1122895 h 1453509"/>
                  <a:gd name="connsiteX146" fmla="*/ 732711 w 1346614"/>
                  <a:gd name="connsiteY146" fmla="*/ 1128852 h 1453509"/>
                  <a:gd name="connsiteX147" fmla="*/ 714840 w 1346614"/>
                  <a:gd name="connsiteY147" fmla="*/ 1137788 h 1453509"/>
                  <a:gd name="connsiteX148" fmla="*/ 705905 w 1346614"/>
                  <a:gd name="connsiteY148" fmla="*/ 1140766 h 1453509"/>
                  <a:gd name="connsiteX149" fmla="*/ 625485 w 1346614"/>
                  <a:gd name="connsiteY149" fmla="*/ 1143745 h 1453509"/>
                  <a:gd name="connsiteX150" fmla="*/ 577829 w 1346614"/>
                  <a:gd name="connsiteY150" fmla="*/ 1152680 h 1453509"/>
                  <a:gd name="connsiteX151" fmla="*/ 568894 w 1346614"/>
                  <a:gd name="connsiteY151" fmla="*/ 1158637 h 1453509"/>
                  <a:gd name="connsiteX152" fmla="*/ 551023 w 1346614"/>
                  <a:gd name="connsiteY152" fmla="*/ 1164594 h 1453509"/>
                  <a:gd name="connsiteX153" fmla="*/ 542087 w 1346614"/>
                  <a:gd name="connsiteY153" fmla="*/ 1170551 h 1453509"/>
                  <a:gd name="connsiteX154" fmla="*/ 533152 w 1346614"/>
                  <a:gd name="connsiteY154" fmla="*/ 1179487 h 1453509"/>
                  <a:gd name="connsiteX155" fmla="*/ 524216 w 1346614"/>
                  <a:gd name="connsiteY155" fmla="*/ 1182465 h 1453509"/>
                  <a:gd name="connsiteX156" fmla="*/ 518259 w 1346614"/>
                  <a:gd name="connsiteY156" fmla="*/ 1191401 h 1453509"/>
                  <a:gd name="connsiteX157" fmla="*/ 509324 w 1346614"/>
                  <a:gd name="connsiteY157" fmla="*/ 1194379 h 1453509"/>
                  <a:gd name="connsiteX158" fmla="*/ 497410 w 1346614"/>
                  <a:gd name="connsiteY158" fmla="*/ 1200336 h 1453509"/>
                  <a:gd name="connsiteX159" fmla="*/ 485496 w 1346614"/>
                  <a:gd name="connsiteY159" fmla="*/ 1209272 h 1453509"/>
                  <a:gd name="connsiteX160" fmla="*/ 467625 w 1346614"/>
                  <a:gd name="connsiteY160" fmla="*/ 1215229 h 1453509"/>
                  <a:gd name="connsiteX161" fmla="*/ 449754 w 1346614"/>
                  <a:gd name="connsiteY161" fmla="*/ 1224164 h 1453509"/>
                  <a:gd name="connsiteX162" fmla="*/ 431883 w 1346614"/>
                  <a:gd name="connsiteY162" fmla="*/ 1239057 h 1453509"/>
                  <a:gd name="connsiteX163" fmla="*/ 414012 w 1346614"/>
                  <a:gd name="connsiteY163" fmla="*/ 1256928 h 1453509"/>
                  <a:gd name="connsiteX164" fmla="*/ 381248 w 1346614"/>
                  <a:gd name="connsiteY164" fmla="*/ 1286713 h 1453509"/>
                  <a:gd name="connsiteX165" fmla="*/ 363377 w 1346614"/>
                  <a:gd name="connsiteY165" fmla="*/ 1304584 h 1453509"/>
                  <a:gd name="connsiteX166" fmla="*/ 348485 w 1346614"/>
                  <a:gd name="connsiteY166" fmla="*/ 1328412 h 1453509"/>
                  <a:gd name="connsiteX167" fmla="*/ 336571 w 1346614"/>
                  <a:gd name="connsiteY167" fmla="*/ 1346283 h 1453509"/>
                  <a:gd name="connsiteX168" fmla="*/ 330614 w 1346614"/>
                  <a:gd name="connsiteY168" fmla="*/ 1355218 h 1453509"/>
                  <a:gd name="connsiteX169" fmla="*/ 321678 w 1346614"/>
                  <a:gd name="connsiteY169" fmla="*/ 1361175 h 1453509"/>
                  <a:gd name="connsiteX170" fmla="*/ 306786 w 1346614"/>
                  <a:gd name="connsiteY170" fmla="*/ 1387982 h 1453509"/>
                  <a:gd name="connsiteX171" fmla="*/ 282958 w 1346614"/>
                  <a:gd name="connsiteY171" fmla="*/ 1417767 h 1453509"/>
                  <a:gd name="connsiteX172" fmla="*/ 268065 w 1346614"/>
                  <a:gd name="connsiteY172" fmla="*/ 1435638 h 1453509"/>
                  <a:gd name="connsiteX173" fmla="*/ 265087 w 1346614"/>
                  <a:gd name="connsiteY173" fmla="*/ 1444573 h 1453509"/>
                  <a:gd name="connsiteX174" fmla="*/ 256151 w 1346614"/>
                  <a:gd name="connsiteY174" fmla="*/ 1453509 h 14535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</a:cxnLst>
                <a:rect l="l" t="t" r="r" b="b"/>
                <a:pathLst>
                  <a:path w="1346614" h="1453509">
                    <a:moveTo>
                      <a:pt x="0" y="0"/>
                    </a:moveTo>
                    <a:cubicBezTo>
                      <a:pt x="2978" y="4964"/>
                      <a:pt x="5462" y="10261"/>
                      <a:pt x="8935" y="14892"/>
                    </a:cubicBezTo>
                    <a:cubicBezTo>
                      <a:pt x="11462" y="18262"/>
                      <a:pt x="15174" y="20592"/>
                      <a:pt x="17871" y="23828"/>
                    </a:cubicBezTo>
                    <a:cubicBezTo>
                      <a:pt x="20163" y="26578"/>
                      <a:pt x="21842" y="29785"/>
                      <a:pt x="23828" y="32763"/>
                    </a:cubicBezTo>
                    <a:cubicBezTo>
                      <a:pt x="24821" y="37727"/>
                      <a:pt x="23864" y="43536"/>
                      <a:pt x="26806" y="47656"/>
                    </a:cubicBezTo>
                    <a:cubicBezTo>
                      <a:pt x="49814" y="79869"/>
                      <a:pt x="31457" y="31829"/>
                      <a:pt x="41699" y="62548"/>
                    </a:cubicBezTo>
                    <a:cubicBezTo>
                      <a:pt x="50634" y="59570"/>
                      <a:pt x="60236" y="58123"/>
                      <a:pt x="68505" y="53613"/>
                    </a:cubicBezTo>
                    <a:cubicBezTo>
                      <a:pt x="79596" y="47563"/>
                      <a:pt x="70471" y="38149"/>
                      <a:pt x="77441" y="29785"/>
                    </a:cubicBezTo>
                    <a:cubicBezTo>
                      <a:pt x="80062" y="26640"/>
                      <a:pt x="85384" y="27799"/>
                      <a:pt x="89355" y="26806"/>
                    </a:cubicBezTo>
                    <a:cubicBezTo>
                      <a:pt x="102808" y="17837"/>
                      <a:pt x="102174" y="15492"/>
                      <a:pt x="125097" y="23828"/>
                    </a:cubicBezTo>
                    <a:cubicBezTo>
                      <a:pt x="128461" y="25051"/>
                      <a:pt x="129068" y="29785"/>
                      <a:pt x="131054" y="32763"/>
                    </a:cubicBezTo>
                    <a:cubicBezTo>
                      <a:pt x="132047" y="35742"/>
                      <a:pt x="132628" y="38891"/>
                      <a:pt x="134032" y="41699"/>
                    </a:cubicBezTo>
                    <a:cubicBezTo>
                      <a:pt x="135633" y="44901"/>
                      <a:pt x="138579" y="47344"/>
                      <a:pt x="139989" y="50634"/>
                    </a:cubicBezTo>
                    <a:cubicBezTo>
                      <a:pt x="141602" y="54397"/>
                      <a:pt x="141355" y="58785"/>
                      <a:pt x="142968" y="62548"/>
                    </a:cubicBezTo>
                    <a:cubicBezTo>
                      <a:pt x="144378" y="65838"/>
                      <a:pt x="147149" y="68376"/>
                      <a:pt x="148925" y="71484"/>
                    </a:cubicBezTo>
                    <a:cubicBezTo>
                      <a:pt x="151128" y="75339"/>
                      <a:pt x="152679" y="79543"/>
                      <a:pt x="154882" y="83398"/>
                    </a:cubicBezTo>
                    <a:cubicBezTo>
                      <a:pt x="156658" y="86506"/>
                      <a:pt x="159063" y="89225"/>
                      <a:pt x="160839" y="92333"/>
                    </a:cubicBezTo>
                    <a:cubicBezTo>
                      <a:pt x="163042" y="96188"/>
                      <a:pt x="163953" y="100836"/>
                      <a:pt x="166796" y="104247"/>
                    </a:cubicBezTo>
                    <a:cubicBezTo>
                      <a:pt x="169088" y="106997"/>
                      <a:pt x="172753" y="108218"/>
                      <a:pt x="175732" y="110204"/>
                    </a:cubicBezTo>
                    <a:cubicBezTo>
                      <a:pt x="178068" y="114876"/>
                      <a:pt x="183437" y="126844"/>
                      <a:pt x="187646" y="131054"/>
                    </a:cubicBezTo>
                    <a:cubicBezTo>
                      <a:pt x="190177" y="133585"/>
                      <a:pt x="193603" y="135025"/>
                      <a:pt x="196581" y="137011"/>
                    </a:cubicBezTo>
                    <a:cubicBezTo>
                      <a:pt x="198567" y="142968"/>
                      <a:pt x="198770" y="149859"/>
                      <a:pt x="202538" y="154882"/>
                    </a:cubicBezTo>
                    <a:cubicBezTo>
                      <a:pt x="214001" y="170166"/>
                      <a:pt x="207964" y="163286"/>
                      <a:pt x="220409" y="175732"/>
                    </a:cubicBezTo>
                    <a:cubicBezTo>
                      <a:pt x="221402" y="179703"/>
                      <a:pt x="221357" y="184092"/>
                      <a:pt x="223388" y="187646"/>
                    </a:cubicBezTo>
                    <a:cubicBezTo>
                      <a:pt x="226917" y="193821"/>
                      <a:pt x="235565" y="198742"/>
                      <a:pt x="241259" y="202538"/>
                    </a:cubicBezTo>
                    <a:cubicBezTo>
                      <a:pt x="255636" y="224103"/>
                      <a:pt x="246769" y="217207"/>
                      <a:pt x="265087" y="226366"/>
                    </a:cubicBezTo>
                    <a:cubicBezTo>
                      <a:pt x="269058" y="232323"/>
                      <a:pt x="275265" y="237291"/>
                      <a:pt x="277001" y="244237"/>
                    </a:cubicBezTo>
                    <a:cubicBezTo>
                      <a:pt x="277196" y="245019"/>
                      <a:pt x="281403" y="263143"/>
                      <a:pt x="282958" y="265087"/>
                    </a:cubicBezTo>
                    <a:cubicBezTo>
                      <a:pt x="285194" y="267882"/>
                      <a:pt x="288915" y="269058"/>
                      <a:pt x="291893" y="271044"/>
                    </a:cubicBezTo>
                    <a:cubicBezTo>
                      <a:pt x="305408" y="298074"/>
                      <a:pt x="296418" y="289946"/>
                      <a:pt x="312743" y="300829"/>
                    </a:cubicBezTo>
                    <a:cubicBezTo>
                      <a:pt x="320226" y="323280"/>
                      <a:pt x="310134" y="295613"/>
                      <a:pt x="321678" y="318700"/>
                    </a:cubicBezTo>
                    <a:cubicBezTo>
                      <a:pt x="334010" y="343364"/>
                      <a:pt x="313541" y="310961"/>
                      <a:pt x="330614" y="336571"/>
                    </a:cubicBezTo>
                    <a:cubicBezTo>
                      <a:pt x="337903" y="358438"/>
                      <a:pt x="332131" y="350002"/>
                      <a:pt x="345506" y="363377"/>
                    </a:cubicBezTo>
                    <a:cubicBezTo>
                      <a:pt x="349252" y="374613"/>
                      <a:pt x="350158" y="379943"/>
                      <a:pt x="360399" y="390184"/>
                    </a:cubicBezTo>
                    <a:cubicBezTo>
                      <a:pt x="363377" y="393162"/>
                      <a:pt x="366638" y="395883"/>
                      <a:pt x="369334" y="399119"/>
                    </a:cubicBezTo>
                    <a:cubicBezTo>
                      <a:pt x="377794" y="409271"/>
                      <a:pt x="373491" y="409233"/>
                      <a:pt x="384227" y="419969"/>
                    </a:cubicBezTo>
                    <a:cubicBezTo>
                      <a:pt x="386758" y="422500"/>
                      <a:pt x="390412" y="423634"/>
                      <a:pt x="393162" y="425926"/>
                    </a:cubicBezTo>
                    <a:cubicBezTo>
                      <a:pt x="396398" y="428623"/>
                      <a:pt x="399401" y="431625"/>
                      <a:pt x="402098" y="434861"/>
                    </a:cubicBezTo>
                    <a:cubicBezTo>
                      <a:pt x="404390" y="437611"/>
                      <a:pt x="405260" y="441561"/>
                      <a:pt x="408055" y="443797"/>
                    </a:cubicBezTo>
                    <a:cubicBezTo>
                      <a:pt x="410506" y="445758"/>
                      <a:pt x="414012" y="445782"/>
                      <a:pt x="416990" y="446775"/>
                    </a:cubicBezTo>
                    <a:lnTo>
                      <a:pt x="443797" y="473582"/>
                    </a:lnTo>
                    <a:cubicBezTo>
                      <a:pt x="446775" y="476560"/>
                      <a:pt x="450848" y="478750"/>
                      <a:pt x="452732" y="482517"/>
                    </a:cubicBezTo>
                    <a:cubicBezTo>
                      <a:pt x="466696" y="510445"/>
                      <a:pt x="447555" y="475302"/>
                      <a:pt x="479539" y="515281"/>
                    </a:cubicBezTo>
                    <a:cubicBezTo>
                      <a:pt x="493414" y="532625"/>
                      <a:pt x="485422" y="528162"/>
                      <a:pt x="500388" y="533152"/>
                    </a:cubicBezTo>
                    <a:cubicBezTo>
                      <a:pt x="520292" y="553053"/>
                      <a:pt x="496315" y="532383"/>
                      <a:pt x="524216" y="545066"/>
                    </a:cubicBezTo>
                    <a:cubicBezTo>
                      <a:pt x="530734" y="548029"/>
                      <a:pt x="536130" y="553009"/>
                      <a:pt x="542087" y="556980"/>
                    </a:cubicBezTo>
                    <a:lnTo>
                      <a:pt x="551023" y="562937"/>
                    </a:lnTo>
                    <a:cubicBezTo>
                      <a:pt x="563908" y="582264"/>
                      <a:pt x="548181" y="563015"/>
                      <a:pt x="568894" y="574851"/>
                    </a:cubicBezTo>
                    <a:cubicBezTo>
                      <a:pt x="572551" y="576941"/>
                      <a:pt x="574631" y="581045"/>
                      <a:pt x="577829" y="583786"/>
                    </a:cubicBezTo>
                    <a:cubicBezTo>
                      <a:pt x="581598" y="587017"/>
                      <a:pt x="585974" y="589491"/>
                      <a:pt x="589743" y="592722"/>
                    </a:cubicBezTo>
                    <a:cubicBezTo>
                      <a:pt x="592941" y="595463"/>
                      <a:pt x="595174" y="599320"/>
                      <a:pt x="598679" y="601657"/>
                    </a:cubicBezTo>
                    <a:cubicBezTo>
                      <a:pt x="601291" y="603398"/>
                      <a:pt x="604763" y="603320"/>
                      <a:pt x="607614" y="604636"/>
                    </a:cubicBezTo>
                    <a:cubicBezTo>
                      <a:pt x="609904" y="605693"/>
                      <a:pt x="635440" y="620328"/>
                      <a:pt x="646335" y="622507"/>
                    </a:cubicBezTo>
                    <a:cubicBezTo>
                      <a:pt x="653219" y="623884"/>
                      <a:pt x="660234" y="624492"/>
                      <a:pt x="667184" y="625485"/>
                    </a:cubicBezTo>
                    <a:cubicBezTo>
                      <a:pt x="669170" y="628464"/>
                      <a:pt x="670162" y="632435"/>
                      <a:pt x="673141" y="634421"/>
                    </a:cubicBezTo>
                    <a:cubicBezTo>
                      <a:pt x="676547" y="636692"/>
                      <a:pt x="681032" y="636645"/>
                      <a:pt x="685055" y="637399"/>
                    </a:cubicBezTo>
                    <a:cubicBezTo>
                      <a:pt x="696926" y="639625"/>
                      <a:pt x="708953" y="640987"/>
                      <a:pt x="720797" y="643356"/>
                    </a:cubicBezTo>
                    <a:cubicBezTo>
                      <a:pt x="730725" y="645342"/>
                      <a:pt x="740716" y="647036"/>
                      <a:pt x="750582" y="649313"/>
                    </a:cubicBezTo>
                    <a:cubicBezTo>
                      <a:pt x="753641" y="650019"/>
                      <a:pt x="756710" y="650888"/>
                      <a:pt x="759518" y="652292"/>
                    </a:cubicBezTo>
                    <a:cubicBezTo>
                      <a:pt x="782606" y="663837"/>
                      <a:pt x="754934" y="653744"/>
                      <a:pt x="777389" y="661227"/>
                    </a:cubicBezTo>
                    <a:cubicBezTo>
                      <a:pt x="798992" y="690033"/>
                      <a:pt x="774794" y="662476"/>
                      <a:pt x="795260" y="676120"/>
                    </a:cubicBezTo>
                    <a:cubicBezTo>
                      <a:pt x="798765" y="678456"/>
                      <a:pt x="800959" y="682359"/>
                      <a:pt x="804195" y="685055"/>
                    </a:cubicBezTo>
                    <a:cubicBezTo>
                      <a:pt x="806945" y="687347"/>
                      <a:pt x="810381" y="688720"/>
                      <a:pt x="813131" y="691012"/>
                    </a:cubicBezTo>
                    <a:cubicBezTo>
                      <a:pt x="816367" y="693709"/>
                      <a:pt x="818494" y="697715"/>
                      <a:pt x="822066" y="699948"/>
                    </a:cubicBezTo>
                    <a:cubicBezTo>
                      <a:pt x="826600" y="702782"/>
                      <a:pt x="831995" y="703919"/>
                      <a:pt x="836959" y="705905"/>
                    </a:cubicBezTo>
                    <a:cubicBezTo>
                      <a:pt x="864338" y="746973"/>
                      <a:pt x="835764" y="704828"/>
                      <a:pt x="857808" y="735690"/>
                    </a:cubicBezTo>
                    <a:cubicBezTo>
                      <a:pt x="859889" y="738603"/>
                      <a:pt x="860970" y="742389"/>
                      <a:pt x="863765" y="744625"/>
                    </a:cubicBezTo>
                    <a:cubicBezTo>
                      <a:pt x="866217" y="746586"/>
                      <a:pt x="869722" y="746611"/>
                      <a:pt x="872701" y="747604"/>
                    </a:cubicBezTo>
                    <a:cubicBezTo>
                      <a:pt x="887908" y="762811"/>
                      <a:pt x="877632" y="757186"/>
                      <a:pt x="908443" y="753561"/>
                    </a:cubicBezTo>
                    <a:cubicBezTo>
                      <a:pt x="916393" y="752626"/>
                      <a:pt x="924404" y="752057"/>
                      <a:pt x="932271" y="750582"/>
                    </a:cubicBezTo>
                    <a:cubicBezTo>
                      <a:pt x="937378" y="749624"/>
                      <a:pt x="962683" y="742380"/>
                      <a:pt x="970991" y="741647"/>
                    </a:cubicBezTo>
                    <a:cubicBezTo>
                      <a:pt x="999740" y="739110"/>
                      <a:pt x="1028576" y="737676"/>
                      <a:pt x="1057368" y="735690"/>
                    </a:cubicBezTo>
                    <a:cubicBezTo>
                      <a:pt x="1067296" y="733704"/>
                      <a:pt x="1081537" y="738158"/>
                      <a:pt x="1087153" y="729733"/>
                    </a:cubicBezTo>
                    <a:cubicBezTo>
                      <a:pt x="1094852" y="718185"/>
                      <a:pt x="1089714" y="721929"/>
                      <a:pt x="1102046" y="717819"/>
                    </a:cubicBezTo>
                    <a:cubicBezTo>
                      <a:pt x="1105024" y="712855"/>
                      <a:pt x="1106887" y="707020"/>
                      <a:pt x="1110981" y="702926"/>
                    </a:cubicBezTo>
                    <a:cubicBezTo>
                      <a:pt x="1113201" y="700706"/>
                      <a:pt x="1117109" y="701352"/>
                      <a:pt x="1119917" y="699948"/>
                    </a:cubicBezTo>
                    <a:cubicBezTo>
                      <a:pt x="1123119" y="698347"/>
                      <a:pt x="1126102" y="696283"/>
                      <a:pt x="1128852" y="693991"/>
                    </a:cubicBezTo>
                    <a:cubicBezTo>
                      <a:pt x="1132088" y="691294"/>
                      <a:pt x="1134552" y="687752"/>
                      <a:pt x="1137788" y="685055"/>
                    </a:cubicBezTo>
                    <a:cubicBezTo>
                      <a:pt x="1146025" y="678191"/>
                      <a:pt x="1151087" y="677352"/>
                      <a:pt x="1161616" y="673141"/>
                    </a:cubicBezTo>
                    <a:cubicBezTo>
                      <a:pt x="1175085" y="652939"/>
                      <a:pt x="1157700" y="677058"/>
                      <a:pt x="1182465" y="652292"/>
                    </a:cubicBezTo>
                    <a:cubicBezTo>
                      <a:pt x="1198823" y="635933"/>
                      <a:pt x="1173993" y="649127"/>
                      <a:pt x="1203315" y="637399"/>
                    </a:cubicBezTo>
                    <a:cubicBezTo>
                      <a:pt x="1206293" y="633428"/>
                      <a:pt x="1208436" y="628663"/>
                      <a:pt x="1212250" y="625485"/>
                    </a:cubicBezTo>
                    <a:cubicBezTo>
                      <a:pt x="1214662" y="623475"/>
                      <a:pt x="1218378" y="623911"/>
                      <a:pt x="1221186" y="622507"/>
                    </a:cubicBezTo>
                    <a:cubicBezTo>
                      <a:pt x="1224388" y="620906"/>
                      <a:pt x="1227143" y="618536"/>
                      <a:pt x="1230121" y="616550"/>
                    </a:cubicBezTo>
                    <a:cubicBezTo>
                      <a:pt x="1235085" y="617543"/>
                      <a:pt x="1241125" y="616287"/>
                      <a:pt x="1245014" y="619528"/>
                    </a:cubicBezTo>
                    <a:cubicBezTo>
                      <a:pt x="1248159" y="622149"/>
                      <a:pt x="1246380" y="627679"/>
                      <a:pt x="1247992" y="631442"/>
                    </a:cubicBezTo>
                    <a:cubicBezTo>
                      <a:pt x="1249402" y="634732"/>
                      <a:pt x="1251963" y="637399"/>
                      <a:pt x="1253949" y="640378"/>
                    </a:cubicBezTo>
                    <a:cubicBezTo>
                      <a:pt x="1252956" y="660235"/>
                      <a:pt x="1256538" y="680862"/>
                      <a:pt x="1250971" y="699948"/>
                    </a:cubicBezTo>
                    <a:cubicBezTo>
                      <a:pt x="1248966" y="706821"/>
                      <a:pt x="1238163" y="706800"/>
                      <a:pt x="1233100" y="711862"/>
                    </a:cubicBezTo>
                    <a:cubicBezTo>
                      <a:pt x="1230121" y="714840"/>
                      <a:pt x="1227846" y="718751"/>
                      <a:pt x="1224164" y="720797"/>
                    </a:cubicBezTo>
                    <a:cubicBezTo>
                      <a:pt x="1218675" y="723846"/>
                      <a:pt x="1206293" y="726754"/>
                      <a:pt x="1206293" y="726754"/>
                    </a:cubicBezTo>
                    <a:cubicBezTo>
                      <a:pt x="1184531" y="741263"/>
                      <a:pt x="1211888" y="723557"/>
                      <a:pt x="1185444" y="738668"/>
                    </a:cubicBezTo>
                    <a:cubicBezTo>
                      <a:pt x="1180726" y="741364"/>
                      <a:pt x="1167794" y="750818"/>
                      <a:pt x="1164594" y="753561"/>
                    </a:cubicBezTo>
                    <a:cubicBezTo>
                      <a:pt x="1161396" y="756302"/>
                      <a:pt x="1158637" y="759518"/>
                      <a:pt x="1155659" y="762496"/>
                    </a:cubicBezTo>
                    <a:cubicBezTo>
                      <a:pt x="1153673" y="768453"/>
                      <a:pt x="1153185" y="775142"/>
                      <a:pt x="1149702" y="780367"/>
                    </a:cubicBezTo>
                    <a:cubicBezTo>
                      <a:pt x="1145731" y="786324"/>
                      <a:pt x="1140052" y="791446"/>
                      <a:pt x="1137788" y="798238"/>
                    </a:cubicBezTo>
                    <a:cubicBezTo>
                      <a:pt x="1130699" y="819505"/>
                      <a:pt x="1135314" y="810884"/>
                      <a:pt x="1125874" y="825045"/>
                    </a:cubicBezTo>
                    <a:cubicBezTo>
                      <a:pt x="1127860" y="842916"/>
                      <a:pt x="1126145" y="861600"/>
                      <a:pt x="1131831" y="878658"/>
                    </a:cubicBezTo>
                    <a:cubicBezTo>
                      <a:pt x="1134495" y="886650"/>
                      <a:pt x="1144647" y="889789"/>
                      <a:pt x="1149702" y="896529"/>
                    </a:cubicBezTo>
                    <a:cubicBezTo>
                      <a:pt x="1151723" y="899224"/>
                      <a:pt x="1162418" y="913026"/>
                      <a:pt x="1164594" y="917378"/>
                    </a:cubicBezTo>
                    <a:cubicBezTo>
                      <a:pt x="1165998" y="920186"/>
                      <a:pt x="1166580" y="923335"/>
                      <a:pt x="1167573" y="926314"/>
                    </a:cubicBezTo>
                    <a:cubicBezTo>
                      <a:pt x="1177484" y="985790"/>
                      <a:pt x="1159117" y="870879"/>
                      <a:pt x="1173530" y="1024604"/>
                    </a:cubicBezTo>
                    <a:cubicBezTo>
                      <a:pt x="1174029" y="1029927"/>
                      <a:pt x="1177501" y="1034533"/>
                      <a:pt x="1179487" y="1039497"/>
                    </a:cubicBezTo>
                    <a:cubicBezTo>
                      <a:pt x="1189415" y="1038504"/>
                      <a:pt x="1199394" y="1037929"/>
                      <a:pt x="1209272" y="1036518"/>
                    </a:cubicBezTo>
                    <a:cubicBezTo>
                      <a:pt x="1213324" y="1035939"/>
                      <a:pt x="1217632" y="1035571"/>
                      <a:pt x="1221186" y="1033540"/>
                    </a:cubicBezTo>
                    <a:cubicBezTo>
                      <a:pt x="1248142" y="1018136"/>
                      <a:pt x="1208634" y="1028901"/>
                      <a:pt x="1245014" y="1021626"/>
                    </a:cubicBezTo>
                    <a:cubicBezTo>
                      <a:pt x="1247000" y="1018647"/>
                      <a:pt x="1247992" y="1014676"/>
                      <a:pt x="1250971" y="1012690"/>
                    </a:cubicBezTo>
                    <a:cubicBezTo>
                      <a:pt x="1254377" y="1010419"/>
                      <a:pt x="1258812" y="1010119"/>
                      <a:pt x="1262885" y="1009712"/>
                    </a:cubicBezTo>
                    <a:cubicBezTo>
                      <a:pt x="1278722" y="1008128"/>
                      <a:pt x="1294656" y="1007726"/>
                      <a:pt x="1310541" y="1006733"/>
                    </a:cubicBezTo>
                    <a:cubicBezTo>
                      <a:pt x="1315505" y="1005740"/>
                      <a:pt x="1320824" y="1005850"/>
                      <a:pt x="1325433" y="1003755"/>
                    </a:cubicBezTo>
                    <a:cubicBezTo>
                      <a:pt x="1331951" y="1000792"/>
                      <a:pt x="1343304" y="991841"/>
                      <a:pt x="1343304" y="991841"/>
                    </a:cubicBezTo>
                    <a:cubicBezTo>
                      <a:pt x="1344297" y="994819"/>
                      <a:pt x="1346283" y="997636"/>
                      <a:pt x="1346283" y="1000776"/>
                    </a:cubicBezTo>
                    <a:cubicBezTo>
                      <a:pt x="1346283" y="1010754"/>
                      <a:pt x="1348082" y="1021801"/>
                      <a:pt x="1343304" y="1030561"/>
                    </a:cubicBezTo>
                    <a:cubicBezTo>
                      <a:pt x="1340880" y="1035005"/>
                      <a:pt x="1333412" y="1032750"/>
                      <a:pt x="1328412" y="1033540"/>
                    </a:cubicBezTo>
                    <a:cubicBezTo>
                      <a:pt x="1314543" y="1035730"/>
                      <a:pt x="1300613" y="1037511"/>
                      <a:pt x="1286713" y="1039497"/>
                    </a:cubicBezTo>
                    <a:cubicBezTo>
                      <a:pt x="1280756" y="1043468"/>
                      <a:pt x="1271106" y="1044619"/>
                      <a:pt x="1268842" y="1051411"/>
                    </a:cubicBezTo>
                    <a:cubicBezTo>
                      <a:pt x="1264731" y="1063743"/>
                      <a:pt x="1267605" y="1057735"/>
                      <a:pt x="1259906" y="1069282"/>
                    </a:cubicBezTo>
                    <a:cubicBezTo>
                      <a:pt x="1258913" y="1072261"/>
                      <a:pt x="1258889" y="1075766"/>
                      <a:pt x="1256928" y="1078218"/>
                    </a:cubicBezTo>
                    <a:cubicBezTo>
                      <a:pt x="1243747" y="1094695"/>
                      <a:pt x="1198329" y="1081415"/>
                      <a:pt x="1194379" y="1081196"/>
                    </a:cubicBezTo>
                    <a:cubicBezTo>
                      <a:pt x="1191401" y="1079210"/>
                      <a:pt x="1188646" y="1076840"/>
                      <a:pt x="1185444" y="1075239"/>
                    </a:cubicBezTo>
                    <a:cubicBezTo>
                      <a:pt x="1178640" y="1071837"/>
                      <a:pt x="1168405" y="1070979"/>
                      <a:pt x="1161616" y="1069282"/>
                    </a:cubicBezTo>
                    <a:cubicBezTo>
                      <a:pt x="1158570" y="1068521"/>
                      <a:pt x="1155659" y="1067297"/>
                      <a:pt x="1152680" y="1066304"/>
                    </a:cubicBezTo>
                    <a:cubicBezTo>
                      <a:pt x="1139773" y="1067297"/>
                      <a:pt x="1126316" y="1065421"/>
                      <a:pt x="1113960" y="1069282"/>
                    </a:cubicBezTo>
                    <a:cubicBezTo>
                      <a:pt x="1109222" y="1070763"/>
                      <a:pt x="1108255" y="1077427"/>
                      <a:pt x="1105024" y="1081196"/>
                    </a:cubicBezTo>
                    <a:cubicBezTo>
                      <a:pt x="1102283" y="1084394"/>
                      <a:pt x="1099067" y="1087153"/>
                      <a:pt x="1096089" y="1090132"/>
                    </a:cubicBezTo>
                    <a:cubicBezTo>
                      <a:pt x="1089715" y="1109251"/>
                      <a:pt x="1098508" y="1088527"/>
                      <a:pt x="1081196" y="1108003"/>
                    </a:cubicBezTo>
                    <a:cubicBezTo>
                      <a:pt x="1068323" y="1122486"/>
                      <a:pt x="1071145" y="1126369"/>
                      <a:pt x="1060347" y="1140766"/>
                    </a:cubicBezTo>
                    <a:cubicBezTo>
                      <a:pt x="1057820" y="1144136"/>
                      <a:pt x="1054390" y="1146723"/>
                      <a:pt x="1051411" y="1149702"/>
                    </a:cubicBezTo>
                    <a:cubicBezTo>
                      <a:pt x="1042475" y="1148709"/>
                      <a:pt x="1033326" y="1148904"/>
                      <a:pt x="1024604" y="1146723"/>
                    </a:cubicBezTo>
                    <a:cubicBezTo>
                      <a:pt x="1021131" y="1145855"/>
                      <a:pt x="1018344" y="1143144"/>
                      <a:pt x="1015669" y="1140766"/>
                    </a:cubicBezTo>
                    <a:cubicBezTo>
                      <a:pt x="1009373" y="1135169"/>
                      <a:pt x="1005790" y="1125559"/>
                      <a:pt x="997798" y="1122895"/>
                    </a:cubicBezTo>
                    <a:lnTo>
                      <a:pt x="979927" y="1116938"/>
                    </a:lnTo>
                    <a:cubicBezTo>
                      <a:pt x="949023" y="1137540"/>
                      <a:pt x="995257" y="1104584"/>
                      <a:pt x="965034" y="1134809"/>
                    </a:cubicBezTo>
                    <a:cubicBezTo>
                      <a:pt x="962814" y="1137029"/>
                      <a:pt x="959211" y="1137373"/>
                      <a:pt x="956099" y="1137788"/>
                    </a:cubicBezTo>
                    <a:cubicBezTo>
                      <a:pt x="944249" y="1139368"/>
                      <a:pt x="932271" y="1139773"/>
                      <a:pt x="920357" y="1140766"/>
                    </a:cubicBezTo>
                    <a:cubicBezTo>
                      <a:pt x="911422" y="1167572"/>
                      <a:pt x="921350" y="1153673"/>
                      <a:pt x="905464" y="1161616"/>
                    </a:cubicBezTo>
                    <a:cubicBezTo>
                      <a:pt x="902262" y="1163217"/>
                      <a:pt x="899507" y="1165587"/>
                      <a:pt x="896529" y="1167573"/>
                    </a:cubicBezTo>
                    <a:cubicBezTo>
                      <a:pt x="892762" y="1166820"/>
                      <a:pt x="877630" y="1164433"/>
                      <a:pt x="872701" y="1161616"/>
                    </a:cubicBezTo>
                    <a:cubicBezTo>
                      <a:pt x="847458" y="1147191"/>
                      <a:pt x="872338" y="1156529"/>
                      <a:pt x="851851" y="1149702"/>
                    </a:cubicBezTo>
                    <a:cubicBezTo>
                      <a:pt x="850858" y="1146723"/>
                      <a:pt x="851325" y="1142727"/>
                      <a:pt x="848873" y="1140766"/>
                    </a:cubicBezTo>
                    <a:cubicBezTo>
                      <a:pt x="845677" y="1138209"/>
                      <a:pt x="840895" y="1138913"/>
                      <a:pt x="836959" y="1137788"/>
                    </a:cubicBezTo>
                    <a:cubicBezTo>
                      <a:pt x="809875" y="1130050"/>
                      <a:pt x="853026" y="1136595"/>
                      <a:pt x="786324" y="1131831"/>
                    </a:cubicBezTo>
                    <a:cubicBezTo>
                      <a:pt x="781360" y="1130838"/>
                      <a:pt x="775827" y="1131364"/>
                      <a:pt x="771432" y="1128852"/>
                    </a:cubicBezTo>
                    <a:cubicBezTo>
                      <a:pt x="768324" y="1127076"/>
                      <a:pt x="768006" y="1122448"/>
                      <a:pt x="765475" y="1119917"/>
                    </a:cubicBezTo>
                    <a:cubicBezTo>
                      <a:pt x="762944" y="1117386"/>
                      <a:pt x="759518" y="1115946"/>
                      <a:pt x="756539" y="1113960"/>
                    </a:cubicBezTo>
                    <a:cubicBezTo>
                      <a:pt x="751575" y="1116938"/>
                      <a:pt x="746556" y="1119827"/>
                      <a:pt x="741647" y="1122895"/>
                    </a:cubicBezTo>
                    <a:cubicBezTo>
                      <a:pt x="738611" y="1124792"/>
                      <a:pt x="735840" y="1127113"/>
                      <a:pt x="732711" y="1128852"/>
                    </a:cubicBezTo>
                    <a:cubicBezTo>
                      <a:pt x="726889" y="1132087"/>
                      <a:pt x="720926" y="1135083"/>
                      <a:pt x="714840" y="1137788"/>
                    </a:cubicBezTo>
                    <a:cubicBezTo>
                      <a:pt x="711971" y="1139063"/>
                      <a:pt x="709037" y="1140557"/>
                      <a:pt x="705905" y="1140766"/>
                    </a:cubicBezTo>
                    <a:cubicBezTo>
                      <a:pt x="679139" y="1142550"/>
                      <a:pt x="652292" y="1142752"/>
                      <a:pt x="625485" y="1143745"/>
                    </a:cubicBezTo>
                    <a:cubicBezTo>
                      <a:pt x="613887" y="1145678"/>
                      <a:pt x="586274" y="1150082"/>
                      <a:pt x="577829" y="1152680"/>
                    </a:cubicBezTo>
                    <a:cubicBezTo>
                      <a:pt x="574408" y="1153733"/>
                      <a:pt x="572165" y="1157183"/>
                      <a:pt x="568894" y="1158637"/>
                    </a:cubicBezTo>
                    <a:cubicBezTo>
                      <a:pt x="563156" y="1161187"/>
                      <a:pt x="551023" y="1164594"/>
                      <a:pt x="551023" y="1164594"/>
                    </a:cubicBezTo>
                    <a:cubicBezTo>
                      <a:pt x="548044" y="1166580"/>
                      <a:pt x="544837" y="1168259"/>
                      <a:pt x="542087" y="1170551"/>
                    </a:cubicBezTo>
                    <a:cubicBezTo>
                      <a:pt x="538851" y="1173248"/>
                      <a:pt x="536657" y="1177150"/>
                      <a:pt x="533152" y="1179487"/>
                    </a:cubicBezTo>
                    <a:cubicBezTo>
                      <a:pt x="530540" y="1181229"/>
                      <a:pt x="527195" y="1181472"/>
                      <a:pt x="524216" y="1182465"/>
                    </a:cubicBezTo>
                    <a:cubicBezTo>
                      <a:pt x="522230" y="1185444"/>
                      <a:pt x="521054" y="1189165"/>
                      <a:pt x="518259" y="1191401"/>
                    </a:cubicBezTo>
                    <a:cubicBezTo>
                      <a:pt x="515808" y="1193362"/>
                      <a:pt x="512210" y="1193142"/>
                      <a:pt x="509324" y="1194379"/>
                    </a:cubicBezTo>
                    <a:cubicBezTo>
                      <a:pt x="505243" y="1196128"/>
                      <a:pt x="501175" y="1197983"/>
                      <a:pt x="497410" y="1200336"/>
                    </a:cubicBezTo>
                    <a:cubicBezTo>
                      <a:pt x="493200" y="1202967"/>
                      <a:pt x="489936" y="1207052"/>
                      <a:pt x="485496" y="1209272"/>
                    </a:cubicBezTo>
                    <a:cubicBezTo>
                      <a:pt x="479880" y="1212080"/>
                      <a:pt x="472850" y="1211746"/>
                      <a:pt x="467625" y="1215229"/>
                    </a:cubicBezTo>
                    <a:cubicBezTo>
                      <a:pt x="456077" y="1222927"/>
                      <a:pt x="462085" y="1220054"/>
                      <a:pt x="449754" y="1224164"/>
                    </a:cubicBezTo>
                    <a:cubicBezTo>
                      <a:pt x="443578" y="1242690"/>
                      <a:pt x="452255" y="1224241"/>
                      <a:pt x="431883" y="1239057"/>
                    </a:cubicBezTo>
                    <a:cubicBezTo>
                      <a:pt x="425070" y="1244012"/>
                      <a:pt x="420590" y="1251665"/>
                      <a:pt x="414012" y="1256928"/>
                    </a:cubicBezTo>
                    <a:cubicBezTo>
                      <a:pt x="392541" y="1274105"/>
                      <a:pt x="403614" y="1264347"/>
                      <a:pt x="381248" y="1286713"/>
                    </a:cubicBezTo>
                    <a:lnTo>
                      <a:pt x="363377" y="1304584"/>
                    </a:lnTo>
                    <a:cubicBezTo>
                      <a:pt x="345334" y="1331647"/>
                      <a:pt x="373614" y="1288922"/>
                      <a:pt x="348485" y="1328412"/>
                    </a:cubicBezTo>
                    <a:cubicBezTo>
                      <a:pt x="344641" y="1334452"/>
                      <a:pt x="340542" y="1340326"/>
                      <a:pt x="336571" y="1346283"/>
                    </a:cubicBezTo>
                    <a:cubicBezTo>
                      <a:pt x="334585" y="1349261"/>
                      <a:pt x="333592" y="1353232"/>
                      <a:pt x="330614" y="1355218"/>
                    </a:cubicBezTo>
                    <a:lnTo>
                      <a:pt x="321678" y="1361175"/>
                    </a:lnTo>
                    <a:cubicBezTo>
                      <a:pt x="316650" y="1376261"/>
                      <a:pt x="319954" y="1368963"/>
                      <a:pt x="306786" y="1387982"/>
                    </a:cubicBezTo>
                    <a:cubicBezTo>
                      <a:pt x="291181" y="1410522"/>
                      <a:pt x="297076" y="1403648"/>
                      <a:pt x="282958" y="1417767"/>
                    </a:cubicBezTo>
                    <a:cubicBezTo>
                      <a:pt x="276127" y="1438255"/>
                      <a:pt x="286098" y="1413997"/>
                      <a:pt x="268065" y="1435638"/>
                    </a:cubicBezTo>
                    <a:cubicBezTo>
                      <a:pt x="266055" y="1438050"/>
                      <a:pt x="266828" y="1441961"/>
                      <a:pt x="265087" y="1444573"/>
                    </a:cubicBezTo>
                    <a:cubicBezTo>
                      <a:pt x="262750" y="1448078"/>
                      <a:pt x="256151" y="1453509"/>
                      <a:pt x="256151" y="1453509"/>
                    </a:cubicBezTo>
                  </a:path>
                </a:pathLst>
              </a:cu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フリーフォーム: 図形 15">
                <a:extLst>
                  <a:ext uri="{FF2B5EF4-FFF2-40B4-BE49-F238E27FC236}">
                    <a16:creationId xmlns:a16="http://schemas.microsoft.com/office/drawing/2014/main" id="{56AFC0CB-3374-4454-9AED-6434B2F3CE67}"/>
                  </a:ext>
                </a:extLst>
              </p:cNvPr>
              <p:cNvSpPr/>
              <p:nvPr/>
            </p:nvSpPr>
            <p:spPr>
              <a:xfrm>
                <a:off x="6147627" y="765475"/>
                <a:ext cx="1316498" cy="1498186"/>
              </a:xfrm>
              <a:custGeom>
                <a:avLst/>
                <a:gdLst>
                  <a:gd name="connsiteX0" fmla="*/ 1316498 w 1316498"/>
                  <a:gd name="connsiteY0" fmla="*/ 1429681 h 1498186"/>
                  <a:gd name="connsiteX1" fmla="*/ 1313520 w 1316498"/>
                  <a:gd name="connsiteY1" fmla="*/ 1447552 h 1498186"/>
                  <a:gd name="connsiteX2" fmla="*/ 1304584 w 1316498"/>
                  <a:gd name="connsiteY2" fmla="*/ 1450530 h 1498186"/>
                  <a:gd name="connsiteX3" fmla="*/ 1295649 w 1316498"/>
                  <a:gd name="connsiteY3" fmla="*/ 1456487 h 1498186"/>
                  <a:gd name="connsiteX4" fmla="*/ 1268842 w 1316498"/>
                  <a:gd name="connsiteY4" fmla="*/ 1462444 h 1498186"/>
                  <a:gd name="connsiteX5" fmla="*/ 1259907 w 1316498"/>
                  <a:gd name="connsiteY5" fmla="*/ 1465423 h 1498186"/>
                  <a:gd name="connsiteX6" fmla="*/ 1245014 w 1316498"/>
                  <a:gd name="connsiteY6" fmla="*/ 1456487 h 1498186"/>
                  <a:gd name="connsiteX7" fmla="*/ 1236079 w 1316498"/>
                  <a:gd name="connsiteY7" fmla="*/ 1450530 h 1498186"/>
                  <a:gd name="connsiteX8" fmla="*/ 1224165 w 1316498"/>
                  <a:gd name="connsiteY8" fmla="*/ 1432659 h 1498186"/>
                  <a:gd name="connsiteX9" fmla="*/ 1215229 w 1316498"/>
                  <a:gd name="connsiteY9" fmla="*/ 1423724 h 1498186"/>
                  <a:gd name="connsiteX10" fmla="*/ 1212251 w 1316498"/>
                  <a:gd name="connsiteY10" fmla="*/ 1414788 h 1498186"/>
                  <a:gd name="connsiteX11" fmla="*/ 1194380 w 1316498"/>
                  <a:gd name="connsiteY11" fmla="*/ 1399896 h 1498186"/>
                  <a:gd name="connsiteX12" fmla="*/ 1188423 w 1316498"/>
                  <a:gd name="connsiteY12" fmla="*/ 1390960 h 1498186"/>
                  <a:gd name="connsiteX13" fmla="*/ 1179487 w 1316498"/>
                  <a:gd name="connsiteY13" fmla="*/ 1382025 h 1498186"/>
                  <a:gd name="connsiteX14" fmla="*/ 1176509 w 1316498"/>
                  <a:gd name="connsiteY14" fmla="*/ 1373089 h 1498186"/>
                  <a:gd name="connsiteX15" fmla="*/ 1158637 w 1316498"/>
                  <a:gd name="connsiteY15" fmla="*/ 1364154 h 1498186"/>
                  <a:gd name="connsiteX16" fmla="*/ 1128852 w 1316498"/>
                  <a:gd name="connsiteY16" fmla="*/ 1352240 h 1498186"/>
                  <a:gd name="connsiteX17" fmla="*/ 1119917 w 1316498"/>
                  <a:gd name="connsiteY17" fmla="*/ 1349261 h 1498186"/>
                  <a:gd name="connsiteX18" fmla="*/ 1102046 w 1316498"/>
                  <a:gd name="connsiteY18" fmla="*/ 1340326 h 1498186"/>
                  <a:gd name="connsiteX19" fmla="*/ 1084175 w 1316498"/>
                  <a:gd name="connsiteY19" fmla="*/ 1337347 h 1498186"/>
                  <a:gd name="connsiteX20" fmla="*/ 1072261 w 1316498"/>
                  <a:gd name="connsiteY20" fmla="*/ 1331390 h 1498186"/>
                  <a:gd name="connsiteX21" fmla="*/ 1063325 w 1316498"/>
                  <a:gd name="connsiteY21" fmla="*/ 1325433 h 1498186"/>
                  <a:gd name="connsiteX22" fmla="*/ 1033540 w 1316498"/>
                  <a:gd name="connsiteY22" fmla="*/ 1313519 h 1498186"/>
                  <a:gd name="connsiteX23" fmla="*/ 1024605 w 1316498"/>
                  <a:gd name="connsiteY23" fmla="*/ 1307562 h 1498186"/>
                  <a:gd name="connsiteX24" fmla="*/ 1003755 w 1316498"/>
                  <a:gd name="connsiteY24" fmla="*/ 1301605 h 1498186"/>
                  <a:gd name="connsiteX25" fmla="*/ 994820 w 1316498"/>
                  <a:gd name="connsiteY25" fmla="*/ 1298627 h 1498186"/>
                  <a:gd name="connsiteX26" fmla="*/ 979927 w 1316498"/>
                  <a:gd name="connsiteY26" fmla="*/ 1280756 h 1498186"/>
                  <a:gd name="connsiteX27" fmla="*/ 968013 w 1316498"/>
                  <a:gd name="connsiteY27" fmla="*/ 1277777 h 1498186"/>
                  <a:gd name="connsiteX28" fmla="*/ 956099 w 1316498"/>
                  <a:gd name="connsiteY28" fmla="*/ 1256928 h 1498186"/>
                  <a:gd name="connsiteX29" fmla="*/ 938228 w 1316498"/>
                  <a:gd name="connsiteY29" fmla="*/ 1247992 h 1498186"/>
                  <a:gd name="connsiteX30" fmla="*/ 926314 w 1316498"/>
                  <a:gd name="connsiteY30" fmla="*/ 1239057 h 1498186"/>
                  <a:gd name="connsiteX31" fmla="*/ 914400 w 1316498"/>
                  <a:gd name="connsiteY31" fmla="*/ 1233100 h 1498186"/>
                  <a:gd name="connsiteX32" fmla="*/ 905465 w 1316498"/>
                  <a:gd name="connsiteY32" fmla="*/ 1224164 h 1498186"/>
                  <a:gd name="connsiteX33" fmla="*/ 875680 w 1316498"/>
                  <a:gd name="connsiteY33" fmla="*/ 1203315 h 1498186"/>
                  <a:gd name="connsiteX34" fmla="*/ 842916 w 1316498"/>
                  <a:gd name="connsiteY34" fmla="*/ 1173530 h 1498186"/>
                  <a:gd name="connsiteX35" fmla="*/ 828024 w 1316498"/>
                  <a:gd name="connsiteY35" fmla="*/ 1146723 h 1498186"/>
                  <a:gd name="connsiteX36" fmla="*/ 804196 w 1316498"/>
                  <a:gd name="connsiteY36" fmla="*/ 1113960 h 1498186"/>
                  <a:gd name="connsiteX37" fmla="*/ 795260 w 1316498"/>
                  <a:gd name="connsiteY37" fmla="*/ 1108003 h 1498186"/>
                  <a:gd name="connsiteX38" fmla="*/ 750583 w 1316498"/>
                  <a:gd name="connsiteY38" fmla="*/ 1110981 h 1498186"/>
                  <a:gd name="connsiteX39" fmla="*/ 741647 w 1316498"/>
                  <a:gd name="connsiteY39" fmla="*/ 1113960 h 1498186"/>
                  <a:gd name="connsiteX40" fmla="*/ 726755 w 1316498"/>
                  <a:gd name="connsiteY40" fmla="*/ 1116938 h 1498186"/>
                  <a:gd name="connsiteX41" fmla="*/ 717819 w 1316498"/>
                  <a:gd name="connsiteY41" fmla="*/ 1122895 h 1498186"/>
                  <a:gd name="connsiteX42" fmla="*/ 702927 w 1316498"/>
                  <a:gd name="connsiteY42" fmla="*/ 1125874 h 1498186"/>
                  <a:gd name="connsiteX43" fmla="*/ 693991 w 1316498"/>
                  <a:gd name="connsiteY43" fmla="*/ 1134809 h 1498186"/>
                  <a:gd name="connsiteX44" fmla="*/ 676120 w 1316498"/>
                  <a:gd name="connsiteY44" fmla="*/ 1140766 h 1498186"/>
                  <a:gd name="connsiteX45" fmla="*/ 664206 w 1316498"/>
                  <a:gd name="connsiteY45" fmla="*/ 1149702 h 1498186"/>
                  <a:gd name="connsiteX46" fmla="*/ 646335 w 1316498"/>
                  <a:gd name="connsiteY46" fmla="*/ 1152680 h 1498186"/>
                  <a:gd name="connsiteX47" fmla="*/ 634421 w 1316498"/>
                  <a:gd name="connsiteY47" fmla="*/ 1155659 h 1498186"/>
                  <a:gd name="connsiteX48" fmla="*/ 559959 w 1316498"/>
                  <a:gd name="connsiteY48" fmla="*/ 1158637 h 1498186"/>
                  <a:gd name="connsiteX49" fmla="*/ 554002 w 1316498"/>
                  <a:gd name="connsiteY49" fmla="*/ 1167573 h 1498186"/>
                  <a:gd name="connsiteX50" fmla="*/ 545066 w 1316498"/>
                  <a:gd name="connsiteY50" fmla="*/ 1170551 h 1498186"/>
                  <a:gd name="connsiteX51" fmla="*/ 536131 w 1316498"/>
                  <a:gd name="connsiteY51" fmla="*/ 1176508 h 1498186"/>
                  <a:gd name="connsiteX52" fmla="*/ 533152 w 1316498"/>
                  <a:gd name="connsiteY52" fmla="*/ 1185444 h 1498186"/>
                  <a:gd name="connsiteX53" fmla="*/ 503367 w 1316498"/>
                  <a:gd name="connsiteY53" fmla="*/ 1194379 h 1498186"/>
                  <a:gd name="connsiteX54" fmla="*/ 491453 w 1316498"/>
                  <a:gd name="connsiteY54" fmla="*/ 1203315 h 1498186"/>
                  <a:gd name="connsiteX55" fmla="*/ 455711 w 1316498"/>
                  <a:gd name="connsiteY55" fmla="*/ 1209272 h 1498186"/>
                  <a:gd name="connsiteX56" fmla="*/ 434862 w 1316498"/>
                  <a:gd name="connsiteY56" fmla="*/ 1206293 h 1498186"/>
                  <a:gd name="connsiteX57" fmla="*/ 431883 w 1316498"/>
                  <a:gd name="connsiteY57" fmla="*/ 1191401 h 1498186"/>
                  <a:gd name="connsiteX58" fmla="*/ 422948 w 1316498"/>
                  <a:gd name="connsiteY58" fmla="*/ 1182465 h 1498186"/>
                  <a:gd name="connsiteX59" fmla="*/ 408055 w 1316498"/>
                  <a:gd name="connsiteY59" fmla="*/ 1161616 h 1498186"/>
                  <a:gd name="connsiteX60" fmla="*/ 402098 w 1316498"/>
                  <a:gd name="connsiteY60" fmla="*/ 1146723 h 1498186"/>
                  <a:gd name="connsiteX61" fmla="*/ 396141 w 1316498"/>
                  <a:gd name="connsiteY61" fmla="*/ 1128852 h 1498186"/>
                  <a:gd name="connsiteX62" fmla="*/ 384227 w 1316498"/>
                  <a:gd name="connsiteY62" fmla="*/ 1119917 h 1498186"/>
                  <a:gd name="connsiteX63" fmla="*/ 375292 w 1316498"/>
                  <a:gd name="connsiteY63" fmla="*/ 1096089 h 1498186"/>
                  <a:gd name="connsiteX64" fmla="*/ 372313 w 1316498"/>
                  <a:gd name="connsiteY64" fmla="*/ 1087153 h 1498186"/>
                  <a:gd name="connsiteX65" fmla="*/ 366356 w 1316498"/>
                  <a:gd name="connsiteY65" fmla="*/ 1078218 h 1498186"/>
                  <a:gd name="connsiteX66" fmla="*/ 360399 w 1316498"/>
                  <a:gd name="connsiteY66" fmla="*/ 1066304 h 1498186"/>
                  <a:gd name="connsiteX67" fmla="*/ 354442 w 1316498"/>
                  <a:gd name="connsiteY67" fmla="*/ 1060346 h 1498186"/>
                  <a:gd name="connsiteX68" fmla="*/ 348485 w 1316498"/>
                  <a:gd name="connsiteY68" fmla="*/ 1051411 h 1498186"/>
                  <a:gd name="connsiteX69" fmla="*/ 303808 w 1316498"/>
                  <a:gd name="connsiteY69" fmla="*/ 1054389 h 1498186"/>
                  <a:gd name="connsiteX70" fmla="*/ 277001 w 1316498"/>
                  <a:gd name="connsiteY70" fmla="*/ 1063325 h 1498186"/>
                  <a:gd name="connsiteX71" fmla="*/ 268066 w 1316498"/>
                  <a:gd name="connsiteY71" fmla="*/ 1069282 h 1498186"/>
                  <a:gd name="connsiteX72" fmla="*/ 217431 w 1316498"/>
                  <a:gd name="connsiteY72" fmla="*/ 1075239 h 1498186"/>
                  <a:gd name="connsiteX73" fmla="*/ 214452 w 1316498"/>
                  <a:gd name="connsiteY73" fmla="*/ 1084175 h 1498186"/>
                  <a:gd name="connsiteX74" fmla="*/ 220409 w 1316498"/>
                  <a:gd name="connsiteY74" fmla="*/ 1119917 h 1498186"/>
                  <a:gd name="connsiteX75" fmla="*/ 223388 w 1316498"/>
                  <a:gd name="connsiteY75" fmla="*/ 1155659 h 1498186"/>
                  <a:gd name="connsiteX76" fmla="*/ 226366 w 1316498"/>
                  <a:gd name="connsiteY76" fmla="*/ 1173530 h 1498186"/>
                  <a:gd name="connsiteX77" fmla="*/ 229345 w 1316498"/>
                  <a:gd name="connsiteY77" fmla="*/ 1182465 h 1498186"/>
                  <a:gd name="connsiteX78" fmla="*/ 247216 w 1316498"/>
                  <a:gd name="connsiteY78" fmla="*/ 1194379 h 1498186"/>
                  <a:gd name="connsiteX79" fmla="*/ 256152 w 1316498"/>
                  <a:gd name="connsiteY79" fmla="*/ 1200336 h 1498186"/>
                  <a:gd name="connsiteX80" fmla="*/ 262109 w 1316498"/>
                  <a:gd name="connsiteY80" fmla="*/ 1209272 h 1498186"/>
                  <a:gd name="connsiteX81" fmla="*/ 279980 w 1316498"/>
                  <a:gd name="connsiteY81" fmla="*/ 1218207 h 1498186"/>
                  <a:gd name="connsiteX82" fmla="*/ 285937 w 1316498"/>
                  <a:gd name="connsiteY82" fmla="*/ 1227143 h 1498186"/>
                  <a:gd name="connsiteX83" fmla="*/ 336571 w 1316498"/>
                  <a:gd name="connsiteY83" fmla="*/ 1239057 h 1498186"/>
                  <a:gd name="connsiteX84" fmla="*/ 351464 w 1316498"/>
                  <a:gd name="connsiteY84" fmla="*/ 1268842 h 1498186"/>
                  <a:gd name="connsiteX85" fmla="*/ 357421 w 1316498"/>
                  <a:gd name="connsiteY85" fmla="*/ 1289691 h 1498186"/>
                  <a:gd name="connsiteX86" fmla="*/ 366356 w 1316498"/>
                  <a:gd name="connsiteY86" fmla="*/ 1298627 h 1498186"/>
                  <a:gd name="connsiteX87" fmla="*/ 381249 w 1316498"/>
                  <a:gd name="connsiteY87" fmla="*/ 1316498 h 1498186"/>
                  <a:gd name="connsiteX88" fmla="*/ 393163 w 1316498"/>
                  <a:gd name="connsiteY88" fmla="*/ 1331390 h 1498186"/>
                  <a:gd name="connsiteX89" fmla="*/ 396141 w 1316498"/>
                  <a:gd name="connsiteY89" fmla="*/ 1343304 h 1498186"/>
                  <a:gd name="connsiteX90" fmla="*/ 422948 w 1316498"/>
                  <a:gd name="connsiteY90" fmla="*/ 1355218 h 1498186"/>
                  <a:gd name="connsiteX91" fmla="*/ 428905 w 1316498"/>
                  <a:gd name="connsiteY91" fmla="*/ 1364154 h 1498186"/>
                  <a:gd name="connsiteX92" fmla="*/ 437840 w 1316498"/>
                  <a:gd name="connsiteY92" fmla="*/ 1367132 h 1498186"/>
                  <a:gd name="connsiteX93" fmla="*/ 458690 w 1316498"/>
                  <a:gd name="connsiteY93" fmla="*/ 1376068 h 1498186"/>
                  <a:gd name="connsiteX94" fmla="*/ 464647 w 1316498"/>
                  <a:gd name="connsiteY94" fmla="*/ 1385003 h 1498186"/>
                  <a:gd name="connsiteX95" fmla="*/ 488475 w 1316498"/>
                  <a:gd name="connsiteY95" fmla="*/ 1390960 h 1498186"/>
                  <a:gd name="connsiteX96" fmla="*/ 479539 w 1316498"/>
                  <a:gd name="connsiteY96" fmla="*/ 1393939 h 1498186"/>
                  <a:gd name="connsiteX97" fmla="*/ 470604 w 1316498"/>
                  <a:gd name="connsiteY97" fmla="*/ 1399896 h 1498186"/>
                  <a:gd name="connsiteX98" fmla="*/ 458690 w 1316498"/>
                  <a:gd name="connsiteY98" fmla="*/ 1402874 h 1498186"/>
                  <a:gd name="connsiteX99" fmla="*/ 428905 w 1316498"/>
                  <a:gd name="connsiteY99" fmla="*/ 1411810 h 1498186"/>
                  <a:gd name="connsiteX100" fmla="*/ 405077 w 1316498"/>
                  <a:gd name="connsiteY100" fmla="*/ 1405853 h 1498186"/>
                  <a:gd name="connsiteX101" fmla="*/ 396141 w 1316498"/>
                  <a:gd name="connsiteY101" fmla="*/ 1402874 h 1498186"/>
                  <a:gd name="connsiteX102" fmla="*/ 369335 w 1316498"/>
                  <a:gd name="connsiteY102" fmla="*/ 1385003 h 1498186"/>
                  <a:gd name="connsiteX103" fmla="*/ 360399 w 1316498"/>
                  <a:gd name="connsiteY103" fmla="*/ 1379046 h 1498186"/>
                  <a:gd name="connsiteX104" fmla="*/ 342528 w 1316498"/>
                  <a:gd name="connsiteY104" fmla="*/ 1367132 h 1498186"/>
                  <a:gd name="connsiteX105" fmla="*/ 336571 w 1316498"/>
                  <a:gd name="connsiteY105" fmla="*/ 1358197 h 1498186"/>
                  <a:gd name="connsiteX106" fmla="*/ 300829 w 1316498"/>
                  <a:gd name="connsiteY106" fmla="*/ 1358197 h 1498186"/>
                  <a:gd name="connsiteX107" fmla="*/ 274023 w 1316498"/>
                  <a:gd name="connsiteY107" fmla="*/ 1370111 h 1498186"/>
                  <a:gd name="connsiteX108" fmla="*/ 265087 w 1316498"/>
                  <a:gd name="connsiteY108" fmla="*/ 1376068 h 1498186"/>
                  <a:gd name="connsiteX109" fmla="*/ 241259 w 1316498"/>
                  <a:gd name="connsiteY109" fmla="*/ 1382025 h 1498186"/>
                  <a:gd name="connsiteX110" fmla="*/ 208495 w 1316498"/>
                  <a:gd name="connsiteY110" fmla="*/ 1399896 h 1498186"/>
                  <a:gd name="connsiteX111" fmla="*/ 199560 w 1316498"/>
                  <a:gd name="connsiteY111" fmla="*/ 1408831 h 1498186"/>
                  <a:gd name="connsiteX112" fmla="*/ 181689 w 1316498"/>
                  <a:gd name="connsiteY112" fmla="*/ 1414788 h 1498186"/>
                  <a:gd name="connsiteX113" fmla="*/ 172753 w 1316498"/>
                  <a:gd name="connsiteY113" fmla="*/ 1420745 h 1498186"/>
                  <a:gd name="connsiteX114" fmla="*/ 160839 w 1316498"/>
                  <a:gd name="connsiteY114" fmla="*/ 1426702 h 1498186"/>
                  <a:gd name="connsiteX115" fmla="*/ 154882 w 1316498"/>
                  <a:gd name="connsiteY115" fmla="*/ 1435638 h 1498186"/>
                  <a:gd name="connsiteX116" fmla="*/ 145947 w 1316498"/>
                  <a:gd name="connsiteY116" fmla="*/ 1444573 h 1498186"/>
                  <a:gd name="connsiteX117" fmla="*/ 134033 w 1316498"/>
                  <a:gd name="connsiteY117" fmla="*/ 1450530 h 1498186"/>
                  <a:gd name="connsiteX118" fmla="*/ 125097 w 1316498"/>
                  <a:gd name="connsiteY118" fmla="*/ 1456487 h 1498186"/>
                  <a:gd name="connsiteX119" fmla="*/ 107226 w 1316498"/>
                  <a:gd name="connsiteY119" fmla="*/ 1468401 h 1498186"/>
                  <a:gd name="connsiteX120" fmla="*/ 86377 w 1316498"/>
                  <a:gd name="connsiteY120" fmla="*/ 1483294 h 1498186"/>
                  <a:gd name="connsiteX121" fmla="*/ 68506 w 1316498"/>
                  <a:gd name="connsiteY121" fmla="*/ 1489251 h 1498186"/>
                  <a:gd name="connsiteX122" fmla="*/ 47656 w 1316498"/>
                  <a:gd name="connsiteY122" fmla="*/ 1498186 h 1498186"/>
                  <a:gd name="connsiteX123" fmla="*/ 38721 w 1316498"/>
                  <a:gd name="connsiteY123" fmla="*/ 1489251 h 1498186"/>
                  <a:gd name="connsiteX124" fmla="*/ 32764 w 1316498"/>
                  <a:gd name="connsiteY124" fmla="*/ 1468401 h 1498186"/>
                  <a:gd name="connsiteX125" fmla="*/ 23828 w 1316498"/>
                  <a:gd name="connsiteY125" fmla="*/ 1450530 h 1498186"/>
                  <a:gd name="connsiteX126" fmla="*/ 20850 w 1316498"/>
                  <a:gd name="connsiteY126" fmla="*/ 1432659 h 1498186"/>
                  <a:gd name="connsiteX127" fmla="*/ 17871 w 1316498"/>
                  <a:gd name="connsiteY127" fmla="*/ 1423724 h 1498186"/>
                  <a:gd name="connsiteX128" fmla="*/ 14893 w 1316498"/>
                  <a:gd name="connsiteY128" fmla="*/ 1402874 h 1498186"/>
                  <a:gd name="connsiteX129" fmla="*/ 20850 w 1316498"/>
                  <a:gd name="connsiteY129" fmla="*/ 1361175 h 1498186"/>
                  <a:gd name="connsiteX130" fmla="*/ 29785 w 1316498"/>
                  <a:gd name="connsiteY130" fmla="*/ 1352240 h 1498186"/>
                  <a:gd name="connsiteX131" fmla="*/ 32764 w 1316498"/>
                  <a:gd name="connsiteY131" fmla="*/ 1343304 h 1498186"/>
                  <a:gd name="connsiteX132" fmla="*/ 44678 w 1316498"/>
                  <a:gd name="connsiteY132" fmla="*/ 1331390 h 1498186"/>
                  <a:gd name="connsiteX133" fmla="*/ 50635 w 1316498"/>
                  <a:gd name="connsiteY133" fmla="*/ 1322455 h 1498186"/>
                  <a:gd name="connsiteX134" fmla="*/ 53613 w 1316498"/>
                  <a:gd name="connsiteY134" fmla="*/ 1313519 h 1498186"/>
                  <a:gd name="connsiteX135" fmla="*/ 59570 w 1316498"/>
                  <a:gd name="connsiteY135" fmla="*/ 1304584 h 1498186"/>
                  <a:gd name="connsiteX136" fmla="*/ 71484 w 1316498"/>
                  <a:gd name="connsiteY136" fmla="*/ 1283734 h 1498186"/>
                  <a:gd name="connsiteX137" fmla="*/ 77441 w 1316498"/>
                  <a:gd name="connsiteY137" fmla="*/ 1268842 h 1498186"/>
                  <a:gd name="connsiteX138" fmla="*/ 83398 w 1316498"/>
                  <a:gd name="connsiteY138" fmla="*/ 1259906 h 1498186"/>
                  <a:gd name="connsiteX139" fmla="*/ 86377 w 1316498"/>
                  <a:gd name="connsiteY139" fmla="*/ 1250971 h 1498186"/>
                  <a:gd name="connsiteX140" fmla="*/ 95312 w 1316498"/>
                  <a:gd name="connsiteY140" fmla="*/ 1245014 h 1498186"/>
                  <a:gd name="connsiteX141" fmla="*/ 98291 w 1316498"/>
                  <a:gd name="connsiteY141" fmla="*/ 1218207 h 1498186"/>
                  <a:gd name="connsiteX142" fmla="*/ 83398 w 1316498"/>
                  <a:gd name="connsiteY142" fmla="*/ 1215229 h 1498186"/>
                  <a:gd name="connsiteX143" fmla="*/ 59570 w 1316498"/>
                  <a:gd name="connsiteY143" fmla="*/ 1197358 h 1498186"/>
                  <a:gd name="connsiteX144" fmla="*/ 53613 w 1316498"/>
                  <a:gd name="connsiteY144" fmla="*/ 1188422 h 1498186"/>
                  <a:gd name="connsiteX145" fmla="*/ 35742 w 1316498"/>
                  <a:gd name="connsiteY145" fmla="*/ 1176508 h 1498186"/>
                  <a:gd name="connsiteX146" fmla="*/ 23828 w 1316498"/>
                  <a:gd name="connsiteY146" fmla="*/ 1161616 h 1498186"/>
                  <a:gd name="connsiteX147" fmla="*/ 14893 w 1316498"/>
                  <a:gd name="connsiteY147" fmla="*/ 1149702 h 1498186"/>
                  <a:gd name="connsiteX148" fmla="*/ 0 w 1316498"/>
                  <a:gd name="connsiteY148" fmla="*/ 1131831 h 1498186"/>
                  <a:gd name="connsiteX149" fmla="*/ 11914 w 1316498"/>
                  <a:gd name="connsiteY149" fmla="*/ 1099067 h 1498186"/>
                  <a:gd name="connsiteX150" fmla="*/ 14893 w 1316498"/>
                  <a:gd name="connsiteY150" fmla="*/ 1090132 h 1498186"/>
                  <a:gd name="connsiteX151" fmla="*/ 23828 w 1316498"/>
                  <a:gd name="connsiteY151" fmla="*/ 1084175 h 1498186"/>
                  <a:gd name="connsiteX152" fmla="*/ 29785 w 1316498"/>
                  <a:gd name="connsiteY152" fmla="*/ 1075239 h 1498186"/>
                  <a:gd name="connsiteX153" fmla="*/ 32764 w 1316498"/>
                  <a:gd name="connsiteY153" fmla="*/ 1066304 h 1498186"/>
                  <a:gd name="connsiteX154" fmla="*/ 41699 w 1316498"/>
                  <a:gd name="connsiteY154" fmla="*/ 1057368 h 1498186"/>
                  <a:gd name="connsiteX155" fmla="*/ 44678 w 1316498"/>
                  <a:gd name="connsiteY155" fmla="*/ 1045454 h 1498186"/>
                  <a:gd name="connsiteX156" fmla="*/ 59570 w 1316498"/>
                  <a:gd name="connsiteY156" fmla="*/ 1027583 h 1498186"/>
                  <a:gd name="connsiteX157" fmla="*/ 56592 w 1316498"/>
                  <a:gd name="connsiteY157" fmla="*/ 1003755 h 1498186"/>
                  <a:gd name="connsiteX158" fmla="*/ 53613 w 1316498"/>
                  <a:gd name="connsiteY158" fmla="*/ 991841 h 1498186"/>
                  <a:gd name="connsiteX159" fmla="*/ 62549 w 1316498"/>
                  <a:gd name="connsiteY159" fmla="*/ 985884 h 1498186"/>
                  <a:gd name="connsiteX160" fmla="*/ 80420 w 1316498"/>
                  <a:gd name="connsiteY160" fmla="*/ 979927 h 1498186"/>
                  <a:gd name="connsiteX161" fmla="*/ 86377 w 1316498"/>
                  <a:gd name="connsiteY161" fmla="*/ 970991 h 1498186"/>
                  <a:gd name="connsiteX162" fmla="*/ 95312 w 1316498"/>
                  <a:gd name="connsiteY162" fmla="*/ 968013 h 1498186"/>
                  <a:gd name="connsiteX163" fmla="*/ 119140 w 1316498"/>
                  <a:gd name="connsiteY163" fmla="*/ 965034 h 1498186"/>
                  <a:gd name="connsiteX164" fmla="*/ 241259 w 1316498"/>
                  <a:gd name="connsiteY164" fmla="*/ 968013 h 1498186"/>
                  <a:gd name="connsiteX165" fmla="*/ 247216 w 1316498"/>
                  <a:gd name="connsiteY165" fmla="*/ 976948 h 1498186"/>
                  <a:gd name="connsiteX166" fmla="*/ 265087 w 1316498"/>
                  <a:gd name="connsiteY166" fmla="*/ 979927 h 1498186"/>
                  <a:gd name="connsiteX167" fmla="*/ 285937 w 1316498"/>
                  <a:gd name="connsiteY167" fmla="*/ 976948 h 1498186"/>
                  <a:gd name="connsiteX168" fmla="*/ 297851 w 1316498"/>
                  <a:gd name="connsiteY168" fmla="*/ 953120 h 1498186"/>
                  <a:gd name="connsiteX169" fmla="*/ 318700 w 1316498"/>
                  <a:gd name="connsiteY169" fmla="*/ 932271 h 1498186"/>
                  <a:gd name="connsiteX170" fmla="*/ 327636 w 1316498"/>
                  <a:gd name="connsiteY170" fmla="*/ 923335 h 1498186"/>
                  <a:gd name="connsiteX171" fmla="*/ 336571 w 1316498"/>
                  <a:gd name="connsiteY171" fmla="*/ 917378 h 1498186"/>
                  <a:gd name="connsiteX172" fmla="*/ 372313 w 1316498"/>
                  <a:gd name="connsiteY172" fmla="*/ 908443 h 1498186"/>
                  <a:gd name="connsiteX173" fmla="*/ 363378 w 1316498"/>
                  <a:gd name="connsiteY173" fmla="*/ 869722 h 1498186"/>
                  <a:gd name="connsiteX174" fmla="*/ 354442 w 1316498"/>
                  <a:gd name="connsiteY174" fmla="*/ 860787 h 1498186"/>
                  <a:gd name="connsiteX175" fmla="*/ 345507 w 1316498"/>
                  <a:gd name="connsiteY175" fmla="*/ 839937 h 1498186"/>
                  <a:gd name="connsiteX176" fmla="*/ 336571 w 1316498"/>
                  <a:gd name="connsiteY176" fmla="*/ 833980 h 1498186"/>
                  <a:gd name="connsiteX177" fmla="*/ 318700 w 1316498"/>
                  <a:gd name="connsiteY177" fmla="*/ 819088 h 1498186"/>
                  <a:gd name="connsiteX178" fmla="*/ 312743 w 1316498"/>
                  <a:gd name="connsiteY178" fmla="*/ 810152 h 1498186"/>
                  <a:gd name="connsiteX179" fmla="*/ 303808 w 1316498"/>
                  <a:gd name="connsiteY179" fmla="*/ 783346 h 1498186"/>
                  <a:gd name="connsiteX180" fmla="*/ 306786 w 1316498"/>
                  <a:gd name="connsiteY180" fmla="*/ 765475 h 1498186"/>
                  <a:gd name="connsiteX181" fmla="*/ 315722 w 1316498"/>
                  <a:gd name="connsiteY181" fmla="*/ 759518 h 1498186"/>
                  <a:gd name="connsiteX182" fmla="*/ 354442 w 1316498"/>
                  <a:gd name="connsiteY182" fmla="*/ 762496 h 1498186"/>
                  <a:gd name="connsiteX183" fmla="*/ 363378 w 1316498"/>
                  <a:gd name="connsiteY183" fmla="*/ 768453 h 1498186"/>
                  <a:gd name="connsiteX184" fmla="*/ 375292 w 1316498"/>
                  <a:gd name="connsiteY184" fmla="*/ 771432 h 1498186"/>
                  <a:gd name="connsiteX185" fmla="*/ 381249 w 1316498"/>
                  <a:gd name="connsiteY185" fmla="*/ 780367 h 1498186"/>
                  <a:gd name="connsiteX186" fmla="*/ 396141 w 1316498"/>
                  <a:gd name="connsiteY186" fmla="*/ 783346 h 1498186"/>
                  <a:gd name="connsiteX187" fmla="*/ 419969 w 1316498"/>
                  <a:gd name="connsiteY187" fmla="*/ 810152 h 1498186"/>
                  <a:gd name="connsiteX188" fmla="*/ 428905 w 1316498"/>
                  <a:gd name="connsiteY188" fmla="*/ 816109 h 1498186"/>
                  <a:gd name="connsiteX189" fmla="*/ 440819 w 1316498"/>
                  <a:gd name="connsiteY189" fmla="*/ 819088 h 1498186"/>
                  <a:gd name="connsiteX190" fmla="*/ 449754 w 1316498"/>
                  <a:gd name="connsiteY190" fmla="*/ 822066 h 1498186"/>
                  <a:gd name="connsiteX191" fmla="*/ 473582 w 1316498"/>
                  <a:gd name="connsiteY191" fmla="*/ 828023 h 1498186"/>
                  <a:gd name="connsiteX192" fmla="*/ 482518 w 1316498"/>
                  <a:gd name="connsiteY192" fmla="*/ 831002 h 1498186"/>
                  <a:gd name="connsiteX193" fmla="*/ 503367 w 1316498"/>
                  <a:gd name="connsiteY193" fmla="*/ 836959 h 1498186"/>
                  <a:gd name="connsiteX194" fmla="*/ 518260 w 1316498"/>
                  <a:gd name="connsiteY194" fmla="*/ 842916 h 1498186"/>
                  <a:gd name="connsiteX195" fmla="*/ 542088 w 1316498"/>
                  <a:gd name="connsiteY195" fmla="*/ 845894 h 1498186"/>
                  <a:gd name="connsiteX196" fmla="*/ 559959 w 1316498"/>
                  <a:gd name="connsiteY196" fmla="*/ 851851 h 1498186"/>
                  <a:gd name="connsiteX197" fmla="*/ 568894 w 1316498"/>
                  <a:gd name="connsiteY197" fmla="*/ 854830 h 1498186"/>
                  <a:gd name="connsiteX198" fmla="*/ 583787 w 1316498"/>
                  <a:gd name="connsiteY198" fmla="*/ 857808 h 1498186"/>
                  <a:gd name="connsiteX199" fmla="*/ 592722 w 1316498"/>
                  <a:gd name="connsiteY199" fmla="*/ 866744 h 1498186"/>
                  <a:gd name="connsiteX200" fmla="*/ 619529 w 1316498"/>
                  <a:gd name="connsiteY200" fmla="*/ 872701 h 1498186"/>
                  <a:gd name="connsiteX201" fmla="*/ 634421 w 1316498"/>
                  <a:gd name="connsiteY201" fmla="*/ 878658 h 1498186"/>
                  <a:gd name="connsiteX202" fmla="*/ 670163 w 1316498"/>
                  <a:gd name="connsiteY202" fmla="*/ 875679 h 1498186"/>
                  <a:gd name="connsiteX203" fmla="*/ 676120 w 1316498"/>
                  <a:gd name="connsiteY203" fmla="*/ 866744 h 1498186"/>
                  <a:gd name="connsiteX204" fmla="*/ 682077 w 1316498"/>
                  <a:gd name="connsiteY204" fmla="*/ 842916 h 1498186"/>
                  <a:gd name="connsiteX205" fmla="*/ 691013 w 1316498"/>
                  <a:gd name="connsiteY205" fmla="*/ 836959 h 1498186"/>
                  <a:gd name="connsiteX206" fmla="*/ 696970 w 1316498"/>
                  <a:gd name="connsiteY206" fmla="*/ 816109 h 1498186"/>
                  <a:gd name="connsiteX207" fmla="*/ 699948 w 1316498"/>
                  <a:gd name="connsiteY207" fmla="*/ 801217 h 1498186"/>
                  <a:gd name="connsiteX208" fmla="*/ 711862 w 1316498"/>
                  <a:gd name="connsiteY208" fmla="*/ 783346 h 1498186"/>
                  <a:gd name="connsiteX209" fmla="*/ 717819 w 1316498"/>
                  <a:gd name="connsiteY209" fmla="*/ 759518 h 1498186"/>
                  <a:gd name="connsiteX210" fmla="*/ 723776 w 1316498"/>
                  <a:gd name="connsiteY210" fmla="*/ 708883 h 1498186"/>
                  <a:gd name="connsiteX211" fmla="*/ 729733 w 1316498"/>
                  <a:gd name="connsiteY211" fmla="*/ 696969 h 1498186"/>
                  <a:gd name="connsiteX212" fmla="*/ 735690 w 1316498"/>
                  <a:gd name="connsiteY212" fmla="*/ 670163 h 1498186"/>
                  <a:gd name="connsiteX213" fmla="*/ 738669 w 1316498"/>
                  <a:gd name="connsiteY213" fmla="*/ 658249 h 1498186"/>
                  <a:gd name="connsiteX214" fmla="*/ 756540 w 1316498"/>
                  <a:gd name="connsiteY214" fmla="*/ 655270 h 1498186"/>
                  <a:gd name="connsiteX215" fmla="*/ 819088 w 1316498"/>
                  <a:gd name="connsiteY215" fmla="*/ 652292 h 1498186"/>
                  <a:gd name="connsiteX216" fmla="*/ 831002 w 1316498"/>
                  <a:gd name="connsiteY216" fmla="*/ 646335 h 1498186"/>
                  <a:gd name="connsiteX217" fmla="*/ 848873 w 1316498"/>
                  <a:gd name="connsiteY217" fmla="*/ 634421 h 1498186"/>
                  <a:gd name="connsiteX218" fmla="*/ 857809 w 1316498"/>
                  <a:gd name="connsiteY218" fmla="*/ 625485 h 1498186"/>
                  <a:gd name="connsiteX219" fmla="*/ 869723 w 1316498"/>
                  <a:gd name="connsiteY219" fmla="*/ 604636 h 1498186"/>
                  <a:gd name="connsiteX220" fmla="*/ 881637 w 1316498"/>
                  <a:gd name="connsiteY220" fmla="*/ 586765 h 1498186"/>
                  <a:gd name="connsiteX221" fmla="*/ 887594 w 1316498"/>
                  <a:gd name="connsiteY221" fmla="*/ 565915 h 1498186"/>
                  <a:gd name="connsiteX222" fmla="*/ 890572 w 1316498"/>
                  <a:gd name="connsiteY222" fmla="*/ 533152 h 1498186"/>
                  <a:gd name="connsiteX223" fmla="*/ 902486 w 1316498"/>
                  <a:gd name="connsiteY223" fmla="*/ 476560 h 1498186"/>
                  <a:gd name="connsiteX224" fmla="*/ 905465 w 1316498"/>
                  <a:gd name="connsiteY224" fmla="*/ 464646 h 1498186"/>
                  <a:gd name="connsiteX225" fmla="*/ 911422 w 1316498"/>
                  <a:gd name="connsiteY225" fmla="*/ 449754 h 1498186"/>
                  <a:gd name="connsiteX226" fmla="*/ 914400 w 1316498"/>
                  <a:gd name="connsiteY226" fmla="*/ 434861 h 1498186"/>
                  <a:gd name="connsiteX227" fmla="*/ 920357 w 1316498"/>
                  <a:gd name="connsiteY227" fmla="*/ 425926 h 1498186"/>
                  <a:gd name="connsiteX228" fmla="*/ 935250 w 1316498"/>
                  <a:gd name="connsiteY228" fmla="*/ 399119 h 1498186"/>
                  <a:gd name="connsiteX229" fmla="*/ 944185 w 1316498"/>
                  <a:gd name="connsiteY229" fmla="*/ 381248 h 1498186"/>
                  <a:gd name="connsiteX230" fmla="*/ 956099 w 1316498"/>
                  <a:gd name="connsiteY230" fmla="*/ 360399 h 1498186"/>
                  <a:gd name="connsiteX231" fmla="*/ 965035 w 1316498"/>
                  <a:gd name="connsiteY231" fmla="*/ 351463 h 1498186"/>
                  <a:gd name="connsiteX232" fmla="*/ 970992 w 1316498"/>
                  <a:gd name="connsiteY232" fmla="*/ 342528 h 1498186"/>
                  <a:gd name="connsiteX233" fmla="*/ 979927 w 1316498"/>
                  <a:gd name="connsiteY233" fmla="*/ 333592 h 1498186"/>
                  <a:gd name="connsiteX234" fmla="*/ 985884 w 1316498"/>
                  <a:gd name="connsiteY234" fmla="*/ 321678 h 1498186"/>
                  <a:gd name="connsiteX235" fmla="*/ 994820 w 1316498"/>
                  <a:gd name="connsiteY235" fmla="*/ 297850 h 1498186"/>
                  <a:gd name="connsiteX236" fmla="*/ 997798 w 1316498"/>
                  <a:gd name="connsiteY236" fmla="*/ 282958 h 1498186"/>
                  <a:gd name="connsiteX237" fmla="*/ 988863 w 1316498"/>
                  <a:gd name="connsiteY237" fmla="*/ 157861 h 1498186"/>
                  <a:gd name="connsiteX238" fmla="*/ 985884 w 1316498"/>
                  <a:gd name="connsiteY238" fmla="*/ 145946 h 1498186"/>
                  <a:gd name="connsiteX239" fmla="*/ 979927 w 1316498"/>
                  <a:gd name="connsiteY239" fmla="*/ 122118 h 1498186"/>
                  <a:gd name="connsiteX240" fmla="*/ 976949 w 1316498"/>
                  <a:gd name="connsiteY240" fmla="*/ 110204 h 1498186"/>
                  <a:gd name="connsiteX241" fmla="*/ 968013 w 1316498"/>
                  <a:gd name="connsiteY241" fmla="*/ 104247 h 1498186"/>
                  <a:gd name="connsiteX242" fmla="*/ 965035 w 1316498"/>
                  <a:gd name="connsiteY242" fmla="*/ 95312 h 1498186"/>
                  <a:gd name="connsiteX243" fmla="*/ 976949 w 1316498"/>
                  <a:gd name="connsiteY243" fmla="*/ 59570 h 1498186"/>
                  <a:gd name="connsiteX244" fmla="*/ 988863 w 1316498"/>
                  <a:gd name="connsiteY244" fmla="*/ 38720 h 1498186"/>
                  <a:gd name="connsiteX245" fmla="*/ 994820 w 1316498"/>
                  <a:gd name="connsiteY245" fmla="*/ 26806 h 1498186"/>
                  <a:gd name="connsiteX246" fmla="*/ 1012691 w 1316498"/>
                  <a:gd name="connsiteY246" fmla="*/ 14892 h 1498186"/>
                  <a:gd name="connsiteX247" fmla="*/ 1021626 w 1316498"/>
                  <a:gd name="connsiteY247" fmla="*/ 8935 h 1498186"/>
                  <a:gd name="connsiteX248" fmla="*/ 1039497 w 1316498"/>
                  <a:gd name="connsiteY248" fmla="*/ 0 h 14981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  <a:cxn ang="0">
                    <a:pos x="connsiteX216" y="connsiteY216"/>
                  </a:cxn>
                  <a:cxn ang="0">
                    <a:pos x="connsiteX217" y="connsiteY217"/>
                  </a:cxn>
                  <a:cxn ang="0">
                    <a:pos x="connsiteX218" y="connsiteY218"/>
                  </a:cxn>
                  <a:cxn ang="0">
                    <a:pos x="connsiteX219" y="connsiteY219"/>
                  </a:cxn>
                  <a:cxn ang="0">
                    <a:pos x="connsiteX220" y="connsiteY220"/>
                  </a:cxn>
                  <a:cxn ang="0">
                    <a:pos x="connsiteX221" y="connsiteY221"/>
                  </a:cxn>
                  <a:cxn ang="0">
                    <a:pos x="connsiteX222" y="connsiteY222"/>
                  </a:cxn>
                  <a:cxn ang="0">
                    <a:pos x="connsiteX223" y="connsiteY223"/>
                  </a:cxn>
                  <a:cxn ang="0">
                    <a:pos x="connsiteX224" y="connsiteY224"/>
                  </a:cxn>
                  <a:cxn ang="0">
                    <a:pos x="connsiteX225" y="connsiteY225"/>
                  </a:cxn>
                  <a:cxn ang="0">
                    <a:pos x="connsiteX226" y="connsiteY226"/>
                  </a:cxn>
                  <a:cxn ang="0">
                    <a:pos x="connsiteX227" y="connsiteY227"/>
                  </a:cxn>
                  <a:cxn ang="0">
                    <a:pos x="connsiteX228" y="connsiteY228"/>
                  </a:cxn>
                  <a:cxn ang="0">
                    <a:pos x="connsiteX229" y="connsiteY229"/>
                  </a:cxn>
                  <a:cxn ang="0">
                    <a:pos x="connsiteX230" y="connsiteY230"/>
                  </a:cxn>
                  <a:cxn ang="0">
                    <a:pos x="connsiteX231" y="connsiteY231"/>
                  </a:cxn>
                  <a:cxn ang="0">
                    <a:pos x="connsiteX232" y="connsiteY232"/>
                  </a:cxn>
                  <a:cxn ang="0">
                    <a:pos x="connsiteX233" y="connsiteY233"/>
                  </a:cxn>
                  <a:cxn ang="0">
                    <a:pos x="connsiteX234" y="connsiteY234"/>
                  </a:cxn>
                  <a:cxn ang="0">
                    <a:pos x="connsiteX235" y="connsiteY235"/>
                  </a:cxn>
                  <a:cxn ang="0">
                    <a:pos x="connsiteX236" y="connsiteY236"/>
                  </a:cxn>
                  <a:cxn ang="0">
                    <a:pos x="connsiteX237" y="connsiteY237"/>
                  </a:cxn>
                  <a:cxn ang="0">
                    <a:pos x="connsiteX238" y="connsiteY238"/>
                  </a:cxn>
                  <a:cxn ang="0">
                    <a:pos x="connsiteX239" y="connsiteY239"/>
                  </a:cxn>
                  <a:cxn ang="0">
                    <a:pos x="connsiteX240" y="connsiteY240"/>
                  </a:cxn>
                  <a:cxn ang="0">
                    <a:pos x="connsiteX241" y="connsiteY241"/>
                  </a:cxn>
                  <a:cxn ang="0">
                    <a:pos x="connsiteX242" y="connsiteY242"/>
                  </a:cxn>
                  <a:cxn ang="0">
                    <a:pos x="connsiteX243" y="connsiteY243"/>
                  </a:cxn>
                  <a:cxn ang="0">
                    <a:pos x="connsiteX244" y="connsiteY244"/>
                  </a:cxn>
                  <a:cxn ang="0">
                    <a:pos x="connsiteX245" y="connsiteY245"/>
                  </a:cxn>
                  <a:cxn ang="0">
                    <a:pos x="connsiteX246" y="connsiteY246"/>
                  </a:cxn>
                  <a:cxn ang="0">
                    <a:pos x="connsiteX247" y="connsiteY247"/>
                  </a:cxn>
                  <a:cxn ang="0">
                    <a:pos x="connsiteX248" y="connsiteY248"/>
                  </a:cxn>
                </a:cxnLst>
                <a:rect l="l" t="t" r="r" b="b"/>
                <a:pathLst>
                  <a:path w="1316498" h="1498186">
                    <a:moveTo>
                      <a:pt x="1316498" y="1429681"/>
                    </a:moveTo>
                    <a:cubicBezTo>
                      <a:pt x="1315505" y="1435638"/>
                      <a:pt x="1316516" y="1442309"/>
                      <a:pt x="1313520" y="1447552"/>
                    </a:cubicBezTo>
                    <a:cubicBezTo>
                      <a:pt x="1311962" y="1450278"/>
                      <a:pt x="1307392" y="1449126"/>
                      <a:pt x="1304584" y="1450530"/>
                    </a:cubicBezTo>
                    <a:cubicBezTo>
                      <a:pt x="1301382" y="1452131"/>
                      <a:pt x="1299045" y="1455355"/>
                      <a:pt x="1295649" y="1456487"/>
                    </a:cubicBezTo>
                    <a:cubicBezTo>
                      <a:pt x="1286965" y="1459382"/>
                      <a:pt x="1277722" y="1460224"/>
                      <a:pt x="1268842" y="1462444"/>
                    </a:cubicBezTo>
                    <a:cubicBezTo>
                      <a:pt x="1265796" y="1463205"/>
                      <a:pt x="1262885" y="1464430"/>
                      <a:pt x="1259907" y="1465423"/>
                    </a:cubicBezTo>
                    <a:cubicBezTo>
                      <a:pt x="1254943" y="1462444"/>
                      <a:pt x="1249923" y="1459555"/>
                      <a:pt x="1245014" y="1456487"/>
                    </a:cubicBezTo>
                    <a:cubicBezTo>
                      <a:pt x="1241979" y="1454590"/>
                      <a:pt x="1238436" y="1453224"/>
                      <a:pt x="1236079" y="1450530"/>
                    </a:cubicBezTo>
                    <a:cubicBezTo>
                      <a:pt x="1231365" y="1445142"/>
                      <a:pt x="1228136" y="1438616"/>
                      <a:pt x="1224165" y="1432659"/>
                    </a:cubicBezTo>
                    <a:cubicBezTo>
                      <a:pt x="1221828" y="1429154"/>
                      <a:pt x="1218208" y="1426702"/>
                      <a:pt x="1215229" y="1423724"/>
                    </a:cubicBezTo>
                    <a:cubicBezTo>
                      <a:pt x="1214236" y="1420745"/>
                      <a:pt x="1213993" y="1417400"/>
                      <a:pt x="1212251" y="1414788"/>
                    </a:cubicBezTo>
                    <a:cubicBezTo>
                      <a:pt x="1207666" y="1407910"/>
                      <a:pt x="1200971" y="1404290"/>
                      <a:pt x="1194380" y="1399896"/>
                    </a:cubicBezTo>
                    <a:cubicBezTo>
                      <a:pt x="1192394" y="1396917"/>
                      <a:pt x="1190715" y="1393710"/>
                      <a:pt x="1188423" y="1390960"/>
                    </a:cubicBezTo>
                    <a:cubicBezTo>
                      <a:pt x="1185726" y="1387724"/>
                      <a:pt x="1181824" y="1385530"/>
                      <a:pt x="1179487" y="1382025"/>
                    </a:cubicBezTo>
                    <a:cubicBezTo>
                      <a:pt x="1177745" y="1379413"/>
                      <a:pt x="1178470" y="1375541"/>
                      <a:pt x="1176509" y="1373089"/>
                    </a:cubicBezTo>
                    <a:cubicBezTo>
                      <a:pt x="1171911" y="1367342"/>
                      <a:pt x="1164873" y="1366552"/>
                      <a:pt x="1158637" y="1364154"/>
                    </a:cubicBezTo>
                    <a:cubicBezTo>
                      <a:pt x="1148657" y="1360316"/>
                      <a:pt x="1138996" y="1355622"/>
                      <a:pt x="1128852" y="1352240"/>
                    </a:cubicBezTo>
                    <a:cubicBezTo>
                      <a:pt x="1125874" y="1351247"/>
                      <a:pt x="1122725" y="1350665"/>
                      <a:pt x="1119917" y="1349261"/>
                    </a:cubicBezTo>
                    <a:cubicBezTo>
                      <a:pt x="1107065" y="1342835"/>
                      <a:pt x="1115520" y="1343320"/>
                      <a:pt x="1102046" y="1340326"/>
                    </a:cubicBezTo>
                    <a:cubicBezTo>
                      <a:pt x="1096151" y="1339016"/>
                      <a:pt x="1090132" y="1338340"/>
                      <a:pt x="1084175" y="1337347"/>
                    </a:cubicBezTo>
                    <a:cubicBezTo>
                      <a:pt x="1080204" y="1335361"/>
                      <a:pt x="1076116" y="1333593"/>
                      <a:pt x="1072261" y="1331390"/>
                    </a:cubicBezTo>
                    <a:cubicBezTo>
                      <a:pt x="1069153" y="1329614"/>
                      <a:pt x="1066596" y="1326887"/>
                      <a:pt x="1063325" y="1325433"/>
                    </a:cubicBezTo>
                    <a:cubicBezTo>
                      <a:pt x="1035869" y="1313231"/>
                      <a:pt x="1054869" y="1325707"/>
                      <a:pt x="1033540" y="1313519"/>
                    </a:cubicBezTo>
                    <a:cubicBezTo>
                      <a:pt x="1030432" y="1311743"/>
                      <a:pt x="1027807" y="1309163"/>
                      <a:pt x="1024605" y="1307562"/>
                    </a:cubicBezTo>
                    <a:cubicBezTo>
                      <a:pt x="1019850" y="1305185"/>
                      <a:pt x="1008200" y="1302875"/>
                      <a:pt x="1003755" y="1301605"/>
                    </a:cubicBezTo>
                    <a:cubicBezTo>
                      <a:pt x="1000736" y="1300743"/>
                      <a:pt x="997798" y="1299620"/>
                      <a:pt x="994820" y="1298627"/>
                    </a:cubicBezTo>
                    <a:cubicBezTo>
                      <a:pt x="991023" y="1292931"/>
                      <a:pt x="986104" y="1284285"/>
                      <a:pt x="979927" y="1280756"/>
                    </a:cubicBezTo>
                    <a:cubicBezTo>
                      <a:pt x="976373" y="1278725"/>
                      <a:pt x="971984" y="1278770"/>
                      <a:pt x="968013" y="1277777"/>
                    </a:cubicBezTo>
                    <a:cubicBezTo>
                      <a:pt x="965676" y="1273104"/>
                      <a:pt x="960310" y="1261139"/>
                      <a:pt x="956099" y="1256928"/>
                    </a:cubicBezTo>
                    <a:cubicBezTo>
                      <a:pt x="950325" y="1251154"/>
                      <a:pt x="945496" y="1250415"/>
                      <a:pt x="938228" y="1247992"/>
                    </a:cubicBezTo>
                    <a:cubicBezTo>
                      <a:pt x="934257" y="1245014"/>
                      <a:pt x="930524" y="1241688"/>
                      <a:pt x="926314" y="1239057"/>
                    </a:cubicBezTo>
                    <a:cubicBezTo>
                      <a:pt x="922549" y="1236704"/>
                      <a:pt x="918013" y="1235681"/>
                      <a:pt x="914400" y="1233100"/>
                    </a:cubicBezTo>
                    <a:cubicBezTo>
                      <a:pt x="910972" y="1230652"/>
                      <a:pt x="908790" y="1226750"/>
                      <a:pt x="905465" y="1224164"/>
                    </a:cubicBezTo>
                    <a:cubicBezTo>
                      <a:pt x="895677" y="1216551"/>
                      <a:pt x="884853" y="1211654"/>
                      <a:pt x="875680" y="1203315"/>
                    </a:cubicBezTo>
                    <a:cubicBezTo>
                      <a:pt x="837400" y="1168516"/>
                      <a:pt x="869723" y="1193634"/>
                      <a:pt x="842916" y="1173530"/>
                    </a:cubicBezTo>
                    <a:cubicBezTo>
                      <a:pt x="837247" y="1156520"/>
                      <a:pt x="842654" y="1170130"/>
                      <a:pt x="828024" y="1146723"/>
                    </a:cubicBezTo>
                    <a:cubicBezTo>
                      <a:pt x="818421" y="1131359"/>
                      <a:pt x="816371" y="1124106"/>
                      <a:pt x="804196" y="1113960"/>
                    </a:cubicBezTo>
                    <a:cubicBezTo>
                      <a:pt x="801446" y="1111668"/>
                      <a:pt x="798239" y="1109989"/>
                      <a:pt x="795260" y="1108003"/>
                    </a:cubicBezTo>
                    <a:cubicBezTo>
                      <a:pt x="780368" y="1108996"/>
                      <a:pt x="765417" y="1109333"/>
                      <a:pt x="750583" y="1110981"/>
                    </a:cubicBezTo>
                    <a:cubicBezTo>
                      <a:pt x="747462" y="1111328"/>
                      <a:pt x="744693" y="1113198"/>
                      <a:pt x="741647" y="1113960"/>
                    </a:cubicBezTo>
                    <a:cubicBezTo>
                      <a:pt x="736736" y="1115188"/>
                      <a:pt x="731719" y="1115945"/>
                      <a:pt x="726755" y="1116938"/>
                    </a:cubicBezTo>
                    <a:cubicBezTo>
                      <a:pt x="723776" y="1118924"/>
                      <a:pt x="721171" y="1121638"/>
                      <a:pt x="717819" y="1122895"/>
                    </a:cubicBezTo>
                    <a:cubicBezTo>
                      <a:pt x="713079" y="1124673"/>
                      <a:pt x="707455" y="1123610"/>
                      <a:pt x="702927" y="1125874"/>
                    </a:cubicBezTo>
                    <a:cubicBezTo>
                      <a:pt x="699159" y="1127758"/>
                      <a:pt x="697673" y="1132763"/>
                      <a:pt x="693991" y="1134809"/>
                    </a:cubicBezTo>
                    <a:cubicBezTo>
                      <a:pt x="688502" y="1137858"/>
                      <a:pt x="676120" y="1140766"/>
                      <a:pt x="676120" y="1140766"/>
                    </a:cubicBezTo>
                    <a:cubicBezTo>
                      <a:pt x="672149" y="1143745"/>
                      <a:pt x="668815" y="1147858"/>
                      <a:pt x="664206" y="1149702"/>
                    </a:cubicBezTo>
                    <a:cubicBezTo>
                      <a:pt x="658599" y="1151945"/>
                      <a:pt x="652257" y="1151496"/>
                      <a:pt x="646335" y="1152680"/>
                    </a:cubicBezTo>
                    <a:cubicBezTo>
                      <a:pt x="642321" y="1153483"/>
                      <a:pt x="638505" y="1155377"/>
                      <a:pt x="634421" y="1155659"/>
                    </a:cubicBezTo>
                    <a:cubicBezTo>
                      <a:pt x="609639" y="1157368"/>
                      <a:pt x="584780" y="1157644"/>
                      <a:pt x="559959" y="1158637"/>
                    </a:cubicBezTo>
                    <a:cubicBezTo>
                      <a:pt x="557973" y="1161616"/>
                      <a:pt x="556797" y="1165337"/>
                      <a:pt x="554002" y="1167573"/>
                    </a:cubicBezTo>
                    <a:cubicBezTo>
                      <a:pt x="551550" y="1169534"/>
                      <a:pt x="547874" y="1169147"/>
                      <a:pt x="545066" y="1170551"/>
                    </a:cubicBezTo>
                    <a:cubicBezTo>
                      <a:pt x="541864" y="1172152"/>
                      <a:pt x="539109" y="1174522"/>
                      <a:pt x="536131" y="1176508"/>
                    </a:cubicBezTo>
                    <a:cubicBezTo>
                      <a:pt x="535138" y="1179487"/>
                      <a:pt x="535707" y="1183619"/>
                      <a:pt x="533152" y="1185444"/>
                    </a:cubicBezTo>
                    <a:cubicBezTo>
                      <a:pt x="529246" y="1188234"/>
                      <a:pt x="509737" y="1192787"/>
                      <a:pt x="503367" y="1194379"/>
                    </a:cubicBezTo>
                    <a:cubicBezTo>
                      <a:pt x="499396" y="1197358"/>
                      <a:pt x="495893" y="1201095"/>
                      <a:pt x="491453" y="1203315"/>
                    </a:cubicBezTo>
                    <a:cubicBezTo>
                      <a:pt x="484896" y="1206593"/>
                      <a:pt x="457941" y="1208993"/>
                      <a:pt x="455711" y="1209272"/>
                    </a:cubicBezTo>
                    <a:cubicBezTo>
                      <a:pt x="448761" y="1208279"/>
                      <a:pt x="440478" y="1210505"/>
                      <a:pt x="434862" y="1206293"/>
                    </a:cubicBezTo>
                    <a:cubicBezTo>
                      <a:pt x="430812" y="1203256"/>
                      <a:pt x="434147" y="1195929"/>
                      <a:pt x="431883" y="1191401"/>
                    </a:cubicBezTo>
                    <a:cubicBezTo>
                      <a:pt x="429999" y="1187633"/>
                      <a:pt x="425396" y="1185893"/>
                      <a:pt x="422948" y="1182465"/>
                    </a:cubicBezTo>
                    <a:cubicBezTo>
                      <a:pt x="403353" y="1155031"/>
                      <a:pt x="431282" y="1184840"/>
                      <a:pt x="408055" y="1161616"/>
                    </a:cubicBezTo>
                    <a:cubicBezTo>
                      <a:pt x="406069" y="1156652"/>
                      <a:pt x="403925" y="1151748"/>
                      <a:pt x="402098" y="1146723"/>
                    </a:cubicBezTo>
                    <a:cubicBezTo>
                      <a:pt x="399952" y="1140822"/>
                      <a:pt x="401164" y="1132619"/>
                      <a:pt x="396141" y="1128852"/>
                    </a:cubicBezTo>
                    <a:lnTo>
                      <a:pt x="384227" y="1119917"/>
                    </a:lnTo>
                    <a:cubicBezTo>
                      <a:pt x="378482" y="1091186"/>
                      <a:pt x="385518" y="1116539"/>
                      <a:pt x="375292" y="1096089"/>
                    </a:cubicBezTo>
                    <a:cubicBezTo>
                      <a:pt x="373888" y="1093281"/>
                      <a:pt x="373717" y="1089961"/>
                      <a:pt x="372313" y="1087153"/>
                    </a:cubicBezTo>
                    <a:cubicBezTo>
                      <a:pt x="370712" y="1083951"/>
                      <a:pt x="368132" y="1081326"/>
                      <a:pt x="366356" y="1078218"/>
                    </a:cubicBezTo>
                    <a:cubicBezTo>
                      <a:pt x="364153" y="1074363"/>
                      <a:pt x="362862" y="1069998"/>
                      <a:pt x="360399" y="1066304"/>
                    </a:cubicBezTo>
                    <a:cubicBezTo>
                      <a:pt x="358841" y="1063967"/>
                      <a:pt x="356196" y="1062539"/>
                      <a:pt x="354442" y="1060346"/>
                    </a:cubicBezTo>
                    <a:cubicBezTo>
                      <a:pt x="352206" y="1057551"/>
                      <a:pt x="350471" y="1054389"/>
                      <a:pt x="348485" y="1051411"/>
                    </a:cubicBezTo>
                    <a:cubicBezTo>
                      <a:pt x="333593" y="1052404"/>
                      <a:pt x="318530" y="1051935"/>
                      <a:pt x="303808" y="1054389"/>
                    </a:cubicBezTo>
                    <a:cubicBezTo>
                      <a:pt x="294517" y="1055937"/>
                      <a:pt x="277001" y="1063325"/>
                      <a:pt x="277001" y="1063325"/>
                    </a:cubicBezTo>
                    <a:cubicBezTo>
                      <a:pt x="274023" y="1065311"/>
                      <a:pt x="271591" y="1068660"/>
                      <a:pt x="268066" y="1069282"/>
                    </a:cubicBezTo>
                    <a:cubicBezTo>
                      <a:pt x="193205" y="1082493"/>
                      <a:pt x="246351" y="1065600"/>
                      <a:pt x="217431" y="1075239"/>
                    </a:cubicBezTo>
                    <a:cubicBezTo>
                      <a:pt x="216438" y="1078218"/>
                      <a:pt x="214243" y="1081042"/>
                      <a:pt x="214452" y="1084175"/>
                    </a:cubicBezTo>
                    <a:cubicBezTo>
                      <a:pt x="215255" y="1096227"/>
                      <a:pt x="219406" y="1107880"/>
                      <a:pt x="220409" y="1119917"/>
                    </a:cubicBezTo>
                    <a:cubicBezTo>
                      <a:pt x="221402" y="1131831"/>
                      <a:pt x="222068" y="1143777"/>
                      <a:pt x="223388" y="1155659"/>
                    </a:cubicBezTo>
                    <a:cubicBezTo>
                      <a:pt x="224055" y="1161661"/>
                      <a:pt x="225056" y="1167635"/>
                      <a:pt x="226366" y="1173530"/>
                    </a:cubicBezTo>
                    <a:cubicBezTo>
                      <a:pt x="227047" y="1176595"/>
                      <a:pt x="227125" y="1180245"/>
                      <a:pt x="229345" y="1182465"/>
                    </a:cubicBezTo>
                    <a:cubicBezTo>
                      <a:pt x="234408" y="1187527"/>
                      <a:pt x="241259" y="1190408"/>
                      <a:pt x="247216" y="1194379"/>
                    </a:cubicBezTo>
                    <a:lnTo>
                      <a:pt x="256152" y="1200336"/>
                    </a:lnTo>
                    <a:cubicBezTo>
                      <a:pt x="258138" y="1203315"/>
                      <a:pt x="259578" y="1206741"/>
                      <a:pt x="262109" y="1209272"/>
                    </a:cubicBezTo>
                    <a:cubicBezTo>
                      <a:pt x="267883" y="1215047"/>
                      <a:pt x="272712" y="1215785"/>
                      <a:pt x="279980" y="1218207"/>
                    </a:cubicBezTo>
                    <a:cubicBezTo>
                      <a:pt x="281966" y="1221186"/>
                      <a:pt x="283645" y="1224393"/>
                      <a:pt x="285937" y="1227143"/>
                    </a:cubicBezTo>
                    <a:cubicBezTo>
                      <a:pt x="301395" y="1245694"/>
                      <a:pt x="301688" y="1236565"/>
                      <a:pt x="336571" y="1239057"/>
                    </a:cubicBezTo>
                    <a:cubicBezTo>
                      <a:pt x="342033" y="1266363"/>
                      <a:pt x="334835" y="1242235"/>
                      <a:pt x="351464" y="1268842"/>
                    </a:cubicBezTo>
                    <a:cubicBezTo>
                      <a:pt x="358869" y="1280690"/>
                      <a:pt x="349596" y="1275996"/>
                      <a:pt x="357421" y="1289691"/>
                    </a:cubicBezTo>
                    <a:cubicBezTo>
                      <a:pt x="359511" y="1293348"/>
                      <a:pt x="363659" y="1295391"/>
                      <a:pt x="366356" y="1298627"/>
                    </a:cubicBezTo>
                    <a:cubicBezTo>
                      <a:pt x="387083" y="1323500"/>
                      <a:pt x="355151" y="1290400"/>
                      <a:pt x="381249" y="1316498"/>
                    </a:cubicBezTo>
                    <a:cubicBezTo>
                      <a:pt x="390984" y="1345707"/>
                      <a:pt x="375200" y="1304446"/>
                      <a:pt x="393163" y="1331390"/>
                    </a:cubicBezTo>
                    <a:cubicBezTo>
                      <a:pt x="395434" y="1334796"/>
                      <a:pt x="393520" y="1340159"/>
                      <a:pt x="396141" y="1343304"/>
                    </a:cubicBezTo>
                    <a:cubicBezTo>
                      <a:pt x="398228" y="1345809"/>
                      <a:pt x="421525" y="1354649"/>
                      <a:pt x="422948" y="1355218"/>
                    </a:cubicBezTo>
                    <a:cubicBezTo>
                      <a:pt x="424934" y="1358197"/>
                      <a:pt x="426110" y="1361918"/>
                      <a:pt x="428905" y="1364154"/>
                    </a:cubicBezTo>
                    <a:cubicBezTo>
                      <a:pt x="431356" y="1366115"/>
                      <a:pt x="435032" y="1365728"/>
                      <a:pt x="437840" y="1367132"/>
                    </a:cubicBezTo>
                    <a:cubicBezTo>
                      <a:pt x="458412" y="1377417"/>
                      <a:pt x="433892" y="1369867"/>
                      <a:pt x="458690" y="1376068"/>
                    </a:cubicBezTo>
                    <a:cubicBezTo>
                      <a:pt x="460676" y="1379046"/>
                      <a:pt x="461852" y="1382767"/>
                      <a:pt x="464647" y="1385003"/>
                    </a:cubicBezTo>
                    <a:cubicBezTo>
                      <a:pt x="467702" y="1387447"/>
                      <a:pt x="487730" y="1390811"/>
                      <a:pt x="488475" y="1390960"/>
                    </a:cubicBezTo>
                    <a:cubicBezTo>
                      <a:pt x="485496" y="1391953"/>
                      <a:pt x="482347" y="1392535"/>
                      <a:pt x="479539" y="1393939"/>
                    </a:cubicBezTo>
                    <a:cubicBezTo>
                      <a:pt x="476337" y="1395540"/>
                      <a:pt x="473894" y="1398486"/>
                      <a:pt x="470604" y="1399896"/>
                    </a:cubicBezTo>
                    <a:cubicBezTo>
                      <a:pt x="466841" y="1401508"/>
                      <a:pt x="462611" y="1401698"/>
                      <a:pt x="458690" y="1402874"/>
                    </a:cubicBezTo>
                    <a:cubicBezTo>
                      <a:pt x="422408" y="1413758"/>
                      <a:pt x="456381" y="1404940"/>
                      <a:pt x="428905" y="1411810"/>
                    </a:cubicBezTo>
                    <a:cubicBezTo>
                      <a:pt x="420962" y="1409824"/>
                      <a:pt x="412976" y="1408007"/>
                      <a:pt x="405077" y="1405853"/>
                    </a:cubicBezTo>
                    <a:cubicBezTo>
                      <a:pt x="402048" y="1405027"/>
                      <a:pt x="398886" y="1404399"/>
                      <a:pt x="396141" y="1402874"/>
                    </a:cubicBezTo>
                    <a:cubicBezTo>
                      <a:pt x="396131" y="1402868"/>
                      <a:pt x="373808" y="1387985"/>
                      <a:pt x="369335" y="1385003"/>
                    </a:cubicBezTo>
                    <a:cubicBezTo>
                      <a:pt x="366356" y="1383017"/>
                      <a:pt x="362930" y="1381577"/>
                      <a:pt x="360399" y="1379046"/>
                    </a:cubicBezTo>
                    <a:cubicBezTo>
                      <a:pt x="349244" y="1367891"/>
                      <a:pt x="355460" y="1371443"/>
                      <a:pt x="342528" y="1367132"/>
                    </a:cubicBezTo>
                    <a:cubicBezTo>
                      <a:pt x="340542" y="1364154"/>
                      <a:pt x="339366" y="1360433"/>
                      <a:pt x="336571" y="1358197"/>
                    </a:cubicBezTo>
                    <a:cubicBezTo>
                      <a:pt x="328051" y="1351380"/>
                      <a:pt x="305144" y="1357717"/>
                      <a:pt x="300829" y="1358197"/>
                    </a:cubicBezTo>
                    <a:cubicBezTo>
                      <a:pt x="275822" y="1376951"/>
                      <a:pt x="303004" y="1359242"/>
                      <a:pt x="274023" y="1370111"/>
                    </a:cubicBezTo>
                    <a:cubicBezTo>
                      <a:pt x="270671" y="1371368"/>
                      <a:pt x="268289" y="1374467"/>
                      <a:pt x="265087" y="1376068"/>
                    </a:cubicBezTo>
                    <a:cubicBezTo>
                      <a:pt x="258983" y="1379120"/>
                      <a:pt x="246920" y="1380893"/>
                      <a:pt x="241259" y="1382025"/>
                    </a:cubicBezTo>
                    <a:cubicBezTo>
                      <a:pt x="234480" y="1385415"/>
                      <a:pt x="216656" y="1393095"/>
                      <a:pt x="208495" y="1399896"/>
                    </a:cubicBezTo>
                    <a:cubicBezTo>
                      <a:pt x="205259" y="1402592"/>
                      <a:pt x="203242" y="1406785"/>
                      <a:pt x="199560" y="1408831"/>
                    </a:cubicBezTo>
                    <a:cubicBezTo>
                      <a:pt x="194071" y="1411880"/>
                      <a:pt x="181689" y="1414788"/>
                      <a:pt x="181689" y="1414788"/>
                    </a:cubicBezTo>
                    <a:cubicBezTo>
                      <a:pt x="178710" y="1416774"/>
                      <a:pt x="175861" y="1418969"/>
                      <a:pt x="172753" y="1420745"/>
                    </a:cubicBezTo>
                    <a:cubicBezTo>
                      <a:pt x="168898" y="1422948"/>
                      <a:pt x="164250" y="1423859"/>
                      <a:pt x="160839" y="1426702"/>
                    </a:cubicBezTo>
                    <a:cubicBezTo>
                      <a:pt x="158089" y="1428994"/>
                      <a:pt x="157174" y="1432888"/>
                      <a:pt x="154882" y="1435638"/>
                    </a:cubicBezTo>
                    <a:cubicBezTo>
                      <a:pt x="152186" y="1438874"/>
                      <a:pt x="149374" y="1442125"/>
                      <a:pt x="145947" y="1444573"/>
                    </a:cubicBezTo>
                    <a:cubicBezTo>
                      <a:pt x="142334" y="1447154"/>
                      <a:pt x="137888" y="1448327"/>
                      <a:pt x="134033" y="1450530"/>
                    </a:cubicBezTo>
                    <a:cubicBezTo>
                      <a:pt x="130925" y="1452306"/>
                      <a:pt x="128076" y="1454501"/>
                      <a:pt x="125097" y="1456487"/>
                    </a:cubicBezTo>
                    <a:cubicBezTo>
                      <a:pt x="114627" y="1472194"/>
                      <a:pt x="125178" y="1460708"/>
                      <a:pt x="107226" y="1468401"/>
                    </a:cubicBezTo>
                    <a:cubicBezTo>
                      <a:pt x="100420" y="1471318"/>
                      <a:pt x="92474" y="1480246"/>
                      <a:pt x="86377" y="1483294"/>
                    </a:cubicBezTo>
                    <a:cubicBezTo>
                      <a:pt x="80761" y="1486102"/>
                      <a:pt x="73731" y="1485768"/>
                      <a:pt x="68506" y="1489251"/>
                    </a:cubicBezTo>
                    <a:cubicBezTo>
                      <a:pt x="56164" y="1497479"/>
                      <a:pt x="63043" y="1494340"/>
                      <a:pt x="47656" y="1498186"/>
                    </a:cubicBezTo>
                    <a:cubicBezTo>
                      <a:pt x="44678" y="1495208"/>
                      <a:pt x="41057" y="1492756"/>
                      <a:pt x="38721" y="1489251"/>
                    </a:cubicBezTo>
                    <a:cubicBezTo>
                      <a:pt x="36552" y="1485998"/>
                      <a:pt x="33759" y="1470889"/>
                      <a:pt x="32764" y="1468401"/>
                    </a:cubicBezTo>
                    <a:cubicBezTo>
                      <a:pt x="30290" y="1462217"/>
                      <a:pt x="26807" y="1456487"/>
                      <a:pt x="23828" y="1450530"/>
                    </a:cubicBezTo>
                    <a:cubicBezTo>
                      <a:pt x="22835" y="1444573"/>
                      <a:pt x="22160" y="1438554"/>
                      <a:pt x="20850" y="1432659"/>
                    </a:cubicBezTo>
                    <a:cubicBezTo>
                      <a:pt x="20169" y="1429594"/>
                      <a:pt x="18487" y="1426803"/>
                      <a:pt x="17871" y="1423724"/>
                    </a:cubicBezTo>
                    <a:cubicBezTo>
                      <a:pt x="16494" y="1416840"/>
                      <a:pt x="15886" y="1409824"/>
                      <a:pt x="14893" y="1402874"/>
                    </a:cubicBezTo>
                    <a:cubicBezTo>
                      <a:pt x="16879" y="1388974"/>
                      <a:pt x="16888" y="1374645"/>
                      <a:pt x="20850" y="1361175"/>
                    </a:cubicBezTo>
                    <a:cubicBezTo>
                      <a:pt x="22038" y="1357134"/>
                      <a:pt x="27449" y="1355745"/>
                      <a:pt x="29785" y="1352240"/>
                    </a:cubicBezTo>
                    <a:cubicBezTo>
                      <a:pt x="31527" y="1349628"/>
                      <a:pt x="30939" y="1345859"/>
                      <a:pt x="32764" y="1343304"/>
                    </a:cubicBezTo>
                    <a:cubicBezTo>
                      <a:pt x="36028" y="1338734"/>
                      <a:pt x="41023" y="1335654"/>
                      <a:pt x="44678" y="1331390"/>
                    </a:cubicBezTo>
                    <a:cubicBezTo>
                      <a:pt x="47008" y="1328672"/>
                      <a:pt x="48649" y="1325433"/>
                      <a:pt x="50635" y="1322455"/>
                    </a:cubicBezTo>
                    <a:cubicBezTo>
                      <a:pt x="51628" y="1319476"/>
                      <a:pt x="52209" y="1316327"/>
                      <a:pt x="53613" y="1313519"/>
                    </a:cubicBezTo>
                    <a:cubicBezTo>
                      <a:pt x="55214" y="1310317"/>
                      <a:pt x="58313" y="1307936"/>
                      <a:pt x="59570" y="1304584"/>
                    </a:cubicBezTo>
                    <a:cubicBezTo>
                      <a:pt x="67545" y="1283318"/>
                      <a:pt x="55301" y="1294524"/>
                      <a:pt x="71484" y="1283734"/>
                    </a:cubicBezTo>
                    <a:cubicBezTo>
                      <a:pt x="73470" y="1278770"/>
                      <a:pt x="75050" y="1273624"/>
                      <a:pt x="77441" y="1268842"/>
                    </a:cubicBezTo>
                    <a:cubicBezTo>
                      <a:pt x="79042" y="1265640"/>
                      <a:pt x="81797" y="1263108"/>
                      <a:pt x="83398" y="1259906"/>
                    </a:cubicBezTo>
                    <a:cubicBezTo>
                      <a:pt x="84802" y="1257098"/>
                      <a:pt x="84416" y="1253423"/>
                      <a:pt x="86377" y="1250971"/>
                    </a:cubicBezTo>
                    <a:cubicBezTo>
                      <a:pt x="88613" y="1248176"/>
                      <a:pt x="92334" y="1247000"/>
                      <a:pt x="95312" y="1245014"/>
                    </a:cubicBezTo>
                    <a:cubicBezTo>
                      <a:pt x="95943" y="1243120"/>
                      <a:pt x="106414" y="1223622"/>
                      <a:pt x="98291" y="1218207"/>
                    </a:cubicBezTo>
                    <a:cubicBezTo>
                      <a:pt x="94079" y="1215399"/>
                      <a:pt x="88362" y="1216222"/>
                      <a:pt x="83398" y="1215229"/>
                    </a:cubicBezTo>
                    <a:cubicBezTo>
                      <a:pt x="70866" y="1207709"/>
                      <a:pt x="68254" y="1207779"/>
                      <a:pt x="59570" y="1197358"/>
                    </a:cubicBezTo>
                    <a:cubicBezTo>
                      <a:pt x="57278" y="1194608"/>
                      <a:pt x="56307" y="1190779"/>
                      <a:pt x="53613" y="1188422"/>
                    </a:cubicBezTo>
                    <a:cubicBezTo>
                      <a:pt x="48225" y="1183707"/>
                      <a:pt x="35742" y="1176508"/>
                      <a:pt x="35742" y="1176508"/>
                    </a:cubicBezTo>
                    <a:cubicBezTo>
                      <a:pt x="29944" y="1159113"/>
                      <a:pt x="37301" y="1175089"/>
                      <a:pt x="23828" y="1161616"/>
                    </a:cubicBezTo>
                    <a:cubicBezTo>
                      <a:pt x="20318" y="1158106"/>
                      <a:pt x="18124" y="1153471"/>
                      <a:pt x="14893" y="1149702"/>
                    </a:cubicBezTo>
                    <a:cubicBezTo>
                      <a:pt x="-2311" y="1129631"/>
                      <a:pt x="13168" y="1151582"/>
                      <a:pt x="0" y="1131831"/>
                    </a:cubicBezTo>
                    <a:cubicBezTo>
                      <a:pt x="12825" y="1080531"/>
                      <a:pt x="-1208" y="1125309"/>
                      <a:pt x="11914" y="1099067"/>
                    </a:cubicBezTo>
                    <a:cubicBezTo>
                      <a:pt x="13318" y="1096259"/>
                      <a:pt x="12932" y="1092584"/>
                      <a:pt x="14893" y="1090132"/>
                    </a:cubicBezTo>
                    <a:cubicBezTo>
                      <a:pt x="17129" y="1087337"/>
                      <a:pt x="20850" y="1086161"/>
                      <a:pt x="23828" y="1084175"/>
                    </a:cubicBezTo>
                    <a:cubicBezTo>
                      <a:pt x="25814" y="1081196"/>
                      <a:pt x="28184" y="1078441"/>
                      <a:pt x="29785" y="1075239"/>
                    </a:cubicBezTo>
                    <a:cubicBezTo>
                      <a:pt x="31189" y="1072431"/>
                      <a:pt x="31023" y="1068916"/>
                      <a:pt x="32764" y="1066304"/>
                    </a:cubicBezTo>
                    <a:cubicBezTo>
                      <a:pt x="35101" y="1062799"/>
                      <a:pt x="38721" y="1060347"/>
                      <a:pt x="41699" y="1057368"/>
                    </a:cubicBezTo>
                    <a:cubicBezTo>
                      <a:pt x="42692" y="1053397"/>
                      <a:pt x="43065" y="1049217"/>
                      <a:pt x="44678" y="1045454"/>
                    </a:cubicBezTo>
                    <a:cubicBezTo>
                      <a:pt x="47789" y="1038196"/>
                      <a:pt x="54201" y="1032952"/>
                      <a:pt x="59570" y="1027583"/>
                    </a:cubicBezTo>
                    <a:cubicBezTo>
                      <a:pt x="58577" y="1019640"/>
                      <a:pt x="57908" y="1011651"/>
                      <a:pt x="56592" y="1003755"/>
                    </a:cubicBezTo>
                    <a:cubicBezTo>
                      <a:pt x="55919" y="999717"/>
                      <a:pt x="52318" y="995725"/>
                      <a:pt x="53613" y="991841"/>
                    </a:cubicBezTo>
                    <a:cubicBezTo>
                      <a:pt x="54745" y="988445"/>
                      <a:pt x="59278" y="987338"/>
                      <a:pt x="62549" y="985884"/>
                    </a:cubicBezTo>
                    <a:cubicBezTo>
                      <a:pt x="68287" y="983334"/>
                      <a:pt x="80420" y="979927"/>
                      <a:pt x="80420" y="979927"/>
                    </a:cubicBezTo>
                    <a:cubicBezTo>
                      <a:pt x="82406" y="976948"/>
                      <a:pt x="83582" y="973227"/>
                      <a:pt x="86377" y="970991"/>
                    </a:cubicBezTo>
                    <a:cubicBezTo>
                      <a:pt x="88828" y="969030"/>
                      <a:pt x="92223" y="968575"/>
                      <a:pt x="95312" y="968013"/>
                    </a:cubicBezTo>
                    <a:cubicBezTo>
                      <a:pt x="103187" y="966581"/>
                      <a:pt x="111197" y="966027"/>
                      <a:pt x="119140" y="965034"/>
                    </a:cubicBezTo>
                    <a:cubicBezTo>
                      <a:pt x="159846" y="966027"/>
                      <a:pt x="200716" y="964242"/>
                      <a:pt x="241259" y="968013"/>
                    </a:cubicBezTo>
                    <a:cubicBezTo>
                      <a:pt x="244823" y="968345"/>
                      <a:pt x="244014" y="975347"/>
                      <a:pt x="247216" y="976948"/>
                    </a:cubicBezTo>
                    <a:cubicBezTo>
                      <a:pt x="252618" y="979649"/>
                      <a:pt x="259130" y="978934"/>
                      <a:pt x="265087" y="979927"/>
                    </a:cubicBezTo>
                    <a:cubicBezTo>
                      <a:pt x="272037" y="978934"/>
                      <a:pt x="279521" y="979799"/>
                      <a:pt x="285937" y="976948"/>
                    </a:cubicBezTo>
                    <a:cubicBezTo>
                      <a:pt x="290668" y="974845"/>
                      <a:pt x="296826" y="954486"/>
                      <a:pt x="297851" y="953120"/>
                    </a:cubicBezTo>
                    <a:cubicBezTo>
                      <a:pt x="303748" y="945257"/>
                      <a:pt x="311750" y="939221"/>
                      <a:pt x="318700" y="932271"/>
                    </a:cubicBezTo>
                    <a:cubicBezTo>
                      <a:pt x="321679" y="929292"/>
                      <a:pt x="324131" y="925672"/>
                      <a:pt x="327636" y="923335"/>
                    </a:cubicBezTo>
                    <a:cubicBezTo>
                      <a:pt x="330614" y="921349"/>
                      <a:pt x="333300" y="918832"/>
                      <a:pt x="336571" y="917378"/>
                    </a:cubicBezTo>
                    <a:cubicBezTo>
                      <a:pt x="350732" y="911084"/>
                      <a:pt x="357327" y="910940"/>
                      <a:pt x="372313" y="908443"/>
                    </a:cubicBezTo>
                    <a:cubicBezTo>
                      <a:pt x="370440" y="891580"/>
                      <a:pt x="372568" y="882587"/>
                      <a:pt x="363378" y="869722"/>
                    </a:cubicBezTo>
                    <a:cubicBezTo>
                      <a:pt x="360930" y="866294"/>
                      <a:pt x="357421" y="863765"/>
                      <a:pt x="354442" y="860787"/>
                    </a:cubicBezTo>
                    <a:cubicBezTo>
                      <a:pt x="352164" y="851673"/>
                      <a:pt x="352363" y="846793"/>
                      <a:pt x="345507" y="839937"/>
                    </a:cubicBezTo>
                    <a:cubicBezTo>
                      <a:pt x="342976" y="837406"/>
                      <a:pt x="339550" y="835966"/>
                      <a:pt x="336571" y="833980"/>
                    </a:cubicBezTo>
                    <a:cubicBezTo>
                      <a:pt x="322056" y="812209"/>
                      <a:pt x="341375" y="837985"/>
                      <a:pt x="318700" y="819088"/>
                    </a:cubicBezTo>
                    <a:cubicBezTo>
                      <a:pt x="315950" y="816796"/>
                      <a:pt x="314344" y="813354"/>
                      <a:pt x="312743" y="810152"/>
                    </a:cubicBezTo>
                    <a:cubicBezTo>
                      <a:pt x="307134" y="798934"/>
                      <a:pt x="306652" y="794724"/>
                      <a:pt x="303808" y="783346"/>
                    </a:cubicBezTo>
                    <a:cubicBezTo>
                      <a:pt x="304801" y="777389"/>
                      <a:pt x="304085" y="770877"/>
                      <a:pt x="306786" y="765475"/>
                    </a:cubicBezTo>
                    <a:cubicBezTo>
                      <a:pt x="308387" y="762273"/>
                      <a:pt x="312149" y="759741"/>
                      <a:pt x="315722" y="759518"/>
                    </a:cubicBezTo>
                    <a:cubicBezTo>
                      <a:pt x="328642" y="758710"/>
                      <a:pt x="341535" y="761503"/>
                      <a:pt x="354442" y="762496"/>
                    </a:cubicBezTo>
                    <a:cubicBezTo>
                      <a:pt x="357421" y="764482"/>
                      <a:pt x="360088" y="767043"/>
                      <a:pt x="363378" y="768453"/>
                    </a:cubicBezTo>
                    <a:cubicBezTo>
                      <a:pt x="367141" y="770066"/>
                      <a:pt x="371886" y="769161"/>
                      <a:pt x="375292" y="771432"/>
                    </a:cubicBezTo>
                    <a:cubicBezTo>
                      <a:pt x="378270" y="773418"/>
                      <a:pt x="378141" y="778591"/>
                      <a:pt x="381249" y="780367"/>
                    </a:cubicBezTo>
                    <a:cubicBezTo>
                      <a:pt x="385644" y="782879"/>
                      <a:pt x="391177" y="782353"/>
                      <a:pt x="396141" y="783346"/>
                    </a:cubicBezTo>
                    <a:cubicBezTo>
                      <a:pt x="403303" y="794089"/>
                      <a:pt x="407729" y="801993"/>
                      <a:pt x="419969" y="810152"/>
                    </a:cubicBezTo>
                    <a:cubicBezTo>
                      <a:pt x="422948" y="812138"/>
                      <a:pt x="425615" y="814699"/>
                      <a:pt x="428905" y="816109"/>
                    </a:cubicBezTo>
                    <a:cubicBezTo>
                      <a:pt x="432668" y="817722"/>
                      <a:pt x="436883" y="817963"/>
                      <a:pt x="440819" y="819088"/>
                    </a:cubicBezTo>
                    <a:cubicBezTo>
                      <a:pt x="443838" y="819950"/>
                      <a:pt x="446725" y="821240"/>
                      <a:pt x="449754" y="822066"/>
                    </a:cubicBezTo>
                    <a:cubicBezTo>
                      <a:pt x="457653" y="824220"/>
                      <a:pt x="465815" y="825434"/>
                      <a:pt x="473582" y="828023"/>
                    </a:cubicBezTo>
                    <a:cubicBezTo>
                      <a:pt x="476561" y="829016"/>
                      <a:pt x="479499" y="830139"/>
                      <a:pt x="482518" y="831002"/>
                    </a:cubicBezTo>
                    <a:cubicBezTo>
                      <a:pt x="495679" y="834762"/>
                      <a:pt x="491929" y="832669"/>
                      <a:pt x="503367" y="836959"/>
                    </a:cubicBezTo>
                    <a:cubicBezTo>
                      <a:pt x="508373" y="838836"/>
                      <a:pt x="513050" y="841714"/>
                      <a:pt x="518260" y="842916"/>
                    </a:cubicBezTo>
                    <a:cubicBezTo>
                      <a:pt x="526060" y="844716"/>
                      <a:pt x="534145" y="844901"/>
                      <a:pt x="542088" y="845894"/>
                    </a:cubicBezTo>
                    <a:lnTo>
                      <a:pt x="559959" y="851851"/>
                    </a:lnTo>
                    <a:cubicBezTo>
                      <a:pt x="562937" y="852844"/>
                      <a:pt x="565815" y="854214"/>
                      <a:pt x="568894" y="854830"/>
                    </a:cubicBezTo>
                    <a:lnTo>
                      <a:pt x="583787" y="857808"/>
                    </a:lnTo>
                    <a:cubicBezTo>
                      <a:pt x="586765" y="860787"/>
                      <a:pt x="589065" y="864654"/>
                      <a:pt x="592722" y="866744"/>
                    </a:cubicBezTo>
                    <a:cubicBezTo>
                      <a:pt x="595251" y="868189"/>
                      <a:pt x="618304" y="872333"/>
                      <a:pt x="619529" y="872701"/>
                    </a:cubicBezTo>
                    <a:cubicBezTo>
                      <a:pt x="624650" y="874237"/>
                      <a:pt x="629457" y="876672"/>
                      <a:pt x="634421" y="878658"/>
                    </a:cubicBezTo>
                    <a:cubicBezTo>
                      <a:pt x="646335" y="877665"/>
                      <a:pt x="658668" y="878963"/>
                      <a:pt x="670163" y="875679"/>
                    </a:cubicBezTo>
                    <a:cubicBezTo>
                      <a:pt x="673605" y="874696"/>
                      <a:pt x="674897" y="870108"/>
                      <a:pt x="676120" y="866744"/>
                    </a:cubicBezTo>
                    <a:cubicBezTo>
                      <a:pt x="678918" y="859050"/>
                      <a:pt x="675265" y="847457"/>
                      <a:pt x="682077" y="842916"/>
                    </a:cubicBezTo>
                    <a:lnTo>
                      <a:pt x="691013" y="836959"/>
                    </a:lnTo>
                    <a:cubicBezTo>
                      <a:pt x="694327" y="827014"/>
                      <a:pt x="694478" y="827321"/>
                      <a:pt x="696970" y="816109"/>
                    </a:cubicBezTo>
                    <a:cubicBezTo>
                      <a:pt x="698068" y="811167"/>
                      <a:pt x="697853" y="805826"/>
                      <a:pt x="699948" y="801217"/>
                    </a:cubicBezTo>
                    <a:cubicBezTo>
                      <a:pt x="702911" y="794699"/>
                      <a:pt x="709598" y="790138"/>
                      <a:pt x="711862" y="783346"/>
                    </a:cubicBezTo>
                    <a:cubicBezTo>
                      <a:pt x="716442" y="769608"/>
                      <a:pt x="714225" y="777489"/>
                      <a:pt x="717819" y="759518"/>
                    </a:cubicBezTo>
                    <a:cubicBezTo>
                      <a:pt x="719147" y="740925"/>
                      <a:pt x="716815" y="725128"/>
                      <a:pt x="723776" y="708883"/>
                    </a:cubicBezTo>
                    <a:cubicBezTo>
                      <a:pt x="725525" y="704802"/>
                      <a:pt x="727747" y="700940"/>
                      <a:pt x="729733" y="696969"/>
                    </a:cubicBezTo>
                    <a:cubicBezTo>
                      <a:pt x="735108" y="664726"/>
                      <a:pt x="729825" y="690689"/>
                      <a:pt x="735690" y="670163"/>
                    </a:cubicBezTo>
                    <a:cubicBezTo>
                      <a:pt x="736815" y="666227"/>
                      <a:pt x="735338" y="660628"/>
                      <a:pt x="738669" y="658249"/>
                    </a:cubicBezTo>
                    <a:cubicBezTo>
                      <a:pt x="743583" y="654739"/>
                      <a:pt x="750517" y="655716"/>
                      <a:pt x="756540" y="655270"/>
                    </a:cubicBezTo>
                    <a:cubicBezTo>
                      <a:pt x="777356" y="653728"/>
                      <a:pt x="798239" y="653285"/>
                      <a:pt x="819088" y="652292"/>
                    </a:cubicBezTo>
                    <a:cubicBezTo>
                      <a:pt x="823059" y="650306"/>
                      <a:pt x="827389" y="648916"/>
                      <a:pt x="831002" y="646335"/>
                    </a:cubicBezTo>
                    <a:cubicBezTo>
                      <a:pt x="850524" y="632391"/>
                      <a:pt x="829707" y="640809"/>
                      <a:pt x="848873" y="634421"/>
                    </a:cubicBezTo>
                    <a:cubicBezTo>
                      <a:pt x="851852" y="631442"/>
                      <a:pt x="855112" y="628721"/>
                      <a:pt x="857809" y="625485"/>
                    </a:cubicBezTo>
                    <a:cubicBezTo>
                      <a:pt x="865169" y="616653"/>
                      <a:pt x="863480" y="615041"/>
                      <a:pt x="869723" y="604636"/>
                    </a:cubicBezTo>
                    <a:cubicBezTo>
                      <a:pt x="873406" y="598497"/>
                      <a:pt x="881637" y="586765"/>
                      <a:pt x="881637" y="586765"/>
                    </a:cubicBezTo>
                    <a:cubicBezTo>
                      <a:pt x="883677" y="580643"/>
                      <a:pt x="886764" y="572142"/>
                      <a:pt x="887594" y="565915"/>
                    </a:cubicBezTo>
                    <a:cubicBezTo>
                      <a:pt x="889043" y="555045"/>
                      <a:pt x="888965" y="544000"/>
                      <a:pt x="890572" y="533152"/>
                    </a:cubicBezTo>
                    <a:cubicBezTo>
                      <a:pt x="902336" y="453744"/>
                      <a:pt x="893961" y="506398"/>
                      <a:pt x="902486" y="476560"/>
                    </a:cubicBezTo>
                    <a:cubicBezTo>
                      <a:pt x="903611" y="472624"/>
                      <a:pt x="904170" y="468529"/>
                      <a:pt x="905465" y="464646"/>
                    </a:cubicBezTo>
                    <a:cubicBezTo>
                      <a:pt x="907156" y="459574"/>
                      <a:pt x="909436" y="454718"/>
                      <a:pt x="911422" y="449754"/>
                    </a:cubicBezTo>
                    <a:cubicBezTo>
                      <a:pt x="912415" y="444790"/>
                      <a:pt x="912622" y="439601"/>
                      <a:pt x="914400" y="434861"/>
                    </a:cubicBezTo>
                    <a:cubicBezTo>
                      <a:pt x="915657" y="431509"/>
                      <a:pt x="919100" y="429278"/>
                      <a:pt x="920357" y="425926"/>
                    </a:cubicBezTo>
                    <a:cubicBezTo>
                      <a:pt x="930150" y="399814"/>
                      <a:pt x="913419" y="420950"/>
                      <a:pt x="935250" y="399119"/>
                    </a:cubicBezTo>
                    <a:cubicBezTo>
                      <a:pt x="940710" y="382738"/>
                      <a:pt x="934948" y="397414"/>
                      <a:pt x="944185" y="381248"/>
                    </a:cubicBezTo>
                    <a:cubicBezTo>
                      <a:pt x="949482" y="371978"/>
                      <a:pt x="949502" y="368316"/>
                      <a:pt x="956099" y="360399"/>
                    </a:cubicBezTo>
                    <a:cubicBezTo>
                      <a:pt x="958796" y="357163"/>
                      <a:pt x="962338" y="354699"/>
                      <a:pt x="965035" y="351463"/>
                    </a:cubicBezTo>
                    <a:cubicBezTo>
                      <a:pt x="967327" y="348713"/>
                      <a:pt x="968700" y="345278"/>
                      <a:pt x="970992" y="342528"/>
                    </a:cubicBezTo>
                    <a:cubicBezTo>
                      <a:pt x="973689" y="339292"/>
                      <a:pt x="977479" y="337020"/>
                      <a:pt x="979927" y="333592"/>
                    </a:cubicBezTo>
                    <a:cubicBezTo>
                      <a:pt x="982508" y="329979"/>
                      <a:pt x="984081" y="325735"/>
                      <a:pt x="985884" y="321678"/>
                    </a:cubicBezTo>
                    <a:cubicBezTo>
                      <a:pt x="987444" y="318167"/>
                      <a:pt x="993417" y="303462"/>
                      <a:pt x="994820" y="297850"/>
                    </a:cubicBezTo>
                    <a:cubicBezTo>
                      <a:pt x="996048" y="292939"/>
                      <a:pt x="996805" y="287922"/>
                      <a:pt x="997798" y="282958"/>
                    </a:cubicBezTo>
                    <a:cubicBezTo>
                      <a:pt x="994820" y="241259"/>
                      <a:pt x="992485" y="199509"/>
                      <a:pt x="988863" y="157861"/>
                    </a:cubicBezTo>
                    <a:cubicBezTo>
                      <a:pt x="988508" y="153782"/>
                      <a:pt x="986772" y="149942"/>
                      <a:pt x="985884" y="145946"/>
                    </a:cubicBezTo>
                    <a:cubicBezTo>
                      <a:pt x="976796" y="105050"/>
                      <a:pt x="987915" y="150076"/>
                      <a:pt x="979927" y="122118"/>
                    </a:cubicBezTo>
                    <a:cubicBezTo>
                      <a:pt x="978802" y="118182"/>
                      <a:pt x="979220" y="113610"/>
                      <a:pt x="976949" y="110204"/>
                    </a:cubicBezTo>
                    <a:cubicBezTo>
                      <a:pt x="974963" y="107225"/>
                      <a:pt x="970992" y="106233"/>
                      <a:pt x="968013" y="104247"/>
                    </a:cubicBezTo>
                    <a:cubicBezTo>
                      <a:pt x="967020" y="101269"/>
                      <a:pt x="964774" y="98441"/>
                      <a:pt x="965035" y="95312"/>
                    </a:cubicBezTo>
                    <a:cubicBezTo>
                      <a:pt x="966959" y="72224"/>
                      <a:pt x="967795" y="73300"/>
                      <a:pt x="976949" y="59570"/>
                    </a:cubicBezTo>
                    <a:cubicBezTo>
                      <a:pt x="982717" y="36495"/>
                      <a:pt x="975213" y="57830"/>
                      <a:pt x="988863" y="38720"/>
                    </a:cubicBezTo>
                    <a:cubicBezTo>
                      <a:pt x="991444" y="35107"/>
                      <a:pt x="991680" y="29946"/>
                      <a:pt x="994820" y="26806"/>
                    </a:cubicBezTo>
                    <a:cubicBezTo>
                      <a:pt x="999882" y="21744"/>
                      <a:pt x="1006734" y="18863"/>
                      <a:pt x="1012691" y="14892"/>
                    </a:cubicBezTo>
                    <a:cubicBezTo>
                      <a:pt x="1015669" y="12906"/>
                      <a:pt x="1018424" y="10536"/>
                      <a:pt x="1021626" y="8935"/>
                    </a:cubicBezTo>
                    <a:lnTo>
                      <a:pt x="1039497" y="0"/>
                    </a:lnTo>
                  </a:path>
                </a:pathLst>
              </a:cu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8" name="フリーフォーム: 図形 17">
              <a:extLst>
                <a:ext uri="{FF2B5EF4-FFF2-40B4-BE49-F238E27FC236}">
                  <a16:creationId xmlns:a16="http://schemas.microsoft.com/office/drawing/2014/main" id="{83BB965C-B59F-46BD-84FB-BCBEF8B631C5}"/>
                </a:ext>
              </a:extLst>
            </p:cNvPr>
            <p:cNvSpPr/>
            <p:nvPr/>
          </p:nvSpPr>
          <p:spPr>
            <a:xfrm>
              <a:off x="6379950" y="2245790"/>
              <a:ext cx="495985" cy="1268842"/>
            </a:xfrm>
            <a:custGeom>
              <a:avLst/>
              <a:gdLst>
                <a:gd name="connsiteX0" fmla="*/ 181689 w 487049"/>
                <a:gd name="connsiteY0" fmla="*/ 0 h 1271820"/>
                <a:gd name="connsiteX1" fmla="*/ 196581 w 487049"/>
                <a:gd name="connsiteY1" fmla="*/ 14893 h 1271820"/>
                <a:gd name="connsiteX2" fmla="*/ 205517 w 487049"/>
                <a:gd name="connsiteY2" fmla="*/ 17871 h 1271820"/>
                <a:gd name="connsiteX3" fmla="*/ 223388 w 487049"/>
                <a:gd name="connsiteY3" fmla="*/ 26807 h 1271820"/>
                <a:gd name="connsiteX4" fmla="*/ 232323 w 487049"/>
                <a:gd name="connsiteY4" fmla="*/ 35742 h 1271820"/>
                <a:gd name="connsiteX5" fmla="*/ 244237 w 487049"/>
                <a:gd name="connsiteY5" fmla="*/ 41699 h 1271820"/>
                <a:gd name="connsiteX6" fmla="*/ 250194 w 487049"/>
                <a:gd name="connsiteY6" fmla="*/ 50635 h 1271820"/>
                <a:gd name="connsiteX7" fmla="*/ 259130 w 487049"/>
                <a:gd name="connsiteY7" fmla="*/ 59570 h 1271820"/>
                <a:gd name="connsiteX8" fmla="*/ 268065 w 487049"/>
                <a:gd name="connsiteY8" fmla="*/ 65527 h 1271820"/>
                <a:gd name="connsiteX9" fmla="*/ 288915 w 487049"/>
                <a:gd name="connsiteY9" fmla="*/ 71484 h 1271820"/>
                <a:gd name="connsiteX10" fmla="*/ 315721 w 487049"/>
                <a:gd name="connsiteY10" fmla="*/ 68506 h 1271820"/>
                <a:gd name="connsiteX11" fmla="*/ 321678 w 487049"/>
                <a:gd name="connsiteY11" fmla="*/ 59570 h 1271820"/>
                <a:gd name="connsiteX12" fmla="*/ 390184 w 487049"/>
                <a:gd name="connsiteY12" fmla="*/ 65527 h 1271820"/>
                <a:gd name="connsiteX13" fmla="*/ 399119 w 487049"/>
                <a:gd name="connsiteY13" fmla="*/ 71484 h 1271820"/>
                <a:gd name="connsiteX14" fmla="*/ 384227 w 487049"/>
                <a:gd name="connsiteY14" fmla="*/ 92334 h 1271820"/>
                <a:gd name="connsiteX15" fmla="*/ 375291 w 487049"/>
                <a:gd name="connsiteY15" fmla="*/ 101269 h 1271820"/>
                <a:gd name="connsiteX16" fmla="*/ 363377 w 487049"/>
                <a:gd name="connsiteY16" fmla="*/ 104248 h 1271820"/>
                <a:gd name="connsiteX17" fmla="*/ 345506 w 487049"/>
                <a:gd name="connsiteY17" fmla="*/ 110205 h 1271820"/>
                <a:gd name="connsiteX18" fmla="*/ 336571 w 487049"/>
                <a:gd name="connsiteY18" fmla="*/ 128076 h 1271820"/>
                <a:gd name="connsiteX19" fmla="*/ 330614 w 487049"/>
                <a:gd name="connsiteY19" fmla="*/ 137011 h 1271820"/>
                <a:gd name="connsiteX20" fmla="*/ 321678 w 487049"/>
                <a:gd name="connsiteY20" fmla="*/ 154882 h 1271820"/>
                <a:gd name="connsiteX21" fmla="*/ 318700 w 487049"/>
                <a:gd name="connsiteY21" fmla="*/ 169775 h 1271820"/>
                <a:gd name="connsiteX22" fmla="*/ 312743 w 487049"/>
                <a:gd name="connsiteY22" fmla="*/ 178710 h 1271820"/>
                <a:gd name="connsiteX23" fmla="*/ 315721 w 487049"/>
                <a:gd name="connsiteY23" fmla="*/ 318700 h 1271820"/>
                <a:gd name="connsiteX24" fmla="*/ 321678 w 487049"/>
                <a:gd name="connsiteY24" fmla="*/ 354442 h 1271820"/>
                <a:gd name="connsiteX25" fmla="*/ 327635 w 487049"/>
                <a:gd name="connsiteY25" fmla="*/ 375291 h 1271820"/>
                <a:gd name="connsiteX26" fmla="*/ 333592 w 487049"/>
                <a:gd name="connsiteY26" fmla="*/ 387205 h 1271820"/>
                <a:gd name="connsiteX27" fmla="*/ 351463 w 487049"/>
                <a:gd name="connsiteY27" fmla="*/ 402098 h 1271820"/>
                <a:gd name="connsiteX28" fmla="*/ 363377 w 487049"/>
                <a:gd name="connsiteY28" fmla="*/ 419969 h 1271820"/>
                <a:gd name="connsiteX29" fmla="*/ 381248 w 487049"/>
                <a:gd name="connsiteY29" fmla="*/ 437840 h 1271820"/>
                <a:gd name="connsiteX30" fmla="*/ 390184 w 487049"/>
                <a:gd name="connsiteY30" fmla="*/ 455711 h 1271820"/>
                <a:gd name="connsiteX31" fmla="*/ 396141 w 487049"/>
                <a:gd name="connsiteY31" fmla="*/ 467625 h 1271820"/>
                <a:gd name="connsiteX32" fmla="*/ 405076 w 487049"/>
                <a:gd name="connsiteY32" fmla="*/ 476560 h 1271820"/>
                <a:gd name="connsiteX33" fmla="*/ 411033 w 487049"/>
                <a:gd name="connsiteY33" fmla="*/ 485496 h 1271820"/>
                <a:gd name="connsiteX34" fmla="*/ 414012 w 487049"/>
                <a:gd name="connsiteY34" fmla="*/ 497410 h 1271820"/>
                <a:gd name="connsiteX35" fmla="*/ 416990 w 487049"/>
                <a:gd name="connsiteY35" fmla="*/ 512303 h 1271820"/>
                <a:gd name="connsiteX36" fmla="*/ 428904 w 487049"/>
                <a:gd name="connsiteY36" fmla="*/ 530174 h 1271820"/>
                <a:gd name="connsiteX37" fmla="*/ 437840 w 487049"/>
                <a:gd name="connsiteY37" fmla="*/ 554002 h 1271820"/>
                <a:gd name="connsiteX38" fmla="*/ 446775 w 487049"/>
                <a:gd name="connsiteY38" fmla="*/ 559959 h 1271820"/>
                <a:gd name="connsiteX39" fmla="*/ 452732 w 487049"/>
                <a:gd name="connsiteY39" fmla="*/ 586765 h 1271820"/>
                <a:gd name="connsiteX40" fmla="*/ 464646 w 487049"/>
                <a:gd name="connsiteY40" fmla="*/ 613572 h 1271820"/>
                <a:gd name="connsiteX41" fmla="*/ 470603 w 487049"/>
                <a:gd name="connsiteY41" fmla="*/ 631443 h 1271820"/>
                <a:gd name="connsiteX42" fmla="*/ 482517 w 487049"/>
                <a:gd name="connsiteY42" fmla="*/ 658249 h 1271820"/>
                <a:gd name="connsiteX43" fmla="*/ 485496 w 487049"/>
                <a:gd name="connsiteY43" fmla="*/ 670163 h 1271820"/>
                <a:gd name="connsiteX44" fmla="*/ 470603 w 487049"/>
                <a:gd name="connsiteY44" fmla="*/ 732712 h 1271820"/>
                <a:gd name="connsiteX45" fmla="*/ 458689 w 487049"/>
                <a:gd name="connsiteY45" fmla="*/ 735690 h 1271820"/>
                <a:gd name="connsiteX46" fmla="*/ 446775 w 487049"/>
                <a:gd name="connsiteY46" fmla="*/ 777389 h 1271820"/>
                <a:gd name="connsiteX47" fmla="*/ 452732 w 487049"/>
                <a:gd name="connsiteY47" fmla="*/ 786325 h 1271820"/>
                <a:gd name="connsiteX48" fmla="*/ 455711 w 487049"/>
                <a:gd name="connsiteY48" fmla="*/ 801217 h 1271820"/>
                <a:gd name="connsiteX49" fmla="*/ 467625 w 487049"/>
                <a:gd name="connsiteY49" fmla="*/ 813131 h 1271820"/>
                <a:gd name="connsiteX50" fmla="*/ 455711 w 487049"/>
                <a:gd name="connsiteY50" fmla="*/ 845895 h 1271820"/>
                <a:gd name="connsiteX51" fmla="*/ 446775 w 487049"/>
                <a:gd name="connsiteY51" fmla="*/ 857809 h 1271820"/>
                <a:gd name="connsiteX52" fmla="*/ 440818 w 487049"/>
                <a:gd name="connsiteY52" fmla="*/ 872701 h 1271820"/>
                <a:gd name="connsiteX53" fmla="*/ 437840 w 487049"/>
                <a:gd name="connsiteY53" fmla="*/ 887594 h 1271820"/>
                <a:gd name="connsiteX54" fmla="*/ 425926 w 487049"/>
                <a:gd name="connsiteY54" fmla="*/ 905465 h 1271820"/>
                <a:gd name="connsiteX55" fmla="*/ 419969 w 487049"/>
                <a:gd name="connsiteY55" fmla="*/ 914400 h 1271820"/>
                <a:gd name="connsiteX56" fmla="*/ 405076 w 487049"/>
                <a:gd name="connsiteY56" fmla="*/ 941207 h 1271820"/>
                <a:gd name="connsiteX57" fmla="*/ 402098 w 487049"/>
                <a:gd name="connsiteY57" fmla="*/ 950142 h 1271820"/>
                <a:gd name="connsiteX58" fmla="*/ 393162 w 487049"/>
                <a:gd name="connsiteY58" fmla="*/ 959078 h 1271820"/>
                <a:gd name="connsiteX59" fmla="*/ 390184 w 487049"/>
                <a:gd name="connsiteY59" fmla="*/ 973970 h 1271820"/>
                <a:gd name="connsiteX60" fmla="*/ 381248 w 487049"/>
                <a:gd name="connsiteY60" fmla="*/ 994820 h 1271820"/>
                <a:gd name="connsiteX61" fmla="*/ 372313 w 487049"/>
                <a:gd name="connsiteY61" fmla="*/ 1003755 h 1271820"/>
                <a:gd name="connsiteX62" fmla="*/ 369334 w 487049"/>
                <a:gd name="connsiteY62" fmla="*/ 1012691 h 1271820"/>
                <a:gd name="connsiteX63" fmla="*/ 333592 w 487049"/>
                <a:gd name="connsiteY63" fmla="*/ 1030562 h 1271820"/>
                <a:gd name="connsiteX64" fmla="*/ 306786 w 487049"/>
                <a:gd name="connsiteY64" fmla="*/ 1033540 h 1271820"/>
                <a:gd name="connsiteX65" fmla="*/ 288915 w 487049"/>
                <a:gd name="connsiteY65" fmla="*/ 1039497 h 1271820"/>
                <a:gd name="connsiteX66" fmla="*/ 262108 w 487049"/>
                <a:gd name="connsiteY66" fmla="*/ 1045454 h 1271820"/>
                <a:gd name="connsiteX67" fmla="*/ 235302 w 487049"/>
                <a:gd name="connsiteY67" fmla="*/ 1057368 h 1271820"/>
                <a:gd name="connsiteX68" fmla="*/ 223388 w 487049"/>
                <a:gd name="connsiteY68" fmla="*/ 1075239 h 1271820"/>
                <a:gd name="connsiteX69" fmla="*/ 208495 w 487049"/>
                <a:gd name="connsiteY69" fmla="*/ 1093110 h 1271820"/>
                <a:gd name="connsiteX70" fmla="*/ 205517 w 487049"/>
                <a:gd name="connsiteY70" fmla="*/ 1102046 h 1271820"/>
                <a:gd name="connsiteX71" fmla="*/ 196581 w 487049"/>
                <a:gd name="connsiteY71" fmla="*/ 1108003 h 1271820"/>
                <a:gd name="connsiteX72" fmla="*/ 190624 w 487049"/>
                <a:gd name="connsiteY72" fmla="*/ 1131831 h 1271820"/>
                <a:gd name="connsiteX73" fmla="*/ 181689 w 487049"/>
                <a:gd name="connsiteY73" fmla="*/ 1152680 h 1271820"/>
                <a:gd name="connsiteX74" fmla="*/ 178710 w 487049"/>
                <a:gd name="connsiteY74" fmla="*/ 1212250 h 1271820"/>
                <a:gd name="connsiteX75" fmla="*/ 169775 w 487049"/>
                <a:gd name="connsiteY75" fmla="*/ 1271820 h 1271820"/>
                <a:gd name="connsiteX76" fmla="*/ 154882 w 487049"/>
                <a:gd name="connsiteY76" fmla="*/ 1265863 h 1271820"/>
                <a:gd name="connsiteX77" fmla="*/ 145947 w 487049"/>
                <a:gd name="connsiteY77" fmla="*/ 1256928 h 1271820"/>
                <a:gd name="connsiteX78" fmla="*/ 134033 w 487049"/>
                <a:gd name="connsiteY78" fmla="*/ 1236078 h 1271820"/>
                <a:gd name="connsiteX79" fmla="*/ 110205 w 487049"/>
                <a:gd name="connsiteY79" fmla="*/ 1212250 h 1271820"/>
                <a:gd name="connsiteX80" fmla="*/ 101269 w 487049"/>
                <a:gd name="connsiteY80" fmla="*/ 1203315 h 1271820"/>
                <a:gd name="connsiteX81" fmla="*/ 89355 w 487049"/>
                <a:gd name="connsiteY81" fmla="*/ 1206293 h 1271820"/>
                <a:gd name="connsiteX82" fmla="*/ 86377 w 487049"/>
                <a:gd name="connsiteY82" fmla="*/ 1227143 h 1271820"/>
                <a:gd name="connsiteX83" fmla="*/ 83398 w 487049"/>
                <a:gd name="connsiteY83" fmla="*/ 1236078 h 1271820"/>
                <a:gd name="connsiteX84" fmla="*/ 71484 w 487049"/>
                <a:gd name="connsiteY84" fmla="*/ 1242035 h 1271820"/>
                <a:gd name="connsiteX85" fmla="*/ 14893 w 487049"/>
                <a:gd name="connsiteY85" fmla="*/ 1247992 h 1271820"/>
                <a:gd name="connsiteX86" fmla="*/ 11914 w 487049"/>
                <a:gd name="connsiteY86" fmla="*/ 1259906 h 1271820"/>
                <a:gd name="connsiteX87" fmla="*/ 2978 w 487049"/>
                <a:gd name="connsiteY87" fmla="*/ 1262885 h 1271820"/>
                <a:gd name="connsiteX88" fmla="*/ 0 w 487049"/>
                <a:gd name="connsiteY88" fmla="*/ 1265863 h 12718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</a:cxnLst>
              <a:rect l="l" t="t" r="r" b="b"/>
              <a:pathLst>
                <a:path w="487049" h="1271820">
                  <a:moveTo>
                    <a:pt x="181689" y="0"/>
                  </a:moveTo>
                  <a:cubicBezTo>
                    <a:pt x="186653" y="4964"/>
                    <a:pt x="190965" y="10681"/>
                    <a:pt x="196581" y="14893"/>
                  </a:cubicBezTo>
                  <a:cubicBezTo>
                    <a:pt x="199093" y="16777"/>
                    <a:pt x="202709" y="16467"/>
                    <a:pt x="205517" y="17871"/>
                  </a:cubicBezTo>
                  <a:cubicBezTo>
                    <a:pt x="228621" y="29422"/>
                    <a:pt x="200919" y="19317"/>
                    <a:pt x="223388" y="26807"/>
                  </a:cubicBezTo>
                  <a:cubicBezTo>
                    <a:pt x="226366" y="29785"/>
                    <a:pt x="228896" y="33294"/>
                    <a:pt x="232323" y="35742"/>
                  </a:cubicBezTo>
                  <a:cubicBezTo>
                    <a:pt x="235936" y="38323"/>
                    <a:pt x="240826" y="38856"/>
                    <a:pt x="244237" y="41699"/>
                  </a:cubicBezTo>
                  <a:cubicBezTo>
                    <a:pt x="246987" y="43991"/>
                    <a:pt x="247902" y="47885"/>
                    <a:pt x="250194" y="50635"/>
                  </a:cubicBezTo>
                  <a:cubicBezTo>
                    <a:pt x="252891" y="53871"/>
                    <a:pt x="255894" y="56873"/>
                    <a:pt x="259130" y="59570"/>
                  </a:cubicBezTo>
                  <a:cubicBezTo>
                    <a:pt x="261880" y="61862"/>
                    <a:pt x="264863" y="63926"/>
                    <a:pt x="268065" y="65527"/>
                  </a:cubicBezTo>
                  <a:cubicBezTo>
                    <a:pt x="272341" y="67665"/>
                    <a:pt x="285093" y="70529"/>
                    <a:pt x="288915" y="71484"/>
                  </a:cubicBezTo>
                  <a:cubicBezTo>
                    <a:pt x="297850" y="70491"/>
                    <a:pt x="307272" y="71578"/>
                    <a:pt x="315721" y="68506"/>
                  </a:cubicBezTo>
                  <a:cubicBezTo>
                    <a:pt x="319085" y="67283"/>
                    <a:pt x="318101" y="59713"/>
                    <a:pt x="321678" y="59570"/>
                  </a:cubicBezTo>
                  <a:cubicBezTo>
                    <a:pt x="344581" y="58654"/>
                    <a:pt x="367349" y="63541"/>
                    <a:pt x="390184" y="65527"/>
                  </a:cubicBezTo>
                  <a:cubicBezTo>
                    <a:pt x="393162" y="67513"/>
                    <a:pt x="398136" y="68042"/>
                    <a:pt x="399119" y="71484"/>
                  </a:cubicBezTo>
                  <a:cubicBezTo>
                    <a:pt x="403987" y="88522"/>
                    <a:pt x="393025" y="86050"/>
                    <a:pt x="384227" y="92334"/>
                  </a:cubicBezTo>
                  <a:cubicBezTo>
                    <a:pt x="380799" y="94782"/>
                    <a:pt x="378948" y="99179"/>
                    <a:pt x="375291" y="101269"/>
                  </a:cubicBezTo>
                  <a:cubicBezTo>
                    <a:pt x="371737" y="103300"/>
                    <a:pt x="367298" y="103072"/>
                    <a:pt x="363377" y="104248"/>
                  </a:cubicBezTo>
                  <a:cubicBezTo>
                    <a:pt x="357363" y="106052"/>
                    <a:pt x="345506" y="110205"/>
                    <a:pt x="345506" y="110205"/>
                  </a:cubicBezTo>
                  <a:cubicBezTo>
                    <a:pt x="328435" y="135810"/>
                    <a:pt x="348902" y="103413"/>
                    <a:pt x="336571" y="128076"/>
                  </a:cubicBezTo>
                  <a:cubicBezTo>
                    <a:pt x="334970" y="131278"/>
                    <a:pt x="332215" y="133809"/>
                    <a:pt x="330614" y="137011"/>
                  </a:cubicBezTo>
                  <a:cubicBezTo>
                    <a:pt x="318282" y="161673"/>
                    <a:pt x="338749" y="129277"/>
                    <a:pt x="321678" y="154882"/>
                  </a:cubicBezTo>
                  <a:cubicBezTo>
                    <a:pt x="320685" y="159846"/>
                    <a:pt x="320478" y="165035"/>
                    <a:pt x="318700" y="169775"/>
                  </a:cubicBezTo>
                  <a:cubicBezTo>
                    <a:pt x="317443" y="173127"/>
                    <a:pt x="312815" y="175131"/>
                    <a:pt x="312743" y="178710"/>
                  </a:cubicBezTo>
                  <a:cubicBezTo>
                    <a:pt x="311810" y="225375"/>
                    <a:pt x="313351" y="272086"/>
                    <a:pt x="315721" y="318700"/>
                  </a:cubicBezTo>
                  <a:cubicBezTo>
                    <a:pt x="316334" y="330763"/>
                    <a:pt x="319452" y="342571"/>
                    <a:pt x="321678" y="354442"/>
                  </a:cubicBezTo>
                  <a:cubicBezTo>
                    <a:pt x="322517" y="358915"/>
                    <a:pt x="325588" y="370515"/>
                    <a:pt x="327635" y="375291"/>
                  </a:cubicBezTo>
                  <a:cubicBezTo>
                    <a:pt x="329384" y="379372"/>
                    <a:pt x="331011" y="383592"/>
                    <a:pt x="333592" y="387205"/>
                  </a:cubicBezTo>
                  <a:cubicBezTo>
                    <a:pt x="338804" y="394502"/>
                    <a:pt x="344338" y="397348"/>
                    <a:pt x="351463" y="402098"/>
                  </a:cubicBezTo>
                  <a:cubicBezTo>
                    <a:pt x="355434" y="408055"/>
                    <a:pt x="358315" y="414907"/>
                    <a:pt x="363377" y="419969"/>
                  </a:cubicBezTo>
                  <a:lnTo>
                    <a:pt x="381248" y="437840"/>
                  </a:lnTo>
                  <a:cubicBezTo>
                    <a:pt x="386710" y="454223"/>
                    <a:pt x="380945" y="439543"/>
                    <a:pt x="390184" y="455711"/>
                  </a:cubicBezTo>
                  <a:cubicBezTo>
                    <a:pt x="392387" y="459566"/>
                    <a:pt x="393560" y="464012"/>
                    <a:pt x="396141" y="467625"/>
                  </a:cubicBezTo>
                  <a:cubicBezTo>
                    <a:pt x="398589" y="471052"/>
                    <a:pt x="402380" y="473324"/>
                    <a:pt x="405076" y="476560"/>
                  </a:cubicBezTo>
                  <a:cubicBezTo>
                    <a:pt x="407368" y="479310"/>
                    <a:pt x="409047" y="482517"/>
                    <a:pt x="411033" y="485496"/>
                  </a:cubicBezTo>
                  <a:cubicBezTo>
                    <a:pt x="412026" y="489467"/>
                    <a:pt x="413124" y="493414"/>
                    <a:pt x="414012" y="497410"/>
                  </a:cubicBezTo>
                  <a:cubicBezTo>
                    <a:pt x="415110" y="502352"/>
                    <a:pt x="414895" y="507694"/>
                    <a:pt x="416990" y="512303"/>
                  </a:cubicBezTo>
                  <a:cubicBezTo>
                    <a:pt x="419952" y="518821"/>
                    <a:pt x="426640" y="523382"/>
                    <a:pt x="428904" y="530174"/>
                  </a:cubicBezTo>
                  <a:cubicBezTo>
                    <a:pt x="430697" y="535553"/>
                    <a:pt x="435616" y="550889"/>
                    <a:pt x="437840" y="554002"/>
                  </a:cubicBezTo>
                  <a:cubicBezTo>
                    <a:pt x="439921" y="556915"/>
                    <a:pt x="443797" y="557973"/>
                    <a:pt x="446775" y="559959"/>
                  </a:cubicBezTo>
                  <a:cubicBezTo>
                    <a:pt x="447954" y="565851"/>
                    <a:pt x="450631" y="580463"/>
                    <a:pt x="452732" y="586765"/>
                  </a:cubicBezTo>
                  <a:cubicBezTo>
                    <a:pt x="462782" y="616916"/>
                    <a:pt x="454269" y="587629"/>
                    <a:pt x="464646" y="613572"/>
                  </a:cubicBezTo>
                  <a:cubicBezTo>
                    <a:pt x="466978" y="619402"/>
                    <a:pt x="467795" y="625827"/>
                    <a:pt x="470603" y="631443"/>
                  </a:cubicBezTo>
                  <a:cubicBezTo>
                    <a:pt x="475793" y="641823"/>
                    <a:pt x="478714" y="646840"/>
                    <a:pt x="482517" y="658249"/>
                  </a:cubicBezTo>
                  <a:cubicBezTo>
                    <a:pt x="483812" y="662132"/>
                    <a:pt x="484503" y="666192"/>
                    <a:pt x="485496" y="670163"/>
                  </a:cubicBezTo>
                  <a:cubicBezTo>
                    <a:pt x="483593" y="704408"/>
                    <a:pt x="496461" y="719783"/>
                    <a:pt x="470603" y="732712"/>
                  </a:cubicBezTo>
                  <a:cubicBezTo>
                    <a:pt x="466942" y="734543"/>
                    <a:pt x="462660" y="734697"/>
                    <a:pt x="458689" y="735690"/>
                  </a:cubicBezTo>
                  <a:cubicBezTo>
                    <a:pt x="434719" y="751670"/>
                    <a:pt x="436125" y="742776"/>
                    <a:pt x="446775" y="777389"/>
                  </a:cubicBezTo>
                  <a:cubicBezTo>
                    <a:pt x="447828" y="780811"/>
                    <a:pt x="450746" y="783346"/>
                    <a:pt x="452732" y="786325"/>
                  </a:cubicBezTo>
                  <a:cubicBezTo>
                    <a:pt x="453725" y="791289"/>
                    <a:pt x="453252" y="796792"/>
                    <a:pt x="455711" y="801217"/>
                  </a:cubicBezTo>
                  <a:cubicBezTo>
                    <a:pt x="458439" y="806126"/>
                    <a:pt x="466702" y="807591"/>
                    <a:pt x="467625" y="813131"/>
                  </a:cubicBezTo>
                  <a:cubicBezTo>
                    <a:pt x="469698" y="825571"/>
                    <a:pt x="462318" y="836645"/>
                    <a:pt x="455711" y="845895"/>
                  </a:cubicBezTo>
                  <a:cubicBezTo>
                    <a:pt x="452826" y="849935"/>
                    <a:pt x="449186" y="853470"/>
                    <a:pt x="446775" y="857809"/>
                  </a:cubicBezTo>
                  <a:cubicBezTo>
                    <a:pt x="444178" y="862483"/>
                    <a:pt x="442804" y="867737"/>
                    <a:pt x="440818" y="872701"/>
                  </a:cubicBezTo>
                  <a:cubicBezTo>
                    <a:pt x="439825" y="877665"/>
                    <a:pt x="439935" y="882985"/>
                    <a:pt x="437840" y="887594"/>
                  </a:cubicBezTo>
                  <a:cubicBezTo>
                    <a:pt x="434878" y="894112"/>
                    <a:pt x="429897" y="899508"/>
                    <a:pt x="425926" y="905465"/>
                  </a:cubicBezTo>
                  <a:cubicBezTo>
                    <a:pt x="423940" y="908443"/>
                    <a:pt x="421101" y="911004"/>
                    <a:pt x="419969" y="914400"/>
                  </a:cubicBezTo>
                  <a:cubicBezTo>
                    <a:pt x="414726" y="930128"/>
                    <a:pt x="418732" y="920724"/>
                    <a:pt x="405076" y="941207"/>
                  </a:cubicBezTo>
                  <a:cubicBezTo>
                    <a:pt x="404083" y="944185"/>
                    <a:pt x="403839" y="947530"/>
                    <a:pt x="402098" y="950142"/>
                  </a:cubicBezTo>
                  <a:cubicBezTo>
                    <a:pt x="399761" y="953647"/>
                    <a:pt x="395046" y="955310"/>
                    <a:pt x="393162" y="959078"/>
                  </a:cubicBezTo>
                  <a:cubicBezTo>
                    <a:pt x="390898" y="963606"/>
                    <a:pt x="391412" y="969059"/>
                    <a:pt x="390184" y="973970"/>
                  </a:cubicBezTo>
                  <a:cubicBezTo>
                    <a:pt x="388688" y="979952"/>
                    <a:pt x="384526" y="990231"/>
                    <a:pt x="381248" y="994820"/>
                  </a:cubicBezTo>
                  <a:cubicBezTo>
                    <a:pt x="378800" y="998247"/>
                    <a:pt x="375291" y="1000777"/>
                    <a:pt x="372313" y="1003755"/>
                  </a:cubicBezTo>
                  <a:cubicBezTo>
                    <a:pt x="371320" y="1006734"/>
                    <a:pt x="371076" y="1010079"/>
                    <a:pt x="369334" y="1012691"/>
                  </a:cubicBezTo>
                  <a:cubicBezTo>
                    <a:pt x="361039" y="1025133"/>
                    <a:pt x="348069" y="1027345"/>
                    <a:pt x="333592" y="1030562"/>
                  </a:cubicBezTo>
                  <a:cubicBezTo>
                    <a:pt x="324816" y="1032512"/>
                    <a:pt x="315721" y="1032547"/>
                    <a:pt x="306786" y="1033540"/>
                  </a:cubicBezTo>
                  <a:cubicBezTo>
                    <a:pt x="300829" y="1035526"/>
                    <a:pt x="294973" y="1037845"/>
                    <a:pt x="288915" y="1039497"/>
                  </a:cubicBezTo>
                  <a:cubicBezTo>
                    <a:pt x="275949" y="1043033"/>
                    <a:pt x="274129" y="1041447"/>
                    <a:pt x="262108" y="1045454"/>
                  </a:cubicBezTo>
                  <a:cubicBezTo>
                    <a:pt x="250702" y="1049256"/>
                    <a:pt x="245680" y="1052179"/>
                    <a:pt x="235302" y="1057368"/>
                  </a:cubicBezTo>
                  <a:cubicBezTo>
                    <a:pt x="231331" y="1063325"/>
                    <a:pt x="228450" y="1070177"/>
                    <a:pt x="223388" y="1075239"/>
                  </a:cubicBezTo>
                  <a:cubicBezTo>
                    <a:pt x="211921" y="1086706"/>
                    <a:pt x="216789" y="1080670"/>
                    <a:pt x="208495" y="1093110"/>
                  </a:cubicBezTo>
                  <a:cubicBezTo>
                    <a:pt x="207502" y="1096089"/>
                    <a:pt x="207478" y="1099594"/>
                    <a:pt x="205517" y="1102046"/>
                  </a:cubicBezTo>
                  <a:cubicBezTo>
                    <a:pt x="203281" y="1104841"/>
                    <a:pt x="198182" y="1104801"/>
                    <a:pt x="196581" y="1108003"/>
                  </a:cubicBezTo>
                  <a:cubicBezTo>
                    <a:pt x="192920" y="1115326"/>
                    <a:pt x="193213" y="1124064"/>
                    <a:pt x="190624" y="1131831"/>
                  </a:cubicBezTo>
                  <a:cubicBezTo>
                    <a:pt x="186242" y="1144978"/>
                    <a:pt x="189050" y="1137958"/>
                    <a:pt x="181689" y="1152680"/>
                  </a:cubicBezTo>
                  <a:cubicBezTo>
                    <a:pt x="180696" y="1172537"/>
                    <a:pt x="179783" y="1192398"/>
                    <a:pt x="178710" y="1212250"/>
                  </a:cubicBezTo>
                  <a:cubicBezTo>
                    <a:pt x="175803" y="1266037"/>
                    <a:pt x="185052" y="1248907"/>
                    <a:pt x="169775" y="1271820"/>
                  </a:cubicBezTo>
                  <a:cubicBezTo>
                    <a:pt x="164811" y="1269834"/>
                    <a:pt x="159416" y="1268697"/>
                    <a:pt x="154882" y="1265863"/>
                  </a:cubicBezTo>
                  <a:cubicBezTo>
                    <a:pt x="151310" y="1263631"/>
                    <a:pt x="148395" y="1260355"/>
                    <a:pt x="145947" y="1256928"/>
                  </a:cubicBezTo>
                  <a:cubicBezTo>
                    <a:pt x="137200" y="1244682"/>
                    <a:pt x="143412" y="1246395"/>
                    <a:pt x="134033" y="1236078"/>
                  </a:cubicBezTo>
                  <a:cubicBezTo>
                    <a:pt x="126477" y="1227766"/>
                    <a:pt x="118148" y="1220193"/>
                    <a:pt x="110205" y="1212250"/>
                  </a:cubicBezTo>
                  <a:lnTo>
                    <a:pt x="101269" y="1203315"/>
                  </a:lnTo>
                  <a:cubicBezTo>
                    <a:pt x="97298" y="1204308"/>
                    <a:pt x="91525" y="1202822"/>
                    <a:pt x="89355" y="1206293"/>
                  </a:cubicBezTo>
                  <a:cubicBezTo>
                    <a:pt x="85634" y="1212246"/>
                    <a:pt x="87754" y="1220259"/>
                    <a:pt x="86377" y="1227143"/>
                  </a:cubicBezTo>
                  <a:cubicBezTo>
                    <a:pt x="85761" y="1230222"/>
                    <a:pt x="85618" y="1233858"/>
                    <a:pt x="83398" y="1236078"/>
                  </a:cubicBezTo>
                  <a:cubicBezTo>
                    <a:pt x="80258" y="1239218"/>
                    <a:pt x="75792" y="1240958"/>
                    <a:pt x="71484" y="1242035"/>
                  </a:cubicBezTo>
                  <a:cubicBezTo>
                    <a:pt x="64040" y="1243896"/>
                    <a:pt x="18275" y="1247685"/>
                    <a:pt x="14893" y="1247992"/>
                  </a:cubicBezTo>
                  <a:cubicBezTo>
                    <a:pt x="13900" y="1251963"/>
                    <a:pt x="14471" y="1256710"/>
                    <a:pt x="11914" y="1259906"/>
                  </a:cubicBezTo>
                  <a:cubicBezTo>
                    <a:pt x="9953" y="1262358"/>
                    <a:pt x="5786" y="1261481"/>
                    <a:pt x="2978" y="1262885"/>
                  </a:cubicBezTo>
                  <a:cubicBezTo>
                    <a:pt x="1722" y="1263513"/>
                    <a:pt x="993" y="1264870"/>
                    <a:pt x="0" y="1265863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フリーフォーム: 図形 19">
              <a:extLst>
                <a:ext uri="{FF2B5EF4-FFF2-40B4-BE49-F238E27FC236}">
                  <a16:creationId xmlns:a16="http://schemas.microsoft.com/office/drawing/2014/main" id="{A0C6E92A-C719-4EFC-8C87-170B19F434A7}"/>
                </a:ext>
              </a:extLst>
            </p:cNvPr>
            <p:cNvSpPr/>
            <p:nvPr/>
          </p:nvSpPr>
          <p:spPr>
            <a:xfrm>
              <a:off x="3541438" y="3496761"/>
              <a:ext cx="2841491" cy="1605412"/>
            </a:xfrm>
            <a:custGeom>
              <a:avLst/>
              <a:gdLst>
                <a:gd name="connsiteX0" fmla="*/ 2841491 w 2841491"/>
                <a:gd name="connsiteY0" fmla="*/ 0 h 1605412"/>
                <a:gd name="connsiteX1" fmla="*/ 2826598 w 2841491"/>
                <a:gd name="connsiteY1" fmla="*/ 14892 h 1605412"/>
                <a:gd name="connsiteX2" fmla="*/ 2817663 w 2841491"/>
                <a:gd name="connsiteY2" fmla="*/ 56591 h 1605412"/>
                <a:gd name="connsiteX3" fmla="*/ 2808727 w 2841491"/>
                <a:gd name="connsiteY3" fmla="*/ 71484 h 1605412"/>
                <a:gd name="connsiteX4" fmla="*/ 2796813 w 2841491"/>
                <a:gd name="connsiteY4" fmla="*/ 104247 h 1605412"/>
                <a:gd name="connsiteX5" fmla="*/ 2787878 w 2841491"/>
                <a:gd name="connsiteY5" fmla="*/ 113183 h 1605412"/>
                <a:gd name="connsiteX6" fmla="*/ 2784899 w 2841491"/>
                <a:gd name="connsiteY6" fmla="*/ 128075 h 1605412"/>
                <a:gd name="connsiteX7" fmla="*/ 2772985 w 2841491"/>
                <a:gd name="connsiteY7" fmla="*/ 139989 h 1605412"/>
                <a:gd name="connsiteX8" fmla="*/ 2767028 w 2841491"/>
                <a:gd name="connsiteY8" fmla="*/ 148925 h 1605412"/>
                <a:gd name="connsiteX9" fmla="*/ 2758093 w 2841491"/>
                <a:gd name="connsiteY9" fmla="*/ 160839 h 1605412"/>
                <a:gd name="connsiteX10" fmla="*/ 2755114 w 2841491"/>
                <a:gd name="connsiteY10" fmla="*/ 172753 h 1605412"/>
                <a:gd name="connsiteX11" fmla="*/ 2740222 w 2841491"/>
                <a:gd name="connsiteY11" fmla="*/ 190624 h 1605412"/>
                <a:gd name="connsiteX12" fmla="*/ 2734265 w 2841491"/>
                <a:gd name="connsiteY12" fmla="*/ 199560 h 1605412"/>
                <a:gd name="connsiteX13" fmla="*/ 2734265 w 2841491"/>
                <a:gd name="connsiteY13" fmla="*/ 226366 h 1605412"/>
                <a:gd name="connsiteX14" fmla="*/ 2746179 w 2841491"/>
                <a:gd name="connsiteY14" fmla="*/ 244237 h 1605412"/>
                <a:gd name="connsiteX15" fmla="*/ 2755114 w 2841491"/>
                <a:gd name="connsiteY15" fmla="*/ 262108 h 1605412"/>
                <a:gd name="connsiteX16" fmla="*/ 2764050 w 2841491"/>
                <a:gd name="connsiteY16" fmla="*/ 271044 h 1605412"/>
                <a:gd name="connsiteX17" fmla="*/ 2770007 w 2841491"/>
                <a:gd name="connsiteY17" fmla="*/ 279979 h 1605412"/>
                <a:gd name="connsiteX18" fmla="*/ 2778942 w 2841491"/>
                <a:gd name="connsiteY18" fmla="*/ 291893 h 1605412"/>
                <a:gd name="connsiteX19" fmla="*/ 2778942 w 2841491"/>
                <a:gd name="connsiteY19" fmla="*/ 425926 h 1605412"/>
                <a:gd name="connsiteX20" fmla="*/ 2772985 w 2841491"/>
                <a:gd name="connsiteY20" fmla="*/ 434861 h 1605412"/>
                <a:gd name="connsiteX21" fmla="*/ 2755114 w 2841491"/>
                <a:gd name="connsiteY21" fmla="*/ 452732 h 1605412"/>
                <a:gd name="connsiteX22" fmla="*/ 2746179 w 2841491"/>
                <a:gd name="connsiteY22" fmla="*/ 461668 h 1605412"/>
                <a:gd name="connsiteX23" fmla="*/ 2731286 w 2841491"/>
                <a:gd name="connsiteY23" fmla="*/ 479539 h 1605412"/>
                <a:gd name="connsiteX24" fmla="*/ 2728308 w 2841491"/>
                <a:gd name="connsiteY24" fmla="*/ 488474 h 1605412"/>
                <a:gd name="connsiteX25" fmla="*/ 2725329 w 2841491"/>
                <a:gd name="connsiteY25" fmla="*/ 506345 h 1605412"/>
                <a:gd name="connsiteX26" fmla="*/ 2701501 w 2841491"/>
                <a:gd name="connsiteY26" fmla="*/ 530173 h 1605412"/>
                <a:gd name="connsiteX27" fmla="*/ 2683630 w 2841491"/>
                <a:gd name="connsiteY27" fmla="*/ 548044 h 1605412"/>
                <a:gd name="connsiteX28" fmla="*/ 2671716 w 2841491"/>
                <a:gd name="connsiteY28" fmla="*/ 559958 h 1605412"/>
                <a:gd name="connsiteX29" fmla="*/ 2650867 w 2841491"/>
                <a:gd name="connsiteY29" fmla="*/ 568894 h 1605412"/>
                <a:gd name="connsiteX30" fmla="*/ 2644910 w 2841491"/>
                <a:gd name="connsiteY30" fmla="*/ 577829 h 1605412"/>
                <a:gd name="connsiteX31" fmla="*/ 2635974 w 2841491"/>
                <a:gd name="connsiteY31" fmla="*/ 583786 h 1605412"/>
                <a:gd name="connsiteX32" fmla="*/ 2627039 w 2841491"/>
                <a:gd name="connsiteY32" fmla="*/ 592722 h 1605412"/>
                <a:gd name="connsiteX33" fmla="*/ 2618103 w 2841491"/>
                <a:gd name="connsiteY33" fmla="*/ 616550 h 1605412"/>
                <a:gd name="connsiteX34" fmla="*/ 2609168 w 2841491"/>
                <a:gd name="connsiteY34" fmla="*/ 631442 h 1605412"/>
                <a:gd name="connsiteX35" fmla="*/ 2600232 w 2841491"/>
                <a:gd name="connsiteY35" fmla="*/ 652292 h 1605412"/>
                <a:gd name="connsiteX36" fmla="*/ 2582361 w 2841491"/>
                <a:gd name="connsiteY36" fmla="*/ 661227 h 1605412"/>
                <a:gd name="connsiteX37" fmla="*/ 2567469 w 2841491"/>
                <a:gd name="connsiteY37" fmla="*/ 685055 h 1605412"/>
                <a:gd name="connsiteX38" fmla="*/ 2558533 w 2841491"/>
                <a:gd name="connsiteY38" fmla="*/ 693991 h 1605412"/>
                <a:gd name="connsiteX39" fmla="*/ 2555555 w 2841491"/>
                <a:gd name="connsiteY39" fmla="*/ 705905 h 1605412"/>
                <a:gd name="connsiteX40" fmla="*/ 2546619 w 2841491"/>
                <a:gd name="connsiteY40" fmla="*/ 711862 h 1605412"/>
                <a:gd name="connsiteX41" fmla="*/ 2540662 w 2841491"/>
                <a:gd name="connsiteY41" fmla="*/ 720797 h 1605412"/>
                <a:gd name="connsiteX42" fmla="*/ 2534705 w 2841491"/>
                <a:gd name="connsiteY42" fmla="*/ 744625 h 1605412"/>
                <a:gd name="connsiteX43" fmla="*/ 2522791 w 2841491"/>
                <a:gd name="connsiteY43" fmla="*/ 774410 h 1605412"/>
                <a:gd name="connsiteX44" fmla="*/ 2516834 w 2841491"/>
                <a:gd name="connsiteY44" fmla="*/ 810152 h 1605412"/>
                <a:gd name="connsiteX45" fmla="*/ 2513856 w 2841491"/>
                <a:gd name="connsiteY45" fmla="*/ 825045 h 1605412"/>
                <a:gd name="connsiteX46" fmla="*/ 2507899 w 2841491"/>
                <a:gd name="connsiteY46" fmla="*/ 833980 h 1605412"/>
                <a:gd name="connsiteX47" fmla="*/ 2513856 w 2841491"/>
                <a:gd name="connsiteY47" fmla="*/ 914400 h 1605412"/>
                <a:gd name="connsiteX48" fmla="*/ 2516834 w 2841491"/>
                <a:gd name="connsiteY48" fmla="*/ 929292 h 1605412"/>
                <a:gd name="connsiteX49" fmla="*/ 2531727 w 2841491"/>
                <a:gd name="connsiteY49" fmla="*/ 950142 h 1605412"/>
                <a:gd name="connsiteX50" fmla="*/ 2546619 w 2841491"/>
                <a:gd name="connsiteY50" fmla="*/ 976948 h 1605412"/>
                <a:gd name="connsiteX51" fmla="*/ 2558533 w 2841491"/>
                <a:gd name="connsiteY51" fmla="*/ 997798 h 1605412"/>
                <a:gd name="connsiteX52" fmla="*/ 2570447 w 2841491"/>
                <a:gd name="connsiteY52" fmla="*/ 1015669 h 1605412"/>
                <a:gd name="connsiteX53" fmla="*/ 2576404 w 2841491"/>
                <a:gd name="connsiteY53" fmla="*/ 1024604 h 1605412"/>
                <a:gd name="connsiteX54" fmla="*/ 2579383 w 2841491"/>
                <a:gd name="connsiteY54" fmla="*/ 1039497 h 1605412"/>
                <a:gd name="connsiteX55" fmla="*/ 2585340 w 2841491"/>
                <a:gd name="connsiteY55" fmla="*/ 1054389 h 1605412"/>
                <a:gd name="connsiteX56" fmla="*/ 2573426 w 2841491"/>
                <a:gd name="connsiteY56" fmla="*/ 1060346 h 1605412"/>
                <a:gd name="connsiteX57" fmla="*/ 2567469 w 2841491"/>
                <a:gd name="connsiteY57" fmla="*/ 1051411 h 1605412"/>
                <a:gd name="connsiteX58" fmla="*/ 2543641 w 2841491"/>
                <a:gd name="connsiteY58" fmla="*/ 1045454 h 1605412"/>
                <a:gd name="connsiteX59" fmla="*/ 2534705 w 2841491"/>
                <a:gd name="connsiteY59" fmla="*/ 1042475 h 1605412"/>
                <a:gd name="connsiteX60" fmla="*/ 2495985 w 2841491"/>
                <a:gd name="connsiteY60" fmla="*/ 1045454 h 1605412"/>
                <a:gd name="connsiteX61" fmla="*/ 2481092 w 2841491"/>
                <a:gd name="connsiteY61" fmla="*/ 1057368 h 1605412"/>
                <a:gd name="connsiteX62" fmla="*/ 2442372 w 2841491"/>
                <a:gd name="connsiteY62" fmla="*/ 1066303 h 1605412"/>
                <a:gd name="connsiteX63" fmla="*/ 2433436 w 2841491"/>
                <a:gd name="connsiteY63" fmla="*/ 1072260 h 1605412"/>
                <a:gd name="connsiteX64" fmla="*/ 2427479 w 2841491"/>
                <a:gd name="connsiteY64" fmla="*/ 1078218 h 1605412"/>
                <a:gd name="connsiteX65" fmla="*/ 2412587 w 2841491"/>
                <a:gd name="connsiteY65" fmla="*/ 1099067 h 1605412"/>
                <a:gd name="connsiteX66" fmla="*/ 2400673 w 2841491"/>
                <a:gd name="connsiteY66" fmla="*/ 1119917 h 1605412"/>
                <a:gd name="connsiteX67" fmla="*/ 2397694 w 2841491"/>
                <a:gd name="connsiteY67" fmla="*/ 1131831 h 1605412"/>
                <a:gd name="connsiteX68" fmla="*/ 2394716 w 2841491"/>
                <a:gd name="connsiteY68" fmla="*/ 1161616 h 1605412"/>
                <a:gd name="connsiteX69" fmla="*/ 2376845 w 2841491"/>
                <a:gd name="connsiteY69" fmla="*/ 1173530 h 1605412"/>
                <a:gd name="connsiteX70" fmla="*/ 2361952 w 2841491"/>
                <a:gd name="connsiteY70" fmla="*/ 1179487 h 1605412"/>
                <a:gd name="connsiteX71" fmla="*/ 2341103 w 2841491"/>
                <a:gd name="connsiteY71" fmla="*/ 1188422 h 1605412"/>
                <a:gd name="connsiteX72" fmla="*/ 2338124 w 2841491"/>
                <a:gd name="connsiteY72" fmla="*/ 1197358 h 1605412"/>
                <a:gd name="connsiteX73" fmla="*/ 2332167 w 2841491"/>
                <a:gd name="connsiteY73" fmla="*/ 1212250 h 1605412"/>
                <a:gd name="connsiteX74" fmla="*/ 2326210 w 2841491"/>
                <a:gd name="connsiteY74" fmla="*/ 1233100 h 1605412"/>
                <a:gd name="connsiteX75" fmla="*/ 2317275 w 2841491"/>
                <a:gd name="connsiteY75" fmla="*/ 1236078 h 1605412"/>
                <a:gd name="connsiteX76" fmla="*/ 2266640 w 2841491"/>
                <a:gd name="connsiteY76" fmla="*/ 1233100 h 1605412"/>
                <a:gd name="connsiteX77" fmla="*/ 2230898 w 2841491"/>
                <a:gd name="connsiteY77" fmla="*/ 1230121 h 1605412"/>
                <a:gd name="connsiteX78" fmla="*/ 2221963 w 2841491"/>
                <a:gd name="connsiteY78" fmla="*/ 1236078 h 1605412"/>
                <a:gd name="connsiteX79" fmla="*/ 2198135 w 2841491"/>
                <a:gd name="connsiteY79" fmla="*/ 1242035 h 1605412"/>
                <a:gd name="connsiteX80" fmla="*/ 2177285 w 2841491"/>
                <a:gd name="connsiteY80" fmla="*/ 1256928 h 1605412"/>
                <a:gd name="connsiteX81" fmla="*/ 2168350 w 2841491"/>
                <a:gd name="connsiteY81" fmla="*/ 1259906 h 1605412"/>
                <a:gd name="connsiteX82" fmla="*/ 2159414 w 2841491"/>
                <a:gd name="connsiteY82" fmla="*/ 1268842 h 1605412"/>
                <a:gd name="connsiteX83" fmla="*/ 2138565 w 2841491"/>
                <a:gd name="connsiteY83" fmla="*/ 1277777 h 1605412"/>
                <a:gd name="connsiteX84" fmla="*/ 2117715 w 2841491"/>
                <a:gd name="connsiteY84" fmla="*/ 1289691 h 1605412"/>
                <a:gd name="connsiteX85" fmla="*/ 2102823 w 2841491"/>
                <a:gd name="connsiteY85" fmla="*/ 1307562 h 1605412"/>
                <a:gd name="connsiteX86" fmla="*/ 2096866 w 2841491"/>
                <a:gd name="connsiteY86" fmla="*/ 1298627 h 1605412"/>
                <a:gd name="connsiteX87" fmla="*/ 2081973 w 2841491"/>
                <a:gd name="connsiteY87" fmla="*/ 1271820 h 1605412"/>
                <a:gd name="connsiteX88" fmla="*/ 2087930 w 2841491"/>
                <a:gd name="connsiteY88" fmla="*/ 1256928 h 1605412"/>
                <a:gd name="connsiteX89" fmla="*/ 2111758 w 2841491"/>
                <a:gd name="connsiteY89" fmla="*/ 1250971 h 1605412"/>
                <a:gd name="connsiteX90" fmla="*/ 2120694 w 2841491"/>
                <a:gd name="connsiteY90" fmla="*/ 1245014 h 1605412"/>
                <a:gd name="connsiteX91" fmla="*/ 2123672 w 2841491"/>
                <a:gd name="connsiteY91" fmla="*/ 1236078 h 1605412"/>
                <a:gd name="connsiteX92" fmla="*/ 2126651 w 2841491"/>
                <a:gd name="connsiteY92" fmla="*/ 1206293 h 1605412"/>
                <a:gd name="connsiteX93" fmla="*/ 2132608 w 2841491"/>
                <a:gd name="connsiteY93" fmla="*/ 1191401 h 1605412"/>
                <a:gd name="connsiteX94" fmla="*/ 2141543 w 2841491"/>
                <a:gd name="connsiteY94" fmla="*/ 1158637 h 1605412"/>
                <a:gd name="connsiteX95" fmla="*/ 2144522 w 2841491"/>
                <a:gd name="connsiteY95" fmla="*/ 1122895 h 1605412"/>
                <a:gd name="connsiteX96" fmla="*/ 2171328 w 2841491"/>
                <a:gd name="connsiteY96" fmla="*/ 1102046 h 1605412"/>
                <a:gd name="connsiteX97" fmla="*/ 2210049 w 2841491"/>
                <a:gd name="connsiteY97" fmla="*/ 1093110 h 1605412"/>
                <a:gd name="connsiteX98" fmla="*/ 2218984 w 2841491"/>
                <a:gd name="connsiteY98" fmla="*/ 1087153 h 1605412"/>
                <a:gd name="connsiteX99" fmla="*/ 2230898 w 2841491"/>
                <a:gd name="connsiteY99" fmla="*/ 1081196 h 1605412"/>
                <a:gd name="connsiteX100" fmla="*/ 2254726 w 2841491"/>
                <a:gd name="connsiteY100" fmla="*/ 1066303 h 1605412"/>
                <a:gd name="connsiteX101" fmla="*/ 2260683 w 2841491"/>
                <a:gd name="connsiteY101" fmla="*/ 1057368 h 1605412"/>
                <a:gd name="connsiteX102" fmla="*/ 2257705 w 2841491"/>
                <a:gd name="connsiteY102" fmla="*/ 1024604 h 1605412"/>
                <a:gd name="connsiteX103" fmla="*/ 2254726 w 2841491"/>
                <a:gd name="connsiteY103" fmla="*/ 1015669 h 1605412"/>
                <a:gd name="connsiteX104" fmla="*/ 2204092 w 2841491"/>
                <a:gd name="connsiteY104" fmla="*/ 1012690 h 1605412"/>
                <a:gd name="connsiteX105" fmla="*/ 2186221 w 2841491"/>
                <a:gd name="connsiteY105" fmla="*/ 1009712 h 1605412"/>
                <a:gd name="connsiteX106" fmla="*/ 2165371 w 2841491"/>
                <a:gd name="connsiteY106" fmla="*/ 1003755 h 1605412"/>
                <a:gd name="connsiteX107" fmla="*/ 2111758 w 2841491"/>
                <a:gd name="connsiteY107" fmla="*/ 1012690 h 1605412"/>
                <a:gd name="connsiteX108" fmla="*/ 2102823 w 2841491"/>
                <a:gd name="connsiteY108" fmla="*/ 1021626 h 1605412"/>
                <a:gd name="connsiteX109" fmla="*/ 2084952 w 2841491"/>
                <a:gd name="connsiteY109" fmla="*/ 1066303 h 1605412"/>
                <a:gd name="connsiteX110" fmla="*/ 2078995 w 2841491"/>
                <a:gd name="connsiteY110" fmla="*/ 1093110 h 1605412"/>
                <a:gd name="connsiteX111" fmla="*/ 2076016 w 2841491"/>
                <a:gd name="connsiteY111" fmla="*/ 1119917 h 1605412"/>
                <a:gd name="connsiteX112" fmla="*/ 2067081 w 2841491"/>
                <a:gd name="connsiteY112" fmla="*/ 1131831 h 1605412"/>
                <a:gd name="connsiteX113" fmla="*/ 2061124 w 2841491"/>
                <a:gd name="connsiteY113" fmla="*/ 1158637 h 1605412"/>
                <a:gd name="connsiteX114" fmla="*/ 2058145 w 2841491"/>
                <a:gd name="connsiteY114" fmla="*/ 1179487 h 1605412"/>
                <a:gd name="connsiteX115" fmla="*/ 2049210 w 2841491"/>
                <a:gd name="connsiteY115" fmla="*/ 1182465 h 1605412"/>
                <a:gd name="connsiteX116" fmla="*/ 2040274 w 2841491"/>
                <a:gd name="connsiteY116" fmla="*/ 1191401 h 1605412"/>
                <a:gd name="connsiteX117" fmla="*/ 1995597 w 2841491"/>
                <a:gd name="connsiteY117" fmla="*/ 1194379 h 1605412"/>
                <a:gd name="connsiteX118" fmla="*/ 1977726 w 2841491"/>
                <a:gd name="connsiteY118" fmla="*/ 1170551 h 1605412"/>
                <a:gd name="connsiteX119" fmla="*/ 1974747 w 2841491"/>
                <a:gd name="connsiteY119" fmla="*/ 1161616 h 1605412"/>
                <a:gd name="connsiteX120" fmla="*/ 1956876 w 2841491"/>
                <a:gd name="connsiteY120" fmla="*/ 1155659 h 1605412"/>
                <a:gd name="connsiteX121" fmla="*/ 1909220 w 2841491"/>
                <a:gd name="connsiteY121" fmla="*/ 1161616 h 1605412"/>
                <a:gd name="connsiteX122" fmla="*/ 1891349 w 2841491"/>
                <a:gd name="connsiteY122" fmla="*/ 1164594 h 1605412"/>
                <a:gd name="connsiteX123" fmla="*/ 1876456 w 2841491"/>
                <a:gd name="connsiteY123" fmla="*/ 1167573 h 1605412"/>
                <a:gd name="connsiteX124" fmla="*/ 1804972 w 2841491"/>
                <a:gd name="connsiteY124" fmla="*/ 1170551 h 1605412"/>
                <a:gd name="connsiteX125" fmla="*/ 1796037 w 2841491"/>
                <a:gd name="connsiteY125" fmla="*/ 1245014 h 1605412"/>
                <a:gd name="connsiteX126" fmla="*/ 1778166 w 2841491"/>
                <a:gd name="connsiteY126" fmla="*/ 1253949 h 1605412"/>
                <a:gd name="connsiteX127" fmla="*/ 1769230 w 2841491"/>
                <a:gd name="connsiteY127" fmla="*/ 1259906 h 1605412"/>
                <a:gd name="connsiteX128" fmla="*/ 1763273 w 2841491"/>
                <a:gd name="connsiteY128" fmla="*/ 1268842 h 1605412"/>
                <a:gd name="connsiteX129" fmla="*/ 1754338 w 2841491"/>
                <a:gd name="connsiteY129" fmla="*/ 1271820 h 1605412"/>
                <a:gd name="connsiteX130" fmla="*/ 1724553 w 2841491"/>
                <a:gd name="connsiteY130" fmla="*/ 1301605 h 1605412"/>
                <a:gd name="connsiteX131" fmla="*/ 1715617 w 2841491"/>
                <a:gd name="connsiteY131" fmla="*/ 1310541 h 1605412"/>
                <a:gd name="connsiteX132" fmla="*/ 1703703 w 2841491"/>
                <a:gd name="connsiteY132" fmla="*/ 1325433 h 1605412"/>
                <a:gd name="connsiteX133" fmla="*/ 1697746 w 2841491"/>
                <a:gd name="connsiteY133" fmla="*/ 1337347 h 1605412"/>
                <a:gd name="connsiteX134" fmla="*/ 1685832 w 2841491"/>
                <a:gd name="connsiteY134" fmla="*/ 1346283 h 1605412"/>
                <a:gd name="connsiteX135" fmla="*/ 1664983 w 2841491"/>
                <a:gd name="connsiteY135" fmla="*/ 1361175 h 1605412"/>
                <a:gd name="connsiteX136" fmla="*/ 1656047 w 2841491"/>
                <a:gd name="connsiteY136" fmla="*/ 1358197 h 1605412"/>
                <a:gd name="connsiteX137" fmla="*/ 1644133 w 2841491"/>
                <a:gd name="connsiteY137" fmla="*/ 1328412 h 1605412"/>
                <a:gd name="connsiteX138" fmla="*/ 1638176 w 2841491"/>
                <a:gd name="connsiteY138" fmla="*/ 1319476 h 1605412"/>
                <a:gd name="connsiteX139" fmla="*/ 1635198 w 2841491"/>
                <a:gd name="connsiteY139" fmla="*/ 1298627 h 1605412"/>
                <a:gd name="connsiteX140" fmla="*/ 1632219 w 2841491"/>
                <a:gd name="connsiteY140" fmla="*/ 1289691 h 1605412"/>
                <a:gd name="connsiteX141" fmla="*/ 1641155 w 2841491"/>
                <a:gd name="connsiteY141" fmla="*/ 1239057 h 1605412"/>
                <a:gd name="connsiteX142" fmla="*/ 1650090 w 2841491"/>
                <a:gd name="connsiteY142" fmla="*/ 1233100 h 1605412"/>
                <a:gd name="connsiteX143" fmla="*/ 1667961 w 2841491"/>
                <a:gd name="connsiteY143" fmla="*/ 1215229 h 1605412"/>
                <a:gd name="connsiteX144" fmla="*/ 1676897 w 2841491"/>
                <a:gd name="connsiteY144" fmla="*/ 1206293 h 1605412"/>
                <a:gd name="connsiteX145" fmla="*/ 1685832 w 2841491"/>
                <a:gd name="connsiteY145" fmla="*/ 1197358 h 1605412"/>
                <a:gd name="connsiteX146" fmla="*/ 1676897 w 2841491"/>
                <a:gd name="connsiteY146" fmla="*/ 1152680 h 1605412"/>
                <a:gd name="connsiteX147" fmla="*/ 1664983 w 2841491"/>
                <a:gd name="connsiteY147" fmla="*/ 1146723 h 1605412"/>
                <a:gd name="connsiteX148" fmla="*/ 1608391 w 2841491"/>
                <a:gd name="connsiteY148" fmla="*/ 1149702 h 1605412"/>
                <a:gd name="connsiteX149" fmla="*/ 1584563 w 2841491"/>
                <a:gd name="connsiteY149" fmla="*/ 1155659 h 1605412"/>
                <a:gd name="connsiteX150" fmla="*/ 1569671 w 2841491"/>
                <a:gd name="connsiteY150" fmla="*/ 1161616 h 1605412"/>
                <a:gd name="connsiteX151" fmla="*/ 1557757 w 2841491"/>
                <a:gd name="connsiteY151" fmla="*/ 1164594 h 1605412"/>
                <a:gd name="connsiteX152" fmla="*/ 1548821 w 2841491"/>
                <a:gd name="connsiteY152" fmla="*/ 1173530 h 1605412"/>
                <a:gd name="connsiteX153" fmla="*/ 1545843 w 2841491"/>
                <a:gd name="connsiteY153" fmla="*/ 1182465 h 1605412"/>
                <a:gd name="connsiteX154" fmla="*/ 1533929 w 2841491"/>
                <a:gd name="connsiteY154" fmla="*/ 1188422 h 1605412"/>
                <a:gd name="connsiteX155" fmla="*/ 1483294 w 2841491"/>
                <a:gd name="connsiteY155" fmla="*/ 1194379 h 1605412"/>
                <a:gd name="connsiteX156" fmla="*/ 1477337 w 2841491"/>
                <a:gd name="connsiteY156" fmla="*/ 1203315 h 1605412"/>
                <a:gd name="connsiteX157" fmla="*/ 1447552 w 2841491"/>
                <a:gd name="connsiteY157" fmla="*/ 1218207 h 1605412"/>
                <a:gd name="connsiteX158" fmla="*/ 1429681 w 2841491"/>
                <a:gd name="connsiteY158" fmla="*/ 1224164 h 1605412"/>
                <a:gd name="connsiteX159" fmla="*/ 1420746 w 2841491"/>
                <a:gd name="connsiteY159" fmla="*/ 1233100 h 1605412"/>
                <a:gd name="connsiteX160" fmla="*/ 1396918 w 2841491"/>
                <a:gd name="connsiteY160" fmla="*/ 1265863 h 1605412"/>
                <a:gd name="connsiteX161" fmla="*/ 1387982 w 2841491"/>
                <a:gd name="connsiteY161" fmla="*/ 1268842 h 1605412"/>
                <a:gd name="connsiteX162" fmla="*/ 1385004 w 2841491"/>
                <a:gd name="connsiteY162" fmla="*/ 1316498 h 1605412"/>
                <a:gd name="connsiteX163" fmla="*/ 1340326 w 2841491"/>
                <a:gd name="connsiteY163" fmla="*/ 1304584 h 1605412"/>
                <a:gd name="connsiteX164" fmla="*/ 1328412 w 2841491"/>
                <a:gd name="connsiteY164" fmla="*/ 1301605 h 1605412"/>
                <a:gd name="connsiteX165" fmla="*/ 1319477 w 2841491"/>
                <a:gd name="connsiteY165" fmla="*/ 1298627 h 1605412"/>
                <a:gd name="connsiteX166" fmla="*/ 1313520 w 2841491"/>
                <a:gd name="connsiteY166" fmla="*/ 1289691 h 1605412"/>
                <a:gd name="connsiteX167" fmla="*/ 1304584 w 2841491"/>
                <a:gd name="connsiteY167" fmla="*/ 1286713 h 1605412"/>
                <a:gd name="connsiteX168" fmla="*/ 1277778 w 2841491"/>
                <a:gd name="connsiteY168" fmla="*/ 1283734 h 1605412"/>
                <a:gd name="connsiteX169" fmla="*/ 1253950 w 2841491"/>
                <a:gd name="connsiteY169" fmla="*/ 1274799 h 1605412"/>
                <a:gd name="connsiteX170" fmla="*/ 1236079 w 2841491"/>
                <a:gd name="connsiteY170" fmla="*/ 1268842 h 1605412"/>
                <a:gd name="connsiteX171" fmla="*/ 1197358 w 2841491"/>
                <a:gd name="connsiteY171" fmla="*/ 1265863 h 1605412"/>
                <a:gd name="connsiteX172" fmla="*/ 1167573 w 2841491"/>
                <a:gd name="connsiteY172" fmla="*/ 1253949 h 1605412"/>
                <a:gd name="connsiteX173" fmla="*/ 1137788 w 2841491"/>
                <a:gd name="connsiteY173" fmla="*/ 1245014 h 1605412"/>
                <a:gd name="connsiteX174" fmla="*/ 1125874 w 2841491"/>
                <a:gd name="connsiteY174" fmla="*/ 1239057 h 1605412"/>
                <a:gd name="connsiteX175" fmla="*/ 1060347 w 2841491"/>
                <a:gd name="connsiteY175" fmla="*/ 1245014 h 1605412"/>
                <a:gd name="connsiteX176" fmla="*/ 1015669 w 2841491"/>
                <a:gd name="connsiteY176" fmla="*/ 1271820 h 1605412"/>
                <a:gd name="connsiteX177" fmla="*/ 1000777 w 2841491"/>
                <a:gd name="connsiteY177" fmla="*/ 1274799 h 1605412"/>
                <a:gd name="connsiteX178" fmla="*/ 917379 w 2841491"/>
                <a:gd name="connsiteY178" fmla="*/ 1271820 h 1605412"/>
                <a:gd name="connsiteX179" fmla="*/ 920357 w 2841491"/>
                <a:gd name="connsiteY179" fmla="*/ 1256928 h 1605412"/>
                <a:gd name="connsiteX180" fmla="*/ 935250 w 2841491"/>
                <a:gd name="connsiteY180" fmla="*/ 1253949 h 1605412"/>
                <a:gd name="connsiteX181" fmla="*/ 970992 w 2841491"/>
                <a:gd name="connsiteY181" fmla="*/ 1250971 h 1605412"/>
                <a:gd name="connsiteX182" fmla="*/ 991841 w 2841491"/>
                <a:gd name="connsiteY182" fmla="*/ 1227143 h 1605412"/>
                <a:gd name="connsiteX183" fmla="*/ 997798 w 2841491"/>
                <a:gd name="connsiteY183" fmla="*/ 1218207 h 1605412"/>
                <a:gd name="connsiteX184" fmla="*/ 962056 w 2841491"/>
                <a:gd name="connsiteY184" fmla="*/ 1215229 h 1605412"/>
                <a:gd name="connsiteX185" fmla="*/ 941207 w 2841491"/>
                <a:gd name="connsiteY185" fmla="*/ 1212250 h 1605412"/>
                <a:gd name="connsiteX186" fmla="*/ 938228 w 2841491"/>
                <a:gd name="connsiteY186" fmla="*/ 1200336 h 1605412"/>
                <a:gd name="connsiteX187" fmla="*/ 926314 w 2841491"/>
                <a:gd name="connsiteY187" fmla="*/ 1191401 h 1605412"/>
                <a:gd name="connsiteX188" fmla="*/ 911422 w 2841491"/>
                <a:gd name="connsiteY188" fmla="*/ 1173530 h 1605412"/>
                <a:gd name="connsiteX189" fmla="*/ 908443 w 2841491"/>
                <a:gd name="connsiteY189" fmla="*/ 1164594 h 1605412"/>
                <a:gd name="connsiteX190" fmla="*/ 893551 w 2841491"/>
                <a:gd name="connsiteY190" fmla="*/ 1167573 h 1605412"/>
                <a:gd name="connsiteX191" fmla="*/ 881637 w 2841491"/>
                <a:gd name="connsiteY191" fmla="*/ 1218207 h 1605412"/>
                <a:gd name="connsiteX192" fmla="*/ 878658 w 2841491"/>
                <a:gd name="connsiteY192" fmla="*/ 1227143 h 1605412"/>
                <a:gd name="connsiteX193" fmla="*/ 866744 w 2841491"/>
                <a:gd name="connsiteY193" fmla="*/ 1239057 h 1605412"/>
                <a:gd name="connsiteX194" fmla="*/ 854830 w 2841491"/>
                <a:gd name="connsiteY194" fmla="*/ 1221186 h 1605412"/>
                <a:gd name="connsiteX195" fmla="*/ 845895 w 2841491"/>
                <a:gd name="connsiteY195" fmla="*/ 1215229 h 1605412"/>
                <a:gd name="connsiteX196" fmla="*/ 839938 w 2841491"/>
                <a:gd name="connsiteY196" fmla="*/ 1203315 h 1605412"/>
                <a:gd name="connsiteX197" fmla="*/ 836959 w 2841491"/>
                <a:gd name="connsiteY197" fmla="*/ 1194379 h 1605412"/>
                <a:gd name="connsiteX198" fmla="*/ 831002 w 2841491"/>
                <a:gd name="connsiteY198" fmla="*/ 1182465 h 1605412"/>
                <a:gd name="connsiteX199" fmla="*/ 833981 w 2841491"/>
                <a:gd name="connsiteY199" fmla="*/ 1146723 h 1605412"/>
                <a:gd name="connsiteX200" fmla="*/ 839938 w 2841491"/>
                <a:gd name="connsiteY200" fmla="*/ 1131831 h 1605412"/>
                <a:gd name="connsiteX201" fmla="*/ 825045 w 2841491"/>
                <a:gd name="connsiteY201" fmla="*/ 1102046 h 1605412"/>
                <a:gd name="connsiteX202" fmla="*/ 789303 w 2841491"/>
                <a:gd name="connsiteY202" fmla="*/ 1105024 h 1605412"/>
                <a:gd name="connsiteX203" fmla="*/ 783346 w 2841491"/>
                <a:gd name="connsiteY203" fmla="*/ 1113960 h 1605412"/>
                <a:gd name="connsiteX204" fmla="*/ 774411 w 2841491"/>
                <a:gd name="connsiteY204" fmla="*/ 1122895 h 1605412"/>
                <a:gd name="connsiteX205" fmla="*/ 771432 w 2841491"/>
                <a:gd name="connsiteY205" fmla="*/ 1131831 h 1605412"/>
                <a:gd name="connsiteX206" fmla="*/ 756540 w 2841491"/>
                <a:gd name="connsiteY206" fmla="*/ 1149702 h 1605412"/>
                <a:gd name="connsiteX207" fmla="*/ 747604 w 2841491"/>
                <a:gd name="connsiteY207" fmla="*/ 1155659 h 1605412"/>
                <a:gd name="connsiteX208" fmla="*/ 744626 w 2841491"/>
                <a:gd name="connsiteY208" fmla="*/ 1164594 h 1605412"/>
                <a:gd name="connsiteX209" fmla="*/ 714841 w 2841491"/>
                <a:gd name="connsiteY209" fmla="*/ 1197358 h 1605412"/>
                <a:gd name="connsiteX210" fmla="*/ 708884 w 2841491"/>
                <a:gd name="connsiteY210" fmla="*/ 1206293 h 1605412"/>
                <a:gd name="connsiteX211" fmla="*/ 711862 w 2841491"/>
                <a:gd name="connsiteY211" fmla="*/ 1227143 h 1605412"/>
                <a:gd name="connsiteX212" fmla="*/ 720798 w 2841491"/>
                <a:gd name="connsiteY212" fmla="*/ 1233100 h 1605412"/>
                <a:gd name="connsiteX213" fmla="*/ 726755 w 2841491"/>
                <a:gd name="connsiteY213" fmla="*/ 1242035 h 1605412"/>
                <a:gd name="connsiteX214" fmla="*/ 747604 w 2841491"/>
                <a:gd name="connsiteY214" fmla="*/ 1250971 h 1605412"/>
                <a:gd name="connsiteX215" fmla="*/ 774411 w 2841491"/>
                <a:gd name="connsiteY215" fmla="*/ 1271820 h 1605412"/>
                <a:gd name="connsiteX216" fmla="*/ 789303 w 2841491"/>
                <a:gd name="connsiteY216" fmla="*/ 1280756 h 1605412"/>
                <a:gd name="connsiteX217" fmla="*/ 795260 w 2841491"/>
                <a:gd name="connsiteY217" fmla="*/ 1289691 h 1605412"/>
                <a:gd name="connsiteX218" fmla="*/ 813131 w 2841491"/>
                <a:gd name="connsiteY218" fmla="*/ 1304584 h 1605412"/>
                <a:gd name="connsiteX219" fmla="*/ 819088 w 2841491"/>
                <a:gd name="connsiteY219" fmla="*/ 1313519 h 1605412"/>
                <a:gd name="connsiteX220" fmla="*/ 798239 w 2841491"/>
                <a:gd name="connsiteY220" fmla="*/ 1346283 h 1605412"/>
                <a:gd name="connsiteX221" fmla="*/ 783346 w 2841491"/>
                <a:gd name="connsiteY221" fmla="*/ 1364154 h 1605412"/>
                <a:gd name="connsiteX222" fmla="*/ 780368 w 2841491"/>
                <a:gd name="connsiteY222" fmla="*/ 1373089 h 1605412"/>
                <a:gd name="connsiteX223" fmla="*/ 771432 w 2841491"/>
                <a:gd name="connsiteY223" fmla="*/ 1379046 h 1605412"/>
                <a:gd name="connsiteX224" fmla="*/ 762497 w 2841491"/>
                <a:gd name="connsiteY224" fmla="*/ 1387982 h 1605412"/>
                <a:gd name="connsiteX225" fmla="*/ 756540 w 2841491"/>
                <a:gd name="connsiteY225" fmla="*/ 1396917 h 1605412"/>
                <a:gd name="connsiteX226" fmla="*/ 741647 w 2841491"/>
                <a:gd name="connsiteY226" fmla="*/ 1399896 h 1605412"/>
                <a:gd name="connsiteX227" fmla="*/ 723776 w 2841491"/>
                <a:gd name="connsiteY227" fmla="*/ 1396917 h 1605412"/>
                <a:gd name="connsiteX228" fmla="*/ 732712 w 2841491"/>
                <a:gd name="connsiteY228" fmla="*/ 1361175 h 1605412"/>
                <a:gd name="connsiteX229" fmla="*/ 723776 w 2841491"/>
                <a:gd name="connsiteY229" fmla="*/ 1358197 h 1605412"/>
                <a:gd name="connsiteX230" fmla="*/ 711862 w 2841491"/>
                <a:gd name="connsiteY230" fmla="*/ 1355218 h 1605412"/>
                <a:gd name="connsiteX231" fmla="*/ 702927 w 2841491"/>
                <a:gd name="connsiteY231" fmla="*/ 1349261 h 1605412"/>
                <a:gd name="connsiteX232" fmla="*/ 655271 w 2841491"/>
                <a:gd name="connsiteY232" fmla="*/ 1352240 h 1605412"/>
                <a:gd name="connsiteX233" fmla="*/ 652292 w 2841491"/>
                <a:gd name="connsiteY233" fmla="*/ 1361175 h 1605412"/>
                <a:gd name="connsiteX234" fmla="*/ 637400 w 2841491"/>
                <a:gd name="connsiteY234" fmla="*/ 1379046 h 1605412"/>
                <a:gd name="connsiteX235" fmla="*/ 613572 w 2841491"/>
                <a:gd name="connsiteY235" fmla="*/ 1385003 h 1605412"/>
                <a:gd name="connsiteX236" fmla="*/ 604636 w 2841491"/>
                <a:gd name="connsiteY236" fmla="*/ 1387982 h 1605412"/>
                <a:gd name="connsiteX237" fmla="*/ 595701 w 2841491"/>
                <a:gd name="connsiteY237" fmla="*/ 1393939 h 1605412"/>
                <a:gd name="connsiteX238" fmla="*/ 539109 w 2841491"/>
                <a:gd name="connsiteY238" fmla="*/ 1396917 h 1605412"/>
                <a:gd name="connsiteX239" fmla="*/ 533152 w 2841491"/>
                <a:gd name="connsiteY239" fmla="*/ 1414788 h 1605412"/>
                <a:gd name="connsiteX240" fmla="*/ 524217 w 2841491"/>
                <a:gd name="connsiteY240" fmla="*/ 1420745 h 1605412"/>
                <a:gd name="connsiteX241" fmla="*/ 515281 w 2841491"/>
                <a:gd name="connsiteY241" fmla="*/ 1429681 h 1605412"/>
                <a:gd name="connsiteX242" fmla="*/ 482518 w 2841491"/>
                <a:gd name="connsiteY242" fmla="*/ 1441595 h 1605412"/>
                <a:gd name="connsiteX243" fmla="*/ 467625 w 2841491"/>
                <a:gd name="connsiteY243" fmla="*/ 1450530 h 1605412"/>
                <a:gd name="connsiteX244" fmla="*/ 437840 w 2841491"/>
                <a:gd name="connsiteY244" fmla="*/ 1453509 h 1605412"/>
                <a:gd name="connsiteX245" fmla="*/ 425926 w 2841491"/>
                <a:gd name="connsiteY245" fmla="*/ 1456487 h 1605412"/>
                <a:gd name="connsiteX246" fmla="*/ 408055 w 2841491"/>
                <a:gd name="connsiteY246" fmla="*/ 1471380 h 1605412"/>
                <a:gd name="connsiteX247" fmla="*/ 402098 w 2841491"/>
                <a:gd name="connsiteY247" fmla="*/ 1492229 h 1605412"/>
                <a:gd name="connsiteX248" fmla="*/ 393163 w 2841491"/>
                <a:gd name="connsiteY248" fmla="*/ 1516057 h 1605412"/>
                <a:gd name="connsiteX249" fmla="*/ 390184 w 2841491"/>
                <a:gd name="connsiteY249" fmla="*/ 1524993 h 1605412"/>
                <a:gd name="connsiteX250" fmla="*/ 387206 w 2841491"/>
                <a:gd name="connsiteY250" fmla="*/ 1536907 h 1605412"/>
                <a:gd name="connsiteX251" fmla="*/ 378270 w 2841491"/>
                <a:gd name="connsiteY251" fmla="*/ 1539885 h 1605412"/>
                <a:gd name="connsiteX252" fmla="*/ 366356 w 2841491"/>
                <a:gd name="connsiteY252" fmla="*/ 1545842 h 1605412"/>
                <a:gd name="connsiteX253" fmla="*/ 339550 w 2841491"/>
                <a:gd name="connsiteY253" fmla="*/ 1551799 h 1605412"/>
                <a:gd name="connsiteX254" fmla="*/ 324657 w 2841491"/>
                <a:gd name="connsiteY254" fmla="*/ 1560735 h 1605412"/>
                <a:gd name="connsiteX255" fmla="*/ 309765 w 2841491"/>
                <a:gd name="connsiteY255" fmla="*/ 1563713 h 1605412"/>
                <a:gd name="connsiteX256" fmla="*/ 297851 w 2841491"/>
                <a:gd name="connsiteY256" fmla="*/ 1566692 h 1605412"/>
                <a:gd name="connsiteX257" fmla="*/ 282958 w 2841491"/>
                <a:gd name="connsiteY257" fmla="*/ 1575627 h 1605412"/>
                <a:gd name="connsiteX258" fmla="*/ 274023 w 2841491"/>
                <a:gd name="connsiteY258" fmla="*/ 1578606 h 1605412"/>
                <a:gd name="connsiteX259" fmla="*/ 262109 w 2841491"/>
                <a:gd name="connsiteY259" fmla="*/ 1587541 h 1605412"/>
                <a:gd name="connsiteX260" fmla="*/ 253173 w 2841491"/>
                <a:gd name="connsiteY260" fmla="*/ 1596477 h 1605412"/>
                <a:gd name="connsiteX261" fmla="*/ 241259 w 2841491"/>
                <a:gd name="connsiteY261" fmla="*/ 1599455 h 1605412"/>
                <a:gd name="connsiteX262" fmla="*/ 220410 w 2841491"/>
                <a:gd name="connsiteY262" fmla="*/ 1605412 h 1605412"/>
                <a:gd name="connsiteX263" fmla="*/ 175732 w 2841491"/>
                <a:gd name="connsiteY263" fmla="*/ 1599455 h 1605412"/>
                <a:gd name="connsiteX264" fmla="*/ 169775 w 2841491"/>
                <a:gd name="connsiteY264" fmla="*/ 1590520 h 1605412"/>
                <a:gd name="connsiteX265" fmla="*/ 128076 w 2841491"/>
                <a:gd name="connsiteY265" fmla="*/ 1569670 h 1605412"/>
                <a:gd name="connsiteX266" fmla="*/ 119141 w 2841491"/>
                <a:gd name="connsiteY266" fmla="*/ 1557756 h 1605412"/>
                <a:gd name="connsiteX267" fmla="*/ 113183 w 2841491"/>
                <a:gd name="connsiteY267" fmla="*/ 1551799 h 1605412"/>
                <a:gd name="connsiteX268" fmla="*/ 101269 w 2841491"/>
                <a:gd name="connsiteY268" fmla="*/ 1536907 h 1605412"/>
                <a:gd name="connsiteX269" fmla="*/ 98291 w 2841491"/>
                <a:gd name="connsiteY269" fmla="*/ 1527971 h 1605412"/>
                <a:gd name="connsiteX270" fmla="*/ 77441 w 2841491"/>
                <a:gd name="connsiteY270" fmla="*/ 1516057 h 1605412"/>
                <a:gd name="connsiteX271" fmla="*/ 59570 w 2841491"/>
                <a:gd name="connsiteY271" fmla="*/ 1486272 h 1605412"/>
                <a:gd name="connsiteX272" fmla="*/ 47656 w 2841491"/>
                <a:gd name="connsiteY272" fmla="*/ 1468401 h 1605412"/>
                <a:gd name="connsiteX273" fmla="*/ 29785 w 2841491"/>
                <a:gd name="connsiteY273" fmla="*/ 1450530 h 1605412"/>
                <a:gd name="connsiteX274" fmla="*/ 14893 w 2841491"/>
                <a:gd name="connsiteY274" fmla="*/ 1432659 h 1605412"/>
                <a:gd name="connsiteX275" fmla="*/ 2979 w 2841491"/>
                <a:gd name="connsiteY275" fmla="*/ 1417767 h 1605412"/>
                <a:gd name="connsiteX276" fmla="*/ 0 w 2841491"/>
                <a:gd name="connsiteY276" fmla="*/ 1408831 h 1605412"/>
                <a:gd name="connsiteX277" fmla="*/ 5957 w 2841491"/>
                <a:gd name="connsiteY277" fmla="*/ 1399896 h 1605412"/>
                <a:gd name="connsiteX278" fmla="*/ 23828 w 2841491"/>
                <a:gd name="connsiteY278" fmla="*/ 1382025 h 1605412"/>
                <a:gd name="connsiteX279" fmla="*/ 29785 w 2841491"/>
                <a:gd name="connsiteY279" fmla="*/ 1358197 h 1605412"/>
                <a:gd name="connsiteX280" fmla="*/ 32764 w 2841491"/>
                <a:gd name="connsiteY280" fmla="*/ 1346283 h 1605412"/>
                <a:gd name="connsiteX281" fmla="*/ 38721 w 2841491"/>
                <a:gd name="connsiteY281" fmla="*/ 1334369 h 1605412"/>
                <a:gd name="connsiteX282" fmla="*/ 44678 w 2841491"/>
                <a:gd name="connsiteY282" fmla="*/ 1307562 h 1605412"/>
                <a:gd name="connsiteX283" fmla="*/ 47656 w 2841491"/>
                <a:gd name="connsiteY283" fmla="*/ 1298627 h 1605412"/>
                <a:gd name="connsiteX284" fmla="*/ 56592 w 2841491"/>
                <a:gd name="connsiteY284" fmla="*/ 1292670 h 1605412"/>
                <a:gd name="connsiteX285" fmla="*/ 128076 w 2841491"/>
                <a:gd name="connsiteY285" fmla="*/ 1286713 h 1605412"/>
                <a:gd name="connsiteX286" fmla="*/ 137012 w 2841491"/>
                <a:gd name="connsiteY286" fmla="*/ 1280756 h 1605412"/>
                <a:gd name="connsiteX287" fmla="*/ 145947 w 2841491"/>
                <a:gd name="connsiteY287" fmla="*/ 1277777 h 1605412"/>
                <a:gd name="connsiteX288" fmla="*/ 148926 w 2841491"/>
                <a:gd name="connsiteY288" fmla="*/ 1268842 h 1605412"/>
                <a:gd name="connsiteX289" fmla="*/ 154883 w 2841491"/>
                <a:gd name="connsiteY289" fmla="*/ 1230121 h 1605412"/>
                <a:gd name="connsiteX290" fmla="*/ 157861 w 2841491"/>
                <a:gd name="connsiteY290" fmla="*/ 1200336 h 1605412"/>
                <a:gd name="connsiteX291" fmla="*/ 166797 w 2841491"/>
                <a:gd name="connsiteY291" fmla="*/ 1191401 h 1605412"/>
                <a:gd name="connsiteX292" fmla="*/ 184668 w 2841491"/>
                <a:gd name="connsiteY292" fmla="*/ 1173530 h 1605412"/>
                <a:gd name="connsiteX293" fmla="*/ 193603 w 2841491"/>
                <a:gd name="connsiteY293" fmla="*/ 1152680 h 1605412"/>
                <a:gd name="connsiteX294" fmla="*/ 193603 w 2841491"/>
                <a:gd name="connsiteY294" fmla="*/ 1122895 h 16054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</a:cxnLst>
              <a:rect l="l" t="t" r="r" b="b"/>
              <a:pathLst>
                <a:path w="2841491" h="1605412">
                  <a:moveTo>
                    <a:pt x="2841491" y="0"/>
                  </a:moveTo>
                  <a:cubicBezTo>
                    <a:pt x="2836527" y="4964"/>
                    <a:pt x="2830624" y="9141"/>
                    <a:pt x="2826598" y="14892"/>
                  </a:cubicBezTo>
                  <a:cubicBezTo>
                    <a:pt x="2816475" y="29353"/>
                    <a:pt x="2822623" y="39232"/>
                    <a:pt x="2817663" y="56591"/>
                  </a:cubicBezTo>
                  <a:cubicBezTo>
                    <a:pt x="2816073" y="62158"/>
                    <a:pt x="2811123" y="66214"/>
                    <a:pt x="2808727" y="71484"/>
                  </a:cubicBezTo>
                  <a:cubicBezTo>
                    <a:pt x="2805483" y="78620"/>
                    <a:pt x="2801352" y="96984"/>
                    <a:pt x="2796813" y="104247"/>
                  </a:cubicBezTo>
                  <a:cubicBezTo>
                    <a:pt x="2794581" y="107819"/>
                    <a:pt x="2790856" y="110204"/>
                    <a:pt x="2787878" y="113183"/>
                  </a:cubicBezTo>
                  <a:cubicBezTo>
                    <a:pt x="2786885" y="118147"/>
                    <a:pt x="2787358" y="123650"/>
                    <a:pt x="2784899" y="128075"/>
                  </a:cubicBezTo>
                  <a:cubicBezTo>
                    <a:pt x="2782171" y="132984"/>
                    <a:pt x="2776640" y="135725"/>
                    <a:pt x="2772985" y="139989"/>
                  </a:cubicBezTo>
                  <a:cubicBezTo>
                    <a:pt x="2770655" y="142707"/>
                    <a:pt x="2769109" y="146012"/>
                    <a:pt x="2767028" y="148925"/>
                  </a:cubicBezTo>
                  <a:cubicBezTo>
                    <a:pt x="2764143" y="152965"/>
                    <a:pt x="2761071" y="156868"/>
                    <a:pt x="2758093" y="160839"/>
                  </a:cubicBezTo>
                  <a:cubicBezTo>
                    <a:pt x="2757100" y="164810"/>
                    <a:pt x="2756727" y="168990"/>
                    <a:pt x="2755114" y="172753"/>
                  </a:cubicBezTo>
                  <a:cubicBezTo>
                    <a:pt x="2751198" y="181890"/>
                    <a:pt x="2746538" y="183044"/>
                    <a:pt x="2740222" y="190624"/>
                  </a:cubicBezTo>
                  <a:cubicBezTo>
                    <a:pt x="2737930" y="193374"/>
                    <a:pt x="2736251" y="196581"/>
                    <a:pt x="2734265" y="199560"/>
                  </a:cubicBezTo>
                  <a:cubicBezTo>
                    <a:pt x="2731439" y="210863"/>
                    <a:pt x="2728775" y="214289"/>
                    <a:pt x="2734265" y="226366"/>
                  </a:cubicBezTo>
                  <a:cubicBezTo>
                    <a:pt x="2737228" y="232884"/>
                    <a:pt x="2746179" y="244237"/>
                    <a:pt x="2746179" y="244237"/>
                  </a:cubicBezTo>
                  <a:cubicBezTo>
                    <a:pt x="2749164" y="253194"/>
                    <a:pt x="2748698" y="254409"/>
                    <a:pt x="2755114" y="262108"/>
                  </a:cubicBezTo>
                  <a:cubicBezTo>
                    <a:pt x="2757811" y="265344"/>
                    <a:pt x="2761353" y="267808"/>
                    <a:pt x="2764050" y="271044"/>
                  </a:cubicBezTo>
                  <a:cubicBezTo>
                    <a:pt x="2766342" y="273794"/>
                    <a:pt x="2767926" y="277066"/>
                    <a:pt x="2770007" y="279979"/>
                  </a:cubicBezTo>
                  <a:cubicBezTo>
                    <a:pt x="2772892" y="284018"/>
                    <a:pt x="2775964" y="287922"/>
                    <a:pt x="2778942" y="291893"/>
                  </a:cubicBezTo>
                  <a:cubicBezTo>
                    <a:pt x="2784458" y="347041"/>
                    <a:pt x="2785422" y="343855"/>
                    <a:pt x="2778942" y="425926"/>
                  </a:cubicBezTo>
                  <a:cubicBezTo>
                    <a:pt x="2778660" y="429494"/>
                    <a:pt x="2775363" y="432186"/>
                    <a:pt x="2772985" y="434861"/>
                  </a:cubicBezTo>
                  <a:cubicBezTo>
                    <a:pt x="2767388" y="441157"/>
                    <a:pt x="2761071" y="446775"/>
                    <a:pt x="2755114" y="452732"/>
                  </a:cubicBezTo>
                  <a:cubicBezTo>
                    <a:pt x="2752136" y="455711"/>
                    <a:pt x="2748516" y="458163"/>
                    <a:pt x="2746179" y="461668"/>
                  </a:cubicBezTo>
                  <a:cubicBezTo>
                    <a:pt x="2737885" y="474108"/>
                    <a:pt x="2742753" y="468072"/>
                    <a:pt x="2731286" y="479539"/>
                  </a:cubicBezTo>
                  <a:cubicBezTo>
                    <a:pt x="2730293" y="482517"/>
                    <a:pt x="2728989" y="485409"/>
                    <a:pt x="2728308" y="488474"/>
                  </a:cubicBezTo>
                  <a:cubicBezTo>
                    <a:pt x="2726998" y="494369"/>
                    <a:pt x="2727828" y="500847"/>
                    <a:pt x="2725329" y="506345"/>
                  </a:cubicBezTo>
                  <a:cubicBezTo>
                    <a:pt x="2718773" y="520768"/>
                    <a:pt x="2711896" y="520818"/>
                    <a:pt x="2701501" y="530173"/>
                  </a:cubicBezTo>
                  <a:cubicBezTo>
                    <a:pt x="2695239" y="535809"/>
                    <a:pt x="2689587" y="542087"/>
                    <a:pt x="2683630" y="548044"/>
                  </a:cubicBezTo>
                  <a:cubicBezTo>
                    <a:pt x="2679659" y="552015"/>
                    <a:pt x="2676739" y="557446"/>
                    <a:pt x="2671716" y="559958"/>
                  </a:cubicBezTo>
                  <a:cubicBezTo>
                    <a:pt x="2656994" y="567319"/>
                    <a:pt x="2664014" y="564511"/>
                    <a:pt x="2650867" y="568894"/>
                  </a:cubicBezTo>
                  <a:cubicBezTo>
                    <a:pt x="2648881" y="571872"/>
                    <a:pt x="2647441" y="575298"/>
                    <a:pt x="2644910" y="577829"/>
                  </a:cubicBezTo>
                  <a:cubicBezTo>
                    <a:pt x="2642379" y="580360"/>
                    <a:pt x="2638724" y="581494"/>
                    <a:pt x="2635974" y="583786"/>
                  </a:cubicBezTo>
                  <a:cubicBezTo>
                    <a:pt x="2632738" y="586483"/>
                    <a:pt x="2630017" y="589743"/>
                    <a:pt x="2627039" y="592722"/>
                  </a:cubicBezTo>
                  <a:cubicBezTo>
                    <a:pt x="2624462" y="600452"/>
                    <a:pt x="2621662" y="609432"/>
                    <a:pt x="2618103" y="616550"/>
                  </a:cubicBezTo>
                  <a:cubicBezTo>
                    <a:pt x="2615514" y="621728"/>
                    <a:pt x="2611757" y="626264"/>
                    <a:pt x="2609168" y="631442"/>
                  </a:cubicBezTo>
                  <a:cubicBezTo>
                    <a:pt x="2605786" y="638205"/>
                    <a:pt x="2604426" y="646000"/>
                    <a:pt x="2600232" y="652292"/>
                  </a:cubicBezTo>
                  <a:cubicBezTo>
                    <a:pt x="2596932" y="657242"/>
                    <a:pt x="2587459" y="659528"/>
                    <a:pt x="2582361" y="661227"/>
                  </a:cubicBezTo>
                  <a:cubicBezTo>
                    <a:pt x="2560755" y="682836"/>
                    <a:pt x="2586275" y="654966"/>
                    <a:pt x="2567469" y="685055"/>
                  </a:cubicBezTo>
                  <a:cubicBezTo>
                    <a:pt x="2565236" y="688627"/>
                    <a:pt x="2561512" y="691012"/>
                    <a:pt x="2558533" y="693991"/>
                  </a:cubicBezTo>
                  <a:cubicBezTo>
                    <a:pt x="2557540" y="697962"/>
                    <a:pt x="2557826" y="702499"/>
                    <a:pt x="2555555" y="705905"/>
                  </a:cubicBezTo>
                  <a:cubicBezTo>
                    <a:pt x="2553569" y="708884"/>
                    <a:pt x="2549150" y="709331"/>
                    <a:pt x="2546619" y="711862"/>
                  </a:cubicBezTo>
                  <a:cubicBezTo>
                    <a:pt x="2544088" y="714393"/>
                    <a:pt x="2542648" y="717819"/>
                    <a:pt x="2540662" y="720797"/>
                  </a:cubicBezTo>
                  <a:cubicBezTo>
                    <a:pt x="2538676" y="728740"/>
                    <a:pt x="2538366" y="737302"/>
                    <a:pt x="2534705" y="744625"/>
                  </a:cubicBezTo>
                  <a:cubicBezTo>
                    <a:pt x="2526931" y="760175"/>
                    <a:pt x="2525547" y="759712"/>
                    <a:pt x="2522791" y="774410"/>
                  </a:cubicBezTo>
                  <a:cubicBezTo>
                    <a:pt x="2520565" y="786281"/>
                    <a:pt x="2519202" y="798308"/>
                    <a:pt x="2516834" y="810152"/>
                  </a:cubicBezTo>
                  <a:cubicBezTo>
                    <a:pt x="2515841" y="815116"/>
                    <a:pt x="2515634" y="820305"/>
                    <a:pt x="2513856" y="825045"/>
                  </a:cubicBezTo>
                  <a:cubicBezTo>
                    <a:pt x="2512599" y="828397"/>
                    <a:pt x="2509885" y="831002"/>
                    <a:pt x="2507899" y="833980"/>
                  </a:cubicBezTo>
                  <a:cubicBezTo>
                    <a:pt x="2512342" y="936193"/>
                    <a:pt x="2505102" y="875007"/>
                    <a:pt x="2513856" y="914400"/>
                  </a:cubicBezTo>
                  <a:cubicBezTo>
                    <a:pt x="2514954" y="919342"/>
                    <a:pt x="2514570" y="924764"/>
                    <a:pt x="2516834" y="929292"/>
                  </a:cubicBezTo>
                  <a:cubicBezTo>
                    <a:pt x="2537572" y="970769"/>
                    <a:pt x="2514755" y="903470"/>
                    <a:pt x="2531727" y="950142"/>
                  </a:cubicBezTo>
                  <a:cubicBezTo>
                    <a:pt x="2541166" y="976099"/>
                    <a:pt x="2530433" y="966157"/>
                    <a:pt x="2546619" y="976948"/>
                  </a:cubicBezTo>
                  <a:cubicBezTo>
                    <a:pt x="2567232" y="1007870"/>
                    <a:pt x="2535852" y="959996"/>
                    <a:pt x="2558533" y="997798"/>
                  </a:cubicBezTo>
                  <a:cubicBezTo>
                    <a:pt x="2562216" y="1003937"/>
                    <a:pt x="2566476" y="1009712"/>
                    <a:pt x="2570447" y="1015669"/>
                  </a:cubicBezTo>
                  <a:lnTo>
                    <a:pt x="2576404" y="1024604"/>
                  </a:lnTo>
                  <a:cubicBezTo>
                    <a:pt x="2577397" y="1029568"/>
                    <a:pt x="2577928" y="1034648"/>
                    <a:pt x="2579383" y="1039497"/>
                  </a:cubicBezTo>
                  <a:cubicBezTo>
                    <a:pt x="2580919" y="1044618"/>
                    <a:pt x="2586809" y="1049248"/>
                    <a:pt x="2585340" y="1054389"/>
                  </a:cubicBezTo>
                  <a:cubicBezTo>
                    <a:pt x="2584120" y="1058658"/>
                    <a:pt x="2577397" y="1058360"/>
                    <a:pt x="2573426" y="1060346"/>
                  </a:cubicBezTo>
                  <a:cubicBezTo>
                    <a:pt x="2571440" y="1057368"/>
                    <a:pt x="2570671" y="1053012"/>
                    <a:pt x="2567469" y="1051411"/>
                  </a:cubicBezTo>
                  <a:cubicBezTo>
                    <a:pt x="2560146" y="1047750"/>
                    <a:pt x="2551408" y="1048043"/>
                    <a:pt x="2543641" y="1045454"/>
                  </a:cubicBezTo>
                  <a:lnTo>
                    <a:pt x="2534705" y="1042475"/>
                  </a:lnTo>
                  <a:cubicBezTo>
                    <a:pt x="2521798" y="1043468"/>
                    <a:pt x="2508830" y="1043848"/>
                    <a:pt x="2495985" y="1045454"/>
                  </a:cubicBezTo>
                  <a:cubicBezTo>
                    <a:pt x="2472495" y="1048390"/>
                    <a:pt x="2501512" y="1047158"/>
                    <a:pt x="2481092" y="1057368"/>
                  </a:cubicBezTo>
                  <a:cubicBezTo>
                    <a:pt x="2476300" y="1059764"/>
                    <a:pt x="2450485" y="1064681"/>
                    <a:pt x="2442372" y="1066303"/>
                  </a:cubicBezTo>
                  <a:cubicBezTo>
                    <a:pt x="2439393" y="1068289"/>
                    <a:pt x="2436231" y="1070024"/>
                    <a:pt x="2433436" y="1072260"/>
                  </a:cubicBezTo>
                  <a:cubicBezTo>
                    <a:pt x="2431243" y="1074014"/>
                    <a:pt x="2429277" y="1076060"/>
                    <a:pt x="2427479" y="1078218"/>
                  </a:cubicBezTo>
                  <a:cubicBezTo>
                    <a:pt x="2421324" y="1085605"/>
                    <a:pt x="2417744" y="1091331"/>
                    <a:pt x="2412587" y="1099067"/>
                  </a:cubicBezTo>
                  <a:cubicBezTo>
                    <a:pt x="2404753" y="1130397"/>
                    <a:pt x="2416446" y="1092313"/>
                    <a:pt x="2400673" y="1119917"/>
                  </a:cubicBezTo>
                  <a:cubicBezTo>
                    <a:pt x="2398642" y="1123471"/>
                    <a:pt x="2398687" y="1127860"/>
                    <a:pt x="2397694" y="1131831"/>
                  </a:cubicBezTo>
                  <a:cubicBezTo>
                    <a:pt x="2396701" y="1141759"/>
                    <a:pt x="2399178" y="1152692"/>
                    <a:pt x="2394716" y="1161616"/>
                  </a:cubicBezTo>
                  <a:cubicBezTo>
                    <a:pt x="2391514" y="1168020"/>
                    <a:pt x="2383492" y="1170871"/>
                    <a:pt x="2376845" y="1173530"/>
                  </a:cubicBezTo>
                  <a:cubicBezTo>
                    <a:pt x="2371881" y="1175516"/>
                    <a:pt x="2366838" y="1177316"/>
                    <a:pt x="2361952" y="1179487"/>
                  </a:cubicBezTo>
                  <a:cubicBezTo>
                    <a:pt x="2339870" y="1189301"/>
                    <a:pt x="2359454" y="1182306"/>
                    <a:pt x="2341103" y="1188422"/>
                  </a:cubicBezTo>
                  <a:cubicBezTo>
                    <a:pt x="2340110" y="1191401"/>
                    <a:pt x="2339227" y="1194418"/>
                    <a:pt x="2338124" y="1197358"/>
                  </a:cubicBezTo>
                  <a:cubicBezTo>
                    <a:pt x="2336247" y="1202364"/>
                    <a:pt x="2333858" y="1207178"/>
                    <a:pt x="2332167" y="1212250"/>
                  </a:cubicBezTo>
                  <a:cubicBezTo>
                    <a:pt x="2329881" y="1219107"/>
                    <a:pt x="2330041" y="1226971"/>
                    <a:pt x="2326210" y="1233100"/>
                  </a:cubicBezTo>
                  <a:cubicBezTo>
                    <a:pt x="2324546" y="1235762"/>
                    <a:pt x="2320253" y="1235085"/>
                    <a:pt x="2317275" y="1236078"/>
                  </a:cubicBezTo>
                  <a:cubicBezTo>
                    <a:pt x="2300397" y="1235085"/>
                    <a:pt x="2283392" y="1235384"/>
                    <a:pt x="2266640" y="1233100"/>
                  </a:cubicBezTo>
                  <a:cubicBezTo>
                    <a:pt x="2225010" y="1227424"/>
                    <a:pt x="2283592" y="1222595"/>
                    <a:pt x="2230898" y="1230121"/>
                  </a:cubicBezTo>
                  <a:cubicBezTo>
                    <a:pt x="2227920" y="1232107"/>
                    <a:pt x="2225315" y="1234821"/>
                    <a:pt x="2221963" y="1236078"/>
                  </a:cubicBezTo>
                  <a:cubicBezTo>
                    <a:pt x="2184669" y="1250064"/>
                    <a:pt x="2223855" y="1231013"/>
                    <a:pt x="2198135" y="1242035"/>
                  </a:cubicBezTo>
                  <a:cubicBezTo>
                    <a:pt x="2169340" y="1254375"/>
                    <a:pt x="2201802" y="1240584"/>
                    <a:pt x="2177285" y="1256928"/>
                  </a:cubicBezTo>
                  <a:cubicBezTo>
                    <a:pt x="2174673" y="1258669"/>
                    <a:pt x="2171328" y="1258913"/>
                    <a:pt x="2168350" y="1259906"/>
                  </a:cubicBezTo>
                  <a:cubicBezTo>
                    <a:pt x="2165371" y="1262885"/>
                    <a:pt x="2162842" y="1266394"/>
                    <a:pt x="2159414" y="1268842"/>
                  </a:cubicBezTo>
                  <a:cubicBezTo>
                    <a:pt x="2149534" y="1275899"/>
                    <a:pt x="2148289" y="1273610"/>
                    <a:pt x="2138565" y="1277777"/>
                  </a:cubicBezTo>
                  <a:cubicBezTo>
                    <a:pt x="2127985" y="1282311"/>
                    <a:pt x="2126688" y="1283709"/>
                    <a:pt x="2117715" y="1289691"/>
                  </a:cubicBezTo>
                  <a:cubicBezTo>
                    <a:pt x="2115918" y="1292386"/>
                    <a:pt x="2106646" y="1307562"/>
                    <a:pt x="2102823" y="1307562"/>
                  </a:cubicBezTo>
                  <a:cubicBezTo>
                    <a:pt x="2099243" y="1307562"/>
                    <a:pt x="2098320" y="1301898"/>
                    <a:pt x="2096866" y="1298627"/>
                  </a:cubicBezTo>
                  <a:cubicBezTo>
                    <a:pt x="2085203" y="1272386"/>
                    <a:pt x="2098283" y="1288130"/>
                    <a:pt x="2081973" y="1271820"/>
                  </a:cubicBezTo>
                  <a:cubicBezTo>
                    <a:pt x="2083959" y="1266856"/>
                    <a:pt x="2083550" y="1259994"/>
                    <a:pt x="2087930" y="1256928"/>
                  </a:cubicBezTo>
                  <a:cubicBezTo>
                    <a:pt x="2094637" y="1252233"/>
                    <a:pt x="2111758" y="1250971"/>
                    <a:pt x="2111758" y="1250971"/>
                  </a:cubicBezTo>
                  <a:cubicBezTo>
                    <a:pt x="2114737" y="1248985"/>
                    <a:pt x="2118458" y="1247809"/>
                    <a:pt x="2120694" y="1245014"/>
                  </a:cubicBezTo>
                  <a:cubicBezTo>
                    <a:pt x="2122655" y="1242562"/>
                    <a:pt x="2123195" y="1239181"/>
                    <a:pt x="2123672" y="1236078"/>
                  </a:cubicBezTo>
                  <a:cubicBezTo>
                    <a:pt x="2125189" y="1226216"/>
                    <a:pt x="2124694" y="1216077"/>
                    <a:pt x="2126651" y="1206293"/>
                  </a:cubicBezTo>
                  <a:cubicBezTo>
                    <a:pt x="2127700" y="1201050"/>
                    <a:pt x="2130917" y="1196473"/>
                    <a:pt x="2132608" y="1191401"/>
                  </a:cubicBezTo>
                  <a:cubicBezTo>
                    <a:pt x="2136151" y="1180773"/>
                    <a:pt x="2138816" y="1169545"/>
                    <a:pt x="2141543" y="1158637"/>
                  </a:cubicBezTo>
                  <a:cubicBezTo>
                    <a:pt x="2142536" y="1146723"/>
                    <a:pt x="2140189" y="1134037"/>
                    <a:pt x="2144522" y="1122895"/>
                  </a:cubicBezTo>
                  <a:cubicBezTo>
                    <a:pt x="2150507" y="1107506"/>
                    <a:pt x="2159657" y="1105936"/>
                    <a:pt x="2171328" y="1102046"/>
                  </a:cubicBezTo>
                  <a:cubicBezTo>
                    <a:pt x="2192156" y="1088162"/>
                    <a:pt x="2166697" y="1103115"/>
                    <a:pt x="2210049" y="1093110"/>
                  </a:cubicBezTo>
                  <a:cubicBezTo>
                    <a:pt x="2213537" y="1092305"/>
                    <a:pt x="2215876" y="1088929"/>
                    <a:pt x="2218984" y="1087153"/>
                  </a:cubicBezTo>
                  <a:cubicBezTo>
                    <a:pt x="2222839" y="1084950"/>
                    <a:pt x="2227017" y="1083352"/>
                    <a:pt x="2230898" y="1081196"/>
                  </a:cubicBezTo>
                  <a:cubicBezTo>
                    <a:pt x="2241677" y="1075208"/>
                    <a:pt x="2245416" y="1072510"/>
                    <a:pt x="2254726" y="1066303"/>
                  </a:cubicBezTo>
                  <a:cubicBezTo>
                    <a:pt x="2256712" y="1063325"/>
                    <a:pt x="2259082" y="1060570"/>
                    <a:pt x="2260683" y="1057368"/>
                  </a:cubicBezTo>
                  <a:cubicBezTo>
                    <a:pt x="2267082" y="1044571"/>
                    <a:pt x="2262257" y="1041294"/>
                    <a:pt x="2257705" y="1024604"/>
                  </a:cubicBezTo>
                  <a:cubicBezTo>
                    <a:pt x="2256879" y="1021575"/>
                    <a:pt x="2257791" y="1016350"/>
                    <a:pt x="2254726" y="1015669"/>
                  </a:cubicBezTo>
                  <a:cubicBezTo>
                    <a:pt x="2238221" y="1012001"/>
                    <a:pt x="2220970" y="1013683"/>
                    <a:pt x="2204092" y="1012690"/>
                  </a:cubicBezTo>
                  <a:cubicBezTo>
                    <a:pt x="2198135" y="1011697"/>
                    <a:pt x="2192143" y="1010896"/>
                    <a:pt x="2186221" y="1009712"/>
                  </a:cubicBezTo>
                  <a:cubicBezTo>
                    <a:pt x="2176879" y="1007844"/>
                    <a:pt x="2173882" y="1006591"/>
                    <a:pt x="2165371" y="1003755"/>
                  </a:cubicBezTo>
                  <a:cubicBezTo>
                    <a:pt x="2136484" y="1005680"/>
                    <a:pt x="2128469" y="998764"/>
                    <a:pt x="2111758" y="1012690"/>
                  </a:cubicBezTo>
                  <a:cubicBezTo>
                    <a:pt x="2108522" y="1015387"/>
                    <a:pt x="2105801" y="1018647"/>
                    <a:pt x="2102823" y="1021626"/>
                  </a:cubicBezTo>
                  <a:cubicBezTo>
                    <a:pt x="2095619" y="1057645"/>
                    <a:pt x="2103191" y="1043505"/>
                    <a:pt x="2084952" y="1066303"/>
                  </a:cubicBezTo>
                  <a:cubicBezTo>
                    <a:pt x="2082783" y="1074980"/>
                    <a:pt x="2080256" y="1084280"/>
                    <a:pt x="2078995" y="1093110"/>
                  </a:cubicBezTo>
                  <a:cubicBezTo>
                    <a:pt x="2077724" y="1102010"/>
                    <a:pt x="2078660" y="1111324"/>
                    <a:pt x="2076016" y="1119917"/>
                  </a:cubicBezTo>
                  <a:cubicBezTo>
                    <a:pt x="2074556" y="1124662"/>
                    <a:pt x="2070059" y="1127860"/>
                    <a:pt x="2067081" y="1131831"/>
                  </a:cubicBezTo>
                  <a:cubicBezTo>
                    <a:pt x="2064401" y="1142549"/>
                    <a:pt x="2063016" y="1147283"/>
                    <a:pt x="2061124" y="1158637"/>
                  </a:cubicBezTo>
                  <a:cubicBezTo>
                    <a:pt x="2059970" y="1165562"/>
                    <a:pt x="2061285" y="1173208"/>
                    <a:pt x="2058145" y="1179487"/>
                  </a:cubicBezTo>
                  <a:cubicBezTo>
                    <a:pt x="2056741" y="1182295"/>
                    <a:pt x="2052188" y="1181472"/>
                    <a:pt x="2049210" y="1182465"/>
                  </a:cubicBezTo>
                  <a:cubicBezTo>
                    <a:pt x="2046231" y="1185444"/>
                    <a:pt x="2043510" y="1188704"/>
                    <a:pt x="2040274" y="1191401"/>
                  </a:cubicBezTo>
                  <a:cubicBezTo>
                    <a:pt x="2024825" y="1204276"/>
                    <a:pt x="2023441" y="1196700"/>
                    <a:pt x="1995597" y="1194379"/>
                  </a:cubicBezTo>
                  <a:cubicBezTo>
                    <a:pt x="1989640" y="1186436"/>
                    <a:pt x="1980866" y="1179970"/>
                    <a:pt x="1977726" y="1170551"/>
                  </a:cubicBezTo>
                  <a:cubicBezTo>
                    <a:pt x="1976733" y="1167573"/>
                    <a:pt x="1977302" y="1163441"/>
                    <a:pt x="1974747" y="1161616"/>
                  </a:cubicBezTo>
                  <a:cubicBezTo>
                    <a:pt x="1969637" y="1157966"/>
                    <a:pt x="1956876" y="1155659"/>
                    <a:pt x="1956876" y="1155659"/>
                  </a:cubicBezTo>
                  <a:lnTo>
                    <a:pt x="1909220" y="1161616"/>
                  </a:lnTo>
                  <a:cubicBezTo>
                    <a:pt x="1903236" y="1162432"/>
                    <a:pt x="1897291" y="1163514"/>
                    <a:pt x="1891349" y="1164594"/>
                  </a:cubicBezTo>
                  <a:cubicBezTo>
                    <a:pt x="1886368" y="1165500"/>
                    <a:pt x="1881507" y="1167225"/>
                    <a:pt x="1876456" y="1167573"/>
                  </a:cubicBezTo>
                  <a:cubicBezTo>
                    <a:pt x="1852664" y="1169214"/>
                    <a:pt x="1828800" y="1169558"/>
                    <a:pt x="1804972" y="1170551"/>
                  </a:cubicBezTo>
                  <a:cubicBezTo>
                    <a:pt x="1804551" y="1178544"/>
                    <a:pt x="1807008" y="1227461"/>
                    <a:pt x="1796037" y="1245014"/>
                  </a:cubicBezTo>
                  <a:cubicBezTo>
                    <a:pt x="1792998" y="1249876"/>
                    <a:pt x="1783035" y="1252326"/>
                    <a:pt x="1778166" y="1253949"/>
                  </a:cubicBezTo>
                  <a:cubicBezTo>
                    <a:pt x="1775187" y="1255935"/>
                    <a:pt x="1771761" y="1257375"/>
                    <a:pt x="1769230" y="1259906"/>
                  </a:cubicBezTo>
                  <a:cubicBezTo>
                    <a:pt x="1766699" y="1262437"/>
                    <a:pt x="1766068" y="1266606"/>
                    <a:pt x="1763273" y="1268842"/>
                  </a:cubicBezTo>
                  <a:cubicBezTo>
                    <a:pt x="1760822" y="1270803"/>
                    <a:pt x="1757316" y="1270827"/>
                    <a:pt x="1754338" y="1271820"/>
                  </a:cubicBezTo>
                  <a:lnTo>
                    <a:pt x="1724553" y="1301605"/>
                  </a:lnTo>
                  <a:lnTo>
                    <a:pt x="1715617" y="1310541"/>
                  </a:lnTo>
                  <a:cubicBezTo>
                    <a:pt x="1708507" y="1331873"/>
                    <a:pt x="1718672" y="1307471"/>
                    <a:pt x="1703703" y="1325433"/>
                  </a:cubicBezTo>
                  <a:cubicBezTo>
                    <a:pt x="1700860" y="1328844"/>
                    <a:pt x="1700636" y="1333976"/>
                    <a:pt x="1697746" y="1337347"/>
                  </a:cubicBezTo>
                  <a:cubicBezTo>
                    <a:pt x="1694515" y="1341116"/>
                    <a:pt x="1689568" y="1343014"/>
                    <a:pt x="1685832" y="1346283"/>
                  </a:cubicBezTo>
                  <a:cubicBezTo>
                    <a:pt x="1668437" y="1361504"/>
                    <a:pt x="1681069" y="1355814"/>
                    <a:pt x="1664983" y="1361175"/>
                  </a:cubicBezTo>
                  <a:cubicBezTo>
                    <a:pt x="1662004" y="1360182"/>
                    <a:pt x="1658267" y="1360417"/>
                    <a:pt x="1656047" y="1358197"/>
                  </a:cubicBezTo>
                  <a:cubicBezTo>
                    <a:pt x="1651171" y="1353322"/>
                    <a:pt x="1645994" y="1332599"/>
                    <a:pt x="1644133" y="1328412"/>
                  </a:cubicBezTo>
                  <a:cubicBezTo>
                    <a:pt x="1642679" y="1325141"/>
                    <a:pt x="1640162" y="1322455"/>
                    <a:pt x="1638176" y="1319476"/>
                  </a:cubicBezTo>
                  <a:cubicBezTo>
                    <a:pt x="1637183" y="1312526"/>
                    <a:pt x="1636575" y="1305511"/>
                    <a:pt x="1635198" y="1298627"/>
                  </a:cubicBezTo>
                  <a:cubicBezTo>
                    <a:pt x="1634582" y="1295548"/>
                    <a:pt x="1631907" y="1292815"/>
                    <a:pt x="1632219" y="1289691"/>
                  </a:cubicBezTo>
                  <a:cubicBezTo>
                    <a:pt x="1633924" y="1272637"/>
                    <a:pt x="1635994" y="1255400"/>
                    <a:pt x="1641155" y="1239057"/>
                  </a:cubicBezTo>
                  <a:cubicBezTo>
                    <a:pt x="1642233" y="1235644"/>
                    <a:pt x="1647415" y="1235478"/>
                    <a:pt x="1650090" y="1233100"/>
                  </a:cubicBezTo>
                  <a:cubicBezTo>
                    <a:pt x="1656386" y="1227503"/>
                    <a:pt x="1662004" y="1221186"/>
                    <a:pt x="1667961" y="1215229"/>
                  </a:cubicBezTo>
                  <a:lnTo>
                    <a:pt x="1676897" y="1206293"/>
                  </a:lnTo>
                  <a:lnTo>
                    <a:pt x="1685832" y="1197358"/>
                  </a:lnTo>
                  <a:cubicBezTo>
                    <a:pt x="1691933" y="1179056"/>
                    <a:pt x="1693201" y="1181211"/>
                    <a:pt x="1676897" y="1152680"/>
                  </a:cubicBezTo>
                  <a:cubicBezTo>
                    <a:pt x="1674694" y="1148825"/>
                    <a:pt x="1668954" y="1148709"/>
                    <a:pt x="1664983" y="1146723"/>
                  </a:cubicBezTo>
                  <a:cubicBezTo>
                    <a:pt x="1646119" y="1147716"/>
                    <a:pt x="1627216" y="1148133"/>
                    <a:pt x="1608391" y="1149702"/>
                  </a:cubicBezTo>
                  <a:cubicBezTo>
                    <a:pt x="1600769" y="1150337"/>
                    <a:pt x="1591883" y="1152914"/>
                    <a:pt x="1584563" y="1155659"/>
                  </a:cubicBezTo>
                  <a:cubicBezTo>
                    <a:pt x="1579557" y="1157536"/>
                    <a:pt x="1574743" y="1159925"/>
                    <a:pt x="1569671" y="1161616"/>
                  </a:cubicBezTo>
                  <a:cubicBezTo>
                    <a:pt x="1565788" y="1162910"/>
                    <a:pt x="1561728" y="1163601"/>
                    <a:pt x="1557757" y="1164594"/>
                  </a:cubicBezTo>
                  <a:cubicBezTo>
                    <a:pt x="1554778" y="1167573"/>
                    <a:pt x="1551158" y="1170025"/>
                    <a:pt x="1548821" y="1173530"/>
                  </a:cubicBezTo>
                  <a:cubicBezTo>
                    <a:pt x="1547080" y="1176142"/>
                    <a:pt x="1548063" y="1180245"/>
                    <a:pt x="1545843" y="1182465"/>
                  </a:cubicBezTo>
                  <a:cubicBezTo>
                    <a:pt x="1542703" y="1185605"/>
                    <a:pt x="1538291" y="1187591"/>
                    <a:pt x="1533929" y="1188422"/>
                  </a:cubicBezTo>
                  <a:cubicBezTo>
                    <a:pt x="1517234" y="1191602"/>
                    <a:pt x="1500172" y="1192393"/>
                    <a:pt x="1483294" y="1194379"/>
                  </a:cubicBezTo>
                  <a:cubicBezTo>
                    <a:pt x="1481308" y="1197358"/>
                    <a:pt x="1480031" y="1200958"/>
                    <a:pt x="1477337" y="1203315"/>
                  </a:cubicBezTo>
                  <a:cubicBezTo>
                    <a:pt x="1460900" y="1217698"/>
                    <a:pt x="1463644" y="1213380"/>
                    <a:pt x="1447552" y="1218207"/>
                  </a:cubicBezTo>
                  <a:cubicBezTo>
                    <a:pt x="1441538" y="1220011"/>
                    <a:pt x="1429681" y="1224164"/>
                    <a:pt x="1429681" y="1224164"/>
                  </a:cubicBezTo>
                  <a:cubicBezTo>
                    <a:pt x="1426703" y="1227143"/>
                    <a:pt x="1423223" y="1229693"/>
                    <a:pt x="1420746" y="1233100"/>
                  </a:cubicBezTo>
                  <a:cubicBezTo>
                    <a:pt x="1414463" y="1241739"/>
                    <a:pt x="1407600" y="1258742"/>
                    <a:pt x="1396918" y="1265863"/>
                  </a:cubicBezTo>
                  <a:cubicBezTo>
                    <a:pt x="1394306" y="1267605"/>
                    <a:pt x="1390961" y="1267849"/>
                    <a:pt x="1387982" y="1268842"/>
                  </a:cubicBezTo>
                  <a:cubicBezTo>
                    <a:pt x="1386989" y="1284727"/>
                    <a:pt x="1395428" y="1304470"/>
                    <a:pt x="1385004" y="1316498"/>
                  </a:cubicBezTo>
                  <a:cubicBezTo>
                    <a:pt x="1361447" y="1343679"/>
                    <a:pt x="1351944" y="1311223"/>
                    <a:pt x="1340326" y="1304584"/>
                  </a:cubicBezTo>
                  <a:cubicBezTo>
                    <a:pt x="1336772" y="1302553"/>
                    <a:pt x="1332348" y="1302730"/>
                    <a:pt x="1328412" y="1301605"/>
                  </a:cubicBezTo>
                  <a:cubicBezTo>
                    <a:pt x="1325393" y="1300743"/>
                    <a:pt x="1322455" y="1299620"/>
                    <a:pt x="1319477" y="1298627"/>
                  </a:cubicBezTo>
                  <a:cubicBezTo>
                    <a:pt x="1317491" y="1295648"/>
                    <a:pt x="1316315" y="1291927"/>
                    <a:pt x="1313520" y="1289691"/>
                  </a:cubicBezTo>
                  <a:cubicBezTo>
                    <a:pt x="1311068" y="1287730"/>
                    <a:pt x="1307681" y="1287229"/>
                    <a:pt x="1304584" y="1286713"/>
                  </a:cubicBezTo>
                  <a:cubicBezTo>
                    <a:pt x="1295716" y="1285235"/>
                    <a:pt x="1286713" y="1284727"/>
                    <a:pt x="1277778" y="1283734"/>
                  </a:cubicBezTo>
                  <a:lnTo>
                    <a:pt x="1253950" y="1274799"/>
                  </a:lnTo>
                  <a:cubicBezTo>
                    <a:pt x="1248037" y="1272687"/>
                    <a:pt x="1242340" y="1269324"/>
                    <a:pt x="1236079" y="1268842"/>
                  </a:cubicBezTo>
                  <a:lnTo>
                    <a:pt x="1197358" y="1265863"/>
                  </a:lnTo>
                  <a:cubicBezTo>
                    <a:pt x="1187430" y="1261892"/>
                    <a:pt x="1177717" y="1257330"/>
                    <a:pt x="1167573" y="1253949"/>
                  </a:cubicBezTo>
                  <a:cubicBezTo>
                    <a:pt x="1145819" y="1246698"/>
                    <a:pt x="1155794" y="1249515"/>
                    <a:pt x="1137788" y="1245014"/>
                  </a:cubicBezTo>
                  <a:cubicBezTo>
                    <a:pt x="1133817" y="1243028"/>
                    <a:pt x="1130309" y="1239268"/>
                    <a:pt x="1125874" y="1239057"/>
                  </a:cubicBezTo>
                  <a:cubicBezTo>
                    <a:pt x="1094121" y="1237545"/>
                    <a:pt x="1084652" y="1240152"/>
                    <a:pt x="1060347" y="1245014"/>
                  </a:cubicBezTo>
                  <a:cubicBezTo>
                    <a:pt x="1034709" y="1270652"/>
                    <a:pt x="1048200" y="1264313"/>
                    <a:pt x="1015669" y="1271820"/>
                  </a:cubicBezTo>
                  <a:cubicBezTo>
                    <a:pt x="1010736" y="1272958"/>
                    <a:pt x="1005741" y="1273806"/>
                    <a:pt x="1000777" y="1274799"/>
                  </a:cubicBezTo>
                  <a:cubicBezTo>
                    <a:pt x="972978" y="1273806"/>
                    <a:pt x="944534" y="1277854"/>
                    <a:pt x="917379" y="1271820"/>
                  </a:cubicBezTo>
                  <a:cubicBezTo>
                    <a:pt x="912437" y="1270722"/>
                    <a:pt x="916777" y="1260508"/>
                    <a:pt x="920357" y="1256928"/>
                  </a:cubicBezTo>
                  <a:cubicBezTo>
                    <a:pt x="923937" y="1253348"/>
                    <a:pt x="930222" y="1254541"/>
                    <a:pt x="935250" y="1253949"/>
                  </a:cubicBezTo>
                  <a:cubicBezTo>
                    <a:pt x="947123" y="1252552"/>
                    <a:pt x="959078" y="1251964"/>
                    <a:pt x="970992" y="1250971"/>
                  </a:cubicBezTo>
                  <a:cubicBezTo>
                    <a:pt x="985884" y="1241043"/>
                    <a:pt x="977942" y="1247992"/>
                    <a:pt x="991841" y="1227143"/>
                  </a:cubicBezTo>
                  <a:lnTo>
                    <a:pt x="997798" y="1218207"/>
                  </a:lnTo>
                  <a:cubicBezTo>
                    <a:pt x="985884" y="1217214"/>
                    <a:pt x="973946" y="1216481"/>
                    <a:pt x="962056" y="1215229"/>
                  </a:cubicBezTo>
                  <a:cubicBezTo>
                    <a:pt x="955074" y="1214494"/>
                    <a:pt x="947160" y="1215971"/>
                    <a:pt x="941207" y="1212250"/>
                  </a:cubicBezTo>
                  <a:cubicBezTo>
                    <a:pt x="937736" y="1210080"/>
                    <a:pt x="940607" y="1203667"/>
                    <a:pt x="938228" y="1200336"/>
                  </a:cubicBezTo>
                  <a:cubicBezTo>
                    <a:pt x="935343" y="1196297"/>
                    <a:pt x="930083" y="1194632"/>
                    <a:pt x="926314" y="1191401"/>
                  </a:cubicBezTo>
                  <a:cubicBezTo>
                    <a:pt x="920552" y="1186462"/>
                    <a:pt x="914868" y="1180422"/>
                    <a:pt x="911422" y="1173530"/>
                  </a:cubicBezTo>
                  <a:cubicBezTo>
                    <a:pt x="910018" y="1170722"/>
                    <a:pt x="909436" y="1167573"/>
                    <a:pt x="908443" y="1164594"/>
                  </a:cubicBezTo>
                  <a:cubicBezTo>
                    <a:pt x="903479" y="1165587"/>
                    <a:pt x="895329" y="1162833"/>
                    <a:pt x="893551" y="1167573"/>
                  </a:cubicBezTo>
                  <a:cubicBezTo>
                    <a:pt x="870499" y="1229046"/>
                    <a:pt x="907748" y="1200799"/>
                    <a:pt x="881637" y="1218207"/>
                  </a:cubicBezTo>
                  <a:cubicBezTo>
                    <a:pt x="880644" y="1221186"/>
                    <a:pt x="880483" y="1224588"/>
                    <a:pt x="878658" y="1227143"/>
                  </a:cubicBezTo>
                  <a:cubicBezTo>
                    <a:pt x="875394" y="1231713"/>
                    <a:pt x="872193" y="1240419"/>
                    <a:pt x="866744" y="1239057"/>
                  </a:cubicBezTo>
                  <a:cubicBezTo>
                    <a:pt x="859798" y="1237321"/>
                    <a:pt x="860787" y="1225157"/>
                    <a:pt x="854830" y="1221186"/>
                  </a:cubicBezTo>
                  <a:lnTo>
                    <a:pt x="845895" y="1215229"/>
                  </a:lnTo>
                  <a:cubicBezTo>
                    <a:pt x="843909" y="1211258"/>
                    <a:pt x="841687" y="1207396"/>
                    <a:pt x="839938" y="1203315"/>
                  </a:cubicBezTo>
                  <a:cubicBezTo>
                    <a:pt x="838701" y="1200429"/>
                    <a:pt x="838196" y="1197265"/>
                    <a:pt x="836959" y="1194379"/>
                  </a:cubicBezTo>
                  <a:cubicBezTo>
                    <a:pt x="835210" y="1190298"/>
                    <a:pt x="832988" y="1186436"/>
                    <a:pt x="831002" y="1182465"/>
                  </a:cubicBezTo>
                  <a:cubicBezTo>
                    <a:pt x="831995" y="1170551"/>
                    <a:pt x="831903" y="1158496"/>
                    <a:pt x="833981" y="1146723"/>
                  </a:cubicBezTo>
                  <a:cubicBezTo>
                    <a:pt x="834910" y="1141458"/>
                    <a:pt x="840987" y="1137074"/>
                    <a:pt x="839938" y="1131831"/>
                  </a:cubicBezTo>
                  <a:cubicBezTo>
                    <a:pt x="837761" y="1120946"/>
                    <a:pt x="830009" y="1111974"/>
                    <a:pt x="825045" y="1102046"/>
                  </a:cubicBezTo>
                  <a:cubicBezTo>
                    <a:pt x="813131" y="1103039"/>
                    <a:pt x="800798" y="1101740"/>
                    <a:pt x="789303" y="1105024"/>
                  </a:cubicBezTo>
                  <a:cubicBezTo>
                    <a:pt x="785861" y="1106007"/>
                    <a:pt x="785638" y="1111210"/>
                    <a:pt x="783346" y="1113960"/>
                  </a:cubicBezTo>
                  <a:cubicBezTo>
                    <a:pt x="780650" y="1117196"/>
                    <a:pt x="777389" y="1119917"/>
                    <a:pt x="774411" y="1122895"/>
                  </a:cubicBezTo>
                  <a:cubicBezTo>
                    <a:pt x="773418" y="1125874"/>
                    <a:pt x="772836" y="1129023"/>
                    <a:pt x="771432" y="1131831"/>
                  </a:cubicBezTo>
                  <a:cubicBezTo>
                    <a:pt x="768086" y="1138523"/>
                    <a:pt x="762184" y="1144998"/>
                    <a:pt x="756540" y="1149702"/>
                  </a:cubicBezTo>
                  <a:cubicBezTo>
                    <a:pt x="753790" y="1151994"/>
                    <a:pt x="750583" y="1153673"/>
                    <a:pt x="747604" y="1155659"/>
                  </a:cubicBezTo>
                  <a:cubicBezTo>
                    <a:pt x="746611" y="1158637"/>
                    <a:pt x="746184" y="1161868"/>
                    <a:pt x="744626" y="1164594"/>
                  </a:cubicBezTo>
                  <a:cubicBezTo>
                    <a:pt x="729916" y="1190335"/>
                    <a:pt x="738955" y="1161188"/>
                    <a:pt x="714841" y="1197358"/>
                  </a:cubicBezTo>
                  <a:lnTo>
                    <a:pt x="708884" y="1206293"/>
                  </a:lnTo>
                  <a:cubicBezTo>
                    <a:pt x="709877" y="1213243"/>
                    <a:pt x="709011" y="1220728"/>
                    <a:pt x="711862" y="1227143"/>
                  </a:cubicBezTo>
                  <a:cubicBezTo>
                    <a:pt x="713316" y="1230414"/>
                    <a:pt x="718267" y="1230569"/>
                    <a:pt x="720798" y="1233100"/>
                  </a:cubicBezTo>
                  <a:cubicBezTo>
                    <a:pt x="723329" y="1235631"/>
                    <a:pt x="724224" y="1239504"/>
                    <a:pt x="726755" y="1242035"/>
                  </a:cubicBezTo>
                  <a:cubicBezTo>
                    <a:pt x="733611" y="1248891"/>
                    <a:pt x="738490" y="1248692"/>
                    <a:pt x="747604" y="1250971"/>
                  </a:cubicBezTo>
                  <a:cubicBezTo>
                    <a:pt x="760555" y="1263921"/>
                    <a:pt x="754816" y="1259350"/>
                    <a:pt x="774411" y="1271820"/>
                  </a:cubicBezTo>
                  <a:cubicBezTo>
                    <a:pt x="779295" y="1274928"/>
                    <a:pt x="789303" y="1280756"/>
                    <a:pt x="789303" y="1280756"/>
                  </a:cubicBezTo>
                  <a:cubicBezTo>
                    <a:pt x="791289" y="1283734"/>
                    <a:pt x="792968" y="1286941"/>
                    <a:pt x="795260" y="1289691"/>
                  </a:cubicBezTo>
                  <a:cubicBezTo>
                    <a:pt x="802427" y="1298291"/>
                    <a:pt x="804345" y="1298726"/>
                    <a:pt x="813131" y="1304584"/>
                  </a:cubicBezTo>
                  <a:cubicBezTo>
                    <a:pt x="815117" y="1307562"/>
                    <a:pt x="818644" y="1309967"/>
                    <a:pt x="819088" y="1313519"/>
                  </a:cubicBezTo>
                  <a:cubicBezTo>
                    <a:pt x="821473" y="1332596"/>
                    <a:pt x="808017" y="1331617"/>
                    <a:pt x="798239" y="1346283"/>
                  </a:cubicBezTo>
                  <a:cubicBezTo>
                    <a:pt x="789945" y="1358723"/>
                    <a:pt x="794813" y="1352687"/>
                    <a:pt x="783346" y="1364154"/>
                  </a:cubicBezTo>
                  <a:cubicBezTo>
                    <a:pt x="782353" y="1367132"/>
                    <a:pt x="782329" y="1370638"/>
                    <a:pt x="780368" y="1373089"/>
                  </a:cubicBezTo>
                  <a:cubicBezTo>
                    <a:pt x="778132" y="1375884"/>
                    <a:pt x="774182" y="1376754"/>
                    <a:pt x="771432" y="1379046"/>
                  </a:cubicBezTo>
                  <a:cubicBezTo>
                    <a:pt x="768196" y="1381743"/>
                    <a:pt x="765194" y="1384746"/>
                    <a:pt x="762497" y="1387982"/>
                  </a:cubicBezTo>
                  <a:cubicBezTo>
                    <a:pt x="760205" y="1390732"/>
                    <a:pt x="759648" y="1395141"/>
                    <a:pt x="756540" y="1396917"/>
                  </a:cubicBezTo>
                  <a:cubicBezTo>
                    <a:pt x="752144" y="1399429"/>
                    <a:pt x="746611" y="1398903"/>
                    <a:pt x="741647" y="1399896"/>
                  </a:cubicBezTo>
                  <a:lnTo>
                    <a:pt x="723776" y="1396917"/>
                  </a:lnTo>
                  <a:cubicBezTo>
                    <a:pt x="716547" y="1382459"/>
                    <a:pt x="725990" y="1371258"/>
                    <a:pt x="732712" y="1361175"/>
                  </a:cubicBezTo>
                  <a:cubicBezTo>
                    <a:pt x="729733" y="1360182"/>
                    <a:pt x="726795" y="1359060"/>
                    <a:pt x="723776" y="1358197"/>
                  </a:cubicBezTo>
                  <a:cubicBezTo>
                    <a:pt x="719840" y="1357072"/>
                    <a:pt x="715625" y="1356831"/>
                    <a:pt x="711862" y="1355218"/>
                  </a:cubicBezTo>
                  <a:cubicBezTo>
                    <a:pt x="708572" y="1353808"/>
                    <a:pt x="705905" y="1351247"/>
                    <a:pt x="702927" y="1349261"/>
                  </a:cubicBezTo>
                  <a:cubicBezTo>
                    <a:pt x="687042" y="1350254"/>
                    <a:pt x="670764" y="1348595"/>
                    <a:pt x="655271" y="1352240"/>
                  </a:cubicBezTo>
                  <a:cubicBezTo>
                    <a:pt x="652215" y="1352959"/>
                    <a:pt x="653696" y="1358367"/>
                    <a:pt x="652292" y="1361175"/>
                  </a:cubicBezTo>
                  <a:cubicBezTo>
                    <a:pt x="649544" y="1366670"/>
                    <a:pt x="642341" y="1375752"/>
                    <a:pt x="637400" y="1379046"/>
                  </a:cubicBezTo>
                  <a:cubicBezTo>
                    <a:pt x="633313" y="1381771"/>
                    <a:pt x="615982" y="1384400"/>
                    <a:pt x="613572" y="1385003"/>
                  </a:cubicBezTo>
                  <a:cubicBezTo>
                    <a:pt x="610526" y="1385765"/>
                    <a:pt x="607444" y="1386578"/>
                    <a:pt x="604636" y="1387982"/>
                  </a:cubicBezTo>
                  <a:cubicBezTo>
                    <a:pt x="601434" y="1389583"/>
                    <a:pt x="599248" y="1393455"/>
                    <a:pt x="595701" y="1393939"/>
                  </a:cubicBezTo>
                  <a:cubicBezTo>
                    <a:pt x="576984" y="1396491"/>
                    <a:pt x="557973" y="1395924"/>
                    <a:pt x="539109" y="1396917"/>
                  </a:cubicBezTo>
                  <a:cubicBezTo>
                    <a:pt x="537123" y="1402874"/>
                    <a:pt x="538377" y="1411305"/>
                    <a:pt x="533152" y="1414788"/>
                  </a:cubicBezTo>
                  <a:cubicBezTo>
                    <a:pt x="530174" y="1416774"/>
                    <a:pt x="526967" y="1418453"/>
                    <a:pt x="524217" y="1420745"/>
                  </a:cubicBezTo>
                  <a:cubicBezTo>
                    <a:pt x="520981" y="1423442"/>
                    <a:pt x="518893" y="1427514"/>
                    <a:pt x="515281" y="1429681"/>
                  </a:cubicBezTo>
                  <a:cubicBezTo>
                    <a:pt x="502726" y="1437214"/>
                    <a:pt x="495239" y="1438414"/>
                    <a:pt x="482518" y="1441595"/>
                  </a:cubicBezTo>
                  <a:cubicBezTo>
                    <a:pt x="477554" y="1444573"/>
                    <a:pt x="473219" y="1449038"/>
                    <a:pt x="467625" y="1450530"/>
                  </a:cubicBezTo>
                  <a:cubicBezTo>
                    <a:pt x="457984" y="1453101"/>
                    <a:pt x="447718" y="1452098"/>
                    <a:pt x="437840" y="1453509"/>
                  </a:cubicBezTo>
                  <a:cubicBezTo>
                    <a:pt x="433788" y="1454088"/>
                    <a:pt x="429897" y="1455494"/>
                    <a:pt x="425926" y="1456487"/>
                  </a:cubicBezTo>
                  <a:cubicBezTo>
                    <a:pt x="419333" y="1460883"/>
                    <a:pt x="412642" y="1464500"/>
                    <a:pt x="408055" y="1471380"/>
                  </a:cubicBezTo>
                  <a:cubicBezTo>
                    <a:pt x="406271" y="1474055"/>
                    <a:pt x="402593" y="1490496"/>
                    <a:pt x="402098" y="1492229"/>
                  </a:cubicBezTo>
                  <a:cubicBezTo>
                    <a:pt x="399391" y="1501705"/>
                    <a:pt x="396947" y="1505967"/>
                    <a:pt x="393163" y="1516057"/>
                  </a:cubicBezTo>
                  <a:cubicBezTo>
                    <a:pt x="392060" y="1518997"/>
                    <a:pt x="391047" y="1521974"/>
                    <a:pt x="390184" y="1524993"/>
                  </a:cubicBezTo>
                  <a:cubicBezTo>
                    <a:pt x="389059" y="1528929"/>
                    <a:pt x="389763" y="1533711"/>
                    <a:pt x="387206" y="1536907"/>
                  </a:cubicBezTo>
                  <a:cubicBezTo>
                    <a:pt x="385245" y="1539359"/>
                    <a:pt x="381156" y="1538648"/>
                    <a:pt x="378270" y="1539885"/>
                  </a:cubicBezTo>
                  <a:cubicBezTo>
                    <a:pt x="374189" y="1541634"/>
                    <a:pt x="370437" y="1544093"/>
                    <a:pt x="366356" y="1545842"/>
                  </a:cubicBezTo>
                  <a:cubicBezTo>
                    <a:pt x="357021" y="1549843"/>
                    <a:pt x="350267" y="1550013"/>
                    <a:pt x="339550" y="1551799"/>
                  </a:cubicBezTo>
                  <a:cubicBezTo>
                    <a:pt x="334586" y="1554778"/>
                    <a:pt x="330032" y="1558585"/>
                    <a:pt x="324657" y="1560735"/>
                  </a:cubicBezTo>
                  <a:cubicBezTo>
                    <a:pt x="319957" y="1562615"/>
                    <a:pt x="314707" y="1562615"/>
                    <a:pt x="309765" y="1563713"/>
                  </a:cubicBezTo>
                  <a:cubicBezTo>
                    <a:pt x="305769" y="1564601"/>
                    <a:pt x="301822" y="1565699"/>
                    <a:pt x="297851" y="1566692"/>
                  </a:cubicBezTo>
                  <a:cubicBezTo>
                    <a:pt x="292887" y="1569670"/>
                    <a:pt x="288136" y="1573038"/>
                    <a:pt x="282958" y="1575627"/>
                  </a:cubicBezTo>
                  <a:cubicBezTo>
                    <a:pt x="280150" y="1577031"/>
                    <a:pt x="276749" y="1577048"/>
                    <a:pt x="274023" y="1578606"/>
                  </a:cubicBezTo>
                  <a:cubicBezTo>
                    <a:pt x="269713" y="1581069"/>
                    <a:pt x="265878" y="1584310"/>
                    <a:pt x="262109" y="1587541"/>
                  </a:cubicBezTo>
                  <a:cubicBezTo>
                    <a:pt x="258911" y="1590282"/>
                    <a:pt x="256830" y="1594387"/>
                    <a:pt x="253173" y="1596477"/>
                  </a:cubicBezTo>
                  <a:cubicBezTo>
                    <a:pt x="249619" y="1598508"/>
                    <a:pt x="245195" y="1598330"/>
                    <a:pt x="241259" y="1599455"/>
                  </a:cubicBezTo>
                  <a:cubicBezTo>
                    <a:pt x="211349" y="1608001"/>
                    <a:pt x="257656" y="1596102"/>
                    <a:pt x="220410" y="1605412"/>
                  </a:cubicBezTo>
                  <a:cubicBezTo>
                    <a:pt x="205517" y="1603426"/>
                    <a:pt x="190146" y="1603694"/>
                    <a:pt x="175732" y="1599455"/>
                  </a:cubicBezTo>
                  <a:cubicBezTo>
                    <a:pt x="172298" y="1598445"/>
                    <a:pt x="172469" y="1592877"/>
                    <a:pt x="169775" y="1590520"/>
                  </a:cubicBezTo>
                  <a:cubicBezTo>
                    <a:pt x="155233" y="1577796"/>
                    <a:pt x="146301" y="1576505"/>
                    <a:pt x="128076" y="1569670"/>
                  </a:cubicBezTo>
                  <a:cubicBezTo>
                    <a:pt x="125098" y="1565699"/>
                    <a:pt x="122319" y="1561569"/>
                    <a:pt x="119141" y="1557756"/>
                  </a:cubicBezTo>
                  <a:cubicBezTo>
                    <a:pt x="117343" y="1555599"/>
                    <a:pt x="114628" y="1554207"/>
                    <a:pt x="113183" y="1551799"/>
                  </a:cubicBezTo>
                  <a:cubicBezTo>
                    <a:pt x="103591" y="1535813"/>
                    <a:pt x="119069" y="1548773"/>
                    <a:pt x="101269" y="1536907"/>
                  </a:cubicBezTo>
                  <a:cubicBezTo>
                    <a:pt x="100276" y="1533928"/>
                    <a:pt x="100252" y="1530423"/>
                    <a:pt x="98291" y="1527971"/>
                  </a:cubicBezTo>
                  <a:cubicBezTo>
                    <a:pt x="95485" y="1524463"/>
                    <a:pt x="80372" y="1517522"/>
                    <a:pt x="77441" y="1516057"/>
                  </a:cubicBezTo>
                  <a:cubicBezTo>
                    <a:pt x="67096" y="1485022"/>
                    <a:pt x="78260" y="1509635"/>
                    <a:pt x="59570" y="1486272"/>
                  </a:cubicBezTo>
                  <a:cubicBezTo>
                    <a:pt x="55098" y="1480681"/>
                    <a:pt x="52718" y="1473463"/>
                    <a:pt x="47656" y="1468401"/>
                  </a:cubicBezTo>
                  <a:cubicBezTo>
                    <a:pt x="41699" y="1462444"/>
                    <a:pt x="34458" y="1457539"/>
                    <a:pt x="29785" y="1450530"/>
                  </a:cubicBezTo>
                  <a:cubicBezTo>
                    <a:pt x="21491" y="1438090"/>
                    <a:pt x="26359" y="1444126"/>
                    <a:pt x="14893" y="1432659"/>
                  </a:cubicBezTo>
                  <a:cubicBezTo>
                    <a:pt x="7405" y="1410199"/>
                    <a:pt x="18377" y="1437015"/>
                    <a:pt x="2979" y="1417767"/>
                  </a:cubicBezTo>
                  <a:cubicBezTo>
                    <a:pt x="1018" y="1415315"/>
                    <a:pt x="993" y="1411810"/>
                    <a:pt x="0" y="1408831"/>
                  </a:cubicBezTo>
                  <a:cubicBezTo>
                    <a:pt x="1986" y="1405853"/>
                    <a:pt x="3579" y="1402571"/>
                    <a:pt x="5957" y="1399896"/>
                  </a:cubicBezTo>
                  <a:cubicBezTo>
                    <a:pt x="11554" y="1393600"/>
                    <a:pt x="23828" y="1382025"/>
                    <a:pt x="23828" y="1382025"/>
                  </a:cubicBezTo>
                  <a:lnTo>
                    <a:pt x="29785" y="1358197"/>
                  </a:lnTo>
                  <a:cubicBezTo>
                    <a:pt x="30778" y="1354226"/>
                    <a:pt x="30933" y="1349944"/>
                    <a:pt x="32764" y="1346283"/>
                  </a:cubicBezTo>
                  <a:lnTo>
                    <a:pt x="38721" y="1334369"/>
                  </a:lnTo>
                  <a:cubicBezTo>
                    <a:pt x="40707" y="1325433"/>
                    <a:pt x="42458" y="1316442"/>
                    <a:pt x="44678" y="1307562"/>
                  </a:cubicBezTo>
                  <a:cubicBezTo>
                    <a:pt x="45439" y="1304516"/>
                    <a:pt x="45695" y="1301078"/>
                    <a:pt x="47656" y="1298627"/>
                  </a:cubicBezTo>
                  <a:cubicBezTo>
                    <a:pt x="49892" y="1295832"/>
                    <a:pt x="53138" y="1293612"/>
                    <a:pt x="56592" y="1292670"/>
                  </a:cubicBezTo>
                  <a:cubicBezTo>
                    <a:pt x="68376" y="1289456"/>
                    <a:pt x="127783" y="1286731"/>
                    <a:pt x="128076" y="1286713"/>
                  </a:cubicBezTo>
                  <a:cubicBezTo>
                    <a:pt x="131055" y="1284727"/>
                    <a:pt x="133810" y="1282357"/>
                    <a:pt x="137012" y="1280756"/>
                  </a:cubicBezTo>
                  <a:cubicBezTo>
                    <a:pt x="139820" y="1279352"/>
                    <a:pt x="143727" y="1279997"/>
                    <a:pt x="145947" y="1277777"/>
                  </a:cubicBezTo>
                  <a:cubicBezTo>
                    <a:pt x="148167" y="1275557"/>
                    <a:pt x="147933" y="1271820"/>
                    <a:pt x="148926" y="1268842"/>
                  </a:cubicBezTo>
                  <a:cubicBezTo>
                    <a:pt x="150912" y="1255935"/>
                    <a:pt x="153194" y="1243070"/>
                    <a:pt x="154883" y="1230121"/>
                  </a:cubicBezTo>
                  <a:cubicBezTo>
                    <a:pt x="156173" y="1220227"/>
                    <a:pt x="154927" y="1209873"/>
                    <a:pt x="157861" y="1200336"/>
                  </a:cubicBezTo>
                  <a:cubicBezTo>
                    <a:pt x="159100" y="1196310"/>
                    <a:pt x="164056" y="1194599"/>
                    <a:pt x="166797" y="1191401"/>
                  </a:cubicBezTo>
                  <a:cubicBezTo>
                    <a:pt x="181576" y="1174159"/>
                    <a:pt x="168936" y="1184018"/>
                    <a:pt x="184668" y="1173530"/>
                  </a:cubicBezTo>
                  <a:cubicBezTo>
                    <a:pt x="186396" y="1170074"/>
                    <a:pt x="193204" y="1157862"/>
                    <a:pt x="193603" y="1152680"/>
                  </a:cubicBezTo>
                  <a:cubicBezTo>
                    <a:pt x="194364" y="1142781"/>
                    <a:pt x="193603" y="1132823"/>
                    <a:pt x="193603" y="1122895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フリーフォーム: 図形 21">
              <a:extLst>
                <a:ext uri="{FF2B5EF4-FFF2-40B4-BE49-F238E27FC236}">
                  <a16:creationId xmlns:a16="http://schemas.microsoft.com/office/drawing/2014/main" id="{200D502B-F22C-43CE-82F1-2833E27BF7F2}"/>
                </a:ext>
              </a:extLst>
            </p:cNvPr>
            <p:cNvSpPr/>
            <p:nvPr/>
          </p:nvSpPr>
          <p:spPr>
            <a:xfrm>
              <a:off x="1797648" y="4368593"/>
              <a:ext cx="1936924" cy="384848"/>
            </a:xfrm>
            <a:custGeom>
              <a:avLst/>
              <a:gdLst>
                <a:gd name="connsiteX0" fmla="*/ 1936915 w 1936924"/>
                <a:gd name="connsiteY0" fmla="*/ 251052 h 384848"/>
                <a:gd name="connsiteX1" fmla="*/ 1935083 w 1936924"/>
                <a:gd name="connsiteY1" fmla="*/ 241889 h 384848"/>
                <a:gd name="connsiteX2" fmla="*/ 1913093 w 1936924"/>
                <a:gd name="connsiteY2" fmla="*/ 247387 h 384848"/>
                <a:gd name="connsiteX3" fmla="*/ 1907596 w 1936924"/>
                <a:gd name="connsiteY3" fmla="*/ 251052 h 384848"/>
                <a:gd name="connsiteX4" fmla="*/ 1902099 w 1936924"/>
                <a:gd name="connsiteY4" fmla="*/ 252884 h 384848"/>
                <a:gd name="connsiteX5" fmla="*/ 1896601 w 1936924"/>
                <a:gd name="connsiteY5" fmla="*/ 258381 h 384848"/>
                <a:gd name="connsiteX6" fmla="*/ 1891104 w 1936924"/>
                <a:gd name="connsiteY6" fmla="*/ 260214 h 384848"/>
                <a:gd name="connsiteX7" fmla="*/ 1880109 w 1936924"/>
                <a:gd name="connsiteY7" fmla="*/ 265711 h 384848"/>
                <a:gd name="connsiteX8" fmla="*/ 1874612 w 1936924"/>
                <a:gd name="connsiteY8" fmla="*/ 269376 h 384848"/>
                <a:gd name="connsiteX9" fmla="*/ 1808643 w 1936924"/>
                <a:gd name="connsiteY9" fmla="*/ 265711 h 384848"/>
                <a:gd name="connsiteX10" fmla="*/ 1803146 w 1936924"/>
                <a:gd name="connsiteY10" fmla="*/ 263879 h 384848"/>
                <a:gd name="connsiteX11" fmla="*/ 1799481 w 1936924"/>
                <a:gd name="connsiteY11" fmla="*/ 258381 h 384848"/>
                <a:gd name="connsiteX12" fmla="*/ 1788486 w 1936924"/>
                <a:gd name="connsiteY12" fmla="*/ 251052 h 384848"/>
                <a:gd name="connsiteX13" fmla="*/ 1775659 w 1936924"/>
                <a:gd name="connsiteY13" fmla="*/ 238224 h 384848"/>
                <a:gd name="connsiteX14" fmla="*/ 1771994 w 1936924"/>
                <a:gd name="connsiteY14" fmla="*/ 232727 h 384848"/>
                <a:gd name="connsiteX15" fmla="*/ 1755501 w 1936924"/>
                <a:gd name="connsiteY15" fmla="*/ 221732 h 384848"/>
                <a:gd name="connsiteX16" fmla="*/ 1750004 w 1936924"/>
                <a:gd name="connsiteY16" fmla="*/ 219900 h 384848"/>
                <a:gd name="connsiteX17" fmla="*/ 1742674 w 1936924"/>
                <a:gd name="connsiteY17" fmla="*/ 216235 h 384848"/>
                <a:gd name="connsiteX18" fmla="*/ 1729847 w 1936924"/>
                <a:gd name="connsiteY18" fmla="*/ 208905 h 384848"/>
                <a:gd name="connsiteX19" fmla="*/ 1718852 w 1936924"/>
                <a:gd name="connsiteY19" fmla="*/ 201575 h 384848"/>
                <a:gd name="connsiteX20" fmla="*/ 1706025 w 1936924"/>
                <a:gd name="connsiteY20" fmla="*/ 196078 h 384848"/>
                <a:gd name="connsiteX21" fmla="*/ 1695030 w 1936924"/>
                <a:gd name="connsiteY21" fmla="*/ 188748 h 384848"/>
                <a:gd name="connsiteX22" fmla="*/ 1689533 w 1936924"/>
                <a:gd name="connsiteY22" fmla="*/ 186915 h 384848"/>
                <a:gd name="connsiteX23" fmla="*/ 1678538 w 1936924"/>
                <a:gd name="connsiteY23" fmla="*/ 181418 h 384848"/>
                <a:gd name="connsiteX24" fmla="*/ 1663878 w 1936924"/>
                <a:gd name="connsiteY24" fmla="*/ 175920 h 384848"/>
                <a:gd name="connsiteX25" fmla="*/ 1651051 w 1936924"/>
                <a:gd name="connsiteY25" fmla="*/ 174088 h 384848"/>
                <a:gd name="connsiteX26" fmla="*/ 1643721 w 1936924"/>
                <a:gd name="connsiteY26" fmla="*/ 172256 h 384848"/>
                <a:gd name="connsiteX27" fmla="*/ 1577752 w 1936924"/>
                <a:gd name="connsiteY27" fmla="*/ 168591 h 384848"/>
                <a:gd name="connsiteX28" fmla="*/ 1563093 w 1936924"/>
                <a:gd name="connsiteY28" fmla="*/ 166758 h 384848"/>
                <a:gd name="connsiteX29" fmla="*/ 1552098 w 1936924"/>
                <a:gd name="connsiteY29" fmla="*/ 161261 h 384848"/>
                <a:gd name="connsiteX30" fmla="*/ 1546600 w 1936924"/>
                <a:gd name="connsiteY30" fmla="*/ 159428 h 384848"/>
                <a:gd name="connsiteX31" fmla="*/ 1539271 w 1936924"/>
                <a:gd name="connsiteY31" fmla="*/ 153931 h 384848"/>
                <a:gd name="connsiteX32" fmla="*/ 1519113 w 1936924"/>
                <a:gd name="connsiteY32" fmla="*/ 155763 h 384848"/>
                <a:gd name="connsiteX33" fmla="*/ 1508119 w 1936924"/>
                <a:gd name="connsiteY33" fmla="*/ 166758 h 384848"/>
                <a:gd name="connsiteX34" fmla="*/ 1497124 w 1936924"/>
                <a:gd name="connsiteY34" fmla="*/ 175920 h 384848"/>
                <a:gd name="connsiteX35" fmla="*/ 1493459 w 1936924"/>
                <a:gd name="connsiteY35" fmla="*/ 181418 h 384848"/>
                <a:gd name="connsiteX36" fmla="*/ 1480632 w 1936924"/>
                <a:gd name="connsiteY36" fmla="*/ 186915 h 384848"/>
                <a:gd name="connsiteX37" fmla="*/ 1475134 w 1936924"/>
                <a:gd name="connsiteY37" fmla="*/ 188748 h 384848"/>
                <a:gd name="connsiteX38" fmla="*/ 1469637 w 1936924"/>
                <a:gd name="connsiteY38" fmla="*/ 194245 h 384848"/>
                <a:gd name="connsiteX39" fmla="*/ 1460475 w 1936924"/>
                <a:gd name="connsiteY39" fmla="*/ 196078 h 384848"/>
                <a:gd name="connsiteX40" fmla="*/ 1454977 w 1936924"/>
                <a:gd name="connsiteY40" fmla="*/ 197910 h 384848"/>
                <a:gd name="connsiteX41" fmla="*/ 1443982 w 1936924"/>
                <a:gd name="connsiteY41" fmla="*/ 199743 h 384848"/>
                <a:gd name="connsiteX42" fmla="*/ 1431155 w 1936924"/>
                <a:gd name="connsiteY42" fmla="*/ 207072 h 384848"/>
                <a:gd name="connsiteX43" fmla="*/ 1423825 w 1936924"/>
                <a:gd name="connsiteY43" fmla="*/ 214402 h 384848"/>
                <a:gd name="connsiteX44" fmla="*/ 1410998 w 1936924"/>
                <a:gd name="connsiteY44" fmla="*/ 218067 h 384848"/>
                <a:gd name="connsiteX45" fmla="*/ 1401836 w 1936924"/>
                <a:gd name="connsiteY45" fmla="*/ 227230 h 384848"/>
                <a:gd name="connsiteX46" fmla="*/ 1396338 w 1936924"/>
                <a:gd name="connsiteY46" fmla="*/ 230894 h 384848"/>
                <a:gd name="connsiteX47" fmla="*/ 1390841 w 1936924"/>
                <a:gd name="connsiteY47" fmla="*/ 236392 h 384848"/>
                <a:gd name="connsiteX48" fmla="*/ 1379846 w 1936924"/>
                <a:gd name="connsiteY48" fmla="*/ 241889 h 384848"/>
                <a:gd name="connsiteX49" fmla="*/ 1359689 w 1936924"/>
                <a:gd name="connsiteY49" fmla="*/ 247387 h 384848"/>
                <a:gd name="connsiteX50" fmla="*/ 1348694 w 1936924"/>
                <a:gd name="connsiteY50" fmla="*/ 251052 h 384848"/>
                <a:gd name="connsiteX51" fmla="*/ 1284558 w 1936924"/>
                <a:gd name="connsiteY51" fmla="*/ 249219 h 384848"/>
                <a:gd name="connsiteX52" fmla="*/ 1279061 w 1936924"/>
                <a:gd name="connsiteY52" fmla="*/ 245554 h 384848"/>
                <a:gd name="connsiteX53" fmla="*/ 1273563 w 1936924"/>
                <a:gd name="connsiteY53" fmla="*/ 243722 h 384848"/>
                <a:gd name="connsiteX54" fmla="*/ 1258903 w 1936924"/>
                <a:gd name="connsiteY54" fmla="*/ 241889 h 384848"/>
                <a:gd name="connsiteX55" fmla="*/ 1249741 w 1936924"/>
                <a:gd name="connsiteY55" fmla="*/ 240057 h 384848"/>
                <a:gd name="connsiteX56" fmla="*/ 1244244 w 1936924"/>
                <a:gd name="connsiteY56" fmla="*/ 236392 h 384848"/>
                <a:gd name="connsiteX57" fmla="*/ 1220422 w 1936924"/>
                <a:gd name="connsiteY57" fmla="*/ 230894 h 384848"/>
                <a:gd name="connsiteX58" fmla="*/ 1198432 w 1936924"/>
                <a:gd name="connsiteY58" fmla="*/ 229062 h 384848"/>
                <a:gd name="connsiteX59" fmla="*/ 1191102 w 1936924"/>
                <a:gd name="connsiteY59" fmla="*/ 225397 h 384848"/>
                <a:gd name="connsiteX60" fmla="*/ 1143458 w 1936924"/>
                <a:gd name="connsiteY60" fmla="*/ 221732 h 384848"/>
                <a:gd name="connsiteX61" fmla="*/ 1092149 w 1936924"/>
                <a:gd name="connsiteY61" fmla="*/ 221732 h 384848"/>
                <a:gd name="connsiteX62" fmla="*/ 1088484 w 1936924"/>
                <a:gd name="connsiteY62" fmla="*/ 227230 h 384848"/>
                <a:gd name="connsiteX63" fmla="*/ 1077489 w 1936924"/>
                <a:gd name="connsiteY63" fmla="*/ 230894 h 384848"/>
                <a:gd name="connsiteX64" fmla="*/ 1071992 w 1936924"/>
                <a:gd name="connsiteY64" fmla="*/ 234559 h 384848"/>
                <a:gd name="connsiteX65" fmla="*/ 1066495 w 1936924"/>
                <a:gd name="connsiteY65" fmla="*/ 236392 h 384848"/>
                <a:gd name="connsiteX66" fmla="*/ 1060997 w 1936924"/>
                <a:gd name="connsiteY66" fmla="*/ 241889 h 384848"/>
                <a:gd name="connsiteX67" fmla="*/ 1055500 w 1936924"/>
                <a:gd name="connsiteY67" fmla="*/ 245554 h 384848"/>
                <a:gd name="connsiteX68" fmla="*/ 1042673 w 1936924"/>
                <a:gd name="connsiteY68" fmla="*/ 256549 h 384848"/>
                <a:gd name="connsiteX69" fmla="*/ 1037175 w 1936924"/>
                <a:gd name="connsiteY69" fmla="*/ 258381 h 384848"/>
                <a:gd name="connsiteX70" fmla="*/ 943719 w 1936924"/>
                <a:gd name="connsiteY70" fmla="*/ 265711 h 384848"/>
                <a:gd name="connsiteX71" fmla="*/ 918065 w 1936924"/>
                <a:gd name="connsiteY71" fmla="*/ 263879 h 384848"/>
                <a:gd name="connsiteX72" fmla="*/ 883248 w 1936924"/>
                <a:gd name="connsiteY72" fmla="*/ 260214 h 384848"/>
                <a:gd name="connsiteX73" fmla="*/ 877751 w 1936924"/>
                <a:gd name="connsiteY73" fmla="*/ 258381 h 384848"/>
                <a:gd name="connsiteX74" fmla="*/ 861259 w 1936924"/>
                <a:gd name="connsiteY74" fmla="*/ 254716 h 384848"/>
                <a:gd name="connsiteX75" fmla="*/ 846599 w 1936924"/>
                <a:gd name="connsiteY75" fmla="*/ 249219 h 384848"/>
                <a:gd name="connsiteX76" fmla="*/ 831939 w 1936924"/>
                <a:gd name="connsiteY76" fmla="*/ 245554 h 384848"/>
                <a:gd name="connsiteX77" fmla="*/ 813614 w 1936924"/>
                <a:gd name="connsiteY77" fmla="*/ 247387 h 384848"/>
                <a:gd name="connsiteX78" fmla="*/ 808117 w 1936924"/>
                <a:gd name="connsiteY78" fmla="*/ 251052 h 384848"/>
                <a:gd name="connsiteX79" fmla="*/ 798955 w 1936924"/>
                <a:gd name="connsiteY79" fmla="*/ 256549 h 384848"/>
                <a:gd name="connsiteX80" fmla="*/ 789792 w 1936924"/>
                <a:gd name="connsiteY80" fmla="*/ 258381 h 384848"/>
                <a:gd name="connsiteX81" fmla="*/ 773300 w 1936924"/>
                <a:gd name="connsiteY81" fmla="*/ 263879 h 384848"/>
                <a:gd name="connsiteX82" fmla="*/ 762305 w 1936924"/>
                <a:gd name="connsiteY82" fmla="*/ 267544 h 384848"/>
                <a:gd name="connsiteX83" fmla="*/ 740316 w 1936924"/>
                <a:gd name="connsiteY83" fmla="*/ 265711 h 384848"/>
                <a:gd name="connsiteX84" fmla="*/ 732986 w 1936924"/>
                <a:gd name="connsiteY84" fmla="*/ 254716 h 384848"/>
                <a:gd name="connsiteX85" fmla="*/ 727489 w 1936924"/>
                <a:gd name="connsiteY85" fmla="*/ 243722 h 384848"/>
                <a:gd name="connsiteX86" fmla="*/ 723824 w 1936924"/>
                <a:gd name="connsiteY86" fmla="*/ 236392 h 384848"/>
                <a:gd name="connsiteX87" fmla="*/ 718326 w 1936924"/>
                <a:gd name="connsiteY87" fmla="*/ 230894 h 384848"/>
                <a:gd name="connsiteX88" fmla="*/ 709164 w 1936924"/>
                <a:gd name="connsiteY88" fmla="*/ 216235 h 384848"/>
                <a:gd name="connsiteX89" fmla="*/ 705499 w 1936924"/>
                <a:gd name="connsiteY89" fmla="*/ 210737 h 384848"/>
                <a:gd name="connsiteX90" fmla="*/ 701834 w 1936924"/>
                <a:gd name="connsiteY90" fmla="*/ 203407 h 384848"/>
                <a:gd name="connsiteX91" fmla="*/ 696337 w 1936924"/>
                <a:gd name="connsiteY91" fmla="*/ 199743 h 384848"/>
                <a:gd name="connsiteX92" fmla="*/ 690839 w 1936924"/>
                <a:gd name="connsiteY92" fmla="*/ 192413 h 384848"/>
                <a:gd name="connsiteX93" fmla="*/ 672515 w 1936924"/>
                <a:gd name="connsiteY93" fmla="*/ 188748 h 384848"/>
                <a:gd name="connsiteX94" fmla="*/ 646860 w 1936924"/>
                <a:gd name="connsiteY94" fmla="*/ 190580 h 384848"/>
                <a:gd name="connsiteX95" fmla="*/ 643195 w 1936924"/>
                <a:gd name="connsiteY95" fmla="*/ 196078 h 384848"/>
                <a:gd name="connsiteX96" fmla="*/ 635865 w 1936924"/>
                <a:gd name="connsiteY96" fmla="*/ 201575 h 384848"/>
                <a:gd name="connsiteX97" fmla="*/ 630368 w 1936924"/>
                <a:gd name="connsiteY97" fmla="*/ 207072 h 384848"/>
                <a:gd name="connsiteX98" fmla="*/ 628535 w 1936924"/>
                <a:gd name="connsiteY98" fmla="*/ 216235 h 384848"/>
                <a:gd name="connsiteX99" fmla="*/ 621206 w 1936924"/>
                <a:gd name="connsiteY99" fmla="*/ 223565 h 384848"/>
                <a:gd name="connsiteX100" fmla="*/ 610211 w 1936924"/>
                <a:gd name="connsiteY100" fmla="*/ 232727 h 384848"/>
                <a:gd name="connsiteX101" fmla="*/ 606546 w 1936924"/>
                <a:gd name="connsiteY101" fmla="*/ 238224 h 384848"/>
                <a:gd name="connsiteX102" fmla="*/ 601049 w 1936924"/>
                <a:gd name="connsiteY102" fmla="*/ 241889 h 384848"/>
                <a:gd name="connsiteX103" fmla="*/ 599216 w 1936924"/>
                <a:gd name="connsiteY103" fmla="*/ 249219 h 384848"/>
                <a:gd name="connsiteX104" fmla="*/ 595551 w 1936924"/>
                <a:gd name="connsiteY104" fmla="*/ 258381 h 384848"/>
                <a:gd name="connsiteX105" fmla="*/ 593719 w 1936924"/>
                <a:gd name="connsiteY105" fmla="*/ 269376 h 384848"/>
                <a:gd name="connsiteX106" fmla="*/ 590054 w 1936924"/>
                <a:gd name="connsiteY106" fmla="*/ 276706 h 384848"/>
                <a:gd name="connsiteX107" fmla="*/ 588221 w 1936924"/>
                <a:gd name="connsiteY107" fmla="*/ 311523 h 384848"/>
                <a:gd name="connsiteX108" fmla="*/ 586389 w 1936924"/>
                <a:gd name="connsiteY108" fmla="*/ 317020 h 384848"/>
                <a:gd name="connsiteX109" fmla="*/ 564399 w 1936924"/>
                <a:gd name="connsiteY109" fmla="*/ 335345 h 384848"/>
                <a:gd name="connsiteX110" fmla="*/ 558902 w 1936924"/>
                <a:gd name="connsiteY110" fmla="*/ 339010 h 384848"/>
                <a:gd name="connsiteX111" fmla="*/ 555237 w 1936924"/>
                <a:gd name="connsiteY111" fmla="*/ 344507 h 384848"/>
                <a:gd name="connsiteX112" fmla="*/ 560734 w 1936924"/>
                <a:gd name="connsiteY112" fmla="*/ 371994 h 384848"/>
                <a:gd name="connsiteX113" fmla="*/ 568064 w 1936924"/>
                <a:gd name="connsiteY113" fmla="*/ 375659 h 384848"/>
                <a:gd name="connsiteX114" fmla="*/ 573562 w 1936924"/>
                <a:gd name="connsiteY114" fmla="*/ 377492 h 384848"/>
                <a:gd name="connsiteX115" fmla="*/ 579059 w 1936924"/>
                <a:gd name="connsiteY115" fmla="*/ 382989 h 384848"/>
                <a:gd name="connsiteX116" fmla="*/ 573562 w 1936924"/>
                <a:gd name="connsiteY116" fmla="*/ 384821 h 384848"/>
                <a:gd name="connsiteX117" fmla="*/ 536912 w 1936924"/>
                <a:gd name="connsiteY117" fmla="*/ 381157 h 384848"/>
                <a:gd name="connsiteX118" fmla="*/ 514923 w 1936924"/>
                <a:gd name="connsiteY118" fmla="*/ 375659 h 384848"/>
                <a:gd name="connsiteX119" fmla="*/ 503928 w 1936924"/>
                <a:gd name="connsiteY119" fmla="*/ 368329 h 384848"/>
                <a:gd name="connsiteX120" fmla="*/ 489268 w 1936924"/>
                <a:gd name="connsiteY120" fmla="*/ 362832 h 384848"/>
                <a:gd name="connsiteX121" fmla="*/ 476441 w 1936924"/>
                <a:gd name="connsiteY121" fmla="*/ 359167 h 384848"/>
                <a:gd name="connsiteX122" fmla="*/ 470944 w 1936924"/>
                <a:gd name="connsiteY122" fmla="*/ 355502 h 384848"/>
                <a:gd name="connsiteX123" fmla="*/ 454451 w 1936924"/>
                <a:gd name="connsiteY123" fmla="*/ 351837 h 384848"/>
                <a:gd name="connsiteX124" fmla="*/ 432462 w 1936924"/>
                <a:gd name="connsiteY124" fmla="*/ 346340 h 384848"/>
                <a:gd name="connsiteX125" fmla="*/ 425132 w 1936924"/>
                <a:gd name="connsiteY125" fmla="*/ 340842 h 384848"/>
                <a:gd name="connsiteX126" fmla="*/ 419634 w 1936924"/>
                <a:gd name="connsiteY126" fmla="*/ 337177 h 384848"/>
                <a:gd name="connsiteX127" fmla="*/ 406807 w 1936924"/>
                <a:gd name="connsiteY127" fmla="*/ 326183 h 384848"/>
                <a:gd name="connsiteX128" fmla="*/ 401310 w 1936924"/>
                <a:gd name="connsiteY128" fmla="*/ 324350 h 384848"/>
                <a:gd name="connsiteX129" fmla="*/ 384818 w 1936924"/>
                <a:gd name="connsiteY129" fmla="*/ 311523 h 384848"/>
                <a:gd name="connsiteX130" fmla="*/ 377488 w 1936924"/>
                <a:gd name="connsiteY130" fmla="*/ 306026 h 384848"/>
                <a:gd name="connsiteX131" fmla="*/ 357331 w 1936924"/>
                <a:gd name="connsiteY131" fmla="*/ 296863 h 384848"/>
                <a:gd name="connsiteX132" fmla="*/ 346336 w 1936924"/>
                <a:gd name="connsiteY132" fmla="*/ 291366 h 384848"/>
                <a:gd name="connsiteX133" fmla="*/ 340839 w 1936924"/>
                <a:gd name="connsiteY133" fmla="*/ 287701 h 384848"/>
                <a:gd name="connsiteX134" fmla="*/ 333509 w 1936924"/>
                <a:gd name="connsiteY134" fmla="*/ 282203 h 384848"/>
                <a:gd name="connsiteX135" fmla="*/ 318849 w 1936924"/>
                <a:gd name="connsiteY135" fmla="*/ 278539 h 384848"/>
                <a:gd name="connsiteX136" fmla="*/ 307854 w 1936924"/>
                <a:gd name="connsiteY136" fmla="*/ 271209 h 384848"/>
                <a:gd name="connsiteX137" fmla="*/ 296859 w 1936924"/>
                <a:gd name="connsiteY137" fmla="*/ 258381 h 384848"/>
                <a:gd name="connsiteX138" fmla="*/ 289529 w 1936924"/>
                <a:gd name="connsiteY138" fmla="*/ 256549 h 384848"/>
                <a:gd name="connsiteX139" fmla="*/ 284032 w 1936924"/>
                <a:gd name="connsiteY139" fmla="*/ 251052 h 384848"/>
                <a:gd name="connsiteX140" fmla="*/ 276702 w 1936924"/>
                <a:gd name="connsiteY140" fmla="*/ 249219 h 384848"/>
                <a:gd name="connsiteX141" fmla="*/ 271205 w 1936924"/>
                <a:gd name="connsiteY141" fmla="*/ 245554 h 384848"/>
                <a:gd name="connsiteX142" fmla="*/ 252880 w 1936924"/>
                <a:gd name="connsiteY142" fmla="*/ 247387 h 384848"/>
                <a:gd name="connsiteX143" fmla="*/ 247383 w 1936924"/>
                <a:gd name="connsiteY143" fmla="*/ 249219 h 384848"/>
                <a:gd name="connsiteX144" fmla="*/ 227226 w 1936924"/>
                <a:gd name="connsiteY144" fmla="*/ 252884 h 384848"/>
                <a:gd name="connsiteX145" fmla="*/ 212566 w 1936924"/>
                <a:gd name="connsiteY145" fmla="*/ 258381 h 384848"/>
                <a:gd name="connsiteX146" fmla="*/ 201571 w 1936924"/>
                <a:gd name="connsiteY146" fmla="*/ 262046 h 384848"/>
                <a:gd name="connsiteX147" fmla="*/ 196074 w 1936924"/>
                <a:gd name="connsiteY147" fmla="*/ 263879 h 384848"/>
                <a:gd name="connsiteX148" fmla="*/ 175917 w 1936924"/>
                <a:gd name="connsiteY148" fmla="*/ 262046 h 384848"/>
                <a:gd name="connsiteX149" fmla="*/ 166754 w 1936924"/>
                <a:gd name="connsiteY149" fmla="*/ 260214 h 384848"/>
                <a:gd name="connsiteX150" fmla="*/ 155760 w 1936924"/>
                <a:gd name="connsiteY150" fmla="*/ 251052 h 384848"/>
                <a:gd name="connsiteX151" fmla="*/ 148430 w 1936924"/>
                <a:gd name="connsiteY151" fmla="*/ 249219 h 384848"/>
                <a:gd name="connsiteX152" fmla="*/ 142932 w 1936924"/>
                <a:gd name="connsiteY152" fmla="*/ 247387 h 384848"/>
                <a:gd name="connsiteX153" fmla="*/ 135602 w 1936924"/>
                <a:gd name="connsiteY153" fmla="*/ 245554 h 384848"/>
                <a:gd name="connsiteX154" fmla="*/ 130105 w 1936924"/>
                <a:gd name="connsiteY154" fmla="*/ 243722 h 384848"/>
                <a:gd name="connsiteX155" fmla="*/ 97121 w 1936924"/>
                <a:gd name="connsiteY155" fmla="*/ 241889 h 384848"/>
                <a:gd name="connsiteX156" fmla="*/ 75131 w 1936924"/>
                <a:gd name="connsiteY156" fmla="*/ 238224 h 384848"/>
                <a:gd name="connsiteX157" fmla="*/ 45812 w 1936924"/>
                <a:gd name="connsiteY157" fmla="*/ 234559 h 384848"/>
                <a:gd name="connsiteX158" fmla="*/ 40314 w 1936924"/>
                <a:gd name="connsiteY158" fmla="*/ 232727 h 384848"/>
                <a:gd name="connsiteX159" fmla="*/ 32984 w 1936924"/>
                <a:gd name="connsiteY159" fmla="*/ 230894 h 384848"/>
                <a:gd name="connsiteX160" fmla="*/ 27487 w 1936924"/>
                <a:gd name="connsiteY160" fmla="*/ 227230 h 384848"/>
                <a:gd name="connsiteX161" fmla="*/ 14660 w 1936924"/>
                <a:gd name="connsiteY161" fmla="*/ 223565 h 384848"/>
                <a:gd name="connsiteX162" fmla="*/ 7330 w 1936924"/>
                <a:gd name="connsiteY162" fmla="*/ 219900 h 384848"/>
                <a:gd name="connsiteX163" fmla="*/ 1832 w 1936924"/>
                <a:gd name="connsiteY163" fmla="*/ 218067 h 384848"/>
                <a:gd name="connsiteX164" fmla="*/ 0 w 1936924"/>
                <a:gd name="connsiteY164" fmla="*/ 212570 h 384848"/>
                <a:gd name="connsiteX165" fmla="*/ 3665 w 1936924"/>
                <a:gd name="connsiteY165" fmla="*/ 192413 h 384848"/>
                <a:gd name="connsiteX166" fmla="*/ 7330 w 1936924"/>
                <a:gd name="connsiteY166" fmla="*/ 186915 h 384848"/>
                <a:gd name="connsiteX167" fmla="*/ 10995 w 1936924"/>
                <a:gd name="connsiteY167" fmla="*/ 174088 h 384848"/>
                <a:gd name="connsiteX168" fmla="*/ 12827 w 1936924"/>
                <a:gd name="connsiteY168" fmla="*/ 150266 h 384848"/>
                <a:gd name="connsiteX169" fmla="*/ 14660 w 1936924"/>
                <a:gd name="connsiteY169" fmla="*/ 144769 h 384848"/>
                <a:gd name="connsiteX170" fmla="*/ 25655 w 1936924"/>
                <a:gd name="connsiteY170" fmla="*/ 133774 h 384848"/>
                <a:gd name="connsiteX171" fmla="*/ 31152 w 1936924"/>
                <a:gd name="connsiteY171" fmla="*/ 128276 h 384848"/>
                <a:gd name="connsiteX172" fmla="*/ 34817 w 1936924"/>
                <a:gd name="connsiteY172" fmla="*/ 122779 h 384848"/>
                <a:gd name="connsiteX173" fmla="*/ 36649 w 1936924"/>
                <a:gd name="connsiteY173" fmla="*/ 117282 h 384848"/>
                <a:gd name="connsiteX174" fmla="*/ 38482 w 1936924"/>
                <a:gd name="connsiteY174" fmla="*/ 109952 h 384848"/>
                <a:gd name="connsiteX175" fmla="*/ 43979 w 1936924"/>
                <a:gd name="connsiteY175" fmla="*/ 104454 h 384848"/>
                <a:gd name="connsiteX176" fmla="*/ 47644 w 1936924"/>
                <a:gd name="connsiteY176" fmla="*/ 98957 h 384848"/>
                <a:gd name="connsiteX177" fmla="*/ 58639 w 1936924"/>
                <a:gd name="connsiteY177" fmla="*/ 91627 h 384848"/>
                <a:gd name="connsiteX178" fmla="*/ 71466 w 1936924"/>
                <a:gd name="connsiteY178" fmla="*/ 82465 h 384848"/>
                <a:gd name="connsiteX179" fmla="*/ 117278 w 1936924"/>
                <a:gd name="connsiteY179" fmla="*/ 84297 h 384848"/>
                <a:gd name="connsiteX180" fmla="*/ 139267 w 1936924"/>
                <a:gd name="connsiteY180" fmla="*/ 87962 h 384848"/>
                <a:gd name="connsiteX181" fmla="*/ 142932 w 1936924"/>
                <a:gd name="connsiteY181" fmla="*/ 93460 h 384848"/>
                <a:gd name="connsiteX182" fmla="*/ 148430 w 1936924"/>
                <a:gd name="connsiteY182" fmla="*/ 98957 h 384848"/>
                <a:gd name="connsiteX183" fmla="*/ 155760 w 1936924"/>
                <a:gd name="connsiteY183" fmla="*/ 111784 h 384848"/>
                <a:gd name="connsiteX184" fmla="*/ 185079 w 1936924"/>
                <a:gd name="connsiteY184" fmla="*/ 117282 h 384848"/>
                <a:gd name="connsiteX185" fmla="*/ 210733 w 1936924"/>
                <a:gd name="connsiteY185" fmla="*/ 115449 h 384848"/>
                <a:gd name="connsiteX186" fmla="*/ 219896 w 1936924"/>
                <a:gd name="connsiteY186" fmla="*/ 111784 h 384848"/>
                <a:gd name="connsiteX187" fmla="*/ 225393 w 1936924"/>
                <a:gd name="connsiteY187" fmla="*/ 109952 h 384848"/>
                <a:gd name="connsiteX188" fmla="*/ 236388 w 1936924"/>
                <a:gd name="connsiteY188" fmla="*/ 100789 h 384848"/>
                <a:gd name="connsiteX189" fmla="*/ 249215 w 1936924"/>
                <a:gd name="connsiteY189" fmla="*/ 97124 h 384848"/>
                <a:gd name="connsiteX190" fmla="*/ 260210 w 1936924"/>
                <a:gd name="connsiteY190" fmla="*/ 89795 h 384848"/>
                <a:gd name="connsiteX191" fmla="*/ 285865 w 1936924"/>
                <a:gd name="connsiteY191" fmla="*/ 86130 h 384848"/>
                <a:gd name="connsiteX192" fmla="*/ 293194 w 1936924"/>
                <a:gd name="connsiteY192" fmla="*/ 84297 h 384848"/>
                <a:gd name="connsiteX193" fmla="*/ 296859 w 1936924"/>
                <a:gd name="connsiteY193" fmla="*/ 78800 h 384848"/>
                <a:gd name="connsiteX194" fmla="*/ 307854 w 1936924"/>
                <a:gd name="connsiteY194" fmla="*/ 76967 h 384848"/>
                <a:gd name="connsiteX195" fmla="*/ 313352 w 1936924"/>
                <a:gd name="connsiteY195" fmla="*/ 75135 h 384848"/>
                <a:gd name="connsiteX196" fmla="*/ 326179 w 1936924"/>
                <a:gd name="connsiteY196" fmla="*/ 62308 h 384848"/>
                <a:gd name="connsiteX197" fmla="*/ 333509 w 1936924"/>
                <a:gd name="connsiteY197" fmla="*/ 49480 h 384848"/>
                <a:gd name="connsiteX198" fmla="*/ 339006 w 1936924"/>
                <a:gd name="connsiteY198" fmla="*/ 47648 h 384848"/>
                <a:gd name="connsiteX199" fmla="*/ 346336 w 1936924"/>
                <a:gd name="connsiteY199" fmla="*/ 38486 h 384848"/>
                <a:gd name="connsiteX200" fmla="*/ 351833 w 1936924"/>
                <a:gd name="connsiteY200" fmla="*/ 34821 h 384848"/>
                <a:gd name="connsiteX201" fmla="*/ 357331 w 1936924"/>
                <a:gd name="connsiteY201" fmla="*/ 23826 h 384848"/>
                <a:gd name="connsiteX202" fmla="*/ 379320 w 1936924"/>
                <a:gd name="connsiteY202" fmla="*/ 14664 h 384848"/>
                <a:gd name="connsiteX203" fmla="*/ 393980 w 1936924"/>
                <a:gd name="connsiteY203" fmla="*/ 12831 h 384848"/>
                <a:gd name="connsiteX204" fmla="*/ 415970 w 1936924"/>
                <a:gd name="connsiteY204" fmla="*/ 5501 h 384848"/>
                <a:gd name="connsiteX205" fmla="*/ 421467 w 1936924"/>
                <a:gd name="connsiteY205" fmla="*/ 3669 h 384848"/>
                <a:gd name="connsiteX206" fmla="*/ 428797 w 1936924"/>
                <a:gd name="connsiteY206" fmla="*/ 1836 h 384848"/>
                <a:gd name="connsiteX207" fmla="*/ 436127 w 1936924"/>
                <a:gd name="connsiteY207" fmla="*/ 4 h 3848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</a:cxnLst>
              <a:rect l="l" t="t" r="r" b="b"/>
              <a:pathLst>
                <a:path w="1936924" h="384848">
                  <a:moveTo>
                    <a:pt x="1936915" y="251052"/>
                  </a:moveTo>
                  <a:cubicBezTo>
                    <a:pt x="1936304" y="247998"/>
                    <a:pt x="1938162" y="242363"/>
                    <a:pt x="1935083" y="241889"/>
                  </a:cubicBezTo>
                  <a:cubicBezTo>
                    <a:pt x="1927615" y="240740"/>
                    <a:pt x="1913093" y="247387"/>
                    <a:pt x="1913093" y="247387"/>
                  </a:cubicBezTo>
                  <a:cubicBezTo>
                    <a:pt x="1911261" y="248609"/>
                    <a:pt x="1909566" y="250067"/>
                    <a:pt x="1907596" y="251052"/>
                  </a:cubicBezTo>
                  <a:cubicBezTo>
                    <a:pt x="1905868" y="251916"/>
                    <a:pt x="1903706" y="251813"/>
                    <a:pt x="1902099" y="252884"/>
                  </a:cubicBezTo>
                  <a:cubicBezTo>
                    <a:pt x="1899943" y="254321"/>
                    <a:pt x="1898757" y="256943"/>
                    <a:pt x="1896601" y="258381"/>
                  </a:cubicBezTo>
                  <a:cubicBezTo>
                    <a:pt x="1894994" y="259452"/>
                    <a:pt x="1892832" y="259350"/>
                    <a:pt x="1891104" y="260214"/>
                  </a:cubicBezTo>
                  <a:cubicBezTo>
                    <a:pt x="1876903" y="267315"/>
                    <a:pt x="1893918" y="261109"/>
                    <a:pt x="1880109" y="265711"/>
                  </a:cubicBezTo>
                  <a:cubicBezTo>
                    <a:pt x="1878277" y="266933"/>
                    <a:pt x="1876813" y="269313"/>
                    <a:pt x="1874612" y="269376"/>
                  </a:cubicBezTo>
                  <a:cubicBezTo>
                    <a:pt x="1848264" y="270129"/>
                    <a:pt x="1830462" y="271945"/>
                    <a:pt x="1808643" y="265711"/>
                  </a:cubicBezTo>
                  <a:cubicBezTo>
                    <a:pt x="1806786" y="265180"/>
                    <a:pt x="1804978" y="264490"/>
                    <a:pt x="1803146" y="263879"/>
                  </a:cubicBezTo>
                  <a:cubicBezTo>
                    <a:pt x="1801924" y="262046"/>
                    <a:pt x="1801139" y="259831"/>
                    <a:pt x="1799481" y="258381"/>
                  </a:cubicBezTo>
                  <a:cubicBezTo>
                    <a:pt x="1796166" y="255481"/>
                    <a:pt x="1788486" y="251052"/>
                    <a:pt x="1788486" y="251052"/>
                  </a:cubicBezTo>
                  <a:cubicBezTo>
                    <a:pt x="1780202" y="238624"/>
                    <a:pt x="1790891" y="253456"/>
                    <a:pt x="1775659" y="238224"/>
                  </a:cubicBezTo>
                  <a:cubicBezTo>
                    <a:pt x="1774102" y="236667"/>
                    <a:pt x="1773551" y="234284"/>
                    <a:pt x="1771994" y="232727"/>
                  </a:cubicBezTo>
                  <a:cubicBezTo>
                    <a:pt x="1768926" y="229659"/>
                    <a:pt x="1758989" y="223476"/>
                    <a:pt x="1755501" y="221732"/>
                  </a:cubicBezTo>
                  <a:cubicBezTo>
                    <a:pt x="1753773" y="220868"/>
                    <a:pt x="1751779" y="220661"/>
                    <a:pt x="1750004" y="219900"/>
                  </a:cubicBezTo>
                  <a:cubicBezTo>
                    <a:pt x="1747493" y="218824"/>
                    <a:pt x="1745117" y="217457"/>
                    <a:pt x="1742674" y="216235"/>
                  </a:cubicBezTo>
                  <a:cubicBezTo>
                    <a:pt x="1730333" y="203891"/>
                    <a:pt x="1744612" y="216287"/>
                    <a:pt x="1729847" y="208905"/>
                  </a:cubicBezTo>
                  <a:cubicBezTo>
                    <a:pt x="1725907" y="206935"/>
                    <a:pt x="1722792" y="203545"/>
                    <a:pt x="1718852" y="201575"/>
                  </a:cubicBezTo>
                  <a:cubicBezTo>
                    <a:pt x="1709794" y="197046"/>
                    <a:pt x="1714114" y="198774"/>
                    <a:pt x="1706025" y="196078"/>
                  </a:cubicBezTo>
                  <a:cubicBezTo>
                    <a:pt x="1702360" y="193635"/>
                    <a:pt x="1699209" y="190141"/>
                    <a:pt x="1695030" y="188748"/>
                  </a:cubicBezTo>
                  <a:cubicBezTo>
                    <a:pt x="1693198" y="188137"/>
                    <a:pt x="1691261" y="187779"/>
                    <a:pt x="1689533" y="186915"/>
                  </a:cubicBezTo>
                  <a:cubicBezTo>
                    <a:pt x="1675332" y="179814"/>
                    <a:pt x="1692347" y="186020"/>
                    <a:pt x="1678538" y="181418"/>
                  </a:cubicBezTo>
                  <a:cubicBezTo>
                    <a:pt x="1670984" y="176381"/>
                    <a:pt x="1674445" y="177681"/>
                    <a:pt x="1663878" y="175920"/>
                  </a:cubicBezTo>
                  <a:cubicBezTo>
                    <a:pt x="1659618" y="175210"/>
                    <a:pt x="1655300" y="174860"/>
                    <a:pt x="1651051" y="174088"/>
                  </a:cubicBezTo>
                  <a:cubicBezTo>
                    <a:pt x="1648573" y="173638"/>
                    <a:pt x="1646232" y="172444"/>
                    <a:pt x="1643721" y="172256"/>
                  </a:cubicBezTo>
                  <a:cubicBezTo>
                    <a:pt x="1621759" y="170609"/>
                    <a:pt x="1599742" y="169813"/>
                    <a:pt x="1577752" y="168591"/>
                  </a:cubicBezTo>
                  <a:cubicBezTo>
                    <a:pt x="1572866" y="167980"/>
                    <a:pt x="1567938" y="167639"/>
                    <a:pt x="1563093" y="166758"/>
                  </a:cubicBezTo>
                  <a:cubicBezTo>
                    <a:pt x="1555851" y="165441"/>
                    <a:pt x="1558808" y="164616"/>
                    <a:pt x="1552098" y="161261"/>
                  </a:cubicBezTo>
                  <a:cubicBezTo>
                    <a:pt x="1550370" y="160397"/>
                    <a:pt x="1548433" y="160039"/>
                    <a:pt x="1546600" y="159428"/>
                  </a:cubicBezTo>
                  <a:cubicBezTo>
                    <a:pt x="1544157" y="157596"/>
                    <a:pt x="1542298" y="154335"/>
                    <a:pt x="1539271" y="153931"/>
                  </a:cubicBezTo>
                  <a:cubicBezTo>
                    <a:pt x="1532583" y="153039"/>
                    <a:pt x="1525710" y="154349"/>
                    <a:pt x="1519113" y="155763"/>
                  </a:cubicBezTo>
                  <a:cubicBezTo>
                    <a:pt x="1514033" y="156852"/>
                    <a:pt x="1510835" y="163589"/>
                    <a:pt x="1508119" y="166758"/>
                  </a:cubicBezTo>
                  <a:cubicBezTo>
                    <a:pt x="1503415" y="172246"/>
                    <a:pt x="1502780" y="172150"/>
                    <a:pt x="1497124" y="175920"/>
                  </a:cubicBezTo>
                  <a:cubicBezTo>
                    <a:pt x="1495902" y="177753"/>
                    <a:pt x="1495016" y="179860"/>
                    <a:pt x="1493459" y="181418"/>
                  </a:cubicBezTo>
                  <a:cubicBezTo>
                    <a:pt x="1488995" y="185882"/>
                    <a:pt x="1486521" y="185233"/>
                    <a:pt x="1480632" y="186915"/>
                  </a:cubicBezTo>
                  <a:cubicBezTo>
                    <a:pt x="1478774" y="187446"/>
                    <a:pt x="1476967" y="188137"/>
                    <a:pt x="1475134" y="188748"/>
                  </a:cubicBezTo>
                  <a:cubicBezTo>
                    <a:pt x="1473302" y="190580"/>
                    <a:pt x="1471955" y="193086"/>
                    <a:pt x="1469637" y="194245"/>
                  </a:cubicBezTo>
                  <a:cubicBezTo>
                    <a:pt x="1466851" y="195638"/>
                    <a:pt x="1463497" y="195323"/>
                    <a:pt x="1460475" y="196078"/>
                  </a:cubicBezTo>
                  <a:cubicBezTo>
                    <a:pt x="1458601" y="196547"/>
                    <a:pt x="1456863" y="197491"/>
                    <a:pt x="1454977" y="197910"/>
                  </a:cubicBezTo>
                  <a:cubicBezTo>
                    <a:pt x="1451350" y="198716"/>
                    <a:pt x="1447647" y="199132"/>
                    <a:pt x="1443982" y="199743"/>
                  </a:cubicBezTo>
                  <a:cubicBezTo>
                    <a:pt x="1426576" y="217149"/>
                    <a:pt x="1450843" y="194768"/>
                    <a:pt x="1431155" y="207072"/>
                  </a:cubicBezTo>
                  <a:cubicBezTo>
                    <a:pt x="1428225" y="208903"/>
                    <a:pt x="1426637" y="212393"/>
                    <a:pt x="1423825" y="214402"/>
                  </a:cubicBezTo>
                  <a:cubicBezTo>
                    <a:pt x="1422407" y="215415"/>
                    <a:pt x="1411768" y="217874"/>
                    <a:pt x="1410998" y="218067"/>
                  </a:cubicBezTo>
                  <a:cubicBezTo>
                    <a:pt x="1396332" y="227845"/>
                    <a:pt x="1414060" y="215008"/>
                    <a:pt x="1401836" y="227230"/>
                  </a:cubicBezTo>
                  <a:cubicBezTo>
                    <a:pt x="1400279" y="228787"/>
                    <a:pt x="1398030" y="229484"/>
                    <a:pt x="1396338" y="230894"/>
                  </a:cubicBezTo>
                  <a:cubicBezTo>
                    <a:pt x="1394347" y="232553"/>
                    <a:pt x="1392832" y="234733"/>
                    <a:pt x="1390841" y="236392"/>
                  </a:cubicBezTo>
                  <a:cubicBezTo>
                    <a:pt x="1387000" y="239593"/>
                    <a:pt x="1384570" y="240708"/>
                    <a:pt x="1379846" y="241889"/>
                  </a:cubicBezTo>
                  <a:cubicBezTo>
                    <a:pt x="1359136" y="247067"/>
                    <a:pt x="1383264" y="239529"/>
                    <a:pt x="1359689" y="247387"/>
                  </a:cubicBezTo>
                  <a:lnTo>
                    <a:pt x="1348694" y="251052"/>
                  </a:lnTo>
                  <a:cubicBezTo>
                    <a:pt x="1327315" y="250441"/>
                    <a:pt x="1305879" y="250902"/>
                    <a:pt x="1284558" y="249219"/>
                  </a:cubicBezTo>
                  <a:cubicBezTo>
                    <a:pt x="1282363" y="249046"/>
                    <a:pt x="1281031" y="246539"/>
                    <a:pt x="1279061" y="245554"/>
                  </a:cubicBezTo>
                  <a:cubicBezTo>
                    <a:pt x="1277333" y="244690"/>
                    <a:pt x="1275464" y="244068"/>
                    <a:pt x="1273563" y="243722"/>
                  </a:cubicBezTo>
                  <a:cubicBezTo>
                    <a:pt x="1268718" y="242841"/>
                    <a:pt x="1263770" y="242638"/>
                    <a:pt x="1258903" y="241889"/>
                  </a:cubicBezTo>
                  <a:cubicBezTo>
                    <a:pt x="1255825" y="241415"/>
                    <a:pt x="1252795" y="240668"/>
                    <a:pt x="1249741" y="240057"/>
                  </a:cubicBezTo>
                  <a:cubicBezTo>
                    <a:pt x="1247909" y="238835"/>
                    <a:pt x="1246256" y="237286"/>
                    <a:pt x="1244244" y="236392"/>
                  </a:cubicBezTo>
                  <a:cubicBezTo>
                    <a:pt x="1235749" y="232616"/>
                    <a:pt x="1229698" y="231870"/>
                    <a:pt x="1220422" y="230894"/>
                  </a:cubicBezTo>
                  <a:cubicBezTo>
                    <a:pt x="1213107" y="230124"/>
                    <a:pt x="1205762" y="229673"/>
                    <a:pt x="1198432" y="229062"/>
                  </a:cubicBezTo>
                  <a:cubicBezTo>
                    <a:pt x="1195989" y="227840"/>
                    <a:pt x="1193660" y="226356"/>
                    <a:pt x="1191102" y="225397"/>
                  </a:cubicBezTo>
                  <a:cubicBezTo>
                    <a:pt x="1178455" y="220655"/>
                    <a:pt x="1144980" y="221801"/>
                    <a:pt x="1143458" y="221732"/>
                  </a:cubicBezTo>
                  <a:cubicBezTo>
                    <a:pt x="1124677" y="219854"/>
                    <a:pt x="1112426" y="217676"/>
                    <a:pt x="1092149" y="221732"/>
                  </a:cubicBezTo>
                  <a:cubicBezTo>
                    <a:pt x="1089989" y="222164"/>
                    <a:pt x="1090352" y="226063"/>
                    <a:pt x="1088484" y="227230"/>
                  </a:cubicBezTo>
                  <a:cubicBezTo>
                    <a:pt x="1085208" y="229277"/>
                    <a:pt x="1077489" y="230894"/>
                    <a:pt x="1077489" y="230894"/>
                  </a:cubicBezTo>
                  <a:cubicBezTo>
                    <a:pt x="1075657" y="232116"/>
                    <a:pt x="1073962" y="233574"/>
                    <a:pt x="1071992" y="234559"/>
                  </a:cubicBezTo>
                  <a:cubicBezTo>
                    <a:pt x="1070264" y="235423"/>
                    <a:pt x="1068102" y="235321"/>
                    <a:pt x="1066495" y="236392"/>
                  </a:cubicBezTo>
                  <a:cubicBezTo>
                    <a:pt x="1064339" y="237830"/>
                    <a:pt x="1062988" y="240230"/>
                    <a:pt x="1060997" y="241889"/>
                  </a:cubicBezTo>
                  <a:cubicBezTo>
                    <a:pt x="1059305" y="243299"/>
                    <a:pt x="1057172" y="244121"/>
                    <a:pt x="1055500" y="245554"/>
                  </a:cubicBezTo>
                  <a:cubicBezTo>
                    <a:pt x="1049192" y="250961"/>
                    <a:pt x="1049401" y="253185"/>
                    <a:pt x="1042673" y="256549"/>
                  </a:cubicBezTo>
                  <a:cubicBezTo>
                    <a:pt x="1040945" y="257413"/>
                    <a:pt x="1039039" y="257873"/>
                    <a:pt x="1037175" y="258381"/>
                  </a:cubicBezTo>
                  <a:cubicBezTo>
                    <a:pt x="1001037" y="268236"/>
                    <a:pt x="1006507" y="262791"/>
                    <a:pt x="943719" y="265711"/>
                  </a:cubicBezTo>
                  <a:cubicBezTo>
                    <a:pt x="927399" y="268976"/>
                    <a:pt x="940555" y="267628"/>
                    <a:pt x="918065" y="263879"/>
                  </a:cubicBezTo>
                  <a:cubicBezTo>
                    <a:pt x="914281" y="263248"/>
                    <a:pt x="886201" y="260509"/>
                    <a:pt x="883248" y="260214"/>
                  </a:cubicBezTo>
                  <a:cubicBezTo>
                    <a:pt x="881416" y="259603"/>
                    <a:pt x="879625" y="258849"/>
                    <a:pt x="877751" y="258381"/>
                  </a:cubicBezTo>
                  <a:cubicBezTo>
                    <a:pt x="862583" y="254589"/>
                    <a:pt x="874468" y="258490"/>
                    <a:pt x="861259" y="254716"/>
                  </a:cubicBezTo>
                  <a:cubicBezTo>
                    <a:pt x="844233" y="249851"/>
                    <a:pt x="871870" y="256995"/>
                    <a:pt x="846599" y="249219"/>
                  </a:cubicBezTo>
                  <a:cubicBezTo>
                    <a:pt x="841785" y="247738"/>
                    <a:pt x="831939" y="245554"/>
                    <a:pt x="831939" y="245554"/>
                  </a:cubicBezTo>
                  <a:cubicBezTo>
                    <a:pt x="825831" y="246165"/>
                    <a:pt x="819596" y="246006"/>
                    <a:pt x="813614" y="247387"/>
                  </a:cubicBezTo>
                  <a:cubicBezTo>
                    <a:pt x="811468" y="247882"/>
                    <a:pt x="809984" y="249885"/>
                    <a:pt x="808117" y="251052"/>
                  </a:cubicBezTo>
                  <a:cubicBezTo>
                    <a:pt x="805097" y="252940"/>
                    <a:pt x="802262" y="255226"/>
                    <a:pt x="798955" y="256549"/>
                  </a:cubicBezTo>
                  <a:cubicBezTo>
                    <a:pt x="796063" y="257706"/>
                    <a:pt x="792846" y="257770"/>
                    <a:pt x="789792" y="258381"/>
                  </a:cubicBezTo>
                  <a:cubicBezTo>
                    <a:pt x="771427" y="265728"/>
                    <a:pt x="789078" y="259145"/>
                    <a:pt x="773300" y="263879"/>
                  </a:cubicBezTo>
                  <a:cubicBezTo>
                    <a:pt x="769600" y="264989"/>
                    <a:pt x="762305" y="267544"/>
                    <a:pt x="762305" y="267544"/>
                  </a:cubicBezTo>
                  <a:cubicBezTo>
                    <a:pt x="754975" y="266933"/>
                    <a:pt x="747054" y="268659"/>
                    <a:pt x="740316" y="265711"/>
                  </a:cubicBezTo>
                  <a:cubicBezTo>
                    <a:pt x="736281" y="263945"/>
                    <a:pt x="732986" y="254716"/>
                    <a:pt x="732986" y="254716"/>
                  </a:cubicBezTo>
                  <a:cubicBezTo>
                    <a:pt x="729627" y="244637"/>
                    <a:pt x="733173" y="253668"/>
                    <a:pt x="727489" y="243722"/>
                  </a:cubicBezTo>
                  <a:cubicBezTo>
                    <a:pt x="726134" y="241350"/>
                    <a:pt x="725412" y="238615"/>
                    <a:pt x="723824" y="236392"/>
                  </a:cubicBezTo>
                  <a:cubicBezTo>
                    <a:pt x="722318" y="234283"/>
                    <a:pt x="720159" y="232727"/>
                    <a:pt x="718326" y="230894"/>
                  </a:cubicBezTo>
                  <a:cubicBezTo>
                    <a:pt x="715265" y="218650"/>
                    <a:pt x="718811" y="227490"/>
                    <a:pt x="709164" y="216235"/>
                  </a:cubicBezTo>
                  <a:cubicBezTo>
                    <a:pt x="707731" y="214563"/>
                    <a:pt x="706592" y="212649"/>
                    <a:pt x="705499" y="210737"/>
                  </a:cubicBezTo>
                  <a:cubicBezTo>
                    <a:pt x="704144" y="208365"/>
                    <a:pt x="703583" y="205506"/>
                    <a:pt x="701834" y="203407"/>
                  </a:cubicBezTo>
                  <a:cubicBezTo>
                    <a:pt x="700424" y="201715"/>
                    <a:pt x="698169" y="200964"/>
                    <a:pt x="696337" y="199743"/>
                  </a:cubicBezTo>
                  <a:cubicBezTo>
                    <a:pt x="694504" y="197300"/>
                    <a:pt x="693612" y="193693"/>
                    <a:pt x="690839" y="192413"/>
                  </a:cubicBezTo>
                  <a:cubicBezTo>
                    <a:pt x="685183" y="189803"/>
                    <a:pt x="672515" y="188748"/>
                    <a:pt x="672515" y="188748"/>
                  </a:cubicBezTo>
                  <a:cubicBezTo>
                    <a:pt x="663963" y="189359"/>
                    <a:pt x="655177" y="188501"/>
                    <a:pt x="646860" y="190580"/>
                  </a:cubicBezTo>
                  <a:cubicBezTo>
                    <a:pt x="644723" y="191114"/>
                    <a:pt x="644752" y="194521"/>
                    <a:pt x="643195" y="196078"/>
                  </a:cubicBezTo>
                  <a:cubicBezTo>
                    <a:pt x="641035" y="198238"/>
                    <a:pt x="638184" y="199587"/>
                    <a:pt x="635865" y="201575"/>
                  </a:cubicBezTo>
                  <a:cubicBezTo>
                    <a:pt x="633897" y="203261"/>
                    <a:pt x="632200" y="205240"/>
                    <a:pt x="630368" y="207072"/>
                  </a:cubicBezTo>
                  <a:cubicBezTo>
                    <a:pt x="629757" y="210126"/>
                    <a:pt x="630048" y="213512"/>
                    <a:pt x="628535" y="216235"/>
                  </a:cubicBezTo>
                  <a:cubicBezTo>
                    <a:pt x="626857" y="219255"/>
                    <a:pt x="623455" y="220942"/>
                    <a:pt x="621206" y="223565"/>
                  </a:cubicBezTo>
                  <a:cubicBezTo>
                    <a:pt x="613437" y="232629"/>
                    <a:pt x="622722" y="226472"/>
                    <a:pt x="610211" y="232727"/>
                  </a:cubicBezTo>
                  <a:cubicBezTo>
                    <a:pt x="608989" y="234559"/>
                    <a:pt x="608103" y="236667"/>
                    <a:pt x="606546" y="238224"/>
                  </a:cubicBezTo>
                  <a:cubicBezTo>
                    <a:pt x="604989" y="239781"/>
                    <a:pt x="602271" y="240057"/>
                    <a:pt x="601049" y="241889"/>
                  </a:cubicBezTo>
                  <a:cubicBezTo>
                    <a:pt x="599652" y="243985"/>
                    <a:pt x="600013" y="246830"/>
                    <a:pt x="599216" y="249219"/>
                  </a:cubicBezTo>
                  <a:cubicBezTo>
                    <a:pt x="598176" y="252339"/>
                    <a:pt x="596773" y="255327"/>
                    <a:pt x="595551" y="258381"/>
                  </a:cubicBezTo>
                  <a:cubicBezTo>
                    <a:pt x="594940" y="262046"/>
                    <a:pt x="594787" y="265817"/>
                    <a:pt x="593719" y="269376"/>
                  </a:cubicBezTo>
                  <a:cubicBezTo>
                    <a:pt x="592934" y="271993"/>
                    <a:pt x="590407" y="273997"/>
                    <a:pt x="590054" y="276706"/>
                  </a:cubicBezTo>
                  <a:cubicBezTo>
                    <a:pt x="588551" y="288230"/>
                    <a:pt x="589273" y="299949"/>
                    <a:pt x="588221" y="311523"/>
                  </a:cubicBezTo>
                  <a:cubicBezTo>
                    <a:pt x="588046" y="313446"/>
                    <a:pt x="587575" y="315495"/>
                    <a:pt x="586389" y="317020"/>
                  </a:cubicBezTo>
                  <a:cubicBezTo>
                    <a:pt x="578791" y="326789"/>
                    <a:pt x="574173" y="328829"/>
                    <a:pt x="564399" y="335345"/>
                  </a:cubicBezTo>
                  <a:lnTo>
                    <a:pt x="558902" y="339010"/>
                  </a:lnTo>
                  <a:cubicBezTo>
                    <a:pt x="557680" y="340842"/>
                    <a:pt x="555384" y="342310"/>
                    <a:pt x="555237" y="344507"/>
                  </a:cubicBezTo>
                  <a:cubicBezTo>
                    <a:pt x="554905" y="349492"/>
                    <a:pt x="553691" y="366126"/>
                    <a:pt x="560734" y="371994"/>
                  </a:cubicBezTo>
                  <a:cubicBezTo>
                    <a:pt x="562833" y="373743"/>
                    <a:pt x="565553" y="374583"/>
                    <a:pt x="568064" y="375659"/>
                  </a:cubicBezTo>
                  <a:cubicBezTo>
                    <a:pt x="569840" y="376420"/>
                    <a:pt x="571729" y="376881"/>
                    <a:pt x="573562" y="377492"/>
                  </a:cubicBezTo>
                  <a:cubicBezTo>
                    <a:pt x="575394" y="379324"/>
                    <a:pt x="579059" y="380398"/>
                    <a:pt x="579059" y="382989"/>
                  </a:cubicBezTo>
                  <a:cubicBezTo>
                    <a:pt x="579059" y="384920"/>
                    <a:pt x="575492" y="384905"/>
                    <a:pt x="573562" y="384821"/>
                  </a:cubicBezTo>
                  <a:cubicBezTo>
                    <a:pt x="561296" y="384288"/>
                    <a:pt x="549109" y="382564"/>
                    <a:pt x="536912" y="381157"/>
                  </a:cubicBezTo>
                  <a:cubicBezTo>
                    <a:pt x="531928" y="380582"/>
                    <a:pt x="519231" y="378531"/>
                    <a:pt x="514923" y="375659"/>
                  </a:cubicBezTo>
                  <a:cubicBezTo>
                    <a:pt x="511258" y="373216"/>
                    <a:pt x="508107" y="369721"/>
                    <a:pt x="503928" y="368329"/>
                  </a:cubicBezTo>
                  <a:cubicBezTo>
                    <a:pt x="491472" y="364178"/>
                    <a:pt x="506759" y="369392"/>
                    <a:pt x="489268" y="362832"/>
                  </a:cubicBezTo>
                  <a:cubicBezTo>
                    <a:pt x="484004" y="360858"/>
                    <a:pt x="482226" y="360613"/>
                    <a:pt x="476441" y="359167"/>
                  </a:cubicBezTo>
                  <a:cubicBezTo>
                    <a:pt x="474609" y="357945"/>
                    <a:pt x="472968" y="356369"/>
                    <a:pt x="470944" y="355502"/>
                  </a:cubicBezTo>
                  <a:cubicBezTo>
                    <a:pt x="468071" y="354271"/>
                    <a:pt x="456834" y="352487"/>
                    <a:pt x="454451" y="351837"/>
                  </a:cubicBezTo>
                  <a:cubicBezTo>
                    <a:pt x="431642" y="345616"/>
                    <a:pt x="455241" y="350136"/>
                    <a:pt x="432462" y="346340"/>
                  </a:cubicBezTo>
                  <a:cubicBezTo>
                    <a:pt x="430019" y="344507"/>
                    <a:pt x="427617" y="342617"/>
                    <a:pt x="425132" y="340842"/>
                  </a:cubicBezTo>
                  <a:cubicBezTo>
                    <a:pt x="423340" y="339562"/>
                    <a:pt x="421306" y="338610"/>
                    <a:pt x="419634" y="337177"/>
                  </a:cubicBezTo>
                  <a:cubicBezTo>
                    <a:pt x="413318" y="331763"/>
                    <a:pt x="413541" y="329550"/>
                    <a:pt x="406807" y="326183"/>
                  </a:cubicBezTo>
                  <a:cubicBezTo>
                    <a:pt x="405079" y="325319"/>
                    <a:pt x="403142" y="324961"/>
                    <a:pt x="401310" y="324350"/>
                  </a:cubicBezTo>
                  <a:cubicBezTo>
                    <a:pt x="390121" y="313163"/>
                    <a:pt x="402347" y="324668"/>
                    <a:pt x="384818" y="311523"/>
                  </a:cubicBezTo>
                  <a:cubicBezTo>
                    <a:pt x="382375" y="309691"/>
                    <a:pt x="380107" y="307597"/>
                    <a:pt x="377488" y="306026"/>
                  </a:cubicBezTo>
                  <a:cubicBezTo>
                    <a:pt x="361332" y="296332"/>
                    <a:pt x="372079" y="304237"/>
                    <a:pt x="357331" y="296863"/>
                  </a:cubicBezTo>
                  <a:cubicBezTo>
                    <a:pt x="343126" y="289761"/>
                    <a:pt x="360149" y="295969"/>
                    <a:pt x="346336" y="291366"/>
                  </a:cubicBezTo>
                  <a:cubicBezTo>
                    <a:pt x="344504" y="290144"/>
                    <a:pt x="342631" y="288981"/>
                    <a:pt x="340839" y="287701"/>
                  </a:cubicBezTo>
                  <a:cubicBezTo>
                    <a:pt x="338354" y="285926"/>
                    <a:pt x="336161" y="283718"/>
                    <a:pt x="333509" y="282203"/>
                  </a:cubicBezTo>
                  <a:cubicBezTo>
                    <a:pt x="330477" y="280470"/>
                    <a:pt x="321166" y="279002"/>
                    <a:pt x="318849" y="278539"/>
                  </a:cubicBezTo>
                  <a:cubicBezTo>
                    <a:pt x="310921" y="266646"/>
                    <a:pt x="320598" y="278492"/>
                    <a:pt x="307854" y="271209"/>
                  </a:cubicBezTo>
                  <a:cubicBezTo>
                    <a:pt x="297243" y="265145"/>
                    <a:pt x="307394" y="265905"/>
                    <a:pt x="296859" y="258381"/>
                  </a:cubicBezTo>
                  <a:cubicBezTo>
                    <a:pt x="294810" y="256917"/>
                    <a:pt x="291972" y="257160"/>
                    <a:pt x="289529" y="256549"/>
                  </a:cubicBezTo>
                  <a:cubicBezTo>
                    <a:pt x="287697" y="254717"/>
                    <a:pt x="286282" y="252338"/>
                    <a:pt x="284032" y="251052"/>
                  </a:cubicBezTo>
                  <a:cubicBezTo>
                    <a:pt x="281845" y="249802"/>
                    <a:pt x="279017" y="250211"/>
                    <a:pt x="276702" y="249219"/>
                  </a:cubicBezTo>
                  <a:cubicBezTo>
                    <a:pt x="274678" y="248351"/>
                    <a:pt x="273037" y="246776"/>
                    <a:pt x="271205" y="245554"/>
                  </a:cubicBezTo>
                  <a:cubicBezTo>
                    <a:pt x="265097" y="246165"/>
                    <a:pt x="258947" y="246454"/>
                    <a:pt x="252880" y="247387"/>
                  </a:cubicBezTo>
                  <a:cubicBezTo>
                    <a:pt x="250971" y="247681"/>
                    <a:pt x="249277" y="248840"/>
                    <a:pt x="247383" y="249219"/>
                  </a:cubicBezTo>
                  <a:cubicBezTo>
                    <a:pt x="214537" y="255789"/>
                    <a:pt x="248966" y="247451"/>
                    <a:pt x="227226" y="252884"/>
                  </a:cubicBezTo>
                  <a:cubicBezTo>
                    <a:pt x="217658" y="259262"/>
                    <a:pt x="225979" y="254723"/>
                    <a:pt x="212566" y="258381"/>
                  </a:cubicBezTo>
                  <a:cubicBezTo>
                    <a:pt x="208839" y="259397"/>
                    <a:pt x="205236" y="260824"/>
                    <a:pt x="201571" y="262046"/>
                  </a:cubicBezTo>
                  <a:lnTo>
                    <a:pt x="196074" y="263879"/>
                  </a:lnTo>
                  <a:cubicBezTo>
                    <a:pt x="189355" y="263268"/>
                    <a:pt x="182612" y="262883"/>
                    <a:pt x="175917" y="262046"/>
                  </a:cubicBezTo>
                  <a:cubicBezTo>
                    <a:pt x="172826" y="261660"/>
                    <a:pt x="169540" y="261607"/>
                    <a:pt x="166754" y="260214"/>
                  </a:cubicBezTo>
                  <a:cubicBezTo>
                    <a:pt x="140322" y="246998"/>
                    <a:pt x="179880" y="261388"/>
                    <a:pt x="155760" y="251052"/>
                  </a:cubicBezTo>
                  <a:cubicBezTo>
                    <a:pt x="153445" y="250060"/>
                    <a:pt x="150852" y="249911"/>
                    <a:pt x="148430" y="249219"/>
                  </a:cubicBezTo>
                  <a:cubicBezTo>
                    <a:pt x="146573" y="248688"/>
                    <a:pt x="144789" y="247918"/>
                    <a:pt x="142932" y="247387"/>
                  </a:cubicBezTo>
                  <a:cubicBezTo>
                    <a:pt x="140510" y="246695"/>
                    <a:pt x="138024" y="246246"/>
                    <a:pt x="135602" y="245554"/>
                  </a:cubicBezTo>
                  <a:cubicBezTo>
                    <a:pt x="133745" y="245023"/>
                    <a:pt x="132028" y="243905"/>
                    <a:pt x="130105" y="243722"/>
                  </a:cubicBezTo>
                  <a:cubicBezTo>
                    <a:pt x="119143" y="242678"/>
                    <a:pt x="108116" y="242500"/>
                    <a:pt x="97121" y="241889"/>
                  </a:cubicBezTo>
                  <a:cubicBezTo>
                    <a:pt x="89791" y="240667"/>
                    <a:pt x="82487" y="239275"/>
                    <a:pt x="75131" y="238224"/>
                  </a:cubicBezTo>
                  <a:cubicBezTo>
                    <a:pt x="65381" y="236831"/>
                    <a:pt x="45812" y="234559"/>
                    <a:pt x="45812" y="234559"/>
                  </a:cubicBezTo>
                  <a:cubicBezTo>
                    <a:pt x="43979" y="233948"/>
                    <a:pt x="42171" y="233258"/>
                    <a:pt x="40314" y="232727"/>
                  </a:cubicBezTo>
                  <a:cubicBezTo>
                    <a:pt x="37892" y="232035"/>
                    <a:pt x="35299" y="231886"/>
                    <a:pt x="32984" y="230894"/>
                  </a:cubicBezTo>
                  <a:cubicBezTo>
                    <a:pt x="30960" y="230027"/>
                    <a:pt x="29532" y="228048"/>
                    <a:pt x="27487" y="227230"/>
                  </a:cubicBezTo>
                  <a:cubicBezTo>
                    <a:pt x="23358" y="225579"/>
                    <a:pt x="18839" y="225085"/>
                    <a:pt x="14660" y="223565"/>
                  </a:cubicBezTo>
                  <a:cubicBezTo>
                    <a:pt x="12093" y="222631"/>
                    <a:pt x="9841" y="220976"/>
                    <a:pt x="7330" y="219900"/>
                  </a:cubicBezTo>
                  <a:cubicBezTo>
                    <a:pt x="5554" y="219139"/>
                    <a:pt x="3665" y="218678"/>
                    <a:pt x="1832" y="218067"/>
                  </a:cubicBezTo>
                  <a:cubicBezTo>
                    <a:pt x="1221" y="216235"/>
                    <a:pt x="0" y="214501"/>
                    <a:pt x="0" y="212570"/>
                  </a:cubicBezTo>
                  <a:cubicBezTo>
                    <a:pt x="0" y="208774"/>
                    <a:pt x="1087" y="197569"/>
                    <a:pt x="3665" y="192413"/>
                  </a:cubicBezTo>
                  <a:cubicBezTo>
                    <a:pt x="4650" y="190443"/>
                    <a:pt x="6108" y="188748"/>
                    <a:pt x="7330" y="186915"/>
                  </a:cubicBezTo>
                  <a:cubicBezTo>
                    <a:pt x="8514" y="183363"/>
                    <a:pt x="10577" y="177640"/>
                    <a:pt x="10995" y="174088"/>
                  </a:cubicBezTo>
                  <a:cubicBezTo>
                    <a:pt x="11926" y="166178"/>
                    <a:pt x="11839" y="158169"/>
                    <a:pt x="12827" y="150266"/>
                  </a:cubicBezTo>
                  <a:cubicBezTo>
                    <a:pt x="13067" y="148349"/>
                    <a:pt x="13474" y="146294"/>
                    <a:pt x="14660" y="144769"/>
                  </a:cubicBezTo>
                  <a:cubicBezTo>
                    <a:pt x="17842" y="140678"/>
                    <a:pt x="21990" y="137439"/>
                    <a:pt x="25655" y="133774"/>
                  </a:cubicBezTo>
                  <a:cubicBezTo>
                    <a:pt x="27487" y="131941"/>
                    <a:pt x="29714" y="130432"/>
                    <a:pt x="31152" y="128276"/>
                  </a:cubicBezTo>
                  <a:lnTo>
                    <a:pt x="34817" y="122779"/>
                  </a:lnTo>
                  <a:cubicBezTo>
                    <a:pt x="35428" y="120947"/>
                    <a:pt x="36118" y="119139"/>
                    <a:pt x="36649" y="117282"/>
                  </a:cubicBezTo>
                  <a:cubicBezTo>
                    <a:pt x="37341" y="114860"/>
                    <a:pt x="37232" y="112139"/>
                    <a:pt x="38482" y="109952"/>
                  </a:cubicBezTo>
                  <a:cubicBezTo>
                    <a:pt x="39768" y="107702"/>
                    <a:pt x="42320" y="106445"/>
                    <a:pt x="43979" y="104454"/>
                  </a:cubicBezTo>
                  <a:cubicBezTo>
                    <a:pt x="45389" y="102762"/>
                    <a:pt x="45987" y="100407"/>
                    <a:pt x="47644" y="98957"/>
                  </a:cubicBezTo>
                  <a:cubicBezTo>
                    <a:pt x="50959" y="96056"/>
                    <a:pt x="55524" y="94742"/>
                    <a:pt x="58639" y="91627"/>
                  </a:cubicBezTo>
                  <a:cubicBezTo>
                    <a:pt x="66068" y="84198"/>
                    <a:pt x="61818" y="87289"/>
                    <a:pt x="71466" y="82465"/>
                  </a:cubicBezTo>
                  <a:cubicBezTo>
                    <a:pt x="86737" y="83076"/>
                    <a:pt x="102025" y="83344"/>
                    <a:pt x="117278" y="84297"/>
                  </a:cubicBezTo>
                  <a:cubicBezTo>
                    <a:pt x="123882" y="84710"/>
                    <a:pt x="132580" y="86625"/>
                    <a:pt x="139267" y="87962"/>
                  </a:cubicBezTo>
                  <a:cubicBezTo>
                    <a:pt x="140489" y="89795"/>
                    <a:pt x="141522" y="91768"/>
                    <a:pt x="142932" y="93460"/>
                  </a:cubicBezTo>
                  <a:cubicBezTo>
                    <a:pt x="144591" y="95451"/>
                    <a:pt x="146992" y="96801"/>
                    <a:pt x="148430" y="98957"/>
                  </a:cubicBezTo>
                  <a:cubicBezTo>
                    <a:pt x="151349" y="103335"/>
                    <a:pt x="148911" y="109261"/>
                    <a:pt x="155760" y="111784"/>
                  </a:cubicBezTo>
                  <a:cubicBezTo>
                    <a:pt x="165090" y="115222"/>
                    <a:pt x="185079" y="117282"/>
                    <a:pt x="185079" y="117282"/>
                  </a:cubicBezTo>
                  <a:cubicBezTo>
                    <a:pt x="193630" y="116671"/>
                    <a:pt x="202265" y="116786"/>
                    <a:pt x="210733" y="115449"/>
                  </a:cubicBezTo>
                  <a:cubicBezTo>
                    <a:pt x="213982" y="114936"/>
                    <a:pt x="216816" y="112939"/>
                    <a:pt x="219896" y="111784"/>
                  </a:cubicBezTo>
                  <a:cubicBezTo>
                    <a:pt x="221704" y="111106"/>
                    <a:pt x="223561" y="110563"/>
                    <a:pt x="225393" y="109952"/>
                  </a:cubicBezTo>
                  <a:cubicBezTo>
                    <a:pt x="229445" y="105900"/>
                    <a:pt x="231287" y="103340"/>
                    <a:pt x="236388" y="100789"/>
                  </a:cubicBezTo>
                  <a:cubicBezTo>
                    <a:pt x="239013" y="99476"/>
                    <a:pt x="246872" y="97710"/>
                    <a:pt x="249215" y="97124"/>
                  </a:cubicBezTo>
                  <a:cubicBezTo>
                    <a:pt x="252880" y="94681"/>
                    <a:pt x="255839" y="90341"/>
                    <a:pt x="260210" y="89795"/>
                  </a:cubicBezTo>
                  <a:cubicBezTo>
                    <a:pt x="269200" y="88671"/>
                    <a:pt x="277072" y="87889"/>
                    <a:pt x="285865" y="86130"/>
                  </a:cubicBezTo>
                  <a:cubicBezTo>
                    <a:pt x="288334" y="85636"/>
                    <a:pt x="290751" y="84908"/>
                    <a:pt x="293194" y="84297"/>
                  </a:cubicBezTo>
                  <a:cubicBezTo>
                    <a:pt x="294416" y="82465"/>
                    <a:pt x="294889" y="79785"/>
                    <a:pt x="296859" y="78800"/>
                  </a:cubicBezTo>
                  <a:cubicBezTo>
                    <a:pt x="300182" y="77138"/>
                    <a:pt x="304227" y="77773"/>
                    <a:pt x="307854" y="76967"/>
                  </a:cubicBezTo>
                  <a:cubicBezTo>
                    <a:pt x="309740" y="76548"/>
                    <a:pt x="311519" y="75746"/>
                    <a:pt x="313352" y="75135"/>
                  </a:cubicBezTo>
                  <a:cubicBezTo>
                    <a:pt x="317628" y="70859"/>
                    <a:pt x="323475" y="67716"/>
                    <a:pt x="326179" y="62308"/>
                  </a:cubicBezTo>
                  <a:cubicBezTo>
                    <a:pt x="327081" y="60505"/>
                    <a:pt x="331351" y="51206"/>
                    <a:pt x="333509" y="49480"/>
                  </a:cubicBezTo>
                  <a:cubicBezTo>
                    <a:pt x="335017" y="48273"/>
                    <a:pt x="337174" y="48259"/>
                    <a:pt x="339006" y="47648"/>
                  </a:cubicBezTo>
                  <a:cubicBezTo>
                    <a:pt x="354760" y="37145"/>
                    <a:pt x="336220" y="51130"/>
                    <a:pt x="346336" y="38486"/>
                  </a:cubicBezTo>
                  <a:cubicBezTo>
                    <a:pt x="347712" y="36766"/>
                    <a:pt x="350001" y="36043"/>
                    <a:pt x="351833" y="34821"/>
                  </a:cubicBezTo>
                  <a:cubicBezTo>
                    <a:pt x="352917" y="31569"/>
                    <a:pt x="354242" y="25988"/>
                    <a:pt x="357331" y="23826"/>
                  </a:cubicBezTo>
                  <a:cubicBezTo>
                    <a:pt x="363624" y="19421"/>
                    <a:pt x="371585" y="15953"/>
                    <a:pt x="379320" y="14664"/>
                  </a:cubicBezTo>
                  <a:cubicBezTo>
                    <a:pt x="384178" y="13854"/>
                    <a:pt x="389093" y="13442"/>
                    <a:pt x="393980" y="12831"/>
                  </a:cubicBezTo>
                  <a:lnTo>
                    <a:pt x="415970" y="5501"/>
                  </a:lnTo>
                  <a:cubicBezTo>
                    <a:pt x="417802" y="4890"/>
                    <a:pt x="419593" y="4138"/>
                    <a:pt x="421467" y="3669"/>
                  </a:cubicBezTo>
                  <a:cubicBezTo>
                    <a:pt x="423910" y="3058"/>
                    <a:pt x="426375" y="2528"/>
                    <a:pt x="428797" y="1836"/>
                  </a:cubicBezTo>
                  <a:cubicBezTo>
                    <a:pt x="435885" y="-189"/>
                    <a:pt x="432043" y="4"/>
                    <a:pt x="436127" y="4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フリーフォーム: 図形 22">
              <a:extLst>
                <a:ext uri="{FF2B5EF4-FFF2-40B4-BE49-F238E27FC236}">
                  <a16:creationId xmlns:a16="http://schemas.microsoft.com/office/drawing/2014/main" id="{9AD0BD2A-F4B4-47E0-90B5-BB4A6460240C}"/>
                </a:ext>
              </a:extLst>
            </p:cNvPr>
            <p:cNvSpPr/>
            <p:nvPr/>
          </p:nvSpPr>
          <p:spPr>
            <a:xfrm>
              <a:off x="2235607" y="4156027"/>
              <a:ext cx="1578397" cy="212566"/>
            </a:xfrm>
            <a:custGeom>
              <a:avLst/>
              <a:gdLst>
                <a:gd name="connsiteX0" fmla="*/ 0 w 1578397"/>
                <a:gd name="connsiteY0" fmla="*/ 212566 h 212566"/>
                <a:gd name="connsiteX1" fmla="*/ 64136 w 1578397"/>
                <a:gd name="connsiteY1" fmla="*/ 210734 h 212566"/>
                <a:gd name="connsiteX2" fmla="*/ 69633 w 1578397"/>
                <a:gd name="connsiteY2" fmla="*/ 205236 h 212566"/>
                <a:gd name="connsiteX3" fmla="*/ 76963 w 1578397"/>
                <a:gd name="connsiteY3" fmla="*/ 201572 h 212566"/>
                <a:gd name="connsiteX4" fmla="*/ 80628 w 1578397"/>
                <a:gd name="connsiteY4" fmla="*/ 196074 h 212566"/>
                <a:gd name="connsiteX5" fmla="*/ 86126 w 1578397"/>
                <a:gd name="connsiteY5" fmla="*/ 194242 h 212566"/>
                <a:gd name="connsiteX6" fmla="*/ 93455 w 1578397"/>
                <a:gd name="connsiteY6" fmla="*/ 190577 h 212566"/>
                <a:gd name="connsiteX7" fmla="*/ 98953 w 1578397"/>
                <a:gd name="connsiteY7" fmla="*/ 185079 h 212566"/>
                <a:gd name="connsiteX8" fmla="*/ 106283 w 1578397"/>
                <a:gd name="connsiteY8" fmla="*/ 183247 h 212566"/>
                <a:gd name="connsiteX9" fmla="*/ 117278 w 1578397"/>
                <a:gd name="connsiteY9" fmla="*/ 179582 h 212566"/>
                <a:gd name="connsiteX10" fmla="*/ 139267 w 1578397"/>
                <a:gd name="connsiteY10" fmla="*/ 168587 h 212566"/>
                <a:gd name="connsiteX11" fmla="*/ 152094 w 1578397"/>
                <a:gd name="connsiteY11" fmla="*/ 161257 h 212566"/>
                <a:gd name="connsiteX12" fmla="*/ 166754 w 1578397"/>
                <a:gd name="connsiteY12" fmla="*/ 159425 h 212566"/>
                <a:gd name="connsiteX13" fmla="*/ 177749 w 1578397"/>
                <a:gd name="connsiteY13" fmla="*/ 157592 h 212566"/>
                <a:gd name="connsiteX14" fmla="*/ 186911 w 1578397"/>
                <a:gd name="connsiteY14" fmla="*/ 155760 h 212566"/>
                <a:gd name="connsiteX15" fmla="*/ 192409 w 1578397"/>
                <a:gd name="connsiteY15" fmla="*/ 153927 h 212566"/>
                <a:gd name="connsiteX16" fmla="*/ 199738 w 1578397"/>
                <a:gd name="connsiteY16" fmla="*/ 152095 h 212566"/>
                <a:gd name="connsiteX17" fmla="*/ 214398 w 1578397"/>
                <a:gd name="connsiteY17" fmla="*/ 146598 h 212566"/>
                <a:gd name="connsiteX18" fmla="*/ 219896 w 1578397"/>
                <a:gd name="connsiteY18" fmla="*/ 142933 h 212566"/>
                <a:gd name="connsiteX19" fmla="*/ 227225 w 1578397"/>
                <a:gd name="connsiteY19" fmla="*/ 141100 h 212566"/>
                <a:gd name="connsiteX20" fmla="*/ 232723 w 1578397"/>
                <a:gd name="connsiteY20" fmla="*/ 137435 h 212566"/>
                <a:gd name="connsiteX21" fmla="*/ 238220 w 1578397"/>
                <a:gd name="connsiteY21" fmla="*/ 135603 h 212566"/>
                <a:gd name="connsiteX22" fmla="*/ 256545 w 1578397"/>
                <a:gd name="connsiteY22" fmla="*/ 126440 h 212566"/>
                <a:gd name="connsiteX23" fmla="*/ 260210 w 1578397"/>
                <a:gd name="connsiteY23" fmla="*/ 120943 h 212566"/>
                <a:gd name="connsiteX24" fmla="*/ 278534 w 1578397"/>
                <a:gd name="connsiteY24" fmla="*/ 115446 h 212566"/>
                <a:gd name="connsiteX25" fmla="*/ 282199 w 1578397"/>
                <a:gd name="connsiteY25" fmla="*/ 109948 h 212566"/>
                <a:gd name="connsiteX26" fmla="*/ 296859 w 1578397"/>
                <a:gd name="connsiteY26" fmla="*/ 106283 h 212566"/>
                <a:gd name="connsiteX27" fmla="*/ 309686 w 1578397"/>
                <a:gd name="connsiteY27" fmla="*/ 97121 h 212566"/>
                <a:gd name="connsiteX28" fmla="*/ 320681 w 1578397"/>
                <a:gd name="connsiteY28" fmla="*/ 89791 h 212566"/>
                <a:gd name="connsiteX29" fmla="*/ 326179 w 1578397"/>
                <a:gd name="connsiteY29" fmla="*/ 87959 h 212566"/>
                <a:gd name="connsiteX30" fmla="*/ 364660 w 1578397"/>
                <a:gd name="connsiteY30" fmla="*/ 82461 h 212566"/>
                <a:gd name="connsiteX31" fmla="*/ 370158 w 1578397"/>
                <a:gd name="connsiteY31" fmla="*/ 80629 h 212566"/>
                <a:gd name="connsiteX32" fmla="*/ 377488 w 1578397"/>
                <a:gd name="connsiteY32" fmla="*/ 78796 h 212566"/>
                <a:gd name="connsiteX33" fmla="*/ 390315 w 1578397"/>
                <a:gd name="connsiteY33" fmla="*/ 76964 h 212566"/>
                <a:gd name="connsiteX34" fmla="*/ 397645 w 1578397"/>
                <a:gd name="connsiteY34" fmla="*/ 75131 h 212566"/>
                <a:gd name="connsiteX35" fmla="*/ 417802 w 1578397"/>
                <a:gd name="connsiteY35" fmla="*/ 71467 h 212566"/>
                <a:gd name="connsiteX36" fmla="*/ 428797 w 1578397"/>
                <a:gd name="connsiteY36" fmla="*/ 60472 h 212566"/>
                <a:gd name="connsiteX37" fmla="*/ 430629 w 1578397"/>
                <a:gd name="connsiteY37" fmla="*/ 54974 h 212566"/>
                <a:gd name="connsiteX38" fmla="*/ 445289 w 1578397"/>
                <a:gd name="connsiteY38" fmla="*/ 42147 h 212566"/>
                <a:gd name="connsiteX39" fmla="*/ 450786 w 1578397"/>
                <a:gd name="connsiteY39" fmla="*/ 40315 h 212566"/>
                <a:gd name="connsiteX40" fmla="*/ 452619 w 1578397"/>
                <a:gd name="connsiteY40" fmla="*/ 34817 h 212566"/>
                <a:gd name="connsiteX41" fmla="*/ 461781 w 1578397"/>
                <a:gd name="connsiteY41" fmla="*/ 21990 h 212566"/>
                <a:gd name="connsiteX42" fmla="*/ 472776 w 1578397"/>
                <a:gd name="connsiteY42" fmla="*/ 9163 h 212566"/>
                <a:gd name="connsiteX43" fmla="*/ 476441 w 1578397"/>
                <a:gd name="connsiteY43" fmla="*/ 3665 h 212566"/>
                <a:gd name="connsiteX44" fmla="*/ 483770 w 1578397"/>
                <a:gd name="connsiteY44" fmla="*/ 0 h 212566"/>
                <a:gd name="connsiteX45" fmla="*/ 538744 w 1578397"/>
                <a:gd name="connsiteY45" fmla="*/ 3665 h 212566"/>
                <a:gd name="connsiteX46" fmla="*/ 553404 w 1578397"/>
                <a:gd name="connsiteY46" fmla="*/ 5498 h 212566"/>
                <a:gd name="connsiteX47" fmla="*/ 707331 w 1578397"/>
                <a:gd name="connsiteY47" fmla="*/ 7330 h 212566"/>
                <a:gd name="connsiteX48" fmla="*/ 709164 w 1578397"/>
                <a:gd name="connsiteY48" fmla="*/ 12828 h 212566"/>
                <a:gd name="connsiteX49" fmla="*/ 712829 w 1578397"/>
                <a:gd name="connsiteY49" fmla="*/ 20158 h 212566"/>
                <a:gd name="connsiteX50" fmla="*/ 707331 w 1578397"/>
                <a:gd name="connsiteY50" fmla="*/ 21990 h 212566"/>
                <a:gd name="connsiteX51" fmla="*/ 698169 w 1578397"/>
                <a:gd name="connsiteY51" fmla="*/ 23822 h 212566"/>
                <a:gd name="connsiteX52" fmla="*/ 668849 w 1578397"/>
                <a:gd name="connsiteY52" fmla="*/ 27487 h 212566"/>
                <a:gd name="connsiteX53" fmla="*/ 656022 w 1578397"/>
                <a:gd name="connsiteY53" fmla="*/ 32985 h 212566"/>
                <a:gd name="connsiteX54" fmla="*/ 645027 w 1578397"/>
                <a:gd name="connsiteY54" fmla="*/ 40315 h 212566"/>
                <a:gd name="connsiteX55" fmla="*/ 637698 w 1578397"/>
                <a:gd name="connsiteY55" fmla="*/ 42147 h 212566"/>
                <a:gd name="connsiteX56" fmla="*/ 632200 w 1578397"/>
                <a:gd name="connsiteY56" fmla="*/ 45812 h 212566"/>
                <a:gd name="connsiteX57" fmla="*/ 536912 w 1578397"/>
                <a:gd name="connsiteY57" fmla="*/ 51309 h 212566"/>
                <a:gd name="connsiteX58" fmla="*/ 542409 w 1578397"/>
                <a:gd name="connsiteY58" fmla="*/ 53142 h 212566"/>
                <a:gd name="connsiteX59" fmla="*/ 544242 w 1578397"/>
                <a:gd name="connsiteY59" fmla="*/ 58639 h 212566"/>
                <a:gd name="connsiteX60" fmla="*/ 549739 w 1578397"/>
                <a:gd name="connsiteY60" fmla="*/ 60472 h 212566"/>
                <a:gd name="connsiteX61" fmla="*/ 566231 w 1578397"/>
                <a:gd name="connsiteY61" fmla="*/ 67802 h 212566"/>
                <a:gd name="connsiteX62" fmla="*/ 615708 w 1578397"/>
                <a:gd name="connsiteY62" fmla="*/ 65969 h 212566"/>
                <a:gd name="connsiteX63" fmla="*/ 630368 w 1578397"/>
                <a:gd name="connsiteY63" fmla="*/ 56807 h 212566"/>
                <a:gd name="connsiteX64" fmla="*/ 641362 w 1578397"/>
                <a:gd name="connsiteY64" fmla="*/ 51309 h 212566"/>
                <a:gd name="connsiteX65" fmla="*/ 646860 w 1578397"/>
                <a:gd name="connsiteY65" fmla="*/ 47644 h 212566"/>
                <a:gd name="connsiteX66" fmla="*/ 654190 w 1578397"/>
                <a:gd name="connsiteY66" fmla="*/ 43980 h 212566"/>
                <a:gd name="connsiteX67" fmla="*/ 687174 w 1578397"/>
                <a:gd name="connsiteY67" fmla="*/ 45812 h 212566"/>
                <a:gd name="connsiteX68" fmla="*/ 698169 w 1578397"/>
                <a:gd name="connsiteY68" fmla="*/ 53142 h 212566"/>
                <a:gd name="connsiteX69" fmla="*/ 712829 w 1578397"/>
                <a:gd name="connsiteY69" fmla="*/ 56807 h 212566"/>
                <a:gd name="connsiteX70" fmla="*/ 745813 w 1578397"/>
                <a:gd name="connsiteY70" fmla="*/ 54974 h 212566"/>
                <a:gd name="connsiteX71" fmla="*/ 754975 w 1578397"/>
                <a:gd name="connsiteY71" fmla="*/ 53142 h 212566"/>
                <a:gd name="connsiteX72" fmla="*/ 758640 w 1578397"/>
                <a:gd name="connsiteY72" fmla="*/ 47644 h 212566"/>
                <a:gd name="connsiteX73" fmla="*/ 775132 w 1578397"/>
                <a:gd name="connsiteY73" fmla="*/ 38482 h 212566"/>
                <a:gd name="connsiteX74" fmla="*/ 778797 w 1578397"/>
                <a:gd name="connsiteY74" fmla="*/ 32985 h 212566"/>
                <a:gd name="connsiteX75" fmla="*/ 786127 w 1578397"/>
                <a:gd name="connsiteY75" fmla="*/ 31152 h 212566"/>
                <a:gd name="connsiteX76" fmla="*/ 797122 w 1578397"/>
                <a:gd name="connsiteY76" fmla="*/ 27487 h 212566"/>
                <a:gd name="connsiteX77" fmla="*/ 802619 w 1578397"/>
                <a:gd name="connsiteY77" fmla="*/ 21990 h 212566"/>
                <a:gd name="connsiteX78" fmla="*/ 822777 w 1578397"/>
                <a:gd name="connsiteY78" fmla="*/ 16493 h 212566"/>
                <a:gd name="connsiteX79" fmla="*/ 828274 w 1578397"/>
                <a:gd name="connsiteY79" fmla="*/ 12828 h 212566"/>
                <a:gd name="connsiteX80" fmla="*/ 835604 w 1578397"/>
                <a:gd name="connsiteY80" fmla="*/ 10995 h 212566"/>
                <a:gd name="connsiteX81" fmla="*/ 883248 w 1578397"/>
                <a:gd name="connsiteY81" fmla="*/ 14660 h 212566"/>
                <a:gd name="connsiteX82" fmla="*/ 890578 w 1578397"/>
                <a:gd name="connsiteY82" fmla="*/ 23822 h 212566"/>
                <a:gd name="connsiteX83" fmla="*/ 894243 w 1578397"/>
                <a:gd name="connsiteY83" fmla="*/ 31152 h 212566"/>
                <a:gd name="connsiteX84" fmla="*/ 907070 w 1578397"/>
                <a:gd name="connsiteY84" fmla="*/ 43980 h 212566"/>
                <a:gd name="connsiteX85" fmla="*/ 951049 w 1578397"/>
                <a:gd name="connsiteY85" fmla="*/ 42147 h 212566"/>
                <a:gd name="connsiteX86" fmla="*/ 1015185 w 1578397"/>
                <a:gd name="connsiteY86" fmla="*/ 43980 h 212566"/>
                <a:gd name="connsiteX87" fmla="*/ 1117803 w 1578397"/>
                <a:gd name="connsiteY87" fmla="*/ 45812 h 212566"/>
                <a:gd name="connsiteX88" fmla="*/ 1125133 w 1578397"/>
                <a:gd name="connsiteY88" fmla="*/ 47644 h 212566"/>
                <a:gd name="connsiteX89" fmla="*/ 1130631 w 1578397"/>
                <a:gd name="connsiteY89" fmla="*/ 49477 h 212566"/>
                <a:gd name="connsiteX90" fmla="*/ 1143458 w 1578397"/>
                <a:gd name="connsiteY90" fmla="*/ 51309 h 212566"/>
                <a:gd name="connsiteX91" fmla="*/ 1154453 w 1578397"/>
                <a:gd name="connsiteY91" fmla="*/ 54974 h 212566"/>
                <a:gd name="connsiteX92" fmla="*/ 1161783 w 1578397"/>
                <a:gd name="connsiteY92" fmla="*/ 58639 h 212566"/>
                <a:gd name="connsiteX93" fmla="*/ 1183772 w 1578397"/>
                <a:gd name="connsiteY93" fmla="*/ 60472 h 212566"/>
                <a:gd name="connsiteX94" fmla="*/ 1205762 w 1578397"/>
                <a:gd name="connsiteY94" fmla="*/ 56807 h 212566"/>
                <a:gd name="connsiteX95" fmla="*/ 1207594 w 1578397"/>
                <a:gd name="connsiteY95" fmla="*/ 42147 h 212566"/>
                <a:gd name="connsiteX96" fmla="*/ 1214924 w 1578397"/>
                <a:gd name="connsiteY96" fmla="*/ 31152 h 212566"/>
                <a:gd name="connsiteX97" fmla="*/ 1225919 w 1578397"/>
                <a:gd name="connsiteY97" fmla="*/ 21990 h 212566"/>
                <a:gd name="connsiteX98" fmla="*/ 1258903 w 1578397"/>
                <a:gd name="connsiteY98" fmla="*/ 23822 h 212566"/>
                <a:gd name="connsiteX99" fmla="*/ 1266233 w 1578397"/>
                <a:gd name="connsiteY99" fmla="*/ 25655 h 212566"/>
                <a:gd name="connsiteX100" fmla="*/ 1271730 w 1578397"/>
                <a:gd name="connsiteY100" fmla="*/ 29320 h 212566"/>
                <a:gd name="connsiteX101" fmla="*/ 1273563 w 1578397"/>
                <a:gd name="connsiteY101" fmla="*/ 34817 h 212566"/>
                <a:gd name="connsiteX102" fmla="*/ 1280893 w 1578397"/>
                <a:gd name="connsiteY102" fmla="*/ 38482 h 212566"/>
                <a:gd name="connsiteX103" fmla="*/ 1286390 w 1578397"/>
                <a:gd name="connsiteY103" fmla="*/ 42147 h 212566"/>
                <a:gd name="connsiteX104" fmla="*/ 1293720 w 1578397"/>
                <a:gd name="connsiteY104" fmla="*/ 43980 h 212566"/>
                <a:gd name="connsiteX105" fmla="*/ 1312045 w 1578397"/>
                <a:gd name="connsiteY105" fmla="*/ 49477 h 212566"/>
                <a:gd name="connsiteX106" fmla="*/ 1473302 w 1578397"/>
                <a:gd name="connsiteY106" fmla="*/ 45812 h 212566"/>
                <a:gd name="connsiteX107" fmla="*/ 1484296 w 1578397"/>
                <a:gd name="connsiteY107" fmla="*/ 42147 h 212566"/>
                <a:gd name="connsiteX108" fmla="*/ 1495291 w 1578397"/>
                <a:gd name="connsiteY108" fmla="*/ 40315 h 212566"/>
                <a:gd name="connsiteX109" fmla="*/ 1577752 w 1578397"/>
                <a:gd name="connsiteY109" fmla="*/ 43980 h 212566"/>
                <a:gd name="connsiteX110" fmla="*/ 1575920 w 1578397"/>
                <a:gd name="connsiteY110" fmla="*/ 49477 h 212566"/>
                <a:gd name="connsiteX111" fmla="*/ 1572255 w 1578397"/>
                <a:gd name="connsiteY111" fmla="*/ 54974 h 212566"/>
                <a:gd name="connsiteX112" fmla="*/ 1566757 w 1578397"/>
                <a:gd name="connsiteY112" fmla="*/ 56807 h 212566"/>
                <a:gd name="connsiteX113" fmla="*/ 1559427 w 1578397"/>
                <a:gd name="connsiteY113" fmla="*/ 58639 h 212566"/>
                <a:gd name="connsiteX114" fmla="*/ 1546600 w 1578397"/>
                <a:gd name="connsiteY114" fmla="*/ 62304 h 212566"/>
                <a:gd name="connsiteX115" fmla="*/ 1539270 w 1578397"/>
                <a:gd name="connsiteY115" fmla="*/ 76964 h 212566"/>
                <a:gd name="connsiteX116" fmla="*/ 1533773 w 1578397"/>
                <a:gd name="connsiteY116" fmla="*/ 84294 h 2125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</a:cxnLst>
              <a:rect l="l" t="t" r="r" b="b"/>
              <a:pathLst>
                <a:path w="1578397" h="212566">
                  <a:moveTo>
                    <a:pt x="0" y="212566"/>
                  </a:moveTo>
                  <a:cubicBezTo>
                    <a:pt x="21379" y="211955"/>
                    <a:pt x="42866" y="212973"/>
                    <a:pt x="64136" y="210734"/>
                  </a:cubicBezTo>
                  <a:cubicBezTo>
                    <a:pt x="66713" y="210463"/>
                    <a:pt x="67524" y="206742"/>
                    <a:pt x="69633" y="205236"/>
                  </a:cubicBezTo>
                  <a:cubicBezTo>
                    <a:pt x="71856" y="203648"/>
                    <a:pt x="74520" y="202793"/>
                    <a:pt x="76963" y="201572"/>
                  </a:cubicBezTo>
                  <a:cubicBezTo>
                    <a:pt x="78185" y="199739"/>
                    <a:pt x="78908" y="197450"/>
                    <a:pt x="80628" y="196074"/>
                  </a:cubicBezTo>
                  <a:cubicBezTo>
                    <a:pt x="82136" y="194867"/>
                    <a:pt x="84350" y="195003"/>
                    <a:pt x="86126" y="194242"/>
                  </a:cubicBezTo>
                  <a:cubicBezTo>
                    <a:pt x="88637" y="193166"/>
                    <a:pt x="91232" y="192165"/>
                    <a:pt x="93455" y="190577"/>
                  </a:cubicBezTo>
                  <a:cubicBezTo>
                    <a:pt x="95564" y="189070"/>
                    <a:pt x="96703" y="186365"/>
                    <a:pt x="98953" y="185079"/>
                  </a:cubicBezTo>
                  <a:cubicBezTo>
                    <a:pt x="101140" y="183830"/>
                    <a:pt x="103871" y="183971"/>
                    <a:pt x="106283" y="183247"/>
                  </a:cubicBezTo>
                  <a:cubicBezTo>
                    <a:pt x="109983" y="182137"/>
                    <a:pt x="117278" y="179582"/>
                    <a:pt x="117278" y="179582"/>
                  </a:cubicBezTo>
                  <a:cubicBezTo>
                    <a:pt x="131486" y="170109"/>
                    <a:pt x="124094" y="173645"/>
                    <a:pt x="139267" y="168587"/>
                  </a:cubicBezTo>
                  <a:cubicBezTo>
                    <a:pt x="142539" y="166405"/>
                    <a:pt x="148373" y="162187"/>
                    <a:pt x="152094" y="161257"/>
                  </a:cubicBezTo>
                  <a:cubicBezTo>
                    <a:pt x="156872" y="160063"/>
                    <a:pt x="161879" y="160121"/>
                    <a:pt x="166754" y="159425"/>
                  </a:cubicBezTo>
                  <a:cubicBezTo>
                    <a:pt x="170432" y="158900"/>
                    <a:pt x="174093" y="158257"/>
                    <a:pt x="177749" y="157592"/>
                  </a:cubicBezTo>
                  <a:cubicBezTo>
                    <a:pt x="180813" y="157035"/>
                    <a:pt x="183890" y="156515"/>
                    <a:pt x="186911" y="155760"/>
                  </a:cubicBezTo>
                  <a:cubicBezTo>
                    <a:pt x="188785" y="155291"/>
                    <a:pt x="190551" y="154458"/>
                    <a:pt x="192409" y="153927"/>
                  </a:cubicBezTo>
                  <a:cubicBezTo>
                    <a:pt x="194830" y="153235"/>
                    <a:pt x="197295" y="152706"/>
                    <a:pt x="199738" y="152095"/>
                  </a:cubicBezTo>
                  <a:cubicBezTo>
                    <a:pt x="212632" y="143500"/>
                    <a:pt x="196282" y="153391"/>
                    <a:pt x="214398" y="146598"/>
                  </a:cubicBezTo>
                  <a:cubicBezTo>
                    <a:pt x="216460" y="145825"/>
                    <a:pt x="217872" y="143801"/>
                    <a:pt x="219896" y="142933"/>
                  </a:cubicBezTo>
                  <a:cubicBezTo>
                    <a:pt x="222211" y="141941"/>
                    <a:pt x="224782" y="141711"/>
                    <a:pt x="227225" y="141100"/>
                  </a:cubicBezTo>
                  <a:cubicBezTo>
                    <a:pt x="229058" y="139878"/>
                    <a:pt x="230753" y="138420"/>
                    <a:pt x="232723" y="137435"/>
                  </a:cubicBezTo>
                  <a:cubicBezTo>
                    <a:pt x="234451" y="136571"/>
                    <a:pt x="236532" y="136541"/>
                    <a:pt x="238220" y="135603"/>
                  </a:cubicBezTo>
                  <a:cubicBezTo>
                    <a:pt x="256073" y="125685"/>
                    <a:pt x="242219" y="130022"/>
                    <a:pt x="256545" y="126440"/>
                  </a:cubicBezTo>
                  <a:cubicBezTo>
                    <a:pt x="257767" y="124608"/>
                    <a:pt x="258342" y="122110"/>
                    <a:pt x="260210" y="120943"/>
                  </a:cubicBezTo>
                  <a:cubicBezTo>
                    <a:pt x="263185" y="119083"/>
                    <a:pt x="274242" y="116519"/>
                    <a:pt x="278534" y="115446"/>
                  </a:cubicBezTo>
                  <a:cubicBezTo>
                    <a:pt x="279756" y="113613"/>
                    <a:pt x="280229" y="110933"/>
                    <a:pt x="282199" y="109948"/>
                  </a:cubicBezTo>
                  <a:cubicBezTo>
                    <a:pt x="286704" y="107695"/>
                    <a:pt x="296859" y="106283"/>
                    <a:pt x="296859" y="106283"/>
                  </a:cubicBezTo>
                  <a:cubicBezTo>
                    <a:pt x="314749" y="94355"/>
                    <a:pt x="286931" y="113049"/>
                    <a:pt x="309686" y="97121"/>
                  </a:cubicBezTo>
                  <a:cubicBezTo>
                    <a:pt x="313295" y="94595"/>
                    <a:pt x="316502" y="91183"/>
                    <a:pt x="320681" y="89791"/>
                  </a:cubicBezTo>
                  <a:lnTo>
                    <a:pt x="326179" y="87959"/>
                  </a:lnTo>
                  <a:cubicBezTo>
                    <a:pt x="341326" y="77860"/>
                    <a:pt x="327035" y="86044"/>
                    <a:pt x="364660" y="82461"/>
                  </a:cubicBezTo>
                  <a:cubicBezTo>
                    <a:pt x="366583" y="82278"/>
                    <a:pt x="368301" y="81160"/>
                    <a:pt x="370158" y="80629"/>
                  </a:cubicBezTo>
                  <a:cubicBezTo>
                    <a:pt x="372580" y="79937"/>
                    <a:pt x="375010" y="79247"/>
                    <a:pt x="377488" y="78796"/>
                  </a:cubicBezTo>
                  <a:cubicBezTo>
                    <a:pt x="381737" y="78023"/>
                    <a:pt x="386066" y="77737"/>
                    <a:pt x="390315" y="76964"/>
                  </a:cubicBezTo>
                  <a:cubicBezTo>
                    <a:pt x="392793" y="76513"/>
                    <a:pt x="395175" y="75625"/>
                    <a:pt x="397645" y="75131"/>
                  </a:cubicBezTo>
                  <a:cubicBezTo>
                    <a:pt x="404342" y="73792"/>
                    <a:pt x="411083" y="72688"/>
                    <a:pt x="417802" y="71467"/>
                  </a:cubicBezTo>
                  <a:cubicBezTo>
                    <a:pt x="423919" y="66879"/>
                    <a:pt x="425583" y="66901"/>
                    <a:pt x="428797" y="60472"/>
                  </a:cubicBezTo>
                  <a:cubicBezTo>
                    <a:pt x="429661" y="58744"/>
                    <a:pt x="429470" y="56519"/>
                    <a:pt x="430629" y="54974"/>
                  </a:cubicBezTo>
                  <a:cubicBezTo>
                    <a:pt x="433495" y="51152"/>
                    <a:pt x="440202" y="44690"/>
                    <a:pt x="445289" y="42147"/>
                  </a:cubicBezTo>
                  <a:cubicBezTo>
                    <a:pt x="447017" y="41283"/>
                    <a:pt x="448954" y="40926"/>
                    <a:pt x="450786" y="40315"/>
                  </a:cubicBezTo>
                  <a:cubicBezTo>
                    <a:pt x="451397" y="38482"/>
                    <a:pt x="451755" y="36545"/>
                    <a:pt x="452619" y="34817"/>
                  </a:cubicBezTo>
                  <a:cubicBezTo>
                    <a:pt x="454057" y="31942"/>
                    <a:pt x="460401" y="23922"/>
                    <a:pt x="461781" y="21990"/>
                  </a:cubicBezTo>
                  <a:cubicBezTo>
                    <a:pt x="473799" y="5165"/>
                    <a:pt x="453790" y="31314"/>
                    <a:pt x="472776" y="9163"/>
                  </a:cubicBezTo>
                  <a:cubicBezTo>
                    <a:pt x="474209" y="7491"/>
                    <a:pt x="474749" y="5075"/>
                    <a:pt x="476441" y="3665"/>
                  </a:cubicBezTo>
                  <a:cubicBezTo>
                    <a:pt x="478539" y="1916"/>
                    <a:pt x="481327" y="1222"/>
                    <a:pt x="483770" y="0"/>
                  </a:cubicBezTo>
                  <a:lnTo>
                    <a:pt x="538744" y="3665"/>
                  </a:lnTo>
                  <a:cubicBezTo>
                    <a:pt x="543648" y="4111"/>
                    <a:pt x="548480" y="5391"/>
                    <a:pt x="553404" y="5498"/>
                  </a:cubicBezTo>
                  <a:lnTo>
                    <a:pt x="707331" y="7330"/>
                  </a:lnTo>
                  <a:cubicBezTo>
                    <a:pt x="707942" y="9163"/>
                    <a:pt x="708403" y="11052"/>
                    <a:pt x="709164" y="12828"/>
                  </a:cubicBezTo>
                  <a:cubicBezTo>
                    <a:pt x="710240" y="15339"/>
                    <a:pt x="713365" y="17479"/>
                    <a:pt x="712829" y="20158"/>
                  </a:cubicBezTo>
                  <a:cubicBezTo>
                    <a:pt x="712450" y="22052"/>
                    <a:pt x="709205" y="21522"/>
                    <a:pt x="707331" y="21990"/>
                  </a:cubicBezTo>
                  <a:cubicBezTo>
                    <a:pt x="704309" y="22745"/>
                    <a:pt x="701252" y="23382"/>
                    <a:pt x="698169" y="23822"/>
                  </a:cubicBezTo>
                  <a:cubicBezTo>
                    <a:pt x="688419" y="25215"/>
                    <a:pt x="678622" y="26265"/>
                    <a:pt x="668849" y="27487"/>
                  </a:cubicBezTo>
                  <a:cubicBezTo>
                    <a:pt x="663163" y="29383"/>
                    <a:pt x="661681" y="29589"/>
                    <a:pt x="656022" y="32985"/>
                  </a:cubicBezTo>
                  <a:cubicBezTo>
                    <a:pt x="652245" y="35251"/>
                    <a:pt x="649300" y="39247"/>
                    <a:pt x="645027" y="40315"/>
                  </a:cubicBezTo>
                  <a:lnTo>
                    <a:pt x="637698" y="42147"/>
                  </a:lnTo>
                  <a:cubicBezTo>
                    <a:pt x="635865" y="43369"/>
                    <a:pt x="634400" y="45700"/>
                    <a:pt x="632200" y="45812"/>
                  </a:cubicBezTo>
                  <a:cubicBezTo>
                    <a:pt x="604810" y="47205"/>
                    <a:pt x="492757" y="32383"/>
                    <a:pt x="536912" y="51309"/>
                  </a:cubicBezTo>
                  <a:cubicBezTo>
                    <a:pt x="538687" y="52070"/>
                    <a:pt x="540577" y="52531"/>
                    <a:pt x="542409" y="53142"/>
                  </a:cubicBezTo>
                  <a:cubicBezTo>
                    <a:pt x="543020" y="54974"/>
                    <a:pt x="542876" y="57273"/>
                    <a:pt x="544242" y="58639"/>
                  </a:cubicBezTo>
                  <a:cubicBezTo>
                    <a:pt x="545608" y="60005"/>
                    <a:pt x="547930" y="59794"/>
                    <a:pt x="549739" y="60472"/>
                  </a:cubicBezTo>
                  <a:cubicBezTo>
                    <a:pt x="559104" y="63984"/>
                    <a:pt x="557898" y="63635"/>
                    <a:pt x="566231" y="67802"/>
                  </a:cubicBezTo>
                  <a:cubicBezTo>
                    <a:pt x="582723" y="67191"/>
                    <a:pt x="599241" y="67067"/>
                    <a:pt x="615708" y="65969"/>
                  </a:cubicBezTo>
                  <a:cubicBezTo>
                    <a:pt x="621709" y="65569"/>
                    <a:pt x="626192" y="59939"/>
                    <a:pt x="630368" y="56807"/>
                  </a:cubicBezTo>
                  <a:cubicBezTo>
                    <a:pt x="640870" y="48930"/>
                    <a:pt x="630796" y="56593"/>
                    <a:pt x="641362" y="51309"/>
                  </a:cubicBezTo>
                  <a:cubicBezTo>
                    <a:pt x="643332" y="50324"/>
                    <a:pt x="644948" y="48737"/>
                    <a:pt x="646860" y="47644"/>
                  </a:cubicBezTo>
                  <a:cubicBezTo>
                    <a:pt x="649232" y="46289"/>
                    <a:pt x="651747" y="45201"/>
                    <a:pt x="654190" y="43980"/>
                  </a:cubicBezTo>
                  <a:cubicBezTo>
                    <a:pt x="665185" y="44591"/>
                    <a:pt x="676394" y="43566"/>
                    <a:pt x="687174" y="45812"/>
                  </a:cubicBezTo>
                  <a:cubicBezTo>
                    <a:pt x="691486" y="46710"/>
                    <a:pt x="693850" y="52278"/>
                    <a:pt x="698169" y="53142"/>
                  </a:cubicBezTo>
                  <a:cubicBezTo>
                    <a:pt x="709225" y="55353"/>
                    <a:pt x="704376" y="53989"/>
                    <a:pt x="712829" y="56807"/>
                  </a:cubicBezTo>
                  <a:cubicBezTo>
                    <a:pt x="723824" y="56196"/>
                    <a:pt x="734843" y="55928"/>
                    <a:pt x="745813" y="54974"/>
                  </a:cubicBezTo>
                  <a:cubicBezTo>
                    <a:pt x="748916" y="54704"/>
                    <a:pt x="752271" y="54687"/>
                    <a:pt x="754975" y="53142"/>
                  </a:cubicBezTo>
                  <a:cubicBezTo>
                    <a:pt x="756887" y="52049"/>
                    <a:pt x="756982" y="49094"/>
                    <a:pt x="758640" y="47644"/>
                  </a:cubicBezTo>
                  <a:cubicBezTo>
                    <a:pt x="766392" y="40861"/>
                    <a:pt x="767583" y="40999"/>
                    <a:pt x="775132" y="38482"/>
                  </a:cubicBezTo>
                  <a:cubicBezTo>
                    <a:pt x="776354" y="36650"/>
                    <a:pt x="776965" y="34207"/>
                    <a:pt x="778797" y="32985"/>
                  </a:cubicBezTo>
                  <a:cubicBezTo>
                    <a:pt x="780893" y="31588"/>
                    <a:pt x="783715" y="31876"/>
                    <a:pt x="786127" y="31152"/>
                  </a:cubicBezTo>
                  <a:cubicBezTo>
                    <a:pt x="789827" y="30042"/>
                    <a:pt x="793457" y="28709"/>
                    <a:pt x="797122" y="27487"/>
                  </a:cubicBezTo>
                  <a:cubicBezTo>
                    <a:pt x="798954" y="25655"/>
                    <a:pt x="800354" y="23248"/>
                    <a:pt x="802619" y="21990"/>
                  </a:cubicBezTo>
                  <a:cubicBezTo>
                    <a:pt x="807852" y="19083"/>
                    <a:pt x="816854" y="17677"/>
                    <a:pt x="822777" y="16493"/>
                  </a:cubicBezTo>
                  <a:cubicBezTo>
                    <a:pt x="824609" y="15271"/>
                    <a:pt x="826250" y="13696"/>
                    <a:pt x="828274" y="12828"/>
                  </a:cubicBezTo>
                  <a:cubicBezTo>
                    <a:pt x="830589" y="11836"/>
                    <a:pt x="833087" y="10911"/>
                    <a:pt x="835604" y="10995"/>
                  </a:cubicBezTo>
                  <a:cubicBezTo>
                    <a:pt x="851523" y="11526"/>
                    <a:pt x="867367" y="13438"/>
                    <a:pt x="883248" y="14660"/>
                  </a:cubicBezTo>
                  <a:cubicBezTo>
                    <a:pt x="887622" y="27786"/>
                    <a:pt x="881368" y="12772"/>
                    <a:pt x="890578" y="23822"/>
                  </a:cubicBezTo>
                  <a:cubicBezTo>
                    <a:pt x="892327" y="25920"/>
                    <a:pt x="892444" y="29096"/>
                    <a:pt x="894243" y="31152"/>
                  </a:cubicBezTo>
                  <a:cubicBezTo>
                    <a:pt x="915569" y="55525"/>
                    <a:pt x="895354" y="26405"/>
                    <a:pt x="907070" y="43980"/>
                  </a:cubicBezTo>
                  <a:cubicBezTo>
                    <a:pt x="921730" y="43369"/>
                    <a:pt x="936377" y="42147"/>
                    <a:pt x="951049" y="42147"/>
                  </a:cubicBezTo>
                  <a:cubicBezTo>
                    <a:pt x="972436" y="42147"/>
                    <a:pt x="993803" y="43510"/>
                    <a:pt x="1015185" y="43980"/>
                  </a:cubicBezTo>
                  <a:lnTo>
                    <a:pt x="1117803" y="45812"/>
                  </a:lnTo>
                  <a:cubicBezTo>
                    <a:pt x="1120246" y="46423"/>
                    <a:pt x="1122711" y="46952"/>
                    <a:pt x="1125133" y="47644"/>
                  </a:cubicBezTo>
                  <a:cubicBezTo>
                    <a:pt x="1126991" y="48175"/>
                    <a:pt x="1128737" y="49098"/>
                    <a:pt x="1130631" y="49477"/>
                  </a:cubicBezTo>
                  <a:cubicBezTo>
                    <a:pt x="1134866" y="50324"/>
                    <a:pt x="1139182" y="50698"/>
                    <a:pt x="1143458" y="51309"/>
                  </a:cubicBezTo>
                  <a:cubicBezTo>
                    <a:pt x="1147123" y="52531"/>
                    <a:pt x="1150998" y="53246"/>
                    <a:pt x="1154453" y="54974"/>
                  </a:cubicBezTo>
                  <a:cubicBezTo>
                    <a:pt x="1156896" y="56196"/>
                    <a:pt x="1159098" y="58136"/>
                    <a:pt x="1161783" y="58639"/>
                  </a:cubicBezTo>
                  <a:cubicBezTo>
                    <a:pt x="1169012" y="59995"/>
                    <a:pt x="1176442" y="59861"/>
                    <a:pt x="1183772" y="60472"/>
                  </a:cubicBezTo>
                  <a:cubicBezTo>
                    <a:pt x="1191102" y="59250"/>
                    <a:pt x="1199872" y="61338"/>
                    <a:pt x="1205762" y="56807"/>
                  </a:cubicBezTo>
                  <a:cubicBezTo>
                    <a:pt x="1209665" y="53804"/>
                    <a:pt x="1206713" y="46992"/>
                    <a:pt x="1207594" y="42147"/>
                  </a:cubicBezTo>
                  <a:cubicBezTo>
                    <a:pt x="1208942" y="34735"/>
                    <a:pt x="1209813" y="37286"/>
                    <a:pt x="1214924" y="31152"/>
                  </a:cubicBezTo>
                  <a:cubicBezTo>
                    <a:pt x="1222323" y="22273"/>
                    <a:pt x="1213867" y="28016"/>
                    <a:pt x="1225919" y="21990"/>
                  </a:cubicBezTo>
                  <a:cubicBezTo>
                    <a:pt x="1236914" y="22601"/>
                    <a:pt x="1247937" y="22825"/>
                    <a:pt x="1258903" y="23822"/>
                  </a:cubicBezTo>
                  <a:cubicBezTo>
                    <a:pt x="1261411" y="24050"/>
                    <a:pt x="1263918" y="24663"/>
                    <a:pt x="1266233" y="25655"/>
                  </a:cubicBezTo>
                  <a:cubicBezTo>
                    <a:pt x="1268257" y="26523"/>
                    <a:pt x="1269898" y="28098"/>
                    <a:pt x="1271730" y="29320"/>
                  </a:cubicBezTo>
                  <a:cubicBezTo>
                    <a:pt x="1272341" y="31152"/>
                    <a:pt x="1272197" y="33451"/>
                    <a:pt x="1273563" y="34817"/>
                  </a:cubicBezTo>
                  <a:cubicBezTo>
                    <a:pt x="1275495" y="36749"/>
                    <a:pt x="1278521" y="37127"/>
                    <a:pt x="1280893" y="38482"/>
                  </a:cubicBezTo>
                  <a:cubicBezTo>
                    <a:pt x="1282805" y="39575"/>
                    <a:pt x="1284366" y="41279"/>
                    <a:pt x="1286390" y="42147"/>
                  </a:cubicBezTo>
                  <a:cubicBezTo>
                    <a:pt x="1288705" y="43139"/>
                    <a:pt x="1291362" y="43096"/>
                    <a:pt x="1293720" y="43980"/>
                  </a:cubicBezTo>
                  <a:cubicBezTo>
                    <a:pt x="1310763" y="50370"/>
                    <a:pt x="1289665" y="45746"/>
                    <a:pt x="1312045" y="49477"/>
                  </a:cubicBezTo>
                  <a:lnTo>
                    <a:pt x="1473302" y="45812"/>
                  </a:lnTo>
                  <a:cubicBezTo>
                    <a:pt x="1477161" y="45648"/>
                    <a:pt x="1480486" y="42782"/>
                    <a:pt x="1484296" y="42147"/>
                  </a:cubicBezTo>
                  <a:lnTo>
                    <a:pt x="1495291" y="40315"/>
                  </a:lnTo>
                  <a:cubicBezTo>
                    <a:pt x="1522778" y="41537"/>
                    <a:pt x="1550414" y="40874"/>
                    <a:pt x="1577752" y="43980"/>
                  </a:cubicBezTo>
                  <a:cubicBezTo>
                    <a:pt x="1579671" y="44198"/>
                    <a:pt x="1576784" y="47749"/>
                    <a:pt x="1575920" y="49477"/>
                  </a:cubicBezTo>
                  <a:cubicBezTo>
                    <a:pt x="1574935" y="51447"/>
                    <a:pt x="1573975" y="53598"/>
                    <a:pt x="1572255" y="54974"/>
                  </a:cubicBezTo>
                  <a:cubicBezTo>
                    <a:pt x="1570746" y="56181"/>
                    <a:pt x="1568615" y="56276"/>
                    <a:pt x="1566757" y="56807"/>
                  </a:cubicBezTo>
                  <a:cubicBezTo>
                    <a:pt x="1564335" y="57499"/>
                    <a:pt x="1561857" y="57976"/>
                    <a:pt x="1559427" y="58639"/>
                  </a:cubicBezTo>
                  <a:cubicBezTo>
                    <a:pt x="1555137" y="59809"/>
                    <a:pt x="1550876" y="61082"/>
                    <a:pt x="1546600" y="62304"/>
                  </a:cubicBezTo>
                  <a:cubicBezTo>
                    <a:pt x="1530460" y="78447"/>
                    <a:pt x="1551756" y="55114"/>
                    <a:pt x="1539270" y="76964"/>
                  </a:cubicBezTo>
                  <a:cubicBezTo>
                    <a:pt x="1532757" y="88362"/>
                    <a:pt x="1533773" y="74513"/>
                    <a:pt x="1533773" y="84294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フリーフォーム: 図形 23">
              <a:extLst>
                <a:ext uri="{FF2B5EF4-FFF2-40B4-BE49-F238E27FC236}">
                  <a16:creationId xmlns:a16="http://schemas.microsoft.com/office/drawing/2014/main" id="{2768825F-1146-4798-B192-87F6AEC842AA}"/>
                </a:ext>
              </a:extLst>
            </p:cNvPr>
            <p:cNvSpPr/>
            <p:nvPr/>
          </p:nvSpPr>
          <p:spPr>
            <a:xfrm>
              <a:off x="3762029" y="3635610"/>
              <a:ext cx="1004212" cy="687175"/>
            </a:xfrm>
            <a:custGeom>
              <a:avLst/>
              <a:gdLst>
                <a:gd name="connsiteX0" fmla="*/ 1854 w 1004212"/>
                <a:gd name="connsiteY0" fmla="*/ 602881 h 687175"/>
                <a:gd name="connsiteX1" fmla="*/ 1854 w 1004212"/>
                <a:gd name="connsiteY1" fmla="*/ 623038 h 687175"/>
                <a:gd name="connsiteX2" fmla="*/ 3686 w 1004212"/>
                <a:gd name="connsiteY2" fmla="*/ 630368 h 687175"/>
                <a:gd name="connsiteX3" fmla="*/ 14681 w 1004212"/>
                <a:gd name="connsiteY3" fmla="*/ 641363 h 687175"/>
                <a:gd name="connsiteX4" fmla="*/ 40336 w 1004212"/>
                <a:gd name="connsiteY4" fmla="*/ 637698 h 687175"/>
                <a:gd name="connsiteX5" fmla="*/ 54995 w 1004212"/>
                <a:gd name="connsiteY5" fmla="*/ 634033 h 687175"/>
                <a:gd name="connsiteX6" fmla="*/ 69655 w 1004212"/>
                <a:gd name="connsiteY6" fmla="*/ 635866 h 687175"/>
                <a:gd name="connsiteX7" fmla="*/ 76985 w 1004212"/>
                <a:gd name="connsiteY7" fmla="*/ 643196 h 687175"/>
                <a:gd name="connsiteX8" fmla="*/ 87980 w 1004212"/>
                <a:gd name="connsiteY8" fmla="*/ 648693 h 687175"/>
                <a:gd name="connsiteX9" fmla="*/ 97142 w 1004212"/>
                <a:gd name="connsiteY9" fmla="*/ 656023 h 687175"/>
                <a:gd name="connsiteX10" fmla="*/ 108137 w 1004212"/>
                <a:gd name="connsiteY10" fmla="*/ 663353 h 687175"/>
                <a:gd name="connsiteX11" fmla="*/ 135624 w 1004212"/>
                <a:gd name="connsiteY11" fmla="*/ 670683 h 687175"/>
                <a:gd name="connsiteX12" fmla="*/ 144786 w 1004212"/>
                <a:gd name="connsiteY12" fmla="*/ 672515 h 687175"/>
                <a:gd name="connsiteX13" fmla="*/ 157613 w 1004212"/>
                <a:gd name="connsiteY13" fmla="*/ 676180 h 687175"/>
                <a:gd name="connsiteX14" fmla="*/ 170441 w 1004212"/>
                <a:gd name="connsiteY14" fmla="*/ 678012 h 687175"/>
                <a:gd name="connsiteX15" fmla="*/ 181436 w 1004212"/>
                <a:gd name="connsiteY15" fmla="*/ 681677 h 687175"/>
                <a:gd name="connsiteX16" fmla="*/ 196095 w 1004212"/>
                <a:gd name="connsiteY16" fmla="*/ 687175 h 687175"/>
                <a:gd name="connsiteX17" fmla="*/ 219917 w 1004212"/>
                <a:gd name="connsiteY17" fmla="*/ 685342 h 687175"/>
                <a:gd name="connsiteX18" fmla="*/ 225415 w 1004212"/>
                <a:gd name="connsiteY18" fmla="*/ 681677 h 687175"/>
                <a:gd name="connsiteX19" fmla="*/ 230912 w 1004212"/>
                <a:gd name="connsiteY19" fmla="*/ 679845 h 687175"/>
                <a:gd name="connsiteX20" fmla="*/ 234577 w 1004212"/>
                <a:gd name="connsiteY20" fmla="*/ 674348 h 687175"/>
                <a:gd name="connsiteX21" fmla="*/ 241907 w 1004212"/>
                <a:gd name="connsiteY21" fmla="*/ 672515 h 687175"/>
                <a:gd name="connsiteX22" fmla="*/ 254734 w 1004212"/>
                <a:gd name="connsiteY22" fmla="*/ 668850 h 687175"/>
                <a:gd name="connsiteX23" fmla="*/ 263896 w 1004212"/>
                <a:gd name="connsiteY23" fmla="*/ 659688 h 687175"/>
                <a:gd name="connsiteX24" fmla="*/ 269394 w 1004212"/>
                <a:gd name="connsiteY24" fmla="*/ 656023 h 687175"/>
                <a:gd name="connsiteX25" fmla="*/ 274891 w 1004212"/>
                <a:gd name="connsiteY25" fmla="*/ 650525 h 687175"/>
                <a:gd name="connsiteX26" fmla="*/ 295048 w 1004212"/>
                <a:gd name="connsiteY26" fmla="*/ 646861 h 687175"/>
                <a:gd name="connsiteX27" fmla="*/ 300546 w 1004212"/>
                <a:gd name="connsiteY27" fmla="*/ 643196 h 687175"/>
                <a:gd name="connsiteX28" fmla="*/ 307876 w 1004212"/>
                <a:gd name="connsiteY28" fmla="*/ 639531 h 687175"/>
                <a:gd name="connsiteX29" fmla="*/ 309708 w 1004212"/>
                <a:gd name="connsiteY29" fmla="*/ 634033 h 687175"/>
                <a:gd name="connsiteX30" fmla="*/ 313373 w 1004212"/>
                <a:gd name="connsiteY30" fmla="*/ 628536 h 687175"/>
                <a:gd name="connsiteX31" fmla="*/ 315205 w 1004212"/>
                <a:gd name="connsiteY31" fmla="*/ 612044 h 687175"/>
                <a:gd name="connsiteX32" fmla="*/ 318870 w 1004212"/>
                <a:gd name="connsiteY32" fmla="*/ 595552 h 687175"/>
                <a:gd name="connsiteX33" fmla="*/ 320703 w 1004212"/>
                <a:gd name="connsiteY33" fmla="*/ 564400 h 687175"/>
                <a:gd name="connsiteX34" fmla="*/ 328033 w 1004212"/>
                <a:gd name="connsiteY34" fmla="*/ 560735 h 687175"/>
                <a:gd name="connsiteX35" fmla="*/ 333530 w 1004212"/>
                <a:gd name="connsiteY35" fmla="*/ 558902 h 687175"/>
                <a:gd name="connsiteX36" fmla="*/ 339028 w 1004212"/>
                <a:gd name="connsiteY36" fmla="*/ 555237 h 687175"/>
                <a:gd name="connsiteX37" fmla="*/ 346357 w 1004212"/>
                <a:gd name="connsiteY37" fmla="*/ 551572 h 687175"/>
                <a:gd name="connsiteX38" fmla="*/ 348190 w 1004212"/>
                <a:gd name="connsiteY38" fmla="*/ 546075 h 687175"/>
                <a:gd name="connsiteX39" fmla="*/ 353687 w 1004212"/>
                <a:gd name="connsiteY39" fmla="*/ 542410 h 687175"/>
                <a:gd name="connsiteX40" fmla="*/ 362850 w 1004212"/>
                <a:gd name="connsiteY40" fmla="*/ 531415 h 687175"/>
                <a:gd name="connsiteX41" fmla="*/ 368347 w 1004212"/>
                <a:gd name="connsiteY41" fmla="*/ 520420 h 687175"/>
                <a:gd name="connsiteX42" fmla="*/ 373844 w 1004212"/>
                <a:gd name="connsiteY42" fmla="*/ 516756 h 687175"/>
                <a:gd name="connsiteX43" fmla="*/ 381174 w 1004212"/>
                <a:gd name="connsiteY43" fmla="*/ 505761 h 687175"/>
                <a:gd name="connsiteX44" fmla="*/ 386672 w 1004212"/>
                <a:gd name="connsiteY44" fmla="*/ 498431 h 687175"/>
                <a:gd name="connsiteX45" fmla="*/ 394001 w 1004212"/>
                <a:gd name="connsiteY45" fmla="*/ 492933 h 687175"/>
                <a:gd name="connsiteX46" fmla="*/ 403164 w 1004212"/>
                <a:gd name="connsiteY46" fmla="*/ 481939 h 687175"/>
                <a:gd name="connsiteX47" fmla="*/ 408661 w 1004212"/>
                <a:gd name="connsiteY47" fmla="*/ 480106 h 687175"/>
                <a:gd name="connsiteX48" fmla="*/ 421488 w 1004212"/>
                <a:gd name="connsiteY48" fmla="*/ 469111 h 687175"/>
                <a:gd name="connsiteX49" fmla="*/ 426986 w 1004212"/>
                <a:gd name="connsiteY49" fmla="*/ 461782 h 687175"/>
                <a:gd name="connsiteX50" fmla="*/ 437981 w 1004212"/>
                <a:gd name="connsiteY50" fmla="*/ 454452 h 687175"/>
                <a:gd name="connsiteX51" fmla="*/ 443478 w 1004212"/>
                <a:gd name="connsiteY51" fmla="*/ 448954 h 687175"/>
                <a:gd name="connsiteX52" fmla="*/ 445310 w 1004212"/>
                <a:gd name="connsiteY52" fmla="*/ 441624 h 687175"/>
                <a:gd name="connsiteX53" fmla="*/ 458138 w 1004212"/>
                <a:gd name="connsiteY53" fmla="*/ 432462 h 687175"/>
                <a:gd name="connsiteX54" fmla="*/ 467300 w 1004212"/>
                <a:gd name="connsiteY54" fmla="*/ 425132 h 687175"/>
                <a:gd name="connsiteX55" fmla="*/ 476462 w 1004212"/>
                <a:gd name="connsiteY55" fmla="*/ 414137 h 687175"/>
                <a:gd name="connsiteX56" fmla="*/ 483792 w 1004212"/>
                <a:gd name="connsiteY56" fmla="*/ 412305 h 687175"/>
                <a:gd name="connsiteX57" fmla="*/ 496619 w 1004212"/>
                <a:gd name="connsiteY57" fmla="*/ 404975 h 687175"/>
                <a:gd name="connsiteX58" fmla="*/ 509447 w 1004212"/>
                <a:gd name="connsiteY58" fmla="*/ 399478 h 687175"/>
                <a:gd name="connsiteX59" fmla="*/ 516777 w 1004212"/>
                <a:gd name="connsiteY59" fmla="*/ 395813 h 687175"/>
                <a:gd name="connsiteX60" fmla="*/ 524106 w 1004212"/>
                <a:gd name="connsiteY60" fmla="*/ 393980 h 687175"/>
                <a:gd name="connsiteX61" fmla="*/ 529604 w 1004212"/>
                <a:gd name="connsiteY61" fmla="*/ 392148 h 687175"/>
                <a:gd name="connsiteX62" fmla="*/ 540599 w 1004212"/>
                <a:gd name="connsiteY62" fmla="*/ 384818 h 687175"/>
                <a:gd name="connsiteX63" fmla="*/ 551593 w 1004212"/>
                <a:gd name="connsiteY63" fmla="*/ 381153 h 687175"/>
                <a:gd name="connsiteX64" fmla="*/ 555258 w 1004212"/>
                <a:gd name="connsiteY64" fmla="*/ 375656 h 687175"/>
                <a:gd name="connsiteX65" fmla="*/ 560756 w 1004212"/>
                <a:gd name="connsiteY65" fmla="*/ 373823 h 687175"/>
                <a:gd name="connsiteX66" fmla="*/ 573583 w 1004212"/>
                <a:gd name="connsiteY66" fmla="*/ 368326 h 687175"/>
                <a:gd name="connsiteX67" fmla="*/ 584578 w 1004212"/>
                <a:gd name="connsiteY67" fmla="*/ 359164 h 687175"/>
                <a:gd name="connsiteX68" fmla="*/ 610232 w 1004212"/>
                <a:gd name="connsiteY68" fmla="*/ 344504 h 687175"/>
                <a:gd name="connsiteX69" fmla="*/ 626725 w 1004212"/>
                <a:gd name="connsiteY69" fmla="*/ 340839 h 687175"/>
                <a:gd name="connsiteX70" fmla="*/ 635887 w 1004212"/>
                <a:gd name="connsiteY70" fmla="*/ 337174 h 687175"/>
                <a:gd name="connsiteX71" fmla="*/ 641384 w 1004212"/>
                <a:gd name="connsiteY71" fmla="*/ 335342 h 687175"/>
                <a:gd name="connsiteX72" fmla="*/ 648714 w 1004212"/>
                <a:gd name="connsiteY72" fmla="*/ 331677 h 687175"/>
                <a:gd name="connsiteX73" fmla="*/ 670704 w 1004212"/>
                <a:gd name="connsiteY73" fmla="*/ 329844 h 687175"/>
                <a:gd name="connsiteX74" fmla="*/ 679866 w 1004212"/>
                <a:gd name="connsiteY74" fmla="*/ 318849 h 687175"/>
                <a:gd name="connsiteX75" fmla="*/ 689028 w 1004212"/>
                <a:gd name="connsiteY75" fmla="*/ 307855 h 687175"/>
                <a:gd name="connsiteX76" fmla="*/ 701856 w 1004212"/>
                <a:gd name="connsiteY76" fmla="*/ 304190 h 687175"/>
                <a:gd name="connsiteX77" fmla="*/ 712850 w 1004212"/>
                <a:gd name="connsiteY77" fmla="*/ 293195 h 687175"/>
                <a:gd name="connsiteX78" fmla="*/ 720180 w 1004212"/>
                <a:gd name="connsiteY78" fmla="*/ 280368 h 687175"/>
                <a:gd name="connsiteX79" fmla="*/ 725678 w 1004212"/>
                <a:gd name="connsiteY79" fmla="*/ 274870 h 687175"/>
                <a:gd name="connsiteX80" fmla="*/ 736672 w 1004212"/>
                <a:gd name="connsiteY80" fmla="*/ 254713 h 687175"/>
                <a:gd name="connsiteX81" fmla="*/ 736672 w 1004212"/>
                <a:gd name="connsiteY81" fmla="*/ 254713 h 687175"/>
                <a:gd name="connsiteX82" fmla="*/ 744002 w 1004212"/>
                <a:gd name="connsiteY82" fmla="*/ 241886 h 687175"/>
                <a:gd name="connsiteX83" fmla="*/ 749500 w 1004212"/>
                <a:gd name="connsiteY83" fmla="*/ 232723 h 687175"/>
                <a:gd name="connsiteX84" fmla="*/ 751332 w 1004212"/>
                <a:gd name="connsiteY84" fmla="*/ 227226 h 687175"/>
                <a:gd name="connsiteX85" fmla="*/ 760494 w 1004212"/>
                <a:gd name="connsiteY85" fmla="*/ 214399 h 687175"/>
                <a:gd name="connsiteX86" fmla="*/ 762327 w 1004212"/>
                <a:gd name="connsiteY86" fmla="*/ 208901 h 687175"/>
                <a:gd name="connsiteX87" fmla="*/ 765992 w 1004212"/>
                <a:gd name="connsiteY87" fmla="*/ 203404 h 687175"/>
                <a:gd name="connsiteX88" fmla="*/ 769657 w 1004212"/>
                <a:gd name="connsiteY88" fmla="*/ 192409 h 687175"/>
                <a:gd name="connsiteX89" fmla="*/ 776987 w 1004212"/>
                <a:gd name="connsiteY89" fmla="*/ 128273 h 687175"/>
                <a:gd name="connsiteX90" fmla="*/ 778819 w 1004212"/>
                <a:gd name="connsiteY90" fmla="*/ 117278 h 687175"/>
                <a:gd name="connsiteX91" fmla="*/ 784316 w 1004212"/>
                <a:gd name="connsiteY91" fmla="*/ 86126 h 687175"/>
                <a:gd name="connsiteX92" fmla="*/ 791646 w 1004212"/>
                <a:gd name="connsiteY92" fmla="*/ 75131 h 687175"/>
                <a:gd name="connsiteX93" fmla="*/ 797144 w 1004212"/>
                <a:gd name="connsiteY93" fmla="*/ 73299 h 687175"/>
                <a:gd name="connsiteX94" fmla="*/ 813636 w 1004212"/>
                <a:gd name="connsiteY94" fmla="*/ 62304 h 687175"/>
                <a:gd name="connsiteX95" fmla="*/ 819133 w 1004212"/>
                <a:gd name="connsiteY95" fmla="*/ 58639 h 687175"/>
                <a:gd name="connsiteX96" fmla="*/ 826463 w 1004212"/>
                <a:gd name="connsiteY96" fmla="*/ 54974 h 687175"/>
                <a:gd name="connsiteX97" fmla="*/ 831961 w 1004212"/>
                <a:gd name="connsiteY97" fmla="*/ 47645 h 687175"/>
                <a:gd name="connsiteX98" fmla="*/ 842955 w 1004212"/>
                <a:gd name="connsiteY98" fmla="*/ 42147 h 687175"/>
                <a:gd name="connsiteX99" fmla="*/ 848453 w 1004212"/>
                <a:gd name="connsiteY99" fmla="*/ 38482 h 687175"/>
                <a:gd name="connsiteX100" fmla="*/ 852118 w 1004212"/>
                <a:gd name="connsiteY100" fmla="*/ 32985 h 687175"/>
                <a:gd name="connsiteX101" fmla="*/ 863112 w 1004212"/>
                <a:gd name="connsiteY101" fmla="*/ 27487 h 687175"/>
                <a:gd name="connsiteX102" fmla="*/ 866777 w 1004212"/>
                <a:gd name="connsiteY102" fmla="*/ 20158 h 687175"/>
                <a:gd name="connsiteX103" fmla="*/ 872275 w 1004212"/>
                <a:gd name="connsiteY103" fmla="*/ 18325 h 687175"/>
                <a:gd name="connsiteX104" fmla="*/ 888767 w 1004212"/>
                <a:gd name="connsiteY104" fmla="*/ 16493 h 687175"/>
                <a:gd name="connsiteX105" fmla="*/ 989553 w 1004212"/>
                <a:gd name="connsiteY105" fmla="*/ 14660 h 687175"/>
                <a:gd name="connsiteX106" fmla="*/ 1004212 w 1004212"/>
                <a:gd name="connsiteY106" fmla="*/ 0 h 6871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</a:cxnLst>
              <a:rect l="l" t="t" r="r" b="b"/>
              <a:pathLst>
                <a:path w="1004212" h="687175">
                  <a:moveTo>
                    <a:pt x="1854" y="602881"/>
                  </a:moveTo>
                  <a:cubicBezTo>
                    <a:pt x="-510" y="614704"/>
                    <a:pt x="-724" y="610144"/>
                    <a:pt x="1854" y="623038"/>
                  </a:cubicBezTo>
                  <a:cubicBezTo>
                    <a:pt x="2348" y="625508"/>
                    <a:pt x="2242" y="628305"/>
                    <a:pt x="3686" y="630368"/>
                  </a:cubicBezTo>
                  <a:cubicBezTo>
                    <a:pt x="6658" y="634614"/>
                    <a:pt x="14681" y="641363"/>
                    <a:pt x="14681" y="641363"/>
                  </a:cubicBezTo>
                  <a:cubicBezTo>
                    <a:pt x="23233" y="640141"/>
                    <a:pt x="31955" y="639793"/>
                    <a:pt x="40336" y="637698"/>
                  </a:cubicBezTo>
                  <a:lnTo>
                    <a:pt x="54995" y="634033"/>
                  </a:lnTo>
                  <a:cubicBezTo>
                    <a:pt x="59882" y="634644"/>
                    <a:pt x="65109" y="633972"/>
                    <a:pt x="69655" y="635866"/>
                  </a:cubicBezTo>
                  <a:cubicBezTo>
                    <a:pt x="72845" y="637195"/>
                    <a:pt x="74362" y="640947"/>
                    <a:pt x="76985" y="643196"/>
                  </a:cubicBezTo>
                  <a:cubicBezTo>
                    <a:pt x="81507" y="647072"/>
                    <a:pt x="82658" y="646920"/>
                    <a:pt x="87980" y="648693"/>
                  </a:cubicBezTo>
                  <a:cubicBezTo>
                    <a:pt x="94751" y="658849"/>
                    <a:pt x="87771" y="650817"/>
                    <a:pt x="97142" y="656023"/>
                  </a:cubicBezTo>
                  <a:cubicBezTo>
                    <a:pt x="100992" y="658162"/>
                    <a:pt x="104472" y="660910"/>
                    <a:pt x="108137" y="663353"/>
                  </a:cubicBezTo>
                  <a:cubicBezTo>
                    <a:pt x="120329" y="671481"/>
                    <a:pt x="109735" y="665506"/>
                    <a:pt x="135624" y="670683"/>
                  </a:cubicBezTo>
                  <a:cubicBezTo>
                    <a:pt x="138678" y="671294"/>
                    <a:pt x="141765" y="671760"/>
                    <a:pt x="144786" y="672515"/>
                  </a:cubicBezTo>
                  <a:cubicBezTo>
                    <a:pt x="155256" y="675133"/>
                    <a:pt x="145042" y="673895"/>
                    <a:pt x="157613" y="676180"/>
                  </a:cubicBezTo>
                  <a:cubicBezTo>
                    <a:pt x="161863" y="676952"/>
                    <a:pt x="166165" y="677401"/>
                    <a:pt x="170441" y="678012"/>
                  </a:cubicBezTo>
                  <a:cubicBezTo>
                    <a:pt x="174106" y="679234"/>
                    <a:pt x="177849" y="680242"/>
                    <a:pt x="181436" y="681677"/>
                  </a:cubicBezTo>
                  <a:cubicBezTo>
                    <a:pt x="197410" y="688067"/>
                    <a:pt x="180221" y="683205"/>
                    <a:pt x="196095" y="687175"/>
                  </a:cubicBezTo>
                  <a:cubicBezTo>
                    <a:pt x="204036" y="686564"/>
                    <a:pt x="212089" y="686810"/>
                    <a:pt x="219917" y="685342"/>
                  </a:cubicBezTo>
                  <a:cubicBezTo>
                    <a:pt x="222082" y="684936"/>
                    <a:pt x="223445" y="682662"/>
                    <a:pt x="225415" y="681677"/>
                  </a:cubicBezTo>
                  <a:cubicBezTo>
                    <a:pt x="227143" y="680813"/>
                    <a:pt x="229080" y="680456"/>
                    <a:pt x="230912" y="679845"/>
                  </a:cubicBezTo>
                  <a:cubicBezTo>
                    <a:pt x="232134" y="678013"/>
                    <a:pt x="232745" y="675570"/>
                    <a:pt x="234577" y="674348"/>
                  </a:cubicBezTo>
                  <a:cubicBezTo>
                    <a:pt x="236673" y="672951"/>
                    <a:pt x="239485" y="673207"/>
                    <a:pt x="241907" y="672515"/>
                  </a:cubicBezTo>
                  <a:cubicBezTo>
                    <a:pt x="260309" y="667257"/>
                    <a:pt x="231817" y="674581"/>
                    <a:pt x="254734" y="668850"/>
                  </a:cubicBezTo>
                  <a:cubicBezTo>
                    <a:pt x="269397" y="659076"/>
                    <a:pt x="251679" y="671905"/>
                    <a:pt x="263896" y="659688"/>
                  </a:cubicBezTo>
                  <a:cubicBezTo>
                    <a:pt x="265453" y="658131"/>
                    <a:pt x="267702" y="657433"/>
                    <a:pt x="269394" y="656023"/>
                  </a:cubicBezTo>
                  <a:cubicBezTo>
                    <a:pt x="271385" y="654364"/>
                    <a:pt x="272573" y="651684"/>
                    <a:pt x="274891" y="650525"/>
                  </a:cubicBezTo>
                  <a:cubicBezTo>
                    <a:pt x="276170" y="649885"/>
                    <a:pt x="294731" y="646914"/>
                    <a:pt x="295048" y="646861"/>
                  </a:cubicBezTo>
                  <a:cubicBezTo>
                    <a:pt x="296881" y="645639"/>
                    <a:pt x="298634" y="644289"/>
                    <a:pt x="300546" y="643196"/>
                  </a:cubicBezTo>
                  <a:cubicBezTo>
                    <a:pt x="302918" y="641841"/>
                    <a:pt x="305944" y="641463"/>
                    <a:pt x="307876" y="639531"/>
                  </a:cubicBezTo>
                  <a:cubicBezTo>
                    <a:pt x="309242" y="638165"/>
                    <a:pt x="308844" y="635761"/>
                    <a:pt x="309708" y="634033"/>
                  </a:cubicBezTo>
                  <a:cubicBezTo>
                    <a:pt x="310693" y="632063"/>
                    <a:pt x="312151" y="630368"/>
                    <a:pt x="313373" y="628536"/>
                  </a:cubicBezTo>
                  <a:cubicBezTo>
                    <a:pt x="313984" y="623039"/>
                    <a:pt x="314296" y="617500"/>
                    <a:pt x="315205" y="612044"/>
                  </a:cubicBezTo>
                  <a:cubicBezTo>
                    <a:pt x="316131" y="606489"/>
                    <a:pt x="318224" y="601146"/>
                    <a:pt x="318870" y="595552"/>
                  </a:cubicBezTo>
                  <a:cubicBezTo>
                    <a:pt x="320062" y="585219"/>
                    <a:pt x="318056" y="574459"/>
                    <a:pt x="320703" y="564400"/>
                  </a:cubicBezTo>
                  <a:cubicBezTo>
                    <a:pt x="321398" y="561758"/>
                    <a:pt x="325522" y="561811"/>
                    <a:pt x="328033" y="560735"/>
                  </a:cubicBezTo>
                  <a:cubicBezTo>
                    <a:pt x="329808" y="559974"/>
                    <a:pt x="331802" y="559766"/>
                    <a:pt x="333530" y="558902"/>
                  </a:cubicBezTo>
                  <a:cubicBezTo>
                    <a:pt x="335500" y="557917"/>
                    <a:pt x="337116" y="556330"/>
                    <a:pt x="339028" y="555237"/>
                  </a:cubicBezTo>
                  <a:cubicBezTo>
                    <a:pt x="341400" y="553882"/>
                    <a:pt x="343914" y="552794"/>
                    <a:pt x="346357" y="551572"/>
                  </a:cubicBezTo>
                  <a:cubicBezTo>
                    <a:pt x="346968" y="549740"/>
                    <a:pt x="346983" y="547583"/>
                    <a:pt x="348190" y="546075"/>
                  </a:cubicBezTo>
                  <a:cubicBezTo>
                    <a:pt x="349566" y="544355"/>
                    <a:pt x="351995" y="543820"/>
                    <a:pt x="353687" y="542410"/>
                  </a:cubicBezTo>
                  <a:cubicBezTo>
                    <a:pt x="358981" y="537999"/>
                    <a:pt x="359245" y="536823"/>
                    <a:pt x="362850" y="531415"/>
                  </a:cubicBezTo>
                  <a:cubicBezTo>
                    <a:pt x="364340" y="526944"/>
                    <a:pt x="364795" y="523972"/>
                    <a:pt x="368347" y="520420"/>
                  </a:cubicBezTo>
                  <a:cubicBezTo>
                    <a:pt x="369904" y="518863"/>
                    <a:pt x="372012" y="517977"/>
                    <a:pt x="373844" y="516756"/>
                  </a:cubicBezTo>
                  <a:cubicBezTo>
                    <a:pt x="376962" y="507405"/>
                    <a:pt x="373687" y="514495"/>
                    <a:pt x="381174" y="505761"/>
                  </a:cubicBezTo>
                  <a:cubicBezTo>
                    <a:pt x="383162" y="503442"/>
                    <a:pt x="384512" y="500591"/>
                    <a:pt x="386672" y="498431"/>
                  </a:cubicBezTo>
                  <a:cubicBezTo>
                    <a:pt x="388831" y="496271"/>
                    <a:pt x="391842" y="495093"/>
                    <a:pt x="394001" y="492933"/>
                  </a:cubicBezTo>
                  <a:cubicBezTo>
                    <a:pt x="400761" y="486172"/>
                    <a:pt x="394158" y="487943"/>
                    <a:pt x="403164" y="481939"/>
                  </a:cubicBezTo>
                  <a:cubicBezTo>
                    <a:pt x="404771" y="480868"/>
                    <a:pt x="406829" y="480717"/>
                    <a:pt x="408661" y="480106"/>
                  </a:cubicBezTo>
                  <a:cubicBezTo>
                    <a:pt x="417307" y="467138"/>
                    <a:pt x="405577" y="483033"/>
                    <a:pt x="421488" y="469111"/>
                  </a:cubicBezTo>
                  <a:cubicBezTo>
                    <a:pt x="423786" y="467100"/>
                    <a:pt x="424703" y="463811"/>
                    <a:pt x="426986" y="461782"/>
                  </a:cubicBezTo>
                  <a:cubicBezTo>
                    <a:pt x="430278" y="458856"/>
                    <a:pt x="434867" y="457567"/>
                    <a:pt x="437981" y="454452"/>
                  </a:cubicBezTo>
                  <a:lnTo>
                    <a:pt x="443478" y="448954"/>
                  </a:lnTo>
                  <a:cubicBezTo>
                    <a:pt x="444089" y="446511"/>
                    <a:pt x="443846" y="443673"/>
                    <a:pt x="445310" y="441624"/>
                  </a:cubicBezTo>
                  <a:cubicBezTo>
                    <a:pt x="446343" y="440178"/>
                    <a:pt x="455911" y="433947"/>
                    <a:pt x="458138" y="432462"/>
                  </a:cubicBezTo>
                  <a:cubicBezTo>
                    <a:pt x="468641" y="416708"/>
                    <a:pt x="454656" y="435248"/>
                    <a:pt x="467300" y="425132"/>
                  </a:cubicBezTo>
                  <a:cubicBezTo>
                    <a:pt x="476781" y="417547"/>
                    <a:pt x="464255" y="421113"/>
                    <a:pt x="476462" y="414137"/>
                  </a:cubicBezTo>
                  <a:cubicBezTo>
                    <a:pt x="478649" y="412887"/>
                    <a:pt x="481349" y="412916"/>
                    <a:pt x="483792" y="412305"/>
                  </a:cubicBezTo>
                  <a:cubicBezTo>
                    <a:pt x="494237" y="401862"/>
                    <a:pt x="483699" y="410513"/>
                    <a:pt x="496619" y="404975"/>
                  </a:cubicBezTo>
                  <a:cubicBezTo>
                    <a:pt x="514325" y="397386"/>
                    <a:pt x="488417" y="404734"/>
                    <a:pt x="509447" y="399478"/>
                  </a:cubicBezTo>
                  <a:cubicBezTo>
                    <a:pt x="511890" y="398256"/>
                    <a:pt x="514219" y="396772"/>
                    <a:pt x="516777" y="395813"/>
                  </a:cubicBezTo>
                  <a:cubicBezTo>
                    <a:pt x="519135" y="394929"/>
                    <a:pt x="521685" y="394672"/>
                    <a:pt x="524106" y="393980"/>
                  </a:cubicBezTo>
                  <a:cubicBezTo>
                    <a:pt x="525963" y="393449"/>
                    <a:pt x="527771" y="392759"/>
                    <a:pt x="529604" y="392148"/>
                  </a:cubicBezTo>
                  <a:cubicBezTo>
                    <a:pt x="533269" y="389705"/>
                    <a:pt x="536420" y="386211"/>
                    <a:pt x="540599" y="384818"/>
                  </a:cubicBezTo>
                  <a:lnTo>
                    <a:pt x="551593" y="381153"/>
                  </a:lnTo>
                  <a:cubicBezTo>
                    <a:pt x="552815" y="379321"/>
                    <a:pt x="553538" y="377032"/>
                    <a:pt x="555258" y="375656"/>
                  </a:cubicBezTo>
                  <a:cubicBezTo>
                    <a:pt x="556767" y="374449"/>
                    <a:pt x="559028" y="374687"/>
                    <a:pt x="560756" y="373823"/>
                  </a:cubicBezTo>
                  <a:cubicBezTo>
                    <a:pt x="573408" y="367496"/>
                    <a:pt x="558330" y="372138"/>
                    <a:pt x="573583" y="368326"/>
                  </a:cubicBezTo>
                  <a:cubicBezTo>
                    <a:pt x="584032" y="354393"/>
                    <a:pt x="573784" y="365160"/>
                    <a:pt x="584578" y="359164"/>
                  </a:cubicBezTo>
                  <a:cubicBezTo>
                    <a:pt x="596646" y="352460"/>
                    <a:pt x="595941" y="349269"/>
                    <a:pt x="610232" y="344504"/>
                  </a:cubicBezTo>
                  <a:cubicBezTo>
                    <a:pt x="619255" y="341496"/>
                    <a:pt x="613824" y="342989"/>
                    <a:pt x="626725" y="340839"/>
                  </a:cubicBezTo>
                  <a:cubicBezTo>
                    <a:pt x="629779" y="339617"/>
                    <a:pt x="632807" y="338329"/>
                    <a:pt x="635887" y="337174"/>
                  </a:cubicBezTo>
                  <a:cubicBezTo>
                    <a:pt x="637695" y="336496"/>
                    <a:pt x="639609" y="336103"/>
                    <a:pt x="641384" y="335342"/>
                  </a:cubicBezTo>
                  <a:cubicBezTo>
                    <a:pt x="643895" y="334266"/>
                    <a:pt x="646029" y="332180"/>
                    <a:pt x="648714" y="331677"/>
                  </a:cubicBezTo>
                  <a:cubicBezTo>
                    <a:pt x="655943" y="330321"/>
                    <a:pt x="663374" y="330455"/>
                    <a:pt x="670704" y="329844"/>
                  </a:cubicBezTo>
                  <a:cubicBezTo>
                    <a:pt x="679803" y="316196"/>
                    <a:pt x="668109" y="332958"/>
                    <a:pt x="679866" y="318849"/>
                  </a:cubicBezTo>
                  <a:cubicBezTo>
                    <a:pt x="684090" y="313780"/>
                    <a:pt x="683008" y="311869"/>
                    <a:pt x="689028" y="307855"/>
                  </a:cubicBezTo>
                  <a:cubicBezTo>
                    <a:pt x="690608" y="306802"/>
                    <a:pt x="700875" y="304435"/>
                    <a:pt x="701856" y="304190"/>
                  </a:cubicBezTo>
                  <a:cubicBezTo>
                    <a:pt x="710489" y="291236"/>
                    <a:pt x="699216" y="306829"/>
                    <a:pt x="712850" y="293195"/>
                  </a:cubicBezTo>
                  <a:cubicBezTo>
                    <a:pt x="717176" y="288869"/>
                    <a:pt x="716589" y="285395"/>
                    <a:pt x="720180" y="280368"/>
                  </a:cubicBezTo>
                  <a:cubicBezTo>
                    <a:pt x="721687" y="278259"/>
                    <a:pt x="723845" y="276703"/>
                    <a:pt x="725678" y="274870"/>
                  </a:cubicBezTo>
                  <a:cubicBezTo>
                    <a:pt x="730979" y="261618"/>
                    <a:pt x="727519" y="268445"/>
                    <a:pt x="736672" y="254713"/>
                  </a:cubicBezTo>
                  <a:lnTo>
                    <a:pt x="736672" y="254713"/>
                  </a:lnTo>
                  <a:cubicBezTo>
                    <a:pt x="742929" y="242199"/>
                    <a:pt x="737526" y="252247"/>
                    <a:pt x="744002" y="241886"/>
                  </a:cubicBezTo>
                  <a:cubicBezTo>
                    <a:pt x="745890" y="238866"/>
                    <a:pt x="747907" y="235909"/>
                    <a:pt x="749500" y="232723"/>
                  </a:cubicBezTo>
                  <a:cubicBezTo>
                    <a:pt x="750364" y="230995"/>
                    <a:pt x="750468" y="228954"/>
                    <a:pt x="751332" y="227226"/>
                  </a:cubicBezTo>
                  <a:cubicBezTo>
                    <a:pt x="752670" y="224550"/>
                    <a:pt x="759252" y="216055"/>
                    <a:pt x="760494" y="214399"/>
                  </a:cubicBezTo>
                  <a:cubicBezTo>
                    <a:pt x="761105" y="212566"/>
                    <a:pt x="761463" y="210629"/>
                    <a:pt x="762327" y="208901"/>
                  </a:cubicBezTo>
                  <a:cubicBezTo>
                    <a:pt x="763312" y="206931"/>
                    <a:pt x="765098" y="205416"/>
                    <a:pt x="765992" y="203404"/>
                  </a:cubicBezTo>
                  <a:cubicBezTo>
                    <a:pt x="767561" y="199874"/>
                    <a:pt x="769657" y="192409"/>
                    <a:pt x="769657" y="192409"/>
                  </a:cubicBezTo>
                  <a:cubicBezTo>
                    <a:pt x="775334" y="131847"/>
                    <a:pt x="768944" y="152394"/>
                    <a:pt x="776987" y="128273"/>
                  </a:cubicBezTo>
                  <a:cubicBezTo>
                    <a:pt x="777598" y="124608"/>
                    <a:pt x="778409" y="120971"/>
                    <a:pt x="778819" y="117278"/>
                  </a:cubicBezTo>
                  <a:cubicBezTo>
                    <a:pt x="780475" y="102378"/>
                    <a:pt x="778123" y="97482"/>
                    <a:pt x="784316" y="86126"/>
                  </a:cubicBezTo>
                  <a:cubicBezTo>
                    <a:pt x="786425" y="82259"/>
                    <a:pt x="787467" y="76523"/>
                    <a:pt x="791646" y="75131"/>
                  </a:cubicBezTo>
                  <a:lnTo>
                    <a:pt x="797144" y="73299"/>
                  </a:lnTo>
                  <a:lnTo>
                    <a:pt x="813636" y="62304"/>
                  </a:lnTo>
                  <a:cubicBezTo>
                    <a:pt x="815468" y="61082"/>
                    <a:pt x="817163" y="59624"/>
                    <a:pt x="819133" y="58639"/>
                  </a:cubicBezTo>
                  <a:lnTo>
                    <a:pt x="826463" y="54974"/>
                  </a:lnTo>
                  <a:cubicBezTo>
                    <a:pt x="828296" y="52531"/>
                    <a:pt x="829801" y="49804"/>
                    <a:pt x="831961" y="47645"/>
                  </a:cubicBezTo>
                  <a:cubicBezTo>
                    <a:pt x="837213" y="42394"/>
                    <a:pt x="836994" y="45128"/>
                    <a:pt x="842955" y="42147"/>
                  </a:cubicBezTo>
                  <a:cubicBezTo>
                    <a:pt x="844925" y="41162"/>
                    <a:pt x="846620" y="39704"/>
                    <a:pt x="848453" y="38482"/>
                  </a:cubicBezTo>
                  <a:cubicBezTo>
                    <a:pt x="849675" y="36650"/>
                    <a:pt x="850561" y="34542"/>
                    <a:pt x="852118" y="32985"/>
                  </a:cubicBezTo>
                  <a:cubicBezTo>
                    <a:pt x="855670" y="29433"/>
                    <a:pt x="858641" y="28978"/>
                    <a:pt x="863112" y="27487"/>
                  </a:cubicBezTo>
                  <a:cubicBezTo>
                    <a:pt x="864334" y="25044"/>
                    <a:pt x="864845" y="22089"/>
                    <a:pt x="866777" y="20158"/>
                  </a:cubicBezTo>
                  <a:cubicBezTo>
                    <a:pt x="868143" y="18792"/>
                    <a:pt x="870369" y="18643"/>
                    <a:pt x="872275" y="18325"/>
                  </a:cubicBezTo>
                  <a:cubicBezTo>
                    <a:pt x="877731" y="17416"/>
                    <a:pt x="883239" y="16666"/>
                    <a:pt x="888767" y="16493"/>
                  </a:cubicBezTo>
                  <a:cubicBezTo>
                    <a:pt x="922351" y="15443"/>
                    <a:pt x="955958" y="15271"/>
                    <a:pt x="989553" y="14660"/>
                  </a:cubicBezTo>
                  <a:lnTo>
                    <a:pt x="1004212" y="0"/>
                  </a:ln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フリーフォーム: 図形 24">
              <a:extLst>
                <a:ext uri="{FF2B5EF4-FFF2-40B4-BE49-F238E27FC236}">
                  <a16:creationId xmlns:a16="http://schemas.microsoft.com/office/drawing/2014/main" id="{A1FE71B2-CCC6-433F-B144-4221E9A00DEA}"/>
                </a:ext>
              </a:extLst>
            </p:cNvPr>
            <p:cNvSpPr/>
            <p:nvPr/>
          </p:nvSpPr>
          <p:spPr>
            <a:xfrm>
              <a:off x="4614147" y="2561786"/>
              <a:ext cx="1552097" cy="1383511"/>
            </a:xfrm>
            <a:custGeom>
              <a:avLst/>
              <a:gdLst>
                <a:gd name="connsiteX0" fmla="*/ 152094 w 1552097"/>
                <a:gd name="connsiteY0" fmla="*/ 1075657 h 1383511"/>
                <a:gd name="connsiteX1" fmla="*/ 161257 w 1552097"/>
                <a:gd name="connsiteY1" fmla="*/ 1077489 h 1383511"/>
                <a:gd name="connsiteX2" fmla="*/ 174084 w 1552097"/>
                <a:gd name="connsiteY2" fmla="*/ 1084819 h 1383511"/>
                <a:gd name="connsiteX3" fmla="*/ 177749 w 1552097"/>
                <a:gd name="connsiteY3" fmla="*/ 1090317 h 1383511"/>
                <a:gd name="connsiteX4" fmla="*/ 183246 w 1552097"/>
                <a:gd name="connsiteY4" fmla="*/ 1093982 h 1383511"/>
                <a:gd name="connsiteX5" fmla="*/ 185079 w 1552097"/>
                <a:gd name="connsiteY5" fmla="*/ 1099479 h 1383511"/>
                <a:gd name="connsiteX6" fmla="*/ 181414 w 1552097"/>
                <a:gd name="connsiteY6" fmla="*/ 1115971 h 1383511"/>
                <a:gd name="connsiteX7" fmla="*/ 172251 w 1552097"/>
                <a:gd name="connsiteY7" fmla="*/ 1125133 h 1383511"/>
                <a:gd name="connsiteX8" fmla="*/ 164922 w 1552097"/>
                <a:gd name="connsiteY8" fmla="*/ 1130631 h 1383511"/>
                <a:gd name="connsiteX9" fmla="*/ 157592 w 1552097"/>
                <a:gd name="connsiteY9" fmla="*/ 1134296 h 1383511"/>
                <a:gd name="connsiteX10" fmla="*/ 141099 w 1552097"/>
                <a:gd name="connsiteY10" fmla="*/ 1148955 h 1383511"/>
                <a:gd name="connsiteX11" fmla="*/ 137435 w 1552097"/>
                <a:gd name="connsiteY11" fmla="*/ 1154453 h 1383511"/>
                <a:gd name="connsiteX12" fmla="*/ 122775 w 1552097"/>
                <a:gd name="connsiteY12" fmla="*/ 1159950 h 1383511"/>
                <a:gd name="connsiteX13" fmla="*/ 115445 w 1552097"/>
                <a:gd name="connsiteY13" fmla="*/ 1163615 h 1383511"/>
                <a:gd name="connsiteX14" fmla="*/ 106283 w 1552097"/>
                <a:gd name="connsiteY14" fmla="*/ 1170945 h 1383511"/>
                <a:gd name="connsiteX15" fmla="*/ 89790 w 1552097"/>
                <a:gd name="connsiteY15" fmla="*/ 1178275 h 1383511"/>
                <a:gd name="connsiteX16" fmla="*/ 82461 w 1552097"/>
                <a:gd name="connsiteY16" fmla="*/ 1181940 h 1383511"/>
                <a:gd name="connsiteX17" fmla="*/ 76963 w 1552097"/>
                <a:gd name="connsiteY17" fmla="*/ 1185605 h 1383511"/>
                <a:gd name="connsiteX18" fmla="*/ 60471 w 1552097"/>
                <a:gd name="connsiteY18" fmla="*/ 1187437 h 1383511"/>
                <a:gd name="connsiteX19" fmla="*/ 51309 w 1552097"/>
                <a:gd name="connsiteY19" fmla="*/ 1191102 h 1383511"/>
                <a:gd name="connsiteX20" fmla="*/ 38481 w 1552097"/>
                <a:gd name="connsiteY20" fmla="*/ 1192935 h 1383511"/>
                <a:gd name="connsiteX21" fmla="*/ 29319 w 1552097"/>
                <a:gd name="connsiteY21" fmla="*/ 1194767 h 1383511"/>
                <a:gd name="connsiteX22" fmla="*/ 23822 w 1552097"/>
                <a:gd name="connsiteY22" fmla="*/ 1202097 h 1383511"/>
                <a:gd name="connsiteX23" fmla="*/ 31152 w 1552097"/>
                <a:gd name="connsiteY23" fmla="*/ 1213092 h 1383511"/>
                <a:gd name="connsiteX24" fmla="*/ 38481 w 1552097"/>
                <a:gd name="connsiteY24" fmla="*/ 1224087 h 1383511"/>
                <a:gd name="connsiteX25" fmla="*/ 42146 w 1552097"/>
                <a:gd name="connsiteY25" fmla="*/ 1235081 h 1383511"/>
                <a:gd name="connsiteX26" fmla="*/ 40314 w 1552097"/>
                <a:gd name="connsiteY26" fmla="*/ 1251574 h 1383511"/>
                <a:gd name="connsiteX27" fmla="*/ 27487 w 1552097"/>
                <a:gd name="connsiteY27" fmla="*/ 1264401 h 1383511"/>
                <a:gd name="connsiteX28" fmla="*/ 20157 w 1552097"/>
                <a:gd name="connsiteY28" fmla="*/ 1269898 h 1383511"/>
                <a:gd name="connsiteX29" fmla="*/ 9162 w 1552097"/>
                <a:gd name="connsiteY29" fmla="*/ 1282725 h 1383511"/>
                <a:gd name="connsiteX30" fmla="*/ 3665 w 1552097"/>
                <a:gd name="connsiteY30" fmla="*/ 1295553 h 1383511"/>
                <a:gd name="connsiteX31" fmla="*/ 0 w 1552097"/>
                <a:gd name="connsiteY31" fmla="*/ 1306547 h 1383511"/>
                <a:gd name="connsiteX32" fmla="*/ 3665 w 1552097"/>
                <a:gd name="connsiteY32" fmla="*/ 1328537 h 1383511"/>
                <a:gd name="connsiteX33" fmla="*/ 14659 w 1552097"/>
                <a:gd name="connsiteY33" fmla="*/ 1341364 h 1383511"/>
                <a:gd name="connsiteX34" fmla="*/ 21989 w 1552097"/>
                <a:gd name="connsiteY34" fmla="*/ 1345029 h 1383511"/>
                <a:gd name="connsiteX35" fmla="*/ 40314 w 1552097"/>
                <a:gd name="connsiteY35" fmla="*/ 1361521 h 1383511"/>
                <a:gd name="connsiteX36" fmla="*/ 45811 w 1552097"/>
                <a:gd name="connsiteY36" fmla="*/ 1363354 h 1383511"/>
                <a:gd name="connsiteX37" fmla="*/ 49476 w 1552097"/>
                <a:gd name="connsiteY37" fmla="*/ 1368851 h 1383511"/>
                <a:gd name="connsiteX38" fmla="*/ 60471 w 1552097"/>
                <a:gd name="connsiteY38" fmla="*/ 1372516 h 1383511"/>
                <a:gd name="connsiteX39" fmla="*/ 91623 w 1552097"/>
                <a:gd name="connsiteY39" fmla="*/ 1376181 h 1383511"/>
                <a:gd name="connsiteX40" fmla="*/ 98953 w 1552097"/>
                <a:gd name="connsiteY40" fmla="*/ 1378014 h 1383511"/>
                <a:gd name="connsiteX41" fmla="*/ 104450 w 1552097"/>
                <a:gd name="connsiteY41" fmla="*/ 1381679 h 1383511"/>
                <a:gd name="connsiteX42" fmla="*/ 115445 w 1552097"/>
                <a:gd name="connsiteY42" fmla="*/ 1383511 h 1383511"/>
                <a:gd name="connsiteX43" fmla="*/ 137435 w 1552097"/>
                <a:gd name="connsiteY43" fmla="*/ 1378014 h 1383511"/>
                <a:gd name="connsiteX44" fmla="*/ 144764 w 1552097"/>
                <a:gd name="connsiteY44" fmla="*/ 1374349 h 1383511"/>
                <a:gd name="connsiteX45" fmla="*/ 152094 w 1552097"/>
                <a:gd name="connsiteY45" fmla="*/ 1363354 h 1383511"/>
                <a:gd name="connsiteX46" fmla="*/ 159424 w 1552097"/>
                <a:gd name="connsiteY46" fmla="*/ 1361521 h 1383511"/>
                <a:gd name="connsiteX47" fmla="*/ 163089 w 1552097"/>
                <a:gd name="connsiteY47" fmla="*/ 1356024 h 1383511"/>
                <a:gd name="connsiteX48" fmla="*/ 175916 w 1552097"/>
                <a:gd name="connsiteY48" fmla="*/ 1346862 h 1383511"/>
                <a:gd name="connsiteX49" fmla="*/ 179581 w 1552097"/>
                <a:gd name="connsiteY49" fmla="*/ 1341364 h 1383511"/>
                <a:gd name="connsiteX50" fmla="*/ 197906 w 1552097"/>
                <a:gd name="connsiteY50" fmla="*/ 1330370 h 1383511"/>
                <a:gd name="connsiteX51" fmla="*/ 205236 w 1552097"/>
                <a:gd name="connsiteY51" fmla="*/ 1323040 h 1383511"/>
                <a:gd name="connsiteX52" fmla="*/ 212566 w 1552097"/>
                <a:gd name="connsiteY52" fmla="*/ 1317542 h 1383511"/>
                <a:gd name="connsiteX53" fmla="*/ 216231 w 1552097"/>
                <a:gd name="connsiteY53" fmla="*/ 1310212 h 1383511"/>
                <a:gd name="connsiteX54" fmla="*/ 229058 w 1552097"/>
                <a:gd name="connsiteY54" fmla="*/ 1304715 h 1383511"/>
                <a:gd name="connsiteX55" fmla="*/ 236388 w 1552097"/>
                <a:gd name="connsiteY55" fmla="*/ 1306547 h 1383511"/>
                <a:gd name="connsiteX56" fmla="*/ 258377 w 1552097"/>
                <a:gd name="connsiteY56" fmla="*/ 1310212 h 1383511"/>
                <a:gd name="connsiteX57" fmla="*/ 263875 w 1552097"/>
                <a:gd name="connsiteY57" fmla="*/ 1313877 h 1383511"/>
                <a:gd name="connsiteX58" fmla="*/ 309686 w 1552097"/>
                <a:gd name="connsiteY58" fmla="*/ 1313877 h 1383511"/>
                <a:gd name="connsiteX59" fmla="*/ 331676 w 1552097"/>
                <a:gd name="connsiteY59" fmla="*/ 1308380 h 1383511"/>
                <a:gd name="connsiteX60" fmla="*/ 335341 w 1552097"/>
                <a:gd name="connsiteY60" fmla="*/ 1302883 h 1383511"/>
                <a:gd name="connsiteX61" fmla="*/ 346336 w 1552097"/>
                <a:gd name="connsiteY61" fmla="*/ 1299218 h 1383511"/>
                <a:gd name="connsiteX62" fmla="*/ 360995 w 1552097"/>
                <a:gd name="connsiteY62" fmla="*/ 1288223 h 1383511"/>
                <a:gd name="connsiteX63" fmla="*/ 371990 w 1552097"/>
                <a:gd name="connsiteY63" fmla="*/ 1284558 h 1383511"/>
                <a:gd name="connsiteX64" fmla="*/ 375655 w 1552097"/>
                <a:gd name="connsiteY64" fmla="*/ 1279060 h 1383511"/>
                <a:gd name="connsiteX65" fmla="*/ 392147 w 1552097"/>
                <a:gd name="connsiteY65" fmla="*/ 1275396 h 1383511"/>
                <a:gd name="connsiteX66" fmla="*/ 397645 w 1552097"/>
                <a:gd name="connsiteY66" fmla="*/ 1269898 h 1383511"/>
                <a:gd name="connsiteX67" fmla="*/ 459948 w 1552097"/>
                <a:gd name="connsiteY67" fmla="*/ 1264401 h 1383511"/>
                <a:gd name="connsiteX68" fmla="*/ 476441 w 1552097"/>
                <a:gd name="connsiteY68" fmla="*/ 1260736 h 1383511"/>
                <a:gd name="connsiteX69" fmla="*/ 487435 w 1552097"/>
                <a:gd name="connsiteY69" fmla="*/ 1257071 h 1383511"/>
                <a:gd name="connsiteX70" fmla="*/ 511257 w 1552097"/>
                <a:gd name="connsiteY70" fmla="*/ 1255238 h 1383511"/>
                <a:gd name="connsiteX71" fmla="*/ 536912 w 1552097"/>
                <a:gd name="connsiteY71" fmla="*/ 1246076 h 1383511"/>
                <a:gd name="connsiteX72" fmla="*/ 558901 w 1552097"/>
                <a:gd name="connsiteY72" fmla="*/ 1240579 h 1383511"/>
                <a:gd name="connsiteX73" fmla="*/ 586388 w 1552097"/>
                <a:gd name="connsiteY73" fmla="*/ 1233249 h 1383511"/>
                <a:gd name="connsiteX74" fmla="*/ 606546 w 1552097"/>
                <a:gd name="connsiteY74" fmla="*/ 1231416 h 1383511"/>
                <a:gd name="connsiteX75" fmla="*/ 623038 w 1552097"/>
                <a:gd name="connsiteY75" fmla="*/ 1229584 h 1383511"/>
                <a:gd name="connsiteX76" fmla="*/ 634033 w 1552097"/>
                <a:gd name="connsiteY76" fmla="*/ 1225919 h 1383511"/>
                <a:gd name="connsiteX77" fmla="*/ 641362 w 1552097"/>
                <a:gd name="connsiteY77" fmla="*/ 1224087 h 1383511"/>
                <a:gd name="connsiteX78" fmla="*/ 659687 w 1552097"/>
                <a:gd name="connsiteY78" fmla="*/ 1218589 h 1383511"/>
                <a:gd name="connsiteX79" fmla="*/ 670682 w 1552097"/>
                <a:gd name="connsiteY79" fmla="*/ 1211259 h 1383511"/>
                <a:gd name="connsiteX80" fmla="*/ 678012 w 1552097"/>
                <a:gd name="connsiteY80" fmla="*/ 1200265 h 1383511"/>
                <a:gd name="connsiteX81" fmla="*/ 687174 w 1552097"/>
                <a:gd name="connsiteY81" fmla="*/ 1185605 h 1383511"/>
                <a:gd name="connsiteX82" fmla="*/ 689007 w 1552097"/>
                <a:gd name="connsiteY82" fmla="*/ 1180107 h 1383511"/>
                <a:gd name="connsiteX83" fmla="*/ 690839 w 1552097"/>
                <a:gd name="connsiteY83" fmla="*/ 1172778 h 1383511"/>
                <a:gd name="connsiteX84" fmla="*/ 696336 w 1552097"/>
                <a:gd name="connsiteY84" fmla="*/ 1167280 h 1383511"/>
                <a:gd name="connsiteX85" fmla="*/ 700001 w 1552097"/>
                <a:gd name="connsiteY85" fmla="*/ 1161783 h 1383511"/>
                <a:gd name="connsiteX86" fmla="*/ 709164 w 1552097"/>
                <a:gd name="connsiteY86" fmla="*/ 1150788 h 1383511"/>
                <a:gd name="connsiteX87" fmla="*/ 718326 w 1552097"/>
                <a:gd name="connsiteY87" fmla="*/ 1139793 h 1383511"/>
                <a:gd name="connsiteX88" fmla="*/ 721991 w 1552097"/>
                <a:gd name="connsiteY88" fmla="*/ 1134296 h 1383511"/>
                <a:gd name="connsiteX89" fmla="*/ 727488 w 1552097"/>
                <a:gd name="connsiteY89" fmla="*/ 1130631 h 1383511"/>
                <a:gd name="connsiteX90" fmla="*/ 740316 w 1552097"/>
                <a:gd name="connsiteY90" fmla="*/ 1121469 h 1383511"/>
                <a:gd name="connsiteX91" fmla="*/ 751310 w 1552097"/>
                <a:gd name="connsiteY91" fmla="*/ 1110474 h 1383511"/>
                <a:gd name="connsiteX92" fmla="*/ 756808 w 1552097"/>
                <a:gd name="connsiteY92" fmla="*/ 1104976 h 1383511"/>
                <a:gd name="connsiteX93" fmla="*/ 760473 w 1552097"/>
                <a:gd name="connsiteY93" fmla="*/ 1099479 h 1383511"/>
                <a:gd name="connsiteX94" fmla="*/ 771467 w 1552097"/>
                <a:gd name="connsiteY94" fmla="*/ 1092149 h 1383511"/>
                <a:gd name="connsiteX95" fmla="*/ 776965 w 1552097"/>
                <a:gd name="connsiteY95" fmla="*/ 1086652 h 1383511"/>
                <a:gd name="connsiteX96" fmla="*/ 784295 w 1552097"/>
                <a:gd name="connsiteY96" fmla="*/ 1082987 h 1383511"/>
                <a:gd name="connsiteX97" fmla="*/ 797122 w 1552097"/>
                <a:gd name="connsiteY97" fmla="*/ 1073824 h 1383511"/>
                <a:gd name="connsiteX98" fmla="*/ 811782 w 1552097"/>
                <a:gd name="connsiteY98" fmla="*/ 1070159 h 1383511"/>
                <a:gd name="connsiteX99" fmla="*/ 817279 w 1552097"/>
                <a:gd name="connsiteY99" fmla="*/ 1066495 h 1383511"/>
                <a:gd name="connsiteX100" fmla="*/ 822776 w 1552097"/>
                <a:gd name="connsiteY100" fmla="*/ 1064662 h 1383511"/>
                <a:gd name="connsiteX101" fmla="*/ 828274 w 1552097"/>
                <a:gd name="connsiteY101" fmla="*/ 1059165 h 1383511"/>
                <a:gd name="connsiteX102" fmla="*/ 839269 w 1552097"/>
                <a:gd name="connsiteY102" fmla="*/ 1053667 h 1383511"/>
                <a:gd name="connsiteX103" fmla="*/ 844766 w 1552097"/>
                <a:gd name="connsiteY103" fmla="*/ 1040840 h 1383511"/>
                <a:gd name="connsiteX104" fmla="*/ 859426 w 1552097"/>
                <a:gd name="connsiteY104" fmla="*/ 1015186 h 1383511"/>
                <a:gd name="connsiteX105" fmla="*/ 864923 w 1552097"/>
                <a:gd name="connsiteY105" fmla="*/ 1009688 h 1383511"/>
                <a:gd name="connsiteX106" fmla="*/ 870421 w 1552097"/>
                <a:gd name="connsiteY106" fmla="*/ 1007856 h 1383511"/>
                <a:gd name="connsiteX107" fmla="*/ 901572 w 1552097"/>
                <a:gd name="connsiteY107" fmla="*/ 1002358 h 1383511"/>
                <a:gd name="connsiteX108" fmla="*/ 945552 w 1552097"/>
                <a:gd name="connsiteY108" fmla="*/ 996861 h 1383511"/>
                <a:gd name="connsiteX109" fmla="*/ 980368 w 1552097"/>
                <a:gd name="connsiteY109" fmla="*/ 993196 h 1383511"/>
                <a:gd name="connsiteX110" fmla="*/ 996861 w 1552097"/>
                <a:gd name="connsiteY110" fmla="*/ 987699 h 1383511"/>
                <a:gd name="connsiteX111" fmla="*/ 1002358 w 1552097"/>
                <a:gd name="connsiteY111" fmla="*/ 985866 h 1383511"/>
                <a:gd name="connsiteX112" fmla="*/ 1009688 w 1552097"/>
                <a:gd name="connsiteY112" fmla="*/ 984034 h 1383511"/>
                <a:gd name="connsiteX113" fmla="*/ 1024348 w 1552097"/>
                <a:gd name="connsiteY113" fmla="*/ 973039 h 1383511"/>
                <a:gd name="connsiteX114" fmla="*/ 1029845 w 1552097"/>
                <a:gd name="connsiteY114" fmla="*/ 969374 h 1383511"/>
                <a:gd name="connsiteX115" fmla="*/ 1039007 w 1552097"/>
                <a:gd name="connsiteY115" fmla="*/ 965709 h 1383511"/>
                <a:gd name="connsiteX116" fmla="*/ 1053667 w 1552097"/>
                <a:gd name="connsiteY116" fmla="*/ 960212 h 1383511"/>
                <a:gd name="connsiteX117" fmla="*/ 1062829 w 1552097"/>
                <a:gd name="connsiteY117" fmla="*/ 956547 h 1383511"/>
                <a:gd name="connsiteX118" fmla="*/ 1073824 w 1552097"/>
                <a:gd name="connsiteY118" fmla="*/ 952882 h 1383511"/>
                <a:gd name="connsiteX119" fmla="*/ 1081154 w 1552097"/>
                <a:gd name="connsiteY119" fmla="*/ 947384 h 1383511"/>
                <a:gd name="connsiteX120" fmla="*/ 1086651 w 1552097"/>
                <a:gd name="connsiteY120" fmla="*/ 943719 h 1383511"/>
                <a:gd name="connsiteX121" fmla="*/ 1092149 w 1552097"/>
                <a:gd name="connsiteY121" fmla="*/ 925395 h 1383511"/>
                <a:gd name="connsiteX122" fmla="*/ 1097646 w 1552097"/>
                <a:gd name="connsiteY122" fmla="*/ 912568 h 1383511"/>
                <a:gd name="connsiteX123" fmla="*/ 1101311 w 1552097"/>
                <a:gd name="connsiteY123" fmla="*/ 894243 h 1383511"/>
                <a:gd name="connsiteX124" fmla="*/ 1104976 w 1552097"/>
                <a:gd name="connsiteY124" fmla="*/ 888745 h 1383511"/>
                <a:gd name="connsiteX125" fmla="*/ 1110473 w 1552097"/>
                <a:gd name="connsiteY125" fmla="*/ 875918 h 1383511"/>
                <a:gd name="connsiteX126" fmla="*/ 1112306 w 1552097"/>
                <a:gd name="connsiteY126" fmla="*/ 870421 h 1383511"/>
                <a:gd name="connsiteX127" fmla="*/ 1119636 w 1552097"/>
                <a:gd name="connsiteY127" fmla="*/ 866756 h 1383511"/>
                <a:gd name="connsiteX128" fmla="*/ 1132463 w 1552097"/>
                <a:gd name="connsiteY128" fmla="*/ 852096 h 1383511"/>
                <a:gd name="connsiteX129" fmla="*/ 1134295 w 1552097"/>
                <a:gd name="connsiteY129" fmla="*/ 846599 h 1383511"/>
                <a:gd name="connsiteX130" fmla="*/ 1139793 w 1552097"/>
                <a:gd name="connsiteY130" fmla="*/ 842934 h 1383511"/>
                <a:gd name="connsiteX131" fmla="*/ 1143458 w 1552097"/>
                <a:gd name="connsiteY131" fmla="*/ 837436 h 1383511"/>
                <a:gd name="connsiteX132" fmla="*/ 1152620 w 1552097"/>
                <a:gd name="connsiteY132" fmla="*/ 822777 h 1383511"/>
                <a:gd name="connsiteX133" fmla="*/ 1154453 w 1552097"/>
                <a:gd name="connsiteY133" fmla="*/ 817279 h 1383511"/>
                <a:gd name="connsiteX134" fmla="*/ 1158118 w 1552097"/>
                <a:gd name="connsiteY134" fmla="*/ 804452 h 1383511"/>
                <a:gd name="connsiteX135" fmla="*/ 1163615 w 1552097"/>
                <a:gd name="connsiteY135" fmla="*/ 800787 h 1383511"/>
                <a:gd name="connsiteX136" fmla="*/ 1170945 w 1552097"/>
                <a:gd name="connsiteY136" fmla="*/ 789792 h 1383511"/>
                <a:gd name="connsiteX137" fmla="*/ 1183772 w 1552097"/>
                <a:gd name="connsiteY137" fmla="*/ 775133 h 1383511"/>
                <a:gd name="connsiteX138" fmla="*/ 1189269 w 1552097"/>
                <a:gd name="connsiteY138" fmla="*/ 762305 h 1383511"/>
                <a:gd name="connsiteX139" fmla="*/ 1192934 w 1552097"/>
                <a:gd name="connsiteY139" fmla="*/ 756808 h 1383511"/>
                <a:gd name="connsiteX140" fmla="*/ 1203929 w 1552097"/>
                <a:gd name="connsiteY140" fmla="*/ 745813 h 1383511"/>
                <a:gd name="connsiteX141" fmla="*/ 1207594 w 1552097"/>
                <a:gd name="connsiteY141" fmla="*/ 740316 h 1383511"/>
                <a:gd name="connsiteX142" fmla="*/ 1213091 w 1552097"/>
                <a:gd name="connsiteY142" fmla="*/ 734818 h 1383511"/>
                <a:gd name="connsiteX143" fmla="*/ 1216756 w 1552097"/>
                <a:gd name="connsiteY143" fmla="*/ 727489 h 1383511"/>
                <a:gd name="connsiteX144" fmla="*/ 1220421 w 1552097"/>
                <a:gd name="connsiteY144" fmla="*/ 721991 h 1383511"/>
                <a:gd name="connsiteX145" fmla="*/ 1225919 w 1552097"/>
                <a:gd name="connsiteY145" fmla="*/ 714661 h 1383511"/>
                <a:gd name="connsiteX146" fmla="*/ 1229584 w 1552097"/>
                <a:gd name="connsiteY146" fmla="*/ 707331 h 1383511"/>
                <a:gd name="connsiteX147" fmla="*/ 1235081 w 1552097"/>
                <a:gd name="connsiteY147" fmla="*/ 705499 h 1383511"/>
                <a:gd name="connsiteX148" fmla="*/ 1247908 w 1552097"/>
                <a:gd name="connsiteY148" fmla="*/ 700002 h 1383511"/>
                <a:gd name="connsiteX149" fmla="*/ 1253406 w 1552097"/>
                <a:gd name="connsiteY149" fmla="*/ 696337 h 1383511"/>
                <a:gd name="connsiteX150" fmla="*/ 1258903 w 1552097"/>
                <a:gd name="connsiteY150" fmla="*/ 694504 h 1383511"/>
                <a:gd name="connsiteX151" fmla="*/ 1266233 w 1552097"/>
                <a:gd name="connsiteY151" fmla="*/ 690839 h 1383511"/>
                <a:gd name="connsiteX152" fmla="*/ 1271730 w 1552097"/>
                <a:gd name="connsiteY152" fmla="*/ 687174 h 1383511"/>
                <a:gd name="connsiteX153" fmla="*/ 1279060 w 1552097"/>
                <a:gd name="connsiteY153" fmla="*/ 685342 h 1383511"/>
                <a:gd name="connsiteX154" fmla="*/ 1286390 w 1552097"/>
                <a:gd name="connsiteY154" fmla="*/ 681677 h 1383511"/>
                <a:gd name="connsiteX155" fmla="*/ 1299217 w 1552097"/>
                <a:gd name="connsiteY155" fmla="*/ 672515 h 1383511"/>
                <a:gd name="connsiteX156" fmla="*/ 1304715 w 1552097"/>
                <a:gd name="connsiteY156" fmla="*/ 670682 h 1383511"/>
                <a:gd name="connsiteX157" fmla="*/ 1315710 w 1552097"/>
                <a:gd name="connsiteY157" fmla="*/ 663352 h 1383511"/>
                <a:gd name="connsiteX158" fmla="*/ 1323039 w 1552097"/>
                <a:gd name="connsiteY158" fmla="*/ 659687 h 1383511"/>
                <a:gd name="connsiteX159" fmla="*/ 1326704 w 1552097"/>
                <a:gd name="connsiteY159" fmla="*/ 654190 h 1383511"/>
                <a:gd name="connsiteX160" fmla="*/ 1334034 w 1552097"/>
                <a:gd name="connsiteY160" fmla="*/ 645028 h 1383511"/>
                <a:gd name="connsiteX161" fmla="*/ 1337699 w 1552097"/>
                <a:gd name="connsiteY161" fmla="*/ 630368 h 1383511"/>
                <a:gd name="connsiteX162" fmla="*/ 1345029 w 1552097"/>
                <a:gd name="connsiteY162" fmla="*/ 617541 h 1383511"/>
                <a:gd name="connsiteX163" fmla="*/ 1352359 w 1552097"/>
                <a:gd name="connsiteY163" fmla="*/ 599216 h 1383511"/>
                <a:gd name="connsiteX164" fmla="*/ 1354191 w 1552097"/>
                <a:gd name="connsiteY164" fmla="*/ 591886 h 1383511"/>
                <a:gd name="connsiteX165" fmla="*/ 1367019 w 1552097"/>
                <a:gd name="connsiteY165" fmla="*/ 579059 h 1383511"/>
                <a:gd name="connsiteX166" fmla="*/ 1378013 w 1552097"/>
                <a:gd name="connsiteY166" fmla="*/ 568064 h 1383511"/>
                <a:gd name="connsiteX167" fmla="*/ 1383511 w 1552097"/>
                <a:gd name="connsiteY167" fmla="*/ 562567 h 1383511"/>
                <a:gd name="connsiteX168" fmla="*/ 1390841 w 1552097"/>
                <a:gd name="connsiteY168" fmla="*/ 551572 h 1383511"/>
                <a:gd name="connsiteX169" fmla="*/ 1392673 w 1552097"/>
                <a:gd name="connsiteY169" fmla="*/ 544242 h 1383511"/>
                <a:gd name="connsiteX170" fmla="*/ 1400003 w 1552097"/>
                <a:gd name="connsiteY170" fmla="*/ 535080 h 1383511"/>
                <a:gd name="connsiteX171" fmla="*/ 1403668 w 1552097"/>
                <a:gd name="connsiteY171" fmla="*/ 529582 h 1383511"/>
                <a:gd name="connsiteX172" fmla="*/ 1407333 w 1552097"/>
                <a:gd name="connsiteY172" fmla="*/ 522252 h 1383511"/>
                <a:gd name="connsiteX173" fmla="*/ 1412830 w 1552097"/>
                <a:gd name="connsiteY173" fmla="*/ 520420 h 1383511"/>
                <a:gd name="connsiteX174" fmla="*/ 1421992 w 1552097"/>
                <a:gd name="connsiteY174" fmla="*/ 514923 h 1383511"/>
                <a:gd name="connsiteX175" fmla="*/ 1427490 w 1552097"/>
                <a:gd name="connsiteY175" fmla="*/ 509425 h 1383511"/>
                <a:gd name="connsiteX176" fmla="*/ 1432987 w 1552097"/>
                <a:gd name="connsiteY176" fmla="*/ 505760 h 1383511"/>
                <a:gd name="connsiteX177" fmla="*/ 1438485 w 1552097"/>
                <a:gd name="connsiteY177" fmla="*/ 500263 h 1383511"/>
                <a:gd name="connsiteX178" fmla="*/ 1443982 w 1552097"/>
                <a:gd name="connsiteY178" fmla="*/ 496598 h 1383511"/>
                <a:gd name="connsiteX179" fmla="*/ 1453144 w 1552097"/>
                <a:gd name="connsiteY179" fmla="*/ 483771 h 1383511"/>
                <a:gd name="connsiteX180" fmla="*/ 1454977 w 1552097"/>
                <a:gd name="connsiteY180" fmla="*/ 478273 h 1383511"/>
                <a:gd name="connsiteX181" fmla="*/ 1458642 w 1552097"/>
                <a:gd name="connsiteY181" fmla="*/ 465446 h 1383511"/>
                <a:gd name="connsiteX182" fmla="*/ 1464139 w 1552097"/>
                <a:gd name="connsiteY182" fmla="*/ 448954 h 1383511"/>
                <a:gd name="connsiteX183" fmla="*/ 1467804 w 1552097"/>
                <a:gd name="connsiteY183" fmla="*/ 423299 h 1383511"/>
                <a:gd name="connsiteX184" fmla="*/ 1475134 w 1552097"/>
                <a:gd name="connsiteY184" fmla="*/ 408640 h 1383511"/>
                <a:gd name="connsiteX185" fmla="*/ 1480631 w 1552097"/>
                <a:gd name="connsiteY185" fmla="*/ 390315 h 1383511"/>
                <a:gd name="connsiteX186" fmla="*/ 1482464 w 1552097"/>
                <a:gd name="connsiteY186" fmla="*/ 381153 h 1383511"/>
                <a:gd name="connsiteX187" fmla="*/ 1484296 w 1552097"/>
                <a:gd name="connsiteY187" fmla="*/ 324346 h 1383511"/>
                <a:gd name="connsiteX188" fmla="*/ 1487961 w 1552097"/>
                <a:gd name="connsiteY188" fmla="*/ 309687 h 1383511"/>
                <a:gd name="connsiteX189" fmla="*/ 1491626 w 1552097"/>
                <a:gd name="connsiteY189" fmla="*/ 304189 h 1383511"/>
                <a:gd name="connsiteX190" fmla="*/ 1497124 w 1552097"/>
                <a:gd name="connsiteY190" fmla="*/ 291362 h 1383511"/>
                <a:gd name="connsiteX191" fmla="*/ 1500788 w 1552097"/>
                <a:gd name="connsiteY191" fmla="*/ 280367 h 1383511"/>
                <a:gd name="connsiteX192" fmla="*/ 1504453 w 1552097"/>
                <a:gd name="connsiteY192" fmla="*/ 271205 h 1383511"/>
                <a:gd name="connsiteX193" fmla="*/ 1508118 w 1552097"/>
                <a:gd name="connsiteY193" fmla="*/ 265707 h 1383511"/>
                <a:gd name="connsiteX194" fmla="*/ 1497124 w 1552097"/>
                <a:gd name="connsiteY194" fmla="*/ 271205 h 1383511"/>
                <a:gd name="connsiteX195" fmla="*/ 1487961 w 1552097"/>
                <a:gd name="connsiteY195" fmla="*/ 278535 h 1383511"/>
                <a:gd name="connsiteX196" fmla="*/ 1484296 w 1552097"/>
                <a:gd name="connsiteY196" fmla="*/ 284032 h 1383511"/>
                <a:gd name="connsiteX197" fmla="*/ 1478799 w 1552097"/>
                <a:gd name="connsiteY197" fmla="*/ 285865 h 1383511"/>
                <a:gd name="connsiteX198" fmla="*/ 1473301 w 1552097"/>
                <a:gd name="connsiteY198" fmla="*/ 289529 h 1383511"/>
                <a:gd name="connsiteX199" fmla="*/ 1458642 w 1552097"/>
                <a:gd name="connsiteY199" fmla="*/ 293194 h 1383511"/>
                <a:gd name="connsiteX200" fmla="*/ 1440317 w 1552097"/>
                <a:gd name="connsiteY200" fmla="*/ 291362 h 1383511"/>
                <a:gd name="connsiteX201" fmla="*/ 1421992 w 1552097"/>
                <a:gd name="connsiteY201" fmla="*/ 285865 h 1383511"/>
                <a:gd name="connsiteX202" fmla="*/ 1398170 w 1552097"/>
                <a:gd name="connsiteY202" fmla="*/ 282200 h 1383511"/>
                <a:gd name="connsiteX203" fmla="*/ 1385343 w 1552097"/>
                <a:gd name="connsiteY203" fmla="*/ 276702 h 1383511"/>
                <a:gd name="connsiteX204" fmla="*/ 1383511 w 1552097"/>
                <a:gd name="connsiteY204" fmla="*/ 271205 h 1383511"/>
                <a:gd name="connsiteX205" fmla="*/ 1385343 w 1552097"/>
                <a:gd name="connsiteY205" fmla="*/ 225393 h 1383511"/>
                <a:gd name="connsiteX206" fmla="*/ 1390841 w 1552097"/>
                <a:gd name="connsiteY206" fmla="*/ 221728 h 1383511"/>
                <a:gd name="connsiteX207" fmla="*/ 1394506 w 1552097"/>
                <a:gd name="connsiteY207" fmla="*/ 216231 h 1383511"/>
                <a:gd name="connsiteX208" fmla="*/ 1414663 w 1552097"/>
                <a:gd name="connsiteY208" fmla="*/ 212566 h 1383511"/>
                <a:gd name="connsiteX209" fmla="*/ 1420160 w 1552097"/>
                <a:gd name="connsiteY209" fmla="*/ 210733 h 1383511"/>
                <a:gd name="connsiteX210" fmla="*/ 1432987 w 1552097"/>
                <a:gd name="connsiteY210" fmla="*/ 197906 h 1383511"/>
                <a:gd name="connsiteX211" fmla="*/ 1451312 w 1552097"/>
                <a:gd name="connsiteY211" fmla="*/ 192409 h 1383511"/>
                <a:gd name="connsiteX212" fmla="*/ 1462307 w 1552097"/>
                <a:gd name="connsiteY212" fmla="*/ 183246 h 1383511"/>
                <a:gd name="connsiteX213" fmla="*/ 1469637 w 1552097"/>
                <a:gd name="connsiteY213" fmla="*/ 181414 h 1383511"/>
                <a:gd name="connsiteX214" fmla="*/ 1486129 w 1552097"/>
                <a:gd name="connsiteY214" fmla="*/ 175917 h 1383511"/>
                <a:gd name="connsiteX215" fmla="*/ 1491626 w 1552097"/>
                <a:gd name="connsiteY215" fmla="*/ 174084 h 1383511"/>
                <a:gd name="connsiteX216" fmla="*/ 1509951 w 1552097"/>
                <a:gd name="connsiteY216" fmla="*/ 170419 h 1383511"/>
                <a:gd name="connsiteX217" fmla="*/ 1515448 w 1552097"/>
                <a:gd name="connsiteY217" fmla="*/ 166754 h 1383511"/>
                <a:gd name="connsiteX218" fmla="*/ 1531940 w 1552097"/>
                <a:gd name="connsiteY218" fmla="*/ 153927 h 1383511"/>
                <a:gd name="connsiteX219" fmla="*/ 1539270 w 1552097"/>
                <a:gd name="connsiteY219" fmla="*/ 150262 h 1383511"/>
                <a:gd name="connsiteX220" fmla="*/ 1544768 w 1552097"/>
                <a:gd name="connsiteY220" fmla="*/ 142932 h 1383511"/>
                <a:gd name="connsiteX221" fmla="*/ 1550265 w 1552097"/>
                <a:gd name="connsiteY221" fmla="*/ 139267 h 1383511"/>
                <a:gd name="connsiteX222" fmla="*/ 1552097 w 1552097"/>
                <a:gd name="connsiteY222" fmla="*/ 131937 h 1383511"/>
                <a:gd name="connsiteX223" fmla="*/ 1548433 w 1552097"/>
                <a:gd name="connsiteY223" fmla="*/ 115445 h 1383511"/>
                <a:gd name="connsiteX224" fmla="*/ 1546600 w 1552097"/>
                <a:gd name="connsiteY224" fmla="*/ 102618 h 1383511"/>
                <a:gd name="connsiteX225" fmla="*/ 1541103 w 1552097"/>
                <a:gd name="connsiteY225" fmla="*/ 97121 h 1383511"/>
                <a:gd name="connsiteX226" fmla="*/ 1537438 w 1552097"/>
                <a:gd name="connsiteY226" fmla="*/ 89791 h 1383511"/>
                <a:gd name="connsiteX227" fmla="*/ 1530108 w 1552097"/>
                <a:gd name="connsiteY227" fmla="*/ 78796 h 1383511"/>
                <a:gd name="connsiteX228" fmla="*/ 1526443 w 1552097"/>
                <a:gd name="connsiteY228" fmla="*/ 71466 h 1383511"/>
                <a:gd name="connsiteX229" fmla="*/ 1519113 w 1552097"/>
                <a:gd name="connsiteY229" fmla="*/ 60471 h 1383511"/>
                <a:gd name="connsiteX230" fmla="*/ 1517281 w 1552097"/>
                <a:gd name="connsiteY230" fmla="*/ 54974 h 1383511"/>
                <a:gd name="connsiteX231" fmla="*/ 1515448 w 1552097"/>
                <a:gd name="connsiteY231" fmla="*/ 43979 h 1383511"/>
                <a:gd name="connsiteX232" fmla="*/ 1509951 w 1552097"/>
                <a:gd name="connsiteY232" fmla="*/ 31152 h 1383511"/>
                <a:gd name="connsiteX233" fmla="*/ 1508118 w 1552097"/>
                <a:gd name="connsiteY233" fmla="*/ 25654 h 1383511"/>
                <a:gd name="connsiteX234" fmla="*/ 1508118 w 1552097"/>
                <a:gd name="connsiteY234" fmla="*/ 0 h 13835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</a:cxnLst>
              <a:rect l="l" t="t" r="r" b="b"/>
              <a:pathLst>
                <a:path w="1552097" h="1383511">
                  <a:moveTo>
                    <a:pt x="152094" y="1075657"/>
                  </a:moveTo>
                  <a:cubicBezTo>
                    <a:pt x="155148" y="1076268"/>
                    <a:pt x="158302" y="1076504"/>
                    <a:pt x="161257" y="1077489"/>
                  </a:cubicBezTo>
                  <a:cubicBezTo>
                    <a:pt x="165903" y="1079038"/>
                    <a:pt x="170065" y="1082140"/>
                    <a:pt x="174084" y="1084819"/>
                  </a:cubicBezTo>
                  <a:cubicBezTo>
                    <a:pt x="175306" y="1086652"/>
                    <a:pt x="176192" y="1088759"/>
                    <a:pt x="177749" y="1090317"/>
                  </a:cubicBezTo>
                  <a:cubicBezTo>
                    <a:pt x="179306" y="1091874"/>
                    <a:pt x="181870" y="1092262"/>
                    <a:pt x="183246" y="1093982"/>
                  </a:cubicBezTo>
                  <a:cubicBezTo>
                    <a:pt x="184453" y="1095490"/>
                    <a:pt x="184468" y="1097647"/>
                    <a:pt x="185079" y="1099479"/>
                  </a:cubicBezTo>
                  <a:cubicBezTo>
                    <a:pt x="183857" y="1104976"/>
                    <a:pt x="183195" y="1110629"/>
                    <a:pt x="181414" y="1115971"/>
                  </a:cubicBezTo>
                  <a:cubicBezTo>
                    <a:pt x="179580" y="1121472"/>
                    <a:pt x="176529" y="1122077"/>
                    <a:pt x="172251" y="1125133"/>
                  </a:cubicBezTo>
                  <a:cubicBezTo>
                    <a:pt x="169766" y="1126908"/>
                    <a:pt x="167512" y="1129012"/>
                    <a:pt x="164922" y="1130631"/>
                  </a:cubicBezTo>
                  <a:cubicBezTo>
                    <a:pt x="162606" y="1132079"/>
                    <a:pt x="159725" y="1132590"/>
                    <a:pt x="157592" y="1134296"/>
                  </a:cubicBezTo>
                  <a:cubicBezTo>
                    <a:pt x="126245" y="1159373"/>
                    <a:pt x="158896" y="1137095"/>
                    <a:pt x="141099" y="1148955"/>
                  </a:cubicBezTo>
                  <a:cubicBezTo>
                    <a:pt x="139878" y="1150788"/>
                    <a:pt x="138992" y="1152896"/>
                    <a:pt x="137435" y="1154453"/>
                  </a:cubicBezTo>
                  <a:cubicBezTo>
                    <a:pt x="132717" y="1159171"/>
                    <a:pt x="129329" y="1158639"/>
                    <a:pt x="122775" y="1159950"/>
                  </a:cubicBezTo>
                  <a:cubicBezTo>
                    <a:pt x="120332" y="1161172"/>
                    <a:pt x="117544" y="1161866"/>
                    <a:pt x="115445" y="1163615"/>
                  </a:cubicBezTo>
                  <a:cubicBezTo>
                    <a:pt x="104394" y="1172825"/>
                    <a:pt x="119407" y="1166571"/>
                    <a:pt x="106283" y="1170945"/>
                  </a:cubicBezTo>
                  <a:cubicBezTo>
                    <a:pt x="90102" y="1181731"/>
                    <a:pt x="115974" y="1165181"/>
                    <a:pt x="89790" y="1178275"/>
                  </a:cubicBezTo>
                  <a:cubicBezTo>
                    <a:pt x="87347" y="1179497"/>
                    <a:pt x="84833" y="1180585"/>
                    <a:pt x="82461" y="1181940"/>
                  </a:cubicBezTo>
                  <a:cubicBezTo>
                    <a:pt x="80549" y="1183033"/>
                    <a:pt x="79100" y="1185071"/>
                    <a:pt x="76963" y="1185605"/>
                  </a:cubicBezTo>
                  <a:cubicBezTo>
                    <a:pt x="71597" y="1186946"/>
                    <a:pt x="65968" y="1186826"/>
                    <a:pt x="60471" y="1187437"/>
                  </a:cubicBezTo>
                  <a:cubicBezTo>
                    <a:pt x="57417" y="1188659"/>
                    <a:pt x="54500" y="1190304"/>
                    <a:pt x="51309" y="1191102"/>
                  </a:cubicBezTo>
                  <a:cubicBezTo>
                    <a:pt x="47119" y="1192150"/>
                    <a:pt x="42742" y="1192225"/>
                    <a:pt x="38481" y="1192935"/>
                  </a:cubicBezTo>
                  <a:cubicBezTo>
                    <a:pt x="35409" y="1193447"/>
                    <a:pt x="32373" y="1194156"/>
                    <a:pt x="29319" y="1194767"/>
                  </a:cubicBezTo>
                  <a:cubicBezTo>
                    <a:pt x="27487" y="1197210"/>
                    <a:pt x="24563" y="1199134"/>
                    <a:pt x="23822" y="1202097"/>
                  </a:cubicBezTo>
                  <a:cubicBezTo>
                    <a:pt x="22131" y="1208860"/>
                    <a:pt x="27106" y="1210395"/>
                    <a:pt x="31152" y="1213092"/>
                  </a:cubicBezTo>
                  <a:cubicBezTo>
                    <a:pt x="37211" y="1231272"/>
                    <a:pt x="27046" y="1203504"/>
                    <a:pt x="38481" y="1224087"/>
                  </a:cubicBezTo>
                  <a:cubicBezTo>
                    <a:pt x="40357" y="1227464"/>
                    <a:pt x="42146" y="1235081"/>
                    <a:pt x="42146" y="1235081"/>
                  </a:cubicBezTo>
                  <a:cubicBezTo>
                    <a:pt x="41535" y="1240579"/>
                    <a:pt x="42174" y="1246365"/>
                    <a:pt x="40314" y="1251574"/>
                  </a:cubicBezTo>
                  <a:cubicBezTo>
                    <a:pt x="37724" y="1258826"/>
                    <a:pt x="32794" y="1260610"/>
                    <a:pt x="27487" y="1264401"/>
                  </a:cubicBezTo>
                  <a:cubicBezTo>
                    <a:pt x="25002" y="1266176"/>
                    <a:pt x="22476" y="1267910"/>
                    <a:pt x="20157" y="1269898"/>
                  </a:cubicBezTo>
                  <a:cubicBezTo>
                    <a:pt x="14798" y="1274492"/>
                    <a:pt x="13507" y="1276932"/>
                    <a:pt x="9162" y="1282725"/>
                  </a:cubicBezTo>
                  <a:cubicBezTo>
                    <a:pt x="3273" y="1300400"/>
                    <a:pt x="12710" y="1272941"/>
                    <a:pt x="3665" y="1295553"/>
                  </a:cubicBezTo>
                  <a:cubicBezTo>
                    <a:pt x="2230" y="1299140"/>
                    <a:pt x="0" y="1306547"/>
                    <a:pt x="0" y="1306547"/>
                  </a:cubicBezTo>
                  <a:cubicBezTo>
                    <a:pt x="1222" y="1313877"/>
                    <a:pt x="1449" y="1321444"/>
                    <a:pt x="3665" y="1328537"/>
                  </a:cubicBezTo>
                  <a:cubicBezTo>
                    <a:pt x="4384" y="1330839"/>
                    <a:pt x="12375" y="1339733"/>
                    <a:pt x="14659" y="1341364"/>
                  </a:cubicBezTo>
                  <a:cubicBezTo>
                    <a:pt x="16882" y="1342952"/>
                    <a:pt x="19875" y="1343299"/>
                    <a:pt x="21989" y="1345029"/>
                  </a:cubicBezTo>
                  <a:cubicBezTo>
                    <a:pt x="29450" y="1351133"/>
                    <a:pt x="32307" y="1357517"/>
                    <a:pt x="40314" y="1361521"/>
                  </a:cubicBezTo>
                  <a:cubicBezTo>
                    <a:pt x="42042" y="1362385"/>
                    <a:pt x="43979" y="1362743"/>
                    <a:pt x="45811" y="1363354"/>
                  </a:cubicBezTo>
                  <a:cubicBezTo>
                    <a:pt x="47033" y="1365186"/>
                    <a:pt x="47608" y="1367684"/>
                    <a:pt x="49476" y="1368851"/>
                  </a:cubicBezTo>
                  <a:cubicBezTo>
                    <a:pt x="52752" y="1370898"/>
                    <a:pt x="56806" y="1371294"/>
                    <a:pt x="60471" y="1372516"/>
                  </a:cubicBezTo>
                  <a:cubicBezTo>
                    <a:pt x="74105" y="1377061"/>
                    <a:pt x="64023" y="1374210"/>
                    <a:pt x="91623" y="1376181"/>
                  </a:cubicBezTo>
                  <a:cubicBezTo>
                    <a:pt x="94066" y="1376792"/>
                    <a:pt x="96638" y="1377022"/>
                    <a:pt x="98953" y="1378014"/>
                  </a:cubicBezTo>
                  <a:cubicBezTo>
                    <a:pt x="100977" y="1378882"/>
                    <a:pt x="102361" y="1380983"/>
                    <a:pt x="104450" y="1381679"/>
                  </a:cubicBezTo>
                  <a:cubicBezTo>
                    <a:pt x="107975" y="1382854"/>
                    <a:pt x="111780" y="1382900"/>
                    <a:pt x="115445" y="1383511"/>
                  </a:cubicBezTo>
                  <a:cubicBezTo>
                    <a:pt x="119220" y="1382672"/>
                    <a:pt x="131604" y="1380513"/>
                    <a:pt x="137435" y="1378014"/>
                  </a:cubicBezTo>
                  <a:cubicBezTo>
                    <a:pt x="139946" y="1376938"/>
                    <a:pt x="142321" y="1375571"/>
                    <a:pt x="144764" y="1374349"/>
                  </a:cubicBezTo>
                  <a:cubicBezTo>
                    <a:pt x="146514" y="1369101"/>
                    <a:pt x="146442" y="1366584"/>
                    <a:pt x="152094" y="1363354"/>
                  </a:cubicBezTo>
                  <a:cubicBezTo>
                    <a:pt x="154281" y="1362104"/>
                    <a:pt x="156981" y="1362132"/>
                    <a:pt x="159424" y="1361521"/>
                  </a:cubicBezTo>
                  <a:cubicBezTo>
                    <a:pt x="160646" y="1359689"/>
                    <a:pt x="161532" y="1357581"/>
                    <a:pt x="163089" y="1356024"/>
                  </a:cubicBezTo>
                  <a:cubicBezTo>
                    <a:pt x="165359" y="1353754"/>
                    <a:pt x="172797" y="1348942"/>
                    <a:pt x="175916" y="1346862"/>
                  </a:cubicBezTo>
                  <a:cubicBezTo>
                    <a:pt x="177138" y="1345029"/>
                    <a:pt x="177923" y="1342814"/>
                    <a:pt x="179581" y="1341364"/>
                  </a:cubicBezTo>
                  <a:cubicBezTo>
                    <a:pt x="185480" y="1336202"/>
                    <a:pt x="191206" y="1333719"/>
                    <a:pt x="197906" y="1330370"/>
                  </a:cubicBezTo>
                  <a:cubicBezTo>
                    <a:pt x="200349" y="1327927"/>
                    <a:pt x="202636" y="1325315"/>
                    <a:pt x="205236" y="1323040"/>
                  </a:cubicBezTo>
                  <a:cubicBezTo>
                    <a:pt x="207535" y="1321029"/>
                    <a:pt x="210578" y="1319861"/>
                    <a:pt x="212566" y="1317542"/>
                  </a:cubicBezTo>
                  <a:cubicBezTo>
                    <a:pt x="214344" y="1315468"/>
                    <a:pt x="214299" y="1312144"/>
                    <a:pt x="216231" y="1310212"/>
                  </a:cubicBezTo>
                  <a:cubicBezTo>
                    <a:pt x="218497" y="1307946"/>
                    <a:pt x="225771" y="1305810"/>
                    <a:pt x="229058" y="1304715"/>
                  </a:cubicBezTo>
                  <a:cubicBezTo>
                    <a:pt x="231501" y="1305326"/>
                    <a:pt x="233899" y="1306164"/>
                    <a:pt x="236388" y="1306547"/>
                  </a:cubicBezTo>
                  <a:cubicBezTo>
                    <a:pt x="259182" y="1310054"/>
                    <a:pt x="246102" y="1306121"/>
                    <a:pt x="258377" y="1310212"/>
                  </a:cubicBezTo>
                  <a:cubicBezTo>
                    <a:pt x="260210" y="1311434"/>
                    <a:pt x="261813" y="1313104"/>
                    <a:pt x="263875" y="1313877"/>
                  </a:cubicBezTo>
                  <a:cubicBezTo>
                    <a:pt x="276322" y="1318545"/>
                    <a:pt x="304128" y="1314155"/>
                    <a:pt x="309686" y="1313877"/>
                  </a:cubicBezTo>
                  <a:cubicBezTo>
                    <a:pt x="324206" y="1309037"/>
                    <a:pt x="316870" y="1310847"/>
                    <a:pt x="331676" y="1308380"/>
                  </a:cubicBezTo>
                  <a:cubicBezTo>
                    <a:pt x="332898" y="1306548"/>
                    <a:pt x="333473" y="1304050"/>
                    <a:pt x="335341" y="1302883"/>
                  </a:cubicBezTo>
                  <a:cubicBezTo>
                    <a:pt x="338617" y="1300836"/>
                    <a:pt x="346336" y="1299218"/>
                    <a:pt x="346336" y="1299218"/>
                  </a:cubicBezTo>
                  <a:cubicBezTo>
                    <a:pt x="347503" y="1298284"/>
                    <a:pt x="357714" y="1289681"/>
                    <a:pt x="360995" y="1288223"/>
                  </a:cubicBezTo>
                  <a:cubicBezTo>
                    <a:pt x="364525" y="1286654"/>
                    <a:pt x="368325" y="1285780"/>
                    <a:pt x="371990" y="1284558"/>
                  </a:cubicBezTo>
                  <a:cubicBezTo>
                    <a:pt x="373212" y="1282725"/>
                    <a:pt x="373822" y="1280282"/>
                    <a:pt x="375655" y="1279060"/>
                  </a:cubicBezTo>
                  <a:cubicBezTo>
                    <a:pt x="376763" y="1278321"/>
                    <a:pt x="391946" y="1275436"/>
                    <a:pt x="392147" y="1275396"/>
                  </a:cubicBezTo>
                  <a:cubicBezTo>
                    <a:pt x="393980" y="1273563"/>
                    <a:pt x="395087" y="1270313"/>
                    <a:pt x="397645" y="1269898"/>
                  </a:cubicBezTo>
                  <a:cubicBezTo>
                    <a:pt x="418225" y="1266561"/>
                    <a:pt x="459948" y="1264401"/>
                    <a:pt x="459948" y="1264401"/>
                  </a:cubicBezTo>
                  <a:cubicBezTo>
                    <a:pt x="465168" y="1263357"/>
                    <a:pt x="471274" y="1262286"/>
                    <a:pt x="476441" y="1260736"/>
                  </a:cubicBezTo>
                  <a:cubicBezTo>
                    <a:pt x="480141" y="1259626"/>
                    <a:pt x="483583" y="1257367"/>
                    <a:pt x="487435" y="1257071"/>
                  </a:cubicBezTo>
                  <a:lnTo>
                    <a:pt x="511257" y="1255238"/>
                  </a:lnTo>
                  <a:cubicBezTo>
                    <a:pt x="526916" y="1243495"/>
                    <a:pt x="508769" y="1255457"/>
                    <a:pt x="536912" y="1246076"/>
                  </a:cubicBezTo>
                  <a:cubicBezTo>
                    <a:pt x="551432" y="1241236"/>
                    <a:pt x="544096" y="1243046"/>
                    <a:pt x="558901" y="1240579"/>
                  </a:cubicBezTo>
                  <a:cubicBezTo>
                    <a:pt x="569762" y="1236959"/>
                    <a:pt x="574107" y="1235091"/>
                    <a:pt x="586388" y="1233249"/>
                  </a:cubicBezTo>
                  <a:cubicBezTo>
                    <a:pt x="593060" y="1232248"/>
                    <a:pt x="599832" y="1232087"/>
                    <a:pt x="606546" y="1231416"/>
                  </a:cubicBezTo>
                  <a:cubicBezTo>
                    <a:pt x="612050" y="1230866"/>
                    <a:pt x="617541" y="1230195"/>
                    <a:pt x="623038" y="1229584"/>
                  </a:cubicBezTo>
                  <a:cubicBezTo>
                    <a:pt x="626703" y="1228362"/>
                    <a:pt x="630285" y="1226856"/>
                    <a:pt x="634033" y="1225919"/>
                  </a:cubicBezTo>
                  <a:cubicBezTo>
                    <a:pt x="636476" y="1225308"/>
                    <a:pt x="638973" y="1224883"/>
                    <a:pt x="641362" y="1224087"/>
                  </a:cubicBezTo>
                  <a:cubicBezTo>
                    <a:pt x="659448" y="1218059"/>
                    <a:pt x="641589" y="1222210"/>
                    <a:pt x="659687" y="1218589"/>
                  </a:cubicBezTo>
                  <a:cubicBezTo>
                    <a:pt x="663352" y="1216146"/>
                    <a:pt x="668239" y="1214924"/>
                    <a:pt x="670682" y="1211259"/>
                  </a:cubicBezTo>
                  <a:cubicBezTo>
                    <a:pt x="673125" y="1207594"/>
                    <a:pt x="676376" y="1204355"/>
                    <a:pt x="678012" y="1200265"/>
                  </a:cubicBezTo>
                  <a:cubicBezTo>
                    <a:pt x="682639" y="1188696"/>
                    <a:pt x="679351" y="1193428"/>
                    <a:pt x="687174" y="1185605"/>
                  </a:cubicBezTo>
                  <a:cubicBezTo>
                    <a:pt x="687785" y="1183772"/>
                    <a:pt x="688476" y="1181965"/>
                    <a:pt x="689007" y="1180107"/>
                  </a:cubicBezTo>
                  <a:cubicBezTo>
                    <a:pt x="689699" y="1177686"/>
                    <a:pt x="689590" y="1174964"/>
                    <a:pt x="690839" y="1172778"/>
                  </a:cubicBezTo>
                  <a:cubicBezTo>
                    <a:pt x="692125" y="1170528"/>
                    <a:pt x="694677" y="1169271"/>
                    <a:pt x="696336" y="1167280"/>
                  </a:cubicBezTo>
                  <a:cubicBezTo>
                    <a:pt x="697746" y="1165588"/>
                    <a:pt x="699016" y="1163753"/>
                    <a:pt x="700001" y="1161783"/>
                  </a:cubicBezTo>
                  <a:cubicBezTo>
                    <a:pt x="705698" y="1150388"/>
                    <a:pt x="699773" y="1153917"/>
                    <a:pt x="709164" y="1150788"/>
                  </a:cubicBezTo>
                  <a:cubicBezTo>
                    <a:pt x="718263" y="1137140"/>
                    <a:pt x="706569" y="1153902"/>
                    <a:pt x="718326" y="1139793"/>
                  </a:cubicBezTo>
                  <a:cubicBezTo>
                    <a:pt x="719736" y="1138101"/>
                    <a:pt x="720434" y="1135853"/>
                    <a:pt x="721991" y="1134296"/>
                  </a:cubicBezTo>
                  <a:cubicBezTo>
                    <a:pt x="723548" y="1132739"/>
                    <a:pt x="725796" y="1132041"/>
                    <a:pt x="727488" y="1130631"/>
                  </a:cubicBezTo>
                  <a:cubicBezTo>
                    <a:pt x="738629" y="1121346"/>
                    <a:pt x="726756" y="1128247"/>
                    <a:pt x="740316" y="1121469"/>
                  </a:cubicBezTo>
                  <a:cubicBezTo>
                    <a:pt x="746766" y="1111791"/>
                    <a:pt x="740704" y="1119565"/>
                    <a:pt x="751310" y="1110474"/>
                  </a:cubicBezTo>
                  <a:cubicBezTo>
                    <a:pt x="753278" y="1108787"/>
                    <a:pt x="755149" y="1106967"/>
                    <a:pt x="756808" y="1104976"/>
                  </a:cubicBezTo>
                  <a:cubicBezTo>
                    <a:pt x="758218" y="1103284"/>
                    <a:pt x="758816" y="1100929"/>
                    <a:pt x="760473" y="1099479"/>
                  </a:cubicBezTo>
                  <a:cubicBezTo>
                    <a:pt x="763788" y="1096579"/>
                    <a:pt x="768352" y="1095263"/>
                    <a:pt x="771467" y="1092149"/>
                  </a:cubicBezTo>
                  <a:cubicBezTo>
                    <a:pt x="773300" y="1090317"/>
                    <a:pt x="774856" y="1088158"/>
                    <a:pt x="776965" y="1086652"/>
                  </a:cubicBezTo>
                  <a:cubicBezTo>
                    <a:pt x="779188" y="1085064"/>
                    <a:pt x="781979" y="1084435"/>
                    <a:pt x="784295" y="1082987"/>
                  </a:cubicBezTo>
                  <a:cubicBezTo>
                    <a:pt x="784809" y="1082665"/>
                    <a:pt x="795268" y="1074498"/>
                    <a:pt x="797122" y="1073824"/>
                  </a:cubicBezTo>
                  <a:cubicBezTo>
                    <a:pt x="801856" y="1072103"/>
                    <a:pt x="811782" y="1070159"/>
                    <a:pt x="811782" y="1070159"/>
                  </a:cubicBezTo>
                  <a:cubicBezTo>
                    <a:pt x="813614" y="1068938"/>
                    <a:pt x="815309" y="1067480"/>
                    <a:pt x="817279" y="1066495"/>
                  </a:cubicBezTo>
                  <a:cubicBezTo>
                    <a:pt x="819007" y="1065631"/>
                    <a:pt x="821169" y="1065733"/>
                    <a:pt x="822776" y="1064662"/>
                  </a:cubicBezTo>
                  <a:cubicBezTo>
                    <a:pt x="824932" y="1063224"/>
                    <a:pt x="826283" y="1060824"/>
                    <a:pt x="828274" y="1059165"/>
                  </a:cubicBezTo>
                  <a:cubicBezTo>
                    <a:pt x="833011" y="1055218"/>
                    <a:pt x="833758" y="1055504"/>
                    <a:pt x="839269" y="1053667"/>
                  </a:cubicBezTo>
                  <a:cubicBezTo>
                    <a:pt x="842600" y="1040340"/>
                    <a:pt x="838860" y="1051808"/>
                    <a:pt x="844766" y="1040840"/>
                  </a:cubicBezTo>
                  <a:cubicBezTo>
                    <a:pt x="852302" y="1026845"/>
                    <a:pt x="851168" y="1024820"/>
                    <a:pt x="859426" y="1015186"/>
                  </a:cubicBezTo>
                  <a:cubicBezTo>
                    <a:pt x="861113" y="1013218"/>
                    <a:pt x="862767" y="1011126"/>
                    <a:pt x="864923" y="1009688"/>
                  </a:cubicBezTo>
                  <a:cubicBezTo>
                    <a:pt x="866530" y="1008616"/>
                    <a:pt x="868527" y="1008235"/>
                    <a:pt x="870421" y="1007856"/>
                  </a:cubicBezTo>
                  <a:cubicBezTo>
                    <a:pt x="880760" y="1005788"/>
                    <a:pt x="891343" y="1004915"/>
                    <a:pt x="901572" y="1002358"/>
                  </a:cubicBezTo>
                  <a:cubicBezTo>
                    <a:pt x="924033" y="996744"/>
                    <a:pt x="890701" y="1004699"/>
                    <a:pt x="945552" y="996861"/>
                  </a:cubicBezTo>
                  <a:cubicBezTo>
                    <a:pt x="965660" y="993988"/>
                    <a:pt x="954075" y="995387"/>
                    <a:pt x="980368" y="993196"/>
                  </a:cubicBezTo>
                  <a:cubicBezTo>
                    <a:pt x="989934" y="986819"/>
                    <a:pt x="982046" y="990991"/>
                    <a:pt x="996861" y="987699"/>
                  </a:cubicBezTo>
                  <a:cubicBezTo>
                    <a:pt x="998747" y="987280"/>
                    <a:pt x="1000501" y="986397"/>
                    <a:pt x="1002358" y="985866"/>
                  </a:cubicBezTo>
                  <a:cubicBezTo>
                    <a:pt x="1004780" y="985174"/>
                    <a:pt x="1007245" y="984645"/>
                    <a:pt x="1009688" y="984034"/>
                  </a:cubicBezTo>
                  <a:cubicBezTo>
                    <a:pt x="1018256" y="975464"/>
                    <a:pt x="1012202" y="980630"/>
                    <a:pt x="1024348" y="973039"/>
                  </a:cubicBezTo>
                  <a:cubicBezTo>
                    <a:pt x="1026216" y="971872"/>
                    <a:pt x="1027875" y="970359"/>
                    <a:pt x="1029845" y="969374"/>
                  </a:cubicBezTo>
                  <a:cubicBezTo>
                    <a:pt x="1032787" y="967903"/>
                    <a:pt x="1036065" y="967180"/>
                    <a:pt x="1039007" y="965709"/>
                  </a:cubicBezTo>
                  <a:cubicBezTo>
                    <a:pt x="1051588" y="959418"/>
                    <a:pt x="1035994" y="963746"/>
                    <a:pt x="1053667" y="960212"/>
                  </a:cubicBezTo>
                  <a:cubicBezTo>
                    <a:pt x="1056721" y="958990"/>
                    <a:pt x="1059738" y="957671"/>
                    <a:pt x="1062829" y="956547"/>
                  </a:cubicBezTo>
                  <a:cubicBezTo>
                    <a:pt x="1066460" y="955227"/>
                    <a:pt x="1073824" y="952882"/>
                    <a:pt x="1073824" y="952882"/>
                  </a:cubicBezTo>
                  <a:cubicBezTo>
                    <a:pt x="1076267" y="951049"/>
                    <a:pt x="1078669" y="949159"/>
                    <a:pt x="1081154" y="947384"/>
                  </a:cubicBezTo>
                  <a:cubicBezTo>
                    <a:pt x="1082946" y="946104"/>
                    <a:pt x="1085371" y="945511"/>
                    <a:pt x="1086651" y="943719"/>
                  </a:cubicBezTo>
                  <a:cubicBezTo>
                    <a:pt x="1091428" y="937031"/>
                    <a:pt x="1089713" y="932701"/>
                    <a:pt x="1092149" y="925395"/>
                  </a:cubicBezTo>
                  <a:cubicBezTo>
                    <a:pt x="1095885" y="914188"/>
                    <a:pt x="1095511" y="922176"/>
                    <a:pt x="1097646" y="912568"/>
                  </a:cubicBezTo>
                  <a:cubicBezTo>
                    <a:pt x="1098344" y="909427"/>
                    <a:pt x="1099628" y="898170"/>
                    <a:pt x="1101311" y="894243"/>
                  </a:cubicBezTo>
                  <a:cubicBezTo>
                    <a:pt x="1102179" y="892219"/>
                    <a:pt x="1103754" y="890578"/>
                    <a:pt x="1104976" y="888745"/>
                  </a:cubicBezTo>
                  <a:cubicBezTo>
                    <a:pt x="1108790" y="873494"/>
                    <a:pt x="1104147" y="888571"/>
                    <a:pt x="1110473" y="875918"/>
                  </a:cubicBezTo>
                  <a:cubicBezTo>
                    <a:pt x="1111337" y="874190"/>
                    <a:pt x="1110940" y="871787"/>
                    <a:pt x="1112306" y="870421"/>
                  </a:cubicBezTo>
                  <a:cubicBezTo>
                    <a:pt x="1114238" y="868489"/>
                    <a:pt x="1117480" y="868433"/>
                    <a:pt x="1119636" y="866756"/>
                  </a:cubicBezTo>
                  <a:cubicBezTo>
                    <a:pt x="1127058" y="860984"/>
                    <a:pt x="1128084" y="858665"/>
                    <a:pt x="1132463" y="852096"/>
                  </a:cubicBezTo>
                  <a:cubicBezTo>
                    <a:pt x="1133074" y="850264"/>
                    <a:pt x="1133088" y="848107"/>
                    <a:pt x="1134295" y="846599"/>
                  </a:cubicBezTo>
                  <a:cubicBezTo>
                    <a:pt x="1135671" y="844879"/>
                    <a:pt x="1138236" y="844491"/>
                    <a:pt x="1139793" y="842934"/>
                  </a:cubicBezTo>
                  <a:cubicBezTo>
                    <a:pt x="1141350" y="841377"/>
                    <a:pt x="1142236" y="839269"/>
                    <a:pt x="1143458" y="837436"/>
                  </a:cubicBezTo>
                  <a:cubicBezTo>
                    <a:pt x="1147819" y="824353"/>
                    <a:pt x="1143909" y="828585"/>
                    <a:pt x="1152620" y="822777"/>
                  </a:cubicBezTo>
                  <a:cubicBezTo>
                    <a:pt x="1153231" y="820944"/>
                    <a:pt x="1153898" y="819129"/>
                    <a:pt x="1154453" y="817279"/>
                  </a:cubicBezTo>
                  <a:cubicBezTo>
                    <a:pt x="1155731" y="813020"/>
                    <a:pt x="1155958" y="808339"/>
                    <a:pt x="1158118" y="804452"/>
                  </a:cubicBezTo>
                  <a:cubicBezTo>
                    <a:pt x="1159187" y="802527"/>
                    <a:pt x="1161783" y="802009"/>
                    <a:pt x="1163615" y="800787"/>
                  </a:cubicBezTo>
                  <a:cubicBezTo>
                    <a:pt x="1166058" y="797122"/>
                    <a:pt x="1167830" y="792907"/>
                    <a:pt x="1170945" y="789792"/>
                  </a:cubicBezTo>
                  <a:cubicBezTo>
                    <a:pt x="1179208" y="781529"/>
                    <a:pt x="1174823" y="786318"/>
                    <a:pt x="1183772" y="775133"/>
                  </a:cubicBezTo>
                  <a:cubicBezTo>
                    <a:pt x="1185827" y="768969"/>
                    <a:pt x="1185649" y="768641"/>
                    <a:pt x="1189269" y="762305"/>
                  </a:cubicBezTo>
                  <a:cubicBezTo>
                    <a:pt x="1190362" y="760393"/>
                    <a:pt x="1191471" y="758454"/>
                    <a:pt x="1192934" y="756808"/>
                  </a:cubicBezTo>
                  <a:cubicBezTo>
                    <a:pt x="1196378" y="752934"/>
                    <a:pt x="1201054" y="750125"/>
                    <a:pt x="1203929" y="745813"/>
                  </a:cubicBezTo>
                  <a:cubicBezTo>
                    <a:pt x="1205151" y="743981"/>
                    <a:pt x="1206184" y="742008"/>
                    <a:pt x="1207594" y="740316"/>
                  </a:cubicBezTo>
                  <a:cubicBezTo>
                    <a:pt x="1209253" y="738325"/>
                    <a:pt x="1211585" y="736927"/>
                    <a:pt x="1213091" y="734818"/>
                  </a:cubicBezTo>
                  <a:cubicBezTo>
                    <a:pt x="1214679" y="732595"/>
                    <a:pt x="1215401" y="729861"/>
                    <a:pt x="1216756" y="727489"/>
                  </a:cubicBezTo>
                  <a:cubicBezTo>
                    <a:pt x="1217849" y="725577"/>
                    <a:pt x="1219141" y="723783"/>
                    <a:pt x="1220421" y="721991"/>
                  </a:cubicBezTo>
                  <a:cubicBezTo>
                    <a:pt x="1222196" y="719506"/>
                    <a:pt x="1224300" y="717251"/>
                    <a:pt x="1225919" y="714661"/>
                  </a:cubicBezTo>
                  <a:cubicBezTo>
                    <a:pt x="1227367" y="712345"/>
                    <a:pt x="1227652" y="709263"/>
                    <a:pt x="1229584" y="707331"/>
                  </a:cubicBezTo>
                  <a:cubicBezTo>
                    <a:pt x="1230950" y="705965"/>
                    <a:pt x="1233249" y="706110"/>
                    <a:pt x="1235081" y="705499"/>
                  </a:cubicBezTo>
                  <a:cubicBezTo>
                    <a:pt x="1248879" y="696299"/>
                    <a:pt x="1231345" y="707100"/>
                    <a:pt x="1247908" y="700002"/>
                  </a:cubicBezTo>
                  <a:cubicBezTo>
                    <a:pt x="1249932" y="699134"/>
                    <a:pt x="1251436" y="697322"/>
                    <a:pt x="1253406" y="696337"/>
                  </a:cubicBezTo>
                  <a:cubicBezTo>
                    <a:pt x="1255134" y="695473"/>
                    <a:pt x="1257128" y="695265"/>
                    <a:pt x="1258903" y="694504"/>
                  </a:cubicBezTo>
                  <a:cubicBezTo>
                    <a:pt x="1261414" y="693428"/>
                    <a:pt x="1263861" y="692194"/>
                    <a:pt x="1266233" y="690839"/>
                  </a:cubicBezTo>
                  <a:cubicBezTo>
                    <a:pt x="1268145" y="689746"/>
                    <a:pt x="1269706" y="688041"/>
                    <a:pt x="1271730" y="687174"/>
                  </a:cubicBezTo>
                  <a:cubicBezTo>
                    <a:pt x="1274045" y="686182"/>
                    <a:pt x="1276617" y="685953"/>
                    <a:pt x="1279060" y="685342"/>
                  </a:cubicBezTo>
                  <a:cubicBezTo>
                    <a:pt x="1281503" y="684120"/>
                    <a:pt x="1284073" y="683125"/>
                    <a:pt x="1286390" y="681677"/>
                  </a:cubicBezTo>
                  <a:cubicBezTo>
                    <a:pt x="1289703" y="679606"/>
                    <a:pt x="1295346" y="674451"/>
                    <a:pt x="1299217" y="672515"/>
                  </a:cubicBezTo>
                  <a:cubicBezTo>
                    <a:pt x="1300945" y="671651"/>
                    <a:pt x="1303026" y="671620"/>
                    <a:pt x="1304715" y="670682"/>
                  </a:cubicBezTo>
                  <a:cubicBezTo>
                    <a:pt x="1308565" y="668543"/>
                    <a:pt x="1311933" y="665618"/>
                    <a:pt x="1315710" y="663352"/>
                  </a:cubicBezTo>
                  <a:cubicBezTo>
                    <a:pt x="1318052" y="661947"/>
                    <a:pt x="1320596" y="660909"/>
                    <a:pt x="1323039" y="659687"/>
                  </a:cubicBezTo>
                  <a:cubicBezTo>
                    <a:pt x="1324261" y="657855"/>
                    <a:pt x="1325383" y="655952"/>
                    <a:pt x="1326704" y="654190"/>
                  </a:cubicBezTo>
                  <a:cubicBezTo>
                    <a:pt x="1329051" y="651061"/>
                    <a:pt x="1331961" y="648345"/>
                    <a:pt x="1334034" y="645028"/>
                  </a:cubicBezTo>
                  <a:cubicBezTo>
                    <a:pt x="1335781" y="642233"/>
                    <a:pt x="1337215" y="632303"/>
                    <a:pt x="1337699" y="630368"/>
                  </a:cubicBezTo>
                  <a:cubicBezTo>
                    <a:pt x="1339447" y="623375"/>
                    <a:pt x="1340034" y="624201"/>
                    <a:pt x="1345029" y="617541"/>
                  </a:cubicBezTo>
                  <a:cubicBezTo>
                    <a:pt x="1348876" y="598299"/>
                    <a:pt x="1343753" y="618580"/>
                    <a:pt x="1352359" y="599216"/>
                  </a:cubicBezTo>
                  <a:cubicBezTo>
                    <a:pt x="1353382" y="596915"/>
                    <a:pt x="1353065" y="594139"/>
                    <a:pt x="1354191" y="591886"/>
                  </a:cubicBezTo>
                  <a:cubicBezTo>
                    <a:pt x="1360072" y="580124"/>
                    <a:pt x="1358448" y="581915"/>
                    <a:pt x="1367019" y="579059"/>
                  </a:cubicBezTo>
                  <a:lnTo>
                    <a:pt x="1378013" y="568064"/>
                  </a:lnTo>
                  <a:lnTo>
                    <a:pt x="1383511" y="562567"/>
                  </a:lnTo>
                  <a:cubicBezTo>
                    <a:pt x="1388770" y="541524"/>
                    <a:pt x="1380717" y="566758"/>
                    <a:pt x="1390841" y="551572"/>
                  </a:cubicBezTo>
                  <a:cubicBezTo>
                    <a:pt x="1392238" y="549476"/>
                    <a:pt x="1391450" y="546444"/>
                    <a:pt x="1392673" y="544242"/>
                  </a:cubicBezTo>
                  <a:cubicBezTo>
                    <a:pt x="1394572" y="540823"/>
                    <a:pt x="1397656" y="538209"/>
                    <a:pt x="1400003" y="535080"/>
                  </a:cubicBezTo>
                  <a:cubicBezTo>
                    <a:pt x="1401325" y="533318"/>
                    <a:pt x="1402575" y="531494"/>
                    <a:pt x="1403668" y="529582"/>
                  </a:cubicBezTo>
                  <a:cubicBezTo>
                    <a:pt x="1405023" y="527210"/>
                    <a:pt x="1405401" y="524184"/>
                    <a:pt x="1407333" y="522252"/>
                  </a:cubicBezTo>
                  <a:cubicBezTo>
                    <a:pt x="1408699" y="520886"/>
                    <a:pt x="1411102" y="521284"/>
                    <a:pt x="1412830" y="520420"/>
                  </a:cubicBezTo>
                  <a:cubicBezTo>
                    <a:pt x="1416016" y="518827"/>
                    <a:pt x="1419143" y="517060"/>
                    <a:pt x="1421992" y="514923"/>
                  </a:cubicBezTo>
                  <a:cubicBezTo>
                    <a:pt x="1424065" y="513368"/>
                    <a:pt x="1425499" y="511084"/>
                    <a:pt x="1427490" y="509425"/>
                  </a:cubicBezTo>
                  <a:cubicBezTo>
                    <a:pt x="1429182" y="508015"/>
                    <a:pt x="1431295" y="507170"/>
                    <a:pt x="1432987" y="505760"/>
                  </a:cubicBezTo>
                  <a:cubicBezTo>
                    <a:pt x="1434978" y="504101"/>
                    <a:pt x="1436494" y="501922"/>
                    <a:pt x="1438485" y="500263"/>
                  </a:cubicBezTo>
                  <a:cubicBezTo>
                    <a:pt x="1440177" y="498853"/>
                    <a:pt x="1442425" y="498155"/>
                    <a:pt x="1443982" y="496598"/>
                  </a:cubicBezTo>
                  <a:cubicBezTo>
                    <a:pt x="1444810" y="495770"/>
                    <a:pt x="1452104" y="485850"/>
                    <a:pt x="1453144" y="483771"/>
                  </a:cubicBezTo>
                  <a:cubicBezTo>
                    <a:pt x="1454008" y="482043"/>
                    <a:pt x="1454422" y="480123"/>
                    <a:pt x="1454977" y="478273"/>
                  </a:cubicBezTo>
                  <a:cubicBezTo>
                    <a:pt x="1456255" y="474014"/>
                    <a:pt x="1457316" y="469690"/>
                    <a:pt x="1458642" y="465446"/>
                  </a:cubicBezTo>
                  <a:cubicBezTo>
                    <a:pt x="1460370" y="459915"/>
                    <a:pt x="1464139" y="448954"/>
                    <a:pt x="1464139" y="448954"/>
                  </a:cubicBezTo>
                  <a:cubicBezTo>
                    <a:pt x="1464546" y="445702"/>
                    <a:pt x="1466587" y="427763"/>
                    <a:pt x="1467804" y="423299"/>
                  </a:cubicBezTo>
                  <a:cubicBezTo>
                    <a:pt x="1469873" y="415713"/>
                    <a:pt x="1471261" y="414449"/>
                    <a:pt x="1475134" y="408640"/>
                  </a:cubicBezTo>
                  <a:cubicBezTo>
                    <a:pt x="1477460" y="401661"/>
                    <a:pt x="1478535" y="398698"/>
                    <a:pt x="1480631" y="390315"/>
                  </a:cubicBezTo>
                  <a:cubicBezTo>
                    <a:pt x="1481386" y="387293"/>
                    <a:pt x="1481853" y="384207"/>
                    <a:pt x="1482464" y="381153"/>
                  </a:cubicBezTo>
                  <a:cubicBezTo>
                    <a:pt x="1483075" y="362217"/>
                    <a:pt x="1482843" y="343236"/>
                    <a:pt x="1484296" y="324346"/>
                  </a:cubicBezTo>
                  <a:cubicBezTo>
                    <a:pt x="1484682" y="319324"/>
                    <a:pt x="1485167" y="313878"/>
                    <a:pt x="1487961" y="309687"/>
                  </a:cubicBezTo>
                  <a:lnTo>
                    <a:pt x="1491626" y="304189"/>
                  </a:lnTo>
                  <a:cubicBezTo>
                    <a:pt x="1496477" y="284788"/>
                    <a:pt x="1489890" y="307641"/>
                    <a:pt x="1497124" y="291362"/>
                  </a:cubicBezTo>
                  <a:cubicBezTo>
                    <a:pt x="1498693" y="287832"/>
                    <a:pt x="1499353" y="283954"/>
                    <a:pt x="1500788" y="280367"/>
                  </a:cubicBezTo>
                  <a:cubicBezTo>
                    <a:pt x="1502010" y="277313"/>
                    <a:pt x="1502982" y="274147"/>
                    <a:pt x="1504453" y="271205"/>
                  </a:cubicBezTo>
                  <a:cubicBezTo>
                    <a:pt x="1505438" y="269235"/>
                    <a:pt x="1510321" y="265707"/>
                    <a:pt x="1508118" y="265707"/>
                  </a:cubicBezTo>
                  <a:cubicBezTo>
                    <a:pt x="1504021" y="265707"/>
                    <a:pt x="1500789" y="269372"/>
                    <a:pt x="1497124" y="271205"/>
                  </a:cubicBezTo>
                  <a:cubicBezTo>
                    <a:pt x="1486622" y="286957"/>
                    <a:pt x="1500606" y="268420"/>
                    <a:pt x="1487961" y="278535"/>
                  </a:cubicBezTo>
                  <a:cubicBezTo>
                    <a:pt x="1486241" y="279911"/>
                    <a:pt x="1486016" y="282656"/>
                    <a:pt x="1484296" y="284032"/>
                  </a:cubicBezTo>
                  <a:cubicBezTo>
                    <a:pt x="1482788" y="285239"/>
                    <a:pt x="1480527" y="285001"/>
                    <a:pt x="1478799" y="285865"/>
                  </a:cubicBezTo>
                  <a:cubicBezTo>
                    <a:pt x="1476829" y="286850"/>
                    <a:pt x="1475371" y="288776"/>
                    <a:pt x="1473301" y="289529"/>
                  </a:cubicBezTo>
                  <a:cubicBezTo>
                    <a:pt x="1468567" y="291250"/>
                    <a:pt x="1458642" y="293194"/>
                    <a:pt x="1458642" y="293194"/>
                  </a:cubicBezTo>
                  <a:cubicBezTo>
                    <a:pt x="1452534" y="292583"/>
                    <a:pt x="1446394" y="292230"/>
                    <a:pt x="1440317" y="291362"/>
                  </a:cubicBezTo>
                  <a:cubicBezTo>
                    <a:pt x="1434318" y="290505"/>
                    <a:pt x="1427587" y="287391"/>
                    <a:pt x="1421992" y="285865"/>
                  </a:cubicBezTo>
                  <a:cubicBezTo>
                    <a:pt x="1414880" y="283926"/>
                    <a:pt x="1405043" y="283059"/>
                    <a:pt x="1398170" y="282200"/>
                  </a:cubicBezTo>
                  <a:cubicBezTo>
                    <a:pt x="1394886" y="281105"/>
                    <a:pt x="1387606" y="278965"/>
                    <a:pt x="1385343" y="276702"/>
                  </a:cubicBezTo>
                  <a:cubicBezTo>
                    <a:pt x="1383977" y="275336"/>
                    <a:pt x="1384122" y="273037"/>
                    <a:pt x="1383511" y="271205"/>
                  </a:cubicBezTo>
                  <a:cubicBezTo>
                    <a:pt x="1384122" y="255934"/>
                    <a:pt x="1383103" y="240511"/>
                    <a:pt x="1385343" y="225393"/>
                  </a:cubicBezTo>
                  <a:cubicBezTo>
                    <a:pt x="1385666" y="223214"/>
                    <a:pt x="1389283" y="223285"/>
                    <a:pt x="1390841" y="221728"/>
                  </a:cubicBezTo>
                  <a:cubicBezTo>
                    <a:pt x="1392398" y="220171"/>
                    <a:pt x="1392594" y="217324"/>
                    <a:pt x="1394506" y="216231"/>
                  </a:cubicBezTo>
                  <a:cubicBezTo>
                    <a:pt x="1395564" y="215626"/>
                    <a:pt x="1414610" y="212575"/>
                    <a:pt x="1414663" y="212566"/>
                  </a:cubicBezTo>
                  <a:cubicBezTo>
                    <a:pt x="1416495" y="211955"/>
                    <a:pt x="1418652" y="211940"/>
                    <a:pt x="1420160" y="210733"/>
                  </a:cubicBezTo>
                  <a:cubicBezTo>
                    <a:pt x="1424882" y="206956"/>
                    <a:pt x="1427251" y="199818"/>
                    <a:pt x="1432987" y="197906"/>
                  </a:cubicBezTo>
                  <a:cubicBezTo>
                    <a:pt x="1446371" y="193445"/>
                    <a:pt x="1440234" y="195178"/>
                    <a:pt x="1451312" y="192409"/>
                  </a:cubicBezTo>
                  <a:cubicBezTo>
                    <a:pt x="1454615" y="189105"/>
                    <a:pt x="1457841" y="185160"/>
                    <a:pt x="1462307" y="183246"/>
                  </a:cubicBezTo>
                  <a:cubicBezTo>
                    <a:pt x="1464622" y="182254"/>
                    <a:pt x="1467230" y="182155"/>
                    <a:pt x="1469637" y="181414"/>
                  </a:cubicBezTo>
                  <a:cubicBezTo>
                    <a:pt x="1475175" y="179710"/>
                    <a:pt x="1480632" y="177750"/>
                    <a:pt x="1486129" y="175917"/>
                  </a:cubicBezTo>
                  <a:cubicBezTo>
                    <a:pt x="1487961" y="175306"/>
                    <a:pt x="1489732" y="174463"/>
                    <a:pt x="1491626" y="174084"/>
                  </a:cubicBezTo>
                  <a:lnTo>
                    <a:pt x="1509951" y="170419"/>
                  </a:lnTo>
                  <a:cubicBezTo>
                    <a:pt x="1511783" y="169197"/>
                    <a:pt x="1513686" y="168075"/>
                    <a:pt x="1515448" y="166754"/>
                  </a:cubicBezTo>
                  <a:cubicBezTo>
                    <a:pt x="1521019" y="162575"/>
                    <a:pt x="1525711" y="157042"/>
                    <a:pt x="1531940" y="153927"/>
                  </a:cubicBezTo>
                  <a:lnTo>
                    <a:pt x="1539270" y="150262"/>
                  </a:lnTo>
                  <a:cubicBezTo>
                    <a:pt x="1541103" y="147819"/>
                    <a:pt x="1542608" y="145092"/>
                    <a:pt x="1544768" y="142932"/>
                  </a:cubicBezTo>
                  <a:cubicBezTo>
                    <a:pt x="1546325" y="141375"/>
                    <a:pt x="1549044" y="141099"/>
                    <a:pt x="1550265" y="139267"/>
                  </a:cubicBezTo>
                  <a:cubicBezTo>
                    <a:pt x="1551662" y="137171"/>
                    <a:pt x="1551486" y="134380"/>
                    <a:pt x="1552097" y="131937"/>
                  </a:cubicBezTo>
                  <a:cubicBezTo>
                    <a:pt x="1550876" y="126440"/>
                    <a:pt x="1549471" y="120980"/>
                    <a:pt x="1548433" y="115445"/>
                  </a:cubicBezTo>
                  <a:cubicBezTo>
                    <a:pt x="1547637" y="111200"/>
                    <a:pt x="1548204" y="106628"/>
                    <a:pt x="1546600" y="102618"/>
                  </a:cubicBezTo>
                  <a:cubicBezTo>
                    <a:pt x="1545638" y="100212"/>
                    <a:pt x="1542609" y="99230"/>
                    <a:pt x="1541103" y="97121"/>
                  </a:cubicBezTo>
                  <a:cubicBezTo>
                    <a:pt x="1539515" y="94898"/>
                    <a:pt x="1538843" y="92133"/>
                    <a:pt x="1537438" y="89791"/>
                  </a:cubicBezTo>
                  <a:cubicBezTo>
                    <a:pt x="1535172" y="86014"/>
                    <a:pt x="1532078" y="82736"/>
                    <a:pt x="1530108" y="78796"/>
                  </a:cubicBezTo>
                  <a:cubicBezTo>
                    <a:pt x="1528886" y="76353"/>
                    <a:pt x="1527848" y="73808"/>
                    <a:pt x="1526443" y="71466"/>
                  </a:cubicBezTo>
                  <a:cubicBezTo>
                    <a:pt x="1524177" y="67689"/>
                    <a:pt x="1519113" y="60471"/>
                    <a:pt x="1519113" y="60471"/>
                  </a:cubicBezTo>
                  <a:cubicBezTo>
                    <a:pt x="1518502" y="58639"/>
                    <a:pt x="1517700" y="56859"/>
                    <a:pt x="1517281" y="54974"/>
                  </a:cubicBezTo>
                  <a:cubicBezTo>
                    <a:pt x="1516475" y="51347"/>
                    <a:pt x="1516541" y="47530"/>
                    <a:pt x="1515448" y="43979"/>
                  </a:cubicBezTo>
                  <a:cubicBezTo>
                    <a:pt x="1514080" y="39533"/>
                    <a:pt x="1511679" y="35471"/>
                    <a:pt x="1509951" y="31152"/>
                  </a:cubicBezTo>
                  <a:cubicBezTo>
                    <a:pt x="1509234" y="29358"/>
                    <a:pt x="1508231" y="27582"/>
                    <a:pt x="1508118" y="25654"/>
                  </a:cubicBezTo>
                  <a:cubicBezTo>
                    <a:pt x="1507616" y="17117"/>
                    <a:pt x="1508118" y="8551"/>
                    <a:pt x="1508118" y="0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フリーフォーム: 図形 25">
              <a:extLst>
                <a:ext uri="{FF2B5EF4-FFF2-40B4-BE49-F238E27FC236}">
                  <a16:creationId xmlns:a16="http://schemas.microsoft.com/office/drawing/2014/main" id="{97DA2D63-E471-4338-9DC5-81ACD2BC0688}"/>
                </a:ext>
              </a:extLst>
            </p:cNvPr>
            <p:cNvSpPr/>
            <p:nvPr/>
          </p:nvSpPr>
          <p:spPr>
            <a:xfrm>
              <a:off x="6124098" y="2248434"/>
              <a:ext cx="544263" cy="315184"/>
            </a:xfrm>
            <a:custGeom>
              <a:avLst/>
              <a:gdLst>
                <a:gd name="connsiteX0" fmla="*/ 448954 w 544263"/>
                <a:gd name="connsiteY0" fmla="*/ 0 h 315184"/>
                <a:gd name="connsiteX1" fmla="*/ 437959 w 544263"/>
                <a:gd name="connsiteY1" fmla="*/ 3665 h 315184"/>
                <a:gd name="connsiteX2" fmla="*/ 436126 w 544263"/>
                <a:gd name="connsiteY2" fmla="*/ 9163 h 315184"/>
                <a:gd name="connsiteX3" fmla="*/ 430629 w 544263"/>
                <a:gd name="connsiteY3" fmla="*/ 10995 h 315184"/>
                <a:gd name="connsiteX4" fmla="*/ 425132 w 544263"/>
                <a:gd name="connsiteY4" fmla="*/ 27487 h 315184"/>
                <a:gd name="connsiteX5" fmla="*/ 423299 w 544263"/>
                <a:gd name="connsiteY5" fmla="*/ 43980 h 315184"/>
                <a:gd name="connsiteX6" fmla="*/ 417802 w 544263"/>
                <a:gd name="connsiteY6" fmla="*/ 47645 h 315184"/>
                <a:gd name="connsiteX7" fmla="*/ 406807 w 544263"/>
                <a:gd name="connsiteY7" fmla="*/ 62304 h 315184"/>
                <a:gd name="connsiteX8" fmla="*/ 399477 w 544263"/>
                <a:gd name="connsiteY8" fmla="*/ 75132 h 315184"/>
                <a:gd name="connsiteX9" fmla="*/ 390315 w 544263"/>
                <a:gd name="connsiteY9" fmla="*/ 91624 h 315184"/>
                <a:gd name="connsiteX10" fmla="*/ 386650 w 544263"/>
                <a:gd name="connsiteY10" fmla="*/ 98954 h 315184"/>
                <a:gd name="connsiteX11" fmla="*/ 382985 w 544263"/>
                <a:gd name="connsiteY11" fmla="*/ 104451 h 315184"/>
                <a:gd name="connsiteX12" fmla="*/ 388482 w 544263"/>
                <a:gd name="connsiteY12" fmla="*/ 126441 h 315184"/>
                <a:gd name="connsiteX13" fmla="*/ 397645 w 544263"/>
                <a:gd name="connsiteY13" fmla="*/ 128273 h 315184"/>
                <a:gd name="connsiteX14" fmla="*/ 472776 w 544263"/>
                <a:gd name="connsiteY14" fmla="*/ 126441 h 315184"/>
                <a:gd name="connsiteX15" fmla="*/ 494765 w 544263"/>
                <a:gd name="connsiteY15" fmla="*/ 124608 h 315184"/>
                <a:gd name="connsiteX16" fmla="*/ 500263 w 544263"/>
                <a:gd name="connsiteY16" fmla="*/ 120943 h 315184"/>
                <a:gd name="connsiteX17" fmla="*/ 509425 w 544263"/>
                <a:gd name="connsiteY17" fmla="*/ 119111 h 315184"/>
                <a:gd name="connsiteX18" fmla="*/ 542409 w 544263"/>
                <a:gd name="connsiteY18" fmla="*/ 117278 h 315184"/>
                <a:gd name="connsiteX19" fmla="*/ 540577 w 544263"/>
                <a:gd name="connsiteY19" fmla="*/ 131938 h 315184"/>
                <a:gd name="connsiteX20" fmla="*/ 536912 w 544263"/>
                <a:gd name="connsiteY20" fmla="*/ 142933 h 315184"/>
                <a:gd name="connsiteX21" fmla="*/ 535080 w 544263"/>
                <a:gd name="connsiteY21" fmla="*/ 148430 h 315184"/>
                <a:gd name="connsiteX22" fmla="*/ 529582 w 544263"/>
                <a:gd name="connsiteY22" fmla="*/ 153928 h 315184"/>
                <a:gd name="connsiteX23" fmla="*/ 524085 w 544263"/>
                <a:gd name="connsiteY23" fmla="*/ 164922 h 315184"/>
                <a:gd name="connsiteX24" fmla="*/ 522252 w 544263"/>
                <a:gd name="connsiteY24" fmla="*/ 170420 h 315184"/>
                <a:gd name="connsiteX25" fmla="*/ 516755 w 544263"/>
                <a:gd name="connsiteY25" fmla="*/ 174085 h 315184"/>
                <a:gd name="connsiteX26" fmla="*/ 511258 w 544263"/>
                <a:gd name="connsiteY26" fmla="*/ 179582 h 315184"/>
                <a:gd name="connsiteX27" fmla="*/ 507593 w 544263"/>
                <a:gd name="connsiteY27" fmla="*/ 185079 h 315184"/>
                <a:gd name="connsiteX28" fmla="*/ 491100 w 544263"/>
                <a:gd name="connsiteY28" fmla="*/ 203404 h 315184"/>
                <a:gd name="connsiteX29" fmla="*/ 481938 w 544263"/>
                <a:gd name="connsiteY29" fmla="*/ 218064 h 315184"/>
                <a:gd name="connsiteX30" fmla="*/ 480106 w 544263"/>
                <a:gd name="connsiteY30" fmla="*/ 223561 h 315184"/>
                <a:gd name="connsiteX31" fmla="*/ 472776 w 544263"/>
                <a:gd name="connsiteY31" fmla="*/ 234556 h 315184"/>
                <a:gd name="connsiteX32" fmla="*/ 470943 w 544263"/>
                <a:gd name="connsiteY32" fmla="*/ 241886 h 315184"/>
                <a:gd name="connsiteX33" fmla="*/ 459948 w 544263"/>
                <a:gd name="connsiteY33" fmla="*/ 245551 h 315184"/>
                <a:gd name="connsiteX34" fmla="*/ 454451 w 544263"/>
                <a:gd name="connsiteY34" fmla="*/ 240053 h 315184"/>
                <a:gd name="connsiteX35" fmla="*/ 447121 w 544263"/>
                <a:gd name="connsiteY35" fmla="*/ 229059 h 315184"/>
                <a:gd name="connsiteX36" fmla="*/ 437959 w 544263"/>
                <a:gd name="connsiteY36" fmla="*/ 216231 h 315184"/>
                <a:gd name="connsiteX37" fmla="*/ 436126 w 544263"/>
                <a:gd name="connsiteY37" fmla="*/ 210734 h 315184"/>
                <a:gd name="connsiteX38" fmla="*/ 432462 w 544263"/>
                <a:gd name="connsiteY38" fmla="*/ 205237 h 315184"/>
                <a:gd name="connsiteX39" fmla="*/ 426964 w 544263"/>
                <a:gd name="connsiteY39" fmla="*/ 194242 h 315184"/>
                <a:gd name="connsiteX40" fmla="*/ 419634 w 544263"/>
                <a:gd name="connsiteY40" fmla="*/ 186912 h 315184"/>
                <a:gd name="connsiteX41" fmla="*/ 415969 w 544263"/>
                <a:gd name="connsiteY41" fmla="*/ 192409 h 315184"/>
                <a:gd name="connsiteX42" fmla="*/ 410472 w 544263"/>
                <a:gd name="connsiteY42" fmla="*/ 196074 h 315184"/>
                <a:gd name="connsiteX43" fmla="*/ 399477 w 544263"/>
                <a:gd name="connsiteY43" fmla="*/ 205237 h 315184"/>
                <a:gd name="connsiteX44" fmla="*/ 392147 w 544263"/>
                <a:gd name="connsiteY44" fmla="*/ 207069 h 315184"/>
                <a:gd name="connsiteX45" fmla="*/ 388482 w 544263"/>
                <a:gd name="connsiteY45" fmla="*/ 212566 h 315184"/>
                <a:gd name="connsiteX46" fmla="*/ 379320 w 544263"/>
                <a:gd name="connsiteY46" fmla="*/ 214399 h 315184"/>
                <a:gd name="connsiteX47" fmla="*/ 373823 w 544263"/>
                <a:gd name="connsiteY47" fmla="*/ 216231 h 315184"/>
                <a:gd name="connsiteX48" fmla="*/ 362828 w 544263"/>
                <a:gd name="connsiteY48" fmla="*/ 225394 h 315184"/>
                <a:gd name="connsiteX49" fmla="*/ 357330 w 544263"/>
                <a:gd name="connsiteY49" fmla="*/ 227226 h 315184"/>
                <a:gd name="connsiteX50" fmla="*/ 340838 w 544263"/>
                <a:gd name="connsiteY50" fmla="*/ 236388 h 315184"/>
                <a:gd name="connsiteX51" fmla="*/ 333508 w 544263"/>
                <a:gd name="connsiteY51" fmla="*/ 238221 h 315184"/>
                <a:gd name="connsiteX52" fmla="*/ 328011 w 544263"/>
                <a:gd name="connsiteY52" fmla="*/ 219896 h 315184"/>
                <a:gd name="connsiteX53" fmla="*/ 326179 w 544263"/>
                <a:gd name="connsiteY53" fmla="*/ 214399 h 315184"/>
                <a:gd name="connsiteX54" fmla="*/ 322514 w 544263"/>
                <a:gd name="connsiteY54" fmla="*/ 199739 h 315184"/>
                <a:gd name="connsiteX55" fmla="*/ 320681 w 544263"/>
                <a:gd name="connsiteY55" fmla="*/ 186912 h 315184"/>
                <a:gd name="connsiteX56" fmla="*/ 317016 w 544263"/>
                <a:gd name="connsiteY56" fmla="*/ 170420 h 315184"/>
                <a:gd name="connsiteX57" fmla="*/ 311519 w 544263"/>
                <a:gd name="connsiteY57" fmla="*/ 150263 h 315184"/>
                <a:gd name="connsiteX58" fmla="*/ 309686 w 544263"/>
                <a:gd name="connsiteY58" fmla="*/ 144765 h 315184"/>
                <a:gd name="connsiteX59" fmla="*/ 304189 w 544263"/>
                <a:gd name="connsiteY59" fmla="*/ 141100 h 315184"/>
                <a:gd name="connsiteX60" fmla="*/ 298692 w 544263"/>
                <a:gd name="connsiteY60" fmla="*/ 130105 h 315184"/>
                <a:gd name="connsiteX61" fmla="*/ 295027 w 544263"/>
                <a:gd name="connsiteY61" fmla="*/ 124608 h 315184"/>
                <a:gd name="connsiteX62" fmla="*/ 284032 w 544263"/>
                <a:gd name="connsiteY62" fmla="*/ 111781 h 315184"/>
                <a:gd name="connsiteX63" fmla="*/ 282199 w 544263"/>
                <a:gd name="connsiteY63" fmla="*/ 106283 h 315184"/>
                <a:gd name="connsiteX64" fmla="*/ 271205 w 544263"/>
                <a:gd name="connsiteY64" fmla="*/ 98954 h 315184"/>
                <a:gd name="connsiteX65" fmla="*/ 267540 w 544263"/>
                <a:gd name="connsiteY65" fmla="*/ 93456 h 315184"/>
                <a:gd name="connsiteX66" fmla="*/ 254712 w 544263"/>
                <a:gd name="connsiteY66" fmla="*/ 98954 h 315184"/>
                <a:gd name="connsiteX67" fmla="*/ 243718 w 544263"/>
                <a:gd name="connsiteY67" fmla="*/ 100786 h 315184"/>
                <a:gd name="connsiteX68" fmla="*/ 227225 w 544263"/>
                <a:gd name="connsiteY68" fmla="*/ 106283 h 315184"/>
                <a:gd name="connsiteX69" fmla="*/ 192409 w 544263"/>
                <a:gd name="connsiteY69" fmla="*/ 113613 h 315184"/>
                <a:gd name="connsiteX70" fmla="*/ 197906 w 544263"/>
                <a:gd name="connsiteY70" fmla="*/ 124608 h 315184"/>
                <a:gd name="connsiteX71" fmla="*/ 203403 w 544263"/>
                <a:gd name="connsiteY71" fmla="*/ 128273 h 315184"/>
                <a:gd name="connsiteX72" fmla="*/ 208901 w 544263"/>
                <a:gd name="connsiteY72" fmla="*/ 133770 h 315184"/>
                <a:gd name="connsiteX73" fmla="*/ 208901 w 544263"/>
                <a:gd name="connsiteY73" fmla="*/ 164922 h 315184"/>
                <a:gd name="connsiteX74" fmla="*/ 205236 w 544263"/>
                <a:gd name="connsiteY74" fmla="*/ 170420 h 315184"/>
                <a:gd name="connsiteX75" fmla="*/ 197906 w 544263"/>
                <a:gd name="connsiteY75" fmla="*/ 172252 h 315184"/>
                <a:gd name="connsiteX76" fmla="*/ 185079 w 544263"/>
                <a:gd name="connsiteY76" fmla="*/ 185079 h 315184"/>
                <a:gd name="connsiteX77" fmla="*/ 172251 w 544263"/>
                <a:gd name="connsiteY77" fmla="*/ 190577 h 315184"/>
                <a:gd name="connsiteX78" fmla="*/ 168587 w 544263"/>
                <a:gd name="connsiteY78" fmla="*/ 197907 h 315184"/>
                <a:gd name="connsiteX79" fmla="*/ 152094 w 544263"/>
                <a:gd name="connsiteY79" fmla="*/ 207069 h 315184"/>
                <a:gd name="connsiteX80" fmla="*/ 139267 w 544263"/>
                <a:gd name="connsiteY80" fmla="*/ 216231 h 315184"/>
                <a:gd name="connsiteX81" fmla="*/ 131937 w 544263"/>
                <a:gd name="connsiteY81" fmla="*/ 219896 h 315184"/>
                <a:gd name="connsiteX82" fmla="*/ 128272 w 544263"/>
                <a:gd name="connsiteY82" fmla="*/ 225394 h 315184"/>
                <a:gd name="connsiteX83" fmla="*/ 117278 w 544263"/>
                <a:gd name="connsiteY83" fmla="*/ 230891 h 315184"/>
                <a:gd name="connsiteX84" fmla="*/ 106283 w 544263"/>
                <a:gd name="connsiteY84" fmla="*/ 238221 h 315184"/>
                <a:gd name="connsiteX85" fmla="*/ 97120 w 544263"/>
                <a:gd name="connsiteY85" fmla="*/ 245551 h 315184"/>
                <a:gd name="connsiteX86" fmla="*/ 89791 w 544263"/>
                <a:gd name="connsiteY86" fmla="*/ 247383 h 315184"/>
                <a:gd name="connsiteX87" fmla="*/ 75131 w 544263"/>
                <a:gd name="connsiteY87" fmla="*/ 258378 h 315184"/>
                <a:gd name="connsiteX88" fmla="*/ 67801 w 544263"/>
                <a:gd name="connsiteY88" fmla="*/ 260210 h 315184"/>
                <a:gd name="connsiteX89" fmla="*/ 62304 w 544263"/>
                <a:gd name="connsiteY89" fmla="*/ 263875 h 315184"/>
                <a:gd name="connsiteX90" fmla="*/ 58639 w 544263"/>
                <a:gd name="connsiteY90" fmla="*/ 269373 h 315184"/>
                <a:gd name="connsiteX91" fmla="*/ 47644 w 544263"/>
                <a:gd name="connsiteY91" fmla="*/ 273038 h 315184"/>
                <a:gd name="connsiteX92" fmla="*/ 40314 w 544263"/>
                <a:gd name="connsiteY92" fmla="*/ 278535 h 315184"/>
                <a:gd name="connsiteX93" fmla="*/ 31152 w 544263"/>
                <a:gd name="connsiteY93" fmla="*/ 289530 h 315184"/>
                <a:gd name="connsiteX94" fmla="*/ 23822 w 544263"/>
                <a:gd name="connsiteY94" fmla="*/ 293195 h 315184"/>
                <a:gd name="connsiteX95" fmla="*/ 10995 w 544263"/>
                <a:gd name="connsiteY95" fmla="*/ 302357 h 315184"/>
                <a:gd name="connsiteX96" fmla="*/ 5497 w 544263"/>
                <a:gd name="connsiteY96" fmla="*/ 307855 h 315184"/>
                <a:gd name="connsiteX97" fmla="*/ 0 w 544263"/>
                <a:gd name="connsiteY97" fmla="*/ 315184 h 3151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</a:cxnLst>
              <a:rect l="l" t="t" r="r" b="b"/>
              <a:pathLst>
                <a:path w="544263" h="315184">
                  <a:moveTo>
                    <a:pt x="448954" y="0"/>
                  </a:moveTo>
                  <a:cubicBezTo>
                    <a:pt x="445289" y="1222"/>
                    <a:pt x="441103" y="1420"/>
                    <a:pt x="437959" y="3665"/>
                  </a:cubicBezTo>
                  <a:cubicBezTo>
                    <a:pt x="436387" y="4788"/>
                    <a:pt x="437492" y="7797"/>
                    <a:pt x="436126" y="9163"/>
                  </a:cubicBezTo>
                  <a:cubicBezTo>
                    <a:pt x="434760" y="10529"/>
                    <a:pt x="432461" y="10384"/>
                    <a:pt x="430629" y="10995"/>
                  </a:cubicBezTo>
                  <a:cubicBezTo>
                    <a:pt x="428175" y="17129"/>
                    <a:pt x="426118" y="21075"/>
                    <a:pt x="425132" y="27487"/>
                  </a:cubicBezTo>
                  <a:cubicBezTo>
                    <a:pt x="424291" y="32954"/>
                    <a:pt x="425189" y="38782"/>
                    <a:pt x="423299" y="43980"/>
                  </a:cubicBezTo>
                  <a:cubicBezTo>
                    <a:pt x="422546" y="46050"/>
                    <a:pt x="419359" y="46088"/>
                    <a:pt x="417802" y="47645"/>
                  </a:cubicBezTo>
                  <a:cubicBezTo>
                    <a:pt x="415453" y="49994"/>
                    <a:pt x="409062" y="58357"/>
                    <a:pt x="406807" y="62304"/>
                  </a:cubicBezTo>
                  <a:cubicBezTo>
                    <a:pt x="397502" y="78587"/>
                    <a:pt x="408410" y="61731"/>
                    <a:pt x="399477" y="75132"/>
                  </a:cubicBezTo>
                  <a:cubicBezTo>
                    <a:pt x="391926" y="97784"/>
                    <a:pt x="400601" y="77223"/>
                    <a:pt x="390315" y="91624"/>
                  </a:cubicBezTo>
                  <a:cubicBezTo>
                    <a:pt x="388727" y="93847"/>
                    <a:pt x="388005" y="96582"/>
                    <a:pt x="386650" y="98954"/>
                  </a:cubicBezTo>
                  <a:cubicBezTo>
                    <a:pt x="385557" y="100866"/>
                    <a:pt x="384207" y="102619"/>
                    <a:pt x="382985" y="104451"/>
                  </a:cubicBezTo>
                  <a:cubicBezTo>
                    <a:pt x="383198" y="106365"/>
                    <a:pt x="382491" y="123018"/>
                    <a:pt x="388482" y="126441"/>
                  </a:cubicBezTo>
                  <a:cubicBezTo>
                    <a:pt x="391186" y="127986"/>
                    <a:pt x="394591" y="127662"/>
                    <a:pt x="397645" y="128273"/>
                  </a:cubicBezTo>
                  <a:lnTo>
                    <a:pt x="472776" y="126441"/>
                  </a:lnTo>
                  <a:cubicBezTo>
                    <a:pt x="480126" y="126164"/>
                    <a:pt x="487553" y="126051"/>
                    <a:pt x="494765" y="124608"/>
                  </a:cubicBezTo>
                  <a:cubicBezTo>
                    <a:pt x="496925" y="124176"/>
                    <a:pt x="498201" y="121716"/>
                    <a:pt x="500263" y="120943"/>
                  </a:cubicBezTo>
                  <a:cubicBezTo>
                    <a:pt x="503179" y="119850"/>
                    <a:pt x="506322" y="119381"/>
                    <a:pt x="509425" y="119111"/>
                  </a:cubicBezTo>
                  <a:cubicBezTo>
                    <a:pt x="520395" y="118157"/>
                    <a:pt x="531414" y="117889"/>
                    <a:pt x="542409" y="117278"/>
                  </a:cubicBezTo>
                  <a:cubicBezTo>
                    <a:pt x="545394" y="126232"/>
                    <a:pt x="544769" y="120411"/>
                    <a:pt x="540577" y="131938"/>
                  </a:cubicBezTo>
                  <a:cubicBezTo>
                    <a:pt x="539257" y="135569"/>
                    <a:pt x="538134" y="139268"/>
                    <a:pt x="536912" y="142933"/>
                  </a:cubicBezTo>
                  <a:cubicBezTo>
                    <a:pt x="536301" y="144765"/>
                    <a:pt x="536446" y="147064"/>
                    <a:pt x="535080" y="148430"/>
                  </a:cubicBezTo>
                  <a:lnTo>
                    <a:pt x="529582" y="153928"/>
                  </a:lnTo>
                  <a:cubicBezTo>
                    <a:pt x="524978" y="167741"/>
                    <a:pt x="531188" y="150718"/>
                    <a:pt x="524085" y="164922"/>
                  </a:cubicBezTo>
                  <a:cubicBezTo>
                    <a:pt x="523221" y="166650"/>
                    <a:pt x="523459" y="168911"/>
                    <a:pt x="522252" y="170420"/>
                  </a:cubicBezTo>
                  <a:cubicBezTo>
                    <a:pt x="520876" y="172140"/>
                    <a:pt x="518447" y="172675"/>
                    <a:pt x="516755" y="174085"/>
                  </a:cubicBezTo>
                  <a:cubicBezTo>
                    <a:pt x="514764" y="175744"/>
                    <a:pt x="512917" y="177591"/>
                    <a:pt x="511258" y="179582"/>
                  </a:cubicBezTo>
                  <a:cubicBezTo>
                    <a:pt x="509848" y="181274"/>
                    <a:pt x="509056" y="183433"/>
                    <a:pt x="507593" y="185079"/>
                  </a:cubicBezTo>
                  <a:cubicBezTo>
                    <a:pt x="486544" y="208758"/>
                    <a:pt x="504360" y="185726"/>
                    <a:pt x="491100" y="203404"/>
                  </a:cubicBezTo>
                  <a:cubicBezTo>
                    <a:pt x="487483" y="221491"/>
                    <a:pt x="492922" y="204882"/>
                    <a:pt x="481938" y="218064"/>
                  </a:cubicBezTo>
                  <a:cubicBezTo>
                    <a:pt x="480702" y="219548"/>
                    <a:pt x="481044" y="221873"/>
                    <a:pt x="480106" y="223561"/>
                  </a:cubicBezTo>
                  <a:cubicBezTo>
                    <a:pt x="477967" y="227411"/>
                    <a:pt x="472776" y="234556"/>
                    <a:pt x="472776" y="234556"/>
                  </a:cubicBezTo>
                  <a:cubicBezTo>
                    <a:pt x="472165" y="236999"/>
                    <a:pt x="472855" y="240247"/>
                    <a:pt x="470943" y="241886"/>
                  </a:cubicBezTo>
                  <a:cubicBezTo>
                    <a:pt x="468010" y="244400"/>
                    <a:pt x="459948" y="245551"/>
                    <a:pt x="459948" y="245551"/>
                  </a:cubicBezTo>
                  <a:cubicBezTo>
                    <a:pt x="458116" y="243718"/>
                    <a:pt x="456042" y="242099"/>
                    <a:pt x="454451" y="240053"/>
                  </a:cubicBezTo>
                  <a:cubicBezTo>
                    <a:pt x="451747" y="236576"/>
                    <a:pt x="447121" y="229059"/>
                    <a:pt x="447121" y="229059"/>
                  </a:cubicBezTo>
                  <a:cubicBezTo>
                    <a:pt x="442983" y="216639"/>
                    <a:pt x="448827" y="231444"/>
                    <a:pt x="437959" y="216231"/>
                  </a:cubicBezTo>
                  <a:cubicBezTo>
                    <a:pt x="436836" y="214659"/>
                    <a:pt x="436990" y="212462"/>
                    <a:pt x="436126" y="210734"/>
                  </a:cubicBezTo>
                  <a:cubicBezTo>
                    <a:pt x="435141" y="208764"/>
                    <a:pt x="433447" y="207207"/>
                    <a:pt x="432462" y="205237"/>
                  </a:cubicBezTo>
                  <a:cubicBezTo>
                    <a:pt x="424880" y="190072"/>
                    <a:pt x="437460" y="209985"/>
                    <a:pt x="426964" y="194242"/>
                  </a:cubicBezTo>
                  <a:cubicBezTo>
                    <a:pt x="426102" y="191654"/>
                    <a:pt x="425384" y="184612"/>
                    <a:pt x="419634" y="186912"/>
                  </a:cubicBezTo>
                  <a:cubicBezTo>
                    <a:pt x="417589" y="187730"/>
                    <a:pt x="417526" y="190852"/>
                    <a:pt x="415969" y="192409"/>
                  </a:cubicBezTo>
                  <a:cubicBezTo>
                    <a:pt x="414412" y="193966"/>
                    <a:pt x="412164" y="194664"/>
                    <a:pt x="410472" y="196074"/>
                  </a:cubicBezTo>
                  <a:cubicBezTo>
                    <a:pt x="405809" y="199961"/>
                    <a:pt x="405099" y="202828"/>
                    <a:pt x="399477" y="205237"/>
                  </a:cubicBezTo>
                  <a:cubicBezTo>
                    <a:pt x="397162" y="206229"/>
                    <a:pt x="394590" y="206458"/>
                    <a:pt x="392147" y="207069"/>
                  </a:cubicBezTo>
                  <a:cubicBezTo>
                    <a:pt x="390925" y="208901"/>
                    <a:pt x="390394" y="211473"/>
                    <a:pt x="388482" y="212566"/>
                  </a:cubicBezTo>
                  <a:cubicBezTo>
                    <a:pt x="385778" y="214111"/>
                    <a:pt x="382342" y="213644"/>
                    <a:pt x="379320" y="214399"/>
                  </a:cubicBezTo>
                  <a:cubicBezTo>
                    <a:pt x="377446" y="214867"/>
                    <a:pt x="375655" y="215620"/>
                    <a:pt x="373823" y="216231"/>
                  </a:cubicBezTo>
                  <a:cubicBezTo>
                    <a:pt x="369772" y="220282"/>
                    <a:pt x="367929" y="222844"/>
                    <a:pt x="362828" y="225394"/>
                  </a:cubicBezTo>
                  <a:cubicBezTo>
                    <a:pt x="361100" y="226258"/>
                    <a:pt x="359163" y="226615"/>
                    <a:pt x="357330" y="227226"/>
                  </a:cubicBezTo>
                  <a:cubicBezTo>
                    <a:pt x="347480" y="233793"/>
                    <a:pt x="349308" y="233968"/>
                    <a:pt x="340838" y="236388"/>
                  </a:cubicBezTo>
                  <a:cubicBezTo>
                    <a:pt x="338416" y="237080"/>
                    <a:pt x="335951" y="237610"/>
                    <a:pt x="333508" y="238221"/>
                  </a:cubicBezTo>
                  <a:cubicBezTo>
                    <a:pt x="326822" y="228194"/>
                    <a:pt x="331379" y="236741"/>
                    <a:pt x="328011" y="219896"/>
                  </a:cubicBezTo>
                  <a:cubicBezTo>
                    <a:pt x="327632" y="218002"/>
                    <a:pt x="326687" y="216262"/>
                    <a:pt x="326179" y="214399"/>
                  </a:cubicBezTo>
                  <a:cubicBezTo>
                    <a:pt x="324854" y="209539"/>
                    <a:pt x="323502" y="204678"/>
                    <a:pt x="322514" y="199739"/>
                  </a:cubicBezTo>
                  <a:cubicBezTo>
                    <a:pt x="321667" y="195504"/>
                    <a:pt x="321391" y="191172"/>
                    <a:pt x="320681" y="186912"/>
                  </a:cubicBezTo>
                  <a:cubicBezTo>
                    <a:pt x="318834" y="175831"/>
                    <a:pt x="319217" y="180326"/>
                    <a:pt x="317016" y="170420"/>
                  </a:cubicBezTo>
                  <a:cubicBezTo>
                    <a:pt x="313561" y="154874"/>
                    <a:pt x="317242" y="167430"/>
                    <a:pt x="311519" y="150263"/>
                  </a:cubicBezTo>
                  <a:cubicBezTo>
                    <a:pt x="310908" y="148430"/>
                    <a:pt x="311293" y="145837"/>
                    <a:pt x="309686" y="144765"/>
                  </a:cubicBezTo>
                  <a:lnTo>
                    <a:pt x="304189" y="141100"/>
                  </a:lnTo>
                  <a:cubicBezTo>
                    <a:pt x="293686" y="125347"/>
                    <a:pt x="306278" y="145278"/>
                    <a:pt x="298692" y="130105"/>
                  </a:cubicBezTo>
                  <a:cubicBezTo>
                    <a:pt x="297707" y="128135"/>
                    <a:pt x="296307" y="126400"/>
                    <a:pt x="295027" y="124608"/>
                  </a:cubicBezTo>
                  <a:cubicBezTo>
                    <a:pt x="289150" y="116381"/>
                    <a:pt x="290691" y="118440"/>
                    <a:pt x="284032" y="111781"/>
                  </a:cubicBezTo>
                  <a:cubicBezTo>
                    <a:pt x="283421" y="109948"/>
                    <a:pt x="283565" y="107649"/>
                    <a:pt x="282199" y="106283"/>
                  </a:cubicBezTo>
                  <a:cubicBezTo>
                    <a:pt x="279085" y="103169"/>
                    <a:pt x="271205" y="98954"/>
                    <a:pt x="271205" y="98954"/>
                  </a:cubicBezTo>
                  <a:cubicBezTo>
                    <a:pt x="269983" y="97121"/>
                    <a:pt x="269630" y="94153"/>
                    <a:pt x="267540" y="93456"/>
                  </a:cubicBezTo>
                  <a:cubicBezTo>
                    <a:pt x="262017" y="91615"/>
                    <a:pt x="258857" y="97572"/>
                    <a:pt x="254712" y="98954"/>
                  </a:cubicBezTo>
                  <a:cubicBezTo>
                    <a:pt x="251187" y="100129"/>
                    <a:pt x="247383" y="100175"/>
                    <a:pt x="243718" y="100786"/>
                  </a:cubicBezTo>
                  <a:cubicBezTo>
                    <a:pt x="238220" y="102618"/>
                    <a:pt x="232953" y="105402"/>
                    <a:pt x="227225" y="106283"/>
                  </a:cubicBezTo>
                  <a:cubicBezTo>
                    <a:pt x="191522" y="111776"/>
                    <a:pt x="202343" y="98714"/>
                    <a:pt x="192409" y="113613"/>
                  </a:cubicBezTo>
                  <a:cubicBezTo>
                    <a:pt x="193899" y="118086"/>
                    <a:pt x="194353" y="121055"/>
                    <a:pt x="197906" y="124608"/>
                  </a:cubicBezTo>
                  <a:cubicBezTo>
                    <a:pt x="199463" y="126165"/>
                    <a:pt x="201711" y="126863"/>
                    <a:pt x="203403" y="128273"/>
                  </a:cubicBezTo>
                  <a:cubicBezTo>
                    <a:pt x="205394" y="129932"/>
                    <a:pt x="207068" y="131938"/>
                    <a:pt x="208901" y="133770"/>
                  </a:cubicBezTo>
                  <a:cubicBezTo>
                    <a:pt x="213016" y="146121"/>
                    <a:pt x="212765" y="143026"/>
                    <a:pt x="208901" y="164922"/>
                  </a:cubicBezTo>
                  <a:cubicBezTo>
                    <a:pt x="208518" y="167091"/>
                    <a:pt x="207069" y="169198"/>
                    <a:pt x="205236" y="170420"/>
                  </a:cubicBezTo>
                  <a:cubicBezTo>
                    <a:pt x="203140" y="171817"/>
                    <a:pt x="200349" y="171641"/>
                    <a:pt x="197906" y="172252"/>
                  </a:cubicBezTo>
                  <a:cubicBezTo>
                    <a:pt x="193630" y="176528"/>
                    <a:pt x="190815" y="183167"/>
                    <a:pt x="185079" y="185079"/>
                  </a:cubicBezTo>
                  <a:cubicBezTo>
                    <a:pt x="176990" y="187776"/>
                    <a:pt x="181309" y="186048"/>
                    <a:pt x="172251" y="190577"/>
                  </a:cubicBezTo>
                  <a:cubicBezTo>
                    <a:pt x="171030" y="193020"/>
                    <a:pt x="170518" y="195975"/>
                    <a:pt x="168587" y="197907"/>
                  </a:cubicBezTo>
                  <a:cubicBezTo>
                    <a:pt x="162285" y="204209"/>
                    <a:pt x="159008" y="204765"/>
                    <a:pt x="152094" y="207069"/>
                  </a:cubicBezTo>
                  <a:cubicBezTo>
                    <a:pt x="148943" y="209432"/>
                    <a:pt x="143022" y="214086"/>
                    <a:pt x="139267" y="216231"/>
                  </a:cubicBezTo>
                  <a:cubicBezTo>
                    <a:pt x="136895" y="217586"/>
                    <a:pt x="134380" y="218674"/>
                    <a:pt x="131937" y="219896"/>
                  </a:cubicBezTo>
                  <a:cubicBezTo>
                    <a:pt x="130715" y="221729"/>
                    <a:pt x="129829" y="223836"/>
                    <a:pt x="128272" y="225394"/>
                  </a:cubicBezTo>
                  <a:cubicBezTo>
                    <a:pt x="124720" y="228947"/>
                    <a:pt x="121749" y="229401"/>
                    <a:pt x="117278" y="230891"/>
                  </a:cubicBezTo>
                  <a:cubicBezTo>
                    <a:pt x="113613" y="233334"/>
                    <a:pt x="109723" y="235469"/>
                    <a:pt x="106283" y="238221"/>
                  </a:cubicBezTo>
                  <a:cubicBezTo>
                    <a:pt x="103229" y="240664"/>
                    <a:pt x="100539" y="243652"/>
                    <a:pt x="97120" y="245551"/>
                  </a:cubicBezTo>
                  <a:cubicBezTo>
                    <a:pt x="94919" y="246774"/>
                    <a:pt x="92234" y="246772"/>
                    <a:pt x="89791" y="247383"/>
                  </a:cubicBezTo>
                  <a:cubicBezTo>
                    <a:pt x="88876" y="248115"/>
                    <a:pt x="78270" y="257033"/>
                    <a:pt x="75131" y="258378"/>
                  </a:cubicBezTo>
                  <a:cubicBezTo>
                    <a:pt x="72816" y="259370"/>
                    <a:pt x="70244" y="259599"/>
                    <a:pt x="67801" y="260210"/>
                  </a:cubicBezTo>
                  <a:cubicBezTo>
                    <a:pt x="65969" y="261432"/>
                    <a:pt x="63861" y="262318"/>
                    <a:pt x="62304" y="263875"/>
                  </a:cubicBezTo>
                  <a:cubicBezTo>
                    <a:pt x="60747" y="265433"/>
                    <a:pt x="60507" y="268206"/>
                    <a:pt x="58639" y="269373"/>
                  </a:cubicBezTo>
                  <a:cubicBezTo>
                    <a:pt x="55363" y="271421"/>
                    <a:pt x="47644" y="273038"/>
                    <a:pt x="47644" y="273038"/>
                  </a:cubicBezTo>
                  <a:cubicBezTo>
                    <a:pt x="45201" y="274870"/>
                    <a:pt x="42474" y="276375"/>
                    <a:pt x="40314" y="278535"/>
                  </a:cubicBezTo>
                  <a:cubicBezTo>
                    <a:pt x="32277" y="286572"/>
                    <a:pt x="41660" y="282025"/>
                    <a:pt x="31152" y="289530"/>
                  </a:cubicBezTo>
                  <a:cubicBezTo>
                    <a:pt x="28929" y="291118"/>
                    <a:pt x="26194" y="291840"/>
                    <a:pt x="23822" y="293195"/>
                  </a:cubicBezTo>
                  <a:cubicBezTo>
                    <a:pt x="20919" y="294854"/>
                    <a:pt x="12964" y="300669"/>
                    <a:pt x="10995" y="302357"/>
                  </a:cubicBezTo>
                  <a:cubicBezTo>
                    <a:pt x="9027" y="304044"/>
                    <a:pt x="7156" y="305864"/>
                    <a:pt x="5497" y="307855"/>
                  </a:cubicBezTo>
                  <a:cubicBezTo>
                    <a:pt x="-4864" y="320287"/>
                    <a:pt x="5827" y="309357"/>
                    <a:pt x="0" y="315184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フリーフォーム: 図形 26">
              <a:extLst>
                <a:ext uri="{FF2B5EF4-FFF2-40B4-BE49-F238E27FC236}">
                  <a16:creationId xmlns:a16="http://schemas.microsoft.com/office/drawing/2014/main" id="{961BD67B-6AAF-4B47-AF71-F098426EF72C}"/>
                </a:ext>
              </a:extLst>
            </p:cNvPr>
            <p:cNvSpPr/>
            <p:nvPr/>
          </p:nvSpPr>
          <p:spPr>
            <a:xfrm>
              <a:off x="2185686" y="4662668"/>
              <a:ext cx="1179558" cy="574876"/>
            </a:xfrm>
            <a:custGeom>
              <a:avLst/>
              <a:gdLst>
                <a:gd name="connsiteX0" fmla="*/ 428263 w 1179558"/>
                <a:gd name="connsiteY0" fmla="*/ 48228 h 574876"/>
                <a:gd name="connsiteX1" fmla="*/ 437909 w 1179558"/>
                <a:gd name="connsiteY1" fmla="*/ 55945 h 574876"/>
                <a:gd name="connsiteX2" fmla="*/ 445625 w 1179558"/>
                <a:gd name="connsiteY2" fmla="*/ 59803 h 574876"/>
                <a:gd name="connsiteX3" fmla="*/ 449484 w 1179558"/>
                <a:gd name="connsiteY3" fmla="*/ 63661 h 574876"/>
                <a:gd name="connsiteX4" fmla="*/ 455271 w 1179558"/>
                <a:gd name="connsiteY4" fmla="*/ 67519 h 574876"/>
                <a:gd name="connsiteX5" fmla="*/ 459129 w 1179558"/>
                <a:gd name="connsiteY5" fmla="*/ 71378 h 574876"/>
                <a:gd name="connsiteX6" fmla="*/ 466846 w 1179558"/>
                <a:gd name="connsiteY6" fmla="*/ 73307 h 574876"/>
                <a:gd name="connsiteX7" fmla="*/ 472633 w 1179558"/>
                <a:gd name="connsiteY7" fmla="*/ 79094 h 574876"/>
                <a:gd name="connsiteX8" fmla="*/ 482279 w 1179558"/>
                <a:gd name="connsiteY8" fmla="*/ 86810 h 574876"/>
                <a:gd name="connsiteX9" fmla="*/ 486137 w 1179558"/>
                <a:gd name="connsiteY9" fmla="*/ 92598 h 574876"/>
                <a:gd name="connsiteX10" fmla="*/ 489995 w 1179558"/>
                <a:gd name="connsiteY10" fmla="*/ 100314 h 574876"/>
                <a:gd name="connsiteX11" fmla="*/ 499641 w 1179558"/>
                <a:gd name="connsiteY11" fmla="*/ 109960 h 574876"/>
                <a:gd name="connsiteX12" fmla="*/ 505428 w 1179558"/>
                <a:gd name="connsiteY12" fmla="*/ 117676 h 574876"/>
                <a:gd name="connsiteX13" fmla="*/ 511215 w 1179558"/>
                <a:gd name="connsiteY13" fmla="*/ 119605 h 574876"/>
                <a:gd name="connsiteX14" fmla="*/ 526648 w 1179558"/>
                <a:gd name="connsiteY14" fmla="*/ 121535 h 574876"/>
                <a:gd name="connsiteX15" fmla="*/ 717630 w 1179558"/>
                <a:gd name="connsiteY15" fmla="*/ 119605 h 574876"/>
                <a:gd name="connsiteX16" fmla="*/ 727276 w 1179558"/>
                <a:gd name="connsiteY16" fmla="*/ 111889 h 574876"/>
                <a:gd name="connsiteX17" fmla="*/ 733063 w 1179558"/>
                <a:gd name="connsiteY17" fmla="*/ 86810 h 574876"/>
                <a:gd name="connsiteX18" fmla="*/ 734992 w 1179558"/>
                <a:gd name="connsiteY18" fmla="*/ 79094 h 574876"/>
                <a:gd name="connsiteX19" fmla="*/ 738851 w 1179558"/>
                <a:gd name="connsiteY19" fmla="*/ 75236 h 574876"/>
                <a:gd name="connsiteX20" fmla="*/ 748496 w 1179558"/>
                <a:gd name="connsiteY20" fmla="*/ 57874 h 574876"/>
                <a:gd name="connsiteX21" fmla="*/ 752355 w 1179558"/>
                <a:gd name="connsiteY21" fmla="*/ 52086 h 574876"/>
                <a:gd name="connsiteX22" fmla="*/ 760071 w 1179558"/>
                <a:gd name="connsiteY22" fmla="*/ 50157 h 574876"/>
                <a:gd name="connsiteX23" fmla="*/ 767787 w 1179558"/>
                <a:gd name="connsiteY23" fmla="*/ 38583 h 574876"/>
                <a:gd name="connsiteX24" fmla="*/ 775504 w 1179558"/>
                <a:gd name="connsiteY24" fmla="*/ 28937 h 574876"/>
                <a:gd name="connsiteX25" fmla="*/ 785149 w 1179558"/>
                <a:gd name="connsiteY25" fmla="*/ 17362 h 574876"/>
                <a:gd name="connsiteX26" fmla="*/ 789008 w 1179558"/>
                <a:gd name="connsiteY26" fmla="*/ 13504 h 574876"/>
                <a:gd name="connsiteX27" fmla="*/ 798653 w 1179558"/>
                <a:gd name="connsiteY27" fmla="*/ 11575 h 574876"/>
                <a:gd name="connsiteX28" fmla="*/ 854598 w 1179558"/>
                <a:gd name="connsiteY28" fmla="*/ 3859 h 574876"/>
                <a:gd name="connsiteX29" fmla="*/ 868101 w 1179558"/>
                <a:gd name="connsiteY29" fmla="*/ 0 h 574876"/>
                <a:gd name="connsiteX30" fmla="*/ 922117 w 1179558"/>
                <a:gd name="connsiteY30" fmla="*/ 1929 h 574876"/>
                <a:gd name="connsiteX31" fmla="*/ 937549 w 1179558"/>
                <a:gd name="connsiteY31" fmla="*/ 7717 h 574876"/>
                <a:gd name="connsiteX32" fmla="*/ 952982 w 1179558"/>
                <a:gd name="connsiteY32" fmla="*/ 11575 h 574876"/>
                <a:gd name="connsiteX33" fmla="*/ 958770 w 1179558"/>
                <a:gd name="connsiteY33" fmla="*/ 15433 h 574876"/>
                <a:gd name="connsiteX34" fmla="*/ 972273 w 1179558"/>
                <a:gd name="connsiteY34" fmla="*/ 19291 h 574876"/>
                <a:gd name="connsiteX35" fmla="*/ 987706 w 1179558"/>
                <a:gd name="connsiteY35" fmla="*/ 28937 h 574876"/>
                <a:gd name="connsiteX36" fmla="*/ 993494 w 1179558"/>
                <a:gd name="connsiteY36" fmla="*/ 30866 h 574876"/>
                <a:gd name="connsiteX37" fmla="*/ 1020501 w 1179558"/>
                <a:gd name="connsiteY37" fmla="*/ 32795 h 574876"/>
                <a:gd name="connsiteX38" fmla="*/ 1024360 w 1179558"/>
                <a:gd name="connsiteY38" fmla="*/ 36654 h 574876"/>
                <a:gd name="connsiteX39" fmla="*/ 1032076 w 1179558"/>
                <a:gd name="connsiteY39" fmla="*/ 38583 h 574876"/>
                <a:gd name="connsiteX40" fmla="*/ 1037863 w 1179558"/>
                <a:gd name="connsiteY40" fmla="*/ 40512 h 574876"/>
                <a:gd name="connsiteX41" fmla="*/ 1043651 w 1179558"/>
                <a:gd name="connsiteY41" fmla="*/ 44370 h 574876"/>
                <a:gd name="connsiteX42" fmla="*/ 1047509 w 1179558"/>
                <a:gd name="connsiteY42" fmla="*/ 50157 h 574876"/>
                <a:gd name="connsiteX43" fmla="*/ 1051367 w 1179558"/>
                <a:gd name="connsiteY43" fmla="*/ 54016 h 574876"/>
                <a:gd name="connsiteX44" fmla="*/ 1057155 w 1179558"/>
                <a:gd name="connsiteY44" fmla="*/ 63661 h 574876"/>
                <a:gd name="connsiteX45" fmla="*/ 1061013 w 1179558"/>
                <a:gd name="connsiteY45" fmla="*/ 79094 h 574876"/>
                <a:gd name="connsiteX46" fmla="*/ 1070658 w 1179558"/>
                <a:gd name="connsiteY46" fmla="*/ 90669 h 574876"/>
                <a:gd name="connsiteX47" fmla="*/ 1076446 w 1179558"/>
                <a:gd name="connsiteY47" fmla="*/ 100314 h 574876"/>
                <a:gd name="connsiteX48" fmla="*/ 1091879 w 1179558"/>
                <a:gd name="connsiteY48" fmla="*/ 104173 h 574876"/>
                <a:gd name="connsiteX49" fmla="*/ 1097666 w 1179558"/>
                <a:gd name="connsiteY49" fmla="*/ 109960 h 574876"/>
                <a:gd name="connsiteX50" fmla="*/ 1103453 w 1179558"/>
                <a:gd name="connsiteY50" fmla="*/ 111889 h 574876"/>
                <a:gd name="connsiteX51" fmla="*/ 1153610 w 1179558"/>
                <a:gd name="connsiteY51" fmla="*/ 115747 h 574876"/>
                <a:gd name="connsiteX52" fmla="*/ 1163256 w 1179558"/>
                <a:gd name="connsiteY52" fmla="*/ 127322 h 574876"/>
                <a:gd name="connsiteX53" fmla="*/ 1165185 w 1179558"/>
                <a:gd name="connsiteY53" fmla="*/ 133109 h 574876"/>
                <a:gd name="connsiteX54" fmla="*/ 1167114 w 1179558"/>
                <a:gd name="connsiteY54" fmla="*/ 163975 h 574876"/>
                <a:gd name="connsiteX55" fmla="*/ 1170972 w 1179558"/>
                <a:gd name="connsiteY55" fmla="*/ 169762 h 574876"/>
                <a:gd name="connsiteX56" fmla="*/ 1172901 w 1179558"/>
                <a:gd name="connsiteY56" fmla="*/ 175550 h 574876"/>
                <a:gd name="connsiteX57" fmla="*/ 1161327 w 1179558"/>
                <a:gd name="connsiteY57" fmla="*/ 266218 h 574876"/>
                <a:gd name="connsiteX58" fmla="*/ 1153610 w 1179558"/>
                <a:gd name="connsiteY58" fmla="*/ 270076 h 574876"/>
                <a:gd name="connsiteX59" fmla="*/ 1136248 w 1179558"/>
                <a:gd name="connsiteY59" fmla="*/ 272005 h 574876"/>
                <a:gd name="connsiteX60" fmla="*/ 1132390 w 1179558"/>
                <a:gd name="connsiteY60" fmla="*/ 275864 h 574876"/>
                <a:gd name="connsiteX61" fmla="*/ 1115028 w 1179558"/>
                <a:gd name="connsiteY61" fmla="*/ 281651 h 574876"/>
                <a:gd name="connsiteX62" fmla="*/ 1109241 w 1179558"/>
                <a:gd name="connsiteY62" fmla="*/ 283580 h 574876"/>
                <a:gd name="connsiteX63" fmla="*/ 1103453 w 1179558"/>
                <a:gd name="connsiteY63" fmla="*/ 287438 h 574876"/>
                <a:gd name="connsiteX64" fmla="*/ 1091879 w 1179558"/>
                <a:gd name="connsiteY64" fmla="*/ 289367 h 574876"/>
                <a:gd name="connsiteX65" fmla="*/ 1076446 w 1179558"/>
                <a:gd name="connsiteY65" fmla="*/ 295155 h 574876"/>
                <a:gd name="connsiteX66" fmla="*/ 1070658 w 1179558"/>
                <a:gd name="connsiteY66" fmla="*/ 299013 h 574876"/>
                <a:gd name="connsiteX67" fmla="*/ 1059084 w 1179558"/>
                <a:gd name="connsiteY67" fmla="*/ 302871 h 574876"/>
                <a:gd name="connsiteX68" fmla="*/ 1053296 w 1179558"/>
                <a:gd name="connsiteY68" fmla="*/ 304800 h 574876"/>
                <a:gd name="connsiteX69" fmla="*/ 1045580 w 1179558"/>
                <a:gd name="connsiteY69" fmla="*/ 308659 h 574876"/>
                <a:gd name="connsiteX70" fmla="*/ 1035934 w 1179558"/>
                <a:gd name="connsiteY70" fmla="*/ 312517 h 574876"/>
                <a:gd name="connsiteX71" fmla="*/ 1024360 w 1179558"/>
                <a:gd name="connsiteY71" fmla="*/ 316375 h 574876"/>
                <a:gd name="connsiteX72" fmla="*/ 1016643 w 1179558"/>
                <a:gd name="connsiteY72" fmla="*/ 322162 h 574876"/>
                <a:gd name="connsiteX73" fmla="*/ 1008927 w 1179558"/>
                <a:gd name="connsiteY73" fmla="*/ 324091 h 574876"/>
                <a:gd name="connsiteX74" fmla="*/ 995423 w 1179558"/>
                <a:gd name="connsiteY74" fmla="*/ 327950 h 574876"/>
                <a:gd name="connsiteX75" fmla="*/ 989636 w 1179558"/>
                <a:gd name="connsiteY75" fmla="*/ 331808 h 574876"/>
                <a:gd name="connsiteX76" fmla="*/ 985777 w 1179558"/>
                <a:gd name="connsiteY76" fmla="*/ 337595 h 574876"/>
                <a:gd name="connsiteX77" fmla="*/ 976132 w 1179558"/>
                <a:gd name="connsiteY77" fmla="*/ 339524 h 574876"/>
                <a:gd name="connsiteX78" fmla="*/ 970344 w 1179558"/>
                <a:gd name="connsiteY78" fmla="*/ 343383 h 574876"/>
                <a:gd name="connsiteX79" fmla="*/ 964557 w 1179558"/>
                <a:gd name="connsiteY79" fmla="*/ 349170 h 574876"/>
                <a:gd name="connsiteX80" fmla="*/ 954911 w 1179558"/>
                <a:gd name="connsiteY80" fmla="*/ 351099 h 574876"/>
                <a:gd name="connsiteX81" fmla="*/ 947195 w 1179558"/>
                <a:gd name="connsiteY81" fmla="*/ 360745 h 574876"/>
                <a:gd name="connsiteX82" fmla="*/ 941408 w 1179558"/>
                <a:gd name="connsiteY82" fmla="*/ 364603 h 574876"/>
                <a:gd name="connsiteX83" fmla="*/ 929833 w 1179558"/>
                <a:gd name="connsiteY83" fmla="*/ 376178 h 574876"/>
                <a:gd name="connsiteX84" fmla="*/ 920187 w 1179558"/>
                <a:gd name="connsiteY84" fmla="*/ 383894 h 574876"/>
                <a:gd name="connsiteX85" fmla="*/ 914400 w 1179558"/>
                <a:gd name="connsiteY85" fmla="*/ 389681 h 574876"/>
                <a:gd name="connsiteX86" fmla="*/ 908613 w 1179558"/>
                <a:gd name="connsiteY86" fmla="*/ 393540 h 574876"/>
                <a:gd name="connsiteX87" fmla="*/ 897038 w 1179558"/>
                <a:gd name="connsiteY87" fmla="*/ 405114 h 574876"/>
                <a:gd name="connsiteX88" fmla="*/ 893180 w 1179558"/>
                <a:gd name="connsiteY88" fmla="*/ 408973 h 574876"/>
                <a:gd name="connsiteX89" fmla="*/ 889322 w 1179558"/>
                <a:gd name="connsiteY89" fmla="*/ 422476 h 574876"/>
                <a:gd name="connsiteX90" fmla="*/ 879676 w 1179558"/>
                <a:gd name="connsiteY90" fmla="*/ 434051 h 574876"/>
                <a:gd name="connsiteX91" fmla="*/ 875818 w 1179558"/>
                <a:gd name="connsiteY91" fmla="*/ 439838 h 574876"/>
                <a:gd name="connsiteX92" fmla="*/ 868101 w 1179558"/>
                <a:gd name="connsiteY92" fmla="*/ 434051 h 574876"/>
                <a:gd name="connsiteX93" fmla="*/ 860385 w 1179558"/>
                <a:gd name="connsiteY93" fmla="*/ 420547 h 574876"/>
                <a:gd name="connsiteX94" fmla="*/ 854598 w 1179558"/>
                <a:gd name="connsiteY94" fmla="*/ 418618 h 574876"/>
                <a:gd name="connsiteX95" fmla="*/ 850739 w 1179558"/>
                <a:gd name="connsiteY95" fmla="*/ 412831 h 574876"/>
                <a:gd name="connsiteX96" fmla="*/ 839165 w 1179558"/>
                <a:gd name="connsiteY96" fmla="*/ 407043 h 574876"/>
                <a:gd name="connsiteX97" fmla="*/ 829519 w 1179558"/>
                <a:gd name="connsiteY97" fmla="*/ 399327 h 574876"/>
                <a:gd name="connsiteX98" fmla="*/ 817944 w 1179558"/>
                <a:gd name="connsiteY98" fmla="*/ 387752 h 574876"/>
                <a:gd name="connsiteX99" fmla="*/ 812157 w 1179558"/>
                <a:gd name="connsiteY99" fmla="*/ 380036 h 574876"/>
                <a:gd name="connsiteX100" fmla="*/ 794795 w 1179558"/>
                <a:gd name="connsiteY100" fmla="*/ 370390 h 574876"/>
                <a:gd name="connsiteX101" fmla="*/ 781291 w 1179558"/>
                <a:gd name="connsiteY101" fmla="*/ 358816 h 574876"/>
                <a:gd name="connsiteX102" fmla="*/ 773575 w 1179558"/>
                <a:gd name="connsiteY102" fmla="*/ 347241 h 574876"/>
                <a:gd name="connsiteX103" fmla="*/ 762000 w 1179558"/>
                <a:gd name="connsiteY103" fmla="*/ 339524 h 574876"/>
                <a:gd name="connsiteX104" fmla="*/ 758142 w 1179558"/>
                <a:gd name="connsiteY104" fmla="*/ 333737 h 574876"/>
                <a:gd name="connsiteX105" fmla="*/ 729205 w 1179558"/>
                <a:gd name="connsiteY105" fmla="*/ 327950 h 574876"/>
                <a:gd name="connsiteX106" fmla="*/ 673261 w 1179558"/>
                <a:gd name="connsiteY106" fmla="*/ 326021 h 574876"/>
                <a:gd name="connsiteX107" fmla="*/ 594167 w 1179558"/>
                <a:gd name="connsiteY107" fmla="*/ 322162 h 574876"/>
                <a:gd name="connsiteX108" fmla="*/ 549798 w 1179558"/>
                <a:gd name="connsiteY108" fmla="*/ 324091 h 574876"/>
                <a:gd name="connsiteX109" fmla="*/ 536294 w 1179558"/>
                <a:gd name="connsiteY109" fmla="*/ 329879 h 574876"/>
                <a:gd name="connsiteX110" fmla="*/ 528577 w 1179558"/>
                <a:gd name="connsiteY110" fmla="*/ 335666 h 574876"/>
                <a:gd name="connsiteX111" fmla="*/ 522790 w 1179558"/>
                <a:gd name="connsiteY111" fmla="*/ 339524 h 574876"/>
                <a:gd name="connsiteX112" fmla="*/ 513144 w 1179558"/>
                <a:gd name="connsiteY112" fmla="*/ 347241 h 574876"/>
                <a:gd name="connsiteX113" fmla="*/ 501570 w 1179558"/>
                <a:gd name="connsiteY113" fmla="*/ 354957 h 574876"/>
                <a:gd name="connsiteX114" fmla="*/ 489995 w 1179558"/>
                <a:gd name="connsiteY114" fmla="*/ 362674 h 574876"/>
                <a:gd name="connsiteX115" fmla="*/ 478420 w 1179558"/>
                <a:gd name="connsiteY115" fmla="*/ 372319 h 574876"/>
                <a:gd name="connsiteX116" fmla="*/ 470704 w 1179558"/>
                <a:gd name="connsiteY116" fmla="*/ 383894 h 574876"/>
                <a:gd name="connsiteX117" fmla="*/ 462987 w 1179558"/>
                <a:gd name="connsiteY117" fmla="*/ 389681 h 574876"/>
                <a:gd name="connsiteX118" fmla="*/ 455271 w 1179558"/>
                <a:gd name="connsiteY118" fmla="*/ 399327 h 574876"/>
                <a:gd name="connsiteX119" fmla="*/ 453342 w 1179558"/>
                <a:gd name="connsiteY119" fmla="*/ 405114 h 574876"/>
                <a:gd name="connsiteX120" fmla="*/ 443696 w 1179558"/>
                <a:gd name="connsiteY120" fmla="*/ 416689 h 574876"/>
                <a:gd name="connsiteX121" fmla="*/ 432122 w 1179558"/>
                <a:gd name="connsiteY121" fmla="*/ 434051 h 574876"/>
                <a:gd name="connsiteX122" fmla="*/ 428263 w 1179558"/>
                <a:gd name="connsiteY122" fmla="*/ 439838 h 574876"/>
                <a:gd name="connsiteX123" fmla="*/ 416689 w 1179558"/>
                <a:gd name="connsiteY123" fmla="*/ 443697 h 574876"/>
                <a:gd name="connsiteX124" fmla="*/ 391610 w 1179558"/>
                <a:gd name="connsiteY124" fmla="*/ 449484 h 574876"/>
                <a:gd name="connsiteX125" fmla="*/ 385823 w 1179558"/>
                <a:gd name="connsiteY125" fmla="*/ 453342 h 574876"/>
                <a:gd name="connsiteX126" fmla="*/ 370390 w 1179558"/>
                <a:gd name="connsiteY126" fmla="*/ 457200 h 574876"/>
                <a:gd name="connsiteX127" fmla="*/ 354957 w 1179558"/>
                <a:gd name="connsiteY127" fmla="*/ 464917 h 574876"/>
                <a:gd name="connsiteX128" fmla="*/ 343382 w 1179558"/>
                <a:gd name="connsiteY128" fmla="*/ 472633 h 574876"/>
                <a:gd name="connsiteX129" fmla="*/ 339524 w 1179558"/>
                <a:gd name="connsiteY129" fmla="*/ 509286 h 574876"/>
                <a:gd name="connsiteX130" fmla="*/ 335666 w 1179558"/>
                <a:gd name="connsiteY130" fmla="*/ 515074 h 574876"/>
                <a:gd name="connsiteX131" fmla="*/ 333737 w 1179558"/>
                <a:gd name="connsiteY131" fmla="*/ 520861 h 574876"/>
                <a:gd name="connsiteX132" fmla="*/ 326020 w 1179558"/>
                <a:gd name="connsiteY132" fmla="*/ 528578 h 574876"/>
                <a:gd name="connsiteX133" fmla="*/ 322162 w 1179558"/>
                <a:gd name="connsiteY133" fmla="*/ 534365 h 574876"/>
                <a:gd name="connsiteX134" fmla="*/ 320233 w 1179558"/>
                <a:gd name="connsiteY134" fmla="*/ 542081 h 574876"/>
                <a:gd name="connsiteX135" fmla="*/ 318304 w 1179558"/>
                <a:gd name="connsiteY135" fmla="*/ 555585 h 574876"/>
                <a:gd name="connsiteX136" fmla="*/ 312517 w 1179558"/>
                <a:gd name="connsiteY136" fmla="*/ 559443 h 574876"/>
                <a:gd name="connsiteX137" fmla="*/ 308658 w 1179558"/>
                <a:gd name="connsiteY137" fmla="*/ 572947 h 574876"/>
                <a:gd name="connsiteX138" fmla="*/ 302871 w 1179558"/>
                <a:gd name="connsiteY138" fmla="*/ 574876 h 574876"/>
                <a:gd name="connsiteX139" fmla="*/ 272005 w 1179558"/>
                <a:gd name="connsiteY139" fmla="*/ 565231 h 574876"/>
                <a:gd name="connsiteX140" fmla="*/ 272005 w 1179558"/>
                <a:gd name="connsiteY140" fmla="*/ 565231 h 574876"/>
                <a:gd name="connsiteX141" fmla="*/ 260430 w 1179558"/>
                <a:gd name="connsiteY141" fmla="*/ 561373 h 574876"/>
                <a:gd name="connsiteX142" fmla="*/ 252714 w 1179558"/>
                <a:gd name="connsiteY142" fmla="*/ 553656 h 574876"/>
                <a:gd name="connsiteX143" fmla="*/ 246927 w 1179558"/>
                <a:gd name="connsiteY143" fmla="*/ 549798 h 574876"/>
                <a:gd name="connsiteX144" fmla="*/ 231494 w 1179558"/>
                <a:gd name="connsiteY144" fmla="*/ 545940 h 574876"/>
                <a:gd name="connsiteX145" fmla="*/ 217990 w 1179558"/>
                <a:gd name="connsiteY145" fmla="*/ 540152 h 574876"/>
                <a:gd name="connsiteX146" fmla="*/ 198699 w 1179558"/>
                <a:gd name="connsiteY146" fmla="*/ 528578 h 574876"/>
                <a:gd name="connsiteX147" fmla="*/ 189053 w 1179558"/>
                <a:gd name="connsiteY147" fmla="*/ 526648 h 574876"/>
                <a:gd name="connsiteX148" fmla="*/ 183266 w 1179558"/>
                <a:gd name="connsiteY148" fmla="*/ 524719 h 574876"/>
                <a:gd name="connsiteX149" fmla="*/ 175549 w 1179558"/>
                <a:gd name="connsiteY149" fmla="*/ 522790 h 574876"/>
                <a:gd name="connsiteX150" fmla="*/ 171691 w 1179558"/>
                <a:gd name="connsiteY150" fmla="*/ 499641 h 574876"/>
                <a:gd name="connsiteX151" fmla="*/ 169762 w 1179558"/>
                <a:gd name="connsiteY151" fmla="*/ 493854 h 574876"/>
                <a:gd name="connsiteX152" fmla="*/ 163975 w 1179558"/>
                <a:gd name="connsiteY152" fmla="*/ 486137 h 574876"/>
                <a:gd name="connsiteX153" fmla="*/ 160117 w 1179558"/>
                <a:gd name="connsiteY153" fmla="*/ 472633 h 574876"/>
                <a:gd name="connsiteX154" fmla="*/ 158187 w 1179558"/>
                <a:gd name="connsiteY154" fmla="*/ 466846 h 574876"/>
                <a:gd name="connsiteX155" fmla="*/ 148542 w 1179558"/>
                <a:gd name="connsiteY155" fmla="*/ 457200 h 574876"/>
                <a:gd name="connsiteX156" fmla="*/ 140825 w 1179558"/>
                <a:gd name="connsiteY156" fmla="*/ 447555 h 574876"/>
                <a:gd name="connsiteX157" fmla="*/ 131180 w 1179558"/>
                <a:gd name="connsiteY157" fmla="*/ 441767 h 574876"/>
                <a:gd name="connsiteX158" fmla="*/ 136967 w 1179558"/>
                <a:gd name="connsiteY158" fmla="*/ 412831 h 574876"/>
                <a:gd name="connsiteX159" fmla="*/ 142755 w 1179558"/>
                <a:gd name="connsiteY159" fmla="*/ 407043 h 574876"/>
                <a:gd name="connsiteX160" fmla="*/ 144684 w 1179558"/>
                <a:gd name="connsiteY160" fmla="*/ 401256 h 574876"/>
                <a:gd name="connsiteX161" fmla="*/ 156258 w 1179558"/>
                <a:gd name="connsiteY161" fmla="*/ 385823 h 574876"/>
                <a:gd name="connsiteX162" fmla="*/ 162046 w 1179558"/>
                <a:gd name="connsiteY162" fmla="*/ 362674 h 574876"/>
                <a:gd name="connsiteX163" fmla="*/ 169762 w 1179558"/>
                <a:gd name="connsiteY163" fmla="*/ 341454 h 574876"/>
                <a:gd name="connsiteX164" fmla="*/ 171691 w 1179558"/>
                <a:gd name="connsiteY164" fmla="*/ 331808 h 574876"/>
                <a:gd name="connsiteX165" fmla="*/ 177479 w 1179558"/>
                <a:gd name="connsiteY165" fmla="*/ 320233 h 574876"/>
                <a:gd name="connsiteX166" fmla="*/ 173620 w 1179558"/>
                <a:gd name="connsiteY166" fmla="*/ 306729 h 574876"/>
                <a:gd name="connsiteX167" fmla="*/ 167833 w 1179558"/>
                <a:gd name="connsiteY167" fmla="*/ 304800 h 574876"/>
                <a:gd name="connsiteX168" fmla="*/ 160117 w 1179558"/>
                <a:gd name="connsiteY168" fmla="*/ 300942 h 574876"/>
                <a:gd name="connsiteX169" fmla="*/ 146613 w 1179558"/>
                <a:gd name="connsiteY169" fmla="*/ 293226 h 574876"/>
                <a:gd name="connsiteX170" fmla="*/ 148542 w 1179558"/>
                <a:gd name="connsiteY170" fmla="*/ 275864 h 574876"/>
                <a:gd name="connsiteX171" fmla="*/ 154329 w 1179558"/>
                <a:gd name="connsiteY171" fmla="*/ 272005 h 574876"/>
                <a:gd name="connsiteX172" fmla="*/ 158187 w 1179558"/>
                <a:gd name="connsiteY172" fmla="*/ 266218 h 574876"/>
                <a:gd name="connsiteX173" fmla="*/ 140825 w 1179558"/>
                <a:gd name="connsiteY173" fmla="*/ 264289 h 574876"/>
                <a:gd name="connsiteX174" fmla="*/ 123463 w 1179558"/>
                <a:gd name="connsiteY174" fmla="*/ 260431 h 574876"/>
                <a:gd name="connsiteX175" fmla="*/ 115747 w 1179558"/>
                <a:gd name="connsiteY175" fmla="*/ 254643 h 574876"/>
                <a:gd name="connsiteX176" fmla="*/ 104172 w 1179558"/>
                <a:gd name="connsiteY176" fmla="*/ 256573 h 574876"/>
                <a:gd name="connsiteX177" fmla="*/ 48228 w 1179558"/>
                <a:gd name="connsiteY177" fmla="*/ 254643 h 574876"/>
                <a:gd name="connsiteX178" fmla="*/ 40511 w 1179558"/>
                <a:gd name="connsiteY178" fmla="*/ 252714 h 574876"/>
                <a:gd name="connsiteX179" fmla="*/ 30866 w 1179558"/>
                <a:gd name="connsiteY179" fmla="*/ 250785 h 574876"/>
                <a:gd name="connsiteX180" fmla="*/ 21220 w 1179558"/>
                <a:gd name="connsiteY180" fmla="*/ 241140 h 574876"/>
                <a:gd name="connsiteX181" fmla="*/ 0 w 1179558"/>
                <a:gd name="connsiteY181" fmla="*/ 239210 h 574876"/>
                <a:gd name="connsiteX182" fmla="*/ 7717 w 1179558"/>
                <a:gd name="connsiteY182" fmla="*/ 235352 h 574876"/>
                <a:gd name="connsiteX183" fmla="*/ 23149 w 1179558"/>
                <a:gd name="connsiteY183" fmla="*/ 231494 h 574876"/>
                <a:gd name="connsiteX184" fmla="*/ 63661 w 1179558"/>
                <a:gd name="connsiteY184" fmla="*/ 225707 h 574876"/>
                <a:gd name="connsiteX185" fmla="*/ 86810 w 1179558"/>
                <a:gd name="connsiteY185" fmla="*/ 219919 h 574876"/>
                <a:gd name="connsiteX186" fmla="*/ 102243 w 1179558"/>
                <a:gd name="connsiteY186" fmla="*/ 216061 h 574876"/>
                <a:gd name="connsiteX187" fmla="*/ 163975 w 1179558"/>
                <a:gd name="connsiteY187" fmla="*/ 214132 h 574876"/>
                <a:gd name="connsiteX188" fmla="*/ 181337 w 1179558"/>
                <a:gd name="connsiteY188" fmla="*/ 212203 h 574876"/>
                <a:gd name="connsiteX189" fmla="*/ 194841 w 1179558"/>
                <a:gd name="connsiteY189" fmla="*/ 210274 h 574876"/>
                <a:gd name="connsiteX190" fmla="*/ 200628 w 1179558"/>
                <a:gd name="connsiteY190" fmla="*/ 204486 h 574876"/>
                <a:gd name="connsiteX191" fmla="*/ 210273 w 1179558"/>
                <a:gd name="connsiteY191" fmla="*/ 202557 h 574876"/>
                <a:gd name="connsiteX192" fmla="*/ 225706 w 1179558"/>
                <a:gd name="connsiteY192" fmla="*/ 196770 h 574876"/>
                <a:gd name="connsiteX193" fmla="*/ 237281 w 1179558"/>
                <a:gd name="connsiteY193" fmla="*/ 189054 h 574876"/>
                <a:gd name="connsiteX194" fmla="*/ 246927 w 1179558"/>
                <a:gd name="connsiteY194" fmla="*/ 183266 h 574876"/>
                <a:gd name="connsiteX195" fmla="*/ 250785 w 1179558"/>
                <a:gd name="connsiteY195" fmla="*/ 177479 h 574876"/>
                <a:gd name="connsiteX196" fmla="*/ 262360 w 1179558"/>
                <a:gd name="connsiteY196" fmla="*/ 169762 h 574876"/>
                <a:gd name="connsiteX197" fmla="*/ 268147 w 1179558"/>
                <a:gd name="connsiteY197" fmla="*/ 165904 h 574876"/>
                <a:gd name="connsiteX198" fmla="*/ 273934 w 1179558"/>
                <a:gd name="connsiteY198" fmla="*/ 160117 h 574876"/>
                <a:gd name="connsiteX199" fmla="*/ 281651 w 1179558"/>
                <a:gd name="connsiteY199" fmla="*/ 158188 h 574876"/>
                <a:gd name="connsiteX200" fmla="*/ 285509 w 1179558"/>
                <a:gd name="connsiteY200" fmla="*/ 154329 h 574876"/>
                <a:gd name="connsiteX201" fmla="*/ 306729 w 1179558"/>
                <a:gd name="connsiteY201" fmla="*/ 146613 h 574876"/>
                <a:gd name="connsiteX202" fmla="*/ 312517 w 1179558"/>
                <a:gd name="connsiteY202" fmla="*/ 144684 h 574876"/>
                <a:gd name="connsiteX203" fmla="*/ 326020 w 1179558"/>
                <a:gd name="connsiteY203" fmla="*/ 135038 h 574876"/>
                <a:gd name="connsiteX204" fmla="*/ 335666 w 1179558"/>
                <a:gd name="connsiteY204" fmla="*/ 133109 h 574876"/>
                <a:gd name="connsiteX205" fmla="*/ 341453 w 1179558"/>
                <a:gd name="connsiteY205" fmla="*/ 125393 h 574876"/>
                <a:gd name="connsiteX206" fmla="*/ 351099 w 1179558"/>
                <a:gd name="connsiteY206" fmla="*/ 123464 h 574876"/>
                <a:gd name="connsiteX207" fmla="*/ 356886 w 1179558"/>
                <a:gd name="connsiteY207" fmla="*/ 121535 h 574876"/>
                <a:gd name="connsiteX208" fmla="*/ 368461 w 1179558"/>
                <a:gd name="connsiteY208" fmla="*/ 115747 h 574876"/>
                <a:gd name="connsiteX209" fmla="*/ 374248 w 1179558"/>
                <a:gd name="connsiteY209" fmla="*/ 111889 h 574876"/>
                <a:gd name="connsiteX210" fmla="*/ 389681 w 1179558"/>
                <a:gd name="connsiteY210" fmla="*/ 108031 h 574876"/>
                <a:gd name="connsiteX211" fmla="*/ 399327 w 1179558"/>
                <a:gd name="connsiteY211" fmla="*/ 98385 h 574876"/>
                <a:gd name="connsiteX212" fmla="*/ 405114 w 1179558"/>
                <a:gd name="connsiteY212" fmla="*/ 90669 h 574876"/>
                <a:gd name="connsiteX213" fmla="*/ 414760 w 1179558"/>
                <a:gd name="connsiteY213" fmla="*/ 81023 h 574876"/>
                <a:gd name="connsiteX214" fmla="*/ 424405 w 1179558"/>
                <a:gd name="connsiteY214" fmla="*/ 65590 h 574876"/>
                <a:gd name="connsiteX215" fmla="*/ 428263 w 1179558"/>
                <a:gd name="connsiteY215" fmla="*/ 54016 h 574876"/>
                <a:gd name="connsiteX216" fmla="*/ 428263 w 1179558"/>
                <a:gd name="connsiteY216" fmla="*/ 48228 h 5748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</a:cxnLst>
              <a:rect l="l" t="t" r="r" b="b"/>
              <a:pathLst>
                <a:path w="1179558" h="574876">
                  <a:moveTo>
                    <a:pt x="428263" y="48228"/>
                  </a:moveTo>
                  <a:cubicBezTo>
                    <a:pt x="431478" y="50800"/>
                    <a:pt x="434483" y="53661"/>
                    <a:pt x="437909" y="55945"/>
                  </a:cubicBezTo>
                  <a:cubicBezTo>
                    <a:pt x="440302" y="57540"/>
                    <a:pt x="443232" y="58208"/>
                    <a:pt x="445625" y="59803"/>
                  </a:cubicBezTo>
                  <a:cubicBezTo>
                    <a:pt x="447138" y="60812"/>
                    <a:pt x="448064" y="62525"/>
                    <a:pt x="449484" y="63661"/>
                  </a:cubicBezTo>
                  <a:cubicBezTo>
                    <a:pt x="451294" y="65109"/>
                    <a:pt x="453461" y="66071"/>
                    <a:pt x="455271" y="67519"/>
                  </a:cubicBezTo>
                  <a:cubicBezTo>
                    <a:pt x="456691" y="68655"/>
                    <a:pt x="457502" y="70565"/>
                    <a:pt x="459129" y="71378"/>
                  </a:cubicBezTo>
                  <a:cubicBezTo>
                    <a:pt x="461501" y="72564"/>
                    <a:pt x="464274" y="72664"/>
                    <a:pt x="466846" y="73307"/>
                  </a:cubicBezTo>
                  <a:cubicBezTo>
                    <a:pt x="468775" y="75236"/>
                    <a:pt x="470537" y="77348"/>
                    <a:pt x="472633" y="79094"/>
                  </a:cubicBezTo>
                  <a:cubicBezTo>
                    <a:pt x="478645" y="84104"/>
                    <a:pt x="477792" y="81201"/>
                    <a:pt x="482279" y="86810"/>
                  </a:cubicBezTo>
                  <a:cubicBezTo>
                    <a:pt x="483727" y="88621"/>
                    <a:pt x="484987" y="90585"/>
                    <a:pt x="486137" y="92598"/>
                  </a:cubicBezTo>
                  <a:cubicBezTo>
                    <a:pt x="487564" y="95095"/>
                    <a:pt x="488230" y="98044"/>
                    <a:pt x="489995" y="100314"/>
                  </a:cubicBezTo>
                  <a:cubicBezTo>
                    <a:pt x="492787" y="103903"/>
                    <a:pt x="496913" y="106322"/>
                    <a:pt x="499641" y="109960"/>
                  </a:cubicBezTo>
                  <a:cubicBezTo>
                    <a:pt x="501570" y="112532"/>
                    <a:pt x="502958" y="115618"/>
                    <a:pt x="505428" y="117676"/>
                  </a:cubicBezTo>
                  <a:cubicBezTo>
                    <a:pt x="506990" y="118978"/>
                    <a:pt x="509214" y="119241"/>
                    <a:pt x="511215" y="119605"/>
                  </a:cubicBezTo>
                  <a:cubicBezTo>
                    <a:pt x="516316" y="120533"/>
                    <a:pt x="521504" y="120892"/>
                    <a:pt x="526648" y="121535"/>
                  </a:cubicBezTo>
                  <a:lnTo>
                    <a:pt x="717630" y="119605"/>
                  </a:lnTo>
                  <a:cubicBezTo>
                    <a:pt x="725686" y="119449"/>
                    <a:pt x="725761" y="118454"/>
                    <a:pt x="727276" y="111889"/>
                  </a:cubicBezTo>
                  <a:cubicBezTo>
                    <a:pt x="742679" y="45138"/>
                    <a:pt x="725604" y="112919"/>
                    <a:pt x="733063" y="86810"/>
                  </a:cubicBezTo>
                  <a:cubicBezTo>
                    <a:pt x="733791" y="84261"/>
                    <a:pt x="733806" y="81465"/>
                    <a:pt x="734992" y="79094"/>
                  </a:cubicBezTo>
                  <a:cubicBezTo>
                    <a:pt x="735806" y="77467"/>
                    <a:pt x="737565" y="76522"/>
                    <a:pt x="738851" y="75236"/>
                  </a:cubicBezTo>
                  <a:cubicBezTo>
                    <a:pt x="742246" y="65049"/>
                    <a:pt x="739652" y="71139"/>
                    <a:pt x="748496" y="57874"/>
                  </a:cubicBezTo>
                  <a:cubicBezTo>
                    <a:pt x="749782" y="55945"/>
                    <a:pt x="750105" y="52648"/>
                    <a:pt x="752355" y="52086"/>
                  </a:cubicBezTo>
                  <a:lnTo>
                    <a:pt x="760071" y="50157"/>
                  </a:lnTo>
                  <a:cubicBezTo>
                    <a:pt x="762643" y="46299"/>
                    <a:pt x="764508" y="41862"/>
                    <a:pt x="767787" y="38583"/>
                  </a:cubicBezTo>
                  <a:cubicBezTo>
                    <a:pt x="772012" y="34358"/>
                    <a:pt x="772259" y="34615"/>
                    <a:pt x="775504" y="28937"/>
                  </a:cubicBezTo>
                  <a:cubicBezTo>
                    <a:pt x="783109" y="15628"/>
                    <a:pt x="774784" y="25654"/>
                    <a:pt x="785149" y="17362"/>
                  </a:cubicBezTo>
                  <a:cubicBezTo>
                    <a:pt x="786569" y="16226"/>
                    <a:pt x="787336" y="14220"/>
                    <a:pt x="789008" y="13504"/>
                  </a:cubicBezTo>
                  <a:cubicBezTo>
                    <a:pt x="792022" y="12213"/>
                    <a:pt x="795438" y="12218"/>
                    <a:pt x="798653" y="11575"/>
                  </a:cubicBezTo>
                  <a:cubicBezTo>
                    <a:pt x="818690" y="-1780"/>
                    <a:pt x="799990" y="9320"/>
                    <a:pt x="854598" y="3859"/>
                  </a:cubicBezTo>
                  <a:cubicBezTo>
                    <a:pt x="858053" y="3513"/>
                    <a:pt x="864580" y="1174"/>
                    <a:pt x="868101" y="0"/>
                  </a:cubicBezTo>
                  <a:cubicBezTo>
                    <a:pt x="886106" y="643"/>
                    <a:pt x="904133" y="839"/>
                    <a:pt x="922117" y="1929"/>
                  </a:cubicBezTo>
                  <a:cubicBezTo>
                    <a:pt x="940593" y="3049"/>
                    <a:pt x="924397" y="2935"/>
                    <a:pt x="937549" y="7717"/>
                  </a:cubicBezTo>
                  <a:cubicBezTo>
                    <a:pt x="942532" y="9529"/>
                    <a:pt x="952982" y="11575"/>
                    <a:pt x="952982" y="11575"/>
                  </a:cubicBezTo>
                  <a:cubicBezTo>
                    <a:pt x="954911" y="12861"/>
                    <a:pt x="956696" y="14396"/>
                    <a:pt x="958770" y="15433"/>
                  </a:cubicBezTo>
                  <a:cubicBezTo>
                    <a:pt x="961538" y="16817"/>
                    <a:pt x="969800" y="18673"/>
                    <a:pt x="972273" y="19291"/>
                  </a:cubicBezTo>
                  <a:cubicBezTo>
                    <a:pt x="976865" y="22352"/>
                    <a:pt x="983051" y="26610"/>
                    <a:pt x="987706" y="28937"/>
                  </a:cubicBezTo>
                  <a:cubicBezTo>
                    <a:pt x="989525" y="29846"/>
                    <a:pt x="991474" y="30628"/>
                    <a:pt x="993494" y="30866"/>
                  </a:cubicBezTo>
                  <a:cubicBezTo>
                    <a:pt x="1002457" y="31920"/>
                    <a:pt x="1011499" y="32152"/>
                    <a:pt x="1020501" y="32795"/>
                  </a:cubicBezTo>
                  <a:cubicBezTo>
                    <a:pt x="1021787" y="34081"/>
                    <a:pt x="1022733" y="35840"/>
                    <a:pt x="1024360" y="36654"/>
                  </a:cubicBezTo>
                  <a:cubicBezTo>
                    <a:pt x="1026731" y="37840"/>
                    <a:pt x="1029527" y="37855"/>
                    <a:pt x="1032076" y="38583"/>
                  </a:cubicBezTo>
                  <a:cubicBezTo>
                    <a:pt x="1034031" y="39142"/>
                    <a:pt x="1036044" y="39603"/>
                    <a:pt x="1037863" y="40512"/>
                  </a:cubicBezTo>
                  <a:cubicBezTo>
                    <a:pt x="1039937" y="41549"/>
                    <a:pt x="1041722" y="43084"/>
                    <a:pt x="1043651" y="44370"/>
                  </a:cubicBezTo>
                  <a:cubicBezTo>
                    <a:pt x="1044937" y="46299"/>
                    <a:pt x="1046061" y="48347"/>
                    <a:pt x="1047509" y="50157"/>
                  </a:cubicBezTo>
                  <a:cubicBezTo>
                    <a:pt x="1048645" y="51577"/>
                    <a:pt x="1050431" y="52456"/>
                    <a:pt x="1051367" y="54016"/>
                  </a:cubicBezTo>
                  <a:cubicBezTo>
                    <a:pt x="1058876" y="66532"/>
                    <a:pt x="1047381" y="53890"/>
                    <a:pt x="1057155" y="63661"/>
                  </a:cubicBezTo>
                  <a:cubicBezTo>
                    <a:pt x="1058441" y="68805"/>
                    <a:pt x="1057263" y="75344"/>
                    <a:pt x="1061013" y="79094"/>
                  </a:cubicBezTo>
                  <a:cubicBezTo>
                    <a:pt x="1065281" y="83362"/>
                    <a:pt x="1067972" y="85296"/>
                    <a:pt x="1070658" y="90669"/>
                  </a:cubicBezTo>
                  <a:cubicBezTo>
                    <a:pt x="1073260" y="95873"/>
                    <a:pt x="1071062" y="97084"/>
                    <a:pt x="1076446" y="100314"/>
                  </a:cubicBezTo>
                  <a:cubicBezTo>
                    <a:pt x="1079411" y="102093"/>
                    <a:pt x="1089806" y="103758"/>
                    <a:pt x="1091879" y="104173"/>
                  </a:cubicBezTo>
                  <a:cubicBezTo>
                    <a:pt x="1093808" y="106102"/>
                    <a:pt x="1095396" y="108447"/>
                    <a:pt x="1097666" y="109960"/>
                  </a:cubicBezTo>
                  <a:cubicBezTo>
                    <a:pt x="1099358" y="111088"/>
                    <a:pt x="1101468" y="111448"/>
                    <a:pt x="1103453" y="111889"/>
                  </a:cubicBezTo>
                  <a:cubicBezTo>
                    <a:pt x="1119898" y="115543"/>
                    <a:pt x="1136904" y="114912"/>
                    <a:pt x="1153610" y="115747"/>
                  </a:cubicBezTo>
                  <a:cubicBezTo>
                    <a:pt x="1157876" y="120013"/>
                    <a:pt x="1160570" y="121951"/>
                    <a:pt x="1163256" y="127322"/>
                  </a:cubicBezTo>
                  <a:cubicBezTo>
                    <a:pt x="1164165" y="129141"/>
                    <a:pt x="1164542" y="131180"/>
                    <a:pt x="1165185" y="133109"/>
                  </a:cubicBezTo>
                  <a:cubicBezTo>
                    <a:pt x="1165828" y="143398"/>
                    <a:pt x="1165506" y="153792"/>
                    <a:pt x="1167114" y="163975"/>
                  </a:cubicBezTo>
                  <a:cubicBezTo>
                    <a:pt x="1167476" y="166265"/>
                    <a:pt x="1169935" y="167688"/>
                    <a:pt x="1170972" y="169762"/>
                  </a:cubicBezTo>
                  <a:cubicBezTo>
                    <a:pt x="1171881" y="171581"/>
                    <a:pt x="1172258" y="173621"/>
                    <a:pt x="1172901" y="175550"/>
                  </a:cubicBezTo>
                  <a:cubicBezTo>
                    <a:pt x="1171149" y="252648"/>
                    <a:pt x="1195205" y="247398"/>
                    <a:pt x="1161327" y="266218"/>
                  </a:cubicBezTo>
                  <a:cubicBezTo>
                    <a:pt x="1158813" y="267615"/>
                    <a:pt x="1156412" y="269429"/>
                    <a:pt x="1153610" y="270076"/>
                  </a:cubicBezTo>
                  <a:cubicBezTo>
                    <a:pt x="1147936" y="271385"/>
                    <a:pt x="1142035" y="271362"/>
                    <a:pt x="1136248" y="272005"/>
                  </a:cubicBezTo>
                  <a:cubicBezTo>
                    <a:pt x="1134962" y="273291"/>
                    <a:pt x="1133969" y="274962"/>
                    <a:pt x="1132390" y="275864"/>
                  </a:cubicBezTo>
                  <a:cubicBezTo>
                    <a:pt x="1125741" y="279664"/>
                    <a:pt x="1121925" y="279681"/>
                    <a:pt x="1115028" y="281651"/>
                  </a:cubicBezTo>
                  <a:cubicBezTo>
                    <a:pt x="1113073" y="282210"/>
                    <a:pt x="1111060" y="282671"/>
                    <a:pt x="1109241" y="283580"/>
                  </a:cubicBezTo>
                  <a:cubicBezTo>
                    <a:pt x="1107167" y="284617"/>
                    <a:pt x="1105653" y="286705"/>
                    <a:pt x="1103453" y="287438"/>
                  </a:cubicBezTo>
                  <a:cubicBezTo>
                    <a:pt x="1099742" y="288675"/>
                    <a:pt x="1095737" y="288724"/>
                    <a:pt x="1091879" y="289367"/>
                  </a:cubicBezTo>
                  <a:cubicBezTo>
                    <a:pt x="1086873" y="291036"/>
                    <a:pt x="1081055" y="292850"/>
                    <a:pt x="1076446" y="295155"/>
                  </a:cubicBezTo>
                  <a:cubicBezTo>
                    <a:pt x="1074372" y="296192"/>
                    <a:pt x="1072777" y="298071"/>
                    <a:pt x="1070658" y="299013"/>
                  </a:cubicBezTo>
                  <a:cubicBezTo>
                    <a:pt x="1066942" y="300665"/>
                    <a:pt x="1062942" y="301585"/>
                    <a:pt x="1059084" y="302871"/>
                  </a:cubicBezTo>
                  <a:cubicBezTo>
                    <a:pt x="1057155" y="303514"/>
                    <a:pt x="1055115" y="303890"/>
                    <a:pt x="1053296" y="304800"/>
                  </a:cubicBezTo>
                  <a:cubicBezTo>
                    <a:pt x="1050724" y="306086"/>
                    <a:pt x="1048208" y="307491"/>
                    <a:pt x="1045580" y="308659"/>
                  </a:cubicBezTo>
                  <a:cubicBezTo>
                    <a:pt x="1042416" y="310066"/>
                    <a:pt x="1039188" y="311334"/>
                    <a:pt x="1035934" y="312517"/>
                  </a:cubicBezTo>
                  <a:cubicBezTo>
                    <a:pt x="1032112" y="313907"/>
                    <a:pt x="1024360" y="316375"/>
                    <a:pt x="1024360" y="316375"/>
                  </a:cubicBezTo>
                  <a:cubicBezTo>
                    <a:pt x="1021788" y="318304"/>
                    <a:pt x="1019519" y="320724"/>
                    <a:pt x="1016643" y="322162"/>
                  </a:cubicBezTo>
                  <a:cubicBezTo>
                    <a:pt x="1014272" y="323348"/>
                    <a:pt x="1011476" y="323363"/>
                    <a:pt x="1008927" y="324091"/>
                  </a:cubicBezTo>
                  <a:cubicBezTo>
                    <a:pt x="989555" y="329627"/>
                    <a:pt x="1019541" y="321921"/>
                    <a:pt x="995423" y="327950"/>
                  </a:cubicBezTo>
                  <a:cubicBezTo>
                    <a:pt x="993494" y="329236"/>
                    <a:pt x="991275" y="330169"/>
                    <a:pt x="989636" y="331808"/>
                  </a:cubicBezTo>
                  <a:cubicBezTo>
                    <a:pt x="987996" y="333447"/>
                    <a:pt x="987790" y="336445"/>
                    <a:pt x="985777" y="337595"/>
                  </a:cubicBezTo>
                  <a:cubicBezTo>
                    <a:pt x="982930" y="339222"/>
                    <a:pt x="979347" y="338881"/>
                    <a:pt x="976132" y="339524"/>
                  </a:cubicBezTo>
                  <a:cubicBezTo>
                    <a:pt x="974203" y="340810"/>
                    <a:pt x="972125" y="341899"/>
                    <a:pt x="970344" y="343383"/>
                  </a:cubicBezTo>
                  <a:cubicBezTo>
                    <a:pt x="968248" y="345129"/>
                    <a:pt x="966997" y="347950"/>
                    <a:pt x="964557" y="349170"/>
                  </a:cubicBezTo>
                  <a:cubicBezTo>
                    <a:pt x="961624" y="350636"/>
                    <a:pt x="958126" y="350456"/>
                    <a:pt x="954911" y="351099"/>
                  </a:cubicBezTo>
                  <a:cubicBezTo>
                    <a:pt x="952048" y="355394"/>
                    <a:pt x="951120" y="357605"/>
                    <a:pt x="947195" y="360745"/>
                  </a:cubicBezTo>
                  <a:cubicBezTo>
                    <a:pt x="945385" y="362193"/>
                    <a:pt x="943141" y="363063"/>
                    <a:pt x="941408" y="364603"/>
                  </a:cubicBezTo>
                  <a:cubicBezTo>
                    <a:pt x="937330" y="368228"/>
                    <a:pt x="934094" y="372770"/>
                    <a:pt x="929833" y="376178"/>
                  </a:cubicBezTo>
                  <a:cubicBezTo>
                    <a:pt x="926618" y="378750"/>
                    <a:pt x="923286" y="381183"/>
                    <a:pt x="920187" y="383894"/>
                  </a:cubicBezTo>
                  <a:cubicBezTo>
                    <a:pt x="918134" y="385690"/>
                    <a:pt x="916496" y="387934"/>
                    <a:pt x="914400" y="389681"/>
                  </a:cubicBezTo>
                  <a:cubicBezTo>
                    <a:pt x="912619" y="391165"/>
                    <a:pt x="910346" y="392000"/>
                    <a:pt x="908613" y="393540"/>
                  </a:cubicBezTo>
                  <a:cubicBezTo>
                    <a:pt x="904535" y="397165"/>
                    <a:pt x="900896" y="401256"/>
                    <a:pt x="897038" y="405114"/>
                  </a:cubicBezTo>
                  <a:lnTo>
                    <a:pt x="893180" y="408973"/>
                  </a:lnTo>
                  <a:cubicBezTo>
                    <a:pt x="892562" y="411445"/>
                    <a:pt x="890706" y="419709"/>
                    <a:pt x="889322" y="422476"/>
                  </a:cubicBezTo>
                  <a:cubicBezTo>
                    <a:pt x="885729" y="429661"/>
                    <a:pt x="885009" y="427651"/>
                    <a:pt x="879676" y="434051"/>
                  </a:cubicBezTo>
                  <a:cubicBezTo>
                    <a:pt x="878192" y="435832"/>
                    <a:pt x="877104" y="437909"/>
                    <a:pt x="875818" y="439838"/>
                  </a:cubicBezTo>
                  <a:cubicBezTo>
                    <a:pt x="873246" y="437909"/>
                    <a:pt x="870194" y="436492"/>
                    <a:pt x="868101" y="434051"/>
                  </a:cubicBezTo>
                  <a:cubicBezTo>
                    <a:pt x="864994" y="430427"/>
                    <a:pt x="864396" y="423756"/>
                    <a:pt x="860385" y="420547"/>
                  </a:cubicBezTo>
                  <a:cubicBezTo>
                    <a:pt x="858797" y="419277"/>
                    <a:pt x="856527" y="419261"/>
                    <a:pt x="854598" y="418618"/>
                  </a:cubicBezTo>
                  <a:cubicBezTo>
                    <a:pt x="853312" y="416689"/>
                    <a:pt x="852379" y="414470"/>
                    <a:pt x="850739" y="412831"/>
                  </a:cubicBezTo>
                  <a:cubicBezTo>
                    <a:pt x="847000" y="409092"/>
                    <a:pt x="843871" y="408612"/>
                    <a:pt x="839165" y="407043"/>
                  </a:cubicBezTo>
                  <a:cubicBezTo>
                    <a:pt x="828570" y="391155"/>
                    <a:pt x="842423" y="409364"/>
                    <a:pt x="829519" y="399327"/>
                  </a:cubicBezTo>
                  <a:cubicBezTo>
                    <a:pt x="825212" y="395977"/>
                    <a:pt x="821218" y="392117"/>
                    <a:pt x="817944" y="387752"/>
                  </a:cubicBezTo>
                  <a:cubicBezTo>
                    <a:pt x="816015" y="385180"/>
                    <a:pt x="814560" y="382172"/>
                    <a:pt x="812157" y="380036"/>
                  </a:cubicBezTo>
                  <a:cubicBezTo>
                    <a:pt x="804196" y="372960"/>
                    <a:pt x="802655" y="373010"/>
                    <a:pt x="794795" y="370390"/>
                  </a:cubicBezTo>
                  <a:cubicBezTo>
                    <a:pt x="783102" y="352850"/>
                    <a:pt x="802234" y="379759"/>
                    <a:pt x="781291" y="358816"/>
                  </a:cubicBezTo>
                  <a:cubicBezTo>
                    <a:pt x="778012" y="355537"/>
                    <a:pt x="777433" y="349813"/>
                    <a:pt x="773575" y="347241"/>
                  </a:cubicBezTo>
                  <a:lnTo>
                    <a:pt x="762000" y="339524"/>
                  </a:lnTo>
                  <a:cubicBezTo>
                    <a:pt x="760714" y="337595"/>
                    <a:pt x="760108" y="334966"/>
                    <a:pt x="758142" y="333737"/>
                  </a:cubicBezTo>
                  <a:cubicBezTo>
                    <a:pt x="751284" y="329451"/>
                    <a:pt x="735947" y="328305"/>
                    <a:pt x="729205" y="327950"/>
                  </a:cubicBezTo>
                  <a:cubicBezTo>
                    <a:pt x="710572" y="326969"/>
                    <a:pt x="691909" y="326664"/>
                    <a:pt x="673261" y="326021"/>
                  </a:cubicBezTo>
                  <a:cubicBezTo>
                    <a:pt x="644779" y="316524"/>
                    <a:pt x="663561" y="322162"/>
                    <a:pt x="594167" y="322162"/>
                  </a:cubicBezTo>
                  <a:cubicBezTo>
                    <a:pt x="579363" y="322162"/>
                    <a:pt x="564588" y="323448"/>
                    <a:pt x="549798" y="324091"/>
                  </a:cubicBezTo>
                  <a:cubicBezTo>
                    <a:pt x="544173" y="325967"/>
                    <a:pt x="541742" y="326474"/>
                    <a:pt x="536294" y="329879"/>
                  </a:cubicBezTo>
                  <a:cubicBezTo>
                    <a:pt x="533567" y="331583"/>
                    <a:pt x="531193" y="333797"/>
                    <a:pt x="528577" y="335666"/>
                  </a:cubicBezTo>
                  <a:cubicBezTo>
                    <a:pt x="526690" y="337013"/>
                    <a:pt x="524645" y="338133"/>
                    <a:pt x="522790" y="339524"/>
                  </a:cubicBezTo>
                  <a:cubicBezTo>
                    <a:pt x="519496" y="341995"/>
                    <a:pt x="516474" y="344819"/>
                    <a:pt x="513144" y="347241"/>
                  </a:cubicBezTo>
                  <a:cubicBezTo>
                    <a:pt x="509394" y="349968"/>
                    <a:pt x="505279" y="352175"/>
                    <a:pt x="501570" y="354957"/>
                  </a:cubicBezTo>
                  <a:cubicBezTo>
                    <a:pt x="489786" y="363795"/>
                    <a:pt x="508651" y="353346"/>
                    <a:pt x="489995" y="362674"/>
                  </a:cubicBezTo>
                  <a:cubicBezTo>
                    <a:pt x="476648" y="382694"/>
                    <a:pt x="498003" y="352736"/>
                    <a:pt x="478420" y="372319"/>
                  </a:cubicBezTo>
                  <a:cubicBezTo>
                    <a:pt x="475141" y="375598"/>
                    <a:pt x="474414" y="381112"/>
                    <a:pt x="470704" y="383894"/>
                  </a:cubicBezTo>
                  <a:lnTo>
                    <a:pt x="462987" y="389681"/>
                  </a:lnTo>
                  <a:cubicBezTo>
                    <a:pt x="458139" y="404228"/>
                    <a:pt x="465242" y="386863"/>
                    <a:pt x="455271" y="399327"/>
                  </a:cubicBezTo>
                  <a:cubicBezTo>
                    <a:pt x="454001" y="400915"/>
                    <a:pt x="454251" y="403295"/>
                    <a:pt x="453342" y="405114"/>
                  </a:cubicBezTo>
                  <a:cubicBezTo>
                    <a:pt x="450655" y="410488"/>
                    <a:pt x="447965" y="412420"/>
                    <a:pt x="443696" y="416689"/>
                  </a:cubicBezTo>
                  <a:cubicBezTo>
                    <a:pt x="439322" y="434183"/>
                    <a:pt x="445943" y="413325"/>
                    <a:pt x="432122" y="434051"/>
                  </a:cubicBezTo>
                  <a:cubicBezTo>
                    <a:pt x="430836" y="435980"/>
                    <a:pt x="430229" y="438609"/>
                    <a:pt x="428263" y="439838"/>
                  </a:cubicBezTo>
                  <a:cubicBezTo>
                    <a:pt x="424814" y="441993"/>
                    <a:pt x="420634" y="442711"/>
                    <a:pt x="416689" y="443697"/>
                  </a:cubicBezTo>
                  <a:cubicBezTo>
                    <a:pt x="382611" y="452217"/>
                    <a:pt x="407586" y="444159"/>
                    <a:pt x="391610" y="449484"/>
                  </a:cubicBezTo>
                  <a:cubicBezTo>
                    <a:pt x="389681" y="450770"/>
                    <a:pt x="387897" y="452305"/>
                    <a:pt x="385823" y="453342"/>
                  </a:cubicBezTo>
                  <a:cubicBezTo>
                    <a:pt x="381868" y="455319"/>
                    <a:pt x="374059" y="456466"/>
                    <a:pt x="370390" y="457200"/>
                  </a:cubicBezTo>
                  <a:cubicBezTo>
                    <a:pt x="351395" y="464799"/>
                    <a:pt x="368443" y="457211"/>
                    <a:pt x="354957" y="464917"/>
                  </a:cubicBezTo>
                  <a:cubicBezTo>
                    <a:pt x="344056" y="471146"/>
                    <a:pt x="350260" y="465757"/>
                    <a:pt x="343382" y="472633"/>
                  </a:cubicBezTo>
                  <a:cubicBezTo>
                    <a:pt x="342096" y="484851"/>
                    <a:pt x="341721" y="497199"/>
                    <a:pt x="339524" y="509286"/>
                  </a:cubicBezTo>
                  <a:cubicBezTo>
                    <a:pt x="339109" y="511567"/>
                    <a:pt x="336703" y="513000"/>
                    <a:pt x="335666" y="515074"/>
                  </a:cubicBezTo>
                  <a:cubicBezTo>
                    <a:pt x="334757" y="516893"/>
                    <a:pt x="334919" y="519206"/>
                    <a:pt x="333737" y="520861"/>
                  </a:cubicBezTo>
                  <a:cubicBezTo>
                    <a:pt x="331623" y="523821"/>
                    <a:pt x="328387" y="525816"/>
                    <a:pt x="326020" y="528578"/>
                  </a:cubicBezTo>
                  <a:cubicBezTo>
                    <a:pt x="324511" y="530338"/>
                    <a:pt x="323448" y="532436"/>
                    <a:pt x="322162" y="534365"/>
                  </a:cubicBezTo>
                  <a:cubicBezTo>
                    <a:pt x="321519" y="536937"/>
                    <a:pt x="320707" y="539473"/>
                    <a:pt x="320233" y="542081"/>
                  </a:cubicBezTo>
                  <a:cubicBezTo>
                    <a:pt x="319420" y="546555"/>
                    <a:pt x="320151" y="551430"/>
                    <a:pt x="318304" y="555585"/>
                  </a:cubicBezTo>
                  <a:cubicBezTo>
                    <a:pt x="317362" y="557704"/>
                    <a:pt x="314446" y="558157"/>
                    <a:pt x="312517" y="559443"/>
                  </a:cubicBezTo>
                  <a:cubicBezTo>
                    <a:pt x="312501" y="559508"/>
                    <a:pt x="309580" y="572025"/>
                    <a:pt x="308658" y="572947"/>
                  </a:cubicBezTo>
                  <a:cubicBezTo>
                    <a:pt x="307220" y="574385"/>
                    <a:pt x="304800" y="574233"/>
                    <a:pt x="302871" y="574876"/>
                  </a:cubicBezTo>
                  <a:cubicBezTo>
                    <a:pt x="278966" y="572486"/>
                    <a:pt x="288957" y="576531"/>
                    <a:pt x="272005" y="565231"/>
                  </a:cubicBezTo>
                  <a:lnTo>
                    <a:pt x="272005" y="565231"/>
                  </a:lnTo>
                  <a:lnTo>
                    <a:pt x="260430" y="561373"/>
                  </a:lnTo>
                  <a:cubicBezTo>
                    <a:pt x="257858" y="558801"/>
                    <a:pt x="255476" y="556023"/>
                    <a:pt x="252714" y="553656"/>
                  </a:cubicBezTo>
                  <a:cubicBezTo>
                    <a:pt x="250954" y="552147"/>
                    <a:pt x="249001" y="550835"/>
                    <a:pt x="246927" y="549798"/>
                  </a:cubicBezTo>
                  <a:cubicBezTo>
                    <a:pt x="242973" y="547821"/>
                    <a:pt x="235161" y="546673"/>
                    <a:pt x="231494" y="545940"/>
                  </a:cubicBezTo>
                  <a:cubicBezTo>
                    <a:pt x="222149" y="536593"/>
                    <a:pt x="235131" y="548151"/>
                    <a:pt x="217990" y="540152"/>
                  </a:cubicBezTo>
                  <a:cubicBezTo>
                    <a:pt x="211195" y="536981"/>
                    <a:pt x="206052" y="530049"/>
                    <a:pt x="198699" y="528578"/>
                  </a:cubicBezTo>
                  <a:cubicBezTo>
                    <a:pt x="195484" y="527935"/>
                    <a:pt x="192234" y="527443"/>
                    <a:pt x="189053" y="526648"/>
                  </a:cubicBezTo>
                  <a:cubicBezTo>
                    <a:pt x="187080" y="526155"/>
                    <a:pt x="185221" y="525278"/>
                    <a:pt x="183266" y="524719"/>
                  </a:cubicBezTo>
                  <a:cubicBezTo>
                    <a:pt x="180717" y="523991"/>
                    <a:pt x="178121" y="523433"/>
                    <a:pt x="175549" y="522790"/>
                  </a:cubicBezTo>
                  <a:cubicBezTo>
                    <a:pt x="173983" y="510265"/>
                    <a:pt x="174523" y="509554"/>
                    <a:pt x="171691" y="499641"/>
                  </a:cubicBezTo>
                  <a:cubicBezTo>
                    <a:pt x="171132" y="497686"/>
                    <a:pt x="170771" y="495619"/>
                    <a:pt x="169762" y="493854"/>
                  </a:cubicBezTo>
                  <a:cubicBezTo>
                    <a:pt x="168167" y="491062"/>
                    <a:pt x="165904" y="488709"/>
                    <a:pt x="163975" y="486137"/>
                  </a:cubicBezTo>
                  <a:cubicBezTo>
                    <a:pt x="159343" y="472242"/>
                    <a:pt x="164970" y="489615"/>
                    <a:pt x="160117" y="472633"/>
                  </a:cubicBezTo>
                  <a:cubicBezTo>
                    <a:pt x="159558" y="470678"/>
                    <a:pt x="159407" y="468473"/>
                    <a:pt x="158187" y="466846"/>
                  </a:cubicBezTo>
                  <a:cubicBezTo>
                    <a:pt x="155459" y="463208"/>
                    <a:pt x="151064" y="460983"/>
                    <a:pt x="148542" y="457200"/>
                  </a:cubicBezTo>
                  <a:cubicBezTo>
                    <a:pt x="146221" y="453719"/>
                    <a:pt x="144326" y="450056"/>
                    <a:pt x="140825" y="447555"/>
                  </a:cubicBezTo>
                  <a:cubicBezTo>
                    <a:pt x="137774" y="445376"/>
                    <a:pt x="134395" y="443696"/>
                    <a:pt x="131180" y="441767"/>
                  </a:cubicBezTo>
                  <a:cubicBezTo>
                    <a:pt x="132545" y="425385"/>
                    <a:pt x="129040" y="422343"/>
                    <a:pt x="136967" y="412831"/>
                  </a:cubicBezTo>
                  <a:cubicBezTo>
                    <a:pt x="138714" y="410735"/>
                    <a:pt x="140826" y="408972"/>
                    <a:pt x="142755" y="407043"/>
                  </a:cubicBezTo>
                  <a:cubicBezTo>
                    <a:pt x="143398" y="405114"/>
                    <a:pt x="143775" y="403075"/>
                    <a:pt x="144684" y="401256"/>
                  </a:cubicBezTo>
                  <a:cubicBezTo>
                    <a:pt x="146731" y="397163"/>
                    <a:pt x="154367" y="388187"/>
                    <a:pt x="156258" y="385823"/>
                  </a:cubicBezTo>
                  <a:cubicBezTo>
                    <a:pt x="166752" y="354346"/>
                    <a:pt x="154257" y="393831"/>
                    <a:pt x="162046" y="362674"/>
                  </a:cubicBezTo>
                  <a:cubicBezTo>
                    <a:pt x="163698" y="356067"/>
                    <a:pt x="167204" y="347848"/>
                    <a:pt x="169762" y="341454"/>
                  </a:cubicBezTo>
                  <a:cubicBezTo>
                    <a:pt x="170405" y="338239"/>
                    <a:pt x="170570" y="334890"/>
                    <a:pt x="171691" y="331808"/>
                  </a:cubicBezTo>
                  <a:cubicBezTo>
                    <a:pt x="173165" y="327754"/>
                    <a:pt x="177148" y="324534"/>
                    <a:pt x="177479" y="320233"/>
                  </a:cubicBezTo>
                  <a:cubicBezTo>
                    <a:pt x="177838" y="315565"/>
                    <a:pt x="176101" y="310699"/>
                    <a:pt x="173620" y="306729"/>
                  </a:cubicBezTo>
                  <a:cubicBezTo>
                    <a:pt x="172542" y="305005"/>
                    <a:pt x="169702" y="305601"/>
                    <a:pt x="167833" y="304800"/>
                  </a:cubicBezTo>
                  <a:cubicBezTo>
                    <a:pt x="165190" y="303667"/>
                    <a:pt x="162457" y="302613"/>
                    <a:pt x="160117" y="300942"/>
                  </a:cubicBezTo>
                  <a:cubicBezTo>
                    <a:pt x="147740" y="292102"/>
                    <a:pt x="161557" y="296962"/>
                    <a:pt x="146613" y="293226"/>
                  </a:cubicBezTo>
                  <a:cubicBezTo>
                    <a:pt x="144083" y="285635"/>
                    <a:pt x="142671" y="285258"/>
                    <a:pt x="148542" y="275864"/>
                  </a:cubicBezTo>
                  <a:cubicBezTo>
                    <a:pt x="149771" y="273898"/>
                    <a:pt x="152400" y="273291"/>
                    <a:pt x="154329" y="272005"/>
                  </a:cubicBezTo>
                  <a:cubicBezTo>
                    <a:pt x="155615" y="270076"/>
                    <a:pt x="160200" y="267368"/>
                    <a:pt x="158187" y="266218"/>
                  </a:cubicBezTo>
                  <a:cubicBezTo>
                    <a:pt x="153131" y="263329"/>
                    <a:pt x="146589" y="265112"/>
                    <a:pt x="140825" y="264289"/>
                  </a:cubicBezTo>
                  <a:cubicBezTo>
                    <a:pt x="135113" y="263473"/>
                    <a:pt x="129078" y="261834"/>
                    <a:pt x="123463" y="260431"/>
                  </a:cubicBezTo>
                  <a:cubicBezTo>
                    <a:pt x="120891" y="258502"/>
                    <a:pt x="118900" y="255274"/>
                    <a:pt x="115747" y="254643"/>
                  </a:cubicBezTo>
                  <a:cubicBezTo>
                    <a:pt x="111911" y="253876"/>
                    <a:pt x="108084" y="256573"/>
                    <a:pt x="104172" y="256573"/>
                  </a:cubicBezTo>
                  <a:cubicBezTo>
                    <a:pt x="85513" y="256573"/>
                    <a:pt x="66876" y="255286"/>
                    <a:pt x="48228" y="254643"/>
                  </a:cubicBezTo>
                  <a:cubicBezTo>
                    <a:pt x="45656" y="254000"/>
                    <a:pt x="43099" y="253289"/>
                    <a:pt x="40511" y="252714"/>
                  </a:cubicBezTo>
                  <a:cubicBezTo>
                    <a:pt x="37310" y="252003"/>
                    <a:pt x="33713" y="252412"/>
                    <a:pt x="30866" y="250785"/>
                  </a:cubicBezTo>
                  <a:cubicBezTo>
                    <a:pt x="22118" y="245786"/>
                    <a:pt x="32542" y="243566"/>
                    <a:pt x="21220" y="241140"/>
                  </a:cubicBezTo>
                  <a:cubicBezTo>
                    <a:pt x="14275" y="239652"/>
                    <a:pt x="7073" y="239853"/>
                    <a:pt x="0" y="239210"/>
                  </a:cubicBezTo>
                  <a:cubicBezTo>
                    <a:pt x="2572" y="237924"/>
                    <a:pt x="4989" y="236261"/>
                    <a:pt x="7717" y="235352"/>
                  </a:cubicBezTo>
                  <a:cubicBezTo>
                    <a:pt x="12747" y="233675"/>
                    <a:pt x="17950" y="232534"/>
                    <a:pt x="23149" y="231494"/>
                  </a:cubicBezTo>
                  <a:cubicBezTo>
                    <a:pt x="41206" y="227883"/>
                    <a:pt x="46590" y="227604"/>
                    <a:pt x="63661" y="225707"/>
                  </a:cubicBezTo>
                  <a:cubicBezTo>
                    <a:pt x="75955" y="221609"/>
                    <a:pt x="64889" y="225077"/>
                    <a:pt x="86810" y="219919"/>
                  </a:cubicBezTo>
                  <a:cubicBezTo>
                    <a:pt x="91972" y="218704"/>
                    <a:pt x="96955" y="216458"/>
                    <a:pt x="102243" y="216061"/>
                  </a:cubicBezTo>
                  <a:cubicBezTo>
                    <a:pt x="122773" y="214521"/>
                    <a:pt x="143398" y="214775"/>
                    <a:pt x="163975" y="214132"/>
                  </a:cubicBezTo>
                  <a:lnTo>
                    <a:pt x="181337" y="212203"/>
                  </a:lnTo>
                  <a:cubicBezTo>
                    <a:pt x="185849" y="211639"/>
                    <a:pt x="190619" y="211963"/>
                    <a:pt x="194841" y="210274"/>
                  </a:cubicBezTo>
                  <a:cubicBezTo>
                    <a:pt x="197374" y="209261"/>
                    <a:pt x="198188" y="205706"/>
                    <a:pt x="200628" y="204486"/>
                  </a:cubicBezTo>
                  <a:cubicBezTo>
                    <a:pt x="203560" y="203020"/>
                    <a:pt x="207092" y="203352"/>
                    <a:pt x="210273" y="202557"/>
                  </a:cubicBezTo>
                  <a:cubicBezTo>
                    <a:pt x="214309" y="201548"/>
                    <a:pt x="222750" y="197952"/>
                    <a:pt x="225706" y="196770"/>
                  </a:cubicBezTo>
                  <a:cubicBezTo>
                    <a:pt x="234558" y="187920"/>
                    <a:pt x="223259" y="198403"/>
                    <a:pt x="237281" y="189054"/>
                  </a:cubicBezTo>
                  <a:cubicBezTo>
                    <a:pt x="247873" y="181992"/>
                    <a:pt x="233492" y="187744"/>
                    <a:pt x="246927" y="183266"/>
                  </a:cubicBezTo>
                  <a:cubicBezTo>
                    <a:pt x="248213" y="181337"/>
                    <a:pt x="249040" y="179006"/>
                    <a:pt x="250785" y="177479"/>
                  </a:cubicBezTo>
                  <a:cubicBezTo>
                    <a:pt x="254275" y="174425"/>
                    <a:pt x="258502" y="172334"/>
                    <a:pt x="262360" y="169762"/>
                  </a:cubicBezTo>
                  <a:cubicBezTo>
                    <a:pt x="264289" y="168476"/>
                    <a:pt x="266508" y="167543"/>
                    <a:pt x="268147" y="165904"/>
                  </a:cubicBezTo>
                  <a:cubicBezTo>
                    <a:pt x="270076" y="163975"/>
                    <a:pt x="271565" y="161470"/>
                    <a:pt x="273934" y="160117"/>
                  </a:cubicBezTo>
                  <a:cubicBezTo>
                    <a:pt x="276236" y="158802"/>
                    <a:pt x="279079" y="158831"/>
                    <a:pt x="281651" y="158188"/>
                  </a:cubicBezTo>
                  <a:cubicBezTo>
                    <a:pt x="282937" y="156902"/>
                    <a:pt x="283930" y="155231"/>
                    <a:pt x="285509" y="154329"/>
                  </a:cubicBezTo>
                  <a:cubicBezTo>
                    <a:pt x="289264" y="152183"/>
                    <a:pt x="303222" y="147782"/>
                    <a:pt x="306729" y="146613"/>
                  </a:cubicBezTo>
                  <a:lnTo>
                    <a:pt x="312517" y="144684"/>
                  </a:lnTo>
                  <a:cubicBezTo>
                    <a:pt x="312957" y="144354"/>
                    <a:pt x="324143" y="135742"/>
                    <a:pt x="326020" y="135038"/>
                  </a:cubicBezTo>
                  <a:cubicBezTo>
                    <a:pt x="329090" y="133887"/>
                    <a:pt x="332451" y="133752"/>
                    <a:pt x="335666" y="133109"/>
                  </a:cubicBezTo>
                  <a:cubicBezTo>
                    <a:pt x="337595" y="130537"/>
                    <a:pt x="338727" y="127097"/>
                    <a:pt x="341453" y="125393"/>
                  </a:cubicBezTo>
                  <a:cubicBezTo>
                    <a:pt x="344234" y="123655"/>
                    <a:pt x="347918" y="124259"/>
                    <a:pt x="351099" y="123464"/>
                  </a:cubicBezTo>
                  <a:cubicBezTo>
                    <a:pt x="353072" y="122971"/>
                    <a:pt x="354957" y="122178"/>
                    <a:pt x="356886" y="121535"/>
                  </a:cubicBezTo>
                  <a:cubicBezTo>
                    <a:pt x="373461" y="110482"/>
                    <a:pt x="352495" y="123729"/>
                    <a:pt x="368461" y="115747"/>
                  </a:cubicBezTo>
                  <a:cubicBezTo>
                    <a:pt x="370535" y="114710"/>
                    <a:pt x="372069" y="112681"/>
                    <a:pt x="374248" y="111889"/>
                  </a:cubicBezTo>
                  <a:cubicBezTo>
                    <a:pt x="379231" y="110077"/>
                    <a:pt x="384537" y="109317"/>
                    <a:pt x="389681" y="108031"/>
                  </a:cubicBezTo>
                  <a:cubicBezTo>
                    <a:pt x="399967" y="92600"/>
                    <a:pt x="386468" y="111243"/>
                    <a:pt x="399327" y="98385"/>
                  </a:cubicBezTo>
                  <a:cubicBezTo>
                    <a:pt x="401600" y="96112"/>
                    <a:pt x="402978" y="93072"/>
                    <a:pt x="405114" y="90669"/>
                  </a:cubicBezTo>
                  <a:cubicBezTo>
                    <a:pt x="408135" y="87270"/>
                    <a:pt x="414760" y="81023"/>
                    <a:pt x="414760" y="81023"/>
                  </a:cubicBezTo>
                  <a:cubicBezTo>
                    <a:pt x="420210" y="64673"/>
                    <a:pt x="410926" y="90303"/>
                    <a:pt x="424405" y="65590"/>
                  </a:cubicBezTo>
                  <a:cubicBezTo>
                    <a:pt x="426352" y="62020"/>
                    <a:pt x="425387" y="56892"/>
                    <a:pt x="428263" y="54016"/>
                  </a:cubicBezTo>
                  <a:lnTo>
                    <a:pt x="428263" y="48228"/>
                  </a:lnTo>
                  <a:close/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フリーフォーム: 図形 28">
              <a:extLst>
                <a:ext uri="{FF2B5EF4-FFF2-40B4-BE49-F238E27FC236}">
                  <a16:creationId xmlns:a16="http://schemas.microsoft.com/office/drawing/2014/main" id="{4C1E56BB-6A66-46E4-A91F-376AFE08DC49}"/>
                </a:ext>
              </a:extLst>
            </p:cNvPr>
            <p:cNvSpPr/>
            <p:nvPr/>
          </p:nvSpPr>
          <p:spPr>
            <a:xfrm>
              <a:off x="1070459" y="4593155"/>
              <a:ext cx="1047708" cy="1145588"/>
            </a:xfrm>
            <a:custGeom>
              <a:avLst/>
              <a:gdLst>
                <a:gd name="connsiteX0" fmla="*/ 79293 w 1047708"/>
                <a:gd name="connsiteY0" fmla="*/ 111954 h 1145588"/>
                <a:gd name="connsiteX1" fmla="*/ 83151 w 1047708"/>
                <a:gd name="connsiteY1" fmla="*/ 123529 h 1145588"/>
                <a:gd name="connsiteX2" fmla="*/ 92797 w 1047708"/>
                <a:gd name="connsiteY2" fmla="*/ 154394 h 1145588"/>
                <a:gd name="connsiteX3" fmla="*/ 127521 w 1047708"/>
                <a:gd name="connsiteY3" fmla="*/ 156323 h 1145588"/>
                <a:gd name="connsiteX4" fmla="*/ 135237 w 1047708"/>
                <a:gd name="connsiteY4" fmla="*/ 150536 h 1145588"/>
                <a:gd name="connsiteX5" fmla="*/ 148741 w 1047708"/>
                <a:gd name="connsiteY5" fmla="*/ 142820 h 1145588"/>
                <a:gd name="connsiteX6" fmla="*/ 152599 w 1047708"/>
                <a:gd name="connsiteY6" fmla="*/ 138961 h 1145588"/>
                <a:gd name="connsiteX7" fmla="*/ 158387 w 1047708"/>
                <a:gd name="connsiteY7" fmla="*/ 135103 h 1145588"/>
                <a:gd name="connsiteX8" fmla="*/ 168032 w 1047708"/>
                <a:gd name="connsiteY8" fmla="*/ 123529 h 1145588"/>
                <a:gd name="connsiteX9" fmla="*/ 175749 w 1047708"/>
                <a:gd name="connsiteY9" fmla="*/ 113883 h 1145588"/>
                <a:gd name="connsiteX10" fmla="*/ 179607 w 1047708"/>
                <a:gd name="connsiteY10" fmla="*/ 98450 h 1145588"/>
                <a:gd name="connsiteX11" fmla="*/ 196969 w 1047708"/>
                <a:gd name="connsiteY11" fmla="*/ 88804 h 1145588"/>
                <a:gd name="connsiteX12" fmla="*/ 243268 w 1047708"/>
                <a:gd name="connsiteY12" fmla="*/ 90734 h 1145588"/>
                <a:gd name="connsiteX13" fmla="*/ 247126 w 1047708"/>
                <a:gd name="connsiteY13" fmla="*/ 100379 h 1145588"/>
                <a:gd name="connsiteX14" fmla="*/ 250984 w 1047708"/>
                <a:gd name="connsiteY14" fmla="*/ 117741 h 1145588"/>
                <a:gd name="connsiteX15" fmla="*/ 258700 w 1047708"/>
                <a:gd name="connsiteY15" fmla="*/ 123529 h 1145588"/>
                <a:gd name="connsiteX16" fmla="*/ 291495 w 1047708"/>
                <a:gd name="connsiteY16" fmla="*/ 125458 h 1145588"/>
                <a:gd name="connsiteX17" fmla="*/ 301141 w 1047708"/>
                <a:gd name="connsiteY17" fmla="*/ 133174 h 1145588"/>
                <a:gd name="connsiteX18" fmla="*/ 306928 w 1047708"/>
                <a:gd name="connsiteY18" fmla="*/ 135103 h 1145588"/>
                <a:gd name="connsiteX19" fmla="*/ 320432 w 1047708"/>
                <a:gd name="connsiteY19" fmla="*/ 131245 h 1145588"/>
                <a:gd name="connsiteX20" fmla="*/ 337794 w 1047708"/>
                <a:gd name="connsiteY20" fmla="*/ 115812 h 1145588"/>
                <a:gd name="connsiteX21" fmla="*/ 349369 w 1047708"/>
                <a:gd name="connsiteY21" fmla="*/ 104237 h 1145588"/>
                <a:gd name="connsiteX22" fmla="*/ 353227 w 1047708"/>
                <a:gd name="connsiteY22" fmla="*/ 98450 h 1145588"/>
                <a:gd name="connsiteX23" fmla="*/ 355156 w 1047708"/>
                <a:gd name="connsiteY23" fmla="*/ 90734 h 1145588"/>
                <a:gd name="connsiteX24" fmla="*/ 362873 w 1047708"/>
                <a:gd name="connsiteY24" fmla="*/ 77230 h 1145588"/>
                <a:gd name="connsiteX25" fmla="*/ 372518 w 1047708"/>
                <a:gd name="connsiteY25" fmla="*/ 88804 h 1145588"/>
                <a:gd name="connsiteX26" fmla="*/ 386022 w 1047708"/>
                <a:gd name="connsiteY26" fmla="*/ 100379 h 1145588"/>
                <a:gd name="connsiteX27" fmla="*/ 453541 w 1047708"/>
                <a:gd name="connsiteY27" fmla="*/ 98450 h 1145588"/>
                <a:gd name="connsiteX28" fmla="*/ 457399 w 1047708"/>
                <a:gd name="connsiteY28" fmla="*/ 90734 h 1145588"/>
                <a:gd name="connsiteX29" fmla="*/ 463187 w 1047708"/>
                <a:gd name="connsiteY29" fmla="*/ 86875 h 1145588"/>
                <a:gd name="connsiteX30" fmla="*/ 468974 w 1047708"/>
                <a:gd name="connsiteY30" fmla="*/ 81088 h 1145588"/>
                <a:gd name="connsiteX31" fmla="*/ 478619 w 1047708"/>
                <a:gd name="connsiteY31" fmla="*/ 65655 h 1145588"/>
                <a:gd name="connsiteX32" fmla="*/ 482478 w 1047708"/>
                <a:gd name="connsiteY32" fmla="*/ 59868 h 1145588"/>
                <a:gd name="connsiteX33" fmla="*/ 490194 w 1047708"/>
                <a:gd name="connsiteY33" fmla="*/ 54080 h 1145588"/>
                <a:gd name="connsiteX34" fmla="*/ 507556 w 1047708"/>
                <a:gd name="connsiteY34" fmla="*/ 44435 h 1145588"/>
                <a:gd name="connsiteX35" fmla="*/ 521060 w 1047708"/>
                <a:gd name="connsiteY35" fmla="*/ 40577 h 1145588"/>
                <a:gd name="connsiteX36" fmla="*/ 538422 w 1047708"/>
                <a:gd name="connsiteY36" fmla="*/ 34789 h 1145588"/>
                <a:gd name="connsiteX37" fmla="*/ 544209 w 1047708"/>
                <a:gd name="connsiteY37" fmla="*/ 32860 h 1145588"/>
                <a:gd name="connsiteX38" fmla="*/ 549997 w 1047708"/>
                <a:gd name="connsiteY38" fmla="*/ 30931 h 1145588"/>
                <a:gd name="connsiteX39" fmla="*/ 563500 w 1047708"/>
                <a:gd name="connsiteY39" fmla="*/ 21286 h 1145588"/>
                <a:gd name="connsiteX40" fmla="*/ 571217 w 1047708"/>
                <a:gd name="connsiteY40" fmla="*/ 17427 h 1145588"/>
                <a:gd name="connsiteX41" fmla="*/ 577004 w 1047708"/>
                <a:gd name="connsiteY41" fmla="*/ 11640 h 1145588"/>
                <a:gd name="connsiteX42" fmla="*/ 582792 w 1047708"/>
                <a:gd name="connsiteY42" fmla="*/ 9711 h 1145588"/>
                <a:gd name="connsiteX43" fmla="*/ 592437 w 1047708"/>
                <a:gd name="connsiteY43" fmla="*/ 7782 h 1145588"/>
                <a:gd name="connsiteX44" fmla="*/ 600154 w 1047708"/>
                <a:gd name="connsiteY44" fmla="*/ 5853 h 1145588"/>
                <a:gd name="connsiteX45" fmla="*/ 605941 w 1047708"/>
                <a:gd name="connsiteY45" fmla="*/ 65 h 1145588"/>
                <a:gd name="connsiteX46" fmla="*/ 607870 w 1047708"/>
                <a:gd name="connsiteY46" fmla="*/ 7782 h 1145588"/>
                <a:gd name="connsiteX47" fmla="*/ 617516 w 1047708"/>
                <a:gd name="connsiteY47" fmla="*/ 17427 h 1145588"/>
                <a:gd name="connsiteX48" fmla="*/ 632949 w 1047708"/>
                <a:gd name="connsiteY48" fmla="*/ 19356 h 1145588"/>
                <a:gd name="connsiteX49" fmla="*/ 640665 w 1047708"/>
                <a:gd name="connsiteY49" fmla="*/ 21286 h 1145588"/>
                <a:gd name="connsiteX50" fmla="*/ 646452 w 1047708"/>
                <a:gd name="connsiteY50" fmla="*/ 23215 h 1145588"/>
                <a:gd name="connsiteX51" fmla="*/ 706255 w 1047708"/>
                <a:gd name="connsiteY51" fmla="*/ 25144 h 1145588"/>
                <a:gd name="connsiteX52" fmla="*/ 733263 w 1047708"/>
                <a:gd name="connsiteY52" fmla="*/ 30931 h 1145588"/>
                <a:gd name="connsiteX53" fmla="*/ 729404 w 1047708"/>
                <a:gd name="connsiteY53" fmla="*/ 46364 h 1145588"/>
                <a:gd name="connsiteX54" fmla="*/ 721688 w 1047708"/>
                <a:gd name="connsiteY54" fmla="*/ 57939 h 1145588"/>
                <a:gd name="connsiteX55" fmla="*/ 719759 w 1047708"/>
                <a:gd name="connsiteY55" fmla="*/ 63726 h 1145588"/>
                <a:gd name="connsiteX56" fmla="*/ 713971 w 1047708"/>
                <a:gd name="connsiteY56" fmla="*/ 67584 h 1145588"/>
                <a:gd name="connsiteX57" fmla="*/ 704326 w 1047708"/>
                <a:gd name="connsiteY57" fmla="*/ 84946 h 1145588"/>
                <a:gd name="connsiteX58" fmla="*/ 694680 w 1047708"/>
                <a:gd name="connsiteY58" fmla="*/ 96521 h 1145588"/>
                <a:gd name="connsiteX59" fmla="*/ 692751 w 1047708"/>
                <a:gd name="connsiteY59" fmla="*/ 104237 h 1145588"/>
                <a:gd name="connsiteX60" fmla="*/ 696609 w 1047708"/>
                <a:gd name="connsiteY60" fmla="*/ 108096 h 1145588"/>
                <a:gd name="connsiteX61" fmla="*/ 700468 w 1047708"/>
                <a:gd name="connsiteY61" fmla="*/ 113883 h 1145588"/>
                <a:gd name="connsiteX62" fmla="*/ 717830 w 1047708"/>
                <a:gd name="connsiteY62" fmla="*/ 129316 h 1145588"/>
                <a:gd name="connsiteX63" fmla="*/ 723617 w 1047708"/>
                <a:gd name="connsiteY63" fmla="*/ 133174 h 1145588"/>
                <a:gd name="connsiteX64" fmla="*/ 729404 w 1047708"/>
                <a:gd name="connsiteY64" fmla="*/ 137032 h 1145588"/>
                <a:gd name="connsiteX65" fmla="*/ 739050 w 1047708"/>
                <a:gd name="connsiteY65" fmla="*/ 140891 h 1145588"/>
                <a:gd name="connsiteX66" fmla="*/ 748695 w 1047708"/>
                <a:gd name="connsiteY66" fmla="*/ 146678 h 1145588"/>
                <a:gd name="connsiteX67" fmla="*/ 767987 w 1047708"/>
                <a:gd name="connsiteY67" fmla="*/ 150536 h 1145588"/>
                <a:gd name="connsiteX68" fmla="*/ 775703 w 1047708"/>
                <a:gd name="connsiteY68" fmla="*/ 152465 h 1145588"/>
                <a:gd name="connsiteX69" fmla="*/ 781490 w 1047708"/>
                <a:gd name="connsiteY69" fmla="*/ 156323 h 1145588"/>
                <a:gd name="connsiteX70" fmla="*/ 785349 w 1047708"/>
                <a:gd name="connsiteY70" fmla="*/ 162111 h 1145588"/>
                <a:gd name="connsiteX71" fmla="*/ 796923 w 1047708"/>
                <a:gd name="connsiteY71" fmla="*/ 165969 h 1145588"/>
                <a:gd name="connsiteX72" fmla="*/ 806569 w 1047708"/>
                <a:gd name="connsiteY72" fmla="*/ 171756 h 1145588"/>
                <a:gd name="connsiteX73" fmla="*/ 818144 w 1047708"/>
                <a:gd name="connsiteY73" fmla="*/ 177544 h 1145588"/>
                <a:gd name="connsiteX74" fmla="*/ 833576 w 1047708"/>
                <a:gd name="connsiteY74" fmla="*/ 191048 h 1145588"/>
                <a:gd name="connsiteX75" fmla="*/ 841293 w 1047708"/>
                <a:gd name="connsiteY75" fmla="*/ 194906 h 1145588"/>
                <a:gd name="connsiteX76" fmla="*/ 849009 w 1047708"/>
                <a:gd name="connsiteY76" fmla="*/ 202622 h 1145588"/>
                <a:gd name="connsiteX77" fmla="*/ 860584 w 1047708"/>
                <a:gd name="connsiteY77" fmla="*/ 206480 h 1145588"/>
                <a:gd name="connsiteX78" fmla="*/ 889521 w 1047708"/>
                <a:gd name="connsiteY78" fmla="*/ 204551 h 1145588"/>
                <a:gd name="connsiteX79" fmla="*/ 903025 w 1047708"/>
                <a:gd name="connsiteY79" fmla="*/ 200693 h 1145588"/>
                <a:gd name="connsiteX80" fmla="*/ 912670 w 1047708"/>
                <a:gd name="connsiteY80" fmla="*/ 198764 h 1145588"/>
                <a:gd name="connsiteX81" fmla="*/ 920387 w 1047708"/>
                <a:gd name="connsiteY81" fmla="*/ 194906 h 1145588"/>
                <a:gd name="connsiteX82" fmla="*/ 926174 w 1047708"/>
                <a:gd name="connsiteY82" fmla="*/ 191048 h 1145588"/>
                <a:gd name="connsiteX83" fmla="*/ 937749 w 1047708"/>
                <a:gd name="connsiteY83" fmla="*/ 187189 h 1145588"/>
                <a:gd name="connsiteX84" fmla="*/ 951252 w 1047708"/>
                <a:gd name="connsiteY84" fmla="*/ 183331 h 1145588"/>
                <a:gd name="connsiteX85" fmla="*/ 955111 w 1047708"/>
                <a:gd name="connsiteY85" fmla="*/ 179473 h 1145588"/>
                <a:gd name="connsiteX86" fmla="*/ 968614 w 1047708"/>
                <a:gd name="connsiteY86" fmla="*/ 181402 h 1145588"/>
                <a:gd name="connsiteX87" fmla="*/ 972473 w 1047708"/>
                <a:gd name="connsiteY87" fmla="*/ 187189 h 1145588"/>
                <a:gd name="connsiteX88" fmla="*/ 976331 w 1047708"/>
                <a:gd name="connsiteY88" fmla="*/ 191048 h 1145588"/>
                <a:gd name="connsiteX89" fmla="*/ 980189 w 1047708"/>
                <a:gd name="connsiteY89" fmla="*/ 198764 h 1145588"/>
                <a:gd name="connsiteX90" fmla="*/ 984047 w 1047708"/>
                <a:gd name="connsiteY90" fmla="*/ 204551 h 1145588"/>
                <a:gd name="connsiteX91" fmla="*/ 985976 w 1047708"/>
                <a:gd name="connsiteY91" fmla="*/ 212268 h 1145588"/>
                <a:gd name="connsiteX92" fmla="*/ 989835 w 1047708"/>
                <a:gd name="connsiteY92" fmla="*/ 216126 h 1145588"/>
                <a:gd name="connsiteX93" fmla="*/ 997551 w 1047708"/>
                <a:gd name="connsiteY93" fmla="*/ 229630 h 1145588"/>
                <a:gd name="connsiteX94" fmla="*/ 995622 w 1047708"/>
                <a:gd name="connsiteY94" fmla="*/ 241204 h 1145588"/>
                <a:gd name="connsiteX95" fmla="*/ 993693 w 1047708"/>
                <a:gd name="connsiteY95" fmla="*/ 248921 h 1145588"/>
                <a:gd name="connsiteX96" fmla="*/ 985976 w 1047708"/>
                <a:gd name="connsiteY96" fmla="*/ 254708 h 1145588"/>
                <a:gd name="connsiteX97" fmla="*/ 972473 w 1047708"/>
                <a:gd name="connsiteY97" fmla="*/ 270141 h 1145588"/>
                <a:gd name="connsiteX98" fmla="*/ 966685 w 1047708"/>
                <a:gd name="connsiteY98" fmla="*/ 272070 h 1145588"/>
                <a:gd name="connsiteX99" fmla="*/ 962827 w 1047708"/>
                <a:gd name="connsiteY99" fmla="*/ 275929 h 1145588"/>
                <a:gd name="connsiteX100" fmla="*/ 935819 w 1047708"/>
                <a:gd name="connsiteY100" fmla="*/ 279787 h 1145588"/>
                <a:gd name="connsiteX101" fmla="*/ 914599 w 1047708"/>
                <a:gd name="connsiteY101" fmla="*/ 283645 h 1145588"/>
                <a:gd name="connsiteX102" fmla="*/ 906883 w 1047708"/>
                <a:gd name="connsiteY102" fmla="*/ 285574 h 1145588"/>
                <a:gd name="connsiteX103" fmla="*/ 903025 w 1047708"/>
                <a:gd name="connsiteY103" fmla="*/ 291361 h 1145588"/>
                <a:gd name="connsiteX104" fmla="*/ 899166 w 1047708"/>
                <a:gd name="connsiteY104" fmla="*/ 295220 h 1145588"/>
                <a:gd name="connsiteX105" fmla="*/ 897237 w 1047708"/>
                <a:gd name="connsiteY105" fmla="*/ 302936 h 1145588"/>
                <a:gd name="connsiteX106" fmla="*/ 903025 w 1047708"/>
                <a:gd name="connsiteY106" fmla="*/ 318369 h 1145588"/>
                <a:gd name="connsiteX107" fmla="*/ 908812 w 1047708"/>
                <a:gd name="connsiteY107" fmla="*/ 322227 h 1145588"/>
                <a:gd name="connsiteX108" fmla="*/ 912670 w 1047708"/>
                <a:gd name="connsiteY108" fmla="*/ 328015 h 1145588"/>
                <a:gd name="connsiteX109" fmla="*/ 930032 w 1047708"/>
                <a:gd name="connsiteY109" fmla="*/ 335731 h 1145588"/>
                <a:gd name="connsiteX110" fmla="*/ 935819 w 1047708"/>
                <a:gd name="connsiteY110" fmla="*/ 339589 h 1145588"/>
                <a:gd name="connsiteX111" fmla="*/ 941607 w 1047708"/>
                <a:gd name="connsiteY111" fmla="*/ 341518 h 1145588"/>
                <a:gd name="connsiteX112" fmla="*/ 980189 w 1047708"/>
                <a:gd name="connsiteY112" fmla="*/ 343448 h 1145588"/>
                <a:gd name="connsiteX113" fmla="*/ 991764 w 1047708"/>
                <a:gd name="connsiteY113" fmla="*/ 345377 h 1145588"/>
                <a:gd name="connsiteX114" fmla="*/ 995622 w 1047708"/>
                <a:gd name="connsiteY114" fmla="*/ 351164 h 1145588"/>
                <a:gd name="connsiteX115" fmla="*/ 1003338 w 1047708"/>
                <a:gd name="connsiteY115" fmla="*/ 355022 h 1145588"/>
                <a:gd name="connsiteX116" fmla="*/ 1007197 w 1047708"/>
                <a:gd name="connsiteY116" fmla="*/ 362739 h 1145588"/>
                <a:gd name="connsiteX117" fmla="*/ 1018771 w 1047708"/>
                <a:gd name="connsiteY117" fmla="*/ 372384 h 1145588"/>
                <a:gd name="connsiteX118" fmla="*/ 1022630 w 1047708"/>
                <a:gd name="connsiteY118" fmla="*/ 383959 h 1145588"/>
                <a:gd name="connsiteX119" fmla="*/ 1024559 w 1047708"/>
                <a:gd name="connsiteY119" fmla="*/ 393604 h 1145588"/>
                <a:gd name="connsiteX120" fmla="*/ 1034204 w 1047708"/>
                <a:gd name="connsiteY120" fmla="*/ 405179 h 1145588"/>
                <a:gd name="connsiteX121" fmla="*/ 1041921 w 1047708"/>
                <a:gd name="connsiteY121" fmla="*/ 422541 h 1145588"/>
                <a:gd name="connsiteX122" fmla="*/ 1039992 w 1047708"/>
                <a:gd name="connsiteY122" fmla="*/ 436045 h 1145588"/>
                <a:gd name="connsiteX123" fmla="*/ 1024559 w 1047708"/>
                <a:gd name="connsiteY123" fmla="*/ 441832 h 1145588"/>
                <a:gd name="connsiteX124" fmla="*/ 1003338 w 1047708"/>
                <a:gd name="connsiteY124" fmla="*/ 447620 h 1145588"/>
                <a:gd name="connsiteX125" fmla="*/ 985976 w 1047708"/>
                <a:gd name="connsiteY125" fmla="*/ 453407 h 1145588"/>
                <a:gd name="connsiteX126" fmla="*/ 984047 w 1047708"/>
                <a:gd name="connsiteY126" fmla="*/ 461123 h 1145588"/>
                <a:gd name="connsiteX127" fmla="*/ 982118 w 1047708"/>
                <a:gd name="connsiteY127" fmla="*/ 466911 h 1145588"/>
                <a:gd name="connsiteX128" fmla="*/ 980189 w 1047708"/>
                <a:gd name="connsiteY128" fmla="*/ 476556 h 1145588"/>
                <a:gd name="connsiteX129" fmla="*/ 984047 w 1047708"/>
                <a:gd name="connsiteY129" fmla="*/ 486202 h 1145588"/>
                <a:gd name="connsiteX130" fmla="*/ 1003338 w 1047708"/>
                <a:gd name="connsiteY130" fmla="*/ 490060 h 1145588"/>
                <a:gd name="connsiteX131" fmla="*/ 1047708 w 1047708"/>
                <a:gd name="connsiteY131" fmla="*/ 497777 h 1145588"/>
                <a:gd name="connsiteX132" fmla="*/ 1039992 w 1047708"/>
                <a:gd name="connsiteY132" fmla="*/ 501635 h 1145588"/>
                <a:gd name="connsiteX133" fmla="*/ 1030346 w 1047708"/>
                <a:gd name="connsiteY133" fmla="*/ 507422 h 1145588"/>
                <a:gd name="connsiteX134" fmla="*/ 1024559 w 1047708"/>
                <a:gd name="connsiteY134" fmla="*/ 511280 h 1145588"/>
                <a:gd name="connsiteX135" fmla="*/ 1018771 w 1047708"/>
                <a:gd name="connsiteY135" fmla="*/ 513210 h 1145588"/>
                <a:gd name="connsiteX136" fmla="*/ 1011055 w 1047708"/>
                <a:gd name="connsiteY136" fmla="*/ 520926 h 1145588"/>
                <a:gd name="connsiteX137" fmla="*/ 995622 w 1047708"/>
                <a:gd name="connsiteY137" fmla="*/ 526713 h 1145588"/>
                <a:gd name="connsiteX138" fmla="*/ 989835 w 1047708"/>
                <a:gd name="connsiteY138" fmla="*/ 532501 h 1145588"/>
                <a:gd name="connsiteX139" fmla="*/ 984047 w 1047708"/>
                <a:gd name="connsiteY139" fmla="*/ 536359 h 1145588"/>
                <a:gd name="connsiteX140" fmla="*/ 978260 w 1047708"/>
                <a:gd name="connsiteY140" fmla="*/ 542146 h 1145588"/>
                <a:gd name="connsiteX141" fmla="*/ 972473 w 1047708"/>
                <a:gd name="connsiteY141" fmla="*/ 546004 h 1145588"/>
                <a:gd name="connsiteX142" fmla="*/ 958969 w 1047708"/>
                <a:gd name="connsiteY142" fmla="*/ 557579 h 1145588"/>
                <a:gd name="connsiteX143" fmla="*/ 951252 w 1047708"/>
                <a:gd name="connsiteY143" fmla="*/ 561437 h 1145588"/>
                <a:gd name="connsiteX144" fmla="*/ 947394 w 1047708"/>
                <a:gd name="connsiteY144" fmla="*/ 565296 h 1145588"/>
                <a:gd name="connsiteX145" fmla="*/ 943536 w 1047708"/>
                <a:gd name="connsiteY145" fmla="*/ 571083 h 1145588"/>
                <a:gd name="connsiteX146" fmla="*/ 931961 w 1047708"/>
                <a:gd name="connsiteY146" fmla="*/ 580729 h 1145588"/>
                <a:gd name="connsiteX147" fmla="*/ 928103 w 1047708"/>
                <a:gd name="connsiteY147" fmla="*/ 586516 h 1145588"/>
                <a:gd name="connsiteX148" fmla="*/ 918457 w 1047708"/>
                <a:gd name="connsiteY148" fmla="*/ 590374 h 1145588"/>
                <a:gd name="connsiteX149" fmla="*/ 908812 w 1047708"/>
                <a:gd name="connsiteY149" fmla="*/ 596161 h 1145588"/>
                <a:gd name="connsiteX150" fmla="*/ 895308 w 1047708"/>
                <a:gd name="connsiteY150" fmla="*/ 611594 h 1145588"/>
                <a:gd name="connsiteX151" fmla="*/ 887592 w 1047708"/>
                <a:gd name="connsiteY151" fmla="*/ 615453 h 1145588"/>
                <a:gd name="connsiteX152" fmla="*/ 879875 w 1047708"/>
                <a:gd name="connsiteY152" fmla="*/ 623169 h 1145588"/>
                <a:gd name="connsiteX153" fmla="*/ 868300 w 1047708"/>
                <a:gd name="connsiteY153" fmla="*/ 630886 h 1145588"/>
                <a:gd name="connsiteX154" fmla="*/ 864442 w 1047708"/>
                <a:gd name="connsiteY154" fmla="*/ 638602 h 1145588"/>
                <a:gd name="connsiteX155" fmla="*/ 858655 w 1047708"/>
                <a:gd name="connsiteY155" fmla="*/ 640531 h 1145588"/>
                <a:gd name="connsiteX156" fmla="*/ 856726 w 1047708"/>
                <a:gd name="connsiteY156" fmla="*/ 646318 h 1145588"/>
                <a:gd name="connsiteX157" fmla="*/ 847080 w 1047708"/>
                <a:gd name="connsiteY157" fmla="*/ 652106 h 1145588"/>
                <a:gd name="connsiteX158" fmla="*/ 835506 w 1047708"/>
                <a:gd name="connsiteY158" fmla="*/ 661751 h 1145588"/>
                <a:gd name="connsiteX159" fmla="*/ 831647 w 1047708"/>
                <a:gd name="connsiteY159" fmla="*/ 667539 h 1145588"/>
                <a:gd name="connsiteX160" fmla="*/ 818144 w 1047708"/>
                <a:gd name="connsiteY160" fmla="*/ 681042 h 1145588"/>
                <a:gd name="connsiteX161" fmla="*/ 810427 w 1047708"/>
                <a:gd name="connsiteY161" fmla="*/ 688759 h 1145588"/>
                <a:gd name="connsiteX162" fmla="*/ 798852 w 1047708"/>
                <a:gd name="connsiteY162" fmla="*/ 698404 h 1145588"/>
                <a:gd name="connsiteX163" fmla="*/ 793065 w 1047708"/>
                <a:gd name="connsiteY163" fmla="*/ 706121 h 1145588"/>
                <a:gd name="connsiteX164" fmla="*/ 777632 w 1047708"/>
                <a:gd name="connsiteY164" fmla="*/ 709979 h 1145588"/>
                <a:gd name="connsiteX165" fmla="*/ 762199 w 1047708"/>
                <a:gd name="connsiteY165" fmla="*/ 725412 h 1145588"/>
                <a:gd name="connsiteX166" fmla="*/ 758341 w 1047708"/>
                <a:gd name="connsiteY166" fmla="*/ 731199 h 1145588"/>
                <a:gd name="connsiteX167" fmla="*/ 750625 w 1047708"/>
                <a:gd name="connsiteY167" fmla="*/ 738916 h 1145588"/>
                <a:gd name="connsiteX168" fmla="*/ 748695 w 1047708"/>
                <a:gd name="connsiteY168" fmla="*/ 748561 h 1145588"/>
                <a:gd name="connsiteX169" fmla="*/ 744837 w 1047708"/>
                <a:gd name="connsiteY169" fmla="*/ 756278 h 1145588"/>
                <a:gd name="connsiteX170" fmla="*/ 739050 w 1047708"/>
                <a:gd name="connsiteY170" fmla="*/ 779427 h 1145588"/>
                <a:gd name="connsiteX171" fmla="*/ 737121 w 1047708"/>
                <a:gd name="connsiteY171" fmla="*/ 808364 h 1145588"/>
                <a:gd name="connsiteX172" fmla="*/ 727475 w 1047708"/>
                <a:gd name="connsiteY172" fmla="*/ 831513 h 1145588"/>
                <a:gd name="connsiteX173" fmla="*/ 723617 w 1047708"/>
                <a:gd name="connsiteY173" fmla="*/ 841159 h 1145588"/>
                <a:gd name="connsiteX174" fmla="*/ 719759 w 1047708"/>
                <a:gd name="connsiteY174" fmla="*/ 854663 h 1145588"/>
                <a:gd name="connsiteX175" fmla="*/ 715900 w 1047708"/>
                <a:gd name="connsiteY175" fmla="*/ 860450 h 1145588"/>
                <a:gd name="connsiteX176" fmla="*/ 710113 w 1047708"/>
                <a:gd name="connsiteY176" fmla="*/ 875883 h 1145588"/>
                <a:gd name="connsiteX177" fmla="*/ 708184 w 1047708"/>
                <a:gd name="connsiteY177" fmla="*/ 885529 h 1145588"/>
                <a:gd name="connsiteX178" fmla="*/ 704326 w 1047708"/>
                <a:gd name="connsiteY178" fmla="*/ 891316 h 1145588"/>
                <a:gd name="connsiteX179" fmla="*/ 702397 w 1047708"/>
                <a:gd name="connsiteY179" fmla="*/ 897103 h 1145588"/>
                <a:gd name="connsiteX180" fmla="*/ 694680 w 1047708"/>
                <a:gd name="connsiteY180" fmla="*/ 910607 h 1145588"/>
                <a:gd name="connsiteX181" fmla="*/ 690822 w 1047708"/>
                <a:gd name="connsiteY181" fmla="*/ 924111 h 1145588"/>
                <a:gd name="connsiteX182" fmla="*/ 685035 w 1047708"/>
                <a:gd name="connsiteY182" fmla="*/ 929898 h 1145588"/>
                <a:gd name="connsiteX183" fmla="*/ 681176 w 1047708"/>
                <a:gd name="connsiteY183" fmla="*/ 935686 h 1145588"/>
                <a:gd name="connsiteX184" fmla="*/ 679247 w 1047708"/>
                <a:gd name="connsiteY184" fmla="*/ 943402 h 1145588"/>
                <a:gd name="connsiteX185" fmla="*/ 673460 w 1047708"/>
                <a:gd name="connsiteY185" fmla="*/ 949189 h 1145588"/>
                <a:gd name="connsiteX186" fmla="*/ 669602 w 1047708"/>
                <a:gd name="connsiteY186" fmla="*/ 954977 h 1145588"/>
                <a:gd name="connsiteX187" fmla="*/ 667673 w 1047708"/>
                <a:gd name="connsiteY187" fmla="*/ 960764 h 1145588"/>
                <a:gd name="connsiteX188" fmla="*/ 656098 w 1047708"/>
                <a:gd name="connsiteY188" fmla="*/ 972339 h 1145588"/>
                <a:gd name="connsiteX189" fmla="*/ 654169 w 1047708"/>
                <a:gd name="connsiteY189" fmla="*/ 983913 h 1145588"/>
                <a:gd name="connsiteX190" fmla="*/ 648382 w 1047708"/>
                <a:gd name="connsiteY190" fmla="*/ 987772 h 1145588"/>
                <a:gd name="connsiteX191" fmla="*/ 632949 w 1047708"/>
                <a:gd name="connsiteY191" fmla="*/ 1003204 h 1145588"/>
                <a:gd name="connsiteX192" fmla="*/ 629090 w 1047708"/>
                <a:gd name="connsiteY192" fmla="*/ 1007063 h 1145588"/>
                <a:gd name="connsiteX193" fmla="*/ 619445 w 1047708"/>
                <a:gd name="connsiteY193" fmla="*/ 1018637 h 1145588"/>
                <a:gd name="connsiteX194" fmla="*/ 615587 w 1047708"/>
                <a:gd name="connsiteY194" fmla="*/ 1026354 h 1145588"/>
                <a:gd name="connsiteX195" fmla="*/ 611728 w 1047708"/>
                <a:gd name="connsiteY195" fmla="*/ 1030212 h 1145588"/>
                <a:gd name="connsiteX196" fmla="*/ 609799 w 1047708"/>
                <a:gd name="connsiteY196" fmla="*/ 1035999 h 1145588"/>
                <a:gd name="connsiteX197" fmla="*/ 604012 w 1047708"/>
                <a:gd name="connsiteY197" fmla="*/ 1041787 h 1145588"/>
                <a:gd name="connsiteX198" fmla="*/ 596295 w 1047708"/>
                <a:gd name="connsiteY198" fmla="*/ 1053361 h 1145588"/>
                <a:gd name="connsiteX199" fmla="*/ 592437 w 1047708"/>
                <a:gd name="connsiteY199" fmla="*/ 1059149 h 1145588"/>
                <a:gd name="connsiteX200" fmla="*/ 584721 w 1047708"/>
                <a:gd name="connsiteY200" fmla="*/ 1057220 h 1145588"/>
                <a:gd name="connsiteX201" fmla="*/ 582792 w 1047708"/>
                <a:gd name="connsiteY201" fmla="*/ 1051432 h 1145588"/>
                <a:gd name="connsiteX202" fmla="*/ 577004 w 1047708"/>
                <a:gd name="connsiteY202" fmla="*/ 1043716 h 1145588"/>
                <a:gd name="connsiteX203" fmla="*/ 569288 w 1047708"/>
                <a:gd name="connsiteY203" fmla="*/ 1032141 h 1145588"/>
                <a:gd name="connsiteX204" fmla="*/ 565430 w 1047708"/>
                <a:gd name="connsiteY204" fmla="*/ 1026354 h 1145588"/>
                <a:gd name="connsiteX205" fmla="*/ 559642 w 1047708"/>
                <a:gd name="connsiteY205" fmla="*/ 1022496 h 1145588"/>
                <a:gd name="connsiteX206" fmla="*/ 549997 w 1047708"/>
                <a:gd name="connsiteY206" fmla="*/ 1010921 h 1145588"/>
                <a:gd name="connsiteX207" fmla="*/ 548068 w 1047708"/>
                <a:gd name="connsiteY207" fmla="*/ 1005134 h 1145588"/>
                <a:gd name="connsiteX208" fmla="*/ 536493 w 1047708"/>
                <a:gd name="connsiteY208" fmla="*/ 993559 h 1145588"/>
                <a:gd name="connsiteX209" fmla="*/ 530706 w 1047708"/>
                <a:gd name="connsiteY209" fmla="*/ 987772 h 1145588"/>
                <a:gd name="connsiteX210" fmla="*/ 517202 w 1047708"/>
                <a:gd name="connsiteY210" fmla="*/ 978126 h 1145588"/>
                <a:gd name="connsiteX211" fmla="*/ 501769 w 1047708"/>
                <a:gd name="connsiteY211" fmla="*/ 981984 h 1145588"/>
                <a:gd name="connsiteX212" fmla="*/ 484407 w 1047708"/>
                <a:gd name="connsiteY212" fmla="*/ 995488 h 1145588"/>
                <a:gd name="connsiteX213" fmla="*/ 478619 w 1047708"/>
                <a:gd name="connsiteY213" fmla="*/ 999346 h 1145588"/>
                <a:gd name="connsiteX214" fmla="*/ 474761 w 1047708"/>
                <a:gd name="connsiteY214" fmla="*/ 1007063 h 1145588"/>
                <a:gd name="connsiteX215" fmla="*/ 482478 w 1047708"/>
                <a:gd name="connsiteY215" fmla="*/ 1039858 h 1145588"/>
                <a:gd name="connsiteX216" fmla="*/ 476690 w 1047708"/>
                <a:gd name="connsiteY216" fmla="*/ 1064936 h 1145588"/>
                <a:gd name="connsiteX217" fmla="*/ 470903 w 1047708"/>
                <a:gd name="connsiteY217" fmla="*/ 1066865 h 1145588"/>
                <a:gd name="connsiteX218" fmla="*/ 459328 w 1047708"/>
                <a:gd name="connsiteY218" fmla="*/ 1076511 h 1145588"/>
                <a:gd name="connsiteX219" fmla="*/ 447754 w 1047708"/>
                <a:gd name="connsiteY219" fmla="*/ 1080369 h 1145588"/>
                <a:gd name="connsiteX220" fmla="*/ 443895 w 1047708"/>
                <a:gd name="connsiteY220" fmla="*/ 1088086 h 1145588"/>
                <a:gd name="connsiteX221" fmla="*/ 426533 w 1047708"/>
                <a:gd name="connsiteY221" fmla="*/ 1095802 h 1145588"/>
                <a:gd name="connsiteX222" fmla="*/ 414959 w 1047708"/>
                <a:gd name="connsiteY222" fmla="*/ 1107377 h 1145588"/>
                <a:gd name="connsiteX223" fmla="*/ 399526 w 1047708"/>
                <a:gd name="connsiteY223" fmla="*/ 1111235 h 1145588"/>
                <a:gd name="connsiteX224" fmla="*/ 391809 w 1047708"/>
                <a:gd name="connsiteY224" fmla="*/ 1113164 h 1145588"/>
                <a:gd name="connsiteX225" fmla="*/ 376376 w 1047708"/>
                <a:gd name="connsiteY225" fmla="*/ 1118951 h 1145588"/>
                <a:gd name="connsiteX226" fmla="*/ 355156 w 1047708"/>
                <a:gd name="connsiteY226" fmla="*/ 1120880 h 1145588"/>
                <a:gd name="connsiteX227" fmla="*/ 343582 w 1047708"/>
                <a:gd name="connsiteY227" fmla="*/ 1122810 h 1145588"/>
                <a:gd name="connsiteX228" fmla="*/ 333936 w 1047708"/>
                <a:gd name="connsiteY228" fmla="*/ 1130526 h 1145588"/>
                <a:gd name="connsiteX229" fmla="*/ 328149 w 1047708"/>
                <a:gd name="connsiteY229" fmla="*/ 1132455 h 1145588"/>
                <a:gd name="connsiteX230" fmla="*/ 312716 w 1047708"/>
                <a:gd name="connsiteY230" fmla="*/ 1136313 h 1145588"/>
                <a:gd name="connsiteX231" fmla="*/ 295354 w 1047708"/>
                <a:gd name="connsiteY231" fmla="*/ 1142101 h 1145588"/>
                <a:gd name="connsiteX232" fmla="*/ 256771 w 1047708"/>
                <a:gd name="connsiteY232" fmla="*/ 1140172 h 1145588"/>
                <a:gd name="connsiteX233" fmla="*/ 258700 w 1047708"/>
                <a:gd name="connsiteY233" fmla="*/ 1074582 h 1145588"/>
                <a:gd name="connsiteX234" fmla="*/ 262559 w 1047708"/>
                <a:gd name="connsiteY234" fmla="*/ 1070723 h 1145588"/>
                <a:gd name="connsiteX235" fmla="*/ 268346 w 1047708"/>
                <a:gd name="connsiteY235" fmla="*/ 1063007 h 1145588"/>
                <a:gd name="connsiteX236" fmla="*/ 279921 w 1047708"/>
                <a:gd name="connsiteY236" fmla="*/ 1055291 h 1145588"/>
                <a:gd name="connsiteX237" fmla="*/ 283779 w 1047708"/>
                <a:gd name="connsiteY237" fmla="*/ 1051432 h 1145588"/>
                <a:gd name="connsiteX238" fmla="*/ 287637 w 1047708"/>
                <a:gd name="connsiteY238" fmla="*/ 1045645 h 1145588"/>
                <a:gd name="connsiteX239" fmla="*/ 295354 w 1047708"/>
                <a:gd name="connsiteY239" fmla="*/ 1039858 h 1145588"/>
                <a:gd name="connsiteX240" fmla="*/ 306928 w 1047708"/>
                <a:gd name="connsiteY240" fmla="*/ 1028283 h 1145588"/>
                <a:gd name="connsiteX241" fmla="*/ 310787 w 1047708"/>
                <a:gd name="connsiteY241" fmla="*/ 1020567 h 1145588"/>
                <a:gd name="connsiteX242" fmla="*/ 316574 w 1047708"/>
                <a:gd name="connsiteY242" fmla="*/ 1018637 h 1145588"/>
                <a:gd name="connsiteX243" fmla="*/ 322361 w 1047708"/>
                <a:gd name="connsiteY243" fmla="*/ 1010921 h 1145588"/>
                <a:gd name="connsiteX244" fmla="*/ 333936 w 1047708"/>
                <a:gd name="connsiteY244" fmla="*/ 999346 h 1145588"/>
                <a:gd name="connsiteX245" fmla="*/ 335865 w 1047708"/>
                <a:gd name="connsiteY245" fmla="*/ 993559 h 1145588"/>
                <a:gd name="connsiteX246" fmla="*/ 328149 w 1047708"/>
                <a:gd name="connsiteY246" fmla="*/ 964622 h 1145588"/>
                <a:gd name="connsiteX247" fmla="*/ 324290 w 1047708"/>
                <a:gd name="connsiteY247" fmla="*/ 937615 h 1145588"/>
                <a:gd name="connsiteX248" fmla="*/ 330078 w 1047708"/>
                <a:gd name="connsiteY248" fmla="*/ 904820 h 1145588"/>
                <a:gd name="connsiteX249" fmla="*/ 337794 w 1047708"/>
                <a:gd name="connsiteY249" fmla="*/ 902891 h 1145588"/>
                <a:gd name="connsiteX250" fmla="*/ 341652 w 1047708"/>
                <a:gd name="connsiteY250" fmla="*/ 897103 h 1145588"/>
                <a:gd name="connsiteX251" fmla="*/ 353227 w 1047708"/>
                <a:gd name="connsiteY251" fmla="*/ 895174 h 1145588"/>
                <a:gd name="connsiteX252" fmla="*/ 359014 w 1047708"/>
                <a:gd name="connsiteY252" fmla="*/ 893245 h 1145588"/>
                <a:gd name="connsiteX253" fmla="*/ 378306 w 1047708"/>
                <a:gd name="connsiteY253" fmla="*/ 887458 h 1145588"/>
                <a:gd name="connsiteX254" fmla="*/ 378306 w 1047708"/>
                <a:gd name="connsiteY254" fmla="*/ 862379 h 1145588"/>
                <a:gd name="connsiteX255" fmla="*/ 372518 w 1047708"/>
                <a:gd name="connsiteY255" fmla="*/ 856592 h 1145588"/>
                <a:gd name="connsiteX256" fmla="*/ 362873 w 1047708"/>
                <a:gd name="connsiteY256" fmla="*/ 845017 h 1145588"/>
                <a:gd name="connsiteX257" fmla="*/ 360944 w 1047708"/>
                <a:gd name="connsiteY257" fmla="*/ 839230 h 1145588"/>
                <a:gd name="connsiteX258" fmla="*/ 351298 w 1047708"/>
                <a:gd name="connsiteY258" fmla="*/ 831513 h 1145588"/>
                <a:gd name="connsiteX259" fmla="*/ 347440 w 1047708"/>
                <a:gd name="connsiteY259" fmla="*/ 825726 h 1145588"/>
                <a:gd name="connsiteX260" fmla="*/ 330078 w 1047708"/>
                <a:gd name="connsiteY260" fmla="*/ 825726 h 1145588"/>
                <a:gd name="connsiteX261" fmla="*/ 312716 w 1047708"/>
                <a:gd name="connsiteY261" fmla="*/ 843088 h 1145588"/>
                <a:gd name="connsiteX262" fmla="*/ 308857 w 1047708"/>
                <a:gd name="connsiteY262" fmla="*/ 846946 h 1145588"/>
                <a:gd name="connsiteX263" fmla="*/ 303070 w 1047708"/>
                <a:gd name="connsiteY263" fmla="*/ 850804 h 1145588"/>
                <a:gd name="connsiteX264" fmla="*/ 293425 w 1047708"/>
                <a:gd name="connsiteY264" fmla="*/ 862379 h 1145588"/>
                <a:gd name="connsiteX265" fmla="*/ 291495 w 1047708"/>
                <a:gd name="connsiteY265" fmla="*/ 872025 h 1145588"/>
                <a:gd name="connsiteX266" fmla="*/ 289566 w 1047708"/>
                <a:gd name="connsiteY266" fmla="*/ 895174 h 1145588"/>
                <a:gd name="connsiteX267" fmla="*/ 283779 w 1047708"/>
                <a:gd name="connsiteY267" fmla="*/ 900961 h 1145588"/>
                <a:gd name="connsiteX268" fmla="*/ 274133 w 1047708"/>
                <a:gd name="connsiteY268" fmla="*/ 912536 h 1145588"/>
                <a:gd name="connsiteX269" fmla="*/ 272204 w 1047708"/>
                <a:gd name="connsiteY269" fmla="*/ 918323 h 1145588"/>
                <a:gd name="connsiteX270" fmla="*/ 268346 w 1047708"/>
                <a:gd name="connsiteY270" fmla="*/ 924111 h 1145588"/>
                <a:gd name="connsiteX271" fmla="*/ 262559 w 1047708"/>
                <a:gd name="connsiteY271" fmla="*/ 933756 h 1145588"/>
                <a:gd name="connsiteX272" fmla="*/ 256771 w 1047708"/>
                <a:gd name="connsiteY272" fmla="*/ 949189 h 1145588"/>
                <a:gd name="connsiteX273" fmla="*/ 249055 w 1047708"/>
                <a:gd name="connsiteY273" fmla="*/ 964622 h 1145588"/>
                <a:gd name="connsiteX274" fmla="*/ 250984 w 1047708"/>
                <a:gd name="connsiteY274" fmla="*/ 985842 h 1145588"/>
                <a:gd name="connsiteX275" fmla="*/ 256771 w 1047708"/>
                <a:gd name="connsiteY275" fmla="*/ 989701 h 1145588"/>
                <a:gd name="connsiteX276" fmla="*/ 274133 w 1047708"/>
                <a:gd name="connsiteY276" fmla="*/ 1005134 h 1145588"/>
                <a:gd name="connsiteX277" fmla="*/ 276063 w 1047708"/>
                <a:gd name="connsiteY277" fmla="*/ 1012850 h 1145588"/>
                <a:gd name="connsiteX278" fmla="*/ 262559 w 1047708"/>
                <a:gd name="connsiteY278" fmla="*/ 1020567 h 1145588"/>
                <a:gd name="connsiteX279" fmla="*/ 250984 w 1047708"/>
                <a:gd name="connsiteY279" fmla="*/ 1032141 h 1145588"/>
                <a:gd name="connsiteX280" fmla="*/ 247126 w 1047708"/>
                <a:gd name="connsiteY280" fmla="*/ 1037929 h 1145588"/>
                <a:gd name="connsiteX281" fmla="*/ 235551 w 1047708"/>
                <a:gd name="connsiteY281" fmla="*/ 1041787 h 1145588"/>
                <a:gd name="connsiteX282" fmla="*/ 229764 w 1047708"/>
                <a:gd name="connsiteY282" fmla="*/ 1047574 h 1145588"/>
                <a:gd name="connsiteX283" fmla="*/ 223976 w 1047708"/>
                <a:gd name="connsiteY283" fmla="*/ 1049503 h 1145588"/>
                <a:gd name="connsiteX284" fmla="*/ 206614 w 1047708"/>
                <a:gd name="connsiteY284" fmla="*/ 1053361 h 1145588"/>
                <a:gd name="connsiteX285" fmla="*/ 193111 w 1047708"/>
                <a:gd name="connsiteY285" fmla="*/ 1051432 h 1145588"/>
                <a:gd name="connsiteX286" fmla="*/ 187323 w 1047708"/>
                <a:gd name="connsiteY286" fmla="*/ 1047574 h 1145588"/>
                <a:gd name="connsiteX287" fmla="*/ 177678 w 1047708"/>
                <a:gd name="connsiteY287" fmla="*/ 1034070 h 1145588"/>
                <a:gd name="connsiteX288" fmla="*/ 173819 w 1047708"/>
                <a:gd name="connsiteY288" fmla="*/ 1030212 h 1145588"/>
                <a:gd name="connsiteX289" fmla="*/ 158387 w 1047708"/>
                <a:gd name="connsiteY289" fmla="*/ 1012850 h 1145588"/>
                <a:gd name="connsiteX290" fmla="*/ 150670 w 1047708"/>
                <a:gd name="connsiteY290" fmla="*/ 1008992 h 1145588"/>
                <a:gd name="connsiteX291" fmla="*/ 144883 w 1047708"/>
                <a:gd name="connsiteY291" fmla="*/ 1003204 h 1145588"/>
                <a:gd name="connsiteX292" fmla="*/ 127521 w 1047708"/>
                <a:gd name="connsiteY292" fmla="*/ 997417 h 1145588"/>
                <a:gd name="connsiteX293" fmla="*/ 106300 w 1047708"/>
                <a:gd name="connsiteY293" fmla="*/ 987772 h 1145588"/>
                <a:gd name="connsiteX294" fmla="*/ 98584 w 1047708"/>
                <a:gd name="connsiteY294" fmla="*/ 983913 h 1145588"/>
                <a:gd name="connsiteX295" fmla="*/ 92797 w 1047708"/>
                <a:gd name="connsiteY295" fmla="*/ 981984 h 1145588"/>
                <a:gd name="connsiteX296" fmla="*/ 83151 w 1047708"/>
                <a:gd name="connsiteY296" fmla="*/ 978126 h 1145588"/>
                <a:gd name="connsiteX297" fmla="*/ 71576 w 1047708"/>
                <a:gd name="connsiteY297" fmla="*/ 970410 h 1145588"/>
                <a:gd name="connsiteX298" fmla="*/ 58073 w 1047708"/>
                <a:gd name="connsiteY298" fmla="*/ 962693 h 1145588"/>
                <a:gd name="connsiteX299" fmla="*/ 54214 w 1047708"/>
                <a:gd name="connsiteY299" fmla="*/ 958835 h 1145588"/>
                <a:gd name="connsiteX300" fmla="*/ 52285 w 1047708"/>
                <a:gd name="connsiteY300" fmla="*/ 937615 h 1145588"/>
                <a:gd name="connsiteX301" fmla="*/ 58073 w 1047708"/>
                <a:gd name="connsiteY301" fmla="*/ 935686 h 1145588"/>
                <a:gd name="connsiteX302" fmla="*/ 75435 w 1047708"/>
                <a:gd name="connsiteY302" fmla="*/ 922182 h 1145588"/>
                <a:gd name="connsiteX303" fmla="*/ 87009 w 1047708"/>
                <a:gd name="connsiteY303" fmla="*/ 912536 h 1145588"/>
                <a:gd name="connsiteX304" fmla="*/ 88938 w 1047708"/>
                <a:gd name="connsiteY304" fmla="*/ 906749 h 1145588"/>
                <a:gd name="connsiteX305" fmla="*/ 102442 w 1047708"/>
                <a:gd name="connsiteY305" fmla="*/ 906749 h 1145588"/>
                <a:gd name="connsiteX306" fmla="*/ 110159 w 1047708"/>
                <a:gd name="connsiteY306" fmla="*/ 910607 h 1145588"/>
                <a:gd name="connsiteX307" fmla="*/ 115946 w 1047708"/>
                <a:gd name="connsiteY307" fmla="*/ 914465 h 1145588"/>
                <a:gd name="connsiteX308" fmla="*/ 135237 w 1047708"/>
                <a:gd name="connsiteY308" fmla="*/ 916394 h 1145588"/>
                <a:gd name="connsiteX309" fmla="*/ 146812 w 1047708"/>
                <a:gd name="connsiteY309" fmla="*/ 916394 h 1145588"/>
                <a:gd name="connsiteX310" fmla="*/ 148741 w 1047708"/>
                <a:gd name="connsiteY310" fmla="*/ 910607 h 1145588"/>
                <a:gd name="connsiteX311" fmla="*/ 154528 w 1047708"/>
                <a:gd name="connsiteY311" fmla="*/ 889387 h 1145588"/>
                <a:gd name="connsiteX312" fmla="*/ 160316 w 1047708"/>
                <a:gd name="connsiteY312" fmla="*/ 873954 h 1145588"/>
                <a:gd name="connsiteX313" fmla="*/ 162245 w 1047708"/>
                <a:gd name="connsiteY313" fmla="*/ 868167 h 1145588"/>
                <a:gd name="connsiteX314" fmla="*/ 166103 w 1047708"/>
                <a:gd name="connsiteY314" fmla="*/ 858521 h 1145588"/>
                <a:gd name="connsiteX315" fmla="*/ 168032 w 1047708"/>
                <a:gd name="connsiteY315" fmla="*/ 837301 h 1145588"/>
                <a:gd name="connsiteX316" fmla="*/ 166103 w 1047708"/>
                <a:gd name="connsiteY316" fmla="*/ 818010 h 1145588"/>
                <a:gd name="connsiteX317" fmla="*/ 162245 w 1047708"/>
                <a:gd name="connsiteY317" fmla="*/ 810293 h 1145588"/>
                <a:gd name="connsiteX318" fmla="*/ 142954 w 1047708"/>
                <a:gd name="connsiteY318" fmla="*/ 792931 h 1145588"/>
                <a:gd name="connsiteX319" fmla="*/ 139095 w 1047708"/>
                <a:gd name="connsiteY319" fmla="*/ 789073 h 1145588"/>
                <a:gd name="connsiteX320" fmla="*/ 131379 w 1047708"/>
                <a:gd name="connsiteY320" fmla="*/ 783286 h 1145588"/>
                <a:gd name="connsiteX321" fmla="*/ 133308 w 1047708"/>
                <a:gd name="connsiteY321" fmla="*/ 771711 h 1145588"/>
                <a:gd name="connsiteX322" fmla="*/ 135237 w 1047708"/>
                <a:gd name="connsiteY322" fmla="*/ 765923 h 1145588"/>
                <a:gd name="connsiteX323" fmla="*/ 137166 w 1047708"/>
                <a:gd name="connsiteY323" fmla="*/ 758207 h 1145588"/>
                <a:gd name="connsiteX324" fmla="*/ 142954 w 1047708"/>
                <a:gd name="connsiteY324" fmla="*/ 746632 h 1145588"/>
                <a:gd name="connsiteX325" fmla="*/ 148741 w 1047708"/>
                <a:gd name="connsiteY325" fmla="*/ 744703 h 1145588"/>
                <a:gd name="connsiteX326" fmla="*/ 158387 w 1047708"/>
                <a:gd name="connsiteY326" fmla="*/ 740845 h 1145588"/>
                <a:gd name="connsiteX327" fmla="*/ 169961 w 1047708"/>
                <a:gd name="connsiteY327" fmla="*/ 736987 h 1145588"/>
                <a:gd name="connsiteX328" fmla="*/ 173819 w 1047708"/>
                <a:gd name="connsiteY328" fmla="*/ 731199 h 1145588"/>
                <a:gd name="connsiteX329" fmla="*/ 164174 w 1047708"/>
                <a:gd name="connsiteY329" fmla="*/ 715767 h 1145588"/>
                <a:gd name="connsiteX330" fmla="*/ 160316 w 1047708"/>
                <a:gd name="connsiteY330" fmla="*/ 702263 h 1145588"/>
                <a:gd name="connsiteX331" fmla="*/ 156457 w 1047708"/>
                <a:gd name="connsiteY331" fmla="*/ 698404 h 1145588"/>
                <a:gd name="connsiteX332" fmla="*/ 158387 w 1047708"/>
                <a:gd name="connsiteY332" fmla="*/ 652106 h 1145588"/>
                <a:gd name="connsiteX333" fmla="*/ 164174 w 1047708"/>
                <a:gd name="connsiteY333" fmla="*/ 638602 h 1145588"/>
                <a:gd name="connsiteX334" fmla="*/ 177678 w 1047708"/>
                <a:gd name="connsiteY334" fmla="*/ 634744 h 1145588"/>
                <a:gd name="connsiteX335" fmla="*/ 185394 w 1047708"/>
                <a:gd name="connsiteY335" fmla="*/ 630886 h 1145588"/>
                <a:gd name="connsiteX336" fmla="*/ 202756 w 1047708"/>
                <a:gd name="connsiteY336" fmla="*/ 636673 h 1145588"/>
                <a:gd name="connsiteX337" fmla="*/ 210473 w 1047708"/>
                <a:gd name="connsiteY337" fmla="*/ 652106 h 1145588"/>
                <a:gd name="connsiteX338" fmla="*/ 220118 w 1047708"/>
                <a:gd name="connsiteY338" fmla="*/ 663680 h 1145588"/>
                <a:gd name="connsiteX339" fmla="*/ 231693 w 1047708"/>
                <a:gd name="connsiteY339" fmla="*/ 661751 h 1145588"/>
                <a:gd name="connsiteX340" fmla="*/ 235551 w 1047708"/>
                <a:gd name="connsiteY340" fmla="*/ 655964 h 1145588"/>
                <a:gd name="connsiteX341" fmla="*/ 241338 w 1047708"/>
                <a:gd name="connsiteY341" fmla="*/ 650177 h 1145588"/>
                <a:gd name="connsiteX342" fmla="*/ 245197 w 1047708"/>
                <a:gd name="connsiteY342" fmla="*/ 644389 h 1145588"/>
                <a:gd name="connsiteX343" fmla="*/ 256771 w 1047708"/>
                <a:gd name="connsiteY343" fmla="*/ 636673 h 1145588"/>
                <a:gd name="connsiteX344" fmla="*/ 276063 w 1047708"/>
                <a:gd name="connsiteY344" fmla="*/ 623169 h 1145588"/>
                <a:gd name="connsiteX345" fmla="*/ 283779 w 1047708"/>
                <a:gd name="connsiteY345" fmla="*/ 617382 h 1145588"/>
                <a:gd name="connsiteX346" fmla="*/ 301141 w 1047708"/>
                <a:gd name="connsiteY346" fmla="*/ 611594 h 1145588"/>
                <a:gd name="connsiteX347" fmla="*/ 304999 w 1047708"/>
                <a:gd name="connsiteY347" fmla="*/ 605807 h 1145588"/>
                <a:gd name="connsiteX348" fmla="*/ 314645 w 1047708"/>
                <a:gd name="connsiteY348" fmla="*/ 601949 h 1145588"/>
                <a:gd name="connsiteX349" fmla="*/ 320432 w 1047708"/>
                <a:gd name="connsiteY349" fmla="*/ 598091 h 1145588"/>
                <a:gd name="connsiteX350" fmla="*/ 326219 w 1047708"/>
                <a:gd name="connsiteY350" fmla="*/ 596161 h 1145588"/>
                <a:gd name="connsiteX351" fmla="*/ 343582 w 1047708"/>
                <a:gd name="connsiteY351" fmla="*/ 582658 h 1145588"/>
                <a:gd name="connsiteX352" fmla="*/ 349369 w 1047708"/>
                <a:gd name="connsiteY352" fmla="*/ 578799 h 1145588"/>
                <a:gd name="connsiteX353" fmla="*/ 362873 w 1047708"/>
                <a:gd name="connsiteY353" fmla="*/ 565296 h 1145588"/>
                <a:gd name="connsiteX354" fmla="*/ 366731 w 1047708"/>
                <a:gd name="connsiteY354" fmla="*/ 561437 h 1145588"/>
                <a:gd name="connsiteX355" fmla="*/ 380235 w 1047708"/>
                <a:gd name="connsiteY355" fmla="*/ 555650 h 1145588"/>
                <a:gd name="connsiteX356" fmla="*/ 397597 w 1047708"/>
                <a:gd name="connsiteY356" fmla="*/ 540217 h 1145588"/>
                <a:gd name="connsiteX357" fmla="*/ 405313 w 1047708"/>
                <a:gd name="connsiteY357" fmla="*/ 528642 h 1145588"/>
                <a:gd name="connsiteX358" fmla="*/ 418817 w 1047708"/>
                <a:gd name="connsiteY358" fmla="*/ 507422 h 1145588"/>
                <a:gd name="connsiteX359" fmla="*/ 422675 w 1047708"/>
                <a:gd name="connsiteY359" fmla="*/ 480415 h 1145588"/>
                <a:gd name="connsiteX360" fmla="*/ 424604 w 1047708"/>
                <a:gd name="connsiteY360" fmla="*/ 470769 h 1145588"/>
                <a:gd name="connsiteX361" fmla="*/ 430392 w 1047708"/>
                <a:gd name="connsiteY361" fmla="*/ 459194 h 1145588"/>
                <a:gd name="connsiteX362" fmla="*/ 432321 w 1047708"/>
                <a:gd name="connsiteY362" fmla="*/ 453407 h 1145588"/>
                <a:gd name="connsiteX363" fmla="*/ 430392 w 1047708"/>
                <a:gd name="connsiteY363" fmla="*/ 430258 h 1145588"/>
                <a:gd name="connsiteX364" fmla="*/ 420746 w 1047708"/>
                <a:gd name="connsiteY364" fmla="*/ 420612 h 1145588"/>
                <a:gd name="connsiteX365" fmla="*/ 414959 w 1047708"/>
                <a:gd name="connsiteY365" fmla="*/ 414825 h 1145588"/>
                <a:gd name="connsiteX366" fmla="*/ 386022 w 1047708"/>
                <a:gd name="connsiteY366" fmla="*/ 410967 h 1145588"/>
                <a:gd name="connsiteX367" fmla="*/ 376376 w 1047708"/>
                <a:gd name="connsiteY367" fmla="*/ 405179 h 1145588"/>
                <a:gd name="connsiteX368" fmla="*/ 382164 w 1047708"/>
                <a:gd name="connsiteY368" fmla="*/ 374313 h 1145588"/>
                <a:gd name="connsiteX369" fmla="*/ 389880 w 1047708"/>
                <a:gd name="connsiteY369" fmla="*/ 362739 h 1145588"/>
                <a:gd name="connsiteX370" fmla="*/ 386022 w 1047708"/>
                <a:gd name="connsiteY370" fmla="*/ 326086 h 1145588"/>
                <a:gd name="connsiteX371" fmla="*/ 376376 w 1047708"/>
                <a:gd name="connsiteY371" fmla="*/ 316440 h 1145588"/>
                <a:gd name="connsiteX372" fmla="*/ 366731 w 1047708"/>
                <a:gd name="connsiteY372" fmla="*/ 302936 h 1145588"/>
                <a:gd name="connsiteX373" fmla="*/ 362873 w 1047708"/>
                <a:gd name="connsiteY373" fmla="*/ 297149 h 1145588"/>
                <a:gd name="connsiteX374" fmla="*/ 359014 w 1047708"/>
                <a:gd name="connsiteY374" fmla="*/ 283645 h 1145588"/>
                <a:gd name="connsiteX375" fmla="*/ 353227 w 1047708"/>
                <a:gd name="connsiteY375" fmla="*/ 277858 h 1145588"/>
                <a:gd name="connsiteX376" fmla="*/ 349369 w 1047708"/>
                <a:gd name="connsiteY376" fmla="*/ 262425 h 1145588"/>
                <a:gd name="connsiteX377" fmla="*/ 347440 w 1047708"/>
                <a:gd name="connsiteY377" fmla="*/ 254708 h 1145588"/>
                <a:gd name="connsiteX378" fmla="*/ 337794 w 1047708"/>
                <a:gd name="connsiteY378" fmla="*/ 250850 h 1145588"/>
                <a:gd name="connsiteX379" fmla="*/ 330078 w 1047708"/>
                <a:gd name="connsiteY379" fmla="*/ 258567 h 1145588"/>
                <a:gd name="connsiteX380" fmla="*/ 326219 w 1047708"/>
                <a:gd name="connsiteY380" fmla="*/ 264354 h 1145588"/>
                <a:gd name="connsiteX381" fmla="*/ 318503 w 1047708"/>
                <a:gd name="connsiteY381" fmla="*/ 266283 h 1145588"/>
                <a:gd name="connsiteX382" fmla="*/ 287637 w 1047708"/>
                <a:gd name="connsiteY382" fmla="*/ 268212 h 1145588"/>
                <a:gd name="connsiteX383" fmla="*/ 281850 w 1047708"/>
                <a:gd name="connsiteY383" fmla="*/ 270141 h 1145588"/>
                <a:gd name="connsiteX384" fmla="*/ 274133 w 1047708"/>
                <a:gd name="connsiteY384" fmla="*/ 272070 h 1145588"/>
                <a:gd name="connsiteX385" fmla="*/ 268346 w 1047708"/>
                <a:gd name="connsiteY385" fmla="*/ 275929 h 1145588"/>
                <a:gd name="connsiteX386" fmla="*/ 266417 w 1047708"/>
                <a:gd name="connsiteY386" fmla="*/ 281716 h 1145588"/>
                <a:gd name="connsiteX387" fmla="*/ 256771 w 1047708"/>
                <a:gd name="connsiteY387" fmla="*/ 297149 h 1145588"/>
                <a:gd name="connsiteX388" fmla="*/ 249055 w 1047708"/>
                <a:gd name="connsiteY388" fmla="*/ 312582 h 1145588"/>
                <a:gd name="connsiteX389" fmla="*/ 247126 w 1047708"/>
                <a:gd name="connsiteY389" fmla="*/ 322227 h 1145588"/>
                <a:gd name="connsiteX390" fmla="*/ 243268 w 1047708"/>
                <a:gd name="connsiteY390" fmla="*/ 328015 h 1145588"/>
                <a:gd name="connsiteX391" fmla="*/ 241338 w 1047708"/>
                <a:gd name="connsiteY391" fmla="*/ 333802 h 1145588"/>
                <a:gd name="connsiteX392" fmla="*/ 237480 w 1047708"/>
                <a:gd name="connsiteY392" fmla="*/ 339589 h 1145588"/>
                <a:gd name="connsiteX393" fmla="*/ 233622 w 1047708"/>
                <a:gd name="connsiteY393" fmla="*/ 347306 h 1145588"/>
                <a:gd name="connsiteX394" fmla="*/ 227835 w 1047708"/>
                <a:gd name="connsiteY394" fmla="*/ 358880 h 1145588"/>
                <a:gd name="connsiteX395" fmla="*/ 231693 w 1047708"/>
                <a:gd name="connsiteY395" fmla="*/ 372384 h 1145588"/>
                <a:gd name="connsiteX396" fmla="*/ 243268 w 1047708"/>
                <a:gd name="connsiteY396" fmla="*/ 374313 h 1145588"/>
                <a:gd name="connsiteX397" fmla="*/ 249055 w 1047708"/>
                <a:gd name="connsiteY397" fmla="*/ 376242 h 1145588"/>
                <a:gd name="connsiteX398" fmla="*/ 272204 w 1047708"/>
                <a:gd name="connsiteY398" fmla="*/ 380101 h 1145588"/>
                <a:gd name="connsiteX399" fmla="*/ 285708 w 1047708"/>
                <a:gd name="connsiteY399" fmla="*/ 383959 h 1145588"/>
                <a:gd name="connsiteX400" fmla="*/ 297283 w 1047708"/>
                <a:gd name="connsiteY400" fmla="*/ 387817 h 1145588"/>
                <a:gd name="connsiteX401" fmla="*/ 306928 w 1047708"/>
                <a:gd name="connsiteY401" fmla="*/ 389746 h 1145588"/>
                <a:gd name="connsiteX402" fmla="*/ 310787 w 1047708"/>
                <a:gd name="connsiteY402" fmla="*/ 395534 h 1145588"/>
                <a:gd name="connsiteX403" fmla="*/ 320432 w 1047708"/>
                <a:gd name="connsiteY403" fmla="*/ 407108 h 1145588"/>
                <a:gd name="connsiteX404" fmla="*/ 322361 w 1047708"/>
                <a:gd name="connsiteY404" fmla="*/ 412896 h 1145588"/>
                <a:gd name="connsiteX405" fmla="*/ 320432 w 1047708"/>
                <a:gd name="connsiteY405" fmla="*/ 434116 h 1145588"/>
                <a:gd name="connsiteX406" fmla="*/ 310787 w 1047708"/>
                <a:gd name="connsiteY406" fmla="*/ 437974 h 1145588"/>
                <a:gd name="connsiteX407" fmla="*/ 297283 w 1047708"/>
                <a:gd name="connsiteY407" fmla="*/ 441832 h 1145588"/>
                <a:gd name="connsiteX408" fmla="*/ 289566 w 1047708"/>
                <a:gd name="connsiteY408" fmla="*/ 449549 h 1145588"/>
                <a:gd name="connsiteX409" fmla="*/ 283779 w 1047708"/>
                <a:gd name="connsiteY409" fmla="*/ 455336 h 1145588"/>
                <a:gd name="connsiteX410" fmla="*/ 276063 w 1047708"/>
                <a:gd name="connsiteY410" fmla="*/ 457265 h 1145588"/>
                <a:gd name="connsiteX411" fmla="*/ 260630 w 1047708"/>
                <a:gd name="connsiteY411" fmla="*/ 464982 h 1145588"/>
                <a:gd name="connsiteX412" fmla="*/ 254842 w 1047708"/>
                <a:gd name="connsiteY412" fmla="*/ 468840 h 1145588"/>
                <a:gd name="connsiteX413" fmla="*/ 239409 w 1047708"/>
                <a:gd name="connsiteY413" fmla="*/ 474627 h 1145588"/>
                <a:gd name="connsiteX414" fmla="*/ 250984 w 1047708"/>
                <a:gd name="connsiteY414" fmla="*/ 495848 h 1145588"/>
                <a:gd name="connsiteX415" fmla="*/ 258700 w 1047708"/>
                <a:gd name="connsiteY415" fmla="*/ 515139 h 1145588"/>
                <a:gd name="connsiteX416" fmla="*/ 258700 w 1047708"/>
                <a:gd name="connsiteY416" fmla="*/ 561437 h 1145588"/>
                <a:gd name="connsiteX417" fmla="*/ 231693 w 1047708"/>
                <a:gd name="connsiteY417" fmla="*/ 563367 h 1145588"/>
                <a:gd name="connsiteX418" fmla="*/ 222047 w 1047708"/>
                <a:gd name="connsiteY418" fmla="*/ 573012 h 1145588"/>
                <a:gd name="connsiteX419" fmla="*/ 212402 w 1047708"/>
                <a:gd name="connsiteY419" fmla="*/ 582658 h 1145588"/>
                <a:gd name="connsiteX420" fmla="*/ 202756 w 1047708"/>
                <a:gd name="connsiteY420" fmla="*/ 584587 h 1145588"/>
                <a:gd name="connsiteX421" fmla="*/ 171890 w 1047708"/>
                <a:gd name="connsiteY421" fmla="*/ 573012 h 1145588"/>
                <a:gd name="connsiteX422" fmla="*/ 160316 w 1047708"/>
                <a:gd name="connsiteY422" fmla="*/ 561437 h 1145588"/>
                <a:gd name="connsiteX423" fmla="*/ 156457 w 1047708"/>
                <a:gd name="connsiteY423" fmla="*/ 557579 h 1145588"/>
                <a:gd name="connsiteX424" fmla="*/ 152599 w 1047708"/>
                <a:gd name="connsiteY424" fmla="*/ 549863 h 1145588"/>
                <a:gd name="connsiteX425" fmla="*/ 148741 w 1047708"/>
                <a:gd name="connsiteY425" fmla="*/ 544075 h 1145588"/>
                <a:gd name="connsiteX426" fmla="*/ 158387 w 1047708"/>
                <a:gd name="connsiteY426" fmla="*/ 517068 h 1145588"/>
                <a:gd name="connsiteX427" fmla="*/ 179607 w 1047708"/>
                <a:gd name="connsiteY427" fmla="*/ 511280 h 1145588"/>
                <a:gd name="connsiteX428" fmla="*/ 183465 w 1047708"/>
                <a:gd name="connsiteY428" fmla="*/ 503564 h 1145588"/>
                <a:gd name="connsiteX429" fmla="*/ 191182 w 1047708"/>
                <a:gd name="connsiteY429" fmla="*/ 491989 h 1145588"/>
                <a:gd name="connsiteX430" fmla="*/ 193111 w 1047708"/>
                <a:gd name="connsiteY430" fmla="*/ 457265 h 1145588"/>
                <a:gd name="connsiteX431" fmla="*/ 196969 w 1047708"/>
                <a:gd name="connsiteY431" fmla="*/ 451478 h 1145588"/>
                <a:gd name="connsiteX432" fmla="*/ 198898 w 1047708"/>
                <a:gd name="connsiteY432" fmla="*/ 445691 h 1145588"/>
                <a:gd name="connsiteX433" fmla="*/ 200827 w 1047708"/>
                <a:gd name="connsiteY433" fmla="*/ 436045 h 1145588"/>
                <a:gd name="connsiteX434" fmla="*/ 208544 w 1047708"/>
                <a:gd name="connsiteY434" fmla="*/ 432187 h 1145588"/>
                <a:gd name="connsiteX435" fmla="*/ 212402 w 1047708"/>
                <a:gd name="connsiteY435" fmla="*/ 426399 h 1145588"/>
                <a:gd name="connsiteX436" fmla="*/ 220118 w 1047708"/>
                <a:gd name="connsiteY436" fmla="*/ 422541 h 1145588"/>
                <a:gd name="connsiteX437" fmla="*/ 222047 w 1047708"/>
                <a:gd name="connsiteY437" fmla="*/ 414825 h 1145588"/>
                <a:gd name="connsiteX438" fmla="*/ 225906 w 1047708"/>
                <a:gd name="connsiteY438" fmla="*/ 410967 h 1145588"/>
                <a:gd name="connsiteX439" fmla="*/ 225906 w 1047708"/>
                <a:gd name="connsiteY439" fmla="*/ 387817 h 1145588"/>
                <a:gd name="connsiteX440" fmla="*/ 216260 w 1047708"/>
                <a:gd name="connsiteY440" fmla="*/ 385888 h 1145588"/>
                <a:gd name="connsiteX441" fmla="*/ 198898 w 1047708"/>
                <a:gd name="connsiteY441" fmla="*/ 382030 h 1145588"/>
                <a:gd name="connsiteX442" fmla="*/ 193111 w 1047708"/>
                <a:gd name="connsiteY442" fmla="*/ 380101 h 1145588"/>
                <a:gd name="connsiteX443" fmla="*/ 133308 w 1047708"/>
                <a:gd name="connsiteY443" fmla="*/ 376242 h 1145588"/>
                <a:gd name="connsiteX444" fmla="*/ 131379 w 1047708"/>
                <a:gd name="connsiteY444" fmla="*/ 370455 h 1145588"/>
                <a:gd name="connsiteX445" fmla="*/ 129450 w 1047708"/>
                <a:gd name="connsiteY445" fmla="*/ 358880 h 1145588"/>
                <a:gd name="connsiteX446" fmla="*/ 137166 w 1047708"/>
                <a:gd name="connsiteY446" fmla="*/ 353093 h 1145588"/>
                <a:gd name="connsiteX447" fmla="*/ 137166 w 1047708"/>
                <a:gd name="connsiteY447" fmla="*/ 312582 h 1145588"/>
                <a:gd name="connsiteX448" fmla="*/ 133308 w 1047708"/>
                <a:gd name="connsiteY448" fmla="*/ 304865 h 1145588"/>
                <a:gd name="connsiteX449" fmla="*/ 127521 w 1047708"/>
                <a:gd name="connsiteY449" fmla="*/ 299078 h 1145588"/>
                <a:gd name="connsiteX450" fmla="*/ 115946 w 1047708"/>
                <a:gd name="connsiteY450" fmla="*/ 283645 h 1145588"/>
                <a:gd name="connsiteX451" fmla="*/ 90868 w 1047708"/>
                <a:gd name="connsiteY451" fmla="*/ 273999 h 1145588"/>
                <a:gd name="connsiteX452" fmla="*/ 83151 w 1047708"/>
                <a:gd name="connsiteY452" fmla="*/ 270141 h 1145588"/>
                <a:gd name="connsiteX453" fmla="*/ 77364 w 1047708"/>
                <a:gd name="connsiteY453" fmla="*/ 268212 h 1145588"/>
                <a:gd name="connsiteX454" fmla="*/ 75435 w 1047708"/>
                <a:gd name="connsiteY454" fmla="*/ 275929 h 1145588"/>
                <a:gd name="connsiteX455" fmla="*/ 79293 w 1047708"/>
                <a:gd name="connsiteY455" fmla="*/ 285574 h 1145588"/>
                <a:gd name="connsiteX456" fmla="*/ 94726 w 1047708"/>
                <a:gd name="connsiteY456" fmla="*/ 302936 h 1145588"/>
                <a:gd name="connsiteX457" fmla="*/ 100513 w 1047708"/>
                <a:gd name="connsiteY457" fmla="*/ 306794 h 1145588"/>
                <a:gd name="connsiteX458" fmla="*/ 102442 w 1047708"/>
                <a:gd name="connsiteY458" fmla="*/ 351164 h 1145588"/>
                <a:gd name="connsiteX459" fmla="*/ 98584 w 1047708"/>
                <a:gd name="connsiteY459" fmla="*/ 382030 h 1145588"/>
                <a:gd name="connsiteX460" fmla="*/ 85080 w 1047708"/>
                <a:gd name="connsiteY460" fmla="*/ 378172 h 1145588"/>
                <a:gd name="connsiteX461" fmla="*/ 73506 w 1047708"/>
                <a:gd name="connsiteY461" fmla="*/ 376242 h 1145588"/>
                <a:gd name="connsiteX462" fmla="*/ 67718 w 1047708"/>
                <a:gd name="connsiteY462" fmla="*/ 372384 h 1145588"/>
                <a:gd name="connsiteX463" fmla="*/ 60002 w 1047708"/>
                <a:gd name="connsiteY463" fmla="*/ 368526 h 1145588"/>
                <a:gd name="connsiteX464" fmla="*/ 48427 w 1047708"/>
                <a:gd name="connsiteY464" fmla="*/ 356951 h 1145588"/>
                <a:gd name="connsiteX465" fmla="*/ 23349 w 1047708"/>
                <a:gd name="connsiteY465" fmla="*/ 337660 h 1145588"/>
                <a:gd name="connsiteX466" fmla="*/ 27207 w 1047708"/>
                <a:gd name="connsiteY466" fmla="*/ 314511 h 1145588"/>
                <a:gd name="connsiteX467" fmla="*/ 31065 w 1047708"/>
                <a:gd name="connsiteY467" fmla="*/ 308723 h 1145588"/>
                <a:gd name="connsiteX468" fmla="*/ 32994 w 1047708"/>
                <a:gd name="connsiteY468" fmla="*/ 302936 h 1145588"/>
                <a:gd name="connsiteX469" fmla="*/ 38782 w 1047708"/>
                <a:gd name="connsiteY469" fmla="*/ 293291 h 1145588"/>
                <a:gd name="connsiteX470" fmla="*/ 36852 w 1047708"/>
                <a:gd name="connsiteY470" fmla="*/ 266283 h 1145588"/>
                <a:gd name="connsiteX471" fmla="*/ 32994 w 1047708"/>
                <a:gd name="connsiteY471" fmla="*/ 258567 h 1145588"/>
                <a:gd name="connsiteX472" fmla="*/ 27207 w 1047708"/>
                <a:gd name="connsiteY472" fmla="*/ 256637 h 1145588"/>
                <a:gd name="connsiteX473" fmla="*/ 13703 w 1047708"/>
                <a:gd name="connsiteY473" fmla="*/ 252779 h 1145588"/>
                <a:gd name="connsiteX474" fmla="*/ 11774 w 1047708"/>
                <a:gd name="connsiteY474" fmla="*/ 245063 h 1145588"/>
                <a:gd name="connsiteX475" fmla="*/ 4057 w 1047708"/>
                <a:gd name="connsiteY475" fmla="*/ 196835 h 1145588"/>
                <a:gd name="connsiteX476" fmla="*/ 199 w 1047708"/>
                <a:gd name="connsiteY476" fmla="*/ 164040 h 1145588"/>
                <a:gd name="connsiteX477" fmla="*/ 2128 w 1047708"/>
                <a:gd name="connsiteY477" fmla="*/ 154394 h 1145588"/>
                <a:gd name="connsiteX478" fmla="*/ 29136 w 1047708"/>
                <a:gd name="connsiteY478" fmla="*/ 152465 h 1145588"/>
                <a:gd name="connsiteX479" fmla="*/ 34923 w 1047708"/>
                <a:gd name="connsiteY479" fmla="*/ 142820 h 1145588"/>
                <a:gd name="connsiteX480" fmla="*/ 48427 w 1047708"/>
                <a:gd name="connsiteY480" fmla="*/ 131245 h 1145588"/>
                <a:gd name="connsiteX481" fmla="*/ 56144 w 1047708"/>
                <a:gd name="connsiteY481" fmla="*/ 129316 h 1145588"/>
                <a:gd name="connsiteX482" fmla="*/ 79293 w 1047708"/>
                <a:gd name="connsiteY482" fmla="*/ 111954 h 1145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</a:cxnLst>
              <a:rect l="l" t="t" r="r" b="b"/>
              <a:pathLst>
                <a:path w="1047708" h="1145588">
                  <a:moveTo>
                    <a:pt x="79293" y="111954"/>
                  </a:moveTo>
                  <a:cubicBezTo>
                    <a:pt x="83794" y="110989"/>
                    <a:pt x="82576" y="119503"/>
                    <a:pt x="83151" y="123529"/>
                  </a:cubicBezTo>
                  <a:cubicBezTo>
                    <a:pt x="87752" y="155734"/>
                    <a:pt x="75017" y="149950"/>
                    <a:pt x="92797" y="154394"/>
                  </a:cubicBezTo>
                  <a:cubicBezTo>
                    <a:pt x="103283" y="164883"/>
                    <a:pt x="98583" y="162111"/>
                    <a:pt x="127521" y="156323"/>
                  </a:cubicBezTo>
                  <a:cubicBezTo>
                    <a:pt x="130674" y="155692"/>
                    <a:pt x="132511" y="152240"/>
                    <a:pt x="135237" y="150536"/>
                  </a:cubicBezTo>
                  <a:cubicBezTo>
                    <a:pt x="144286" y="144881"/>
                    <a:pt x="141159" y="148886"/>
                    <a:pt x="148741" y="142820"/>
                  </a:cubicBezTo>
                  <a:cubicBezTo>
                    <a:pt x="150161" y="141684"/>
                    <a:pt x="151179" y="140097"/>
                    <a:pt x="152599" y="138961"/>
                  </a:cubicBezTo>
                  <a:cubicBezTo>
                    <a:pt x="154410" y="137513"/>
                    <a:pt x="156606" y="136587"/>
                    <a:pt x="158387" y="135103"/>
                  </a:cubicBezTo>
                  <a:cubicBezTo>
                    <a:pt x="166631" y="128233"/>
                    <a:pt x="161966" y="131113"/>
                    <a:pt x="168032" y="123529"/>
                  </a:cubicBezTo>
                  <a:cubicBezTo>
                    <a:pt x="179035" y="109774"/>
                    <a:pt x="163863" y="131708"/>
                    <a:pt x="175749" y="113883"/>
                  </a:cubicBezTo>
                  <a:cubicBezTo>
                    <a:pt x="177035" y="108739"/>
                    <a:pt x="175195" y="101391"/>
                    <a:pt x="179607" y="98450"/>
                  </a:cubicBezTo>
                  <a:cubicBezTo>
                    <a:pt x="192874" y="89606"/>
                    <a:pt x="186783" y="92201"/>
                    <a:pt x="196969" y="88804"/>
                  </a:cubicBezTo>
                  <a:lnTo>
                    <a:pt x="243268" y="90734"/>
                  </a:lnTo>
                  <a:cubicBezTo>
                    <a:pt x="246642" y="91513"/>
                    <a:pt x="246175" y="97050"/>
                    <a:pt x="247126" y="100379"/>
                  </a:cubicBezTo>
                  <a:cubicBezTo>
                    <a:pt x="248755" y="106079"/>
                    <a:pt x="248333" y="112438"/>
                    <a:pt x="250984" y="117741"/>
                  </a:cubicBezTo>
                  <a:cubicBezTo>
                    <a:pt x="252422" y="120617"/>
                    <a:pt x="255542" y="122927"/>
                    <a:pt x="258700" y="123529"/>
                  </a:cubicBezTo>
                  <a:cubicBezTo>
                    <a:pt x="269457" y="125578"/>
                    <a:pt x="280563" y="124815"/>
                    <a:pt x="291495" y="125458"/>
                  </a:cubicBezTo>
                  <a:cubicBezTo>
                    <a:pt x="295083" y="129045"/>
                    <a:pt x="296275" y="130741"/>
                    <a:pt x="301141" y="133174"/>
                  </a:cubicBezTo>
                  <a:cubicBezTo>
                    <a:pt x="302960" y="134083"/>
                    <a:pt x="304999" y="134460"/>
                    <a:pt x="306928" y="135103"/>
                  </a:cubicBezTo>
                  <a:cubicBezTo>
                    <a:pt x="311429" y="133817"/>
                    <a:pt x="316170" y="133182"/>
                    <a:pt x="320432" y="131245"/>
                  </a:cubicBezTo>
                  <a:cubicBezTo>
                    <a:pt x="325639" y="128878"/>
                    <a:pt x="334569" y="119037"/>
                    <a:pt x="337794" y="115812"/>
                  </a:cubicBezTo>
                  <a:lnTo>
                    <a:pt x="349369" y="104237"/>
                  </a:lnTo>
                  <a:lnTo>
                    <a:pt x="353227" y="98450"/>
                  </a:lnTo>
                  <a:cubicBezTo>
                    <a:pt x="353870" y="95878"/>
                    <a:pt x="354225" y="93216"/>
                    <a:pt x="355156" y="90734"/>
                  </a:cubicBezTo>
                  <a:cubicBezTo>
                    <a:pt x="357255" y="85135"/>
                    <a:pt x="359672" y="82030"/>
                    <a:pt x="362873" y="77230"/>
                  </a:cubicBezTo>
                  <a:cubicBezTo>
                    <a:pt x="382942" y="97299"/>
                    <a:pt x="356403" y="70003"/>
                    <a:pt x="372518" y="88804"/>
                  </a:cubicBezTo>
                  <a:cubicBezTo>
                    <a:pt x="378756" y="96081"/>
                    <a:pt x="379196" y="95828"/>
                    <a:pt x="386022" y="100379"/>
                  </a:cubicBezTo>
                  <a:lnTo>
                    <a:pt x="453541" y="98450"/>
                  </a:lnTo>
                  <a:cubicBezTo>
                    <a:pt x="456391" y="98065"/>
                    <a:pt x="455558" y="92943"/>
                    <a:pt x="457399" y="90734"/>
                  </a:cubicBezTo>
                  <a:cubicBezTo>
                    <a:pt x="458883" y="88953"/>
                    <a:pt x="461406" y="88359"/>
                    <a:pt x="463187" y="86875"/>
                  </a:cubicBezTo>
                  <a:cubicBezTo>
                    <a:pt x="465283" y="85129"/>
                    <a:pt x="467045" y="83017"/>
                    <a:pt x="468974" y="81088"/>
                  </a:cubicBezTo>
                  <a:cubicBezTo>
                    <a:pt x="473565" y="67314"/>
                    <a:pt x="469448" y="71769"/>
                    <a:pt x="478619" y="65655"/>
                  </a:cubicBezTo>
                  <a:cubicBezTo>
                    <a:pt x="479905" y="63726"/>
                    <a:pt x="480839" y="61507"/>
                    <a:pt x="482478" y="59868"/>
                  </a:cubicBezTo>
                  <a:cubicBezTo>
                    <a:pt x="484751" y="57595"/>
                    <a:pt x="487519" y="55864"/>
                    <a:pt x="490194" y="54080"/>
                  </a:cubicBezTo>
                  <a:cubicBezTo>
                    <a:pt x="494580" y="51156"/>
                    <a:pt x="502411" y="46640"/>
                    <a:pt x="507556" y="44435"/>
                  </a:cubicBezTo>
                  <a:cubicBezTo>
                    <a:pt x="512863" y="42161"/>
                    <a:pt x="515277" y="42357"/>
                    <a:pt x="521060" y="40577"/>
                  </a:cubicBezTo>
                  <a:cubicBezTo>
                    <a:pt x="526891" y="38783"/>
                    <a:pt x="532635" y="36718"/>
                    <a:pt x="538422" y="34789"/>
                  </a:cubicBezTo>
                  <a:lnTo>
                    <a:pt x="544209" y="32860"/>
                  </a:lnTo>
                  <a:cubicBezTo>
                    <a:pt x="546138" y="32217"/>
                    <a:pt x="548178" y="31840"/>
                    <a:pt x="549997" y="30931"/>
                  </a:cubicBezTo>
                  <a:cubicBezTo>
                    <a:pt x="571142" y="20358"/>
                    <a:pt x="545254" y="34319"/>
                    <a:pt x="563500" y="21286"/>
                  </a:cubicBezTo>
                  <a:cubicBezTo>
                    <a:pt x="565840" y="19614"/>
                    <a:pt x="568877" y="19099"/>
                    <a:pt x="571217" y="17427"/>
                  </a:cubicBezTo>
                  <a:cubicBezTo>
                    <a:pt x="573437" y="15841"/>
                    <a:pt x="574734" y="13153"/>
                    <a:pt x="577004" y="11640"/>
                  </a:cubicBezTo>
                  <a:cubicBezTo>
                    <a:pt x="578696" y="10512"/>
                    <a:pt x="580819" y="10204"/>
                    <a:pt x="582792" y="9711"/>
                  </a:cubicBezTo>
                  <a:cubicBezTo>
                    <a:pt x="585973" y="8916"/>
                    <a:pt x="589236" y="8493"/>
                    <a:pt x="592437" y="7782"/>
                  </a:cubicBezTo>
                  <a:cubicBezTo>
                    <a:pt x="595025" y="7207"/>
                    <a:pt x="597582" y="6496"/>
                    <a:pt x="600154" y="5853"/>
                  </a:cubicBezTo>
                  <a:cubicBezTo>
                    <a:pt x="602083" y="3924"/>
                    <a:pt x="603294" y="-597"/>
                    <a:pt x="605941" y="65"/>
                  </a:cubicBezTo>
                  <a:cubicBezTo>
                    <a:pt x="608513" y="708"/>
                    <a:pt x="606399" y="5576"/>
                    <a:pt x="607870" y="7782"/>
                  </a:cubicBezTo>
                  <a:cubicBezTo>
                    <a:pt x="610392" y="11565"/>
                    <a:pt x="613004" y="16863"/>
                    <a:pt x="617516" y="17427"/>
                  </a:cubicBezTo>
                  <a:lnTo>
                    <a:pt x="632949" y="19356"/>
                  </a:lnTo>
                  <a:cubicBezTo>
                    <a:pt x="635521" y="19999"/>
                    <a:pt x="638116" y="20557"/>
                    <a:pt x="640665" y="21286"/>
                  </a:cubicBezTo>
                  <a:cubicBezTo>
                    <a:pt x="642620" y="21845"/>
                    <a:pt x="644422" y="23096"/>
                    <a:pt x="646452" y="23215"/>
                  </a:cubicBezTo>
                  <a:cubicBezTo>
                    <a:pt x="666362" y="24386"/>
                    <a:pt x="686321" y="24501"/>
                    <a:pt x="706255" y="25144"/>
                  </a:cubicBezTo>
                  <a:cubicBezTo>
                    <a:pt x="709665" y="25712"/>
                    <a:pt x="732195" y="29151"/>
                    <a:pt x="733263" y="30931"/>
                  </a:cubicBezTo>
                  <a:cubicBezTo>
                    <a:pt x="735991" y="35478"/>
                    <a:pt x="731493" y="41490"/>
                    <a:pt x="729404" y="46364"/>
                  </a:cubicBezTo>
                  <a:cubicBezTo>
                    <a:pt x="727577" y="50626"/>
                    <a:pt x="723154" y="53540"/>
                    <a:pt x="721688" y="57939"/>
                  </a:cubicBezTo>
                  <a:cubicBezTo>
                    <a:pt x="721045" y="59868"/>
                    <a:pt x="721029" y="62138"/>
                    <a:pt x="719759" y="63726"/>
                  </a:cubicBezTo>
                  <a:cubicBezTo>
                    <a:pt x="718310" y="65536"/>
                    <a:pt x="715900" y="66298"/>
                    <a:pt x="713971" y="67584"/>
                  </a:cubicBezTo>
                  <a:cubicBezTo>
                    <a:pt x="710440" y="81710"/>
                    <a:pt x="714636" y="69480"/>
                    <a:pt x="704326" y="84946"/>
                  </a:cubicBezTo>
                  <a:cubicBezTo>
                    <a:pt x="696494" y="96695"/>
                    <a:pt x="705229" y="89489"/>
                    <a:pt x="694680" y="96521"/>
                  </a:cubicBezTo>
                  <a:cubicBezTo>
                    <a:pt x="694037" y="99093"/>
                    <a:pt x="692315" y="101622"/>
                    <a:pt x="692751" y="104237"/>
                  </a:cubicBezTo>
                  <a:cubicBezTo>
                    <a:pt x="693050" y="106031"/>
                    <a:pt x="695473" y="106676"/>
                    <a:pt x="696609" y="108096"/>
                  </a:cubicBezTo>
                  <a:cubicBezTo>
                    <a:pt x="698057" y="109906"/>
                    <a:pt x="699120" y="111996"/>
                    <a:pt x="700468" y="113883"/>
                  </a:cubicBezTo>
                  <a:cubicBezTo>
                    <a:pt x="708260" y="124790"/>
                    <a:pt x="704702" y="120564"/>
                    <a:pt x="717830" y="129316"/>
                  </a:cubicBezTo>
                  <a:lnTo>
                    <a:pt x="723617" y="133174"/>
                  </a:lnTo>
                  <a:cubicBezTo>
                    <a:pt x="725546" y="134460"/>
                    <a:pt x="727251" y="136171"/>
                    <a:pt x="729404" y="137032"/>
                  </a:cubicBezTo>
                  <a:cubicBezTo>
                    <a:pt x="732619" y="138318"/>
                    <a:pt x="735953" y="139342"/>
                    <a:pt x="739050" y="140891"/>
                  </a:cubicBezTo>
                  <a:cubicBezTo>
                    <a:pt x="742403" y="142568"/>
                    <a:pt x="745138" y="145492"/>
                    <a:pt x="748695" y="146678"/>
                  </a:cubicBezTo>
                  <a:cubicBezTo>
                    <a:pt x="754917" y="148752"/>
                    <a:pt x="761625" y="148945"/>
                    <a:pt x="767987" y="150536"/>
                  </a:cubicBezTo>
                  <a:lnTo>
                    <a:pt x="775703" y="152465"/>
                  </a:lnTo>
                  <a:cubicBezTo>
                    <a:pt x="777632" y="153751"/>
                    <a:pt x="779851" y="154684"/>
                    <a:pt x="781490" y="156323"/>
                  </a:cubicBezTo>
                  <a:cubicBezTo>
                    <a:pt x="783130" y="157963"/>
                    <a:pt x="783383" y="160882"/>
                    <a:pt x="785349" y="162111"/>
                  </a:cubicBezTo>
                  <a:cubicBezTo>
                    <a:pt x="788798" y="164266"/>
                    <a:pt x="796923" y="165969"/>
                    <a:pt x="796923" y="165969"/>
                  </a:cubicBezTo>
                  <a:cubicBezTo>
                    <a:pt x="806706" y="175749"/>
                    <a:pt x="794042" y="164238"/>
                    <a:pt x="806569" y="171756"/>
                  </a:cubicBezTo>
                  <a:cubicBezTo>
                    <a:pt x="818853" y="179128"/>
                    <a:pt x="799112" y="172787"/>
                    <a:pt x="818144" y="177544"/>
                  </a:cubicBezTo>
                  <a:cubicBezTo>
                    <a:pt x="823720" y="183120"/>
                    <a:pt x="826514" y="186340"/>
                    <a:pt x="833576" y="191048"/>
                  </a:cubicBezTo>
                  <a:cubicBezTo>
                    <a:pt x="835969" y="192643"/>
                    <a:pt x="838721" y="193620"/>
                    <a:pt x="841293" y="194906"/>
                  </a:cubicBezTo>
                  <a:cubicBezTo>
                    <a:pt x="843865" y="197478"/>
                    <a:pt x="845890" y="200751"/>
                    <a:pt x="849009" y="202622"/>
                  </a:cubicBezTo>
                  <a:cubicBezTo>
                    <a:pt x="852496" y="204714"/>
                    <a:pt x="860584" y="206480"/>
                    <a:pt x="860584" y="206480"/>
                  </a:cubicBezTo>
                  <a:cubicBezTo>
                    <a:pt x="870230" y="205837"/>
                    <a:pt x="879907" y="205563"/>
                    <a:pt x="889521" y="204551"/>
                  </a:cubicBezTo>
                  <a:cubicBezTo>
                    <a:pt x="895749" y="203895"/>
                    <a:pt x="897376" y="202105"/>
                    <a:pt x="903025" y="200693"/>
                  </a:cubicBezTo>
                  <a:cubicBezTo>
                    <a:pt x="906206" y="199898"/>
                    <a:pt x="909455" y="199407"/>
                    <a:pt x="912670" y="198764"/>
                  </a:cubicBezTo>
                  <a:cubicBezTo>
                    <a:pt x="915242" y="197478"/>
                    <a:pt x="917890" y="196333"/>
                    <a:pt x="920387" y="194906"/>
                  </a:cubicBezTo>
                  <a:cubicBezTo>
                    <a:pt x="922400" y="193756"/>
                    <a:pt x="924055" y="191990"/>
                    <a:pt x="926174" y="191048"/>
                  </a:cubicBezTo>
                  <a:cubicBezTo>
                    <a:pt x="929891" y="189396"/>
                    <a:pt x="933891" y="188475"/>
                    <a:pt x="937749" y="187189"/>
                  </a:cubicBezTo>
                  <a:cubicBezTo>
                    <a:pt x="946047" y="184423"/>
                    <a:pt x="941568" y="185752"/>
                    <a:pt x="951252" y="183331"/>
                  </a:cubicBezTo>
                  <a:cubicBezTo>
                    <a:pt x="952538" y="182045"/>
                    <a:pt x="953303" y="179674"/>
                    <a:pt x="955111" y="179473"/>
                  </a:cubicBezTo>
                  <a:cubicBezTo>
                    <a:pt x="959630" y="178971"/>
                    <a:pt x="964459" y="179556"/>
                    <a:pt x="968614" y="181402"/>
                  </a:cubicBezTo>
                  <a:cubicBezTo>
                    <a:pt x="970733" y="182344"/>
                    <a:pt x="971025" y="185379"/>
                    <a:pt x="972473" y="187189"/>
                  </a:cubicBezTo>
                  <a:cubicBezTo>
                    <a:pt x="973609" y="188609"/>
                    <a:pt x="975322" y="189535"/>
                    <a:pt x="976331" y="191048"/>
                  </a:cubicBezTo>
                  <a:cubicBezTo>
                    <a:pt x="977926" y="193441"/>
                    <a:pt x="978762" y="196267"/>
                    <a:pt x="980189" y="198764"/>
                  </a:cubicBezTo>
                  <a:cubicBezTo>
                    <a:pt x="981339" y="200777"/>
                    <a:pt x="982761" y="202622"/>
                    <a:pt x="984047" y="204551"/>
                  </a:cubicBezTo>
                  <a:cubicBezTo>
                    <a:pt x="984690" y="207123"/>
                    <a:pt x="984790" y="209896"/>
                    <a:pt x="985976" y="212268"/>
                  </a:cubicBezTo>
                  <a:cubicBezTo>
                    <a:pt x="986789" y="213895"/>
                    <a:pt x="989118" y="214454"/>
                    <a:pt x="989835" y="216126"/>
                  </a:cubicBezTo>
                  <a:cubicBezTo>
                    <a:pt x="996034" y="230589"/>
                    <a:pt x="986338" y="222155"/>
                    <a:pt x="997551" y="229630"/>
                  </a:cubicBezTo>
                  <a:cubicBezTo>
                    <a:pt x="996908" y="233488"/>
                    <a:pt x="996389" y="237369"/>
                    <a:pt x="995622" y="241204"/>
                  </a:cubicBezTo>
                  <a:cubicBezTo>
                    <a:pt x="995102" y="243804"/>
                    <a:pt x="995234" y="246763"/>
                    <a:pt x="993693" y="248921"/>
                  </a:cubicBezTo>
                  <a:cubicBezTo>
                    <a:pt x="991824" y="251537"/>
                    <a:pt x="988548" y="252779"/>
                    <a:pt x="985976" y="254708"/>
                  </a:cubicBezTo>
                  <a:cubicBezTo>
                    <a:pt x="980190" y="263388"/>
                    <a:pt x="980511" y="266123"/>
                    <a:pt x="972473" y="270141"/>
                  </a:cubicBezTo>
                  <a:cubicBezTo>
                    <a:pt x="970654" y="271050"/>
                    <a:pt x="968614" y="271427"/>
                    <a:pt x="966685" y="272070"/>
                  </a:cubicBezTo>
                  <a:cubicBezTo>
                    <a:pt x="965399" y="273356"/>
                    <a:pt x="964499" y="275212"/>
                    <a:pt x="962827" y="275929"/>
                  </a:cubicBezTo>
                  <a:cubicBezTo>
                    <a:pt x="958528" y="277772"/>
                    <a:pt x="936803" y="279678"/>
                    <a:pt x="935819" y="279787"/>
                  </a:cubicBezTo>
                  <a:cubicBezTo>
                    <a:pt x="923403" y="283926"/>
                    <a:pt x="936412" y="280010"/>
                    <a:pt x="914599" y="283645"/>
                  </a:cubicBezTo>
                  <a:cubicBezTo>
                    <a:pt x="911984" y="284081"/>
                    <a:pt x="909455" y="284931"/>
                    <a:pt x="906883" y="285574"/>
                  </a:cubicBezTo>
                  <a:cubicBezTo>
                    <a:pt x="905597" y="287503"/>
                    <a:pt x="904473" y="289551"/>
                    <a:pt x="903025" y="291361"/>
                  </a:cubicBezTo>
                  <a:cubicBezTo>
                    <a:pt x="901889" y="292782"/>
                    <a:pt x="899980" y="293593"/>
                    <a:pt x="899166" y="295220"/>
                  </a:cubicBezTo>
                  <a:cubicBezTo>
                    <a:pt x="897980" y="297591"/>
                    <a:pt x="897880" y="300364"/>
                    <a:pt x="897237" y="302936"/>
                  </a:cubicBezTo>
                  <a:cubicBezTo>
                    <a:pt x="898535" y="308130"/>
                    <a:pt x="899420" y="314044"/>
                    <a:pt x="903025" y="318369"/>
                  </a:cubicBezTo>
                  <a:cubicBezTo>
                    <a:pt x="904509" y="320150"/>
                    <a:pt x="906883" y="320941"/>
                    <a:pt x="908812" y="322227"/>
                  </a:cubicBezTo>
                  <a:cubicBezTo>
                    <a:pt x="910098" y="324156"/>
                    <a:pt x="911031" y="326375"/>
                    <a:pt x="912670" y="328015"/>
                  </a:cubicBezTo>
                  <a:cubicBezTo>
                    <a:pt x="917255" y="332600"/>
                    <a:pt x="924303" y="333821"/>
                    <a:pt x="930032" y="335731"/>
                  </a:cubicBezTo>
                  <a:cubicBezTo>
                    <a:pt x="931961" y="337017"/>
                    <a:pt x="933745" y="338552"/>
                    <a:pt x="935819" y="339589"/>
                  </a:cubicBezTo>
                  <a:cubicBezTo>
                    <a:pt x="937638" y="340498"/>
                    <a:pt x="939581" y="341342"/>
                    <a:pt x="941607" y="341518"/>
                  </a:cubicBezTo>
                  <a:cubicBezTo>
                    <a:pt x="954435" y="342634"/>
                    <a:pt x="967328" y="342805"/>
                    <a:pt x="980189" y="343448"/>
                  </a:cubicBezTo>
                  <a:cubicBezTo>
                    <a:pt x="984047" y="344091"/>
                    <a:pt x="988265" y="343628"/>
                    <a:pt x="991764" y="345377"/>
                  </a:cubicBezTo>
                  <a:cubicBezTo>
                    <a:pt x="993838" y="346414"/>
                    <a:pt x="993841" y="349680"/>
                    <a:pt x="995622" y="351164"/>
                  </a:cubicBezTo>
                  <a:cubicBezTo>
                    <a:pt x="997831" y="353005"/>
                    <a:pt x="1000766" y="353736"/>
                    <a:pt x="1003338" y="355022"/>
                  </a:cubicBezTo>
                  <a:cubicBezTo>
                    <a:pt x="1004624" y="357594"/>
                    <a:pt x="1005163" y="360705"/>
                    <a:pt x="1007197" y="362739"/>
                  </a:cubicBezTo>
                  <a:cubicBezTo>
                    <a:pt x="1026776" y="382318"/>
                    <a:pt x="1005425" y="352365"/>
                    <a:pt x="1018771" y="372384"/>
                  </a:cubicBezTo>
                  <a:cubicBezTo>
                    <a:pt x="1020057" y="376242"/>
                    <a:pt x="1021832" y="379971"/>
                    <a:pt x="1022630" y="383959"/>
                  </a:cubicBezTo>
                  <a:cubicBezTo>
                    <a:pt x="1023273" y="387174"/>
                    <a:pt x="1023408" y="390534"/>
                    <a:pt x="1024559" y="393604"/>
                  </a:cubicBezTo>
                  <a:cubicBezTo>
                    <a:pt x="1026171" y="397903"/>
                    <a:pt x="1031200" y="402175"/>
                    <a:pt x="1034204" y="405179"/>
                  </a:cubicBezTo>
                  <a:cubicBezTo>
                    <a:pt x="1038796" y="418953"/>
                    <a:pt x="1035807" y="413370"/>
                    <a:pt x="1041921" y="422541"/>
                  </a:cubicBezTo>
                  <a:cubicBezTo>
                    <a:pt x="1041278" y="427042"/>
                    <a:pt x="1041430" y="431731"/>
                    <a:pt x="1039992" y="436045"/>
                  </a:cubicBezTo>
                  <a:cubicBezTo>
                    <a:pt x="1038026" y="441944"/>
                    <a:pt x="1027910" y="441162"/>
                    <a:pt x="1024559" y="441832"/>
                  </a:cubicBezTo>
                  <a:cubicBezTo>
                    <a:pt x="1019094" y="442925"/>
                    <a:pt x="1007396" y="446513"/>
                    <a:pt x="1003338" y="447620"/>
                  </a:cubicBezTo>
                  <a:cubicBezTo>
                    <a:pt x="990280" y="451182"/>
                    <a:pt x="1000672" y="447529"/>
                    <a:pt x="985976" y="453407"/>
                  </a:cubicBezTo>
                  <a:cubicBezTo>
                    <a:pt x="985333" y="455979"/>
                    <a:pt x="984775" y="458574"/>
                    <a:pt x="984047" y="461123"/>
                  </a:cubicBezTo>
                  <a:cubicBezTo>
                    <a:pt x="983488" y="463078"/>
                    <a:pt x="982611" y="464938"/>
                    <a:pt x="982118" y="466911"/>
                  </a:cubicBezTo>
                  <a:cubicBezTo>
                    <a:pt x="981323" y="470092"/>
                    <a:pt x="980832" y="473341"/>
                    <a:pt x="980189" y="476556"/>
                  </a:cubicBezTo>
                  <a:cubicBezTo>
                    <a:pt x="981475" y="479771"/>
                    <a:pt x="981056" y="484457"/>
                    <a:pt x="984047" y="486202"/>
                  </a:cubicBezTo>
                  <a:cubicBezTo>
                    <a:pt x="989711" y="489506"/>
                    <a:pt x="996908" y="488774"/>
                    <a:pt x="1003338" y="490060"/>
                  </a:cubicBezTo>
                  <a:cubicBezTo>
                    <a:pt x="1024486" y="494289"/>
                    <a:pt x="1009765" y="491452"/>
                    <a:pt x="1047708" y="497777"/>
                  </a:cubicBezTo>
                  <a:cubicBezTo>
                    <a:pt x="1045136" y="499063"/>
                    <a:pt x="1042506" y="500239"/>
                    <a:pt x="1039992" y="501635"/>
                  </a:cubicBezTo>
                  <a:cubicBezTo>
                    <a:pt x="1036714" y="503456"/>
                    <a:pt x="1033526" y="505435"/>
                    <a:pt x="1030346" y="507422"/>
                  </a:cubicBezTo>
                  <a:cubicBezTo>
                    <a:pt x="1028380" y="508651"/>
                    <a:pt x="1026633" y="510243"/>
                    <a:pt x="1024559" y="511280"/>
                  </a:cubicBezTo>
                  <a:cubicBezTo>
                    <a:pt x="1022740" y="512190"/>
                    <a:pt x="1020700" y="512567"/>
                    <a:pt x="1018771" y="513210"/>
                  </a:cubicBezTo>
                  <a:cubicBezTo>
                    <a:pt x="1016199" y="515782"/>
                    <a:pt x="1014235" y="519160"/>
                    <a:pt x="1011055" y="520926"/>
                  </a:cubicBezTo>
                  <a:cubicBezTo>
                    <a:pt x="991113" y="532004"/>
                    <a:pt x="1009810" y="514889"/>
                    <a:pt x="995622" y="526713"/>
                  </a:cubicBezTo>
                  <a:cubicBezTo>
                    <a:pt x="993526" y="528460"/>
                    <a:pt x="991931" y="530754"/>
                    <a:pt x="989835" y="532501"/>
                  </a:cubicBezTo>
                  <a:cubicBezTo>
                    <a:pt x="988054" y="533985"/>
                    <a:pt x="985828" y="534875"/>
                    <a:pt x="984047" y="536359"/>
                  </a:cubicBezTo>
                  <a:cubicBezTo>
                    <a:pt x="981951" y="538105"/>
                    <a:pt x="980356" y="540400"/>
                    <a:pt x="978260" y="542146"/>
                  </a:cubicBezTo>
                  <a:cubicBezTo>
                    <a:pt x="976479" y="543630"/>
                    <a:pt x="974283" y="544556"/>
                    <a:pt x="972473" y="546004"/>
                  </a:cubicBezTo>
                  <a:cubicBezTo>
                    <a:pt x="960441" y="555630"/>
                    <a:pt x="981943" y="542264"/>
                    <a:pt x="958969" y="557579"/>
                  </a:cubicBezTo>
                  <a:cubicBezTo>
                    <a:pt x="956576" y="559174"/>
                    <a:pt x="953824" y="560151"/>
                    <a:pt x="951252" y="561437"/>
                  </a:cubicBezTo>
                  <a:cubicBezTo>
                    <a:pt x="949966" y="562723"/>
                    <a:pt x="948530" y="563876"/>
                    <a:pt x="947394" y="565296"/>
                  </a:cubicBezTo>
                  <a:cubicBezTo>
                    <a:pt x="945946" y="567106"/>
                    <a:pt x="945175" y="569444"/>
                    <a:pt x="943536" y="571083"/>
                  </a:cubicBezTo>
                  <a:cubicBezTo>
                    <a:pt x="936022" y="578596"/>
                    <a:pt x="937154" y="574237"/>
                    <a:pt x="931961" y="580729"/>
                  </a:cubicBezTo>
                  <a:cubicBezTo>
                    <a:pt x="930513" y="582539"/>
                    <a:pt x="929990" y="585169"/>
                    <a:pt x="928103" y="586516"/>
                  </a:cubicBezTo>
                  <a:cubicBezTo>
                    <a:pt x="925285" y="588529"/>
                    <a:pt x="921554" y="588825"/>
                    <a:pt x="918457" y="590374"/>
                  </a:cubicBezTo>
                  <a:cubicBezTo>
                    <a:pt x="915103" y="592051"/>
                    <a:pt x="912027" y="594232"/>
                    <a:pt x="908812" y="596161"/>
                  </a:cubicBezTo>
                  <a:cubicBezTo>
                    <a:pt x="905308" y="601418"/>
                    <a:pt x="900954" y="608770"/>
                    <a:pt x="895308" y="611594"/>
                  </a:cubicBezTo>
                  <a:cubicBezTo>
                    <a:pt x="892736" y="612880"/>
                    <a:pt x="889893" y="613728"/>
                    <a:pt x="887592" y="615453"/>
                  </a:cubicBezTo>
                  <a:cubicBezTo>
                    <a:pt x="884682" y="617636"/>
                    <a:pt x="882716" y="620897"/>
                    <a:pt x="879875" y="623169"/>
                  </a:cubicBezTo>
                  <a:cubicBezTo>
                    <a:pt x="876254" y="626066"/>
                    <a:pt x="868300" y="630886"/>
                    <a:pt x="868300" y="630886"/>
                  </a:cubicBezTo>
                  <a:cubicBezTo>
                    <a:pt x="867014" y="633458"/>
                    <a:pt x="866475" y="636569"/>
                    <a:pt x="864442" y="638602"/>
                  </a:cubicBezTo>
                  <a:cubicBezTo>
                    <a:pt x="863004" y="640040"/>
                    <a:pt x="860093" y="639093"/>
                    <a:pt x="858655" y="640531"/>
                  </a:cubicBezTo>
                  <a:cubicBezTo>
                    <a:pt x="857217" y="641969"/>
                    <a:pt x="857772" y="644574"/>
                    <a:pt x="856726" y="646318"/>
                  </a:cubicBezTo>
                  <a:cubicBezTo>
                    <a:pt x="854077" y="650733"/>
                    <a:pt x="851634" y="650588"/>
                    <a:pt x="847080" y="652106"/>
                  </a:cubicBezTo>
                  <a:cubicBezTo>
                    <a:pt x="837680" y="666205"/>
                    <a:pt x="850191" y="649514"/>
                    <a:pt x="835506" y="661751"/>
                  </a:cubicBezTo>
                  <a:cubicBezTo>
                    <a:pt x="833725" y="663235"/>
                    <a:pt x="833198" y="665815"/>
                    <a:pt x="831647" y="667539"/>
                  </a:cubicBezTo>
                  <a:cubicBezTo>
                    <a:pt x="827389" y="672270"/>
                    <a:pt x="818144" y="681042"/>
                    <a:pt x="818144" y="681042"/>
                  </a:cubicBezTo>
                  <a:cubicBezTo>
                    <a:pt x="813789" y="694103"/>
                    <a:pt x="819925" y="680844"/>
                    <a:pt x="810427" y="688759"/>
                  </a:cubicBezTo>
                  <a:cubicBezTo>
                    <a:pt x="796413" y="700437"/>
                    <a:pt x="812122" y="693981"/>
                    <a:pt x="798852" y="698404"/>
                  </a:cubicBezTo>
                  <a:cubicBezTo>
                    <a:pt x="796923" y="700976"/>
                    <a:pt x="795535" y="704063"/>
                    <a:pt x="793065" y="706121"/>
                  </a:cubicBezTo>
                  <a:cubicBezTo>
                    <a:pt x="791192" y="707682"/>
                    <a:pt x="777944" y="709917"/>
                    <a:pt x="777632" y="709979"/>
                  </a:cubicBezTo>
                  <a:cubicBezTo>
                    <a:pt x="763683" y="728580"/>
                    <a:pt x="781645" y="705968"/>
                    <a:pt x="762199" y="725412"/>
                  </a:cubicBezTo>
                  <a:cubicBezTo>
                    <a:pt x="760560" y="727051"/>
                    <a:pt x="759850" y="729439"/>
                    <a:pt x="758341" y="731199"/>
                  </a:cubicBezTo>
                  <a:cubicBezTo>
                    <a:pt x="755974" y="733961"/>
                    <a:pt x="753197" y="736344"/>
                    <a:pt x="750625" y="738916"/>
                  </a:cubicBezTo>
                  <a:cubicBezTo>
                    <a:pt x="749982" y="742131"/>
                    <a:pt x="749732" y="745451"/>
                    <a:pt x="748695" y="748561"/>
                  </a:cubicBezTo>
                  <a:cubicBezTo>
                    <a:pt x="747785" y="751289"/>
                    <a:pt x="745534" y="753488"/>
                    <a:pt x="744837" y="756278"/>
                  </a:cubicBezTo>
                  <a:cubicBezTo>
                    <a:pt x="737981" y="783706"/>
                    <a:pt x="747762" y="762004"/>
                    <a:pt x="739050" y="779427"/>
                  </a:cubicBezTo>
                  <a:cubicBezTo>
                    <a:pt x="738407" y="789073"/>
                    <a:pt x="739218" y="798927"/>
                    <a:pt x="737121" y="808364"/>
                  </a:cubicBezTo>
                  <a:cubicBezTo>
                    <a:pt x="735308" y="816524"/>
                    <a:pt x="730658" y="823783"/>
                    <a:pt x="727475" y="831513"/>
                  </a:cubicBezTo>
                  <a:cubicBezTo>
                    <a:pt x="726156" y="834715"/>
                    <a:pt x="724457" y="837799"/>
                    <a:pt x="723617" y="841159"/>
                  </a:cubicBezTo>
                  <a:cubicBezTo>
                    <a:pt x="723000" y="843629"/>
                    <a:pt x="721142" y="851898"/>
                    <a:pt x="719759" y="854663"/>
                  </a:cubicBezTo>
                  <a:cubicBezTo>
                    <a:pt x="718722" y="856737"/>
                    <a:pt x="716859" y="858339"/>
                    <a:pt x="715900" y="860450"/>
                  </a:cubicBezTo>
                  <a:cubicBezTo>
                    <a:pt x="713626" y="865452"/>
                    <a:pt x="711729" y="870632"/>
                    <a:pt x="710113" y="875883"/>
                  </a:cubicBezTo>
                  <a:cubicBezTo>
                    <a:pt x="709149" y="879017"/>
                    <a:pt x="709335" y="882459"/>
                    <a:pt x="708184" y="885529"/>
                  </a:cubicBezTo>
                  <a:cubicBezTo>
                    <a:pt x="707370" y="887700"/>
                    <a:pt x="705363" y="889242"/>
                    <a:pt x="704326" y="891316"/>
                  </a:cubicBezTo>
                  <a:cubicBezTo>
                    <a:pt x="703417" y="893135"/>
                    <a:pt x="703306" y="895284"/>
                    <a:pt x="702397" y="897103"/>
                  </a:cubicBezTo>
                  <a:cubicBezTo>
                    <a:pt x="696800" y="908296"/>
                    <a:pt x="699752" y="897081"/>
                    <a:pt x="694680" y="910607"/>
                  </a:cubicBezTo>
                  <a:cubicBezTo>
                    <a:pt x="694129" y="912076"/>
                    <a:pt x="692154" y="922113"/>
                    <a:pt x="690822" y="924111"/>
                  </a:cubicBezTo>
                  <a:cubicBezTo>
                    <a:pt x="689309" y="926381"/>
                    <a:pt x="686781" y="927802"/>
                    <a:pt x="685035" y="929898"/>
                  </a:cubicBezTo>
                  <a:cubicBezTo>
                    <a:pt x="683551" y="931679"/>
                    <a:pt x="682462" y="933757"/>
                    <a:pt x="681176" y="935686"/>
                  </a:cubicBezTo>
                  <a:cubicBezTo>
                    <a:pt x="680533" y="938258"/>
                    <a:pt x="680562" y="941100"/>
                    <a:pt x="679247" y="943402"/>
                  </a:cubicBezTo>
                  <a:cubicBezTo>
                    <a:pt x="677894" y="945771"/>
                    <a:pt x="675206" y="947093"/>
                    <a:pt x="673460" y="949189"/>
                  </a:cubicBezTo>
                  <a:cubicBezTo>
                    <a:pt x="671976" y="950970"/>
                    <a:pt x="670639" y="952903"/>
                    <a:pt x="669602" y="954977"/>
                  </a:cubicBezTo>
                  <a:cubicBezTo>
                    <a:pt x="668693" y="956796"/>
                    <a:pt x="668921" y="959159"/>
                    <a:pt x="667673" y="960764"/>
                  </a:cubicBezTo>
                  <a:cubicBezTo>
                    <a:pt x="664323" y="965071"/>
                    <a:pt x="656098" y="972339"/>
                    <a:pt x="656098" y="972339"/>
                  </a:cubicBezTo>
                  <a:cubicBezTo>
                    <a:pt x="655455" y="976197"/>
                    <a:pt x="655918" y="980415"/>
                    <a:pt x="654169" y="983913"/>
                  </a:cubicBezTo>
                  <a:cubicBezTo>
                    <a:pt x="653132" y="985987"/>
                    <a:pt x="650098" y="986212"/>
                    <a:pt x="648382" y="987772"/>
                  </a:cubicBezTo>
                  <a:cubicBezTo>
                    <a:pt x="642999" y="992666"/>
                    <a:pt x="638093" y="998060"/>
                    <a:pt x="632949" y="1003204"/>
                  </a:cubicBezTo>
                  <a:cubicBezTo>
                    <a:pt x="631663" y="1004490"/>
                    <a:pt x="630099" y="1005549"/>
                    <a:pt x="629090" y="1007063"/>
                  </a:cubicBezTo>
                  <a:cubicBezTo>
                    <a:pt x="623719" y="1015120"/>
                    <a:pt x="626871" y="1011211"/>
                    <a:pt x="619445" y="1018637"/>
                  </a:cubicBezTo>
                  <a:cubicBezTo>
                    <a:pt x="618159" y="1021209"/>
                    <a:pt x="617182" y="1023961"/>
                    <a:pt x="615587" y="1026354"/>
                  </a:cubicBezTo>
                  <a:cubicBezTo>
                    <a:pt x="614578" y="1027867"/>
                    <a:pt x="612664" y="1028652"/>
                    <a:pt x="611728" y="1030212"/>
                  </a:cubicBezTo>
                  <a:cubicBezTo>
                    <a:pt x="610682" y="1031955"/>
                    <a:pt x="610927" y="1034307"/>
                    <a:pt x="609799" y="1035999"/>
                  </a:cubicBezTo>
                  <a:cubicBezTo>
                    <a:pt x="608286" y="1038269"/>
                    <a:pt x="605687" y="1039633"/>
                    <a:pt x="604012" y="1041787"/>
                  </a:cubicBezTo>
                  <a:cubicBezTo>
                    <a:pt x="601165" y="1045447"/>
                    <a:pt x="598867" y="1049503"/>
                    <a:pt x="596295" y="1053361"/>
                  </a:cubicBezTo>
                  <a:lnTo>
                    <a:pt x="592437" y="1059149"/>
                  </a:lnTo>
                  <a:cubicBezTo>
                    <a:pt x="589865" y="1058506"/>
                    <a:pt x="586791" y="1058876"/>
                    <a:pt x="584721" y="1057220"/>
                  </a:cubicBezTo>
                  <a:cubicBezTo>
                    <a:pt x="583133" y="1055949"/>
                    <a:pt x="583801" y="1053198"/>
                    <a:pt x="582792" y="1051432"/>
                  </a:cubicBezTo>
                  <a:cubicBezTo>
                    <a:pt x="581197" y="1048640"/>
                    <a:pt x="578848" y="1046350"/>
                    <a:pt x="577004" y="1043716"/>
                  </a:cubicBezTo>
                  <a:cubicBezTo>
                    <a:pt x="574345" y="1039917"/>
                    <a:pt x="571860" y="1035999"/>
                    <a:pt x="569288" y="1032141"/>
                  </a:cubicBezTo>
                  <a:cubicBezTo>
                    <a:pt x="568002" y="1030212"/>
                    <a:pt x="567359" y="1027640"/>
                    <a:pt x="565430" y="1026354"/>
                  </a:cubicBezTo>
                  <a:lnTo>
                    <a:pt x="559642" y="1022496"/>
                  </a:lnTo>
                  <a:cubicBezTo>
                    <a:pt x="555466" y="1005789"/>
                    <a:pt x="561766" y="1022690"/>
                    <a:pt x="549997" y="1010921"/>
                  </a:cubicBezTo>
                  <a:cubicBezTo>
                    <a:pt x="548559" y="1009483"/>
                    <a:pt x="549316" y="1006739"/>
                    <a:pt x="548068" y="1005134"/>
                  </a:cubicBezTo>
                  <a:cubicBezTo>
                    <a:pt x="544718" y="1000827"/>
                    <a:pt x="540351" y="997417"/>
                    <a:pt x="536493" y="993559"/>
                  </a:cubicBezTo>
                  <a:cubicBezTo>
                    <a:pt x="534564" y="991630"/>
                    <a:pt x="533146" y="988992"/>
                    <a:pt x="530706" y="987772"/>
                  </a:cubicBezTo>
                  <a:cubicBezTo>
                    <a:pt x="520549" y="982693"/>
                    <a:pt x="525023" y="985947"/>
                    <a:pt x="517202" y="978126"/>
                  </a:cubicBezTo>
                  <a:cubicBezTo>
                    <a:pt x="512058" y="979412"/>
                    <a:pt x="506643" y="979895"/>
                    <a:pt x="501769" y="981984"/>
                  </a:cubicBezTo>
                  <a:cubicBezTo>
                    <a:pt x="489721" y="987147"/>
                    <a:pt x="492416" y="988814"/>
                    <a:pt x="484407" y="995488"/>
                  </a:cubicBezTo>
                  <a:cubicBezTo>
                    <a:pt x="482626" y="996972"/>
                    <a:pt x="480548" y="998060"/>
                    <a:pt x="478619" y="999346"/>
                  </a:cubicBezTo>
                  <a:cubicBezTo>
                    <a:pt x="477333" y="1001918"/>
                    <a:pt x="474601" y="1004192"/>
                    <a:pt x="474761" y="1007063"/>
                  </a:cubicBezTo>
                  <a:cubicBezTo>
                    <a:pt x="475451" y="1019484"/>
                    <a:pt x="478858" y="1028997"/>
                    <a:pt x="482478" y="1039858"/>
                  </a:cubicBezTo>
                  <a:cubicBezTo>
                    <a:pt x="481774" y="1045487"/>
                    <a:pt x="481369" y="1059321"/>
                    <a:pt x="476690" y="1064936"/>
                  </a:cubicBezTo>
                  <a:cubicBezTo>
                    <a:pt x="475388" y="1066498"/>
                    <a:pt x="472832" y="1066222"/>
                    <a:pt x="470903" y="1066865"/>
                  </a:cubicBezTo>
                  <a:cubicBezTo>
                    <a:pt x="467266" y="1070502"/>
                    <a:pt x="464165" y="1074361"/>
                    <a:pt x="459328" y="1076511"/>
                  </a:cubicBezTo>
                  <a:cubicBezTo>
                    <a:pt x="455612" y="1078163"/>
                    <a:pt x="447754" y="1080369"/>
                    <a:pt x="447754" y="1080369"/>
                  </a:cubicBezTo>
                  <a:cubicBezTo>
                    <a:pt x="446468" y="1082941"/>
                    <a:pt x="445929" y="1086052"/>
                    <a:pt x="443895" y="1088086"/>
                  </a:cubicBezTo>
                  <a:cubicBezTo>
                    <a:pt x="442092" y="1089889"/>
                    <a:pt x="427998" y="1095216"/>
                    <a:pt x="426533" y="1095802"/>
                  </a:cubicBezTo>
                  <a:cubicBezTo>
                    <a:pt x="422675" y="1099660"/>
                    <a:pt x="420252" y="1106054"/>
                    <a:pt x="414959" y="1107377"/>
                  </a:cubicBezTo>
                  <a:lnTo>
                    <a:pt x="399526" y="1111235"/>
                  </a:lnTo>
                  <a:cubicBezTo>
                    <a:pt x="396954" y="1111878"/>
                    <a:pt x="394292" y="1112233"/>
                    <a:pt x="391809" y="1113164"/>
                  </a:cubicBezTo>
                  <a:cubicBezTo>
                    <a:pt x="386665" y="1115093"/>
                    <a:pt x="381752" y="1117819"/>
                    <a:pt x="376376" y="1118951"/>
                  </a:cubicBezTo>
                  <a:cubicBezTo>
                    <a:pt x="369426" y="1120414"/>
                    <a:pt x="362210" y="1120050"/>
                    <a:pt x="355156" y="1120880"/>
                  </a:cubicBezTo>
                  <a:cubicBezTo>
                    <a:pt x="351272" y="1121337"/>
                    <a:pt x="347440" y="1122167"/>
                    <a:pt x="343582" y="1122810"/>
                  </a:cubicBezTo>
                  <a:cubicBezTo>
                    <a:pt x="340367" y="1125382"/>
                    <a:pt x="337428" y="1128344"/>
                    <a:pt x="333936" y="1130526"/>
                  </a:cubicBezTo>
                  <a:cubicBezTo>
                    <a:pt x="332212" y="1131604"/>
                    <a:pt x="330111" y="1131920"/>
                    <a:pt x="328149" y="1132455"/>
                  </a:cubicBezTo>
                  <a:cubicBezTo>
                    <a:pt x="323033" y="1133850"/>
                    <a:pt x="317746" y="1134636"/>
                    <a:pt x="312716" y="1136313"/>
                  </a:cubicBezTo>
                  <a:lnTo>
                    <a:pt x="295354" y="1142101"/>
                  </a:lnTo>
                  <a:cubicBezTo>
                    <a:pt x="282493" y="1141458"/>
                    <a:pt x="262915" y="1151489"/>
                    <a:pt x="256771" y="1140172"/>
                  </a:cubicBezTo>
                  <a:cubicBezTo>
                    <a:pt x="246335" y="1120949"/>
                    <a:pt x="256883" y="1096379"/>
                    <a:pt x="258700" y="1074582"/>
                  </a:cubicBezTo>
                  <a:cubicBezTo>
                    <a:pt x="258851" y="1072769"/>
                    <a:pt x="261394" y="1072120"/>
                    <a:pt x="262559" y="1070723"/>
                  </a:cubicBezTo>
                  <a:cubicBezTo>
                    <a:pt x="264617" y="1068253"/>
                    <a:pt x="265943" y="1065143"/>
                    <a:pt x="268346" y="1063007"/>
                  </a:cubicBezTo>
                  <a:cubicBezTo>
                    <a:pt x="271812" y="1059926"/>
                    <a:pt x="276643" y="1058570"/>
                    <a:pt x="279921" y="1055291"/>
                  </a:cubicBezTo>
                  <a:cubicBezTo>
                    <a:pt x="281207" y="1054005"/>
                    <a:pt x="282643" y="1052852"/>
                    <a:pt x="283779" y="1051432"/>
                  </a:cubicBezTo>
                  <a:cubicBezTo>
                    <a:pt x="285227" y="1049622"/>
                    <a:pt x="285998" y="1047284"/>
                    <a:pt x="287637" y="1045645"/>
                  </a:cubicBezTo>
                  <a:cubicBezTo>
                    <a:pt x="289911" y="1043372"/>
                    <a:pt x="292964" y="1042009"/>
                    <a:pt x="295354" y="1039858"/>
                  </a:cubicBezTo>
                  <a:cubicBezTo>
                    <a:pt x="299410" y="1036208"/>
                    <a:pt x="304487" y="1033163"/>
                    <a:pt x="306928" y="1028283"/>
                  </a:cubicBezTo>
                  <a:cubicBezTo>
                    <a:pt x="308214" y="1025711"/>
                    <a:pt x="308754" y="1022600"/>
                    <a:pt x="310787" y="1020567"/>
                  </a:cubicBezTo>
                  <a:cubicBezTo>
                    <a:pt x="312225" y="1019129"/>
                    <a:pt x="314645" y="1019280"/>
                    <a:pt x="316574" y="1018637"/>
                  </a:cubicBezTo>
                  <a:cubicBezTo>
                    <a:pt x="318503" y="1016065"/>
                    <a:pt x="320210" y="1013311"/>
                    <a:pt x="322361" y="1010921"/>
                  </a:cubicBezTo>
                  <a:cubicBezTo>
                    <a:pt x="326011" y="1006865"/>
                    <a:pt x="333936" y="999346"/>
                    <a:pt x="333936" y="999346"/>
                  </a:cubicBezTo>
                  <a:cubicBezTo>
                    <a:pt x="334579" y="997417"/>
                    <a:pt x="336134" y="995575"/>
                    <a:pt x="335865" y="993559"/>
                  </a:cubicBezTo>
                  <a:cubicBezTo>
                    <a:pt x="330905" y="956361"/>
                    <a:pt x="332255" y="981043"/>
                    <a:pt x="328149" y="964622"/>
                  </a:cubicBezTo>
                  <a:cubicBezTo>
                    <a:pt x="325690" y="954787"/>
                    <a:pt x="325492" y="948433"/>
                    <a:pt x="324290" y="937615"/>
                  </a:cubicBezTo>
                  <a:cubicBezTo>
                    <a:pt x="324381" y="936252"/>
                    <a:pt x="319751" y="909983"/>
                    <a:pt x="330078" y="904820"/>
                  </a:cubicBezTo>
                  <a:cubicBezTo>
                    <a:pt x="332449" y="903634"/>
                    <a:pt x="335222" y="903534"/>
                    <a:pt x="337794" y="902891"/>
                  </a:cubicBezTo>
                  <a:cubicBezTo>
                    <a:pt x="339080" y="900962"/>
                    <a:pt x="339578" y="898140"/>
                    <a:pt x="341652" y="897103"/>
                  </a:cubicBezTo>
                  <a:cubicBezTo>
                    <a:pt x="345151" y="895354"/>
                    <a:pt x="349409" y="896022"/>
                    <a:pt x="353227" y="895174"/>
                  </a:cubicBezTo>
                  <a:cubicBezTo>
                    <a:pt x="355212" y="894733"/>
                    <a:pt x="357059" y="893804"/>
                    <a:pt x="359014" y="893245"/>
                  </a:cubicBezTo>
                  <a:cubicBezTo>
                    <a:pt x="379428" y="887413"/>
                    <a:pt x="350793" y="896628"/>
                    <a:pt x="378306" y="887458"/>
                  </a:cubicBezTo>
                  <a:cubicBezTo>
                    <a:pt x="381554" y="877713"/>
                    <a:pt x="382739" y="876786"/>
                    <a:pt x="378306" y="862379"/>
                  </a:cubicBezTo>
                  <a:cubicBezTo>
                    <a:pt x="377504" y="859771"/>
                    <a:pt x="374265" y="858688"/>
                    <a:pt x="372518" y="856592"/>
                  </a:cubicBezTo>
                  <a:cubicBezTo>
                    <a:pt x="359082" y="840469"/>
                    <a:pt x="379788" y="861932"/>
                    <a:pt x="362873" y="845017"/>
                  </a:cubicBezTo>
                  <a:cubicBezTo>
                    <a:pt x="362230" y="843088"/>
                    <a:pt x="361990" y="840973"/>
                    <a:pt x="360944" y="839230"/>
                  </a:cubicBezTo>
                  <a:cubicBezTo>
                    <a:pt x="359113" y="836178"/>
                    <a:pt x="353924" y="833264"/>
                    <a:pt x="351298" y="831513"/>
                  </a:cubicBezTo>
                  <a:cubicBezTo>
                    <a:pt x="350012" y="829584"/>
                    <a:pt x="349250" y="827174"/>
                    <a:pt x="347440" y="825726"/>
                  </a:cubicBezTo>
                  <a:cubicBezTo>
                    <a:pt x="342527" y="821796"/>
                    <a:pt x="334839" y="824933"/>
                    <a:pt x="330078" y="825726"/>
                  </a:cubicBezTo>
                  <a:lnTo>
                    <a:pt x="312716" y="843088"/>
                  </a:lnTo>
                  <a:cubicBezTo>
                    <a:pt x="311430" y="844374"/>
                    <a:pt x="310370" y="845937"/>
                    <a:pt x="308857" y="846946"/>
                  </a:cubicBezTo>
                  <a:cubicBezTo>
                    <a:pt x="306928" y="848232"/>
                    <a:pt x="304851" y="849320"/>
                    <a:pt x="303070" y="850804"/>
                  </a:cubicBezTo>
                  <a:cubicBezTo>
                    <a:pt x="297502" y="855445"/>
                    <a:pt x="297218" y="856690"/>
                    <a:pt x="293425" y="862379"/>
                  </a:cubicBezTo>
                  <a:cubicBezTo>
                    <a:pt x="292782" y="865594"/>
                    <a:pt x="291878" y="868768"/>
                    <a:pt x="291495" y="872025"/>
                  </a:cubicBezTo>
                  <a:cubicBezTo>
                    <a:pt x="290590" y="879715"/>
                    <a:pt x="291561" y="887692"/>
                    <a:pt x="289566" y="895174"/>
                  </a:cubicBezTo>
                  <a:cubicBezTo>
                    <a:pt x="288863" y="897810"/>
                    <a:pt x="285525" y="898865"/>
                    <a:pt x="283779" y="900961"/>
                  </a:cubicBezTo>
                  <a:cubicBezTo>
                    <a:pt x="270358" y="917068"/>
                    <a:pt x="291033" y="895639"/>
                    <a:pt x="274133" y="912536"/>
                  </a:cubicBezTo>
                  <a:cubicBezTo>
                    <a:pt x="273490" y="914465"/>
                    <a:pt x="273113" y="916504"/>
                    <a:pt x="272204" y="918323"/>
                  </a:cubicBezTo>
                  <a:cubicBezTo>
                    <a:pt x="271167" y="920397"/>
                    <a:pt x="269575" y="922145"/>
                    <a:pt x="268346" y="924111"/>
                  </a:cubicBezTo>
                  <a:cubicBezTo>
                    <a:pt x="266359" y="927290"/>
                    <a:pt x="264236" y="930403"/>
                    <a:pt x="262559" y="933756"/>
                  </a:cubicBezTo>
                  <a:cubicBezTo>
                    <a:pt x="248884" y="961105"/>
                    <a:pt x="265115" y="930831"/>
                    <a:pt x="256771" y="949189"/>
                  </a:cubicBezTo>
                  <a:cubicBezTo>
                    <a:pt x="254391" y="954425"/>
                    <a:pt x="249055" y="964622"/>
                    <a:pt x="249055" y="964622"/>
                  </a:cubicBezTo>
                  <a:cubicBezTo>
                    <a:pt x="249698" y="971695"/>
                    <a:pt x="248895" y="979054"/>
                    <a:pt x="250984" y="985842"/>
                  </a:cubicBezTo>
                  <a:cubicBezTo>
                    <a:pt x="251666" y="988058"/>
                    <a:pt x="255038" y="988161"/>
                    <a:pt x="256771" y="989701"/>
                  </a:cubicBezTo>
                  <a:cubicBezTo>
                    <a:pt x="276592" y="1007320"/>
                    <a:pt x="260999" y="996376"/>
                    <a:pt x="274133" y="1005134"/>
                  </a:cubicBezTo>
                  <a:cubicBezTo>
                    <a:pt x="274776" y="1007706"/>
                    <a:pt x="277107" y="1010413"/>
                    <a:pt x="276063" y="1012850"/>
                  </a:cubicBezTo>
                  <a:cubicBezTo>
                    <a:pt x="274117" y="1017390"/>
                    <a:pt x="266717" y="1019180"/>
                    <a:pt x="262559" y="1020567"/>
                  </a:cubicBezTo>
                  <a:cubicBezTo>
                    <a:pt x="253461" y="1034211"/>
                    <a:pt x="265346" y="1017777"/>
                    <a:pt x="250984" y="1032141"/>
                  </a:cubicBezTo>
                  <a:cubicBezTo>
                    <a:pt x="249345" y="1033781"/>
                    <a:pt x="249092" y="1036700"/>
                    <a:pt x="247126" y="1037929"/>
                  </a:cubicBezTo>
                  <a:cubicBezTo>
                    <a:pt x="243677" y="1040085"/>
                    <a:pt x="235551" y="1041787"/>
                    <a:pt x="235551" y="1041787"/>
                  </a:cubicBezTo>
                  <a:cubicBezTo>
                    <a:pt x="233622" y="1043716"/>
                    <a:pt x="232034" y="1046061"/>
                    <a:pt x="229764" y="1047574"/>
                  </a:cubicBezTo>
                  <a:cubicBezTo>
                    <a:pt x="228072" y="1048702"/>
                    <a:pt x="225949" y="1049010"/>
                    <a:pt x="223976" y="1049503"/>
                  </a:cubicBezTo>
                  <a:cubicBezTo>
                    <a:pt x="218224" y="1050941"/>
                    <a:pt x="212401" y="1052075"/>
                    <a:pt x="206614" y="1053361"/>
                  </a:cubicBezTo>
                  <a:cubicBezTo>
                    <a:pt x="202113" y="1052718"/>
                    <a:pt x="197466" y="1052738"/>
                    <a:pt x="193111" y="1051432"/>
                  </a:cubicBezTo>
                  <a:cubicBezTo>
                    <a:pt x="190890" y="1050766"/>
                    <a:pt x="188963" y="1049213"/>
                    <a:pt x="187323" y="1047574"/>
                  </a:cubicBezTo>
                  <a:cubicBezTo>
                    <a:pt x="181887" y="1042138"/>
                    <a:pt x="182063" y="1039551"/>
                    <a:pt x="177678" y="1034070"/>
                  </a:cubicBezTo>
                  <a:cubicBezTo>
                    <a:pt x="176542" y="1032650"/>
                    <a:pt x="174955" y="1031632"/>
                    <a:pt x="173819" y="1030212"/>
                  </a:cubicBezTo>
                  <a:cubicBezTo>
                    <a:pt x="168382" y="1023417"/>
                    <a:pt x="168193" y="1017752"/>
                    <a:pt x="158387" y="1012850"/>
                  </a:cubicBezTo>
                  <a:lnTo>
                    <a:pt x="150670" y="1008992"/>
                  </a:lnTo>
                  <a:cubicBezTo>
                    <a:pt x="148741" y="1007063"/>
                    <a:pt x="147197" y="1004650"/>
                    <a:pt x="144883" y="1003204"/>
                  </a:cubicBezTo>
                  <a:cubicBezTo>
                    <a:pt x="140042" y="1000178"/>
                    <a:pt x="133034" y="998795"/>
                    <a:pt x="127521" y="997417"/>
                  </a:cubicBezTo>
                  <a:cubicBezTo>
                    <a:pt x="113218" y="987882"/>
                    <a:pt x="120493" y="990610"/>
                    <a:pt x="106300" y="987772"/>
                  </a:cubicBezTo>
                  <a:cubicBezTo>
                    <a:pt x="103728" y="986486"/>
                    <a:pt x="101227" y="985046"/>
                    <a:pt x="98584" y="983913"/>
                  </a:cubicBezTo>
                  <a:cubicBezTo>
                    <a:pt x="96715" y="983112"/>
                    <a:pt x="94701" y="982698"/>
                    <a:pt x="92797" y="981984"/>
                  </a:cubicBezTo>
                  <a:cubicBezTo>
                    <a:pt x="89554" y="980768"/>
                    <a:pt x="86366" y="979412"/>
                    <a:pt x="83151" y="978126"/>
                  </a:cubicBezTo>
                  <a:cubicBezTo>
                    <a:pt x="74805" y="965607"/>
                    <a:pt x="84993" y="978077"/>
                    <a:pt x="71576" y="970410"/>
                  </a:cubicBezTo>
                  <a:cubicBezTo>
                    <a:pt x="53697" y="960193"/>
                    <a:pt x="78365" y="967766"/>
                    <a:pt x="58073" y="962693"/>
                  </a:cubicBezTo>
                  <a:cubicBezTo>
                    <a:pt x="56787" y="961407"/>
                    <a:pt x="55350" y="960255"/>
                    <a:pt x="54214" y="958835"/>
                  </a:cubicBezTo>
                  <a:cubicBezTo>
                    <a:pt x="48628" y="951853"/>
                    <a:pt x="47503" y="948375"/>
                    <a:pt x="52285" y="937615"/>
                  </a:cubicBezTo>
                  <a:cubicBezTo>
                    <a:pt x="53111" y="935757"/>
                    <a:pt x="56144" y="936329"/>
                    <a:pt x="58073" y="935686"/>
                  </a:cubicBezTo>
                  <a:cubicBezTo>
                    <a:pt x="87317" y="916188"/>
                    <a:pt x="57307" y="937289"/>
                    <a:pt x="75435" y="922182"/>
                  </a:cubicBezTo>
                  <a:cubicBezTo>
                    <a:pt x="91541" y="908760"/>
                    <a:pt x="70111" y="929434"/>
                    <a:pt x="87009" y="912536"/>
                  </a:cubicBezTo>
                  <a:cubicBezTo>
                    <a:pt x="87652" y="910607"/>
                    <a:pt x="87350" y="908019"/>
                    <a:pt x="88938" y="906749"/>
                  </a:cubicBezTo>
                  <a:cubicBezTo>
                    <a:pt x="93451" y="903139"/>
                    <a:pt x="98110" y="904892"/>
                    <a:pt x="102442" y="906749"/>
                  </a:cubicBezTo>
                  <a:cubicBezTo>
                    <a:pt x="105085" y="907882"/>
                    <a:pt x="107662" y="909180"/>
                    <a:pt x="110159" y="910607"/>
                  </a:cubicBezTo>
                  <a:cubicBezTo>
                    <a:pt x="112172" y="911757"/>
                    <a:pt x="113687" y="913944"/>
                    <a:pt x="115946" y="914465"/>
                  </a:cubicBezTo>
                  <a:cubicBezTo>
                    <a:pt x="122243" y="915918"/>
                    <a:pt x="128807" y="915751"/>
                    <a:pt x="135237" y="916394"/>
                  </a:cubicBezTo>
                  <a:cubicBezTo>
                    <a:pt x="139095" y="917680"/>
                    <a:pt x="142954" y="920252"/>
                    <a:pt x="146812" y="916394"/>
                  </a:cubicBezTo>
                  <a:cubicBezTo>
                    <a:pt x="148250" y="914956"/>
                    <a:pt x="148098" y="912536"/>
                    <a:pt x="148741" y="910607"/>
                  </a:cubicBezTo>
                  <a:cubicBezTo>
                    <a:pt x="153406" y="877951"/>
                    <a:pt x="147164" y="911482"/>
                    <a:pt x="154528" y="889387"/>
                  </a:cubicBezTo>
                  <a:cubicBezTo>
                    <a:pt x="160089" y="872702"/>
                    <a:pt x="152391" y="885838"/>
                    <a:pt x="160316" y="873954"/>
                  </a:cubicBezTo>
                  <a:cubicBezTo>
                    <a:pt x="160959" y="872025"/>
                    <a:pt x="161531" y="870071"/>
                    <a:pt x="162245" y="868167"/>
                  </a:cubicBezTo>
                  <a:cubicBezTo>
                    <a:pt x="163461" y="864924"/>
                    <a:pt x="165465" y="861925"/>
                    <a:pt x="166103" y="858521"/>
                  </a:cubicBezTo>
                  <a:cubicBezTo>
                    <a:pt x="167412" y="851540"/>
                    <a:pt x="167389" y="844374"/>
                    <a:pt x="168032" y="837301"/>
                  </a:cubicBezTo>
                  <a:cubicBezTo>
                    <a:pt x="167389" y="830871"/>
                    <a:pt x="167457" y="824329"/>
                    <a:pt x="166103" y="818010"/>
                  </a:cubicBezTo>
                  <a:cubicBezTo>
                    <a:pt x="165500" y="815198"/>
                    <a:pt x="164066" y="812519"/>
                    <a:pt x="162245" y="810293"/>
                  </a:cubicBezTo>
                  <a:cubicBezTo>
                    <a:pt x="145469" y="789788"/>
                    <a:pt x="154632" y="802273"/>
                    <a:pt x="142954" y="792931"/>
                  </a:cubicBezTo>
                  <a:cubicBezTo>
                    <a:pt x="141534" y="791795"/>
                    <a:pt x="140492" y="790237"/>
                    <a:pt x="139095" y="789073"/>
                  </a:cubicBezTo>
                  <a:cubicBezTo>
                    <a:pt x="136625" y="787015"/>
                    <a:pt x="133951" y="785215"/>
                    <a:pt x="131379" y="783286"/>
                  </a:cubicBezTo>
                  <a:cubicBezTo>
                    <a:pt x="132022" y="779428"/>
                    <a:pt x="132460" y="775529"/>
                    <a:pt x="133308" y="771711"/>
                  </a:cubicBezTo>
                  <a:cubicBezTo>
                    <a:pt x="133749" y="769726"/>
                    <a:pt x="134678" y="767878"/>
                    <a:pt x="135237" y="765923"/>
                  </a:cubicBezTo>
                  <a:cubicBezTo>
                    <a:pt x="135965" y="763374"/>
                    <a:pt x="136438" y="760756"/>
                    <a:pt x="137166" y="758207"/>
                  </a:cubicBezTo>
                  <a:cubicBezTo>
                    <a:pt x="138202" y="754582"/>
                    <a:pt x="139822" y="749138"/>
                    <a:pt x="142954" y="746632"/>
                  </a:cubicBezTo>
                  <a:cubicBezTo>
                    <a:pt x="144542" y="745362"/>
                    <a:pt x="146837" y="745417"/>
                    <a:pt x="148741" y="744703"/>
                  </a:cubicBezTo>
                  <a:cubicBezTo>
                    <a:pt x="151984" y="743487"/>
                    <a:pt x="155133" y="742028"/>
                    <a:pt x="158387" y="740845"/>
                  </a:cubicBezTo>
                  <a:cubicBezTo>
                    <a:pt x="162209" y="739455"/>
                    <a:pt x="169961" y="736987"/>
                    <a:pt x="169961" y="736987"/>
                  </a:cubicBezTo>
                  <a:cubicBezTo>
                    <a:pt x="171247" y="735058"/>
                    <a:pt x="174107" y="733500"/>
                    <a:pt x="173819" y="731199"/>
                  </a:cubicBezTo>
                  <a:cubicBezTo>
                    <a:pt x="173640" y="729767"/>
                    <a:pt x="165906" y="718366"/>
                    <a:pt x="164174" y="715767"/>
                  </a:cubicBezTo>
                  <a:cubicBezTo>
                    <a:pt x="163814" y="714326"/>
                    <a:pt x="161502" y="704240"/>
                    <a:pt x="160316" y="702263"/>
                  </a:cubicBezTo>
                  <a:cubicBezTo>
                    <a:pt x="159380" y="700703"/>
                    <a:pt x="157743" y="699690"/>
                    <a:pt x="156457" y="698404"/>
                  </a:cubicBezTo>
                  <a:cubicBezTo>
                    <a:pt x="157100" y="682971"/>
                    <a:pt x="157246" y="667510"/>
                    <a:pt x="158387" y="652106"/>
                  </a:cubicBezTo>
                  <a:cubicBezTo>
                    <a:pt x="158553" y="649867"/>
                    <a:pt x="163185" y="639261"/>
                    <a:pt x="164174" y="638602"/>
                  </a:cubicBezTo>
                  <a:cubicBezTo>
                    <a:pt x="168069" y="636005"/>
                    <a:pt x="173278" y="636344"/>
                    <a:pt x="177678" y="634744"/>
                  </a:cubicBezTo>
                  <a:cubicBezTo>
                    <a:pt x="180380" y="633761"/>
                    <a:pt x="182822" y="632172"/>
                    <a:pt x="185394" y="630886"/>
                  </a:cubicBezTo>
                  <a:cubicBezTo>
                    <a:pt x="192107" y="624171"/>
                    <a:pt x="190982" y="622759"/>
                    <a:pt x="202756" y="636673"/>
                  </a:cubicBezTo>
                  <a:cubicBezTo>
                    <a:pt x="206471" y="641064"/>
                    <a:pt x="207719" y="647057"/>
                    <a:pt x="210473" y="652106"/>
                  </a:cubicBezTo>
                  <a:cubicBezTo>
                    <a:pt x="213696" y="658015"/>
                    <a:pt x="215219" y="658781"/>
                    <a:pt x="220118" y="663680"/>
                  </a:cubicBezTo>
                  <a:cubicBezTo>
                    <a:pt x="223976" y="663037"/>
                    <a:pt x="228194" y="663500"/>
                    <a:pt x="231693" y="661751"/>
                  </a:cubicBezTo>
                  <a:cubicBezTo>
                    <a:pt x="233767" y="660714"/>
                    <a:pt x="234067" y="657745"/>
                    <a:pt x="235551" y="655964"/>
                  </a:cubicBezTo>
                  <a:cubicBezTo>
                    <a:pt x="237297" y="653868"/>
                    <a:pt x="239592" y="652273"/>
                    <a:pt x="241338" y="650177"/>
                  </a:cubicBezTo>
                  <a:cubicBezTo>
                    <a:pt x="242822" y="648396"/>
                    <a:pt x="243452" y="645916"/>
                    <a:pt x="245197" y="644389"/>
                  </a:cubicBezTo>
                  <a:cubicBezTo>
                    <a:pt x="248686" y="641336"/>
                    <a:pt x="252913" y="639245"/>
                    <a:pt x="256771" y="636673"/>
                  </a:cubicBezTo>
                  <a:cubicBezTo>
                    <a:pt x="266174" y="622572"/>
                    <a:pt x="252718" y="640677"/>
                    <a:pt x="276063" y="623169"/>
                  </a:cubicBezTo>
                  <a:cubicBezTo>
                    <a:pt x="278635" y="621240"/>
                    <a:pt x="280969" y="618943"/>
                    <a:pt x="283779" y="617382"/>
                  </a:cubicBezTo>
                  <a:cubicBezTo>
                    <a:pt x="289725" y="614079"/>
                    <a:pt x="294782" y="613184"/>
                    <a:pt x="301141" y="611594"/>
                  </a:cubicBezTo>
                  <a:cubicBezTo>
                    <a:pt x="302427" y="609665"/>
                    <a:pt x="303112" y="607154"/>
                    <a:pt x="304999" y="605807"/>
                  </a:cubicBezTo>
                  <a:cubicBezTo>
                    <a:pt x="307817" y="603794"/>
                    <a:pt x="311548" y="603498"/>
                    <a:pt x="314645" y="601949"/>
                  </a:cubicBezTo>
                  <a:cubicBezTo>
                    <a:pt x="316719" y="600912"/>
                    <a:pt x="318358" y="599128"/>
                    <a:pt x="320432" y="598091"/>
                  </a:cubicBezTo>
                  <a:cubicBezTo>
                    <a:pt x="322251" y="597181"/>
                    <a:pt x="324441" y="597149"/>
                    <a:pt x="326219" y="596161"/>
                  </a:cubicBezTo>
                  <a:cubicBezTo>
                    <a:pt x="343766" y="586412"/>
                    <a:pt x="332337" y="592029"/>
                    <a:pt x="343582" y="582658"/>
                  </a:cubicBezTo>
                  <a:cubicBezTo>
                    <a:pt x="345363" y="581174"/>
                    <a:pt x="347646" y="580350"/>
                    <a:pt x="349369" y="578799"/>
                  </a:cubicBezTo>
                  <a:cubicBezTo>
                    <a:pt x="354101" y="574541"/>
                    <a:pt x="358372" y="569797"/>
                    <a:pt x="362873" y="565296"/>
                  </a:cubicBezTo>
                  <a:cubicBezTo>
                    <a:pt x="364159" y="564010"/>
                    <a:pt x="365005" y="562012"/>
                    <a:pt x="366731" y="561437"/>
                  </a:cubicBezTo>
                  <a:cubicBezTo>
                    <a:pt x="375246" y="558599"/>
                    <a:pt x="370699" y="560417"/>
                    <a:pt x="380235" y="555650"/>
                  </a:cubicBezTo>
                  <a:cubicBezTo>
                    <a:pt x="393448" y="542435"/>
                    <a:pt x="387269" y="547101"/>
                    <a:pt x="397597" y="540217"/>
                  </a:cubicBezTo>
                  <a:cubicBezTo>
                    <a:pt x="400169" y="536359"/>
                    <a:pt x="403239" y="532789"/>
                    <a:pt x="405313" y="528642"/>
                  </a:cubicBezTo>
                  <a:cubicBezTo>
                    <a:pt x="414250" y="510770"/>
                    <a:pt x="408964" y="517277"/>
                    <a:pt x="418817" y="507422"/>
                  </a:cubicBezTo>
                  <a:cubicBezTo>
                    <a:pt x="420494" y="494003"/>
                    <a:pt x="420450" y="492655"/>
                    <a:pt x="422675" y="480415"/>
                  </a:cubicBezTo>
                  <a:cubicBezTo>
                    <a:pt x="423262" y="477189"/>
                    <a:pt x="423483" y="473851"/>
                    <a:pt x="424604" y="470769"/>
                  </a:cubicBezTo>
                  <a:cubicBezTo>
                    <a:pt x="426078" y="466715"/>
                    <a:pt x="428640" y="463136"/>
                    <a:pt x="430392" y="459194"/>
                  </a:cubicBezTo>
                  <a:cubicBezTo>
                    <a:pt x="431218" y="457336"/>
                    <a:pt x="431678" y="455336"/>
                    <a:pt x="432321" y="453407"/>
                  </a:cubicBezTo>
                  <a:cubicBezTo>
                    <a:pt x="431678" y="445691"/>
                    <a:pt x="432969" y="437560"/>
                    <a:pt x="430392" y="430258"/>
                  </a:cubicBezTo>
                  <a:cubicBezTo>
                    <a:pt x="428879" y="425970"/>
                    <a:pt x="423961" y="423827"/>
                    <a:pt x="420746" y="420612"/>
                  </a:cubicBezTo>
                  <a:cubicBezTo>
                    <a:pt x="418817" y="418683"/>
                    <a:pt x="417547" y="415688"/>
                    <a:pt x="414959" y="414825"/>
                  </a:cubicBezTo>
                  <a:cubicBezTo>
                    <a:pt x="401825" y="410448"/>
                    <a:pt x="411198" y="413065"/>
                    <a:pt x="386022" y="410967"/>
                  </a:cubicBezTo>
                  <a:cubicBezTo>
                    <a:pt x="384093" y="410324"/>
                    <a:pt x="376678" y="408809"/>
                    <a:pt x="376376" y="405179"/>
                  </a:cubicBezTo>
                  <a:cubicBezTo>
                    <a:pt x="375713" y="397217"/>
                    <a:pt x="378149" y="382342"/>
                    <a:pt x="382164" y="374313"/>
                  </a:cubicBezTo>
                  <a:cubicBezTo>
                    <a:pt x="384238" y="370166"/>
                    <a:pt x="389880" y="362739"/>
                    <a:pt x="389880" y="362739"/>
                  </a:cubicBezTo>
                  <a:cubicBezTo>
                    <a:pt x="392898" y="347648"/>
                    <a:pt x="394508" y="346239"/>
                    <a:pt x="386022" y="326086"/>
                  </a:cubicBezTo>
                  <a:cubicBezTo>
                    <a:pt x="384257" y="321895"/>
                    <a:pt x="378898" y="320223"/>
                    <a:pt x="376376" y="316440"/>
                  </a:cubicBezTo>
                  <a:cubicBezTo>
                    <a:pt x="367284" y="302802"/>
                    <a:pt x="378694" y="319686"/>
                    <a:pt x="366731" y="302936"/>
                  </a:cubicBezTo>
                  <a:cubicBezTo>
                    <a:pt x="365384" y="301049"/>
                    <a:pt x="364159" y="299078"/>
                    <a:pt x="362873" y="297149"/>
                  </a:cubicBezTo>
                  <a:cubicBezTo>
                    <a:pt x="362615" y="296115"/>
                    <a:pt x="360124" y="285309"/>
                    <a:pt x="359014" y="283645"/>
                  </a:cubicBezTo>
                  <a:cubicBezTo>
                    <a:pt x="357501" y="281375"/>
                    <a:pt x="355156" y="279787"/>
                    <a:pt x="353227" y="277858"/>
                  </a:cubicBezTo>
                  <a:cubicBezTo>
                    <a:pt x="349780" y="267516"/>
                    <a:pt x="352473" y="276392"/>
                    <a:pt x="349369" y="262425"/>
                  </a:cubicBezTo>
                  <a:cubicBezTo>
                    <a:pt x="348794" y="259837"/>
                    <a:pt x="349315" y="256583"/>
                    <a:pt x="347440" y="254708"/>
                  </a:cubicBezTo>
                  <a:cubicBezTo>
                    <a:pt x="344991" y="252259"/>
                    <a:pt x="341009" y="252136"/>
                    <a:pt x="337794" y="250850"/>
                  </a:cubicBezTo>
                  <a:cubicBezTo>
                    <a:pt x="335222" y="253422"/>
                    <a:pt x="332445" y="255805"/>
                    <a:pt x="330078" y="258567"/>
                  </a:cubicBezTo>
                  <a:cubicBezTo>
                    <a:pt x="328569" y="260327"/>
                    <a:pt x="328148" y="263068"/>
                    <a:pt x="326219" y="264354"/>
                  </a:cubicBezTo>
                  <a:cubicBezTo>
                    <a:pt x="324013" y="265825"/>
                    <a:pt x="321141" y="266019"/>
                    <a:pt x="318503" y="266283"/>
                  </a:cubicBezTo>
                  <a:cubicBezTo>
                    <a:pt x="308245" y="267309"/>
                    <a:pt x="297926" y="267569"/>
                    <a:pt x="287637" y="268212"/>
                  </a:cubicBezTo>
                  <a:cubicBezTo>
                    <a:pt x="285708" y="268855"/>
                    <a:pt x="283805" y="269582"/>
                    <a:pt x="281850" y="270141"/>
                  </a:cubicBezTo>
                  <a:cubicBezTo>
                    <a:pt x="279301" y="270869"/>
                    <a:pt x="276570" y="271025"/>
                    <a:pt x="274133" y="272070"/>
                  </a:cubicBezTo>
                  <a:cubicBezTo>
                    <a:pt x="272002" y="272983"/>
                    <a:pt x="270275" y="274643"/>
                    <a:pt x="268346" y="275929"/>
                  </a:cubicBezTo>
                  <a:cubicBezTo>
                    <a:pt x="267703" y="277858"/>
                    <a:pt x="267326" y="279897"/>
                    <a:pt x="266417" y="281716"/>
                  </a:cubicBezTo>
                  <a:cubicBezTo>
                    <a:pt x="257141" y="300267"/>
                    <a:pt x="269150" y="269916"/>
                    <a:pt x="256771" y="297149"/>
                  </a:cubicBezTo>
                  <a:cubicBezTo>
                    <a:pt x="249381" y="313406"/>
                    <a:pt x="257111" y="304524"/>
                    <a:pt x="249055" y="312582"/>
                  </a:cubicBezTo>
                  <a:cubicBezTo>
                    <a:pt x="248412" y="315797"/>
                    <a:pt x="248277" y="319157"/>
                    <a:pt x="247126" y="322227"/>
                  </a:cubicBezTo>
                  <a:cubicBezTo>
                    <a:pt x="246312" y="324398"/>
                    <a:pt x="244305" y="325941"/>
                    <a:pt x="243268" y="328015"/>
                  </a:cubicBezTo>
                  <a:cubicBezTo>
                    <a:pt x="242359" y="329834"/>
                    <a:pt x="242248" y="331983"/>
                    <a:pt x="241338" y="333802"/>
                  </a:cubicBezTo>
                  <a:cubicBezTo>
                    <a:pt x="240301" y="335876"/>
                    <a:pt x="238630" y="337576"/>
                    <a:pt x="237480" y="339589"/>
                  </a:cubicBezTo>
                  <a:cubicBezTo>
                    <a:pt x="236053" y="342086"/>
                    <a:pt x="235049" y="344809"/>
                    <a:pt x="233622" y="347306"/>
                  </a:cubicBezTo>
                  <a:cubicBezTo>
                    <a:pt x="227638" y="357778"/>
                    <a:pt x="231372" y="348268"/>
                    <a:pt x="227835" y="358880"/>
                  </a:cubicBezTo>
                  <a:cubicBezTo>
                    <a:pt x="229121" y="363381"/>
                    <a:pt x="228383" y="369074"/>
                    <a:pt x="231693" y="372384"/>
                  </a:cubicBezTo>
                  <a:cubicBezTo>
                    <a:pt x="234459" y="375150"/>
                    <a:pt x="239450" y="373465"/>
                    <a:pt x="243268" y="374313"/>
                  </a:cubicBezTo>
                  <a:cubicBezTo>
                    <a:pt x="245253" y="374754"/>
                    <a:pt x="247061" y="375843"/>
                    <a:pt x="249055" y="376242"/>
                  </a:cubicBezTo>
                  <a:cubicBezTo>
                    <a:pt x="256726" y="377776"/>
                    <a:pt x="264682" y="377952"/>
                    <a:pt x="272204" y="380101"/>
                  </a:cubicBezTo>
                  <a:cubicBezTo>
                    <a:pt x="276705" y="381387"/>
                    <a:pt x="281234" y="382582"/>
                    <a:pt x="285708" y="383959"/>
                  </a:cubicBezTo>
                  <a:cubicBezTo>
                    <a:pt x="289595" y="385155"/>
                    <a:pt x="293295" y="387019"/>
                    <a:pt x="297283" y="387817"/>
                  </a:cubicBezTo>
                  <a:lnTo>
                    <a:pt x="306928" y="389746"/>
                  </a:lnTo>
                  <a:cubicBezTo>
                    <a:pt x="308214" y="391675"/>
                    <a:pt x="309303" y="393753"/>
                    <a:pt x="310787" y="395534"/>
                  </a:cubicBezTo>
                  <a:cubicBezTo>
                    <a:pt x="323163" y="410385"/>
                    <a:pt x="310854" y="392741"/>
                    <a:pt x="320432" y="407108"/>
                  </a:cubicBezTo>
                  <a:cubicBezTo>
                    <a:pt x="321075" y="409037"/>
                    <a:pt x="322361" y="410862"/>
                    <a:pt x="322361" y="412896"/>
                  </a:cubicBezTo>
                  <a:cubicBezTo>
                    <a:pt x="322361" y="419998"/>
                    <a:pt x="323408" y="427667"/>
                    <a:pt x="320432" y="434116"/>
                  </a:cubicBezTo>
                  <a:cubicBezTo>
                    <a:pt x="318981" y="437260"/>
                    <a:pt x="314029" y="436758"/>
                    <a:pt x="310787" y="437974"/>
                  </a:cubicBezTo>
                  <a:cubicBezTo>
                    <a:pt x="305254" y="440049"/>
                    <a:pt x="303360" y="440313"/>
                    <a:pt x="297283" y="441832"/>
                  </a:cubicBezTo>
                  <a:lnTo>
                    <a:pt x="289566" y="449549"/>
                  </a:lnTo>
                  <a:cubicBezTo>
                    <a:pt x="287637" y="451478"/>
                    <a:pt x="286426" y="454674"/>
                    <a:pt x="283779" y="455336"/>
                  </a:cubicBezTo>
                  <a:lnTo>
                    <a:pt x="276063" y="457265"/>
                  </a:lnTo>
                  <a:cubicBezTo>
                    <a:pt x="265086" y="468242"/>
                    <a:pt x="276400" y="459069"/>
                    <a:pt x="260630" y="464982"/>
                  </a:cubicBezTo>
                  <a:cubicBezTo>
                    <a:pt x="258459" y="465796"/>
                    <a:pt x="256916" y="467803"/>
                    <a:pt x="254842" y="468840"/>
                  </a:cubicBezTo>
                  <a:cubicBezTo>
                    <a:pt x="250225" y="471148"/>
                    <a:pt x="244420" y="472957"/>
                    <a:pt x="239409" y="474627"/>
                  </a:cubicBezTo>
                  <a:cubicBezTo>
                    <a:pt x="250896" y="488985"/>
                    <a:pt x="244610" y="478849"/>
                    <a:pt x="250984" y="495848"/>
                  </a:cubicBezTo>
                  <a:cubicBezTo>
                    <a:pt x="253416" y="502333"/>
                    <a:pt x="258700" y="515139"/>
                    <a:pt x="258700" y="515139"/>
                  </a:cubicBezTo>
                  <a:cubicBezTo>
                    <a:pt x="259047" y="519299"/>
                    <a:pt x="263500" y="557277"/>
                    <a:pt x="258700" y="561437"/>
                  </a:cubicBezTo>
                  <a:cubicBezTo>
                    <a:pt x="251880" y="567348"/>
                    <a:pt x="240695" y="562724"/>
                    <a:pt x="231693" y="563367"/>
                  </a:cubicBezTo>
                  <a:cubicBezTo>
                    <a:pt x="228478" y="566582"/>
                    <a:pt x="225041" y="569590"/>
                    <a:pt x="222047" y="573012"/>
                  </a:cubicBezTo>
                  <a:cubicBezTo>
                    <a:pt x="217442" y="578275"/>
                    <a:pt x="219579" y="579966"/>
                    <a:pt x="212402" y="582658"/>
                  </a:cubicBezTo>
                  <a:cubicBezTo>
                    <a:pt x="209332" y="583809"/>
                    <a:pt x="205971" y="583944"/>
                    <a:pt x="202756" y="584587"/>
                  </a:cubicBezTo>
                  <a:cubicBezTo>
                    <a:pt x="177008" y="582246"/>
                    <a:pt x="186558" y="587680"/>
                    <a:pt x="171890" y="573012"/>
                  </a:cubicBezTo>
                  <a:lnTo>
                    <a:pt x="160316" y="561437"/>
                  </a:lnTo>
                  <a:lnTo>
                    <a:pt x="156457" y="557579"/>
                  </a:lnTo>
                  <a:cubicBezTo>
                    <a:pt x="155171" y="555007"/>
                    <a:pt x="154026" y="552360"/>
                    <a:pt x="152599" y="549863"/>
                  </a:cubicBezTo>
                  <a:cubicBezTo>
                    <a:pt x="151449" y="547850"/>
                    <a:pt x="148934" y="546386"/>
                    <a:pt x="148741" y="544075"/>
                  </a:cubicBezTo>
                  <a:cubicBezTo>
                    <a:pt x="147943" y="534497"/>
                    <a:pt x="149282" y="522862"/>
                    <a:pt x="158387" y="517068"/>
                  </a:cubicBezTo>
                  <a:cubicBezTo>
                    <a:pt x="159867" y="516126"/>
                    <a:pt x="175603" y="512281"/>
                    <a:pt x="179607" y="511280"/>
                  </a:cubicBezTo>
                  <a:cubicBezTo>
                    <a:pt x="180893" y="508708"/>
                    <a:pt x="181985" y="506030"/>
                    <a:pt x="183465" y="503564"/>
                  </a:cubicBezTo>
                  <a:cubicBezTo>
                    <a:pt x="185851" y="499588"/>
                    <a:pt x="191182" y="491989"/>
                    <a:pt x="191182" y="491989"/>
                  </a:cubicBezTo>
                  <a:cubicBezTo>
                    <a:pt x="191825" y="480414"/>
                    <a:pt x="191472" y="468741"/>
                    <a:pt x="193111" y="457265"/>
                  </a:cubicBezTo>
                  <a:cubicBezTo>
                    <a:pt x="193439" y="454970"/>
                    <a:pt x="195932" y="453552"/>
                    <a:pt x="196969" y="451478"/>
                  </a:cubicBezTo>
                  <a:cubicBezTo>
                    <a:pt x="197878" y="449659"/>
                    <a:pt x="198405" y="447664"/>
                    <a:pt x="198898" y="445691"/>
                  </a:cubicBezTo>
                  <a:cubicBezTo>
                    <a:pt x="199693" y="442510"/>
                    <a:pt x="198921" y="438713"/>
                    <a:pt x="200827" y="436045"/>
                  </a:cubicBezTo>
                  <a:cubicBezTo>
                    <a:pt x="202499" y="433705"/>
                    <a:pt x="205972" y="433473"/>
                    <a:pt x="208544" y="432187"/>
                  </a:cubicBezTo>
                  <a:cubicBezTo>
                    <a:pt x="209830" y="430258"/>
                    <a:pt x="210621" y="427883"/>
                    <a:pt x="212402" y="426399"/>
                  </a:cubicBezTo>
                  <a:cubicBezTo>
                    <a:pt x="214611" y="424558"/>
                    <a:pt x="218277" y="424750"/>
                    <a:pt x="220118" y="422541"/>
                  </a:cubicBezTo>
                  <a:cubicBezTo>
                    <a:pt x="221815" y="420504"/>
                    <a:pt x="220861" y="417196"/>
                    <a:pt x="222047" y="414825"/>
                  </a:cubicBezTo>
                  <a:cubicBezTo>
                    <a:pt x="222861" y="413198"/>
                    <a:pt x="224620" y="412253"/>
                    <a:pt x="225906" y="410967"/>
                  </a:cubicBezTo>
                  <a:cubicBezTo>
                    <a:pt x="228494" y="403201"/>
                    <a:pt x="231444" y="397046"/>
                    <a:pt x="225906" y="387817"/>
                  </a:cubicBezTo>
                  <a:cubicBezTo>
                    <a:pt x="224219" y="385005"/>
                    <a:pt x="219466" y="386575"/>
                    <a:pt x="216260" y="385888"/>
                  </a:cubicBezTo>
                  <a:cubicBezTo>
                    <a:pt x="210463" y="384646"/>
                    <a:pt x="204649" y="383468"/>
                    <a:pt x="198898" y="382030"/>
                  </a:cubicBezTo>
                  <a:cubicBezTo>
                    <a:pt x="196925" y="381537"/>
                    <a:pt x="195136" y="380280"/>
                    <a:pt x="193111" y="380101"/>
                  </a:cubicBezTo>
                  <a:cubicBezTo>
                    <a:pt x="173213" y="378345"/>
                    <a:pt x="153242" y="377528"/>
                    <a:pt x="133308" y="376242"/>
                  </a:cubicBezTo>
                  <a:cubicBezTo>
                    <a:pt x="132665" y="374313"/>
                    <a:pt x="132288" y="372274"/>
                    <a:pt x="131379" y="370455"/>
                  </a:cubicBezTo>
                  <a:cubicBezTo>
                    <a:pt x="128879" y="365456"/>
                    <a:pt x="124607" y="364692"/>
                    <a:pt x="129450" y="358880"/>
                  </a:cubicBezTo>
                  <a:cubicBezTo>
                    <a:pt x="131508" y="356410"/>
                    <a:pt x="134594" y="355022"/>
                    <a:pt x="137166" y="353093"/>
                  </a:cubicBezTo>
                  <a:cubicBezTo>
                    <a:pt x="142391" y="337417"/>
                    <a:pt x="141315" y="343013"/>
                    <a:pt x="137166" y="312582"/>
                  </a:cubicBezTo>
                  <a:cubicBezTo>
                    <a:pt x="136777" y="309732"/>
                    <a:pt x="134979" y="307205"/>
                    <a:pt x="133308" y="304865"/>
                  </a:cubicBezTo>
                  <a:cubicBezTo>
                    <a:pt x="131722" y="302645"/>
                    <a:pt x="129034" y="301348"/>
                    <a:pt x="127521" y="299078"/>
                  </a:cubicBezTo>
                  <a:cubicBezTo>
                    <a:pt x="116602" y="282700"/>
                    <a:pt x="127523" y="291363"/>
                    <a:pt x="115946" y="283645"/>
                  </a:cubicBezTo>
                  <a:cubicBezTo>
                    <a:pt x="111898" y="267452"/>
                    <a:pt x="117364" y="278967"/>
                    <a:pt x="90868" y="273999"/>
                  </a:cubicBezTo>
                  <a:cubicBezTo>
                    <a:pt x="88041" y="273469"/>
                    <a:pt x="85794" y="271274"/>
                    <a:pt x="83151" y="270141"/>
                  </a:cubicBezTo>
                  <a:cubicBezTo>
                    <a:pt x="81282" y="269340"/>
                    <a:pt x="79293" y="268855"/>
                    <a:pt x="77364" y="268212"/>
                  </a:cubicBezTo>
                  <a:cubicBezTo>
                    <a:pt x="76721" y="270784"/>
                    <a:pt x="75142" y="273294"/>
                    <a:pt x="75435" y="275929"/>
                  </a:cubicBezTo>
                  <a:cubicBezTo>
                    <a:pt x="75817" y="279370"/>
                    <a:pt x="77434" y="282653"/>
                    <a:pt x="79293" y="285574"/>
                  </a:cubicBezTo>
                  <a:cubicBezTo>
                    <a:pt x="81075" y="288374"/>
                    <a:pt x="90607" y="299504"/>
                    <a:pt x="94726" y="302936"/>
                  </a:cubicBezTo>
                  <a:cubicBezTo>
                    <a:pt x="96507" y="304420"/>
                    <a:pt x="98584" y="305508"/>
                    <a:pt x="100513" y="306794"/>
                  </a:cubicBezTo>
                  <a:cubicBezTo>
                    <a:pt x="111386" y="323107"/>
                    <a:pt x="105190" y="311321"/>
                    <a:pt x="102442" y="351164"/>
                  </a:cubicBezTo>
                  <a:cubicBezTo>
                    <a:pt x="101794" y="360564"/>
                    <a:pt x="99944" y="372508"/>
                    <a:pt x="98584" y="382030"/>
                  </a:cubicBezTo>
                  <a:cubicBezTo>
                    <a:pt x="94083" y="380744"/>
                    <a:pt x="89642" y="379225"/>
                    <a:pt x="85080" y="378172"/>
                  </a:cubicBezTo>
                  <a:cubicBezTo>
                    <a:pt x="81269" y="377292"/>
                    <a:pt x="77217" y="377479"/>
                    <a:pt x="73506" y="376242"/>
                  </a:cubicBezTo>
                  <a:cubicBezTo>
                    <a:pt x="71306" y="375509"/>
                    <a:pt x="69731" y="373534"/>
                    <a:pt x="67718" y="372384"/>
                  </a:cubicBezTo>
                  <a:cubicBezTo>
                    <a:pt x="65221" y="370957"/>
                    <a:pt x="62574" y="369812"/>
                    <a:pt x="60002" y="368526"/>
                  </a:cubicBezTo>
                  <a:cubicBezTo>
                    <a:pt x="56736" y="355462"/>
                    <a:pt x="61184" y="364392"/>
                    <a:pt x="48427" y="356951"/>
                  </a:cubicBezTo>
                  <a:cubicBezTo>
                    <a:pt x="40044" y="352061"/>
                    <a:pt x="30813" y="343880"/>
                    <a:pt x="23349" y="337660"/>
                  </a:cubicBezTo>
                  <a:cubicBezTo>
                    <a:pt x="24635" y="329944"/>
                    <a:pt x="25191" y="322070"/>
                    <a:pt x="27207" y="314511"/>
                  </a:cubicBezTo>
                  <a:cubicBezTo>
                    <a:pt x="27804" y="312271"/>
                    <a:pt x="30028" y="310797"/>
                    <a:pt x="31065" y="308723"/>
                  </a:cubicBezTo>
                  <a:cubicBezTo>
                    <a:pt x="31974" y="306904"/>
                    <a:pt x="32085" y="304755"/>
                    <a:pt x="32994" y="302936"/>
                  </a:cubicBezTo>
                  <a:cubicBezTo>
                    <a:pt x="34671" y="299582"/>
                    <a:pt x="36853" y="296506"/>
                    <a:pt x="38782" y="293291"/>
                  </a:cubicBezTo>
                  <a:cubicBezTo>
                    <a:pt x="38139" y="284288"/>
                    <a:pt x="38336" y="275186"/>
                    <a:pt x="36852" y="266283"/>
                  </a:cubicBezTo>
                  <a:cubicBezTo>
                    <a:pt x="36379" y="263447"/>
                    <a:pt x="35027" y="260600"/>
                    <a:pt x="32994" y="258567"/>
                  </a:cubicBezTo>
                  <a:cubicBezTo>
                    <a:pt x="31556" y="257129"/>
                    <a:pt x="29162" y="257196"/>
                    <a:pt x="27207" y="256637"/>
                  </a:cubicBezTo>
                  <a:cubicBezTo>
                    <a:pt x="10225" y="251784"/>
                    <a:pt x="27598" y="257411"/>
                    <a:pt x="13703" y="252779"/>
                  </a:cubicBezTo>
                  <a:cubicBezTo>
                    <a:pt x="13060" y="250207"/>
                    <a:pt x="12067" y="247698"/>
                    <a:pt x="11774" y="245063"/>
                  </a:cubicBezTo>
                  <a:cubicBezTo>
                    <a:pt x="6504" y="197626"/>
                    <a:pt x="18569" y="211343"/>
                    <a:pt x="4057" y="196835"/>
                  </a:cubicBezTo>
                  <a:cubicBezTo>
                    <a:pt x="2218" y="185799"/>
                    <a:pt x="199" y="175456"/>
                    <a:pt x="199" y="164040"/>
                  </a:cubicBezTo>
                  <a:cubicBezTo>
                    <a:pt x="199" y="160761"/>
                    <a:pt x="-916" y="155612"/>
                    <a:pt x="2128" y="154394"/>
                  </a:cubicBezTo>
                  <a:cubicBezTo>
                    <a:pt x="10508" y="151042"/>
                    <a:pt x="20133" y="153108"/>
                    <a:pt x="29136" y="152465"/>
                  </a:cubicBezTo>
                  <a:cubicBezTo>
                    <a:pt x="31065" y="149250"/>
                    <a:pt x="32673" y="145819"/>
                    <a:pt x="34923" y="142820"/>
                  </a:cubicBezTo>
                  <a:cubicBezTo>
                    <a:pt x="37240" y="139731"/>
                    <a:pt x="45297" y="132810"/>
                    <a:pt x="48427" y="131245"/>
                  </a:cubicBezTo>
                  <a:cubicBezTo>
                    <a:pt x="50799" y="130059"/>
                    <a:pt x="53535" y="129790"/>
                    <a:pt x="56144" y="129316"/>
                  </a:cubicBezTo>
                  <a:cubicBezTo>
                    <a:pt x="60617" y="128503"/>
                    <a:pt x="74792" y="112919"/>
                    <a:pt x="79293" y="111954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フリーフォーム: 図形 30">
              <a:extLst>
                <a:ext uri="{FF2B5EF4-FFF2-40B4-BE49-F238E27FC236}">
                  <a16:creationId xmlns:a16="http://schemas.microsoft.com/office/drawing/2014/main" id="{9AF377D3-83C8-40FD-BB62-8E0D3C59F20B}"/>
                </a:ext>
              </a:extLst>
            </p:cNvPr>
            <p:cNvSpPr/>
            <p:nvPr/>
          </p:nvSpPr>
          <p:spPr>
            <a:xfrm>
              <a:off x="553496" y="5694744"/>
              <a:ext cx="447714" cy="217990"/>
            </a:xfrm>
            <a:custGeom>
              <a:avLst/>
              <a:gdLst>
                <a:gd name="connsiteX0" fmla="*/ 372479 w 447714"/>
                <a:gd name="connsiteY0" fmla="*/ 36653 h 217990"/>
                <a:gd name="connsiteX1" fmla="*/ 382124 w 447714"/>
                <a:gd name="connsiteY1" fmla="*/ 40512 h 217990"/>
                <a:gd name="connsiteX2" fmla="*/ 439998 w 447714"/>
                <a:gd name="connsiteY2" fmla="*/ 36653 h 217990"/>
                <a:gd name="connsiteX3" fmla="*/ 445785 w 447714"/>
                <a:gd name="connsiteY3" fmla="*/ 38583 h 217990"/>
                <a:gd name="connsiteX4" fmla="*/ 445785 w 447714"/>
                <a:gd name="connsiteY4" fmla="*/ 63661 h 217990"/>
                <a:gd name="connsiteX5" fmla="*/ 434210 w 447714"/>
                <a:gd name="connsiteY5" fmla="*/ 75236 h 217990"/>
                <a:gd name="connsiteX6" fmla="*/ 422636 w 447714"/>
                <a:gd name="connsiteY6" fmla="*/ 82952 h 217990"/>
                <a:gd name="connsiteX7" fmla="*/ 407203 w 447714"/>
                <a:gd name="connsiteY7" fmla="*/ 94527 h 217990"/>
                <a:gd name="connsiteX8" fmla="*/ 395628 w 447714"/>
                <a:gd name="connsiteY8" fmla="*/ 102243 h 217990"/>
                <a:gd name="connsiteX9" fmla="*/ 391770 w 447714"/>
                <a:gd name="connsiteY9" fmla="*/ 108031 h 217990"/>
                <a:gd name="connsiteX10" fmla="*/ 385982 w 447714"/>
                <a:gd name="connsiteY10" fmla="*/ 111889 h 217990"/>
                <a:gd name="connsiteX11" fmla="*/ 382124 w 447714"/>
                <a:gd name="connsiteY11" fmla="*/ 119605 h 217990"/>
                <a:gd name="connsiteX12" fmla="*/ 370550 w 447714"/>
                <a:gd name="connsiteY12" fmla="*/ 129251 h 217990"/>
                <a:gd name="connsiteX13" fmla="*/ 362833 w 447714"/>
                <a:gd name="connsiteY13" fmla="*/ 131180 h 217990"/>
                <a:gd name="connsiteX14" fmla="*/ 322322 w 447714"/>
                <a:gd name="connsiteY14" fmla="*/ 127322 h 217990"/>
                <a:gd name="connsiteX15" fmla="*/ 268307 w 447714"/>
                <a:gd name="connsiteY15" fmla="*/ 123464 h 217990"/>
                <a:gd name="connsiteX16" fmla="*/ 254803 w 447714"/>
                <a:gd name="connsiteY16" fmla="*/ 121534 h 217990"/>
                <a:gd name="connsiteX17" fmla="*/ 249015 w 447714"/>
                <a:gd name="connsiteY17" fmla="*/ 119605 h 217990"/>
                <a:gd name="connsiteX18" fmla="*/ 235512 w 447714"/>
                <a:gd name="connsiteY18" fmla="*/ 106102 h 217990"/>
                <a:gd name="connsiteX19" fmla="*/ 216220 w 447714"/>
                <a:gd name="connsiteY19" fmla="*/ 108031 h 217990"/>
                <a:gd name="connsiteX20" fmla="*/ 208504 w 447714"/>
                <a:gd name="connsiteY20" fmla="*/ 119605 h 217990"/>
                <a:gd name="connsiteX21" fmla="*/ 195000 w 447714"/>
                <a:gd name="connsiteY21" fmla="*/ 127322 h 217990"/>
                <a:gd name="connsiteX22" fmla="*/ 189213 w 447714"/>
                <a:gd name="connsiteY22" fmla="*/ 133109 h 217990"/>
                <a:gd name="connsiteX23" fmla="*/ 179567 w 447714"/>
                <a:gd name="connsiteY23" fmla="*/ 144684 h 217990"/>
                <a:gd name="connsiteX24" fmla="*/ 171851 w 447714"/>
                <a:gd name="connsiteY24" fmla="*/ 146613 h 217990"/>
                <a:gd name="connsiteX25" fmla="*/ 158347 w 447714"/>
                <a:gd name="connsiteY25" fmla="*/ 163975 h 217990"/>
                <a:gd name="connsiteX26" fmla="*/ 156418 w 447714"/>
                <a:gd name="connsiteY26" fmla="*/ 171691 h 217990"/>
                <a:gd name="connsiteX27" fmla="*/ 148701 w 447714"/>
                <a:gd name="connsiteY27" fmla="*/ 169762 h 217990"/>
                <a:gd name="connsiteX28" fmla="*/ 146772 w 447714"/>
                <a:gd name="connsiteY28" fmla="*/ 163975 h 217990"/>
                <a:gd name="connsiteX29" fmla="*/ 137127 w 447714"/>
                <a:gd name="connsiteY29" fmla="*/ 152400 h 217990"/>
                <a:gd name="connsiteX30" fmla="*/ 133269 w 447714"/>
                <a:gd name="connsiteY30" fmla="*/ 138897 h 217990"/>
                <a:gd name="connsiteX31" fmla="*/ 129410 w 447714"/>
                <a:gd name="connsiteY31" fmla="*/ 133109 h 217990"/>
                <a:gd name="connsiteX32" fmla="*/ 123623 w 447714"/>
                <a:gd name="connsiteY32" fmla="*/ 131180 h 217990"/>
                <a:gd name="connsiteX33" fmla="*/ 121694 w 447714"/>
                <a:gd name="connsiteY33" fmla="*/ 125393 h 217990"/>
                <a:gd name="connsiteX34" fmla="*/ 110119 w 447714"/>
                <a:gd name="connsiteY34" fmla="*/ 129251 h 217990"/>
                <a:gd name="connsiteX35" fmla="*/ 94686 w 447714"/>
                <a:gd name="connsiteY35" fmla="*/ 133109 h 217990"/>
                <a:gd name="connsiteX36" fmla="*/ 85041 w 447714"/>
                <a:gd name="connsiteY36" fmla="*/ 142755 h 217990"/>
                <a:gd name="connsiteX37" fmla="*/ 79253 w 447714"/>
                <a:gd name="connsiteY37" fmla="*/ 146613 h 217990"/>
                <a:gd name="connsiteX38" fmla="*/ 73466 w 447714"/>
                <a:gd name="connsiteY38" fmla="*/ 152400 h 217990"/>
                <a:gd name="connsiteX39" fmla="*/ 71537 w 447714"/>
                <a:gd name="connsiteY39" fmla="*/ 162046 h 217990"/>
                <a:gd name="connsiteX40" fmla="*/ 67679 w 447714"/>
                <a:gd name="connsiteY40" fmla="*/ 167833 h 217990"/>
                <a:gd name="connsiteX41" fmla="*/ 65750 w 447714"/>
                <a:gd name="connsiteY41" fmla="*/ 173621 h 217990"/>
                <a:gd name="connsiteX42" fmla="*/ 63820 w 447714"/>
                <a:gd name="connsiteY42" fmla="*/ 181337 h 217990"/>
                <a:gd name="connsiteX43" fmla="*/ 54175 w 447714"/>
                <a:gd name="connsiteY43" fmla="*/ 190983 h 217990"/>
                <a:gd name="connsiteX44" fmla="*/ 46458 w 447714"/>
                <a:gd name="connsiteY44" fmla="*/ 198699 h 217990"/>
                <a:gd name="connsiteX45" fmla="*/ 38742 w 447714"/>
                <a:gd name="connsiteY45" fmla="*/ 210274 h 217990"/>
                <a:gd name="connsiteX46" fmla="*/ 36813 w 447714"/>
                <a:gd name="connsiteY46" fmla="*/ 216061 h 217990"/>
                <a:gd name="connsiteX47" fmla="*/ 31026 w 447714"/>
                <a:gd name="connsiteY47" fmla="*/ 217990 h 217990"/>
                <a:gd name="connsiteX48" fmla="*/ 25238 w 447714"/>
                <a:gd name="connsiteY48" fmla="*/ 212203 h 217990"/>
                <a:gd name="connsiteX49" fmla="*/ 21380 w 447714"/>
                <a:gd name="connsiteY49" fmla="*/ 206415 h 217990"/>
                <a:gd name="connsiteX50" fmla="*/ 11734 w 447714"/>
                <a:gd name="connsiteY50" fmla="*/ 194841 h 217990"/>
                <a:gd name="connsiteX51" fmla="*/ 9805 w 447714"/>
                <a:gd name="connsiteY51" fmla="*/ 185195 h 217990"/>
                <a:gd name="connsiteX52" fmla="*/ 7876 w 447714"/>
                <a:gd name="connsiteY52" fmla="*/ 177479 h 217990"/>
                <a:gd name="connsiteX53" fmla="*/ 2089 w 447714"/>
                <a:gd name="connsiteY53" fmla="*/ 160117 h 217990"/>
                <a:gd name="connsiteX54" fmla="*/ 2089 w 447714"/>
                <a:gd name="connsiteY54" fmla="*/ 142755 h 217990"/>
                <a:gd name="connsiteX55" fmla="*/ 7876 w 447714"/>
                <a:gd name="connsiteY55" fmla="*/ 136967 h 217990"/>
                <a:gd name="connsiteX56" fmla="*/ 27167 w 447714"/>
                <a:gd name="connsiteY56" fmla="*/ 123464 h 217990"/>
                <a:gd name="connsiteX57" fmla="*/ 32955 w 447714"/>
                <a:gd name="connsiteY57" fmla="*/ 121534 h 217990"/>
                <a:gd name="connsiteX58" fmla="*/ 36813 w 447714"/>
                <a:gd name="connsiteY58" fmla="*/ 115747 h 217990"/>
                <a:gd name="connsiteX59" fmla="*/ 50317 w 447714"/>
                <a:gd name="connsiteY59" fmla="*/ 109960 h 217990"/>
                <a:gd name="connsiteX60" fmla="*/ 63820 w 447714"/>
                <a:gd name="connsiteY60" fmla="*/ 102243 h 217990"/>
                <a:gd name="connsiteX61" fmla="*/ 79253 w 447714"/>
                <a:gd name="connsiteY61" fmla="*/ 98385 h 217990"/>
                <a:gd name="connsiteX62" fmla="*/ 85041 w 447714"/>
                <a:gd name="connsiteY62" fmla="*/ 92598 h 217990"/>
                <a:gd name="connsiteX63" fmla="*/ 104332 w 447714"/>
                <a:gd name="connsiteY63" fmla="*/ 86810 h 217990"/>
                <a:gd name="connsiteX64" fmla="*/ 110119 w 447714"/>
                <a:gd name="connsiteY64" fmla="*/ 82952 h 217990"/>
                <a:gd name="connsiteX65" fmla="*/ 106261 w 447714"/>
                <a:gd name="connsiteY65" fmla="*/ 48228 h 217990"/>
                <a:gd name="connsiteX66" fmla="*/ 119765 w 447714"/>
                <a:gd name="connsiteY66" fmla="*/ 44370 h 217990"/>
                <a:gd name="connsiteX67" fmla="*/ 142914 w 447714"/>
                <a:gd name="connsiteY67" fmla="*/ 46299 h 217990"/>
                <a:gd name="connsiteX68" fmla="*/ 144843 w 447714"/>
                <a:gd name="connsiteY68" fmla="*/ 59803 h 217990"/>
                <a:gd name="connsiteX69" fmla="*/ 156418 w 447714"/>
                <a:gd name="connsiteY69" fmla="*/ 63661 h 217990"/>
                <a:gd name="connsiteX70" fmla="*/ 162205 w 447714"/>
                <a:gd name="connsiteY70" fmla="*/ 67519 h 217990"/>
                <a:gd name="connsiteX71" fmla="*/ 166063 w 447714"/>
                <a:gd name="connsiteY71" fmla="*/ 73307 h 217990"/>
                <a:gd name="connsiteX72" fmla="*/ 239370 w 447714"/>
                <a:gd name="connsiteY72" fmla="*/ 63661 h 217990"/>
                <a:gd name="connsiteX73" fmla="*/ 233582 w 447714"/>
                <a:gd name="connsiteY73" fmla="*/ 44370 h 217990"/>
                <a:gd name="connsiteX74" fmla="*/ 227795 w 447714"/>
                <a:gd name="connsiteY74" fmla="*/ 38583 h 217990"/>
                <a:gd name="connsiteX75" fmla="*/ 214291 w 447714"/>
                <a:gd name="connsiteY75" fmla="*/ 30866 h 217990"/>
                <a:gd name="connsiteX76" fmla="*/ 208504 w 447714"/>
                <a:gd name="connsiteY76" fmla="*/ 28937 h 217990"/>
                <a:gd name="connsiteX77" fmla="*/ 187284 w 447714"/>
                <a:gd name="connsiteY77" fmla="*/ 27008 h 217990"/>
                <a:gd name="connsiteX78" fmla="*/ 191142 w 447714"/>
                <a:gd name="connsiteY78" fmla="*/ 7717 h 217990"/>
                <a:gd name="connsiteX79" fmla="*/ 198858 w 447714"/>
                <a:gd name="connsiteY79" fmla="*/ 3859 h 217990"/>
                <a:gd name="connsiteX80" fmla="*/ 210433 w 447714"/>
                <a:gd name="connsiteY80" fmla="*/ 0 h 217990"/>
                <a:gd name="connsiteX81" fmla="*/ 241299 w 447714"/>
                <a:gd name="connsiteY81" fmla="*/ 5788 h 217990"/>
                <a:gd name="connsiteX82" fmla="*/ 250945 w 447714"/>
                <a:gd name="connsiteY82" fmla="*/ 7717 h 217990"/>
                <a:gd name="connsiteX83" fmla="*/ 264448 w 447714"/>
                <a:gd name="connsiteY83" fmla="*/ 46299 h 217990"/>
                <a:gd name="connsiteX84" fmla="*/ 268307 w 447714"/>
                <a:gd name="connsiteY84" fmla="*/ 59803 h 217990"/>
                <a:gd name="connsiteX85" fmla="*/ 274094 w 447714"/>
                <a:gd name="connsiteY85" fmla="*/ 65590 h 217990"/>
                <a:gd name="connsiteX86" fmla="*/ 276023 w 447714"/>
                <a:gd name="connsiteY86" fmla="*/ 73307 h 217990"/>
                <a:gd name="connsiteX87" fmla="*/ 281810 w 447714"/>
                <a:gd name="connsiteY87" fmla="*/ 79094 h 217990"/>
                <a:gd name="connsiteX88" fmla="*/ 285669 w 447714"/>
                <a:gd name="connsiteY88" fmla="*/ 84881 h 217990"/>
                <a:gd name="connsiteX89" fmla="*/ 295314 w 447714"/>
                <a:gd name="connsiteY89" fmla="*/ 82952 h 217990"/>
                <a:gd name="connsiteX90" fmla="*/ 310747 w 447714"/>
                <a:gd name="connsiteY90" fmla="*/ 69448 h 217990"/>
                <a:gd name="connsiteX91" fmla="*/ 316534 w 447714"/>
                <a:gd name="connsiteY91" fmla="*/ 61732 h 217990"/>
                <a:gd name="connsiteX92" fmla="*/ 331967 w 447714"/>
                <a:gd name="connsiteY92" fmla="*/ 57874 h 217990"/>
                <a:gd name="connsiteX93" fmla="*/ 339684 w 447714"/>
                <a:gd name="connsiteY93" fmla="*/ 50157 h 217990"/>
                <a:gd name="connsiteX94" fmla="*/ 372479 w 447714"/>
                <a:gd name="connsiteY94" fmla="*/ 36653 h 2179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</a:cxnLst>
              <a:rect l="l" t="t" r="r" b="b"/>
              <a:pathLst>
                <a:path w="447714" h="217990">
                  <a:moveTo>
                    <a:pt x="372479" y="36653"/>
                  </a:moveTo>
                  <a:cubicBezTo>
                    <a:pt x="379552" y="35045"/>
                    <a:pt x="378663" y="40400"/>
                    <a:pt x="382124" y="40512"/>
                  </a:cubicBezTo>
                  <a:cubicBezTo>
                    <a:pt x="421703" y="41789"/>
                    <a:pt x="418146" y="42118"/>
                    <a:pt x="439998" y="36653"/>
                  </a:cubicBezTo>
                  <a:cubicBezTo>
                    <a:pt x="441927" y="37296"/>
                    <a:pt x="444657" y="36891"/>
                    <a:pt x="445785" y="38583"/>
                  </a:cubicBezTo>
                  <a:cubicBezTo>
                    <a:pt x="449380" y="43977"/>
                    <a:pt x="447093" y="59736"/>
                    <a:pt x="445785" y="63661"/>
                  </a:cubicBezTo>
                  <a:cubicBezTo>
                    <a:pt x="443225" y="71341"/>
                    <a:pt x="439343" y="70959"/>
                    <a:pt x="434210" y="75236"/>
                  </a:cubicBezTo>
                  <a:cubicBezTo>
                    <a:pt x="424576" y="83264"/>
                    <a:pt x="432807" y="79562"/>
                    <a:pt x="422636" y="82952"/>
                  </a:cubicBezTo>
                  <a:cubicBezTo>
                    <a:pt x="409418" y="96170"/>
                    <a:pt x="420914" y="86301"/>
                    <a:pt x="407203" y="94527"/>
                  </a:cubicBezTo>
                  <a:cubicBezTo>
                    <a:pt x="403227" y="96913"/>
                    <a:pt x="395628" y="102243"/>
                    <a:pt x="395628" y="102243"/>
                  </a:cubicBezTo>
                  <a:cubicBezTo>
                    <a:pt x="394342" y="104172"/>
                    <a:pt x="393410" y="106391"/>
                    <a:pt x="391770" y="108031"/>
                  </a:cubicBezTo>
                  <a:cubicBezTo>
                    <a:pt x="390130" y="109671"/>
                    <a:pt x="387466" y="110108"/>
                    <a:pt x="385982" y="111889"/>
                  </a:cubicBezTo>
                  <a:cubicBezTo>
                    <a:pt x="384141" y="114098"/>
                    <a:pt x="383795" y="117265"/>
                    <a:pt x="382124" y="119605"/>
                  </a:cubicBezTo>
                  <a:cubicBezTo>
                    <a:pt x="380079" y="122469"/>
                    <a:pt x="374035" y="127758"/>
                    <a:pt x="370550" y="129251"/>
                  </a:cubicBezTo>
                  <a:cubicBezTo>
                    <a:pt x="368113" y="130295"/>
                    <a:pt x="365405" y="130537"/>
                    <a:pt x="362833" y="131180"/>
                  </a:cubicBezTo>
                  <a:lnTo>
                    <a:pt x="322322" y="127322"/>
                  </a:lnTo>
                  <a:cubicBezTo>
                    <a:pt x="294461" y="125063"/>
                    <a:pt x="293668" y="126134"/>
                    <a:pt x="268307" y="123464"/>
                  </a:cubicBezTo>
                  <a:cubicBezTo>
                    <a:pt x="263785" y="122988"/>
                    <a:pt x="259304" y="122177"/>
                    <a:pt x="254803" y="121534"/>
                  </a:cubicBezTo>
                  <a:cubicBezTo>
                    <a:pt x="252874" y="120891"/>
                    <a:pt x="250603" y="120875"/>
                    <a:pt x="249015" y="119605"/>
                  </a:cubicBezTo>
                  <a:cubicBezTo>
                    <a:pt x="244044" y="115629"/>
                    <a:pt x="235512" y="106102"/>
                    <a:pt x="235512" y="106102"/>
                  </a:cubicBezTo>
                  <a:cubicBezTo>
                    <a:pt x="229081" y="106745"/>
                    <a:pt x="222001" y="105141"/>
                    <a:pt x="216220" y="108031"/>
                  </a:cubicBezTo>
                  <a:cubicBezTo>
                    <a:pt x="212073" y="110104"/>
                    <a:pt x="212651" y="117531"/>
                    <a:pt x="208504" y="119605"/>
                  </a:cubicBezTo>
                  <a:cubicBezTo>
                    <a:pt x="203792" y="121962"/>
                    <a:pt x="199087" y="123917"/>
                    <a:pt x="195000" y="127322"/>
                  </a:cubicBezTo>
                  <a:cubicBezTo>
                    <a:pt x="192904" y="129068"/>
                    <a:pt x="190959" y="131013"/>
                    <a:pt x="189213" y="133109"/>
                  </a:cubicBezTo>
                  <a:cubicBezTo>
                    <a:pt x="185579" y="137470"/>
                    <a:pt x="184950" y="141608"/>
                    <a:pt x="179567" y="144684"/>
                  </a:cubicBezTo>
                  <a:cubicBezTo>
                    <a:pt x="177265" y="145999"/>
                    <a:pt x="174423" y="145970"/>
                    <a:pt x="171851" y="146613"/>
                  </a:cubicBezTo>
                  <a:cubicBezTo>
                    <a:pt x="160800" y="157664"/>
                    <a:pt x="161271" y="153742"/>
                    <a:pt x="158347" y="163975"/>
                  </a:cubicBezTo>
                  <a:cubicBezTo>
                    <a:pt x="157619" y="166524"/>
                    <a:pt x="157061" y="169119"/>
                    <a:pt x="156418" y="171691"/>
                  </a:cubicBezTo>
                  <a:cubicBezTo>
                    <a:pt x="153846" y="171048"/>
                    <a:pt x="150772" y="171418"/>
                    <a:pt x="148701" y="169762"/>
                  </a:cubicBezTo>
                  <a:cubicBezTo>
                    <a:pt x="147113" y="168492"/>
                    <a:pt x="147900" y="165667"/>
                    <a:pt x="146772" y="163975"/>
                  </a:cubicBezTo>
                  <a:cubicBezTo>
                    <a:pt x="138238" y="151173"/>
                    <a:pt x="143440" y="165026"/>
                    <a:pt x="137127" y="152400"/>
                  </a:cubicBezTo>
                  <a:cubicBezTo>
                    <a:pt x="133369" y="144884"/>
                    <a:pt x="136982" y="147561"/>
                    <a:pt x="133269" y="138897"/>
                  </a:cubicBezTo>
                  <a:cubicBezTo>
                    <a:pt x="132355" y="136766"/>
                    <a:pt x="131221" y="134558"/>
                    <a:pt x="129410" y="133109"/>
                  </a:cubicBezTo>
                  <a:cubicBezTo>
                    <a:pt x="127822" y="131839"/>
                    <a:pt x="125552" y="131823"/>
                    <a:pt x="123623" y="131180"/>
                  </a:cubicBezTo>
                  <a:cubicBezTo>
                    <a:pt x="122980" y="129251"/>
                    <a:pt x="123707" y="125681"/>
                    <a:pt x="121694" y="125393"/>
                  </a:cubicBezTo>
                  <a:cubicBezTo>
                    <a:pt x="117668" y="124818"/>
                    <a:pt x="114043" y="128181"/>
                    <a:pt x="110119" y="129251"/>
                  </a:cubicBezTo>
                  <a:cubicBezTo>
                    <a:pt x="84505" y="136236"/>
                    <a:pt x="112253" y="127254"/>
                    <a:pt x="94686" y="133109"/>
                  </a:cubicBezTo>
                  <a:cubicBezTo>
                    <a:pt x="79251" y="143399"/>
                    <a:pt x="97905" y="129891"/>
                    <a:pt x="85041" y="142755"/>
                  </a:cubicBezTo>
                  <a:cubicBezTo>
                    <a:pt x="83401" y="144395"/>
                    <a:pt x="81034" y="145129"/>
                    <a:pt x="79253" y="146613"/>
                  </a:cubicBezTo>
                  <a:cubicBezTo>
                    <a:pt x="77157" y="148359"/>
                    <a:pt x="75395" y="150471"/>
                    <a:pt x="73466" y="152400"/>
                  </a:cubicBezTo>
                  <a:cubicBezTo>
                    <a:pt x="72823" y="155615"/>
                    <a:pt x="72688" y="158976"/>
                    <a:pt x="71537" y="162046"/>
                  </a:cubicBezTo>
                  <a:cubicBezTo>
                    <a:pt x="70723" y="164217"/>
                    <a:pt x="68716" y="165759"/>
                    <a:pt x="67679" y="167833"/>
                  </a:cubicBezTo>
                  <a:cubicBezTo>
                    <a:pt x="66770" y="169652"/>
                    <a:pt x="66309" y="171666"/>
                    <a:pt x="65750" y="173621"/>
                  </a:cubicBezTo>
                  <a:cubicBezTo>
                    <a:pt x="65022" y="176170"/>
                    <a:pt x="65291" y="179131"/>
                    <a:pt x="63820" y="181337"/>
                  </a:cubicBezTo>
                  <a:cubicBezTo>
                    <a:pt x="61298" y="185120"/>
                    <a:pt x="57390" y="187768"/>
                    <a:pt x="54175" y="190983"/>
                  </a:cubicBezTo>
                  <a:cubicBezTo>
                    <a:pt x="51603" y="193555"/>
                    <a:pt x="48476" y="195672"/>
                    <a:pt x="46458" y="198699"/>
                  </a:cubicBezTo>
                  <a:cubicBezTo>
                    <a:pt x="43886" y="202557"/>
                    <a:pt x="40208" y="205875"/>
                    <a:pt x="38742" y="210274"/>
                  </a:cubicBezTo>
                  <a:cubicBezTo>
                    <a:pt x="38099" y="212203"/>
                    <a:pt x="38251" y="214623"/>
                    <a:pt x="36813" y="216061"/>
                  </a:cubicBezTo>
                  <a:cubicBezTo>
                    <a:pt x="35375" y="217499"/>
                    <a:pt x="32955" y="217347"/>
                    <a:pt x="31026" y="217990"/>
                  </a:cubicBezTo>
                  <a:cubicBezTo>
                    <a:pt x="29097" y="216061"/>
                    <a:pt x="26985" y="214299"/>
                    <a:pt x="25238" y="212203"/>
                  </a:cubicBezTo>
                  <a:cubicBezTo>
                    <a:pt x="23754" y="210422"/>
                    <a:pt x="22728" y="208302"/>
                    <a:pt x="21380" y="206415"/>
                  </a:cubicBezTo>
                  <a:cubicBezTo>
                    <a:pt x="15649" y="198391"/>
                    <a:pt x="17218" y="200323"/>
                    <a:pt x="11734" y="194841"/>
                  </a:cubicBezTo>
                  <a:cubicBezTo>
                    <a:pt x="11091" y="191626"/>
                    <a:pt x="10516" y="188396"/>
                    <a:pt x="9805" y="185195"/>
                  </a:cubicBezTo>
                  <a:cubicBezTo>
                    <a:pt x="9230" y="182607"/>
                    <a:pt x="8396" y="180079"/>
                    <a:pt x="7876" y="177479"/>
                  </a:cubicBezTo>
                  <a:cubicBezTo>
                    <a:pt x="4906" y="162627"/>
                    <a:pt x="8508" y="169746"/>
                    <a:pt x="2089" y="160117"/>
                  </a:cubicBezTo>
                  <a:cubicBezTo>
                    <a:pt x="355" y="153180"/>
                    <a:pt x="-1584" y="150102"/>
                    <a:pt x="2089" y="142755"/>
                  </a:cubicBezTo>
                  <a:cubicBezTo>
                    <a:pt x="3309" y="140315"/>
                    <a:pt x="5805" y="138743"/>
                    <a:pt x="7876" y="136967"/>
                  </a:cubicBezTo>
                  <a:cubicBezTo>
                    <a:pt x="10676" y="134567"/>
                    <a:pt x="25359" y="124067"/>
                    <a:pt x="27167" y="123464"/>
                  </a:cubicBezTo>
                  <a:lnTo>
                    <a:pt x="32955" y="121534"/>
                  </a:lnTo>
                  <a:cubicBezTo>
                    <a:pt x="34241" y="119605"/>
                    <a:pt x="35032" y="117231"/>
                    <a:pt x="36813" y="115747"/>
                  </a:cubicBezTo>
                  <a:cubicBezTo>
                    <a:pt x="41330" y="111983"/>
                    <a:pt x="45350" y="112089"/>
                    <a:pt x="50317" y="109960"/>
                  </a:cubicBezTo>
                  <a:cubicBezTo>
                    <a:pt x="73987" y="99816"/>
                    <a:pt x="44449" y="111929"/>
                    <a:pt x="63820" y="102243"/>
                  </a:cubicBezTo>
                  <a:cubicBezTo>
                    <a:pt x="67773" y="100267"/>
                    <a:pt x="75588" y="99118"/>
                    <a:pt x="79253" y="98385"/>
                  </a:cubicBezTo>
                  <a:cubicBezTo>
                    <a:pt x="81182" y="96456"/>
                    <a:pt x="82656" y="93923"/>
                    <a:pt x="85041" y="92598"/>
                  </a:cubicBezTo>
                  <a:cubicBezTo>
                    <a:pt x="88881" y="90465"/>
                    <a:pt x="99353" y="88055"/>
                    <a:pt x="104332" y="86810"/>
                  </a:cubicBezTo>
                  <a:cubicBezTo>
                    <a:pt x="106261" y="85524"/>
                    <a:pt x="109848" y="85254"/>
                    <a:pt x="110119" y="82952"/>
                  </a:cubicBezTo>
                  <a:cubicBezTo>
                    <a:pt x="112273" y="64641"/>
                    <a:pt x="110360" y="60524"/>
                    <a:pt x="106261" y="48228"/>
                  </a:cubicBezTo>
                  <a:cubicBezTo>
                    <a:pt x="108991" y="47318"/>
                    <a:pt x="117342" y="44370"/>
                    <a:pt x="119765" y="44370"/>
                  </a:cubicBezTo>
                  <a:cubicBezTo>
                    <a:pt x="127508" y="44370"/>
                    <a:pt x="135198" y="45656"/>
                    <a:pt x="142914" y="46299"/>
                  </a:cubicBezTo>
                  <a:cubicBezTo>
                    <a:pt x="143557" y="50800"/>
                    <a:pt x="142051" y="56214"/>
                    <a:pt x="144843" y="59803"/>
                  </a:cubicBezTo>
                  <a:cubicBezTo>
                    <a:pt x="147340" y="63013"/>
                    <a:pt x="153034" y="61405"/>
                    <a:pt x="156418" y="63661"/>
                  </a:cubicBezTo>
                  <a:lnTo>
                    <a:pt x="162205" y="67519"/>
                  </a:lnTo>
                  <a:cubicBezTo>
                    <a:pt x="163491" y="69448"/>
                    <a:pt x="163745" y="73252"/>
                    <a:pt x="166063" y="73307"/>
                  </a:cubicBezTo>
                  <a:cubicBezTo>
                    <a:pt x="249518" y="75294"/>
                    <a:pt x="257156" y="90340"/>
                    <a:pt x="239370" y="63661"/>
                  </a:cubicBezTo>
                  <a:cubicBezTo>
                    <a:pt x="238495" y="60163"/>
                    <a:pt x="235149" y="45937"/>
                    <a:pt x="233582" y="44370"/>
                  </a:cubicBezTo>
                  <a:cubicBezTo>
                    <a:pt x="231653" y="42441"/>
                    <a:pt x="229891" y="40330"/>
                    <a:pt x="227795" y="38583"/>
                  </a:cubicBezTo>
                  <a:cubicBezTo>
                    <a:pt x="224373" y="35731"/>
                    <a:pt x="218181" y="32533"/>
                    <a:pt x="214291" y="30866"/>
                  </a:cubicBezTo>
                  <a:cubicBezTo>
                    <a:pt x="212422" y="30065"/>
                    <a:pt x="210517" y="29225"/>
                    <a:pt x="208504" y="28937"/>
                  </a:cubicBezTo>
                  <a:cubicBezTo>
                    <a:pt x="201473" y="27933"/>
                    <a:pt x="194357" y="27651"/>
                    <a:pt x="187284" y="27008"/>
                  </a:cubicBezTo>
                  <a:cubicBezTo>
                    <a:pt x="188570" y="20578"/>
                    <a:pt x="188209" y="13582"/>
                    <a:pt x="191142" y="7717"/>
                  </a:cubicBezTo>
                  <a:cubicBezTo>
                    <a:pt x="192428" y="5145"/>
                    <a:pt x="196188" y="4927"/>
                    <a:pt x="198858" y="3859"/>
                  </a:cubicBezTo>
                  <a:cubicBezTo>
                    <a:pt x="202634" y="2348"/>
                    <a:pt x="210433" y="0"/>
                    <a:pt x="210433" y="0"/>
                  </a:cubicBezTo>
                  <a:lnTo>
                    <a:pt x="241299" y="5788"/>
                  </a:lnTo>
                  <a:lnTo>
                    <a:pt x="250945" y="7717"/>
                  </a:lnTo>
                  <a:cubicBezTo>
                    <a:pt x="264705" y="21477"/>
                    <a:pt x="255977" y="10718"/>
                    <a:pt x="264448" y="46299"/>
                  </a:cubicBezTo>
                  <a:cubicBezTo>
                    <a:pt x="264687" y="47303"/>
                    <a:pt x="267213" y="58162"/>
                    <a:pt x="268307" y="59803"/>
                  </a:cubicBezTo>
                  <a:cubicBezTo>
                    <a:pt x="269820" y="62073"/>
                    <a:pt x="272165" y="63661"/>
                    <a:pt x="274094" y="65590"/>
                  </a:cubicBezTo>
                  <a:cubicBezTo>
                    <a:pt x="274737" y="68162"/>
                    <a:pt x="274708" y="71005"/>
                    <a:pt x="276023" y="73307"/>
                  </a:cubicBezTo>
                  <a:cubicBezTo>
                    <a:pt x="277376" y="75676"/>
                    <a:pt x="280063" y="76998"/>
                    <a:pt x="281810" y="79094"/>
                  </a:cubicBezTo>
                  <a:cubicBezTo>
                    <a:pt x="283294" y="80875"/>
                    <a:pt x="284383" y="82952"/>
                    <a:pt x="285669" y="84881"/>
                  </a:cubicBezTo>
                  <a:cubicBezTo>
                    <a:pt x="288884" y="84238"/>
                    <a:pt x="292244" y="84103"/>
                    <a:pt x="295314" y="82952"/>
                  </a:cubicBezTo>
                  <a:cubicBezTo>
                    <a:pt x="299970" y="81206"/>
                    <a:pt x="309100" y="71644"/>
                    <a:pt x="310747" y="69448"/>
                  </a:cubicBezTo>
                  <a:cubicBezTo>
                    <a:pt x="312676" y="66876"/>
                    <a:pt x="314064" y="63790"/>
                    <a:pt x="316534" y="61732"/>
                  </a:cubicBezTo>
                  <a:cubicBezTo>
                    <a:pt x="318407" y="60171"/>
                    <a:pt x="331655" y="57936"/>
                    <a:pt x="331967" y="57874"/>
                  </a:cubicBezTo>
                  <a:cubicBezTo>
                    <a:pt x="334539" y="55302"/>
                    <a:pt x="336565" y="52029"/>
                    <a:pt x="339684" y="50157"/>
                  </a:cubicBezTo>
                  <a:cubicBezTo>
                    <a:pt x="350520" y="43655"/>
                    <a:pt x="365406" y="38261"/>
                    <a:pt x="372479" y="36653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3" name="楕円 32">
            <a:extLst>
              <a:ext uri="{FF2B5EF4-FFF2-40B4-BE49-F238E27FC236}">
                <a16:creationId xmlns:a16="http://schemas.microsoft.com/office/drawing/2014/main" id="{A27586B3-8C02-4633-8F47-E87E5F6304F3}"/>
              </a:ext>
            </a:extLst>
          </p:cNvPr>
          <p:cNvSpPr/>
          <p:nvPr/>
        </p:nvSpPr>
        <p:spPr>
          <a:xfrm>
            <a:off x="3580174" y="4751128"/>
            <a:ext cx="300251" cy="279779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C8B70F2-C22A-4BA1-8DF9-3948DC34C3B1}"/>
              </a:ext>
            </a:extLst>
          </p:cNvPr>
          <p:cNvSpPr txBox="1"/>
          <p:nvPr/>
        </p:nvSpPr>
        <p:spPr>
          <a:xfrm>
            <a:off x="2687748" y="3234965"/>
            <a:ext cx="139333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/106 (3.8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16CA87E6-56D8-4B49-86B7-3442B5F4DA79}"/>
              </a:ext>
            </a:extLst>
          </p:cNvPr>
          <p:cNvCxnSpPr>
            <a:cxnSpLocks/>
            <a:endCxn id="33" idx="0"/>
          </p:cNvCxnSpPr>
          <p:nvPr/>
        </p:nvCxnSpPr>
        <p:spPr>
          <a:xfrm>
            <a:off x="3730299" y="3604297"/>
            <a:ext cx="1" cy="114683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711DB66-9664-4870-9A52-905CD22C0BDD}"/>
              </a:ext>
            </a:extLst>
          </p:cNvPr>
          <p:cNvSpPr txBox="1"/>
          <p:nvPr/>
        </p:nvSpPr>
        <p:spPr>
          <a:xfrm>
            <a:off x="720650" y="3509306"/>
            <a:ext cx="121860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/186 (0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9F882DDF-C428-4A05-9B96-76C8A16367EB}"/>
              </a:ext>
            </a:extLst>
          </p:cNvPr>
          <p:cNvCxnSpPr>
            <a:cxnSpLocks/>
          </p:cNvCxnSpPr>
          <p:nvPr/>
        </p:nvCxnSpPr>
        <p:spPr>
          <a:xfrm>
            <a:off x="1639785" y="3878638"/>
            <a:ext cx="0" cy="124639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4BF56D5-FB96-4E60-8897-03D059AECDF0}"/>
              </a:ext>
            </a:extLst>
          </p:cNvPr>
          <p:cNvSpPr txBox="1"/>
          <p:nvPr/>
        </p:nvSpPr>
        <p:spPr>
          <a:xfrm>
            <a:off x="5951432" y="831680"/>
            <a:ext cx="139333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/98 (10.2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7420B5BB-27DA-45B8-AE14-4AB3A5188331}"/>
              </a:ext>
            </a:extLst>
          </p:cNvPr>
          <p:cNvCxnSpPr>
            <a:cxnSpLocks/>
          </p:cNvCxnSpPr>
          <p:nvPr/>
        </p:nvCxnSpPr>
        <p:spPr>
          <a:xfrm>
            <a:off x="6970703" y="1201012"/>
            <a:ext cx="0" cy="6941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F4BC6141-339B-4414-9417-4D765A94EFDA}"/>
              </a:ext>
            </a:extLst>
          </p:cNvPr>
          <p:cNvSpPr/>
          <p:nvPr/>
        </p:nvSpPr>
        <p:spPr>
          <a:xfrm>
            <a:off x="155998" y="2826076"/>
            <a:ext cx="2226892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kuoka University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spital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6098CB7F-9F33-430A-BB2B-82FF1EF52106}"/>
              </a:ext>
            </a:extLst>
          </p:cNvPr>
          <p:cNvSpPr/>
          <p:nvPr/>
        </p:nvSpPr>
        <p:spPr>
          <a:xfrm>
            <a:off x="4748865" y="407817"/>
            <a:ext cx="335059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pporo City General Hospital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62772FA2-EA29-4D76-8265-06153622CFE0}"/>
              </a:ext>
            </a:extLst>
          </p:cNvPr>
          <p:cNvSpPr/>
          <p:nvPr/>
        </p:nvSpPr>
        <p:spPr>
          <a:xfrm>
            <a:off x="2687748" y="2849994"/>
            <a:ext cx="281679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be University Hospital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楕円 42">
            <a:extLst>
              <a:ext uri="{FF2B5EF4-FFF2-40B4-BE49-F238E27FC236}">
                <a16:creationId xmlns:a16="http://schemas.microsoft.com/office/drawing/2014/main" id="{6995243B-DDE6-4534-981A-D42C89B89240}"/>
              </a:ext>
            </a:extLst>
          </p:cNvPr>
          <p:cNvSpPr/>
          <p:nvPr/>
        </p:nvSpPr>
        <p:spPr>
          <a:xfrm>
            <a:off x="3580174" y="4880503"/>
            <a:ext cx="300251" cy="279779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CD225F2-5D93-4C62-A5DB-94CF6B63A64C}"/>
              </a:ext>
            </a:extLst>
          </p:cNvPr>
          <p:cNvSpPr txBox="1"/>
          <p:nvPr/>
        </p:nvSpPr>
        <p:spPr>
          <a:xfrm>
            <a:off x="3461103" y="5757458"/>
            <a:ext cx="128753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/79 (5.0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9D6D8145-3D8E-47F8-922D-158E4D2B034B}"/>
              </a:ext>
            </a:extLst>
          </p:cNvPr>
          <p:cNvSpPr/>
          <p:nvPr/>
        </p:nvSpPr>
        <p:spPr>
          <a:xfrm>
            <a:off x="3466714" y="6100890"/>
            <a:ext cx="2895344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be City Medical Center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Hospital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100E92A8-22B7-4F7E-A842-3B1C0FD2D89C}"/>
              </a:ext>
            </a:extLst>
          </p:cNvPr>
          <p:cNvCxnSpPr>
            <a:cxnSpLocks/>
          </p:cNvCxnSpPr>
          <p:nvPr/>
        </p:nvCxnSpPr>
        <p:spPr>
          <a:xfrm>
            <a:off x="3638243" y="5130544"/>
            <a:ext cx="0" cy="60137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楕円 46">
            <a:extLst>
              <a:ext uri="{FF2B5EF4-FFF2-40B4-BE49-F238E27FC236}">
                <a16:creationId xmlns:a16="http://schemas.microsoft.com/office/drawing/2014/main" id="{B7DC5AA3-04D4-4D25-8560-CEC983CFB14B}"/>
              </a:ext>
            </a:extLst>
          </p:cNvPr>
          <p:cNvSpPr/>
          <p:nvPr/>
        </p:nvSpPr>
        <p:spPr>
          <a:xfrm>
            <a:off x="1489660" y="4994197"/>
            <a:ext cx="300251" cy="279779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楕円 47">
            <a:extLst>
              <a:ext uri="{FF2B5EF4-FFF2-40B4-BE49-F238E27FC236}">
                <a16:creationId xmlns:a16="http://schemas.microsoft.com/office/drawing/2014/main" id="{6E25C4F9-0381-4218-9DC2-9B699144D8D0}"/>
              </a:ext>
            </a:extLst>
          </p:cNvPr>
          <p:cNvSpPr/>
          <p:nvPr/>
        </p:nvSpPr>
        <p:spPr>
          <a:xfrm>
            <a:off x="6820578" y="1895194"/>
            <a:ext cx="300251" cy="279779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975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</TotalTime>
  <Words>32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原重雄</dc:creator>
  <cp:lastModifiedBy>原重雄</cp:lastModifiedBy>
  <cp:revision>22</cp:revision>
  <dcterms:created xsi:type="dcterms:W3CDTF">2018-09-10T00:39:28Z</dcterms:created>
  <dcterms:modified xsi:type="dcterms:W3CDTF">2018-09-30T04:28:09Z</dcterms:modified>
</cp:coreProperties>
</file>